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F7A5AB-73D5-4474-8D9E-9D02D474A4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0773A4-9889-45D2-A18A-1FDF16F22D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A0EAAA-8A66-4BDB-9DD0-1650BDB58C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8E4BB-7B6D-48EB-A64E-5D2B3A5B9AF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FDD6A-3139-4923-89A6-7BF47292F4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C78A2-0CDD-4DE0-BED2-84218F8327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EF3B8-BE52-42B5-A65C-6A5D65CCC4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CBFC9A-214E-402E-95C2-9AD5873554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E4DF42-84B1-4AC2-8324-AA219B3B0A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EC7593-77A8-4251-859C-8F33E3B372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2714C-9F6E-44DC-B46F-53A0AE0D1D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FC134-C02E-4BD2-B835-CD18ABFEF3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0C89EC-2F2A-4BD1-9690-0353F7B88E7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image" Target="../media/image5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858"/>
          <p:cNvGrpSpPr/>
          <p:nvPr/>
        </p:nvGrpSpPr>
        <p:grpSpPr>
          <a:xfrm>
            <a:off x="1440000" y="1303200"/>
            <a:ext cx="1439640" cy="1386720"/>
            <a:chOff x="1440000" y="1303200"/>
            <a:chExt cx="1439640" cy="1386720"/>
          </a:xfrm>
        </p:grpSpPr>
        <p:grpSp>
          <p:nvGrpSpPr>
            <p:cNvPr id="42" name="Group 3851"/>
            <p:cNvGrpSpPr/>
            <p:nvPr/>
          </p:nvGrpSpPr>
          <p:grpSpPr>
            <a:xfrm>
              <a:off x="1440000" y="1309320"/>
              <a:ext cx="1409400" cy="1380600"/>
              <a:chOff x="1440000" y="1309320"/>
              <a:chExt cx="1409400" cy="1380600"/>
            </a:xfrm>
          </p:grpSpPr>
          <p:grpSp>
            <p:nvGrpSpPr>
              <p:cNvPr id="43" name="Group 555"/>
              <p:cNvGrpSpPr/>
              <p:nvPr/>
            </p:nvGrpSpPr>
            <p:grpSpPr>
              <a:xfrm>
                <a:off x="1440000" y="1309320"/>
                <a:ext cx="1409400" cy="1380600"/>
                <a:chOff x="1440000" y="1309320"/>
                <a:chExt cx="1409400" cy="1380600"/>
              </a:xfrm>
            </p:grpSpPr>
            <p:sp>
              <p:nvSpPr>
                <p:cNvPr id="44" name="Rectangle 556"/>
                <p:cNvSpPr/>
                <p:nvPr/>
              </p:nvSpPr>
              <p:spPr>
                <a:xfrm>
                  <a:off x="1645560" y="1311120"/>
                  <a:ext cx="1167480" cy="92160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5" name="Group 557"/>
                <p:cNvGrpSpPr/>
                <p:nvPr/>
              </p:nvGrpSpPr>
              <p:grpSpPr>
                <a:xfrm>
                  <a:off x="1596960" y="2231280"/>
                  <a:ext cx="1252440" cy="458640"/>
                  <a:chOff x="1596960" y="2231280"/>
                  <a:chExt cx="1252440" cy="458640"/>
                </a:xfrm>
              </p:grpSpPr>
              <p:sp>
                <p:nvSpPr>
                  <p:cNvPr id="46" name="Line 558"/>
                  <p:cNvSpPr/>
                  <p:nvPr/>
                </p:nvSpPr>
                <p:spPr>
                  <a:xfrm>
                    <a:off x="1643400" y="2231280"/>
                    <a:ext cx="116676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47" name="Group 559"/>
                  <p:cNvGrpSpPr/>
                  <p:nvPr/>
                </p:nvGrpSpPr>
                <p:grpSpPr>
                  <a:xfrm>
                    <a:off x="1643400" y="2234880"/>
                    <a:ext cx="1166400" cy="20880"/>
                    <a:chOff x="1643400" y="2234880"/>
                    <a:chExt cx="1166400" cy="20880"/>
                  </a:xfrm>
                </p:grpSpPr>
                <p:sp>
                  <p:nvSpPr>
                    <p:cNvPr id="48" name="Line 560"/>
                    <p:cNvSpPr/>
                    <p:nvPr/>
                  </p:nvSpPr>
                  <p:spPr>
                    <a:xfrm>
                      <a:off x="1643400" y="22348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" name="Line 561"/>
                    <p:cNvSpPr/>
                    <p:nvPr/>
                  </p:nvSpPr>
                  <p:spPr>
                    <a:xfrm>
                      <a:off x="172872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0" name="Line 562"/>
                    <p:cNvSpPr/>
                    <p:nvPr/>
                  </p:nvSpPr>
                  <p:spPr>
                    <a:xfrm>
                      <a:off x="177876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" name="Line 563"/>
                    <p:cNvSpPr/>
                    <p:nvPr/>
                  </p:nvSpPr>
                  <p:spPr>
                    <a:xfrm>
                      <a:off x="181512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" name="Line 564"/>
                    <p:cNvSpPr/>
                    <p:nvPr/>
                  </p:nvSpPr>
                  <p:spPr>
                    <a:xfrm>
                      <a:off x="1846800" y="223488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" name="Line 565"/>
                    <p:cNvSpPr/>
                    <p:nvPr/>
                  </p:nvSpPr>
                  <p:spPr>
                    <a:xfrm>
                      <a:off x="186948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" name="Line 566"/>
                    <p:cNvSpPr/>
                    <p:nvPr/>
                  </p:nvSpPr>
                  <p:spPr>
                    <a:xfrm>
                      <a:off x="188748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" name="Line 567"/>
                    <p:cNvSpPr/>
                    <p:nvPr/>
                  </p:nvSpPr>
                  <p:spPr>
                    <a:xfrm>
                      <a:off x="190512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" name="Line 568"/>
                    <p:cNvSpPr/>
                    <p:nvPr/>
                  </p:nvSpPr>
                  <p:spPr>
                    <a:xfrm>
                      <a:off x="191916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" name="Line 569"/>
                    <p:cNvSpPr/>
                    <p:nvPr/>
                  </p:nvSpPr>
                  <p:spPr>
                    <a:xfrm>
                      <a:off x="1932480" y="22348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" name="Line 570"/>
                    <p:cNvSpPr/>
                    <p:nvPr/>
                  </p:nvSpPr>
                  <p:spPr>
                    <a:xfrm>
                      <a:off x="202320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9" name="Line 571"/>
                    <p:cNvSpPr/>
                    <p:nvPr/>
                  </p:nvSpPr>
                  <p:spPr>
                    <a:xfrm>
                      <a:off x="207288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0" name="Line 572"/>
                    <p:cNvSpPr/>
                    <p:nvPr/>
                  </p:nvSpPr>
                  <p:spPr>
                    <a:xfrm>
                      <a:off x="210888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" name="Line 573"/>
                    <p:cNvSpPr/>
                    <p:nvPr/>
                  </p:nvSpPr>
                  <p:spPr>
                    <a:xfrm>
                      <a:off x="2135880" y="223488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" name="Line 574"/>
                    <p:cNvSpPr/>
                    <p:nvPr/>
                  </p:nvSpPr>
                  <p:spPr>
                    <a:xfrm>
                      <a:off x="216324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" name="Line 575"/>
                    <p:cNvSpPr/>
                    <p:nvPr/>
                  </p:nvSpPr>
                  <p:spPr>
                    <a:xfrm>
                      <a:off x="218124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" name="Line 576"/>
                    <p:cNvSpPr/>
                    <p:nvPr/>
                  </p:nvSpPr>
                  <p:spPr>
                    <a:xfrm>
                      <a:off x="219960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" name="Line 577"/>
                    <p:cNvSpPr/>
                    <p:nvPr/>
                  </p:nvSpPr>
                  <p:spPr>
                    <a:xfrm>
                      <a:off x="221292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" name="Line 578"/>
                    <p:cNvSpPr/>
                    <p:nvPr/>
                  </p:nvSpPr>
                  <p:spPr>
                    <a:xfrm>
                      <a:off x="2226960" y="22348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" name="Line 579"/>
                    <p:cNvSpPr/>
                    <p:nvPr/>
                  </p:nvSpPr>
                  <p:spPr>
                    <a:xfrm>
                      <a:off x="231228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" name="Line 580"/>
                    <p:cNvSpPr/>
                    <p:nvPr/>
                  </p:nvSpPr>
                  <p:spPr>
                    <a:xfrm>
                      <a:off x="236664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9" name="Line 581"/>
                    <p:cNvSpPr/>
                    <p:nvPr/>
                  </p:nvSpPr>
                  <p:spPr>
                    <a:xfrm>
                      <a:off x="240264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0" name="Line 582"/>
                    <p:cNvSpPr/>
                    <p:nvPr/>
                  </p:nvSpPr>
                  <p:spPr>
                    <a:xfrm>
                      <a:off x="2430000" y="223488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1" name="Line 583"/>
                    <p:cNvSpPr/>
                    <p:nvPr/>
                  </p:nvSpPr>
                  <p:spPr>
                    <a:xfrm>
                      <a:off x="245304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2" name="Line 584"/>
                    <p:cNvSpPr/>
                    <p:nvPr/>
                  </p:nvSpPr>
                  <p:spPr>
                    <a:xfrm>
                      <a:off x="247536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" name="Line 585"/>
                    <p:cNvSpPr/>
                    <p:nvPr/>
                  </p:nvSpPr>
                  <p:spPr>
                    <a:xfrm>
                      <a:off x="248868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" name="Line 586"/>
                    <p:cNvSpPr/>
                    <p:nvPr/>
                  </p:nvSpPr>
                  <p:spPr>
                    <a:xfrm>
                      <a:off x="250668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" name="Line 587"/>
                    <p:cNvSpPr/>
                    <p:nvPr/>
                  </p:nvSpPr>
                  <p:spPr>
                    <a:xfrm>
                      <a:off x="2520720" y="22348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" name="Line 588"/>
                    <p:cNvSpPr/>
                    <p:nvPr/>
                  </p:nvSpPr>
                  <p:spPr>
                    <a:xfrm>
                      <a:off x="260640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" name="Line 589"/>
                    <p:cNvSpPr/>
                    <p:nvPr/>
                  </p:nvSpPr>
                  <p:spPr>
                    <a:xfrm>
                      <a:off x="266076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" name="Line 590"/>
                    <p:cNvSpPr/>
                    <p:nvPr/>
                  </p:nvSpPr>
                  <p:spPr>
                    <a:xfrm>
                      <a:off x="269712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" name="Line 591"/>
                    <p:cNvSpPr/>
                    <p:nvPr/>
                  </p:nvSpPr>
                  <p:spPr>
                    <a:xfrm>
                      <a:off x="2724120" y="223488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" name="Line 592"/>
                    <p:cNvSpPr/>
                    <p:nvPr/>
                  </p:nvSpPr>
                  <p:spPr>
                    <a:xfrm>
                      <a:off x="274680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1" name="Line 593"/>
                    <p:cNvSpPr/>
                    <p:nvPr/>
                  </p:nvSpPr>
                  <p:spPr>
                    <a:xfrm>
                      <a:off x="276480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" name="Line 594"/>
                    <p:cNvSpPr/>
                    <p:nvPr/>
                  </p:nvSpPr>
                  <p:spPr>
                    <a:xfrm>
                      <a:off x="278280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" name="Line 595"/>
                    <p:cNvSpPr/>
                    <p:nvPr/>
                  </p:nvSpPr>
                  <p:spPr>
                    <a:xfrm>
                      <a:off x="2796480" y="22348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" name="Line 596"/>
                    <p:cNvSpPr/>
                    <p:nvPr/>
                  </p:nvSpPr>
                  <p:spPr>
                    <a:xfrm>
                      <a:off x="2809800" y="22348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85" name="Group 597"/>
                  <p:cNvGrpSpPr/>
                  <p:nvPr/>
                </p:nvGrpSpPr>
                <p:grpSpPr>
                  <a:xfrm>
                    <a:off x="1596960" y="2262960"/>
                    <a:ext cx="1252440" cy="60480"/>
                    <a:chOff x="1596960" y="2262960"/>
                    <a:chExt cx="1252440" cy="60480"/>
                  </a:xfrm>
                </p:grpSpPr>
                <p:sp>
                  <p:nvSpPr>
                    <p:cNvPr id="86" name="Rectangle 598"/>
                    <p:cNvSpPr/>
                    <p:nvPr/>
                  </p:nvSpPr>
                  <p:spPr>
                    <a:xfrm>
                      <a:off x="1596960" y="22773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" name="Rectangle 599"/>
                    <p:cNvSpPr/>
                    <p:nvPr/>
                  </p:nvSpPr>
                  <p:spPr>
                    <a:xfrm>
                      <a:off x="1660680" y="22629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" name="Rectangle 600"/>
                    <p:cNvSpPr/>
                    <p:nvPr/>
                  </p:nvSpPr>
                  <p:spPr>
                    <a:xfrm>
                      <a:off x="1886040" y="22773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" name="Rectangle 601"/>
                    <p:cNvSpPr/>
                    <p:nvPr/>
                  </p:nvSpPr>
                  <p:spPr>
                    <a:xfrm>
                      <a:off x="1949760" y="22629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0" name="Rectangle 602"/>
                    <p:cNvSpPr/>
                    <p:nvPr/>
                  </p:nvSpPr>
                  <p:spPr>
                    <a:xfrm>
                      <a:off x="2179800" y="22773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" name="Rectangle 603"/>
                    <p:cNvSpPr/>
                    <p:nvPr/>
                  </p:nvSpPr>
                  <p:spPr>
                    <a:xfrm>
                      <a:off x="2243880" y="22629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" name="Rectangle 604"/>
                    <p:cNvSpPr/>
                    <p:nvPr/>
                  </p:nvSpPr>
                  <p:spPr>
                    <a:xfrm>
                      <a:off x="2474280" y="22773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" name="Rectangle 605"/>
                    <p:cNvSpPr/>
                    <p:nvPr/>
                  </p:nvSpPr>
                  <p:spPr>
                    <a:xfrm>
                      <a:off x="2538000" y="22629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" name="Rectangle 606"/>
                    <p:cNvSpPr/>
                    <p:nvPr/>
                  </p:nvSpPr>
                  <p:spPr>
                    <a:xfrm>
                      <a:off x="2763360" y="22773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" name="Rectangle 607"/>
                    <p:cNvSpPr/>
                    <p:nvPr/>
                  </p:nvSpPr>
                  <p:spPr>
                    <a:xfrm>
                      <a:off x="2827440" y="22629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96" name="Rectangle 608"/>
                  <p:cNvSpPr/>
                  <p:nvPr/>
                </p:nvSpPr>
                <p:spPr>
                  <a:xfrm>
                    <a:off x="2150280" y="2323800"/>
                    <a:ext cx="1800" cy="3661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97" name="Group 609"/>
                <p:cNvGrpSpPr/>
                <p:nvPr/>
              </p:nvGrpSpPr>
              <p:grpSpPr>
                <a:xfrm>
                  <a:off x="1440000" y="1309320"/>
                  <a:ext cx="203040" cy="942480"/>
                  <a:chOff x="1440000" y="1309320"/>
                  <a:chExt cx="203040" cy="942480"/>
                </a:xfrm>
              </p:grpSpPr>
              <p:sp>
                <p:nvSpPr>
                  <p:cNvPr id="98" name="Line 610"/>
                  <p:cNvSpPr/>
                  <p:nvPr/>
                </p:nvSpPr>
                <p:spPr>
                  <a:xfrm flipV="1">
                    <a:off x="1643040" y="1309320"/>
                    <a:ext cx="0" cy="92124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99" name="Group 611"/>
                  <p:cNvGrpSpPr/>
                  <p:nvPr/>
                </p:nvGrpSpPr>
                <p:grpSpPr>
                  <a:xfrm>
                    <a:off x="1500480" y="1327320"/>
                    <a:ext cx="86400" cy="924480"/>
                    <a:chOff x="1500480" y="1327320"/>
                    <a:chExt cx="86400" cy="924480"/>
                  </a:xfrm>
                </p:grpSpPr>
                <p:sp>
                  <p:nvSpPr>
                    <p:cNvPr id="100" name="Rectangle 612"/>
                    <p:cNvSpPr/>
                    <p:nvPr/>
                  </p:nvSpPr>
                  <p:spPr>
                    <a:xfrm>
                      <a:off x="1564920" y="220572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" name="Rectangle 613"/>
                    <p:cNvSpPr/>
                    <p:nvPr/>
                  </p:nvSpPr>
                  <p:spPr>
                    <a:xfrm>
                      <a:off x="1532520" y="20307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" name="Rectangle 614"/>
                    <p:cNvSpPr/>
                    <p:nvPr/>
                  </p:nvSpPr>
                  <p:spPr>
                    <a:xfrm>
                      <a:off x="1532520" y="18558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" name="Rectangle 615"/>
                    <p:cNvSpPr/>
                    <p:nvPr/>
                  </p:nvSpPr>
                  <p:spPr>
                    <a:xfrm>
                      <a:off x="1532520" y="16768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" name="Rectangle 616"/>
                    <p:cNvSpPr/>
                    <p:nvPr/>
                  </p:nvSpPr>
                  <p:spPr>
                    <a:xfrm>
                      <a:off x="1532520" y="15019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5" name="Rectangle 617"/>
                    <p:cNvSpPr/>
                    <p:nvPr/>
                  </p:nvSpPr>
                  <p:spPr>
                    <a:xfrm>
                      <a:off x="1500480" y="132732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06" name="Group 618"/>
                  <p:cNvGrpSpPr/>
                  <p:nvPr/>
                </p:nvGrpSpPr>
                <p:grpSpPr>
                  <a:xfrm>
                    <a:off x="1616040" y="1352160"/>
                    <a:ext cx="26640" cy="878400"/>
                    <a:chOff x="1616040" y="1352160"/>
                    <a:chExt cx="26640" cy="878400"/>
                  </a:xfrm>
                </p:grpSpPr>
                <p:sp>
                  <p:nvSpPr>
                    <p:cNvPr id="107" name="Line 619"/>
                    <p:cNvSpPr/>
                    <p:nvPr/>
                  </p:nvSpPr>
                  <p:spPr>
                    <a:xfrm flipH="1">
                      <a:off x="1616040" y="223056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8" name="Line 620"/>
                    <p:cNvSpPr/>
                    <p:nvPr/>
                  </p:nvSpPr>
                  <p:spPr>
                    <a:xfrm flipH="1">
                      <a:off x="1633320" y="21877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9" name="Line 621"/>
                    <p:cNvSpPr/>
                    <p:nvPr/>
                  </p:nvSpPr>
                  <p:spPr>
                    <a:xfrm flipH="1">
                      <a:off x="1633320" y="21448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" name="Line 622"/>
                    <p:cNvSpPr/>
                    <p:nvPr/>
                  </p:nvSpPr>
                  <p:spPr>
                    <a:xfrm flipH="1">
                      <a:off x="1633320" y="20988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" name="Line 623"/>
                    <p:cNvSpPr/>
                    <p:nvPr/>
                  </p:nvSpPr>
                  <p:spPr>
                    <a:xfrm flipH="1">
                      <a:off x="1616040" y="205560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" name="Line 624"/>
                    <p:cNvSpPr/>
                    <p:nvPr/>
                  </p:nvSpPr>
                  <p:spPr>
                    <a:xfrm flipH="1">
                      <a:off x="1633320" y="20127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" name="Line 625"/>
                    <p:cNvSpPr/>
                    <p:nvPr/>
                  </p:nvSpPr>
                  <p:spPr>
                    <a:xfrm flipH="1">
                      <a:off x="1633320" y="19663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" name="Line 626"/>
                    <p:cNvSpPr/>
                    <p:nvPr/>
                  </p:nvSpPr>
                  <p:spPr>
                    <a:xfrm flipH="1">
                      <a:off x="1633320" y="19238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" name="Line 627"/>
                    <p:cNvSpPr/>
                    <p:nvPr/>
                  </p:nvSpPr>
                  <p:spPr>
                    <a:xfrm flipH="1">
                      <a:off x="1616040" y="188100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" name="Line 628"/>
                    <p:cNvSpPr/>
                    <p:nvPr/>
                  </p:nvSpPr>
                  <p:spPr>
                    <a:xfrm flipH="1">
                      <a:off x="1633320" y="18342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" name="Line 629"/>
                    <p:cNvSpPr/>
                    <p:nvPr/>
                  </p:nvSpPr>
                  <p:spPr>
                    <a:xfrm flipH="1">
                      <a:off x="1633320" y="17913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8" name="Line 630"/>
                    <p:cNvSpPr/>
                    <p:nvPr/>
                  </p:nvSpPr>
                  <p:spPr>
                    <a:xfrm flipH="1">
                      <a:off x="1633320" y="17485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9" name="Line 631"/>
                    <p:cNvSpPr/>
                    <p:nvPr/>
                  </p:nvSpPr>
                  <p:spPr>
                    <a:xfrm flipH="1">
                      <a:off x="1616040" y="170208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0" name="Line 632"/>
                    <p:cNvSpPr/>
                    <p:nvPr/>
                  </p:nvSpPr>
                  <p:spPr>
                    <a:xfrm flipH="1">
                      <a:off x="1633320" y="16592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1" name="Line 633"/>
                    <p:cNvSpPr/>
                    <p:nvPr/>
                  </p:nvSpPr>
                  <p:spPr>
                    <a:xfrm flipH="1">
                      <a:off x="1633320" y="16164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2" name="Line 634"/>
                    <p:cNvSpPr/>
                    <p:nvPr/>
                  </p:nvSpPr>
                  <p:spPr>
                    <a:xfrm flipH="1">
                      <a:off x="1633320" y="15699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3" name="Line 635"/>
                    <p:cNvSpPr/>
                    <p:nvPr/>
                  </p:nvSpPr>
                  <p:spPr>
                    <a:xfrm flipH="1">
                      <a:off x="1616040" y="152748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4" name="Line 636"/>
                    <p:cNvSpPr/>
                    <p:nvPr/>
                  </p:nvSpPr>
                  <p:spPr>
                    <a:xfrm flipH="1">
                      <a:off x="1633320" y="14842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5" name="Line 637"/>
                    <p:cNvSpPr/>
                    <p:nvPr/>
                  </p:nvSpPr>
                  <p:spPr>
                    <a:xfrm flipH="1">
                      <a:off x="1633320" y="14378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6" name="Line 638"/>
                    <p:cNvSpPr/>
                    <p:nvPr/>
                  </p:nvSpPr>
                  <p:spPr>
                    <a:xfrm flipH="1">
                      <a:off x="1633320" y="13950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27" name="Line 639"/>
                    <p:cNvSpPr/>
                    <p:nvPr/>
                  </p:nvSpPr>
                  <p:spPr>
                    <a:xfrm flipH="1">
                      <a:off x="1616040" y="135216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28" name="Rectangle 640"/>
                  <p:cNvSpPr/>
                  <p:nvPr/>
                </p:nvSpPr>
                <p:spPr>
                  <a:xfrm rot="16200000">
                    <a:off x="1457280" y="1827000"/>
                    <a:ext cx="11520" cy="46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300" spc="-1" strike="noStrike">
                        <a:solidFill>
                          <a:srgbClr val="000000"/>
                        </a:solidFill>
                        <a:latin typeface="Arial"/>
                        <a:ea typeface="ＭＳ Ｐゴシック"/>
                      </a:rPr>
                      <a:t> </a:t>
                    </a:r>
                    <a:endParaRPr b="0" lang="en-US" sz="3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29" name="Group 641"/>
              <p:cNvGrpSpPr/>
              <p:nvPr/>
            </p:nvGrpSpPr>
            <p:grpSpPr>
              <a:xfrm>
                <a:off x="1654200" y="1360440"/>
                <a:ext cx="1152000" cy="871200"/>
                <a:chOff x="1654200" y="1360440"/>
                <a:chExt cx="1152000" cy="871200"/>
              </a:xfrm>
            </p:grpSpPr>
            <p:sp>
              <p:nvSpPr>
                <p:cNvPr id="130" name="Freeform 642"/>
                <p:cNvSpPr/>
                <p:nvPr/>
              </p:nvSpPr>
              <p:spPr>
                <a:xfrm>
                  <a:off x="1654200" y="1360440"/>
                  <a:ext cx="1152000" cy="867600"/>
                </a:xfrm>
                <a:custGeom>
                  <a:avLst/>
                  <a:gdLst>
                    <a:gd name="textAreaLeft" fmla="*/ 0 w 1152000"/>
                    <a:gd name="textAreaRight" fmla="*/ 1152360 w 1152000"/>
                    <a:gd name="textAreaTop" fmla="*/ 0 h 867600"/>
                    <a:gd name="textAreaBottom" fmla="*/ 867960 h 867600"/>
                  </a:gdLst>
                  <a:ahLst/>
                  <a:rect l="textAreaLeft" t="textAreaTop" r="textAreaRight" b="textAreaBottom"/>
                  <a:pathLst>
                    <a:path w="510" h="486">
                      <a:moveTo>
                        <a:pt x="0" y="486"/>
                      </a:moveTo>
                      <a:lnTo>
                        <a:pt x="0" y="380"/>
                      </a:lnTo>
                      <a:lnTo>
                        <a:pt x="0" y="398"/>
                      </a:lnTo>
                      <a:lnTo>
                        <a:pt x="2" y="412"/>
                      </a:lnTo>
                      <a:lnTo>
                        <a:pt x="4" y="412"/>
                      </a:lnTo>
                      <a:lnTo>
                        <a:pt x="6" y="402"/>
                      </a:lnTo>
                      <a:lnTo>
                        <a:pt x="8" y="388"/>
                      </a:lnTo>
                      <a:lnTo>
                        <a:pt x="10" y="368"/>
                      </a:lnTo>
                      <a:lnTo>
                        <a:pt x="12" y="340"/>
                      </a:lnTo>
                      <a:lnTo>
                        <a:pt x="14" y="304"/>
                      </a:lnTo>
                      <a:lnTo>
                        <a:pt x="16" y="264"/>
                      </a:lnTo>
                      <a:lnTo>
                        <a:pt x="18" y="228"/>
                      </a:lnTo>
                      <a:lnTo>
                        <a:pt x="20" y="182"/>
                      </a:lnTo>
                      <a:lnTo>
                        <a:pt x="22" y="110"/>
                      </a:lnTo>
                      <a:lnTo>
                        <a:pt x="24" y="70"/>
                      </a:lnTo>
                      <a:lnTo>
                        <a:pt x="26" y="78"/>
                      </a:lnTo>
                      <a:lnTo>
                        <a:pt x="28" y="52"/>
                      </a:lnTo>
                      <a:lnTo>
                        <a:pt x="30" y="18"/>
                      </a:lnTo>
                      <a:lnTo>
                        <a:pt x="32" y="6"/>
                      </a:lnTo>
                      <a:lnTo>
                        <a:pt x="34" y="0"/>
                      </a:lnTo>
                      <a:lnTo>
                        <a:pt x="36" y="0"/>
                      </a:lnTo>
                      <a:lnTo>
                        <a:pt x="38" y="0"/>
                      </a:lnTo>
                      <a:lnTo>
                        <a:pt x="40" y="18"/>
                      </a:lnTo>
                      <a:lnTo>
                        <a:pt x="42" y="54"/>
                      </a:lnTo>
                      <a:lnTo>
                        <a:pt x="44" y="48"/>
                      </a:lnTo>
                      <a:lnTo>
                        <a:pt x="46" y="24"/>
                      </a:lnTo>
                      <a:lnTo>
                        <a:pt x="48" y="96"/>
                      </a:lnTo>
                      <a:lnTo>
                        <a:pt x="50" y="128"/>
                      </a:lnTo>
                      <a:lnTo>
                        <a:pt x="52" y="96"/>
                      </a:lnTo>
                      <a:lnTo>
                        <a:pt x="54" y="128"/>
                      </a:lnTo>
                      <a:lnTo>
                        <a:pt x="56" y="166"/>
                      </a:lnTo>
                      <a:lnTo>
                        <a:pt x="58" y="174"/>
                      </a:lnTo>
                      <a:lnTo>
                        <a:pt x="60" y="184"/>
                      </a:lnTo>
                      <a:lnTo>
                        <a:pt x="62" y="194"/>
                      </a:lnTo>
                      <a:lnTo>
                        <a:pt x="64" y="210"/>
                      </a:lnTo>
                      <a:lnTo>
                        <a:pt x="66" y="236"/>
                      </a:lnTo>
                      <a:lnTo>
                        <a:pt x="68" y="256"/>
                      </a:lnTo>
                      <a:lnTo>
                        <a:pt x="70" y="264"/>
                      </a:lnTo>
                      <a:lnTo>
                        <a:pt x="72" y="270"/>
                      </a:lnTo>
                      <a:lnTo>
                        <a:pt x="74" y="278"/>
                      </a:lnTo>
                      <a:lnTo>
                        <a:pt x="76" y="292"/>
                      </a:lnTo>
                      <a:lnTo>
                        <a:pt x="78" y="304"/>
                      </a:lnTo>
                      <a:lnTo>
                        <a:pt x="80" y="310"/>
                      </a:lnTo>
                      <a:lnTo>
                        <a:pt x="82" y="316"/>
                      </a:lnTo>
                      <a:lnTo>
                        <a:pt x="84" y="320"/>
                      </a:lnTo>
                      <a:lnTo>
                        <a:pt x="86" y="326"/>
                      </a:lnTo>
                      <a:lnTo>
                        <a:pt x="88" y="336"/>
                      </a:lnTo>
                      <a:lnTo>
                        <a:pt x="90" y="340"/>
                      </a:lnTo>
                      <a:lnTo>
                        <a:pt x="92" y="342"/>
                      </a:lnTo>
                      <a:lnTo>
                        <a:pt x="94" y="350"/>
                      </a:lnTo>
                      <a:lnTo>
                        <a:pt x="96" y="360"/>
                      </a:lnTo>
                      <a:lnTo>
                        <a:pt x="98" y="366"/>
                      </a:lnTo>
                      <a:lnTo>
                        <a:pt x="100" y="368"/>
                      </a:lnTo>
                      <a:lnTo>
                        <a:pt x="102" y="366"/>
                      </a:lnTo>
                      <a:lnTo>
                        <a:pt x="104" y="366"/>
                      </a:lnTo>
                      <a:lnTo>
                        <a:pt x="106" y="372"/>
                      </a:lnTo>
                      <a:lnTo>
                        <a:pt x="108" y="386"/>
                      </a:lnTo>
                      <a:lnTo>
                        <a:pt x="110" y="398"/>
                      </a:lnTo>
                      <a:lnTo>
                        <a:pt x="112" y="404"/>
                      </a:lnTo>
                      <a:lnTo>
                        <a:pt x="114" y="404"/>
                      </a:lnTo>
                      <a:lnTo>
                        <a:pt x="116" y="404"/>
                      </a:lnTo>
                      <a:lnTo>
                        <a:pt x="118" y="410"/>
                      </a:lnTo>
                      <a:lnTo>
                        <a:pt x="120" y="416"/>
                      </a:lnTo>
                      <a:lnTo>
                        <a:pt x="122" y="420"/>
                      </a:lnTo>
                      <a:lnTo>
                        <a:pt x="124" y="422"/>
                      </a:lnTo>
                      <a:lnTo>
                        <a:pt x="126" y="426"/>
                      </a:lnTo>
                      <a:lnTo>
                        <a:pt x="128" y="430"/>
                      </a:lnTo>
                      <a:lnTo>
                        <a:pt x="130" y="434"/>
                      </a:lnTo>
                      <a:lnTo>
                        <a:pt x="132" y="436"/>
                      </a:lnTo>
                      <a:lnTo>
                        <a:pt x="134" y="442"/>
                      </a:lnTo>
                      <a:lnTo>
                        <a:pt x="136" y="448"/>
                      </a:lnTo>
                      <a:lnTo>
                        <a:pt x="138" y="450"/>
                      </a:lnTo>
                      <a:lnTo>
                        <a:pt x="140" y="452"/>
                      </a:lnTo>
                      <a:lnTo>
                        <a:pt x="142" y="454"/>
                      </a:lnTo>
                      <a:lnTo>
                        <a:pt x="144" y="456"/>
                      </a:lnTo>
                      <a:lnTo>
                        <a:pt x="146" y="460"/>
                      </a:lnTo>
                      <a:lnTo>
                        <a:pt x="148" y="464"/>
                      </a:lnTo>
                      <a:lnTo>
                        <a:pt x="150" y="466"/>
                      </a:lnTo>
                      <a:lnTo>
                        <a:pt x="152" y="470"/>
                      </a:lnTo>
                      <a:lnTo>
                        <a:pt x="154" y="472"/>
                      </a:lnTo>
                      <a:lnTo>
                        <a:pt x="156" y="474"/>
                      </a:lnTo>
                      <a:lnTo>
                        <a:pt x="158" y="476"/>
                      </a:lnTo>
                      <a:lnTo>
                        <a:pt x="160" y="478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4"/>
                      </a:lnTo>
                      <a:lnTo>
                        <a:pt x="220" y="484"/>
                      </a:lnTo>
                      <a:lnTo>
                        <a:pt x="222" y="484"/>
                      </a:lnTo>
                      <a:lnTo>
                        <a:pt x="224" y="484"/>
                      </a:lnTo>
                      <a:lnTo>
                        <a:pt x="226" y="484"/>
                      </a:lnTo>
                      <a:lnTo>
                        <a:pt x="228" y="484"/>
                      </a:lnTo>
                      <a:lnTo>
                        <a:pt x="230" y="484"/>
                      </a:lnTo>
                      <a:lnTo>
                        <a:pt x="232" y="484"/>
                      </a:lnTo>
                      <a:lnTo>
                        <a:pt x="234" y="484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6"/>
                      </a:lnTo>
                      <a:lnTo>
                        <a:pt x="266" y="486"/>
                      </a:lnTo>
                      <a:lnTo>
                        <a:pt x="268" y="486"/>
                      </a:lnTo>
                      <a:lnTo>
                        <a:pt x="270" y="486"/>
                      </a:lnTo>
                      <a:lnTo>
                        <a:pt x="272" y="486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4"/>
                      </a:lnTo>
                      <a:lnTo>
                        <a:pt x="298" y="484"/>
                      </a:lnTo>
                      <a:lnTo>
                        <a:pt x="300" y="484"/>
                      </a:lnTo>
                      <a:lnTo>
                        <a:pt x="302" y="484"/>
                      </a:lnTo>
                      <a:lnTo>
                        <a:pt x="304" y="484"/>
                      </a:lnTo>
                      <a:lnTo>
                        <a:pt x="306" y="484"/>
                      </a:lnTo>
                      <a:lnTo>
                        <a:pt x="308" y="484"/>
                      </a:lnTo>
                      <a:lnTo>
                        <a:pt x="310" y="484"/>
                      </a:lnTo>
                      <a:lnTo>
                        <a:pt x="312" y="484"/>
                      </a:lnTo>
                      <a:lnTo>
                        <a:pt x="314" y="484"/>
                      </a:lnTo>
                      <a:lnTo>
                        <a:pt x="316" y="484"/>
                      </a:lnTo>
                      <a:lnTo>
                        <a:pt x="318" y="484"/>
                      </a:lnTo>
                      <a:lnTo>
                        <a:pt x="320" y="484"/>
                      </a:lnTo>
                      <a:lnTo>
                        <a:pt x="322" y="484"/>
                      </a:lnTo>
                      <a:lnTo>
                        <a:pt x="324" y="484"/>
                      </a:lnTo>
                      <a:lnTo>
                        <a:pt x="326" y="484"/>
                      </a:lnTo>
                      <a:lnTo>
                        <a:pt x="328" y="484"/>
                      </a:lnTo>
                      <a:lnTo>
                        <a:pt x="330" y="484"/>
                      </a:lnTo>
                      <a:lnTo>
                        <a:pt x="332" y="484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  <a:lnTo>
                        <a:pt x="510" y="486"/>
                      </a:lnTo>
                      <a:lnTo>
                        <a:pt x="0" y="486"/>
                      </a:lnTo>
                      <a:close/>
                    </a:path>
                  </a:pathLst>
                </a:custGeom>
                <a:solidFill>
                  <a:srgbClr val="e8e8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Freeform 643"/>
                <p:cNvSpPr/>
                <p:nvPr/>
              </p:nvSpPr>
              <p:spPr>
                <a:xfrm>
                  <a:off x="1658520" y="1364040"/>
                  <a:ext cx="1147320" cy="867600"/>
                </a:xfrm>
                <a:custGeom>
                  <a:avLst/>
                  <a:gdLst>
                    <a:gd name="textAreaLeft" fmla="*/ 0 w 1147320"/>
                    <a:gd name="textAreaRight" fmla="*/ 1147680 w 1147320"/>
                    <a:gd name="textAreaTop" fmla="*/ 0 h 867600"/>
                    <a:gd name="textAreaBottom" fmla="*/ 867960 h 867600"/>
                  </a:gdLst>
                  <a:ahLst/>
                  <a:rect l="textAreaLeft" t="textAreaTop" r="textAreaRight" b="textAreaBottom"/>
                  <a:pathLst>
                    <a:path w="508" h="486">
                      <a:moveTo>
                        <a:pt x="0" y="486"/>
                      </a:moveTo>
                      <a:lnTo>
                        <a:pt x="0" y="380"/>
                      </a:lnTo>
                      <a:lnTo>
                        <a:pt x="0" y="398"/>
                      </a:lnTo>
                      <a:lnTo>
                        <a:pt x="2" y="412"/>
                      </a:lnTo>
                      <a:lnTo>
                        <a:pt x="4" y="412"/>
                      </a:lnTo>
                      <a:lnTo>
                        <a:pt x="6" y="402"/>
                      </a:lnTo>
                      <a:lnTo>
                        <a:pt x="8" y="388"/>
                      </a:lnTo>
                      <a:lnTo>
                        <a:pt x="10" y="368"/>
                      </a:lnTo>
                      <a:lnTo>
                        <a:pt x="12" y="340"/>
                      </a:lnTo>
                      <a:lnTo>
                        <a:pt x="14" y="304"/>
                      </a:lnTo>
                      <a:lnTo>
                        <a:pt x="16" y="264"/>
                      </a:lnTo>
                      <a:lnTo>
                        <a:pt x="18" y="228"/>
                      </a:lnTo>
                      <a:lnTo>
                        <a:pt x="20" y="182"/>
                      </a:lnTo>
                      <a:lnTo>
                        <a:pt x="22" y="110"/>
                      </a:lnTo>
                      <a:lnTo>
                        <a:pt x="24" y="70"/>
                      </a:lnTo>
                      <a:lnTo>
                        <a:pt x="26" y="78"/>
                      </a:lnTo>
                      <a:lnTo>
                        <a:pt x="28" y="52"/>
                      </a:lnTo>
                      <a:lnTo>
                        <a:pt x="30" y="18"/>
                      </a:lnTo>
                      <a:lnTo>
                        <a:pt x="32" y="6"/>
                      </a:lnTo>
                      <a:lnTo>
                        <a:pt x="34" y="0"/>
                      </a:lnTo>
                      <a:lnTo>
                        <a:pt x="36" y="0"/>
                      </a:lnTo>
                      <a:lnTo>
                        <a:pt x="38" y="0"/>
                      </a:lnTo>
                      <a:lnTo>
                        <a:pt x="40" y="18"/>
                      </a:lnTo>
                      <a:lnTo>
                        <a:pt x="42" y="54"/>
                      </a:lnTo>
                      <a:lnTo>
                        <a:pt x="44" y="48"/>
                      </a:lnTo>
                      <a:lnTo>
                        <a:pt x="46" y="24"/>
                      </a:lnTo>
                      <a:lnTo>
                        <a:pt x="48" y="96"/>
                      </a:lnTo>
                      <a:lnTo>
                        <a:pt x="50" y="128"/>
                      </a:lnTo>
                      <a:lnTo>
                        <a:pt x="52" y="96"/>
                      </a:lnTo>
                      <a:lnTo>
                        <a:pt x="54" y="128"/>
                      </a:lnTo>
                      <a:lnTo>
                        <a:pt x="56" y="166"/>
                      </a:lnTo>
                      <a:lnTo>
                        <a:pt x="58" y="174"/>
                      </a:lnTo>
                      <a:lnTo>
                        <a:pt x="60" y="184"/>
                      </a:lnTo>
                      <a:lnTo>
                        <a:pt x="62" y="194"/>
                      </a:lnTo>
                      <a:lnTo>
                        <a:pt x="64" y="210"/>
                      </a:lnTo>
                      <a:lnTo>
                        <a:pt x="66" y="236"/>
                      </a:lnTo>
                      <a:lnTo>
                        <a:pt x="68" y="256"/>
                      </a:lnTo>
                      <a:lnTo>
                        <a:pt x="70" y="264"/>
                      </a:lnTo>
                      <a:lnTo>
                        <a:pt x="72" y="270"/>
                      </a:lnTo>
                      <a:lnTo>
                        <a:pt x="74" y="278"/>
                      </a:lnTo>
                      <a:lnTo>
                        <a:pt x="76" y="292"/>
                      </a:lnTo>
                      <a:lnTo>
                        <a:pt x="78" y="304"/>
                      </a:lnTo>
                      <a:lnTo>
                        <a:pt x="80" y="310"/>
                      </a:lnTo>
                      <a:lnTo>
                        <a:pt x="82" y="316"/>
                      </a:lnTo>
                      <a:lnTo>
                        <a:pt x="84" y="320"/>
                      </a:lnTo>
                      <a:lnTo>
                        <a:pt x="86" y="326"/>
                      </a:lnTo>
                      <a:lnTo>
                        <a:pt x="88" y="336"/>
                      </a:lnTo>
                      <a:lnTo>
                        <a:pt x="90" y="340"/>
                      </a:lnTo>
                      <a:lnTo>
                        <a:pt x="92" y="342"/>
                      </a:lnTo>
                      <a:lnTo>
                        <a:pt x="94" y="350"/>
                      </a:lnTo>
                      <a:lnTo>
                        <a:pt x="96" y="360"/>
                      </a:lnTo>
                      <a:lnTo>
                        <a:pt x="98" y="366"/>
                      </a:lnTo>
                      <a:lnTo>
                        <a:pt x="100" y="368"/>
                      </a:lnTo>
                      <a:lnTo>
                        <a:pt x="102" y="366"/>
                      </a:lnTo>
                      <a:lnTo>
                        <a:pt x="104" y="366"/>
                      </a:lnTo>
                      <a:lnTo>
                        <a:pt x="106" y="372"/>
                      </a:lnTo>
                      <a:lnTo>
                        <a:pt x="108" y="386"/>
                      </a:lnTo>
                      <a:lnTo>
                        <a:pt x="110" y="398"/>
                      </a:lnTo>
                      <a:lnTo>
                        <a:pt x="112" y="404"/>
                      </a:lnTo>
                      <a:lnTo>
                        <a:pt x="114" y="404"/>
                      </a:lnTo>
                      <a:lnTo>
                        <a:pt x="116" y="404"/>
                      </a:lnTo>
                      <a:lnTo>
                        <a:pt x="118" y="410"/>
                      </a:lnTo>
                      <a:lnTo>
                        <a:pt x="120" y="416"/>
                      </a:lnTo>
                      <a:lnTo>
                        <a:pt x="122" y="420"/>
                      </a:lnTo>
                      <a:lnTo>
                        <a:pt x="124" y="422"/>
                      </a:lnTo>
                      <a:lnTo>
                        <a:pt x="126" y="426"/>
                      </a:lnTo>
                      <a:lnTo>
                        <a:pt x="128" y="430"/>
                      </a:lnTo>
                      <a:lnTo>
                        <a:pt x="130" y="434"/>
                      </a:lnTo>
                      <a:lnTo>
                        <a:pt x="132" y="436"/>
                      </a:lnTo>
                      <a:lnTo>
                        <a:pt x="134" y="442"/>
                      </a:lnTo>
                      <a:lnTo>
                        <a:pt x="136" y="448"/>
                      </a:lnTo>
                      <a:lnTo>
                        <a:pt x="138" y="450"/>
                      </a:lnTo>
                      <a:lnTo>
                        <a:pt x="140" y="452"/>
                      </a:lnTo>
                      <a:lnTo>
                        <a:pt x="142" y="454"/>
                      </a:lnTo>
                      <a:lnTo>
                        <a:pt x="144" y="456"/>
                      </a:lnTo>
                      <a:lnTo>
                        <a:pt x="146" y="460"/>
                      </a:lnTo>
                      <a:lnTo>
                        <a:pt x="148" y="464"/>
                      </a:lnTo>
                      <a:lnTo>
                        <a:pt x="150" y="466"/>
                      </a:lnTo>
                      <a:lnTo>
                        <a:pt x="152" y="470"/>
                      </a:lnTo>
                      <a:lnTo>
                        <a:pt x="154" y="472"/>
                      </a:lnTo>
                      <a:lnTo>
                        <a:pt x="156" y="474"/>
                      </a:lnTo>
                      <a:lnTo>
                        <a:pt x="158" y="476"/>
                      </a:lnTo>
                      <a:lnTo>
                        <a:pt x="160" y="478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4"/>
                      </a:lnTo>
                      <a:lnTo>
                        <a:pt x="220" y="484"/>
                      </a:lnTo>
                      <a:lnTo>
                        <a:pt x="222" y="484"/>
                      </a:lnTo>
                      <a:lnTo>
                        <a:pt x="224" y="484"/>
                      </a:lnTo>
                      <a:lnTo>
                        <a:pt x="226" y="484"/>
                      </a:lnTo>
                      <a:lnTo>
                        <a:pt x="228" y="484"/>
                      </a:lnTo>
                      <a:lnTo>
                        <a:pt x="230" y="484"/>
                      </a:lnTo>
                      <a:lnTo>
                        <a:pt x="232" y="484"/>
                      </a:lnTo>
                      <a:lnTo>
                        <a:pt x="234" y="484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6"/>
                      </a:lnTo>
                      <a:lnTo>
                        <a:pt x="266" y="486"/>
                      </a:lnTo>
                      <a:lnTo>
                        <a:pt x="268" y="486"/>
                      </a:lnTo>
                      <a:lnTo>
                        <a:pt x="270" y="486"/>
                      </a:lnTo>
                      <a:lnTo>
                        <a:pt x="272" y="486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4"/>
                      </a:lnTo>
                      <a:lnTo>
                        <a:pt x="298" y="484"/>
                      </a:lnTo>
                      <a:lnTo>
                        <a:pt x="300" y="484"/>
                      </a:lnTo>
                      <a:lnTo>
                        <a:pt x="302" y="484"/>
                      </a:lnTo>
                      <a:lnTo>
                        <a:pt x="304" y="484"/>
                      </a:lnTo>
                      <a:lnTo>
                        <a:pt x="306" y="484"/>
                      </a:lnTo>
                      <a:lnTo>
                        <a:pt x="308" y="484"/>
                      </a:lnTo>
                      <a:lnTo>
                        <a:pt x="310" y="484"/>
                      </a:lnTo>
                      <a:lnTo>
                        <a:pt x="312" y="484"/>
                      </a:lnTo>
                      <a:lnTo>
                        <a:pt x="314" y="484"/>
                      </a:lnTo>
                      <a:lnTo>
                        <a:pt x="316" y="484"/>
                      </a:lnTo>
                      <a:lnTo>
                        <a:pt x="318" y="484"/>
                      </a:lnTo>
                      <a:lnTo>
                        <a:pt x="320" y="484"/>
                      </a:lnTo>
                      <a:lnTo>
                        <a:pt x="322" y="484"/>
                      </a:lnTo>
                      <a:lnTo>
                        <a:pt x="324" y="484"/>
                      </a:lnTo>
                      <a:lnTo>
                        <a:pt x="326" y="484"/>
                      </a:lnTo>
                      <a:lnTo>
                        <a:pt x="328" y="484"/>
                      </a:lnTo>
                      <a:lnTo>
                        <a:pt x="330" y="484"/>
                      </a:lnTo>
                      <a:lnTo>
                        <a:pt x="332" y="484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</a:path>
                  </a:pathLst>
                </a:custGeom>
                <a:noFill/>
                <a:ln w="6480">
                  <a:solidFill>
                    <a:srgbClr val="b3b3b3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32" name="Freeform 644"/>
              <p:cNvSpPr/>
              <p:nvPr/>
            </p:nvSpPr>
            <p:spPr>
              <a:xfrm>
                <a:off x="1658880" y="1363680"/>
                <a:ext cx="1147680" cy="868320"/>
              </a:xfrm>
              <a:custGeom>
                <a:avLst/>
                <a:gdLst>
                  <a:gd name="textAreaLeft" fmla="*/ 0 w 1147680"/>
                  <a:gd name="textAreaRight" fmla="*/ 1148040 w 1147680"/>
                  <a:gd name="textAreaTop" fmla="*/ 0 h 868320"/>
                  <a:gd name="textAreaBottom" fmla="*/ 868680 h 86832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0" y="484"/>
                    </a:lnTo>
                    <a:lnTo>
                      <a:pt x="2" y="484"/>
                    </a:lnTo>
                    <a:lnTo>
                      <a:pt x="4" y="484"/>
                    </a:lnTo>
                    <a:lnTo>
                      <a:pt x="6" y="484"/>
                    </a:lnTo>
                    <a:lnTo>
                      <a:pt x="8" y="484"/>
                    </a:lnTo>
                    <a:lnTo>
                      <a:pt x="10" y="484"/>
                    </a:lnTo>
                    <a:lnTo>
                      <a:pt x="12" y="484"/>
                    </a:lnTo>
                    <a:lnTo>
                      <a:pt x="14" y="484"/>
                    </a:lnTo>
                    <a:lnTo>
                      <a:pt x="16" y="484"/>
                    </a:lnTo>
                    <a:lnTo>
                      <a:pt x="18" y="484"/>
                    </a:lnTo>
                    <a:lnTo>
                      <a:pt x="20" y="484"/>
                    </a:lnTo>
                    <a:lnTo>
                      <a:pt x="22" y="482"/>
                    </a:lnTo>
                    <a:lnTo>
                      <a:pt x="24" y="482"/>
                    </a:lnTo>
                    <a:lnTo>
                      <a:pt x="26" y="484"/>
                    </a:lnTo>
                    <a:lnTo>
                      <a:pt x="28" y="484"/>
                    </a:lnTo>
                    <a:lnTo>
                      <a:pt x="30" y="484"/>
                    </a:lnTo>
                    <a:lnTo>
                      <a:pt x="32" y="484"/>
                    </a:lnTo>
                    <a:lnTo>
                      <a:pt x="34" y="482"/>
                    </a:lnTo>
                    <a:lnTo>
                      <a:pt x="36" y="482"/>
                    </a:lnTo>
                    <a:lnTo>
                      <a:pt x="38" y="482"/>
                    </a:lnTo>
                    <a:lnTo>
                      <a:pt x="40" y="482"/>
                    </a:lnTo>
                    <a:lnTo>
                      <a:pt x="42" y="482"/>
                    </a:lnTo>
                    <a:lnTo>
                      <a:pt x="44" y="482"/>
                    </a:lnTo>
                    <a:lnTo>
                      <a:pt x="46" y="482"/>
                    </a:lnTo>
                    <a:lnTo>
                      <a:pt x="48" y="482"/>
                    </a:lnTo>
                    <a:lnTo>
                      <a:pt x="50" y="482"/>
                    </a:lnTo>
                    <a:lnTo>
                      <a:pt x="52" y="482"/>
                    </a:lnTo>
                    <a:lnTo>
                      <a:pt x="54" y="482"/>
                    </a:lnTo>
                    <a:lnTo>
                      <a:pt x="56" y="482"/>
                    </a:lnTo>
                    <a:lnTo>
                      <a:pt x="58" y="482"/>
                    </a:lnTo>
                    <a:lnTo>
                      <a:pt x="60" y="482"/>
                    </a:lnTo>
                    <a:lnTo>
                      <a:pt x="62" y="480"/>
                    </a:lnTo>
                    <a:lnTo>
                      <a:pt x="64" y="480"/>
                    </a:lnTo>
                    <a:lnTo>
                      <a:pt x="66" y="482"/>
                    </a:lnTo>
                    <a:lnTo>
                      <a:pt x="68" y="482"/>
                    </a:lnTo>
                    <a:lnTo>
                      <a:pt x="70" y="482"/>
                    </a:lnTo>
                    <a:lnTo>
                      <a:pt x="72" y="482"/>
                    </a:lnTo>
                    <a:lnTo>
                      <a:pt x="74" y="482"/>
                    </a:lnTo>
                    <a:lnTo>
                      <a:pt x="76" y="482"/>
                    </a:lnTo>
                    <a:lnTo>
                      <a:pt x="78" y="482"/>
                    </a:lnTo>
                    <a:lnTo>
                      <a:pt x="80" y="480"/>
                    </a:lnTo>
                    <a:lnTo>
                      <a:pt x="82" y="480"/>
                    </a:lnTo>
                    <a:lnTo>
                      <a:pt x="84" y="480"/>
                    </a:lnTo>
                    <a:lnTo>
                      <a:pt x="86" y="480"/>
                    </a:lnTo>
                    <a:lnTo>
                      <a:pt x="88" y="478"/>
                    </a:lnTo>
                    <a:lnTo>
                      <a:pt x="90" y="478"/>
                    </a:lnTo>
                    <a:lnTo>
                      <a:pt x="92" y="478"/>
                    </a:lnTo>
                    <a:lnTo>
                      <a:pt x="94" y="478"/>
                    </a:lnTo>
                    <a:lnTo>
                      <a:pt x="96" y="478"/>
                    </a:lnTo>
                    <a:lnTo>
                      <a:pt x="98" y="478"/>
                    </a:lnTo>
                    <a:lnTo>
                      <a:pt x="100" y="476"/>
                    </a:lnTo>
                    <a:lnTo>
                      <a:pt x="102" y="476"/>
                    </a:lnTo>
                    <a:lnTo>
                      <a:pt x="104" y="472"/>
                    </a:lnTo>
                    <a:lnTo>
                      <a:pt x="106" y="468"/>
                    </a:lnTo>
                    <a:lnTo>
                      <a:pt x="108" y="464"/>
                    </a:lnTo>
                    <a:lnTo>
                      <a:pt x="110" y="458"/>
                    </a:lnTo>
                    <a:lnTo>
                      <a:pt x="112" y="454"/>
                    </a:lnTo>
                    <a:lnTo>
                      <a:pt x="114" y="448"/>
                    </a:lnTo>
                    <a:lnTo>
                      <a:pt x="116" y="444"/>
                    </a:lnTo>
                    <a:lnTo>
                      <a:pt x="118" y="438"/>
                    </a:lnTo>
                    <a:lnTo>
                      <a:pt x="120" y="432"/>
                    </a:lnTo>
                    <a:lnTo>
                      <a:pt x="122" y="428"/>
                    </a:lnTo>
                    <a:lnTo>
                      <a:pt x="124" y="422"/>
                    </a:lnTo>
                    <a:lnTo>
                      <a:pt x="126" y="414"/>
                    </a:lnTo>
                    <a:lnTo>
                      <a:pt x="128" y="406"/>
                    </a:lnTo>
                    <a:lnTo>
                      <a:pt x="130" y="398"/>
                    </a:lnTo>
                    <a:lnTo>
                      <a:pt x="132" y="392"/>
                    </a:lnTo>
                    <a:lnTo>
                      <a:pt x="134" y="384"/>
                    </a:lnTo>
                    <a:lnTo>
                      <a:pt x="136" y="370"/>
                    </a:lnTo>
                    <a:lnTo>
                      <a:pt x="138" y="358"/>
                    </a:lnTo>
                    <a:lnTo>
                      <a:pt x="140" y="348"/>
                    </a:lnTo>
                    <a:lnTo>
                      <a:pt x="142" y="330"/>
                    </a:lnTo>
                    <a:lnTo>
                      <a:pt x="144" y="310"/>
                    </a:lnTo>
                    <a:lnTo>
                      <a:pt x="146" y="302"/>
                    </a:lnTo>
                    <a:lnTo>
                      <a:pt x="148" y="304"/>
                    </a:lnTo>
                    <a:lnTo>
                      <a:pt x="150" y="298"/>
                    </a:lnTo>
                    <a:lnTo>
                      <a:pt x="152" y="278"/>
                    </a:lnTo>
                    <a:lnTo>
                      <a:pt x="154" y="248"/>
                    </a:lnTo>
                    <a:lnTo>
                      <a:pt x="156" y="228"/>
                    </a:lnTo>
                    <a:lnTo>
                      <a:pt x="158" y="222"/>
                    </a:lnTo>
                    <a:lnTo>
                      <a:pt x="160" y="228"/>
                    </a:lnTo>
                    <a:lnTo>
                      <a:pt x="162" y="226"/>
                    </a:lnTo>
                    <a:lnTo>
                      <a:pt x="164" y="198"/>
                    </a:lnTo>
                    <a:lnTo>
                      <a:pt x="166" y="178"/>
                    </a:lnTo>
                    <a:lnTo>
                      <a:pt x="168" y="184"/>
                    </a:lnTo>
                    <a:lnTo>
                      <a:pt x="170" y="178"/>
                    </a:lnTo>
                    <a:lnTo>
                      <a:pt x="172" y="152"/>
                    </a:lnTo>
                    <a:lnTo>
                      <a:pt x="174" y="128"/>
                    </a:lnTo>
                    <a:lnTo>
                      <a:pt x="176" y="112"/>
                    </a:lnTo>
                    <a:lnTo>
                      <a:pt x="178" y="118"/>
                    </a:lnTo>
                    <a:lnTo>
                      <a:pt x="180" y="114"/>
                    </a:lnTo>
                    <a:lnTo>
                      <a:pt x="182" y="98"/>
                    </a:lnTo>
                    <a:lnTo>
                      <a:pt x="184" y="96"/>
                    </a:lnTo>
                    <a:lnTo>
                      <a:pt x="186" y="98"/>
                    </a:lnTo>
                    <a:lnTo>
                      <a:pt x="188" y="72"/>
                    </a:lnTo>
                    <a:lnTo>
                      <a:pt x="190" y="52"/>
                    </a:lnTo>
                    <a:lnTo>
                      <a:pt x="192" y="46"/>
                    </a:lnTo>
                    <a:lnTo>
                      <a:pt x="194" y="26"/>
                    </a:lnTo>
                    <a:lnTo>
                      <a:pt x="196" y="2"/>
                    </a:lnTo>
                    <a:lnTo>
                      <a:pt x="198" y="0"/>
                    </a:lnTo>
                    <a:lnTo>
                      <a:pt x="200" y="26"/>
                    </a:lnTo>
                    <a:lnTo>
                      <a:pt x="202" y="56"/>
                    </a:lnTo>
                    <a:lnTo>
                      <a:pt x="204" y="46"/>
                    </a:lnTo>
                    <a:lnTo>
                      <a:pt x="206" y="28"/>
                    </a:lnTo>
                    <a:lnTo>
                      <a:pt x="208" y="36"/>
                    </a:lnTo>
                    <a:lnTo>
                      <a:pt x="210" y="52"/>
                    </a:lnTo>
                    <a:lnTo>
                      <a:pt x="212" y="60"/>
                    </a:lnTo>
                    <a:lnTo>
                      <a:pt x="214" y="62"/>
                    </a:lnTo>
                    <a:lnTo>
                      <a:pt x="216" y="60"/>
                    </a:lnTo>
                    <a:lnTo>
                      <a:pt x="218" y="86"/>
                    </a:lnTo>
                    <a:lnTo>
                      <a:pt x="220" y="114"/>
                    </a:lnTo>
                    <a:lnTo>
                      <a:pt x="222" y="128"/>
                    </a:lnTo>
                    <a:lnTo>
                      <a:pt x="224" y="130"/>
                    </a:lnTo>
                    <a:lnTo>
                      <a:pt x="226" y="132"/>
                    </a:lnTo>
                    <a:lnTo>
                      <a:pt x="228" y="140"/>
                    </a:lnTo>
                    <a:lnTo>
                      <a:pt x="230" y="158"/>
                    </a:lnTo>
                    <a:lnTo>
                      <a:pt x="232" y="176"/>
                    </a:lnTo>
                    <a:lnTo>
                      <a:pt x="234" y="196"/>
                    </a:lnTo>
                    <a:lnTo>
                      <a:pt x="236" y="208"/>
                    </a:lnTo>
                    <a:lnTo>
                      <a:pt x="238" y="216"/>
                    </a:lnTo>
                    <a:lnTo>
                      <a:pt x="240" y="222"/>
                    </a:lnTo>
                    <a:lnTo>
                      <a:pt x="242" y="218"/>
                    </a:lnTo>
                    <a:lnTo>
                      <a:pt x="244" y="208"/>
                    </a:lnTo>
                    <a:lnTo>
                      <a:pt x="246" y="218"/>
                    </a:lnTo>
                    <a:lnTo>
                      <a:pt x="248" y="234"/>
                    </a:lnTo>
                    <a:lnTo>
                      <a:pt x="250" y="242"/>
                    </a:lnTo>
                    <a:lnTo>
                      <a:pt x="252" y="254"/>
                    </a:lnTo>
                    <a:lnTo>
                      <a:pt x="254" y="274"/>
                    </a:lnTo>
                    <a:lnTo>
                      <a:pt x="256" y="292"/>
                    </a:lnTo>
                    <a:lnTo>
                      <a:pt x="258" y="300"/>
                    </a:lnTo>
                    <a:lnTo>
                      <a:pt x="260" y="310"/>
                    </a:lnTo>
                    <a:lnTo>
                      <a:pt x="262" y="322"/>
                    </a:lnTo>
                    <a:lnTo>
                      <a:pt x="264" y="324"/>
                    </a:lnTo>
                    <a:lnTo>
                      <a:pt x="266" y="308"/>
                    </a:lnTo>
                    <a:lnTo>
                      <a:pt x="268" y="292"/>
                    </a:lnTo>
                    <a:lnTo>
                      <a:pt x="270" y="292"/>
                    </a:lnTo>
                    <a:lnTo>
                      <a:pt x="272" y="298"/>
                    </a:lnTo>
                    <a:lnTo>
                      <a:pt x="274" y="302"/>
                    </a:lnTo>
                    <a:lnTo>
                      <a:pt x="276" y="308"/>
                    </a:lnTo>
                    <a:lnTo>
                      <a:pt x="278" y="310"/>
                    </a:lnTo>
                    <a:lnTo>
                      <a:pt x="280" y="300"/>
                    </a:lnTo>
                    <a:lnTo>
                      <a:pt x="282" y="292"/>
                    </a:lnTo>
                    <a:lnTo>
                      <a:pt x="284" y="300"/>
                    </a:lnTo>
                    <a:lnTo>
                      <a:pt x="286" y="318"/>
                    </a:lnTo>
                    <a:lnTo>
                      <a:pt x="288" y="322"/>
                    </a:lnTo>
                    <a:lnTo>
                      <a:pt x="290" y="312"/>
                    </a:lnTo>
                    <a:lnTo>
                      <a:pt x="292" y="308"/>
                    </a:lnTo>
                    <a:lnTo>
                      <a:pt x="294" y="312"/>
                    </a:lnTo>
                    <a:lnTo>
                      <a:pt x="296" y="312"/>
                    </a:lnTo>
                    <a:lnTo>
                      <a:pt x="298" y="306"/>
                    </a:lnTo>
                    <a:lnTo>
                      <a:pt x="300" y="302"/>
                    </a:lnTo>
                    <a:lnTo>
                      <a:pt x="302" y="302"/>
                    </a:lnTo>
                    <a:lnTo>
                      <a:pt x="304" y="298"/>
                    </a:lnTo>
                    <a:lnTo>
                      <a:pt x="306" y="292"/>
                    </a:lnTo>
                    <a:lnTo>
                      <a:pt x="308" y="288"/>
                    </a:lnTo>
                    <a:lnTo>
                      <a:pt x="310" y="294"/>
                    </a:lnTo>
                    <a:lnTo>
                      <a:pt x="312" y="306"/>
                    </a:lnTo>
                    <a:lnTo>
                      <a:pt x="314" y="312"/>
                    </a:lnTo>
                    <a:lnTo>
                      <a:pt x="316" y="310"/>
                    </a:lnTo>
                    <a:lnTo>
                      <a:pt x="318" y="306"/>
                    </a:lnTo>
                    <a:lnTo>
                      <a:pt x="320" y="304"/>
                    </a:lnTo>
                    <a:lnTo>
                      <a:pt x="322" y="306"/>
                    </a:lnTo>
                    <a:lnTo>
                      <a:pt x="324" y="316"/>
                    </a:lnTo>
                    <a:lnTo>
                      <a:pt x="326" y="332"/>
                    </a:lnTo>
                    <a:lnTo>
                      <a:pt x="328" y="340"/>
                    </a:lnTo>
                    <a:lnTo>
                      <a:pt x="330" y="338"/>
                    </a:lnTo>
                    <a:lnTo>
                      <a:pt x="332" y="332"/>
                    </a:lnTo>
                    <a:lnTo>
                      <a:pt x="334" y="334"/>
                    </a:lnTo>
                    <a:lnTo>
                      <a:pt x="336" y="344"/>
                    </a:lnTo>
                    <a:lnTo>
                      <a:pt x="338" y="354"/>
                    </a:lnTo>
                    <a:lnTo>
                      <a:pt x="340" y="362"/>
                    </a:lnTo>
                    <a:lnTo>
                      <a:pt x="342" y="366"/>
                    </a:lnTo>
                    <a:lnTo>
                      <a:pt x="344" y="374"/>
                    </a:lnTo>
                    <a:lnTo>
                      <a:pt x="346" y="380"/>
                    </a:lnTo>
                    <a:lnTo>
                      <a:pt x="348" y="384"/>
                    </a:lnTo>
                    <a:lnTo>
                      <a:pt x="350" y="386"/>
                    </a:lnTo>
                    <a:lnTo>
                      <a:pt x="352" y="390"/>
                    </a:lnTo>
                    <a:lnTo>
                      <a:pt x="354" y="398"/>
                    </a:lnTo>
                    <a:lnTo>
                      <a:pt x="356" y="406"/>
                    </a:lnTo>
                    <a:lnTo>
                      <a:pt x="358" y="414"/>
                    </a:lnTo>
                    <a:lnTo>
                      <a:pt x="360" y="420"/>
                    </a:lnTo>
                    <a:lnTo>
                      <a:pt x="362" y="422"/>
                    </a:lnTo>
                    <a:lnTo>
                      <a:pt x="364" y="426"/>
                    </a:lnTo>
                    <a:lnTo>
                      <a:pt x="366" y="432"/>
                    </a:lnTo>
                    <a:lnTo>
                      <a:pt x="368" y="440"/>
                    </a:lnTo>
                    <a:lnTo>
                      <a:pt x="370" y="446"/>
                    </a:lnTo>
                    <a:lnTo>
                      <a:pt x="372" y="448"/>
                    </a:lnTo>
                    <a:lnTo>
                      <a:pt x="374" y="452"/>
                    </a:lnTo>
                    <a:lnTo>
                      <a:pt x="376" y="454"/>
                    </a:lnTo>
                    <a:lnTo>
                      <a:pt x="378" y="456"/>
                    </a:lnTo>
                    <a:lnTo>
                      <a:pt x="380" y="458"/>
                    </a:lnTo>
                    <a:lnTo>
                      <a:pt x="382" y="462"/>
                    </a:lnTo>
                    <a:lnTo>
                      <a:pt x="384" y="464"/>
                    </a:lnTo>
                    <a:lnTo>
                      <a:pt x="386" y="466"/>
                    </a:lnTo>
                    <a:lnTo>
                      <a:pt x="388" y="470"/>
                    </a:lnTo>
                    <a:lnTo>
                      <a:pt x="390" y="470"/>
                    </a:lnTo>
                    <a:lnTo>
                      <a:pt x="392" y="472"/>
                    </a:lnTo>
                    <a:lnTo>
                      <a:pt x="394" y="472"/>
                    </a:lnTo>
                    <a:lnTo>
                      <a:pt x="396" y="474"/>
                    </a:lnTo>
                    <a:lnTo>
                      <a:pt x="398" y="476"/>
                    </a:lnTo>
                    <a:lnTo>
                      <a:pt x="400" y="478"/>
                    </a:lnTo>
                    <a:lnTo>
                      <a:pt x="402" y="478"/>
                    </a:lnTo>
                    <a:lnTo>
                      <a:pt x="404" y="480"/>
                    </a:lnTo>
                    <a:lnTo>
                      <a:pt x="406" y="482"/>
                    </a:lnTo>
                    <a:lnTo>
                      <a:pt x="408" y="482"/>
                    </a:lnTo>
                    <a:lnTo>
                      <a:pt x="410" y="482"/>
                    </a:lnTo>
                    <a:lnTo>
                      <a:pt x="412" y="484"/>
                    </a:lnTo>
                    <a:lnTo>
                      <a:pt x="414" y="484"/>
                    </a:lnTo>
                    <a:lnTo>
                      <a:pt x="416" y="484"/>
                    </a:lnTo>
                    <a:lnTo>
                      <a:pt x="418" y="484"/>
                    </a:lnTo>
                    <a:lnTo>
                      <a:pt x="420" y="484"/>
                    </a:lnTo>
                    <a:lnTo>
                      <a:pt x="422" y="484"/>
                    </a:lnTo>
                    <a:lnTo>
                      <a:pt x="424" y="484"/>
                    </a:lnTo>
                    <a:lnTo>
                      <a:pt x="426" y="484"/>
                    </a:lnTo>
                    <a:lnTo>
                      <a:pt x="428" y="484"/>
                    </a:lnTo>
                    <a:lnTo>
                      <a:pt x="430" y="484"/>
                    </a:lnTo>
                    <a:lnTo>
                      <a:pt x="432" y="484"/>
                    </a:lnTo>
                    <a:lnTo>
                      <a:pt x="434" y="484"/>
                    </a:lnTo>
                    <a:lnTo>
                      <a:pt x="436" y="484"/>
                    </a:lnTo>
                    <a:lnTo>
                      <a:pt x="438" y="484"/>
                    </a:lnTo>
                    <a:lnTo>
                      <a:pt x="440" y="484"/>
                    </a:lnTo>
                    <a:lnTo>
                      <a:pt x="442" y="484"/>
                    </a:lnTo>
                    <a:lnTo>
                      <a:pt x="444" y="484"/>
                    </a:lnTo>
                    <a:lnTo>
                      <a:pt x="446" y="484"/>
                    </a:lnTo>
                    <a:lnTo>
                      <a:pt x="448" y="484"/>
                    </a:lnTo>
                    <a:lnTo>
                      <a:pt x="450" y="484"/>
                    </a:lnTo>
                    <a:lnTo>
                      <a:pt x="452" y="484"/>
                    </a:lnTo>
                    <a:lnTo>
                      <a:pt x="454" y="484"/>
                    </a:lnTo>
                    <a:lnTo>
                      <a:pt x="456" y="484"/>
                    </a:lnTo>
                    <a:lnTo>
                      <a:pt x="458" y="484"/>
                    </a:lnTo>
                    <a:lnTo>
                      <a:pt x="460" y="484"/>
                    </a:lnTo>
                    <a:lnTo>
                      <a:pt x="462" y="484"/>
                    </a:lnTo>
                    <a:lnTo>
                      <a:pt x="464" y="484"/>
                    </a:lnTo>
                    <a:lnTo>
                      <a:pt x="466" y="484"/>
                    </a:lnTo>
                    <a:lnTo>
                      <a:pt x="468" y="484"/>
                    </a:lnTo>
                    <a:lnTo>
                      <a:pt x="470" y="484"/>
                    </a:lnTo>
                    <a:lnTo>
                      <a:pt x="472" y="484"/>
                    </a:lnTo>
                    <a:lnTo>
                      <a:pt x="474" y="484"/>
                    </a:lnTo>
                    <a:lnTo>
                      <a:pt x="476" y="484"/>
                    </a:lnTo>
                    <a:lnTo>
                      <a:pt x="478" y="484"/>
                    </a:lnTo>
                    <a:lnTo>
                      <a:pt x="480" y="484"/>
                    </a:lnTo>
                    <a:lnTo>
                      <a:pt x="482" y="486"/>
                    </a:lnTo>
                    <a:lnTo>
                      <a:pt x="484" y="486"/>
                    </a:lnTo>
                    <a:lnTo>
                      <a:pt x="486" y="484"/>
                    </a:lnTo>
                    <a:lnTo>
                      <a:pt x="488" y="484"/>
                    </a:lnTo>
                    <a:lnTo>
                      <a:pt x="490" y="484"/>
                    </a:lnTo>
                    <a:lnTo>
                      <a:pt x="492" y="484"/>
                    </a:lnTo>
                    <a:lnTo>
                      <a:pt x="494" y="484"/>
                    </a:lnTo>
                    <a:lnTo>
                      <a:pt x="496" y="484"/>
                    </a:lnTo>
                    <a:lnTo>
                      <a:pt x="498" y="484"/>
                    </a:lnTo>
                    <a:lnTo>
                      <a:pt x="500" y="484"/>
                    </a:lnTo>
                    <a:lnTo>
                      <a:pt x="502" y="484"/>
                    </a:lnTo>
                    <a:lnTo>
                      <a:pt x="504" y="484"/>
                    </a:lnTo>
                    <a:lnTo>
                      <a:pt x="506" y="484"/>
                    </a:lnTo>
                    <a:lnTo>
                      <a:pt x="508" y="484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3" name="Text Box 645"/>
            <p:cNvSpPr/>
            <p:nvPr/>
          </p:nvSpPr>
          <p:spPr>
            <a:xfrm>
              <a:off x="2208240" y="130320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93.4/12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4" name="Group 3864"/>
          <p:cNvGrpSpPr/>
          <p:nvPr/>
        </p:nvGrpSpPr>
        <p:grpSpPr>
          <a:xfrm>
            <a:off x="3936960" y="1301760"/>
            <a:ext cx="1430280" cy="1387800"/>
            <a:chOff x="3936960" y="1301760"/>
            <a:chExt cx="1430280" cy="1387800"/>
          </a:xfrm>
        </p:grpSpPr>
        <p:grpSp>
          <p:nvGrpSpPr>
            <p:cNvPr id="135" name="Group 3855"/>
            <p:cNvGrpSpPr/>
            <p:nvPr/>
          </p:nvGrpSpPr>
          <p:grpSpPr>
            <a:xfrm>
              <a:off x="3936960" y="1307520"/>
              <a:ext cx="1406160" cy="1382040"/>
              <a:chOff x="3936960" y="1307520"/>
              <a:chExt cx="1406160" cy="1382040"/>
            </a:xfrm>
          </p:grpSpPr>
          <p:grpSp>
            <p:nvGrpSpPr>
              <p:cNvPr id="136" name="Group 464"/>
              <p:cNvGrpSpPr/>
              <p:nvPr/>
            </p:nvGrpSpPr>
            <p:grpSpPr>
              <a:xfrm>
                <a:off x="3936960" y="1307520"/>
                <a:ext cx="1406160" cy="1382040"/>
                <a:chOff x="3936960" y="1307520"/>
                <a:chExt cx="1406160" cy="1382040"/>
              </a:xfrm>
            </p:grpSpPr>
            <p:sp>
              <p:nvSpPr>
                <p:cNvPr id="137" name="Rectangle 465"/>
                <p:cNvSpPr/>
                <p:nvPr/>
              </p:nvSpPr>
              <p:spPr>
                <a:xfrm>
                  <a:off x="4140360" y="1309320"/>
                  <a:ext cx="1166760" cy="92376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38" name="Group 466"/>
                <p:cNvGrpSpPr/>
                <p:nvPr/>
              </p:nvGrpSpPr>
              <p:grpSpPr>
                <a:xfrm>
                  <a:off x="4091760" y="2231640"/>
                  <a:ext cx="1251360" cy="457920"/>
                  <a:chOff x="4091760" y="2231640"/>
                  <a:chExt cx="1251360" cy="457920"/>
                </a:xfrm>
              </p:grpSpPr>
              <p:sp>
                <p:nvSpPr>
                  <p:cNvPr id="139" name="Line 467"/>
                  <p:cNvSpPr/>
                  <p:nvPr/>
                </p:nvSpPr>
                <p:spPr>
                  <a:xfrm>
                    <a:off x="4138200" y="2231640"/>
                    <a:ext cx="116604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40" name="Group 468"/>
                  <p:cNvGrpSpPr/>
                  <p:nvPr/>
                </p:nvGrpSpPr>
                <p:grpSpPr>
                  <a:xfrm>
                    <a:off x="4138200" y="2235240"/>
                    <a:ext cx="1165680" cy="20880"/>
                    <a:chOff x="4138200" y="2235240"/>
                    <a:chExt cx="1165680" cy="20880"/>
                  </a:xfrm>
                </p:grpSpPr>
                <p:sp>
                  <p:nvSpPr>
                    <p:cNvPr id="141" name="Line 469"/>
                    <p:cNvSpPr/>
                    <p:nvPr/>
                  </p:nvSpPr>
                  <p:spPr>
                    <a:xfrm>
                      <a:off x="4138200" y="223524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2" name="Line 470"/>
                    <p:cNvSpPr/>
                    <p:nvPr/>
                  </p:nvSpPr>
                  <p:spPr>
                    <a:xfrm>
                      <a:off x="422352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3" name="Line 471"/>
                    <p:cNvSpPr/>
                    <p:nvPr/>
                  </p:nvSpPr>
                  <p:spPr>
                    <a:xfrm>
                      <a:off x="427320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4" name="Line 472"/>
                    <p:cNvSpPr/>
                    <p:nvPr/>
                  </p:nvSpPr>
                  <p:spPr>
                    <a:xfrm>
                      <a:off x="430956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5" name="Line 473"/>
                    <p:cNvSpPr/>
                    <p:nvPr/>
                  </p:nvSpPr>
                  <p:spPr>
                    <a:xfrm>
                      <a:off x="4341600" y="223524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6" name="Line 474"/>
                    <p:cNvSpPr/>
                    <p:nvPr/>
                  </p:nvSpPr>
                  <p:spPr>
                    <a:xfrm>
                      <a:off x="436392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7" name="Line 475"/>
                    <p:cNvSpPr/>
                    <p:nvPr/>
                  </p:nvSpPr>
                  <p:spPr>
                    <a:xfrm>
                      <a:off x="438192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8" name="Line 476"/>
                    <p:cNvSpPr/>
                    <p:nvPr/>
                  </p:nvSpPr>
                  <p:spPr>
                    <a:xfrm>
                      <a:off x="439992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49" name="Line 477"/>
                    <p:cNvSpPr/>
                    <p:nvPr/>
                  </p:nvSpPr>
                  <p:spPr>
                    <a:xfrm>
                      <a:off x="441360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0" name="Line 478"/>
                    <p:cNvSpPr/>
                    <p:nvPr/>
                  </p:nvSpPr>
                  <p:spPr>
                    <a:xfrm>
                      <a:off x="4426920" y="223524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1" name="Line 479"/>
                    <p:cNvSpPr/>
                    <p:nvPr/>
                  </p:nvSpPr>
                  <p:spPr>
                    <a:xfrm>
                      <a:off x="451764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2" name="Line 480"/>
                    <p:cNvSpPr/>
                    <p:nvPr/>
                  </p:nvSpPr>
                  <p:spPr>
                    <a:xfrm>
                      <a:off x="456732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3" name="Line 481"/>
                    <p:cNvSpPr/>
                    <p:nvPr/>
                  </p:nvSpPr>
                  <p:spPr>
                    <a:xfrm>
                      <a:off x="460332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4" name="Line 482"/>
                    <p:cNvSpPr/>
                    <p:nvPr/>
                  </p:nvSpPr>
                  <p:spPr>
                    <a:xfrm>
                      <a:off x="4630680" y="223524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5" name="Line 483"/>
                    <p:cNvSpPr/>
                    <p:nvPr/>
                  </p:nvSpPr>
                  <p:spPr>
                    <a:xfrm>
                      <a:off x="46576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6" name="Line 484"/>
                    <p:cNvSpPr/>
                    <p:nvPr/>
                  </p:nvSpPr>
                  <p:spPr>
                    <a:xfrm>
                      <a:off x="46756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7" name="Line 485"/>
                    <p:cNvSpPr/>
                    <p:nvPr/>
                  </p:nvSpPr>
                  <p:spPr>
                    <a:xfrm>
                      <a:off x="46936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8" name="Line 486"/>
                    <p:cNvSpPr/>
                    <p:nvPr/>
                  </p:nvSpPr>
                  <p:spPr>
                    <a:xfrm>
                      <a:off x="470736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9" name="Line 487"/>
                    <p:cNvSpPr/>
                    <p:nvPr/>
                  </p:nvSpPr>
                  <p:spPr>
                    <a:xfrm>
                      <a:off x="4720680" y="223524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0" name="Line 488"/>
                    <p:cNvSpPr/>
                    <p:nvPr/>
                  </p:nvSpPr>
                  <p:spPr>
                    <a:xfrm>
                      <a:off x="480672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1" name="Line 489"/>
                    <p:cNvSpPr/>
                    <p:nvPr/>
                  </p:nvSpPr>
                  <p:spPr>
                    <a:xfrm>
                      <a:off x="48610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2" name="Line 490"/>
                    <p:cNvSpPr/>
                    <p:nvPr/>
                  </p:nvSpPr>
                  <p:spPr>
                    <a:xfrm>
                      <a:off x="48970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3" name="Line 491"/>
                    <p:cNvSpPr/>
                    <p:nvPr/>
                  </p:nvSpPr>
                  <p:spPr>
                    <a:xfrm>
                      <a:off x="4924080" y="223524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4" name="Line 492"/>
                    <p:cNvSpPr/>
                    <p:nvPr/>
                  </p:nvSpPr>
                  <p:spPr>
                    <a:xfrm>
                      <a:off x="494676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5" name="Line 493"/>
                    <p:cNvSpPr/>
                    <p:nvPr/>
                  </p:nvSpPr>
                  <p:spPr>
                    <a:xfrm>
                      <a:off x="49690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6" name="Line 494"/>
                    <p:cNvSpPr/>
                    <p:nvPr/>
                  </p:nvSpPr>
                  <p:spPr>
                    <a:xfrm>
                      <a:off x="498312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7" name="Line 495"/>
                    <p:cNvSpPr/>
                    <p:nvPr/>
                  </p:nvSpPr>
                  <p:spPr>
                    <a:xfrm>
                      <a:off x="500112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8" name="Line 496"/>
                    <p:cNvSpPr/>
                    <p:nvPr/>
                  </p:nvSpPr>
                  <p:spPr>
                    <a:xfrm>
                      <a:off x="5014800" y="223524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9" name="Line 497"/>
                    <p:cNvSpPr/>
                    <p:nvPr/>
                  </p:nvSpPr>
                  <p:spPr>
                    <a:xfrm>
                      <a:off x="51004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0" name="Line 498"/>
                    <p:cNvSpPr/>
                    <p:nvPr/>
                  </p:nvSpPr>
                  <p:spPr>
                    <a:xfrm>
                      <a:off x="515484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1" name="Line 499"/>
                    <p:cNvSpPr/>
                    <p:nvPr/>
                  </p:nvSpPr>
                  <p:spPr>
                    <a:xfrm>
                      <a:off x="519120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2" name="Line 500"/>
                    <p:cNvSpPr/>
                    <p:nvPr/>
                  </p:nvSpPr>
                  <p:spPr>
                    <a:xfrm>
                      <a:off x="5218200" y="223524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3" name="Line 501"/>
                    <p:cNvSpPr/>
                    <p:nvPr/>
                  </p:nvSpPr>
                  <p:spPr>
                    <a:xfrm>
                      <a:off x="52408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4" name="Line 502"/>
                    <p:cNvSpPr/>
                    <p:nvPr/>
                  </p:nvSpPr>
                  <p:spPr>
                    <a:xfrm>
                      <a:off x="52588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5" name="Line 503"/>
                    <p:cNvSpPr/>
                    <p:nvPr/>
                  </p:nvSpPr>
                  <p:spPr>
                    <a:xfrm>
                      <a:off x="527688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6" name="Line 504"/>
                    <p:cNvSpPr/>
                    <p:nvPr/>
                  </p:nvSpPr>
                  <p:spPr>
                    <a:xfrm>
                      <a:off x="5290560" y="223524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7" name="Line 505"/>
                    <p:cNvSpPr/>
                    <p:nvPr/>
                  </p:nvSpPr>
                  <p:spPr>
                    <a:xfrm>
                      <a:off x="5303880" y="223524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78" name="Group 506"/>
                  <p:cNvGrpSpPr/>
                  <p:nvPr/>
                </p:nvGrpSpPr>
                <p:grpSpPr>
                  <a:xfrm>
                    <a:off x="4091760" y="2263680"/>
                    <a:ext cx="1251360" cy="60480"/>
                    <a:chOff x="4091760" y="2263680"/>
                    <a:chExt cx="1251360" cy="60480"/>
                  </a:xfrm>
                </p:grpSpPr>
                <p:sp>
                  <p:nvSpPr>
                    <p:cNvPr id="179" name="Rectangle 507"/>
                    <p:cNvSpPr/>
                    <p:nvPr/>
                  </p:nvSpPr>
                  <p:spPr>
                    <a:xfrm>
                      <a:off x="4091760" y="2278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0" name="Rectangle 508"/>
                    <p:cNvSpPr/>
                    <p:nvPr/>
                  </p:nvSpPr>
                  <p:spPr>
                    <a:xfrm>
                      <a:off x="4155480" y="22636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1" name="Rectangle 509"/>
                    <p:cNvSpPr/>
                    <p:nvPr/>
                  </p:nvSpPr>
                  <p:spPr>
                    <a:xfrm>
                      <a:off x="4380480" y="2278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2" name="Rectangle 510"/>
                    <p:cNvSpPr/>
                    <p:nvPr/>
                  </p:nvSpPr>
                  <p:spPr>
                    <a:xfrm>
                      <a:off x="4444200" y="22636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3" name="Rectangle 511"/>
                    <p:cNvSpPr/>
                    <p:nvPr/>
                  </p:nvSpPr>
                  <p:spPr>
                    <a:xfrm>
                      <a:off x="4674240" y="2278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4" name="Rectangle 512"/>
                    <p:cNvSpPr/>
                    <p:nvPr/>
                  </p:nvSpPr>
                  <p:spPr>
                    <a:xfrm>
                      <a:off x="4738320" y="22636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5" name="Rectangle 513"/>
                    <p:cNvSpPr/>
                    <p:nvPr/>
                  </p:nvSpPr>
                  <p:spPr>
                    <a:xfrm>
                      <a:off x="4968000" y="2278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6" name="Rectangle 514"/>
                    <p:cNvSpPr/>
                    <p:nvPr/>
                  </p:nvSpPr>
                  <p:spPr>
                    <a:xfrm>
                      <a:off x="5032080" y="22636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7" name="Rectangle 515"/>
                    <p:cNvSpPr/>
                    <p:nvPr/>
                  </p:nvSpPr>
                  <p:spPr>
                    <a:xfrm>
                      <a:off x="5257440" y="2278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8" name="Rectangle 516"/>
                    <p:cNvSpPr/>
                    <p:nvPr/>
                  </p:nvSpPr>
                  <p:spPr>
                    <a:xfrm>
                      <a:off x="5321160" y="22636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89" name="Rectangle 517"/>
                  <p:cNvSpPr/>
                  <p:nvPr/>
                </p:nvSpPr>
                <p:spPr>
                  <a:xfrm>
                    <a:off x="4644000" y="2324520"/>
                    <a:ext cx="2520" cy="36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90" name="Group 518"/>
                <p:cNvGrpSpPr/>
                <p:nvPr/>
              </p:nvGrpSpPr>
              <p:grpSpPr>
                <a:xfrm>
                  <a:off x="3936960" y="1307520"/>
                  <a:ext cx="200880" cy="944280"/>
                  <a:chOff x="3936960" y="1307520"/>
                  <a:chExt cx="200880" cy="944280"/>
                </a:xfrm>
              </p:grpSpPr>
              <p:sp>
                <p:nvSpPr>
                  <p:cNvPr id="191" name="Line 519"/>
                  <p:cNvSpPr/>
                  <p:nvPr/>
                </p:nvSpPr>
                <p:spPr>
                  <a:xfrm flipV="1">
                    <a:off x="4137840" y="1307520"/>
                    <a:ext cx="0" cy="92340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92" name="Group 520"/>
                  <p:cNvGrpSpPr/>
                  <p:nvPr/>
                </p:nvGrpSpPr>
                <p:grpSpPr>
                  <a:xfrm>
                    <a:off x="3995640" y="1325520"/>
                    <a:ext cx="86040" cy="926280"/>
                    <a:chOff x="3995640" y="1325520"/>
                    <a:chExt cx="86040" cy="926280"/>
                  </a:xfrm>
                </p:grpSpPr>
                <p:sp>
                  <p:nvSpPr>
                    <p:cNvPr id="193" name="Rectangle 521"/>
                    <p:cNvSpPr/>
                    <p:nvPr/>
                  </p:nvSpPr>
                  <p:spPr>
                    <a:xfrm>
                      <a:off x="4059720" y="220572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4" name="Rectangle 522"/>
                    <p:cNvSpPr/>
                    <p:nvPr/>
                  </p:nvSpPr>
                  <p:spPr>
                    <a:xfrm>
                      <a:off x="4027320" y="2030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5" name="Rectangle 523"/>
                    <p:cNvSpPr/>
                    <p:nvPr/>
                  </p:nvSpPr>
                  <p:spPr>
                    <a:xfrm>
                      <a:off x="4027320" y="1855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6" name="Rectangle 524"/>
                    <p:cNvSpPr/>
                    <p:nvPr/>
                  </p:nvSpPr>
                  <p:spPr>
                    <a:xfrm>
                      <a:off x="4027320" y="16761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7" name="Rectangle 525"/>
                    <p:cNvSpPr/>
                    <p:nvPr/>
                  </p:nvSpPr>
                  <p:spPr>
                    <a:xfrm>
                      <a:off x="4027320" y="15008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8" name="Rectangle 526"/>
                    <p:cNvSpPr/>
                    <p:nvPr/>
                  </p:nvSpPr>
                  <p:spPr>
                    <a:xfrm>
                      <a:off x="3995640" y="132552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99" name="Group 527"/>
                  <p:cNvGrpSpPr/>
                  <p:nvPr/>
                </p:nvGrpSpPr>
                <p:grpSpPr>
                  <a:xfrm>
                    <a:off x="4110840" y="1350360"/>
                    <a:ext cx="26640" cy="880560"/>
                    <a:chOff x="4110840" y="1350360"/>
                    <a:chExt cx="26640" cy="880560"/>
                  </a:xfrm>
                </p:grpSpPr>
                <p:sp>
                  <p:nvSpPr>
                    <p:cNvPr id="200" name="Line 528"/>
                    <p:cNvSpPr/>
                    <p:nvPr/>
                  </p:nvSpPr>
                  <p:spPr>
                    <a:xfrm flipH="1">
                      <a:off x="4110840" y="223092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1" name="Line 529"/>
                    <p:cNvSpPr/>
                    <p:nvPr/>
                  </p:nvSpPr>
                  <p:spPr>
                    <a:xfrm flipH="1">
                      <a:off x="4128120" y="21880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2" name="Line 530"/>
                    <p:cNvSpPr/>
                    <p:nvPr/>
                  </p:nvSpPr>
                  <p:spPr>
                    <a:xfrm flipH="1">
                      <a:off x="4128120" y="21448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3" name="Line 531"/>
                    <p:cNvSpPr/>
                    <p:nvPr/>
                  </p:nvSpPr>
                  <p:spPr>
                    <a:xfrm flipH="1">
                      <a:off x="4128120" y="20988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4" name="Line 532"/>
                    <p:cNvSpPr/>
                    <p:nvPr/>
                  </p:nvSpPr>
                  <p:spPr>
                    <a:xfrm flipH="1">
                      <a:off x="4110840" y="205560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5" name="Line 533"/>
                    <p:cNvSpPr/>
                    <p:nvPr/>
                  </p:nvSpPr>
                  <p:spPr>
                    <a:xfrm flipH="1">
                      <a:off x="4128120" y="20127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6" name="Line 534"/>
                    <p:cNvSpPr/>
                    <p:nvPr/>
                  </p:nvSpPr>
                  <p:spPr>
                    <a:xfrm flipH="1">
                      <a:off x="4128120" y="19659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7" name="Line 535"/>
                    <p:cNvSpPr/>
                    <p:nvPr/>
                  </p:nvSpPr>
                  <p:spPr>
                    <a:xfrm flipH="1">
                      <a:off x="4128120" y="19234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8" name="Line 536"/>
                    <p:cNvSpPr/>
                    <p:nvPr/>
                  </p:nvSpPr>
                  <p:spPr>
                    <a:xfrm flipH="1">
                      <a:off x="4110840" y="188028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9" name="Line 537"/>
                    <p:cNvSpPr/>
                    <p:nvPr/>
                  </p:nvSpPr>
                  <p:spPr>
                    <a:xfrm flipH="1">
                      <a:off x="4128120" y="18334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0" name="Line 538"/>
                    <p:cNvSpPr/>
                    <p:nvPr/>
                  </p:nvSpPr>
                  <p:spPr>
                    <a:xfrm flipH="1">
                      <a:off x="4128120" y="17906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1" name="Line 539"/>
                    <p:cNvSpPr/>
                    <p:nvPr/>
                  </p:nvSpPr>
                  <p:spPr>
                    <a:xfrm flipH="1">
                      <a:off x="4128120" y="17474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2" name="Line 540"/>
                    <p:cNvSpPr/>
                    <p:nvPr/>
                  </p:nvSpPr>
                  <p:spPr>
                    <a:xfrm flipH="1">
                      <a:off x="4110840" y="170136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3" name="Line 541"/>
                    <p:cNvSpPr/>
                    <p:nvPr/>
                  </p:nvSpPr>
                  <p:spPr>
                    <a:xfrm flipH="1">
                      <a:off x="4128120" y="16581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4" name="Line 542"/>
                    <p:cNvSpPr/>
                    <p:nvPr/>
                  </p:nvSpPr>
                  <p:spPr>
                    <a:xfrm flipH="1">
                      <a:off x="4128120" y="16153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5" name="Line 543"/>
                    <p:cNvSpPr/>
                    <p:nvPr/>
                  </p:nvSpPr>
                  <p:spPr>
                    <a:xfrm flipH="1">
                      <a:off x="4128120" y="15685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6" name="Line 544"/>
                    <p:cNvSpPr/>
                    <p:nvPr/>
                  </p:nvSpPr>
                  <p:spPr>
                    <a:xfrm flipH="1">
                      <a:off x="4110840" y="152604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7" name="Line 545"/>
                    <p:cNvSpPr/>
                    <p:nvPr/>
                  </p:nvSpPr>
                  <p:spPr>
                    <a:xfrm flipH="1">
                      <a:off x="4128120" y="14828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8" name="Line 546"/>
                    <p:cNvSpPr/>
                    <p:nvPr/>
                  </p:nvSpPr>
                  <p:spPr>
                    <a:xfrm flipH="1">
                      <a:off x="4128120" y="14364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9" name="Line 547"/>
                    <p:cNvSpPr/>
                    <p:nvPr/>
                  </p:nvSpPr>
                  <p:spPr>
                    <a:xfrm flipH="1">
                      <a:off x="4128120" y="13932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0" name="Line 548"/>
                    <p:cNvSpPr/>
                    <p:nvPr/>
                  </p:nvSpPr>
                  <p:spPr>
                    <a:xfrm flipH="1">
                      <a:off x="4110840" y="135036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21" name="Rectangle 549"/>
                  <p:cNvSpPr/>
                  <p:nvPr/>
                </p:nvSpPr>
                <p:spPr>
                  <a:xfrm rot="16200000">
                    <a:off x="3755880" y="2030760"/>
                    <a:ext cx="364680" cy="2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 vert="eaVer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222" name="Group 550"/>
              <p:cNvGrpSpPr/>
              <p:nvPr/>
            </p:nvGrpSpPr>
            <p:grpSpPr>
              <a:xfrm>
                <a:off x="4148280" y="1356840"/>
                <a:ext cx="1152000" cy="870840"/>
                <a:chOff x="4148280" y="1356840"/>
                <a:chExt cx="1152000" cy="870840"/>
              </a:xfrm>
            </p:grpSpPr>
            <p:sp>
              <p:nvSpPr>
                <p:cNvPr id="223" name="Freeform 551"/>
                <p:cNvSpPr/>
                <p:nvPr/>
              </p:nvSpPr>
              <p:spPr>
                <a:xfrm>
                  <a:off x="4148280" y="1356840"/>
                  <a:ext cx="1152000" cy="867240"/>
                </a:xfrm>
                <a:custGeom>
                  <a:avLst/>
                  <a:gdLst>
                    <a:gd name="textAreaLeft" fmla="*/ 0 w 1152000"/>
                    <a:gd name="textAreaRight" fmla="*/ 1152360 w 1152000"/>
                    <a:gd name="textAreaTop" fmla="*/ 0 h 867240"/>
                    <a:gd name="textAreaBottom" fmla="*/ 867600 h 867240"/>
                  </a:gdLst>
                  <a:ahLst/>
                  <a:rect l="textAreaLeft" t="textAreaTop" r="textAreaRight" b="textAreaBottom"/>
                  <a:pathLst>
                    <a:path w="510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  <a:lnTo>
                        <a:pt x="510" y="486"/>
                      </a:lnTo>
                      <a:lnTo>
                        <a:pt x="0" y="486"/>
                      </a:lnTo>
                      <a:close/>
                    </a:path>
                  </a:pathLst>
                </a:custGeom>
                <a:solidFill>
                  <a:srgbClr val="e8e8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Freeform 552"/>
                <p:cNvSpPr/>
                <p:nvPr/>
              </p:nvSpPr>
              <p:spPr>
                <a:xfrm>
                  <a:off x="4152600" y="1360440"/>
                  <a:ext cx="1147320" cy="867240"/>
                </a:xfrm>
                <a:custGeom>
                  <a:avLst/>
                  <a:gdLst>
                    <a:gd name="textAreaLeft" fmla="*/ 0 w 1147320"/>
                    <a:gd name="textAreaRight" fmla="*/ 1147680 w 1147320"/>
                    <a:gd name="textAreaTop" fmla="*/ 0 h 867240"/>
                    <a:gd name="textAreaBottom" fmla="*/ 867600 h 867240"/>
                  </a:gdLst>
                  <a:ahLst/>
                  <a:rect l="textAreaLeft" t="textAreaTop" r="textAreaRight" b="textAreaBottom"/>
                  <a:pathLst>
                    <a:path w="508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</a:path>
                  </a:pathLst>
                </a:custGeom>
                <a:noFill/>
                <a:ln w="6480">
                  <a:solidFill>
                    <a:srgbClr val="b3b3b3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25" name="Freeform 553"/>
              <p:cNvSpPr/>
              <p:nvPr/>
            </p:nvSpPr>
            <p:spPr>
              <a:xfrm>
                <a:off x="4152960" y="1360080"/>
                <a:ext cx="1147680" cy="867960"/>
              </a:xfrm>
              <a:custGeom>
                <a:avLst/>
                <a:gdLst>
                  <a:gd name="textAreaLeft" fmla="*/ 0 w 1147680"/>
                  <a:gd name="textAreaRight" fmla="*/ 1148040 w 1147680"/>
                  <a:gd name="textAreaTop" fmla="*/ 0 h 867960"/>
                  <a:gd name="textAreaBottom" fmla="*/ 868320 h 86796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0" y="484"/>
                    </a:lnTo>
                    <a:lnTo>
                      <a:pt x="2" y="484"/>
                    </a:lnTo>
                    <a:lnTo>
                      <a:pt x="4" y="484"/>
                    </a:lnTo>
                    <a:lnTo>
                      <a:pt x="6" y="484"/>
                    </a:lnTo>
                    <a:lnTo>
                      <a:pt x="8" y="484"/>
                    </a:lnTo>
                    <a:lnTo>
                      <a:pt x="10" y="484"/>
                    </a:lnTo>
                    <a:lnTo>
                      <a:pt x="12" y="484"/>
                    </a:lnTo>
                    <a:lnTo>
                      <a:pt x="14" y="484"/>
                    </a:lnTo>
                    <a:lnTo>
                      <a:pt x="16" y="484"/>
                    </a:lnTo>
                    <a:lnTo>
                      <a:pt x="18" y="484"/>
                    </a:lnTo>
                    <a:lnTo>
                      <a:pt x="20" y="484"/>
                    </a:lnTo>
                    <a:lnTo>
                      <a:pt x="22" y="484"/>
                    </a:lnTo>
                    <a:lnTo>
                      <a:pt x="24" y="484"/>
                    </a:lnTo>
                    <a:lnTo>
                      <a:pt x="26" y="484"/>
                    </a:lnTo>
                    <a:lnTo>
                      <a:pt x="28" y="484"/>
                    </a:lnTo>
                    <a:lnTo>
                      <a:pt x="30" y="484"/>
                    </a:lnTo>
                    <a:lnTo>
                      <a:pt x="32" y="484"/>
                    </a:lnTo>
                    <a:lnTo>
                      <a:pt x="34" y="484"/>
                    </a:lnTo>
                    <a:lnTo>
                      <a:pt x="36" y="484"/>
                    </a:lnTo>
                    <a:lnTo>
                      <a:pt x="38" y="484"/>
                    </a:lnTo>
                    <a:lnTo>
                      <a:pt x="40" y="484"/>
                    </a:lnTo>
                    <a:lnTo>
                      <a:pt x="42" y="484"/>
                    </a:lnTo>
                    <a:lnTo>
                      <a:pt x="44" y="484"/>
                    </a:lnTo>
                    <a:lnTo>
                      <a:pt x="46" y="484"/>
                    </a:lnTo>
                    <a:lnTo>
                      <a:pt x="48" y="484"/>
                    </a:lnTo>
                    <a:lnTo>
                      <a:pt x="50" y="484"/>
                    </a:lnTo>
                    <a:lnTo>
                      <a:pt x="52" y="484"/>
                    </a:lnTo>
                    <a:lnTo>
                      <a:pt x="54" y="484"/>
                    </a:lnTo>
                    <a:lnTo>
                      <a:pt x="56" y="484"/>
                    </a:lnTo>
                    <a:lnTo>
                      <a:pt x="58" y="484"/>
                    </a:lnTo>
                    <a:lnTo>
                      <a:pt x="60" y="484"/>
                    </a:lnTo>
                    <a:lnTo>
                      <a:pt x="62" y="484"/>
                    </a:lnTo>
                    <a:lnTo>
                      <a:pt x="64" y="484"/>
                    </a:lnTo>
                    <a:lnTo>
                      <a:pt x="66" y="484"/>
                    </a:lnTo>
                    <a:lnTo>
                      <a:pt x="68" y="484"/>
                    </a:lnTo>
                    <a:lnTo>
                      <a:pt x="70" y="484"/>
                    </a:lnTo>
                    <a:lnTo>
                      <a:pt x="72" y="484"/>
                    </a:lnTo>
                    <a:lnTo>
                      <a:pt x="74" y="484"/>
                    </a:lnTo>
                    <a:lnTo>
                      <a:pt x="76" y="484"/>
                    </a:lnTo>
                    <a:lnTo>
                      <a:pt x="78" y="484"/>
                    </a:lnTo>
                    <a:lnTo>
                      <a:pt x="80" y="484"/>
                    </a:lnTo>
                    <a:lnTo>
                      <a:pt x="82" y="482"/>
                    </a:lnTo>
                    <a:lnTo>
                      <a:pt x="84" y="482"/>
                    </a:lnTo>
                    <a:lnTo>
                      <a:pt x="86" y="482"/>
                    </a:lnTo>
                    <a:lnTo>
                      <a:pt x="88" y="482"/>
                    </a:lnTo>
                    <a:lnTo>
                      <a:pt x="90" y="482"/>
                    </a:lnTo>
                    <a:lnTo>
                      <a:pt x="92" y="482"/>
                    </a:lnTo>
                    <a:lnTo>
                      <a:pt x="94" y="482"/>
                    </a:lnTo>
                    <a:lnTo>
                      <a:pt x="96" y="482"/>
                    </a:lnTo>
                    <a:lnTo>
                      <a:pt x="98" y="482"/>
                    </a:lnTo>
                    <a:lnTo>
                      <a:pt x="100" y="484"/>
                    </a:lnTo>
                    <a:lnTo>
                      <a:pt x="102" y="484"/>
                    </a:lnTo>
                    <a:lnTo>
                      <a:pt x="104" y="484"/>
                    </a:lnTo>
                    <a:lnTo>
                      <a:pt x="106" y="484"/>
                    </a:lnTo>
                    <a:lnTo>
                      <a:pt x="108" y="484"/>
                    </a:lnTo>
                    <a:lnTo>
                      <a:pt x="110" y="484"/>
                    </a:lnTo>
                    <a:lnTo>
                      <a:pt x="112" y="484"/>
                    </a:lnTo>
                    <a:lnTo>
                      <a:pt x="114" y="484"/>
                    </a:lnTo>
                    <a:lnTo>
                      <a:pt x="116" y="484"/>
                    </a:lnTo>
                    <a:lnTo>
                      <a:pt x="118" y="484"/>
                    </a:lnTo>
                    <a:lnTo>
                      <a:pt x="120" y="484"/>
                    </a:lnTo>
                    <a:lnTo>
                      <a:pt x="122" y="484"/>
                    </a:lnTo>
                    <a:lnTo>
                      <a:pt x="124" y="484"/>
                    </a:lnTo>
                    <a:lnTo>
                      <a:pt x="126" y="484"/>
                    </a:lnTo>
                    <a:lnTo>
                      <a:pt x="128" y="484"/>
                    </a:lnTo>
                    <a:lnTo>
                      <a:pt x="130" y="484"/>
                    </a:lnTo>
                    <a:lnTo>
                      <a:pt x="132" y="484"/>
                    </a:lnTo>
                    <a:lnTo>
                      <a:pt x="134" y="484"/>
                    </a:lnTo>
                    <a:lnTo>
                      <a:pt x="136" y="484"/>
                    </a:lnTo>
                    <a:lnTo>
                      <a:pt x="138" y="484"/>
                    </a:lnTo>
                    <a:lnTo>
                      <a:pt x="140" y="484"/>
                    </a:lnTo>
                    <a:lnTo>
                      <a:pt x="142" y="484"/>
                    </a:lnTo>
                    <a:lnTo>
                      <a:pt x="144" y="484"/>
                    </a:lnTo>
                    <a:lnTo>
                      <a:pt x="146" y="484"/>
                    </a:lnTo>
                    <a:lnTo>
                      <a:pt x="148" y="484"/>
                    </a:lnTo>
                    <a:lnTo>
                      <a:pt x="150" y="484"/>
                    </a:lnTo>
                    <a:lnTo>
                      <a:pt x="152" y="484"/>
                    </a:lnTo>
                    <a:lnTo>
                      <a:pt x="154" y="484"/>
                    </a:lnTo>
                    <a:lnTo>
                      <a:pt x="156" y="482"/>
                    </a:lnTo>
                    <a:lnTo>
                      <a:pt x="158" y="482"/>
                    </a:lnTo>
                    <a:lnTo>
                      <a:pt x="160" y="482"/>
                    </a:lnTo>
                    <a:lnTo>
                      <a:pt x="162" y="482"/>
                    </a:lnTo>
                    <a:lnTo>
                      <a:pt x="164" y="482"/>
                    </a:lnTo>
                    <a:lnTo>
                      <a:pt x="166" y="482"/>
                    </a:lnTo>
                    <a:lnTo>
                      <a:pt x="168" y="482"/>
                    </a:lnTo>
                    <a:lnTo>
                      <a:pt x="170" y="482"/>
                    </a:lnTo>
                    <a:lnTo>
                      <a:pt x="172" y="482"/>
                    </a:lnTo>
                    <a:lnTo>
                      <a:pt x="174" y="482"/>
                    </a:lnTo>
                    <a:lnTo>
                      <a:pt x="176" y="482"/>
                    </a:lnTo>
                    <a:lnTo>
                      <a:pt x="178" y="482"/>
                    </a:lnTo>
                    <a:lnTo>
                      <a:pt x="180" y="482"/>
                    </a:lnTo>
                    <a:lnTo>
                      <a:pt x="182" y="482"/>
                    </a:lnTo>
                    <a:lnTo>
                      <a:pt x="184" y="482"/>
                    </a:lnTo>
                    <a:lnTo>
                      <a:pt x="186" y="482"/>
                    </a:lnTo>
                    <a:lnTo>
                      <a:pt x="188" y="482"/>
                    </a:lnTo>
                    <a:lnTo>
                      <a:pt x="190" y="482"/>
                    </a:lnTo>
                    <a:lnTo>
                      <a:pt x="192" y="482"/>
                    </a:lnTo>
                    <a:lnTo>
                      <a:pt x="194" y="482"/>
                    </a:lnTo>
                    <a:lnTo>
                      <a:pt x="196" y="482"/>
                    </a:lnTo>
                    <a:lnTo>
                      <a:pt x="198" y="480"/>
                    </a:lnTo>
                    <a:lnTo>
                      <a:pt x="200" y="480"/>
                    </a:lnTo>
                    <a:lnTo>
                      <a:pt x="202" y="478"/>
                    </a:lnTo>
                    <a:lnTo>
                      <a:pt x="204" y="478"/>
                    </a:lnTo>
                    <a:lnTo>
                      <a:pt x="206" y="478"/>
                    </a:lnTo>
                    <a:lnTo>
                      <a:pt x="208" y="478"/>
                    </a:lnTo>
                    <a:lnTo>
                      <a:pt x="210" y="478"/>
                    </a:lnTo>
                    <a:lnTo>
                      <a:pt x="212" y="478"/>
                    </a:lnTo>
                    <a:lnTo>
                      <a:pt x="214" y="476"/>
                    </a:lnTo>
                    <a:lnTo>
                      <a:pt x="216" y="476"/>
                    </a:lnTo>
                    <a:lnTo>
                      <a:pt x="218" y="474"/>
                    </a:lnTo>
                    <a:lnTo>
                      <a:pt x="220" y="472"/>
                    </a:lnTo>
                    <a:lnTo>
                      <a:pt x="222" y="468"/>
                    </a:lnTo>
                    <a:lnTo>
                      <a:pt x="224" y="466"/>
                    </a:lnTo>
                    <a:lnTo>
                      <a:pt x="226" y="462"/>
                    </a:lnTo>
                    <a:lnTo>
                      <a:pt x="228" y="460"/>
                    </a:lnTo>
                    <a:lnTo>
                      <a:pt x="230" y="456"/>
                    </a:lnTo>
                    <a:lnTo>
                      <a:pt x="232" y="454"/>
                    </a:lnTo>
                    <a:lnTo>
                      <a:pt x="234" y="450"/>
                    </a:lnTo>
                    <a:lnTo>
                      <a:pt x="236" y="446"/>
                    </a:lnTo>
                    <a:lnTo>
                      <a:pt x="238" y="444"/>
                    </a:lnTo>
                    <a:lnTo>
                      <a:pt x="240" y="442"/>
                    </a:lnTo>
                    <a:lnTo>
                      <a:pt x="242" y="440"/>
                    </a:lnTo>
                    <a:lnTo>
                      <a:pt x="244" y="436"/>
                    </a:lnTo>
                    <a:lnTo>
                      <a:pt x="246" y="434"/>
                    </a:lnTo>
                    <a:lnTo>
                      <a:pt x="248" y="428"/>
                    </a:lnTo>
                    <a:lnTo>
                      <a:pt x="250" y="422"/>
                    </a:lnTo>
                    <a:lnTo>
                      <a:pt x="252" y="412"/>
                    </a:lnTo>
                    <a:lnTo>
                      <a:pt x="254" y="400"/>
                    </a:lnTo>
                    <a:lnTo>
                      <a:pt x="256" y="382"/>
                    </a:lnTo>
                    <a:lnTo>
                      <a:pt x="258" y="366"/>
                    </a:lnTo>
                    <a:lnTo>
                      <a:pt x="260" y="350"/>
                    </a:lnTo>
                    <a:lnTo>
                      <a:pt x="262" y="330"/>
                    </a:lnTo>
                    <a:lnTo>
                      <a:pt x="264" y="300"/>
                    </a:lnTo>
                    <a:lnTo>
                      <a:pt x="266" y="278"/>
                    </a:lnTo>
                    <a:lnTo>
                      <a:pt x="268" y="248"/>
                    </a:lnTo>
                    <a:lnTo>
                      <a:pt x="270" y="222"/>
                    </a:lnTo>
                    <a:lnTo>
                      <a:pt x="272" y="214"/>
                    </a:lnTo>
                    <a:lnTo>
                      <a:pt x="274" y="190"/>
                    </a:lnTo>
                    <a:lnTo>
                      <a:pt x="276" y="146"/>
                    </a:lnTo>
                    <a:lnTo>
                      <a:pt x="278" y="104"/>
                    </a:lnTo>
                    <a:lnTo>
                      <a:pt x="280" y="70"/>
                    </a:lnTo>
                    <a:lnTo>
                      <a:pt x="282" y="48"/>
                    </a:lnTo>
                    <a:lnTo>
                      <a:pt x="284" y="30"/>
                    </a:lnTo>
                    <a:lnTo>
                      <a:pt x="286" y="12"/>
                    </a:lnTo>
                    <a:lnTo>
                      <a:pt x="288" y="0"/>
                    </a:lnTo>
                    <a:lnTo>
                      <a:pt x="290" y="10"/>
                    </a:lnTo>
                    <a:lnTo>
                      <a:pt x="292" y="36"/>
                    </a:lnTo>
                    <a:lnTo>
                      <a:pt x="294" y="70"/>
                    </a:lnTo>
                    <a:lnTo>
                      <a:pt x="296" y="110"/>
                    </a:lnTo>
                    <a:lnTo>
                      <a:pt x="298" y="148"/>
                    </a:lnTo>
                    <a:lnTo>
                      <a:pt x="300" y="190"/>
                    </a:lnTo>
                    <a:lnTo>
                      <a:pt x="302" y="220"/>
                    </a:lnTo>
                    <a:lnTo>
                      <a:pt x="304" y="232"/>
                    </a:lnTo>
                    <a:lnTo>
                      <a:pt x="306" y="276"/>
                    </a:lnTo>
                    <a:lnTo>
                      <a:pt x="308" y="324"/>
                    </a:lnTo>
                    <a:lnTo>
                      <a:pt x="310" y="350"/>
                    </a:lnTo>
                    <a:lnTo>
                      <a:pt x="312" y="374"/>
                    </a:lnTo>
                    <a:lnTo>
                      <a:pt x="314" y="394"/>
                    </a:lnTo>
                    <a:lnTo>
                      <a:pt x="316" y="408"/>
                    </a:lnTo>
                    <a:lnTo>
                      <a:pt x="318" y="418"/>
                    </a:lnTo>
                    <a:lnTo>
                      <a:pt x="320" y="428"/>
                    </a:lnTo>
                    <a:lnTo>
                      <a:pt x="322" y="436"/>
                    </a:lnTo>
                    <a:lnTo>
                      <a:pt x="324" y="440"/>
                    </a:lnTo>
                    <a:lnTo>
                      <a:pt x="326" y="444"/>
                    </a:lnTo>
                    <a:lnTo>
                      <a:pt x="328" y="452"/>
                    </a:lnTo>
                    <a:lnTo>
                      <a:pt x="330" y="460"/>
                    </a:lnTo>
                    <a:lnTo>
                      <a:pt x="332" y="466"/>
                    </a:lnTo>
                    <a:lnTo>
                      <a:pt x="334" y="470"/>
                    </a:lnTo>
                    <a:lnTo>
                      <a:pt x="336" y="472"/>
                    </a:lnTo>
                    <a:lnTo>
                      <a:pt x="338" y="474"/>
                    </a:lnTo>
                    <a:lnTo>
                      <a:pt x="340" y="474"/>
                    </a:lnTo>
                    <a:lnTo>
                      <a:pt x="342" y="476"/>
                    </a:lnTo>
                    <a:lnTo>
                      <a:pt x="344" y="476"/>
                    </a:lnTo>
                    <a:lnTo>
                      <a:pt x="346" y="478"/>
                    </a:lnTo>
                    <a:lnTo>
                      <a:pt x="348" y="478"/>
                    </a:lnTo>
                    <a:lnTo>
                      <a:pt x="350" y="480"/>
                    </a:lnTo>
                    <a:lnTo>
                      <a:pt x="352" y="480"/>
                    </a:lnTo>
                    <a:lnTo>
                      <a:pt x="354" y="482"/>
                    </a:lnTo>
                    <a:lnTo>
                      <a:pt x="356" y="482"/>
                    </a:lnTo>
                    <a:lnTo>
                      <a:pt x="358" y="484"/>
                    </a:lnTo>
                    <a:lnTo>
                      <a:pt x="360" y="484"/>
                    </a:lnTo>
                    <a:lnTo>
                      <a:pt x="362" y="484"/>
                    </a:lnTo>
                    <a:lnTo>
                      <a:pt x="364" y="484"/>
                    </a:lnTo>
                    <a:lnTo>
                      <a:pt x="366" y="484"/>
                    </a:lnTo>
                    <a:lnTo>
                      <a:pt x="368" y="484"/>
                    </a:lnTo>
                    <a:lnTo>
                      <a:pt x="370" y="484"/>
                    </a:lnTo>
                    <a:lnTo>
                      <a:pt x="372" y="484"/>
                    </a:lnTo>
                    <a:lnTo>
                      <a:pt x="374" y="484"/>
                    </a:lnTo>
                    <a:lnTo>
                      <a:pt x="376" y="484"/>
                    </a:lnTo>
                    <a:lnTo>
                      <a:pt x="378" y="484"/>
                    </a:lnTo>
                    <a:lnTo>
                      <a:pt x="380" y="484"/>
                    </a:lnTo>
                    <a:lnTo>
                      <a:pt x="382" y="484"/>
                    </a:lnTo>
                    <a:lnTo>
                      <a:pt x="384" y="484"/>
                    </a:lnTo>
                    <a:lnTo>
                      <a:pt x="386" y="484"/>
                    </a:lnTo>
                    <a:lnTo>
                      <a:pt x="388" y="484"/>
                    </a:lnTo>
                    <a:lnTo>
                      <a:pt x="390" y="484"/>
                    </a:lnTo>
                    <a:lnTo>
                      <a:pt x="392" y="484"/>
                    </a:lnTo>
                    <a:lnTo>
                      <a:pt x="394" y="484"/>
                    </a:lnTo>
                    <a:lnTo>
                      <a:pt x="396" y="484"/>
                    </a:lnTo>
                    <a:lnTo>
                      <a:pt x="398" y="484"/>
                    </a:lnTo>
                    <a:lnTo>
                      <a:pt x="400" y="484"/>
                    </a:lnTo>
                    <a:lnTo>
                      <a:pt x="402" y="484"/>
                    </a:lnTo>
                    <a:lnTo>
                      <a:pt x="404" y="486"/>
                    </a:lnTo>
                    <a:lnTo>
                      <a:pt x="406" y="486"/>
                    </a:lnTo>
                    <a:lnTo>
                      <a:pt x="408" y="486"/>
                    </a:lnTo>
                    <a:lnTo>
                      <a:pt x="410" y="486"/>
                    </a:lnTo>
                    <a:lnTo>
                      <a:pt x="412" y="486"/>
                    </a:lnTo>
                    <a:lnTo>
                      <a:pt x="414" y="486"/>
                    </a:lnTo>
                    <a:lnTo>
                      <a:pt x="416" y="486"/>
                    </a:lnTo>
                    <a:lnTo>
                      <a:pt x="418" y="486"/>
                    </a:lnTo>
                    <a:lnTo>
                      <a:pt x="420" y="486"/>
                    </a:lnTo>
                    <a:lnTo>
                      <a:pt x="422" y="486"/>
                    </a:lnTo>
                    <a:lnTo>
                      <a:pt x="424" y="486"/>
                    </a:lnTo>
                    <a:lnTo>
                      <a:pt x="426" y="486"/>
                    </a:lnTo>
                    <a:lnTo>
                      <a:pt x="428" y="486"/>
                    </a:lnTo>
                    <a:lnTo>
                      <a:pt x="430" y="486"/>
                    </a:lnTo>
                    <a:lnTo>
                      <a:pt x="432" y="486"/>
                    </a:lnTo>
                    <a:lnTo>
                      <a:pt x="434" y="486"/>
                    </a:lnTo>
                    <a:lnTo>
                      <a:pt x="436" y="486"/>
                    </a:lnTo>
                    <a:lnTo>
                      <a:pt x="438" y="486"/>
                    </a:lnTo>
                    <a:lnTo>
                      <a:pt x="440" y="486"/>
                    </a:lnTo>
                    <a:lnTo>
                      <a:pt x="442" y="486"/>
                    </a:lnTo>
                    <a:lnTo>
                      <a:pt x="444" y="486"/>
                    </a:lnTo>
                    <a:lnTo>
                      <a:pt x="446" y="486"/>
                    </a:lnTo>
                    <a:lnTo>
                      <a:pt x="448" y="486"/>
                    </a:lnTo>
                    <a:lnTo>
                      <a:pt x="450" y="486"/>
                    </a:lnTo>
                    <a:lnTo>
                      <a:pt x="452" y="486"/>
                    </a:lnTo>
                    <a:lnTo>
                      <a:pt x="454" y="486"/>
                    </a:lnTo>
                    <a:lnTo>
                      <a:pt x="456" y="486"/>
                    </a:lnTo>
                    <a:lnTo>
                      <a:pt x="458" y="486"/>
                    </a:lnTo>
                    <a:lnTo>
                      <a:pt x="460" y="486"/>
                    </a:lnTo>
                    <a:lnTo>
                      <a:pt x="462" y="486"/>
                    </a:lnTo>
                    <a:lnTo>
                      <a:pt x="464" y="486"/>
                    </a:lnTo>
                    <a:lnTo>
                      <a:pt x="466" y="486"/>
                    </a:lnTo>
                    <a:lnTo>
                      <a:pt x="468" y="486"/>
                    </a:lnTo>
                    <a:lnTo>
                      <a:pt x="470" y="486"/>
                    </a:lnTo>
                    <a:lnTo>
                      <a:pt x="472" y="486"/>
                    </a:lnTo>
                    <a:lnTo>
                      <a:pt x="474" y="486"/>
                    </a:lnTo>
                    <a:lnTo>
                      <a:pt x="476" y="486"/>
                    </a:lnTo>
                    <a:lnTo>
                      <a:pt x="478" y="486"/>
                    </a:lnTo>
                    <a:lnTo>
                      <a:pt x="480" y="486"/>
                    </a:lnTo>
                    <a:lnTo>
                      <a:pt x="482" y="486"/>
                    </a:lnTo>
                    <a:lnTo>
                      <a:pt x="484" y="486"/>
                    </a:lnTo>
                    <a:lnTo>
                      <a:pt x="486" y="486"/>
                    </a:lnTo>
                    <a:lnTo>
                      <a:pt x="488" y="486"/>
                    </a:lnTo>
                    <a:lnTo>
                      <a:pt x="490" y="486"/>
                    </a:lnTo>
                    <a:lnTo>
                      <a:pt x="492" y="486"/>
                    </a:lnTo>
                    <a:lnTo>
                      <a:pt x="494" y="486"/>
                    </a:lnTo>
                    <a:lnTo>
                      <a:pt x="496" y="486"/>
                    </a:lnTo>
                    <a:lnTo>
                      <a:pt x="498" y="486"/>
                    </a:lnTo>
                    <a:lnTo>
                      <a:pt x="500" y="486"/>
                    </a:lnTo>
                    <a:lnTo>
                      <a:pt x="502" y="486"/>
                    </a:lnTo>
                    <a:lnTo>
                      <a:pt x="504" y="486"/>
                    </a:lnTo>
                    <a:lnTo>
                      <a:pt x="506" y="486"/>
                    </a:lnTo>
                    <a:lnTo>
                      <a:pt x="508" y="486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6" name="Text Box 3831"/>
            <p:cNvSpPr/>
            <p:nvPr/>
          </p:nvSpPr>
          <p:spPr>
            <a:xfrm>
              <a:off x="4695840" y="130176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99.3/18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7" name="Group 3859"/>
          <p:cNvGrpSpPr/>
          <p:nvPr/>
        </p:nvGrpSpPr>
        <p:grpSpPr>
          <a:xfrm>
            <a:off x="1422360" y="2433600"/>
            <a:ext cx="1409400" cy="1396080"/>
            <a:chOff x="1422360" y="2433600"/>
            <a:chExt cx="1409400" cy="1396080"/>
          </a:xfrm>
        </p:grpSpPr>
        <p:grpSp>
          <p:nvGrpSpPr>
            <p:cNvPr id="228" name="Group 3852"/>
            <p:cNvGrpSpPr/>
            <p:nvPr/>
          </p:nvGrpSpPr>
          <p:grpSpPr>
            <a:xfrm>
              <a:off x="1422360" y="2447640"/>
              <a:ext cx="1409400" cy="1382040"/>
              <a:chOff x="1422360" y="2447640"/>
              <a:chExt cx="1409400" cy="1382040"/>
            </a:xfrm>
          </p:grpSpPr>
          <p:grpSp>
            <p:nvGrpSpPr>
              <p:cNvPr id="229" name="Group 373"/>
              <p:cNvGrpSpPr/>
              <p:nvPr/>
            </p:nvGrpSpPr>
            <p:grpSpPr>
              <a:xfrm>
                <a:off x="1422360" y="2447640"/>
                <a:ext cx="1409400" cy="1382040"/>
                <a:chOff x="1422360" y="2447640"/>
                <a:chExt cx="1409400" cy="1382040"/>
              </a:xfrm>
            </p:grpSpPr>
            <p:sp>
              <p:nvSpPr>
                <p:cNvPr id="230" name="Rectangle 374"/>
                <p:cNvSpPr/>
                <p:nvPr/>
              </p:nvSpPr>
              <p:spPr>
                <a:xfrm>
                  <a:off x="1638000" y="2449800"/>
                  <a:ext cx="1157400" cy="92340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31" name="Group 375"/>
                <p:cNvGrpSpPr/>
                <p:nvPr/>
              </p:nvGrpSpPr>
              <p:grpSpPr>
                <a:xfrm>
                  <a:off x="1588680" y="3371760"/>
                  <a:ext cx="1243080" cy="457920"/>
                  <a:chOff x="1588680" y="3371760"/>
                  <a:chExt cx="1243080" cy="457920"/>
                </a:xfrm>
              </p:grpSpPr>
              <p:sp>
                <p:nvSpPr>
                  <p:cNvPr id="232" name="Line 376"/>
                  <p:cNvSpPr/>
                  <p:nvPr/>
                </p:nvSpPr>
                <p:spPr>
                  <a:xfrm>
                    <a:off x="1635120" y="3371760"/>
                    <a:ext cx="115776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33" name="Group 377"/>
                  <p:cNvGrpSpPr/>
                  <p:nvPr/>
                </p:nvGrpSpPr>
                <p:grpSpPr>
                  <a:xfrm>
                    <a:off x="1635120" y="3375360"/>
                    <a:ext cx="1157400" cy="20880"/>
                    <a:chOff x="1635120" y="3375360"/>
                    <a:chExt cx="1157400" cy="20880"/>
                  </a:xfrm>
                </p:grpSpPr>
                <p:sp>
                  <p:nvSpPr>
                    <p:cNvPr id="234" name="Line 378"/>
                    <p:cNvSpPr/>
                    <p:nvPr/>
                  </p:nvSpPr>
                  <p:spPr>
                    <a:xfrm>
                      <a:off x="1635120" y="33753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5" name="Line 379"/>
                    <p:cNvSpPr/>
                    <p:nvPr/>
                  </p:nvSpPr>
                  <p:spPr>
                    <a:xfrm>
                      <a:off x="172044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6" name="Line 380"/>
                    <p:cNvSpPr/>
                    <p:nvPr/>
                  </p:nvSpPr>
                  <p:spPr>
                    <a:xfrm>
                      <a:off x="176976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7" name="Line 381"/>
                    <p:cNvSpPr/>
                    <p:nvPr/>
                  </p:nvSpPr>
                  <p:spPr>
                    <a:xfrm>
                      <a:off x="18054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8" name="Line 382"/>
                    <p:cNvSpPr/>
                    <p:nvPr/>
                  </p:nvSpPr>
                  <p:spPr>
                    <a:xfrm>
                      <a:off x="1836720" y="33753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9" name="Line 383"/>
                    <p:cNvSpPr/>
                    <p:nvPr/>
                  </p:nvSpPr>
                  <p:spPr>
                    <a:xfrm>
                      <a:off x="18594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0" name="Line 384"/>
                    <p:cNvSpPr/>
                    <p:nvPr/>
                  </p:nvSpPr>
                  <p:spPr>
                    <a:xfrm>
                      <a:off x="187704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1" name="Line 385"/>
                    <p:cNvSpPr/>
                    <p:nvPr/>
                  </p:nvSpPr>
                  <p:spPr>
                    <a:xfrm>
                      <a:off x="18954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2" name="Line 386"/>
                    <p:cNvSpPr/>
                    <p:nvPr/>
                  </p:nvSpPr>
                  <p:spPr>
                    <a:xfrm>
                      <a:off x="190872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3" name="Line 387"/>
                    <p:cNvSpPr/>
                    <p:nvPr/>
                  </p:nvSpPr>
                  <p:spPr>
                    <a:xfrm>
                      <a:off x="1922400" y="33753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4" name="Line 388"/>
                    <p:cNvSpPr/>
                    <p:nvPr/>
                  </p:nvSpPr>
                  <p:spPr>
                    <a:xfrm>
                      <a:off x="201168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5" name="Line 389"/>
                    <p:cNvSpPr/>
                    <p:nvPr/>
                  </p:nvSpPr>
                  <p:spPr>
                    <a:xfrm>
                      <a:off x="20610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6" name="Line 390"/>
                    <p:cNvSpPr/>
                    <p:nvPr/>
                  </p:nvSpPr>
                  <p:spPr>
                    <a:xfrm>
                      <a:off x="209736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7" name="Line 391"/>
                    <p:cNvSpPr/>
                    <p:nvPr/>
                  </p:nvSpPr>
                  <p:spPr>
                    <a:xfrm>
                      <a:off x="2124360" y="33753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8" name="Line 392"/>
                    <p:cNvSpPr/>
                    <p:nvPr/>
                  </p:nvSpPr>
                  <p:spPr>
                    <a:xfrm>
                      <a:off x="215064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9" name="Line 393"/>
                    <p:cNvSpPr/>
                    <p:nvPr/>
                  </p:nvSpPr>
                  <p:spPr>
                    <a:xfrm>
                      <a:off x="21690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0" name="Line 394"/>
                    <p:cNvSpPr/>
                    <p:nvPr/>
                  </p:nvSpPr>
                  <p:spPr>
                    <a:xfrm>
                      <a:off x="218664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1" name="Line 395"/>
                    <p:cNvSpPr/>
                    <p:nvPr/>
                  </p:nvSpPr>
                  <p:spPr>
                    <a:xfrm>
                      <a:off x="219996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2" name="Line 396"/>
                    <p:cNvSpPr/>
                    <p:nvPr/>
                  </p:nvSpPr>
                  <p:spPr>
                    <a:xfrm>
                      <a:off x="2213640" y="33753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3" name="Line 397"/>
                    <p:cNvSpPr/>
                    <p:nvPr/>
                  </p:nvSpPr>
                  <p:spPr>
                    <a:xfrm>
                      <a:off x="22986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4" name="Line 398"/>
                    <p:cNvSpPr/>
                    <p:nvPr/>
                  </p:nvSpPr>
                  <p:spPr>
                    <a:xfrm>
                      <a:off x="23526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5" name="Line 399"/>
                    <p:cNvSpPr/>
                    <p:nvPr/>
                  </p:nvSpPr>
                  <p:spPr>
                    <a:xfrm>
                      <a:off x="23886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6" name="Line 400"/>
                    <p:cNvSpPr/>
                    <p:nvPr/>
                  </p:nvSpPr>
                  <p:spPr>
                    <a:xfrm>
                      <a:off x="2415600" y="33753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7" name="Line 401"/>
                    <p:cNvSpPr/>
                    <p:nvPr/>
                  </p:nvSpPr>
                  <p:spPr>
                    <a:xfrm>
                      <a:off x="243792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8" name="Line 402"/>
                    <p:cNvSpPr/>
                    <p:nvPr/>
                  </p:nvSpPr>
                  <p:spPr>
                    <a:xfrm>
                      <a:off x="24606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9" name="Line 403"/>
                    <p:cNvSpPr/>
                    <p:nvPr/>
                  </p:nvSpPr>
                  <p:spPr>
                    <a:xfrm>
                      <a:off x="247356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0" name="Line 404"/>
                    <p:cNvSpPr/>
                    <p:nvPr/>
                  </p:nvSpPr>
                  <p:spPr>
                    <a:xfrm>
                      <a:off x="249192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1" name="Line 405"/>
                    <p:cNvSpPr/>
                    <p:nvPr/>
                  </p:nvSpPr>
                  <p:spPr>
                    <a:xfrm>
                      <a:off x="2505240" y="33753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2" name="Line 406"/>
                    <p:cNvSpPr/>
                    <p:nvPr/>
                  </p:nvSpPr>
                  <p:spPr>
                    <a:xfrm>
                      <a:off x="259056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3" name="Line 407"/>
                    <p:cNvSpPr/>
                    <p:nvPr/>
                  </p:nvSpPr>
                  <p:spPr>
                    <a:xfrm>
                      <a:off x="264456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4" name="Line 408"/>
                    <p:cNvSpPr/>
                    <p:nvPr/>
                  </p:nvSpPr>
                  <p:spPr>
                    <a:xfrm>
                      <a:off x="268020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5" name="Line 409"/>
                    <p:cNvSpPr/>
                    <p:nvPr/>
                  </p:nvSpPr>
                  <p:spPr>
                    <a:xfrm>
                      <a:off x="2707200" y="33753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6" name="Line 410"/>
                    <p:cNvSpPr/>
                    <p:nvPr/>
                  </p:nvSpPr>
                  <p:spPr>
                    <a:xfrm>
                      <a:off x="272952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7" name="Line 411"/>
                    <p:cNvSpPr/>
                    <p:nvPr/>
                  </p:nvSpPr>
                  <p:spPr>
                    <a:xfrm>
                      <a:off x="274716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8" name="Line 412"/>
                    <p:cNvSpPr/>
                    <p:nvPr/>
                  </p:nvSpPr>
                  <p:spPr>
                    <a:xfrm>
                      <a:off x="276552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9" name="Line 413"/>
                    <p:cNvSpPr/>
                    <p:nvPr/>
                  </p:nvSpPr>
                  <p:spPr>
                    <a:xfrm>
                      <a:off x="2778840" y="3375360"/>
                      <a:ext cx="0" cy="64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0320" bIns="-403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0" name="Line 414"/>
                    <p:cNvSpPr/>
                    <p:nvPr/>
                  </p:nvSpPr>
                  <p:spPr>
                    <a:xfrm>
                      <a:off x="2792520" y="33753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71" name="Group 415"/>
                  <p:cNvGrpSpPr/>
                  <p:nvPr/>
                </p:nvGrpSpPr>
                <p:grpSpPr>
                  <a:xfrm>
                    <a:off x="1588680" y="3403800"/>
                    <a:ext cx="1243080" cy="60120"/>
                    <a:chOff x="1588680" y="3403800"/>
                    <a:chExt cx="1243080" cy="60120"/>
                  </a:xfrm>
                </p:grpSpPr>
                <p:sp>
                  <p:nvSpPr>
                    <p:cNvPr id="272" name="Rectangle 416"/>
                    <p:cNvSpPr/>
                    <p:nvPr/>
                  </p:nvSpPr>
                  <p:spPr>
                    <a:xfrm>
                      <a:off x="1588680" y="34178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3" name="Rectangle 417"/>
                    <p:cNvSpPr/>
                    <p:nvPr/>
                  </p:nvSpPr>
                  <p:spPr>
                    <a:xfrm>
                      <a:off x="1652040" y="34038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4" name="Rectangle 418"/>
                    <p:cNvSpPr/>
                    <p:nvPr/>
                  </p:nvSpPr>
                  <p:spPr>
                    <a:xfrm>
                      <a:off x="1875600" y="34178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5" name="Rectangle 419"/>
                    <p:cNvSpPr/>
                    <p:nvPr/>
                  </p:nvSpPr>
                  <p:spPr>
                    <a:xfrm>
                      <a:off x="1939320" y="34038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6" name="Rectangle 420"/>
                    <p:cNvSpPr/>
                    <p:nvPr/>
                  </p:nvSpPr>
                  <p:spPr>
                    <a:xfrm>
                      <a:off x="2168280" y="34178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7" name="Rectangle 421"/>
                    <p:cNvSpPr/>
                    <p:nvPr/>
                  </p:nvSpPr>
                  <p:spPr>
                    <a:xfrm>
                      <a:off x="2230920" y="34038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8" name="Rectangle 422"/>
                    <p:cNvSpPr/>
                    <p:nvPr/>
                  </p:nvSpPr>
                  <p:spPr>
                    <a:xfrm>
                      <a:off x="2458800" y="34178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9" name="Rectangle 423"/>
                    <p:cNvSpPr/>
                    <p:nvPr/>
                  </p:nvSpPr>
                  <p:spPr>
                    <a:xfrm>
                      <a:off x="2522160" y="34038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0" name="Rectangle 424"/>
                    <p:cNvSpPr/>
                    <p:nvPr/>
                  </p:nvSpPr>
                  <p:spPr>
                    <a:xfrm>
                      <a:off x="2746800" y="34178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1" name="Rectangle 425"/>
                    <p:cNvSpPr/>
                    <p:nvPr/>
                  </p:nvSpPr>
                  <p:spPr>
                    <a:xfrm>
                      <a:off x="2809800" y="34038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82" name="Rectangle 426"/>
                  <p:cNvSpPr/>
                  <p:nvPr/>
                </p:nvSpPr>
                <p:spPr>
                  <a:xfrm>
                    <a:off x="2137680" y="3464640"/>
                    <a:ext cx="1800" cy="36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83" name="Group 427"/>
                <p:cNvGrpSpPr/>
                <p:nvPr/>
              </p:nvGrpSpPr>
              <p:grpSpPr>
                <a:xfrm>
                  <a:off x="1422360" y="2447640"/>
                  <a:ext cx="212760" cy="944280"/>
                  <a:chOff x="1422360" y="2447640"/>
                  <a:chExt cx="212760" cy="944280"/>
                </a:xfrm>
              </p:grpSpPr>
              <p:sp>
                <p:nvSpPr>
                  <p:cNvPr id="284" name="Line 428"/>
                  <p:cNvSpPr/>
                  <p:nvPr/>
                </p:nvSpPr>
                <p:spPr>
                  <a:xfrm flipV="1">
                    <a:off x="1635120" y="2447640"/>
                    <a:ext cx="0" cy="92340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85" name="Group 429"/>
                  <p:cNvGrpSpPr/>
                  <p:nvPr/>
                </p:nvGrpSpPr>
                <p:grpSpPr>
                  <a:xfrm>
                    <a:off x="1495440" y="2465640"/>
                    <a:ext cx="84600" cy="926280"/>
                    <a:chOff x="1495440" y="2465640"/>
                    <a:chExt cx="84600" cy="926280"/>
                  </a:xfrm>
                </p:grpSpPr>
                <p:sp>
                  <p:nvSpPr>
                    <p:cNvPr id="286" name="Rectangle 430"/>
                    <p:cNvSpPr/>
                    <p:nvPr/>
                  </p:nvSpPr>
                  <p:spPr>
                    <a:xfrm>
                      <a:off x="1558080" y="334584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7" name="Rectangle 431"/>
                    <p:cNvSpPr/>
                    <p:nvPr/>
                  </p:nvSpPr>
                  <p:spPr>
                    <a:xfrm>
                      <a:off x="1527120" y="31705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8" name="Rectangle 432"/>
                    <p:cNvSpPr/>
                    <p:nvPr/>
                  </p:nvSpPr>
                  <p:spPr>
                    <a:xfrm>
                      <a:off x="1527120" y="29955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9" name="Rectangle 433"/>
                    <p:cNvSpPr/>
                    <p:nvPr/>
                  </p:nvSpPr>
                  <p:spPr>
                    <a:xfrm>
                      <a:off x="1527120" y="28162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0" name="Rectangle 434"/>
                    <p:cNvSpPr/>
                    <p:nvPr/>
                  </p:nvSpPr>
                  <p:spPr>
                    <a:xfrm>
                      <a:off x="1527120" y="26413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1" name="Rectangle 435"/>
                    <p:cNvSpPr/>
                    <p:nvPr/>
                  </p:nvSpPr>
                  <p:spPr>
                    <a:xfrm>
                      <a:off x="1495440" y="246564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92" name="Group 436"/>
                  <p:cNvGrpSpPr/>
                  <p:nvPr/>
                </p:nvGrpSpPr>
                <p:grpSpPr>
                  <a:xfrm>
                    <a:off x="1607760" y="2490840"/>
                    <a:ext cx="26280" cy="880200"/>
                    <a:chOff x="1607760" y="2490840"/>
                    <a:chExt cx="26280" cy="880200"/>
                  </a:xfrm>
                </p:grpSpPr>
                <p:sp>
                  <p:nvSpPr>
                    <p:cNvPr id="293" name="Line 437"/>
                    <p:cNvSpPr/>
                    <p:nvPr/>
                  </p:nvSpPr>
                  <p:spPr>
                    <a:xfrm flipH="1">
                      <a:off x="1607760" y="337104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4" name="Line 438"/>
                    <p:cNvSpPr/>
                    <p:nvPr/>
                  </p:nvSpPr>
                  <p:spPr>
                    <a:xfrm flipH="1">
                      <a:off x="1625760" y="33282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5" name="Line 439"/>
                    <p:cNvSpPr/>
                    <p:nvPr/>
                  </p:nvSpPr>
                  <p:spPr>
                    <a:xfrm flipH="1">
                      <a:off x="1625760" y="32850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6" name="Line 440"/>
                    <p:cNvSpPr/>
                    <p:nvPr/>
                  </p:nvSpPr>
                  <p:spPr>
                    <a:xfrm flipH="1">
                      <a:off x="1625760" y="323856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7" name="Line 441"/>
                    <p:cNvSpPr/>
                    <p:nvPr/>
                  </p:nvSpPr>
                  <p:spPr>
                    <a:xfrm flipH="1">
                      <a:off x="1607760" y="319572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8" name="Line 442"/>
                    <p:cNvSpPr/>
                    <p:nvPr/>
                  </p:nvSpPr>
                  <p:spPr>
                    <a:xfrm flipH="1">
                      <a:off x="1625760" y="315288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9" name="Line 443"/>
                    <p:cNvSpPr/>
                    <p:nvPr/>
                  </p:nvSpPr>
                  <p:spPr>
                    <a:xfrm flipH="1">
                      <a:off x="1625760" y="310608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0" name="Line 444"/>
                    <p:cNvSpPr/>
                    <p:nvPr/>
                  </p:nvSpPr>
                  <p:spPr>
                    <a:xfrm flipH="1">
                      <a:off x="1625760" y="306324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1" name="Line 445"/>
                    <p:cNvSpPr/>
                    <p:nvPr/>
                  </p:nvSpPr>
                  <p:spPr>
                    <a:xfrm flipH="1">
                      <a:off x="1607760" y="302076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2" name="Line 446"/>
                    <p:cNvSpPr/>
                    <p:nvPr/>
                  </p:nvSpPr>
                  <p:spPr>
                    <a:xfrm flipH="1">
                      <a:off x="1625760" y="297396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3" name="Line 447"/>
                    <p:cNvSpPr/>
                    <p:nvPr/>
                  </p:nvSpPr>
                  <p:spPr>
                    <a:xfrm flipH="1">
                      <a:off x="1625760" y="293076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4" name="Line 448"/>
                    <p:cNvSpPr/>
                    <p:nvPr/>
                  </p:nvSpPr>
                  <p:spPr>
                    <a:xfrm flipH="1">
                      <a:off x="1625760" y="288792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5" name="Line 449"/>
                    <p:cNvSpPr/>
                    <p:nvPr/>
                  </p:nvSpPr>
                  <p:spPr>
                    <a:xfrm flipH="1">
                      <a:off x="1607760" y="284148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6" name="Line 450"/>
                    <p:cNvSpPr/>
                    <p:nvPr/>
                  </p:nvSpPr>
                  <p:spPr>
                    <a:xfrm flipH="1">
                      <a:off x="1625760" y="279864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7" name="Line 451"/>
                    <p:cNvSpPr/>
                    <p:nvPr/>
                  </p:nvSpPr>
                  <p:spPr>
                    <a:xfrm flipH="1">
                      <a:off x="1625760" y="27558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8" name="Line 452"/>
                    <p:cNvSpPr/>
                    <p:nvPr/>
                  </p:nvSpPr>
                  <p:spPr>
                    <a:xfrm flipH="1">
                      <a:off x="1625760" y="27090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9" name="Line 453"/>
                    <p:cNvSpPr/>
                    <p:nvPr/>
                  </p:nvSpPr>
                  <p:spPr>
                    <a:xfrm flipH="1">
                      <a:off x="1607760" y="266580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0" name="Line 454"/>
                    <p:cNvSpPr/>
                    <p:nvPr/>
                  </p:nvSpPr>
                  <p:spPr>
                    <a:xfrm flipH="1">
                      <a:off x="1625760" y="262332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1" name="Line 455"/>
                    <p:cNvSpPr/>
                    <p:nvPr/>
                  </p:nvSpPr>
                  <p:spPr>
                    <a:xfrm flipH="1">
                      <a:off x="1625760" y="257652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2" name="Line 456"/>
                    <p:cNvSpPr/>
                    <p:nvPr/>
                  </p:nvSpPr>
                  <p:spPr>
                    <a:xfrm flipH="1">
                      <a:off x="1625760" y="253368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3" name="Line 457"/>
                    <p:cNvSpPr/>
                    <p:nvPr/>
                  </p:nvSpPr>
                  <p:spPr>
                    <a:xfrm flipH="1">
                      <a:off x="1607760" y="249084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14" name="Rectangle 458"/>
                  <p:cNvSpPr/>
                  <p:nvPr/>
                </p:nvSpPr>
                <p:spPr>
                  <a:xfrm rot="16200000">
                    <a:off x="1241280" y="3176280"/>
                    <a:ext cx="364680" cy="2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 vert="eaVer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315" name="Group 459"/>
              <p:cNvGrpSpPr/>
              <p:nvPr/>
            </p:nvGrpSpPr>
            <p:grpSpPr>
              <a:xfrm>
                <a:off x="1646280" y="2494080"/>
                <a:ext cx="1147320" cy="870840"/>
                <a:chOff x="1646280" y="2494080"/>
                <a:chExt cx="1147320" cy="870840"/>
              </a:xfrm>
            </p:grpSpPr>
            <p:sp>
              <p:nvSpPr>
                <p:cNvPr id="316" name="Freeform 460"/>
                <p:cNvSpPr/>
                <p:nvPr/>
              </p:nvSpPr>
              <p:spPr>
                <a:xfrm>
                  <a:off x="1646280" y="2494080"/>
                  <a:ext cx="1147320" cy="867240"/>
                </a:xfrm>
                <a:custGeom>
                  <a:avLst/>
                  <a:gdLst>
                    <a:gd name="textAreaLeft" fmla="*/ 0 w 1147320"/>
                    <a:gd name="textAreaRight" fmla="*/ 1147680 w 1147320"/>
                    <a:gd name="textAreaTop" fmla="*/ 0 h 867240"/>
                    <a:gd name="textAreaBottom" fmla="*/ 867600 h 867240"/>
                  </a:gdLst>
                  <a:ahLst/>
                  <a:rect l="textAreaLeft" t="textAreaTop" r="textAreaRight" b="textAreaBottom"/>
                  <a:pathLst>
                    <a:path w="510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  <a:lnTo>
                        <a:pt x="510" y="486"/>
                      </a:lnTo>
                      <a:lnTo>
                        <a:pt x="0" y="486"/>
                      </a:lnTo>
                      <a:close/>
                    </a:path>
                  </a:pathLst>
                </a:custGeom>
                <a:solidFill>
                  <a:srgbClr val="e8e8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Freeform 461"/>
                <p:cNvSpPr/>
                <p:nvPr/>
              </p:nvSpPr>
              <p:spPr>
                <a:xfrm>
                  <a:off x="1650600" y="2497680"/>
                  <a:ext cx="1142640" cy="867240"/>
                </a:xfrm>
                <a:custGeom>
                  <a:avLst/>
                  <a:gdLst>
                    <a:gd name="textAreaLeft" fmla="*/ 0 w 1142640"/>
                    <a:gd name="textAreaRight" fmla="*/ 1143000 w 1142640"/>
                    <a:gd name="textAreaTop" fmla="*/ 0 h 867240"/>
                    <a:gd name="textAreaBottom" fmla="*/ 867600 h 867240"/>
                  </a:gdLst>
                  <a:ahLst/>
                  <a:rect l="textAreaLeft" t="textAreaTop" r="textAreaRight" b="textAreaBottom"/>
                  <a:pathLst>
                    <a:path w="508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</a:path>
                  </a:pathLst>
                </a:custGeom>
                <a:noFill/>
                <a:ln w="6480">
                  <a:solidFill>
                    <a:srgbClr val="b3b3b3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18" name="Freeform 462"/>
              <p:cNvSpPr/>
              <p:nvPr/>
            </p:nvSpPr>
            <p:spPr>
              <a:xfrm>
                <a:off x="1650960" y="2496960"/>
                <a:ext cx="1143000" cy="868320"/>
              </a:xfrm>
              <a:custGeom>
                <a:avLst/>
                <a:gdLst>
                  <a:gd name="textAreaLeft" fmla="*/ 0 w 1143000"/>
                  <a:gd name="textAreaRight" fmla="*/ 1143360 w 1143000"/>
                  <a:gd name="textAreaTop" fmla="*/ 0 h 868320"/>
                  <a:gd name="textAreaBottom" fmla="*/ 868680 h 86832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2" y="486"/>
                    </a:lnTo>
                    <a:lnTo>
                      <a:pt x="4" y="486"/>
                    </a:lnTo>
                    <a:lnTo>
                      <a:pt x="6" y="486"/>
                    </a:lnTo>
                    <a:lnTo>
                      <a:pt x="8" y="486"/>
                    </a:lnTo>
                    <a:lnTo>
                      <a:pt x="10" y="486"/>
                    </a:lnTo>
                    <a:lnTo>
                      <a:pt x="12" y="486"/>
                    </a:lnTo>
                    <a:lnTo>
                      <a:pt x="14" y="486"/>
                    </a:lnTo>
                    <a:lnTo>
                      <a:pt x="16" y="486"/>
                    </a:lnTo>
                    <a:lnTo>
                      <a:pt x="18" y="486"/>
                    </a:lnTo>
                    <a:lnTo>
                      <a:pt x="20" y="486"/>
                    </a:lnTo>
                    <a:lnTo>
                      <a:pt x="22" y="486"/>
                    </a:lnTo>
                    <a:lnTo>
                      <a:pt x="24" y="484"/>
                    </a:lnTo>
                    <a:lnTo>
                      <a:pt x="26" y="484"/>
                    </a:lnTo>
                    <a:lnTo>
                      <a:pt x="28" y="484"/>
                    </a:lnTo>
                    <a:lnTo>
                      <a:pt x="30" y="484"/>
                    </a:lnTo>
                    <a:lnTo>
                      <a:pt x="32" y="484"/>
                    </a:lnTo>
                    <a:lnTo>
                      <a:pt x="34" y="484"/>
                    </a:lnTo>
                    <a:lnTo>
                      <a:pt x="36" y="484"/>
                    </a:lnTo>
                    <a:lnTo>
                      <a:pt x="38" y="484"/>
                    </a:lnTo>
                    <a:lnTo>
                      <a:pt x="40" y="484"/>
                    </a:lnTo>
                    <a:lnTo>
                      <a:pt x="42" y="484"/>
                    </a:lnTo>
                    <a:lnTo>
                      <a:pt x="44" y="484"/>
                    </a:lnTo>
                    <a:lnTo>
                      <a:pt x="46" y="484"/>
                    </a:lnTo>
                    <a:lnTo>
                      <a:pt x="48" y="484"/>
                    </a:lnTo>
                    <a:lnTo>
                      <a:pt x="50" y="484"/>
                    </a:lnTo>
                    <a:lnTo>
                      <a:pt x="52" y="484"/>
                    </a:lnTo>
                    <a:lnTo>
                      <a:pt x="54" y="484"/>
                    </a:lnTo>
                    <a:lnTo>
                      <a:pt x="56" y="484"/>
                    </a:lnTo>
                    <a:lnTo>
                      <a:pt x="58" y="484"/>
                    </a:lnTo>
                    <a:lnTo>
                      <a:pt x="60" y="484"/>
                    </a:lnTo>
                    <a:lnTo>
                      <a:pt x="62" y="484"/>
                    </a:lnTo>
                    <a:lnTo>
                      <a:pt x="64" y="484"/>
                    </a:lnTo>
                    <a:lnTo>
                      <a:pt x="66" y="484"/>
                    </a:lnTo>
                    <a:lnTo>
                      <a:pt x="68" y="484"/>
                    </a:lnTo>
                    <a:lnTo>
                      <a:pt x="70" y="484"/>
                    </a:lnTo>
                    <a:lnTo>
                      <a:pt x="72" y="484"/>
                    </a:lnTo>
                    <a:lnTo>
                      <a:pt x="74" y="484"/>
                    </a:lnTo>
                    <a:lnTo>
                      <a:pt x="76" y="484"/>
                    </a:lnTo>
                    <a:lnTo>
                      <a:pt x="78" y="484"/>
                    </a:lnTo>
                    <a:lnTo>
                      <a:pt x="80" y="484"/>
                    </a:lnTo>
                    <a:lnTo>
                      <a:pt x="82" y="484"/>
                    </a:lnTo>
                    <a:lnTo>
                      <a:pt x="84" y="484"/>
                    </a:lnTo>
                    <a:lnTo>
                      <a:pt x="86" y="484"/>
                    </a:lnTo>
                    <a:lnTo>
                      <a:pt x="88" y="484"/>
                    </a:lnTo>
                    <a:lnTo>
                      <a:pt x="90" y="484"/>
                    </a:lnTo>
                    <a:lnTo>
                      <a:pt x="92" y="484"/>
                    </a:lnTo>
                    <a:lnTo>
                      <a:pt x="94" y="484"/>
                    </a:lnTo>
                    <a:lnTo>
                      <a:pt x="96" y="484"/>
                    </a:lnTo>
                    <a:lnTo>
                      <a:pt x="98" y="484"/>
                    </a:lnTo>
                    <a:lnTo>
                      <a:pt x="100" y="484"/>
                    </a:lnTo>
                    <a:lnTo>
                      <a:pt x="102" y="484"/>
                    </a:lnTo>
                    <a:lnTo>
                      <a:pt x="104" y="484"/>
                    </a:lnTo>
                    <a:lnTo>
                      <a:pt x="106" y="484"/>
                    </a:lnTo>
                    <a:lnTo>
                      <a:pt x="108" y="484"/>
                    </a:lnTo>
                    <a:lnTo>
                      <a:pt x="110" y="484"/>
                    </a:lnTo>
                    <a:lnTo>
                      <a:pt x="112" y="484"/>
                    </a:lnTo>
                    <a:lnTo>
                      <a:pt x="114" y="484"/>
                    </a:lnTo>
                    <a:lnTo>
                      <a:pt x="116" y="482"/>
                    </a:lnTo>
                    <a:lnTo>
                      <a:pt x="118" y="482"/>
                    </a:lnTo>
                    <a:lnTo>
                      <a:pt x="120" y="482"/>
                    </a:lnTo>
                    <a:lnTo>
                      <a:pt x="122" y="482"/>
                    </a:lnTo>
                    <a:lnTo>
                      <a:pt x="124" y="480"/>
                    </a:lnTo>
                    <a:lnTo>
                      <a:pt x="126" y="480"/>
                    </a:lnTo>
                    <a:lnTo>
                      <a:pt x="128" y="480"/>
                    </a:lnTo>
                    <a:lnTo>
                      <a:pt x="130" y="480"/>
                    </a:lnTo>
                    <a:lnTo>
                      <a:pt x="132" y="478"/>
                    </a:lnTo>
                    <a:lnTo>
                      <a:pt x="134" y="478"/>
                    </a:lnTo>
                    <a:lnTo>
                      <a:pt x="136" y="478"/>
                    </a:lnTo>
                    <a:lnTo>
                      <a:pt x="138" y="476"/>
                    </a:lnTo>
                    <a:lnTo>
                      <a:pt x="140" y="474"/>
                    </a:lnTo>
                    <a:lnTo>
                      <a:pt x="142" y="472"/>
                    </a:lnTo>
                    <a:lnTo>
                      <a:pt x="144" y="470"/>
                    </a:lnTo>
                    <a:lnTo>
                      <a:pt x="146" y="468"/>
                    </a:lnTo>
                    <a:lnTo>
                      <a:pt x="148" y="466"/>
                    </a:lnTo>
                    <a:lnTo>
                      <a:pt x="150" y="464"/>
                    </a:lnTo>
                    <a:lnTo>
                      <a:pt x="152" y="462"/>
                    </a:lnTo>
                    <a:lnTo>
                      <a:pt x="154" y="460"/>
                    </a:lnTo>
                    <a:lnTo>
                      <a:pt x="156" y="456"/>
                    </a:lnTo>
                    <a:lnTo>
                      <a:pt x="158" y="452"/>
                    </a:lnTo>
                    <a:lnTo>
                      <a:pt x="160" y="446"/>
                    </a:lnTo>
                    <a:lnTo>
                      <a:pt x="162" y="442"/>
                    </a:lnTo>
                    <a:lnTo>
                      <a:pt x="164" y="434"/>
                    </a:lnTo>
                    <a:lnTo>
                      <a:pt x="166" y="426"/>
                    </a:lnTo>
                    <a:lnTo>
                      <a:pt x="168" y="418"/>
                    </a:lnTo>
                    <a:lnTo>
                      <a:pt x="170" y="408"/>
                    </a:lnTo>
                    <a:lnTo>
                      <a:pt x="172" y="398"/>
                    </a:lnTo>
                    <a:lnTo>
                      <a:pt x="174" y="380"/>
                    </a:lnTo>
                    <a:lnTo>
                      <a:pt x="176" y="358"/>
                    </a:lnTo>
                    <a:lnTo>
                      <a:pt x="178" y="342"/>
                    </a:lnTo>
                    <a:lnTo>
                      <a:pt x="180" y="318"/>
                    </a:lnTo>
                    <a:lnTo>
                      <a:pt x="182" y="294"/>
                    </a:lnTo>
                    <a:lnTo>
                      <a:pt x="184" y="272"/>
                    </a:lnTo>
                    <a:lnTo>
                      <a:pt x="186" y="252"/>
                    </a:lnTo>
                    <a:lnTo>
                      <a:pt x="188" y="228"/>
                    </a:lnTo>
                    <a:lnTo>
                      <a:pt x="190" y="200"/>
                    </a:lnTo>
                    <a:lnTo>
                      <a:pt x="192" y="172"/>
                    </a:lnTo>
                    <a:lnTo>
                      <a:pt x="194" y="124"/>
                    </a:lnTo>
                    <a:lnTo>
                      <a:pt x="196" y="66"/>
                    </a:lnTo>
                    <a:lnTo>
                      <a:pt x="198" y="62"/>
                    </a:lnTo>
                    <a:lnTo>
                      <a:pt x="200" y="92"/>
                    </a:lnTo>
                    <a:lnTo>
                      <a:pt x="202" y="82"/>
                    </a:lnTo>
                    <a:lnTo>
                      <a:pt x="204" y="48"/>
                    </a:lnTo>
                    <a:lnTo>
                      <a:pt x="206" y="16"/>
                    </a:lnTo>
                    <a:lnTo>
                      <a:pt x="208" y="0"/>
                    </a:lnTo>
                    <a:lnTo>
                      <a:pt x="210" y="8"/>
                    </a:lnTo>
                    <a:lnTo>
                      <a:pt x="212" y="34"/>
                    </a:lnTo>
                    <a:lnTo>
                      <a:pt x="214" y="68"/>
                    </a:lnTo>
                    <a:lnTo>
                      <a:pt x="216" y="78"/>
                    </a:lnTo>
                    <a:lnTo>
                      <a:pt x="218" y="52"/>
                    </a:lnTo>
                    <a:lnTo>
                      <a:pt x="220" y="74"/>
                    </a:lnTo>
                    <a:lnTo>
                      <a:pt x="222" y="114"/>
                    </a:lnTo>
                    <a:lnTo>
                      <a:pt x="224" y="140"/>
                    </a:lnTo>
                    <a:lnTo>
                      <a:pt x="226" y="176"/>
                    </a:lnTo>
                    <a:lnTo>
                      <a:pt x="228" y="206"/>
                    </a:lnTo>
                    <a:lnTo>
                      <a:pt x="230" y="216"/>
                    </a:lnTo>
                    <a:lnTo>
                      <a:pt x="232" y="232"/>
                    </a:lnTo>
                    <a:lnTo>
                      <a:pt x="234" y="258"/>
                    </a:lnTo>
                    <a:lnTo>
                      <a:pt x="236" y="274"/>
                    </a:lnTo>
                    <a:lnTo>
                      <a:pt x="238" y="292"/>
                    </a:lnTo>
                    <a:lnTo>
                      <a:pt x="240" y="312"/>
                    </a:lnTo>
                    <a:lnTo>
                      <a:pt x="242" y="322"/>
                    </a:lnTo>
                    <a:lnTo>
                      <a:pt x="244" y="326"/>
                    </a:lnTo>
                    <a:lnTo>
                      <a:pt x="246" y="330"/>
                    </a:lnTo>
                    <a:lnTo>
                      <a:pt x="248" y="340"/>
                    </a:lnTo>
                    <a:lnTo>
                      <a:pt x="250" y="358"/>
                    </a:lnTo>
                    <a:lnTo>
                      <a:pt x="252" y="362"/>
                    </a:lnTo>
                    <a:lnTo>
                      <a:pt x="254" y="356"/>
                    </a:lnTo>
                    <a:lnTo>
                      <a:pt x="256" y="352"/>
                    </a:lnTo>
                    <a:lnTo>
                      <a:pt x="258" y="356"/>
                    </a:lnTo>
                    <a:lnTo>
                      <a:pt x="260" y="362"/>
                    </a:lnTo>
                    <a:lnTo>
                      <a:pt x="262" y="366"/>
                    </a:lnTo>
                    <a:lnTo>
                      <a:pt x="264" y="370"/>
                    </a:lnTo>
                    <a:lnTo>
                      <a:pt x="266" y="378"/>
                    </a:lnTo>
                    <a:lnTo>
                      <a:pt x="268" y="392"/>
                    </a:lnTo>
                    <a:lnTo>
                      <a:pt x="270" y="402"/>
                    </a:lnTo>
                    <a:lnTo>
                      <a:pt x="272" y="404"/>
                    </a:lnTo>
                    <a:lnTo>
                      <a:pt x="274" y="402"/>
                    </a:lnTo>
                    <a:lnTo>
                      <a:pt x="276" y="402"/>
                    </a:lnTo>
                    <a:lnTo>
                      <a:pt x="278" y="400"/>
                    </a:lnTo>
                    <a:lnTo>
                      <a:pt x="280" y="398"/>
                    </a:lnTo>
                    <a:lnTo>
                      <a:pt x="282" y="398"/>
                    </a:lnTo>
                    <a:lnTo>
                      <a:pt x="284" y="400"/>
                    </a:lnTo>
                    <a:lnTo>
                      <a:pt x="286" y="400"/>
                    </a:lnTo>
                    <a:lnTo>
                      <a:pt x="288" y="402"/>
                    </a:lnTo>
                    <a:lnTo>
                      <a:pt x="290" y="408"/>
                    </a:lnTo>
                    <a:lnTo>
                      <a:pt x="292" y="412"/>
                    </a:lnTo>
                    <a:lnTo>
                      <a:pt x="294" y="416"/>
                    </a:lnTo>
                    <a:lnTo>
                      <a:pt x="296" y="416"/>
                    </a:lnTo>
                    <a:lnTo>
                      <a:pt x="298" y="416"/>
                    </a:lnTo>
                    <a:lnTo>
                      <a:pt x="300" y="416"/>
                    </a:lnTo>
                    <a:lnTo>
                      <a:pt x="302" y="418"/>
                    </a:lnTo>
                    <a:lnTo>
                      <a:pt x="304" y="422"/>
                    </a:lnTo>
                    <a:lnTo>
                      <a:pt x="306" y="424"/>
                    </a:lnTo>
                    <a:lnTo>
                      <a:pt x="308" y="424"/>
                    </a:lnTo>
                    <a:lnTo>
                      <a:pt x="310" y="426"/>
                    </a:lnTo>
                    <a:lnTo>
                      <a:pt x="312" y="428"/>
                    </a:lnTo>
                    <a:lnTo>
                      <a:pt x="314" y="428"/>
                    </a:lnTo>
                    <a:lnTo>
                      <a:pt x="316" y="430"/>
                    </a:lnTo>
                    <a:lnTo>
                      <a:pt x="318" y="434"/>
                    </a:lnTo>
                    <a:lnTo>
                      <a:pt x="320" y="440"/>
                    </a:lnTo>
                    <a:lnTo>
                      <a:pt x="322" y="446"/>
                    </a:lnTo>
                    <a:lnTo>
                      <a:pt x="324" y="450"/>
                    </a:lnTo>
                    <a:lnTo>
                      <a:pt x="326" y="454"/>
                    </a:lnTo>
                    <a:lnTo>
                      <a:pt x="328" y="456"/>
                    </a:lnTo>
                    <a:lnTo>
                      <a:pt x="330" y="458"/>
                    </a:lnTo>
                    <a:lnTo>
                      <a:pt x="332" y="460"/>
                    </a:lnTo>
                    <a:lnTo>
                      <a:pt x="334" y="464"/>
                    </a:lnTo>
                    <a:lnTo>
                      <a:pt x="336" y="466"/>
                    </a:lnTo>
                    <a:lnTo>
                      <a:pt x="338" y="466"/>
                    </a:lnTo>
                    <a:lnTo>
                      <a:pt x="340" y="468"/>
                    </a:lnTo>
                    <a:lnTo>
                      <a:pt x="342" y="470"/>
                    </a:lnTo>
                    <a:lnTo>
                      <a:pt x="344" y="470"/>
                    </a:lnTo>
                    <a:lnTo>
                      <a:pt x="346" y="472"/>
                    </a:lnTo>
                    <a:lnTo>
                      <a:pt x="348" y="472"/>
                    </a:lnTo>
                    <a:lnTo>
                      <a:pt x="350" y="472"/>
                    </a:lnTo>
                    <a:lnTo>
                      <a:pt x="352" y="472"/>
                    </a:lnTo>
                    <a:lnTo>
                      <a:pt x="354" y="474"/>
                    </a:lnTo>
                    <a:lnTo>
                      <a:pt x="356" y="474"/>
                    </a:lnTo>
                    <a:lnTo>
                      <a:pt x="358" y="474"/>
                    </a:lnTo>
                    <a:lnTo>
                      <a:pt x="360" y="474"/>
                    </a:lnTo>
                    <a:lnTo>
                      <a:pt x="362" y="474"/>
                    </a:lnTo>
                    <a:lnTo>
                      <a:pt x="364" y="476"/>
                    </a:lnTo>
                    <a:lnTo>
                      <a:pt x="366" y="476"/>
                    </a:lnTo>
                    <a:lnTo>
                      <a:pt x="368" y="476"/>
                    </a:lnTo>
                    <a:lnTo>
                      <a:pt x="370" y="478"/>
                    </a:lnTo>
                    <a:lnTo>
                      <a:pt x="372" y="478"/>
                    </a:lnTo>
                    <a:lnTo>
                      <a:pt x="374" y="478"/>
                    </a:lnTo>
                    <a:lnTo>
                      <a:pt x="376" y="478"/>
                    </a:lnTo>
                    <a:lnTo>
                      <a:pt x="378" y="480"/>
                    </a:lnTo>
                    <a:lnTo>
                      <a:pt x="380" y="480"/>
                    </a:lnTo>
                    <a:lnTo>
                      <a:pt x="382" y="480"/>
                    </a:lnTo>
                    <a:lnTo>
                      <a:pt x="384" y="480"/>
                    </a:lnTo>
                    <a:lnTo>
                      <a:pt x="386" y="480"/>
                    </a:lnTo>
                    <a:lnTo>
                      <a:pt x="388" y="482"/>
                    </a:lnTo>
                    <a:lnTo>
                      <a:pt x="390" y="482"/>
                    </a:lnTo>
                    <a:lnTo>
                      <a:pt x="392" y="482"/>
                    </a:lnTo>
                    <a:lnTo>
                      <a:pt x="394" y="482"/>
                    </a:lnTo>
                    <a:lnTo>
                      <a:pt x="396" y="482"/>
                    </a:lnTo>
                    <a:lnTo>
                      <a:pt x="398" y="484"/>
                    </a:lnTo>
                    <a:lnTo>
                      <a:pt x="400" y="484"/>
                    </a:lnTo>
                    <a:lnTo>
                      <a:pt x="402" y="484"/>
                    </a:lnTo>
                    <a:lnTo>
                      <a:pt x="404" y="484"/>
                    </a:lnTo>
                    <a:lnTo>
                      <a:pt x="406" y="484"/>
                    </a:lnTo>
                    <a:lnTo>
                      <a:pt x="408" y="484"/>
                    </a:lnTo>
                    <a:lnTo>
                      <a:pt x="410" y="484"/>
                    </a:lnTo>
                    <a:lnTo>
                      <a:pt x="412" y="484"/>
                    </a:lnTo>
                    <a:lnTo>
                      <a:pt x="414" y="484"/>
                    </a:lnTo>
                    <a:lnTo>
                      <a:pt x="416" y="484"/>
                    </a:lnTo>
                    <a:lnTo>
                      <a:pt x="418" y="484"/>
                    </a:lnTo>
                    <a:lnTo>
                      <a:pt x="420" y="484"/>
                    </a:lnTo>
                    <a:lnTo>
                      <a:pt x="422" y="484"/>
                    </a:lnTo>
                    <a:lnTo>
                      <a:pt x="424" y="486"/>
                    </a:lnTo>
                    <a:lnTo>
                      <a:pt x="426" y="486"/>
                    </a:lnTo>
                    <a:lnTo>
                      <a:pt x="428" y="486"/>
                    </a:lnTo>
                    <a:lnTo>
                      <a:pt x="430" y="486"/>
                    </a:lnTo>
                    <a:lnTo>
                      <a:pt x="432" y="486"/>
                    </a:lnTo>
                    <a:lnTo>
                      <a:pt x="434" y="486"/>
                    </a:lnTo>
                    <a:lnTo>
                      <a:pt x="436" y="486"/>
                    </a:lnTo>
                    <a:lnTo>
                      <a:pt x="438" y="486"/>
                    </a:lnTo>
                    <a:lnTo>
                      <a:pt x="440" y="486"/>
                    </a:lnTo>
                    <a:lnTo>
                      <a:pt x="442" y="486"/>
                    </a:lnTo>
                    <a:lnTo>
                      <a:pt x="444" y="486"/>
                    </a:lnTo>
                    <a:lnTo>
                      <a:pt x="446" y="486"/>
                    </a:lnTo>
                    <a:lnTo>
                      <a:pt x="448" y="486"/>
                    </a:lnTo>
                    <a:lnTo>
                      <a:pt x="450" y="486"/>
                    </a:lnTo>
                    <a:lnTo>
                      <a:pt x="452" y="486"/>
                    </a:lnTo>
                    <a:lnTo>
                      <a:pt x="454" y="486"/>
                    </a:lnTo>
                    <a:lnTo>
                      <a:pt x="456" y="486"/>
                    </a:lnTo>
                    <a:lnTo>
                      <a:pt x="458" y="486"/>
                    </a:lnTo>
                    <a:lnTo>
                      <a:pt x="460" y="486"/>
                    </a:lnTo>
                    <a:lnTo>
                      <a:pt x="462" y="486"/>
                    </a:lnTo>
                    <a:lnTo>
                      <a:pt x="464" y="486"/>
                    </a:lnTo>
                    <a:lnTo>
                      <a:pt x="466" y="486"/>
                    </a:lnTo>
                    <a:lnTo>
                      <a:pt x="468" y="486"/>
                    </a:lnTo>
                    <a:lnTo>
                      <a:pt x="470" y="486"/>
                    </a:lnTo>
                    <a:lnTo>
                      <a:pt x="472" y="486"/>
                    </a:lnTo>
                    <a:lnTo>
                      <a:pt x="474" y="486"/>
                    </a:lnTo>
                    <a:lnTo>
                      <a:pt x="476" y="486"/>
                    </a:lnTo>
                    <a:lnTo>
                      <a:pt x="478" y="486"/>
                    </a:lnTo>
                    <a:lnTo>
                      <a:pt x="480" y="486"/>
                    </a:lnTo>
                    <a:lnTo>
                      <a:pt x="482" y="486"/>
                    </a:lnTo>
                    <a:lnTo>
                      <a:pt x="484" y="486"/>
                    </a:lnTo>
                    <a:lnTo>
                      <a:pt x="486" y="486"/>
                    </a:lnTo>
                    <a:lnTo>
                      <a:pt x="488" y="486"/>
                    </a:lnTo>
                    <a:lnTo>
                      <a:pt x="490" y="486"/>
                    </a:lnTo>
                    <a:lnTo>
                      <a:pt x="492" y="486"/>
                    </a:lnTo>
                    <a:lnTo>
                      <a:pt x="494" y="486"/>
                    </a:lnTo>
                    <a:lnTo>
                      <a:pt x="496" y="486"/>
                    </a:lnTo>
                    <a:lnTo>
                      <a:pt x="498" y="486"/>
                    </a:lnTo>
                    <a:lnTo>
                      <a:pt x="500" y="486"/>
                    </a:lnTo>
                    <a:lnTo>
                      <a:pt x="502" y="486"/>
                    </a:lnTo>
                    <a:lnTo>
                      <a:pt x="504" y="486"/>
                    </a:lnTo>
                    <a:lnTo>
                      <a:pt x="506" y="486"/>
                    </a:lnTo>
                    <a:lnTo>
                      <a:pt x="508" y="486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9" name="Text Box 3832"/>
            <p:cNvSpPr/>
            <p:nvPr/>
          </p:nvSpPr>
          <p:spPr>
            <a:xfrm>
              <a:off x="2108520" y="2433600"/>
              <a:ext cx="70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99.2/87.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0" name="Group 3860"/>
          <p:cNvGrpSpPr/>
          <p:nvPr/>
        </p:nvGrpSpPr>
        <p:grpSpPr>
          <a:xfrm>
            <a:off x="1417680" y="3589200"/>
            <a:ext cx="1454400" cy="1381680"/>
            <a:chOff x="1417680" y="3589200"/>
            <a:chExt cx="1454400" cy="1381680"/>
          </a:xfrm>
        </p:grpSpPr>
        <p:grpSp>
          <p:nvGrpSpPr>
            <p:cNvPr id="321" name="Group 3853"/>
            <p:cNvGrpSpPr/>
            <p:nvPr/>
          </p:nvGrpSpPr>
          <p:grpSpPr>
            <a:xfrm>
              <a:off x="1417680" y="3589200"/>
              <a:ext cx="1409040" cy="1381680"/>
              <a:chOff x="1417680" y="3589200"/>
              <a:chExt cx="1409040" cy="1381680"/>
            </a:xfrm>
          </p:grpSpPr>
          <p:grpSp>
            <p:nvGrpSpPr>
              <p:cNvPr id="322" name="Group 191"/>
              <p:cNvGrpSpPr/>
              <p:nvPr/>
            </p:nvGrpSpPr>
            <p:grpSpPr>
              <a:xfrm>
                <a:off x="1417680" y="3589200"/>
                <a:ext cx="1409040" cy="1381680"/>
                <a:chOff x="1417680" y="3589200"/>
                <a:chExt cx="1409040" cy="1381680"/>
              </a:xfrm>
            </p:grpSpPr>
            <p:sp>
              <p:nvSpPr>
                <p:cNvPr id="323" name="Rectangle 192"/>
                <p:cNvSpPr/>
                <p:nvPr/>
              </p:nvSpPr>
              <p:spPr>
                <a:xfrm>
                  <a:off x="1632960" y="3590640"/>
                  <a:ext cx="1158120" cy="92448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24" name="Group 193"/>
                <p:cNvGrpSpPr/>
                <p:nvPr/>
              </p:nvGrpSpPr>
              <p:grpSpPr>
                <a:xfrm>
                  <a:off x="1584000" y="4512960"/>
                  <a:ext cx="1242720" cy="457920"/>
                  <a:chOff x="1584000" y="4512960"/>
                  <a:chExt cx="1242720" cy="457920"/>
                </a:xfrm>
              </p:grpSpPr>
              <p:sp>
                <p:nvSpPr>
                  <p:cNvPr id="325" name="Line 194"/>
                  <p:cNvSpPr/>
                  <p:nvPr/>
                </p:nvSpPr>
                <p:spPr>
                  <a:xfrm>
                    <a:off x="1630440" y="4512960"/>
                    <a:ext cx="115740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326" name="Group 195"/>
                  <p:cNvGrpSpPr/>
                  <p:nvPr/>
                </p:nvGrpSpPr>
                <p:grpSpPr>
                  <a:xfrm>
                    <a:off x="1630440" y="4516560"/>
                    <a:ext cx="1157040" cy="20880"/>
                    <a:chOff x="1630440" y="4516560"/>
                    <a:chExt cx="1157040" cy="20880"/>
                  </a:xfrm>
                </p:grpSpPr>
                <p:sp>
                  <p:nvSpPr>
                    <p:cNvPr id="327" name="Line 196"/>
                    <p:cNvSpPr/>
                    <p:nvPr/>
                  </p:nvSpPr>
                  <p:spPr>
                    <a:xfrm>
                      <a:off x="163044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8" name="Line 197"/>
                    <p:cNvSpPr/>
                    <p:nvPr/>
                  </p:nvSpPr>
                  <p:spPr>
                    <a:xfrm>
                      <a:off x="171576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29" name="Line 198"/>
                    <p:cNvSpPr/>
                    <p:nvPr/>
                  </p:nvSpPr>
                  <p:spPr>
                    <a:xfrm>
                      <a:off x="176508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0" name="Line 199"/>
                    <p:cNvSpPr/>
                    <p:nvPr/>
                  </p:nvSpPr>
                  <p:spPr>
                    <a:xfrm>
                      <a:off x="18007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1" name="Line 200"/>
                    <p:cNvSpPr/>
                    <p:nvPr/>
                  </p:nvSpPr>
                  <p:spPr>
                    <a:xfrm>
                      <a:off x="1832040" y="45165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2" name="Line 201"/>
                    <p:cNvSpPr/>
                    <p:nvPr/>
                  </p:nvSpPr>
                  <p:spPr>
                    <a:xfrm>
                      <a:off x="18547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3" name="Line 202"/>
                    <p:cNvSpPr/>
                    <p:nvPr/>
                  </p:nvSpPr>
                  <p:spPr>
                    <a:xfrm>
                      <a:off x="187236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4" name="Line 203"/>
                    <p:cNvSpPr/>
                    <p:nvPr/>
                  </p:nvSpPr>
                  <p:spPr>
                    <a:xfrm>
                      <a:off x="18907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5" name="Line 204"/>
                    <p:cNvSpPr/>
                    <p:nvPr/>
                  </p:nvSpPr>
                  <p:spPr>
                    <a:xfrm>
                      <a:off x="19040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6" name="Line 205"/>
                    <p:cNvSpPr/>
                    <p:nvPr/>
                  </p:nvSpPr>
                  <p:spPr>
                    <a:xfrm>
                      <a:off x="191700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7" name="Line 206"/>
                    <p:cNvSpPr/>
                    <p:nvPr/>
                  </p:nvSpPr>
                  <p:spPr>
                    <a:xfrm>
                      <a:off x="200736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8" name="Line 207"/>
                    <p:cNvSpPr/>
                    <p:nvPr/>
                  </p:nvSpPr>
                  <p:spPr>
                    <a:xfrm>
                      <a:off x="205668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9" name="Line 208"/>
                    <p:cNvSpPr/>
                    <p:nvPr/>
                  </p:nvSpPr>
                  <p:spPr>
                    <a:xfrm>
                      <a:off x="20923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0" name="Line 209"/>
                    <p:cNvSpPr/>
                    <p:nvPr/>
                  </p:nvSpPr>
                  <p:spPr>
                    <a:xfrm>
                      <a:off x="2118960" y="45165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1" name="Line 210"/>
                    <p:cNvSpPr/>
                    <p:nvPr/>
                  </p:nvSpPr>
                  <p:spPr>
                    <a:xfrm>
                      <a:off x="214596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2" name="Line 211"/>
                    <p:cNvSpPr/>
                    <p:nvPr/>
                  </p:nvSpPr>
                  <p:spPr>
                    <a:xfrm>
                      <a:off x="21643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3" name="Line 212"/>
                    <p:cNvSpPr/>
                    <p:nvPr/>
                  </p:nvSpPr>
                  <p:spPr>
                    <a:xfrm>
                      <a:off x="21823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4" name="Line 213"/>
                    <p:cNvSpPr/>
                    <p:nvPr/>
                  </p:nvSpPr>
                  <p:spPr>
                    <a:xfrm>
                      <a:off x="219528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5" name="Line 214"/>
                    <p:cNvSpPr/>
                    <p:nvPr/>
                  </p:nvSpPr>
                  <p:spPr>
                    <a:xfrm>
                      <a:off x="220932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6" name="Line 215"/>
                    <p:cNvSpPr/>
                    <p:nvPr/>
                  </p:nvSpPr>
                  <p:spPr>
                    <a:xfrm>
                      <a:off x="22939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7" name="Line 216"/>
                    <p:cNvSpPr/>
                    <p:nvPr/>
                  </p:nvSpPr>
                  <p:spPr>
                    <a:xfrm>
                      <a:off x="23479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8" name="Line 217"/>
                    <p:cNvSpPr/>
                    <p:nvPr/>
                  </p:nvSpPr>
                  <p:spPr>
                    <a:xfrm>
                      <a:off x="238428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9" name="Line 218"/>
                    <p:cNvSpPr/>
                    <p:nvPr/>
                  </p:nvSpPr>
                  <p:spPr>
                    <a:xfrm>
                      <a:off x="2410920" y="45165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0" name="Line 219"/>
                    <p:cNvSpPr/>
                    <p:nvPr/>
                  </p:nvSpPr>
                  <p:spPr>
                    <a:xfrm>
                      <a:off x="243360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1" name="Line 220"/>
                    <p:cNvSpPr/>
                    <p:nvPr/>
                  </p:nvSpPr>
                  <p:spPr>
                    <a:xfrm>
                      <a:off x="24559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2" name="Line 221"/>
                    <p:cNvSpPr/>
                    <p:nvPr/>
                  </p:nvSpPr>
                  <p:spPr>
                    <a:xfrm>
                      <a:off x="24692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3" name="Line 222"/>
                    <p:cNvSpPr/>
                    <p:nvPr/>
                  </p:nvSpPr>
                  <p:spPr>
                    <a:xfrm>
                      <a:off x="24872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4" name="Line 223"/>
                    <p:cNvSpPr/>
                    <p:nvPr/>
                  </p:nvSpPr>
                  <p:spPr>
                    <a:xfrm>
                      <a:off x="250056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5" name="Line 224"/>
                    <p:cNvSpPr/>
                    <p:nvPr/>
                  </p:nvSpPr>
                  <p:spPr>
                    <a:xfrm>
                      <a:off x="25862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6" name="Line 225"/>
                    <p:cNvSpPr/>
                    <p:nvPr/>
                  </p:nvSpPr>
                  <p:spPr>
                    <a:xfrm>
                      <a:off x="26395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7" name="Line 226"/>
                    <p:cNvSpPr/>
                    <p:nvPr/>
                  </p:nvSpPr>
                  <p:spPr>
                    <a:xfrm>
                      <a:off x="26755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8" name="Line 227"/>
                    <p:cNvSpPr/>
                    <p:nvPr/>
                  </p:nvSpPr>
                  <p:spPr>
                    <a:xfrm>
                      <a:off x="2702520" y="45165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9" name="Line 228"/>
                    <p:cNvSpPr/>
                    <p:nvPr/>
                  </p:nvSpPr>
                  <p:spPr>
                    <a:xfrm>
                      <a:off x="27248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0" name="Line 229"/>
                    <p:cNvSpPr/>
                    <p:nvPr/>
                  </p:nvSpPr>
                  <p:spPr>
                    <a:xfrm>
                      <a:off x="27428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1" name="Line 230"/>
                    <p:cNvSpPr/>
                    <p:nvPr/>
                  </p:nvSpPr>
                  <p:spPr>
                    <a:xfrm>
                      <a:off x="276120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2" name="Line 231"/>
                    <p:cNvSpPr/>
                    <p:nvPr/>
                  </p:nvSpPr>
                  <p:spPr>
                    <a:xfrm>
                      <a:off x="277416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3" name="Line 232"/>
                    <p:cNvSpPr/>
                    <p:nvPr/>
                  </p:nvSpPr>
                  <p:spPr>
                    <a:xfrm>
                      <a:off x="278748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364" name="Group 233"/>
                  <p:cNvGrpSpPr/>
                  <p:nvPr/>
                </p:nvGrpSpPr>
                <p:grpSpPr>
                  <a:xfrm>
                    <a:off x="1584000" y="4545360"/>
                    <a:ext cx="1242720" cy="60120"/>
                    <a:chOff x="1584000" y="4545360"/>
                    <a:chExt cx="1242720" cy="60120"/>
                  </a:xfrm>
                </p:grpSpPr>
                <p:sp>
                  <p:nvSpPr>
                    <p:cNvPr id="365" name="Rectangle 234"/>
                    <p:cNvSpPr/>
                    <p:nvPr/>
                  </p:nvSpPr>
                  <p:spPr>
                    <a:xfrm>
                      <a:off x="158400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6" name="Rectangle 235"/>
                    <p:cNvSpPr/>
                    <p:nvPr/>
                  </p:nvSpPr>
                  <p:spPr>
                    <a:xfrm>
                      <a:off x="164736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7" name="Rectangle 236"/>
                    <p:cNvSpPr/>
                    <p:nvPr/>
                  </p:nvSpPr>
                  <p:spPr>
                    <a:xfrm>
                      <a:off x="187092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8" name="Rectangle 237"/>
                    <p:cNvSpPr/>
                    <p:nvPr/>
                  </p:nvSpPr>
                  <p:spPr>
                    <a:xfrm>
                      <a:off x="193464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9" name="Rectangle 238"/>
                    <p:cNvSpPr/>
                    <p:nvPr/>
                  </p:nvSpPr>
                  <p:spPr>
                    <a:xfrm>
                      <a:off x="216360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70" name="Rectangle 239"/>
                    <p:cNvSpPr/>
                    <p:nvPr/>
                  </p:nvSpPr>
                  <p:spPr>
                    <a:xfrm>
                      <a:off x="222624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71" name="Rectangle 240"/>
                    <p:cNvSpPr/>
                    <p:nvPr/>
                  </p:nvSpPr>
                  <p:spPr>
                    <a:xfrm>
                      <a:off x="245412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72" name="Rectangle 241"/>
                    <p:cNvSpPr/>
                    <p:nvPr/>
                  </p:nvSpPr>
                  <p:spPr>
                    <a:xfrm>
                      <a:off x="251784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73" name="Rectangle 242"/>
                    <p:cNvSpPr/>
                    <p:nvPr/>
                  </p:nvSpPr>
                  <p:spPr>
                    <a:xfrm>
                      <a:off x="274248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74" name="Rectangle 243"/>
                    <p:cNvSpPr/>
                    <p:nvPr/>
                  </p:nvSpPr>
                  <p:spPr>
                    <a:xfrm>
                      <a:off x="280476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75" name="Rectangle 244"/>
                  <p:cNvSpPr/>
                  <p:nvPr/>
                </p:nvSpPr>
                <p:spPr>
                  <a:xfrm>
                    <a:off x="2133000" y="4605840"/>
                    <a:ext cx="1800" cy="365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76" name="Group 245"/>
                <p:cNvGrpSpPr/>
                <p:nvPr/>
              </p:nvGrpSpPr>
              <p:grpSpPr>
                <a:xfrm>
                  <a:off x="1417680" y="3589200"/>
                  <a:ext cx="212760" cy="944280"/>
                  <a:chOff x="1417680" y="3589200"/>
                  <a:chExt cx="212760" cy="944280"/>
                </a:xfrm>
              </p:grpSpPr>
              <p:sp>
                <p:nvSpPr>
                  <p:cNvPr id="377" name="Line 246"/>
                  <p:cNvSpPr/>
                  <p:nvPr/>
                </p:nvSpPr>
                <p:spPr>
                  <a:xfrm flipV="1">
                    <a:off x="1630440" y="3589200"/>
                    <a:ext cx="0" cy="92376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378" name="Group 247"/>
                  <p:cNvGrpSpPr/>
                  <p:nvPr/>
                </p:nvGrpSpPr>
                <p:grpSpPr>
                  <a:xfrm>
                    <a:off x="1490760" y="3606840"/>
                    <a:ext cx="84600" cy="926640"/>
                    <a:chOff x="1490760" y="3606840"/>
                    <a:chExt cx="84600" cy="926640"/>
                  </a:xfrm>
                </p:grpSpPr>
                <p:sp>
                  <p:nvSpPr>
                    <p:cNvPr id="379" name="Rectangle 248"/>
                    <p:cNvSpPr/>
                    <p:nvPr/>
                  </p:nvSpPr>
                  <p:spPr>
                    <a:xfrm>
                      <a:off x="1553400" y="44874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0" name="Rectangle 249"/>
                    <p:cNvSpPr/>
                    <p:nvPr/>
                  </p:nvSpPr>
                  <p:spPr>
                    <a:xfrm>
                      <a:off x="1522080" y="4312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1" name="Rectangle 250"/>
                    <p:cNvSpPr/>
                    <p:nvPr/>
                  </p:nvSpPr>
                  <p:spPr>
                    <a:xfrm>
                      <a:off x="1522080" y="41367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2" name="Rectangle 251"/>
                    <p:cNvSpPr/>
                    <p:nvPr/>
                  </p:nvSpPr>
                  <p:spPr>
                    <a:xfrm>
                      <a:off x="1522080" y="39574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3" name="Rectangle 252"/>
                    <p:cNvSpPr/>
                    <p:nvPr/>
                  </p:nvSpPr>
                  <p:spPr>
                    <a:xfrm>
                      <a:off x="1522080" y="37821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4" name="Rectangle 253"/>
                    <p:cNvSpPr/>
                    <p:nvPr/>
                  </p:nvSpPr>
                  <p:spPr>
                    <a:xfrm>
                      <a:off x="1490760" y="360684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385" name="Group 254"/>
                  <p:cNvGrpSpPr/>
                  <p:nvPr/>
                </p:nvGrpSpPr>
                <p:grpSpPr>
                  <a:xfrm>
                    <a:off x="1603080" y="3632040"/>
                    <a:ext cx="26280" cy="880560"/>
                    <a:chOff x="1603080" y="3632040"/>
                    <a:chExt cx="26280" cy="880560"/>
                  </a:xfrm>
                </p:grpSpPr>
                <p:sp>
                  <p:nvSpPr>
                    <p:cNvPr id="386" name="Line 255"/>
                    <p:cNvSpPr/>
                    <p:nvPr/>
                  </p:nvSpPr>
                  <p:spPr>
                    <a:xfrm flipH="1">
                      <a:off x="1603080" y="451260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7" name="Line 256"/>
                    <p:cNvSpPr/>
                    <p:nvPr/>
                  </p:nvSpPr>
                  <p:spPr>
                    <a:xfrm flipH="1">
                      <a:off x="1620360" y="44697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8" name="Line 257"/>
                    <p:cNvSpPr/>
                    <p:nvPr/>
                  </p:nvSpPr>
                  <p:spPr>
                    <a:xfrm flipH="1">
                      <a:off x="1620360" y="44265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9" name="Line 258"/>
                    <p:cNvSpPr/>
                    <p:nvPr/>
                  </p:nvSpPr>
                  <p:spPr>
                    <a:xfrm flipH="1">
                      <a:off x="1620360" y="43804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0" name="Line 259"/>
                    <p:cNvSpPr/>
                    <p:nvPr/>
                  </p:nvSpPr>
                  <p:spPr>
                    <a:xfrm flipH="1">
                      <a:off x="1603080" y="433728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1" name="Line 260"/>
                    <p:cNvSpPr/>
                    <p:nvPr/>
                  </p:nvSpPr>
                  <p:spPr>
                    <a:xfrm flipH="1">
                      <a:off x="1620360" y="42940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2" name="Line 261"/>
                    <p:cNvSpPr/>
                    <p:nvPr/>
                  </p:nvSpPr>
                  <p:spPr>
                    <a:xfrm flipH="1">
                      <a:off x="1620360" y="42480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3" name="Line 262"/>
                    <p:cNvSpPr/>
                    <p:nvPr/>
                  </p:nvSpPr>
                  <p:spPr>
                    <a:xfrm flipH="1">
                      <a:off x="1620360" y="42048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4" name="Line 263"/>
                    <p:cNvSpPr/>
                    <p:nvPr/>
                  </p:nvSpPr>
                  <p:spPr>
                    <a:xfrm flipH="1">
                      <a:off x="1603080" y="416196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5" name="Line 264"/>
                    <p:cNvSpPr/>
                    <p:nvPr/>
                  </p:nvSpPr>
                  <p:spPr>
                    <a:xfrm flipH="1">
                      <a:off x="1620360" y="41151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6" name="Line 265"/>
                    <p:cNvSpPr/>
                    <p:nvPr/>
                  </p:nvSpPr>
                  <p:spPr>
                    <a:xfrm flipH="1">
                      <a:off x="1620360" y="40719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7" name="Line 266"/>
                    <p:cNvSpPr/>
                    <p:nvPr/>
                  </p:nvSpPr>
                  <p:spPr>
                    <a:xfrm flipH="1">
                      <a:off x="1620360" y="40294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8" name="Line 267"/>
                    <p:cNvSpPr/>
                    <p:nvPr/>
                  </p:nvSpPr>
                  <p:spPr>
                    <a:xfrm flipH="1">
                      <a:off x="1603080" y="398268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9" name="Line 268"/>
                    <p:cNvSpPr/>
                    <p:nvPr/>
                  </p:nvSpPr>
                  <p:spPr>
                    <a:xfrm flipH="1">
                      <a:off x="1620360" y="39398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0" name="Line 269"/>
                    <p:cNvSpPr/>
                    <p:nvPr/>
                  </p:nvSpPr>
                  <p:spPr>
                    <a:xfrm flipH="1">
                      <a:off x="1620360" y="38966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1" name="Line 270"/>
                    <p:cNvSpPr/>
                    <p:nvPr/>
                  </p:nvSpPr>
                  <p:spPr>
                    <a:xfrm flipH="1">
                      <a:off x="1620360" y="38502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2" name="Line 271"/>
                    <p:cNvSpPr/>
                    <p:nvPr/>
                  </p:nvSpPr>
                  <p:spPr>
                    <a:xfrm flipH="1">
                      <a:off x="1603080" y="380736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3" name="Line 272"/>
                    <p:cNvSpPr/>
                    <p:nvPr/>
                  </p:nvSpPr>
                  <p:spPr>
                    <a:xfrm flipH="1">
                      <a:off x="1620360" y="37641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4" name="Line 273"/>
                    <p:cNvSpPr/>
                    <p:nvPr/>
                  </p:nvSpPr>
                  <p:spPr>
                    <a:xfrm flipH="1">
                      <a:off x="1620360" y="37177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5" name="Line 274"/>
                    <p:cNvSpPr/>
                    <p:nvPr/>
                  </p:nvSpPr>
                  <p:spPr>
                    <a:xfrm flipH="1">
                      <a:off x="1620360" y="36745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6" name="Line 275"/>
                    <p:cNvSpPr/>
                    <p:nvPr/>
                  </p:nvSpPr>
                  <p:spPr>
                    <a:xfrm flipH="1">
                      <a:off x="1603080" y="363204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407" name="Rectangle 276"/>
                  <p:cNvSpPr/>
                  <p:nvPr/>
                </p:nvSpPr>
                <p:spPr>
                  <a:xfrm rot="16200000">
                    <a:off x="1236240" y="4317840"/>
                    <a:ext cx="365400" cy="2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 vert="eaVer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408" name="Group 277"/>
              <p:cNvGrpSpPr/>
              <p:nvPr/>
            </p:nvGrpSpPr>
            <p:grpSpPr>
              <a:xfrm>
                <a:off x="1642680" y="3635280"/>
                <a:ext cx="1147320" cy="871200"/>
                <a:chOff x="1642680" y="3635280"/>
                <a:chExt cx="1147320" cy="871200"/>
              </a:xfrm>
            </p:grpSpPr>
            <p:sp>
              <p:nvSpPr>
                <p:cNvPr id="409" name="Freeform 278"/>
                <p:cNvSpPr/>
                <p:nvPr/>
              </p:nvSpPr>
              <p:spPr>
                <a:xfrm>
                  <a:off x="1642680" y="3635280"/>
                  <a:ext cx="1147320" cy="867600"/>
                </a:xfrm>
                <a:custGeom>
                  <a:avLst/>
                  <a:gdLst>
                    <a:gd name="textAreaLeft" fmla="*/ 0 w 1147320"/>
                    <a:gd name="textAreaRight" fmla="*/ 1147680 w 1147320"/>
                    <a:gd name="textAreaTop" fmla="*/ 0 h 867600"/>
                    <a:gd name="textAreaBottom" fmla="*/ 867960 h 867600"/>
                  </a:gdLst>
                  <a:ahLst/>
                  <a:rect l="textAreaLeft" t="textAreaTop" r="textAreaRight" b="textAreaBottom"/>
                  <a:pathLst>
                    <a:path w="510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  <a:lnTo>
                        <a:pt x="510" y="486"/>
                      </a:lnTo>
                      <a:lnTo>
                        <a:pt x="0" y="486"/>
                      </a:lnTo>
                      <a:close/>
                    </a:path>
                  </a:pathLst>
                </a:custGeom>
                <a:solidFill>
                  <a:srgbClr val="e8e8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Freeform 279"/>
                <p:cNvSpPr/>
                <p:nvPr/>
              </p:nvSpPr>
              <p:spPr>
                <a:xfrm>
                  <a:off x="1647000" y="3638880"/>
                  <a:ext cx="1142640" cy="867600"/>
                </a:xfrm>
                <a:custGeom>
                  <a:avLst/>
                  <a:gdLst>
                    <a:gd name="textAreaLeft" fmla="*/ 0 w 1142640"/>
                    <a:gd name="textAreaRight" fmla="*/ 1143000 w 1142640"/>
                    <a:gd name="textAreaTop" fmla="*/ 0 h 867600"/>
                    <a:gd name="textAreaBottom" fmla="*/ 867960 h 867600"/>
                  </a:gdLst>
                  <a:ahLst/>
                  <a:rect l="textAreaLeft" t="textAreaTop" r="textAreaRight" b="textAreaBottom"/>
                  <a:pathLst>
                    <a:path w="508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</a:path>
                  </a:pathLst>
                </a:custGeom>
                <a:noFill/>
                <a:ln w="6480">
                  <a:solidFill>
                    <a:srgbClr val="b3b3b3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11" name="Freeform 280"/>
              <p:cNvSpPr/>
              <p:nvPr/>
            </p:nvSpPr>
            <p:spPr>
              <a:xfrm>
                <a:off x="1647720" y="3638520"/>
                <a:ext cx="1142640" cy="868320"/>
              </a:xfrm>
              <a:custGeom>
                <a:avLst/>
                <a:gdLst>
                  <a:gd name="textAreaLeft" fmla="*/ 0 w 1142640"/>
                  <a:gd name="textAreaRight" fmla="*/ 1143000 w 1142640"/>
                  <a:gd name="textAreaTop" fmla="*/ 0 h 868320"/>
                  <a:gd name="textAreaBottom" fmla="*/ 868680 h 86832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0" y="482"/>
                    </a:lnTo>
                    <a:lnTo>
                      <a:pt x="2" y="482"/>
                    </a:lnTo>
                    <a:lnTo>
                      <a:pt x="4" y="482"/>
                    </a:lnTo>
                    <a:lnTo>
                      <a:pt x="6" y="482"/>
                    </a:lnTo>
                    <a:lnTo>
                      <a:pt x="8" y="480"/>
                    </a:lnTo>
                    <a:lnTo>
                      <a:pt x="10" y="480"/>
                    </a:lnTo>
                    <a:lnTo>
                      <a:pt x="12" y="480"/>
                    </a:lnTo>
                    <a:lnTo>
                      <a:pt x="14" y="480"/>
                    </a:lnTo>
                    <a:lnTo>
                      <a:pt x="16" y="480"/>
                    </a:lnTo>
                    <a:lnTo>
                      <a:pt x="18" y="480"/>
                    </a:lnTo>
                    <a:lnTo>
                      <a:pt x="20" y="480"/>
                    </a:lnTo>
                    <a:lnTo>
                      <a:pt x="22" y="480"/>
                    </a:lnTo>
                    <a:lnTo>
                      <a:pt x="24" y="480"/>
                    </a:lnTo>
                    <a:lnTo>
                      <a:pt x="26" y="480"/>
                    </a:lnTo>
                    <a:lnTo>
                      <a:pt x="28" y="480"/>
                    </a:lnTo>
                    <a:lnTo>
                      <a:pt x="30" y="480"/>
                    </a:lnTo>
                    <a:lnTo>
                      <a:pt x="32" y="480"/>
                    </a:lnTo>
                    <a:lnTo>
                      <a:pt x="34" y="480"/>
                    </a:lnTo>
                    <a:lnTo>
                      <a:pt x="36" y="480"/>
                    </a:lnTo>
                    <a:lnTo>
                      <a:pt x="38" y="482"/>
                    </a:lnTo>
                    <a:lnTo>
                      <a:pt x="40" y="482"/>
                    </a:lnTo>
                    <a:lnTo>
                      <a:pt x="42" y="480"/>
                    </a:lnTo>
                    <a:lnTo>
                      <a:pt x="44" y="480"/>
                    </a:lnTo>
                    <a:lnTo>
                      <a:pt x="46" y="480"/>
                    </a:lnTo>
                    <a:lnTo>
                      <a:pt x="48" y="480"/>
                    </a:lnTo>
                    <a:lnTo>
                      <a:pt x="50" y="478"/>
                    </a:lnTo>
                    <a:lnTo>
                      <a:pt x="52" y="476"/>
                    </a:lnTo>
                    <a:lnTo>
                      <a:pt x="54" y="476"/>
                    </a:lnTo>
                    <a:lnTo>
                      <a:pt x="56" y="476"/>
                    </a:lnTo>
                    <a:lnTo>
                      <a:pt x="58" y="474"/>
                    </a:lnTo>
                    <a:lnTo>
                      <a:pt x="60" y="474"/>
                    </a:lnTo>
                    <a:lnTo>
                      <a:pt x="62" y="472"/>
                    </a:lnTo>
                    <a:lnTo>
                      <a:pt x="64" y="470"/>
                    </a:lnTo>
                    <a:lnTo>
                      <a:pt x="66" y="468"/>
                    </a:lnTo>
                    <a:lnTo>
                      <a:pt x="68" y="464"/>
                    </a:lnTo>
                    <a:lnTo>
                      <a:pt x="70" y="464"/>
                    </a:lnTo>
                    <a:lnTo>
                      <a:pt x="72" y="464"/>
                    </a:lnTo>
                    <a:lnTo>
                      <a:pt x="74" y="464"/>
                    </a:lnTo>
                    <a:lnTo>
                      <a:pt x="76" y="464"/>
                    </a:lnTo>
                    <a:lnTo>
                      <a:pt x="78" y="462"/>
                    </a:lnTo>
                    <a:lnTo>
                      <a:pt x="80" y="460"/>
                    </a:lnTo>
                    <a:lnTo>
                      <a:pt x="82" y="454"/>
                    </a:lnTo>
                    <a:lnTo>
                      <a:pt x="84" y="450"/>
                    </a:lnTo>
                    <a:lnTo>
                      <a:pt x="86" y="448"/>
                    </a:lnTo>
                    <a:lnTo>
                      <a:pt x="88" y="448"/>
                    </a:lnTo>
                    <a:lnTo>
                      <a:pt x="90" y="446"/>
                    </a:lnTo>
                    <a:lnTo>
                      <a:pt x="92" y="442"/>
                    </a:lnTo>
                    <a:lnTo>
                      <a:pt x="94" y="436"/>
                    </a:lnTo>
                    <a:lnTo>
                      <a:pt x="96" y="432"/>
                    </a:lnTo>
                    <a:lnTo>
                      <a:pt x="98" y="426"/>
                    </a:lnTo>
                    <a:lnTo>
                      <a:pt x="100" y="418"/>
                    </a:lnTo>
                    <a:lnTo>
                      <a:pt x="102" y="408"/>
                    </a:lnTo>
                    <a:lnTo>
                      <a:pt x="104" y="398"/>
                    </a:lnTo>
                    <a:lnTo>
                      <a:pt x="106" y="394"/>
                    </a:lnTo>
                    <a:lnTo>
                      <a:pt x="108" y="390"/>
                    </a:lnTo>
                    <a:lnTo>
                      <a:pt x="110" y="388"/>
                    </a:lnTo>
                    <a:lnTo>
                      <a:pt x="112" y="386"/>
                    </a:lnTo>
                    <a:lnTo>
                      <a:pt x="114" y="376"/>
                    </a:lnTo>
                    <a:lnTo>
                      <a:pt x="116" y="362"/>
                    </a:lnTo>
                    <a:lnTo>
                      <a:pt x="118" y="348"/>
                    </a:lnTo>
                    <a:lnTo>
                      <a:pt x="120" y="344"/>
                    </a:lnTo>
                    <a:lnTo>
                      <a:pt x="122" y="350"/>
                    </a:lnTo>
                    <a:lnTo>
                      <a:pt x="124" y="362"/>
                    </a:lnTo>
                    <a:lnTo>
                      <a:pt x="126" y="364"/>
                    </a:lnTo>
                    <a:lnTo>
                      <a:pt x="128" y="354"/>
                    </a:lnTo>
                    <a:lnTo>
                      <a:pt x="130" y="338"/>
                    </a:lnTo>
                    <a:lnTo>
                      <a:pt x="132" y="326"/>
                    </a:lnTo>
                    <a:lnTo>
                      <a:pt x="134" y="322"/>
                    </a:lnTo>
                    <a:lnTo>
                      <a:pt x="136" y="326"/>
                    </a:lnTo>
                    <a:lnTo>
                      <a:pt x="138" y="338"/>
                    </a:lnTo>
                    <a:lnTo>
                      <a:pt x="140" y="344"/>
                    </a:lnTo>
                    <a:lnTo>
                      <a:pt x="142" y="342"/>
                    </a:lnTo>
                    <a:lnTo>
                      <a:pt x="144" y="340"/>
                    </a:lnTo>
                    <a:lnTo>
                      <a:pt x="146" y="342"/>
                    </a:lnTo>
                    <a:lnTo>
                      <a:pt x="148" y="342"/>
                    </a:lnTo>
                    <a:lnTo>
                      <a:pt x="150" y="342"/>
                    </a:lnTo>
                    <a:lnTo>
                      <a:pt x="152" y="348"/>
                    </a:lnTo>
                    <a:lnTo>
                      <a:pt x="154" y="350"/>
                    </a:lnTo>
                    <a:lnTo>
                      <a:pt x="156" y="342"/>
                    </a:lnTo>
                    <a:lnTo>
                      <a:pt x="158" y="336"/>
                    </a:lnTo>
                    <a:lnTo>
                      <a:pt x="160" y="340"/>
                    </a:lnTo>
                    <a:lnTo>
                      <a:pt x="162" y="352"/>
                    </a:lnTo>
                    <a:lnTo>
                      <a:pt x="164" y="358"/>
                    </a:lnTo>
                    <a:lnTo>
                      <a:pt x="166" y="354"/>
                    </a:lnTo>
                    <a:lnTo>
                      <a:pt x="168" y="352"/>
                    </a:lnTo>
                    <a:lnTo>
                      <a:pt x="170" y="358"/>
                    </a:lnTo>
                    <a:lnTo>
                      <a:pt x="172" y="364"/>
                    </a:lnTo>
                    <a:lnTo>
                      <a:pt x="174" y="350"/>
                    </a:lnTo>
                    <a:lnTo>
                      <a:pt x="176" y="334"/>
                    </a:lnTo>
                    <a:lnTo>
                      <a:pt x="178" y="336"/>
                    </a:lnTo>
                    <a:lnTo>
                      <a:pt x="180" y="350"/>
                    </a:lnTo>
                    <a:lnTo>
                      <a:pt x="182" y="356"/>
                    </a:lnTo>
                    <a:lnTo>
                      <a:pt x="184" y="356"/>
                    </a:lnTo>
                    <a:lnTo>
                      <a:pt x="186" y="350"/>
                    </a:lnTo>
                    <a:lnTo>
                      <a:pt x="188" y="348"/>
                    </a:lnTo>
                    <a:lnTo>
                      <a:pt x="190" y="344"/>
                    </a:lnTo>
                    <a:lnTo>
                      <a:pt x="192" y="336"/>
                    </a:lnTo>
                    <a:lnTo>
                      <a:pt x="194" y="332"/>
                    </a:lnTo>
                    <a:lnTo>
                      <a:pt x="196" y="332"/>
                    </a:lnTo>
                    <a:lnTo>
                      <a:pt x="198" y="334"/>
                    </a:lnTo>
                    <a:lnTo>
                      <a:pt x="200" y="328"/>
                    </a:lnTo>
                    <a:lnTo>
                      <a:pt x="202" y="312"/>
                    </a:lnTo>
                    <a:lnTo>
                      <a:pt x="204" y="298"/>
                    </a:lnTo>
                    <a:lnTo>
                      <a:pt x="206" y="298"/>
                    </a:lnTo>
                    <a:lnTo>
                      <a:pt x="208" y="300"/>
                    </a:lnTo>
                    <a:lnTo>
                      <a:pt x="210" y="292"/>
                    </a:lnTo>
                    <a:lnTo>
                      <a:pt x="212" y="276"/>
                    </a:lnTo>
                    <a:lnTo>
                      <a:pt x="214" y="266"/>
                    </a:lnTo>
                    <a:lnTo>
                      <a:pt x="216" y="260"/>
                    </a:lnTo>
                    <a:lnTo>
                      <a:pt x="218" y="240"/>
                    </a:lnTo>
                    <a:lnTo>
                      <a:pt x="220" y="224"/>
                    </a:lnTo>
                    <a:lnTo>
                      <a:pt x="222" y="208"/>
                    </a:lnTo>
                    <a:lnTo>
                      <a:pt x="224" y="196"/>
                    </a:lnTo>
                    <a:lnTo>
                      <a:pt x="226" y="190"/>
                    </a:lnTo>
                    <a:lnTo>
                      <a:pt x="228" y="192"/>
                    </a:lnTo>
                    <a:lnTo>
                      <a:pt x="230" y="192"/>
                    </a:lnTo>
                    <a:lnTo>
                      <a:pt x="232" y="184"/>
                    </a:lnTo>
                    <a:lnTo>
                      <a:pt x="234" y="180"/>
                    </a:lnTo>
                    <a:lnTo>
                      <a:pt x="236" y="178"/>
                    </a:lnTo>
                    <a:lnTo>
                      <a:pt x="238" y="160"/>
                    </a:lnTo>
                    <a:lnTo>
                      <a:pt x="240" y="134"/>
                    </a:lnTo>
                    <a:lnTo>
                      <a:pt x="242" y="112"/>
                    </a:lnTo>
                    <a:lnTo>
                      <a:pt x="244" y="106"/>
                    </a:lnTo>
                    <a:lnTo>
                      <a:pt x="246" y="94"/>
                    </a:lnTo>
                    <a:lnTo>
                      <a:pt x="248" y="78"/>
                    </a:lnTo>
                    <a:lnTo>
                      <a:pt x="250" y="62"/>
                    </a:lnTo>
                    <a:lnTo>
                      <a:pt x="252" y="38"/>
                    </a:lnTo>
                    <a:lnTo>
                      <a:pt x="254" y="24"/>
                    </a:lnTo>
                    <a:lnTo>
                      <a:pt x="256" y="12"/>
                    </a:lnTo>
                    <a:lnTo>
                      <a:pt x="258" y="0"/>
                    </a:lnTo>
                    <a:lnTo>
                      <a:pt x="260" y="10"/>
                    </a:lnTo>
                    <a:lnTo>
                      <a:pt x="262" y="24"/>
                    </a:lnTo>
                    <a:lnTo>
                      <a:pt x="264" y="46"/>
                    </a:lnTo>
                    <a:lnTo>
                      <a:pt x="266" y="58"/>
                    </a:lnTo>
                    <a:lnTo>
                      <a:pt x="268" y="68"/>
                    </a:lnTo>
                    <a:lnTo>
                      <a:pt x="270" y="80"/>
                    </a:lnTo>
                    <a:lnTo>
                      <a:pt x="272" y="96"/>
                    </a:lnTo>
                    <a:lnTo>
                      <a:pt x="274" y="92"/>
                    </a:lnTo>
                    <a:lnTo>
                      <a:pt x="276" y="66"/>
                    </a:lnTo>
                    <a:lnTo>
                      <a:pt x="278" y="78"/>
                    </a:lnTo>
                    <a:lnTo>
                      <a:pt x="280" y="146"/>
                    </a:lnTo>
                    <a:lnTo>
                      <a:pt x="282" y="200"/>
                    </a:lnTo>
                    <a:lnTo>
                      <a:pt x="284" y="222"/>
                    </a:lnTo>
                    <a:lnTo>
                      <a:pt x="286" y="248"/>
                    </a:lnTo>
                    <a:lnTo>
                      <a:pt x="288" y="288"/>
                    </a:lnTo>
                    <a:lnTo>
                      <a:pt x="290" y="326"/>
                    </a:lnTo>
                    <a:lnTo>
                      <a:pt x="292" y="356"/>
                    </a:lnTo>
                    <a:lnTo>
                      <a:pt x="294" y="372"/>
                    </a:lnTo>
                    <a:lnTo>
                      <a:pt x="296" y="384"/>
                    </a:lnTo>
                    <a:lnTo>
                      <a:pt x="298" y="398"/>
                    </a:lnTo>
                    <a:lnTo>
                      <a:pt x="300" y="416"/>
                    </a:lnTo>
                    <a:lnTo>
                      <a:pt x="302" y="434"/>
                    </a:lnTo>
                    <a:lnTo>
                      <a:pt x="304" y="450"/>
                    </a:lnTo>
                    <a:lnTo>
                      <a:pt x="306" y="460"/>
                    </a:lnTo>
                    <a:lnTo>
                      <a:pt x="308" y="468"/>
                    </a:lnTo>
                    <a:lnTo>
                      <a:pt x="310" y="472"/>
                    </a:lnTo>
                    <a:lnTo>
                      <a:pt x="312" y="476"/>
                    </a:lnTo>
                    <a:lnTo>
                      <a:pt x="314" y="478"/>
                    </a:lnTo>
                    <a:lnTo>
                      <a:pt x="316" y="480"/>
                    </a:lnTo>
                    <a:lnTo>
                      <a:pt x="318" y="480"/>
                    </a:lnTo>
                    <a:lnTo>
                      <a:pt x="320" y="482"/>
                    </a:lnTo>
                    <a:lnTo>
                      <a:pt x="322" y="482"/>
                    </a:lnTo>
                    <a:lnTo>
                      <a:pt x="324" y="482"/>
                    </a:lnTo>
                    <a:lnTo>
                      <a:pt x="326" y="484"/>
                    </a:lnTo>
                    <a:lnTo>
                      <a:pt x="328" y="484"/>
                    </a:lnTo>
                    <a:lnTo>
                      <a:pt x="330" y="484"/>
                    </a:lnTo>
                    <a:lnTo>
                      <a:pt x="332" y="484"/>
                    </a:lnTo>
                    <a:lnTo>
                      <a:pt x="334" y="484"/>
                    </a:lnTo>
                    <a:lnTo>
                      <a:pt x="336" y="484"/>
                    </a:lnTo>
                    <a:lnTo>
                      <a:pt x="338" y="484"/>
                    </a:lnTo>
                    <a:lnTo>
                      <a:pt x="340" y="484"/>
                    </a:lnTo>
                    <a:lnTo>
                      <a:pt x="342" y="484"/>
                    </a:lnTo>
                    <a:lnTo>
                      <a:pt x="344" y="484"/>
                    </a:lnTo>
                    <a:lnTo>
                      <a:pt x="346" y="484"/>
                    </a:lnTo>
                    <a:lnTo>
                      <a:pt x="348" y="484"/>
                    </a:lnTo>
                    <a:lnTo>
                      <a:pt x="350" y="484"/>
                    </a:lnTo>
                    <a:lnTo>
                      <a:pt x="352" y="484"/>
                    </a:lnTo>
                    <a:lnTo>
                      <a:pt x="354" y="486"/>
                    </a:lnTo>
                    <a:lnTo>
                      <a:pt x="356" y="486"/>
                    </a:lnTo>
                    <a:lnTo>
                      <a:pt x="358" y="486"/>
                    </a:lnTo>
                    <a:lnTo>
                      <a:pt x="360" y="486"/>
                    </a:lnTo>
                    <a:lnTo>
                      <a:pt x="362" y="486"/>
                    </a:lnTo>
                    <a:lnTo>
                      <a:pt x="364" y="486"/>
                    </a:lnTo>
                    <a:lnTo>
                      <a:pt x="366" y="486"/>
                    </a:lnTo>
                    <a:lnTo>
                      <a:pt x="368" y="486"/>
                    </a:lnTo>
                    <a:lnTo>
                      <a:pt x="370" y="486"/>
                    </a:lnTo>
                    <a:lnTo>
                      <a:pt x="372" y="486"/>
                    </a:lnTo>
                    <a:lnTo>
                      <a:pt x="374" y="486"/>
                    </a:lnTo>
                    <a:lnTo>
                      <a:pt x="376" y="486"/>
                    </a:lnTo>
                    <a:lnTo>
                      <a:pt x="378" y="486"/>
                    </a:lnTo>
                    <a:lnTo>
                      <a:pt x="380" y="486"/>
                    </a:lnTo>
                    <a:lnTo>
                      <a:pt x="382" y="486"/>
                    </a:lnTo>
                    <a:lnTo>
                      <a:pt x="384" y="486"/>
                    </a:lnTo>
                    <a:lnTo>
                      <a:pt x="386" y="486"/>
                    </a:lnTo>
                    <a:lnTo>
                      <a:pt x="388" y="486"/>
                    </a:lnTo>
                    <a:lnTo>
                      <a:pt x="390" y="486"/>
                    </a:lnTo>
                    <a:lnTo>
                      <a:pt x="392" y="486"/>
                    </a:lnTo>
                    <a:lnTo>
                      <a:pt x="394" y="486"/>
                    </a:lnTo>
                    <a:lnTo>
                      <a:pt x="396" y="486"/>
                    </a:lnTo>
                    <a:lnTo>
                      <a:pt x="398" y="486"/>
                    </a:lnTo>
                    <a:lnTo>
                      <a:pt x="400" y="486"/>
                    </a:lnTo>
                    <a:lnTo>
                      <a:pt x="402" y="486"/>
                    </a:lnTo>
                    <a:lnTo>
                      <a:pt x="404" y="486"/>
                    </a:lnTo>
                    <a:lnTo>
                      <a:pt x="406" y="486"/>
                    </a:lnTo>
                    <a:lnTo>
                      <a:pt x="408" y="486"/>
                    </a:lnTo>
                    <a:lnTo>
                      <a:pt x="410" y="486"/>
                    </a:lnTo>
                    <a:lnTo>
                      <a:pt x="412" y="486"/>
                    </a:lnTo>
                    <a:lnTo>
                      <a:pt x="414" y="486"/>
                    </a:lnTo>
                    <a:lnTo>
                      <a:pt x="416" y="486"/>
                    </a:lnTo>
                    <a:lnTo>
                      <a:pt x="418" y="486"/>
                    </a:lnTo>
                    <a:lnTo>
                      <a:pt x="420" y="486"/>
                    </a:lnTo>
                    <a:lnTo>
                      <a:pt x="422" y="486"/>
                    </a:lnTo>
                    <a:lnTo>
                      <a:pt x="424" y="486"/>
                    </a:lnTo>
                    <a:lnTo>
                      <a:pt x="426" y="486"/>
                    </a:lnTo>
                    <a:lnTo>
                      <a:pt x="428" y="486"/>
                    </a:lnTo>
                    <a:lnTo>
                      <a:pt x="430" y="486"/>
                    </a:lnTo>
                    <a:lnTo>
                      <a:pt x="432" y="486"/>
                    </a:lnTo>
                    <a:lnTo>
                      <a:pt x="434" y="486"/>
                    </a:lnTo>
                    <a:lnTo>
                      <a:pt x="436" y="486"/>
                    </a:lnTo>
                    <a:lnTo>
                      <a:pt x="438" y="486"/>
                    </a:lnTo>
                    <a:lnTo>
                      <a:pt x="440" y="484"/>
                    </a:lnTo>
                    <a:lnTo>
                      <a:pt x="442" y="484"/>
                    </a:lnTo>
                    <a:lnTo>
                      <a:pt x="444" y="484"/>
                    </a:lnTo>
                    <a:lnTo>
                      <a:pt x="446" y="484"/>
                    </a:lnTo>
                    <a:lnTo>
                      <a:pt x="448" y="484"/>
                    </a:lnTo>
                    <a:lnTo>
                      <a:pt x="450" y="484"/>
                    </a:lnTo>
                    <a:lnTo>
                      <a:pt x="452" y="484"/>
                    </a:lnTo>
                    <a:lnTo>
                      <a:pt x="454" y="484"/>
                    </a:lnTo>
                    <a:lnTo>
                      <a:pt x="456" y="484"/>
                    </a:lnTo>
                    <a:lnTo>
                      <a:pt x="458" y="484"/>
                    </a:lnTo>
                    <a:lnTo>
                      <a:pt x="460" y="484"/>
                    </a:lnTo>
                    <a:lnTo>
                      <a:pt x="462" y="484"/>
                    </a:lnTo>
                    <a:lnTo>
                      <a:pt x="464" y="484"/>
                    </a:lnTo>
                    <a:lnTo>
                      <a:pt x="466" y="484"/>
                    </a:lnTo>
                    <a:lnTo>
                      <a:pt x="468" y="484"/>
                    </a:lnTo>
                    <a:lnTo>
                      <a:pt x="470" y="484"/>
                    </a:lnTo>
                    <a:lnTo>
                      <a:pt x="472" y="484"/>
                    </a:lnTo>
                    <a:lnTo>
                      <a:pt x="474" y="484"/>
                    </a:lnTo>
                    <a:lnTo>
                      <a:pt x="476" y="484"/>
                    </a:lnTo>
                    <a:lnTo>
                      <a:pt x="478" y="484"/>
                    </a:lnTo>
                    <a:lnTo>
                      <a:pt x="480" y="484"/>
                    </a:lnTo>
                    <a:lnTo>
                      <a:pt x="482" y="484"/>
                    </a:lnTo>
                    <a:lnTo>
                      <a:pt x="484" y="484"/>
                    </a:lnTo>
                    <a:lnTo>
                      <a:pt x="486" y="484"/>
                    </a:lnTo>
                    <a:lnTo>
                      <a:pt x="488" y="484"/>
                    </a:lnTo>
                    <a:lnTo>
                      <a:pt x="490" y="484"/>
                    </a:lnTo>
                    <a:lnTo>
                      <a:pt x="492" y="484"/>
                    </a:lnTo>
                    <a:lnTo>
                      <a:pt x="494" y="484"/>
                    </a:lnTo>
                    <a:lnTo>
                      <a:pt x="496" y="484"/>
                    </a:lnTo>
                    <a:lnTo>
                      <a:pt x="498" y="484"/>
                    </a:lnTo>
                    <a:lnTo>
                      <a:pt x="500" y="484"/>
                    </a:lnTo>
                    <a:lnTo>
                      <a:pt x="502" y="484"/>
                    </a:lnTo>
                    <a:lnTo>
                      <a:pt x="504" y="484"/>
                    </a:lnTo>
                    <a:lnTo>
                      <a:pt x="506" y="484"/>
                    </a:lnTo>
                    <a:lnTo>
                      <a:pt x="508" y="484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12" name="Text Box 3833"/>
            <p:cNvSpPr/>
            <p:nvPr/>
          </p:nvSpPr>
          <p:spPr>
            <a:xfrm>
              <a:off x="2165400" y="3593880"/>
              <a:ext cx="70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84.3/80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13" name="Group 3863"/>
          <p:cNvGrpSpPr/>
          <p:nvPr/>
        </p:nvGrpSpPr>
        <p:grpSpPr>
          <a:xfrm>
            <a:off x="3936960" y="2454120"/>
            <a:ext cx="1405800" cy="1381680"/>
            <a:chOff x="3936960" y="2454120"/>
            <a:chExt cx="1405800" cy="1381680"/>
          </a:xfrm>
        </p:grpSpPr>
        <p:grpSp>
          <p:nvGrpSpPr>
            <p:cNvPr id="414" name="Group 3856"/>
            <p:cNvGrpSpPr/>
            <p:nvPr/>
          </p:nvGrpSpPr>
          <p:grpSpPr>
            <a:xfrm>
              <a:off x="3936960" y="2454120"/>
              <a:ext cx="1405800" cy="1381680"/>
              <a:chOff x="3936960" y="2454120"/>
              <a:chExt cx="1405800" cy="1381680"/>
            </a:xfrm>
          </p:grpSpPr>
          <p:grpSp>
            <p:nvGrpSpPr>
              <p:cNvPr id="415" name="Group 282"/>
              <p:cNvGrpSpPr/>
              <p:nvPr/>
            </p:nvGrpSpPr>
            <p:grpSpPr>
              <a:xfrm>
                <a:off x="3936960" y="2454120"/>
                <a:ext cx="1405800" cy="1381680"/>
                <a:chOff x="3936960" y="2454120"/>
                <a:chExt cx="1405800" cy="1381680"/>
              </a:xfrm>
            </p:grpSpPr>
            <p:sp>
              <p:nvSpPr>
                <p:cNvPr id="416" name="Rectangle 283"/>
                <p:cNvSpPr/>
                <p:nvPr/>
              </p:nvSpPr>
              <p:spPr>
                <a:xfrm>
                  <a:off x="4140360" y="2455560"/>
                  <a:ext cx="1166400" cy="92448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17" name="Group 284"/>
                <p:cNvGrpSpPr/>
                <p:nvPr/>
              </p:nvGrpSpPr>
              <p:grpSpPr>
                <a:xfrm>
                  <a:off x="4091040" y="3377880"/>
                  <a:ext cx="1251720" cy="457920"/>
                  <a:chOff x="4091040" y="3377880"/>
                  <a:chExt cx="1251720" cy="457920"/>
                </a:xfrm>
              </p:grpSpPr>
              <p:sp>
                <p:nvSpPr>
                  <p:cNvPr id="418" name="Line 285"/>
                  <p:cNvSpPr/>
                  <p:nvPr/>
                </p:nvSpPr>
                <p:spPr>
                  <a:xfrm>
                    <a:off x="4137480" y="3377880"/>
                    <a:ext cx="116640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419" name="Group 286"/>
                  <p:cNvGrpSpPr/>
                  <p:nvPr/>
                </p:nvGrpSpPr>
                <p:grpSpPr>
                  <a:xfrm>
                    <a:off x="4137480" y="3381480"/>
                    <a:ext cx="1166040" cy="20880"/>
                    <a:chOff x="4137480" y="3381480"/>
                    <a:chExt cx="1166040" cy="20880"/>
                  </a:xfrm>
                </p:grpSpPr>
                <p:sp>
                  <p:nvSpPr>
                    <p:cNvPr id="420" name="Line 287"/>
                    <p:cNvSpPr/>
                    <p:nvPr/>
                  </p:nvSpPr>
                  <p:spPr>
                    <a:xfrm>
                      <a:off x="4137480" y="33814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1" name="Line 288"/>
                    <p:cNvSpPr/>
                    <p:nvPr/>
                  </p:nvSpPr>
                  <p:spPr>
                    <a:xfrm>
                      <a:off x="422352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2" name="Line 289"/>
                    <p:cNvSpPr/>
                    <p:nvPr/>
                  </p:nvSpPr>
                  <p:spPr>
                    <a:xfrm>
                      <a:off x="427320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3" name="Line 290"/>
                    <p:cNvSpPr/>
                    <p:nvPr/>
                  </p:nvSpPr>
                  <p:spPr>
                    <a:xfrm>
                      <a:off x="430884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4" name="Line 291"/>
                    <p:cNvSpPr/>
                    <p:nvPr/>
                  </p:nvSpPr>
                  <p:spPr>
                    <a:xfrm>
                      <a:off x="4340880" y="3381480"/>
                      <a:ext cx="0" cy="144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2400" bIns="-324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5" name="Line 292"/>
                    <p:cNvSpPr/>
                    <p:nvPr/>
                  </p:nvSpPr>
                  <p:spPr>
                    <a:xfrm>
                      <a:off x="436320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6" name="Line 293"/>
                    <p:cNvSpPr/>
                    <p:nvPr/>
                  </p:nvSpPr>
                  <p:spPr>
                    <a:xfrm>
                      <a:off x="438156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7" name="Line 294"/>
                    <p:cNvSpPr/>
                    <p:nvPr/>
                  </p:nvSpPr>
                  <p:spPr>
                    <a:xfrm>
                      <a:off x="439956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8" name="Line 295"/>
                    <p:cNvSpPr/>
                    <p:nvPr/>
                  </p:nvSpPr>
                  <p:spPr>
                    <a:xfrm>
                      <a:off x="441288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29" name="Line 296"/>
                    <p:cNvSpPr/>
                    <p:nvPr/>
                  </p:nvSpPr>
                  <p:spPr>
                    <a:xfrm>
                      <a:off x="4426920" y="33814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0" name="Line 297"/>
                    <p:cNvSpPr/>
                    <p:nvPr/>
                  </p:nvSpPr>
                  <p:spPr>
                    <a:xfrm>
                      <a:off x="451692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1" name="Line 298"/>
                    <p:cNvSpPr/>
                    <p:nvPr/>
                  </p:nvSpPr>
                  <p:spPr>
                    <a:xfrm>
                      <a:off x="456660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2" name="Line 299"/>
                    <p:cNvSpPr/>
                    <p:nvPr/>
                  </p:nvSpPr>
                  <p:spPr>
                    <a:xfrm>
                      <a:off x="460296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3" name="Line 300"/>
                    <p:cNvSpPr/>
                    <p:nvPr/>
                  </p:nvSpPr>
                  <p:spPr>
                    <a:xfrm>
                      <a:off x="4630320" y="3381480"/>
                      <a:ext cx="0" cy="144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2400" bIns="-324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4" name="Line 301"/>
                    <p:cNvSpPr/>
                    <p:nvPr/>
                  </p:nvSpPr>
                  <p:spPr>
                    <a:xfrm>
                      <a:off x="465732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5" name="Line 302"/>
                    <p:cNvSpPr/>
                    <p:nvPr/>
                  </p:nvSpPr>
                  <p:spPr>
                    <a:xfrm>
                      <a:off x="467532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6" name="Line 303"/>
                    <p:cNvSpPr/>
                    <p:nvPr/>
                  </p:nvSpPr>
                  <p:spPr>
                    <a:xfrm>
                      <a:off x="469332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7" name="Line 304"/>
                    <p:cNvSpPr/>
                    <p:nvPr/>
                  </p:nvSpPr>
                  <p:spPr>
                    <a:xfrm>
                      <a:off x="470700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8" name="Line 305"/>
                    <p:cNvSpPr/>
                    <p:nvPr/>
                  </p:nvSpPr>
                  <p:spPr>
                    <a:xfrm>
                      <a:off x="4720320" y="33814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39" name="Line 306"/>
                    <p:cNvSpPr/>
                    <p:nvPr/>
                  </p:nvSpPr>
                  <p:spPr>
                    <a:xfrm>
                      <a:off x="480636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0" name="Line 307"/>
                    <p:cNvSpPr/>
                    <p:nvPr/>
                  </p:nvSpPr>
                  <p:spPr>
                    <a:xfrm>
                      <a:off x="486036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1" name="Line 308"/>
                    <p:cNvSpPr/>
                    <p:nvPr/>
                  </p:nvSpPr>
                  <p:spPr>
                    <a:xfrm>
                      <a:off x="489672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2" name="Line 309"/>
                    <p:cNvSpPr/>
                    <p:nvPr/>
                  </p:nvSpPr>
                  <p:spPr>
                    <a:xfrm>
                      <a:off x="4923720" y="3381480"/>
                      <a:ext cx="0" cy="144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2400" bIns="-324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3" name="Line 310"/>
                    <p:cNvSpPr/>
                    <p:nvPr/>
                  </p:nvSpPr>
                  <p:spPr>
                    <a:xfrm>
                      <a:off x="494640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4" name="Line 311"/>
                    <p:cNvSpPr/>
                    <p:nvPr/>
                  </p:nvSpPr>
                  <p:spPr>
                    <a:xfrm>
                      <a:off x="496908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5" name="Line 312"/>
                    <p:cNvSpPr/>
                    <p:nvPr/>
                  </p:nvSpPr>
                  <p:spPr>
                    <a:xfrm>
                      <a:off x="498276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6" name="Line 313"/>
                    <p:cNvSpPr/>
                    <p:nvPr/>
                  </p:nvSpPr>
                  <p:spPr>
                    <a:xfrm>
                      <a:off x="500076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7" name="Line 314"/>
                    <p:cNvSpPr/>
                    <p:nvPr/>
                  </p:nvSpPr>
                  <p:spPr>
                    <a:xfrm>
                      <a:off x="5014080" y="33814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8" name="Line 315"/>
                    <p:cNvSpPr/>
                    <p:nvPr/>
                  </p:nvSpPr>
                  <p:spPr>
                    <a:xfrm>
                      <a:off x="510012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49" name="Line 316"/>
                    <p:cNvSpPr/>
                    <p:nvPr/>
                  </p:nvSpPr>
                  <p:spPr>
                    <a:xfrm>
                      <a:off x="515448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0" name="Line 317"/>
                    <p:cNvSpPr/>
                    <p:nvPr/>
                  </p:nvSpPr>
                  <p:spPr>
                    <a:xfrm>
                      <a:off x="519048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1" name="Line 318"/>
                    <p:cNvSpPr/>
                    <p:nvPr/>
                  </p:nvSpPr>
                  <p:spPr>
                    <a:xfrm>
                      <a:off x="5217480" y="3381480"/>
                      <a:ext cx="0" cy="144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2400" bIns="-324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2" name="Line 319"/>
                    <p:cNvSpPr/>
                    <p:nvPr/>
                  </p:nvSpPr>
                  <p:spPr>
                    <a:xfrm>
                      <a:off x="524016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3" name="Line 320"/>
                    <p:cNvSpPr/>
                    <p:nvPr/>
                  </p:nvSpPr>
                  <p:spPr>
                    <a:xfrm>
                      <a:off x="525852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4" name="Line 321"/>
                    <p:cNvSpPr/>
                    <p:nvPr/>
                  </p:nvSpPr>
                  <p:spPr>
                    <a:xfrm>
                      <a:off x="527652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5" name="Line 322"/>
                    <p:cNvSpPr/>
                    <p:nvPr/>
                  </p:nvSpPr>
                  <p:spPr>
                    <a:xfrm>
                      <a:off x="5289840" y="338148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6" name="Line 323"/>
                    <p:cNvSpPr/>
                    <p:nvPr/>
                  </p:nvSpPr>
                  <p:spPr>
                    <a:xfrm>
                      <a:off x="5303520" y="338148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457" name="Group 324"/>
                  <p:cNvGrpSpPr/>
                  <p:nvPr/>
                </p:nvGrpSpPr>
                <p:grpSpPr>
                  <a:xfrm>
                    <a:off x="4091040" y="3410280"/>
                    <a:ext cx="1251720" cy="60120"/>
                    <a:chOff x="4091040" y="3410280"/>
                    <a:chExt cx="1251720" cy="60120"/>
                  </a:xfrm>
                </p:grpSpPr>
                <p:sp>
                  <p:nvSpPr>
                    <p:cNvPr id="458" name="Rectangle 325"/>
                    <p:cNvSpPr/>
                    <p:nvPr/>
                  </p:nvSpPr>
                  <p:spPr>
                    <a:xfrm>
                      <a:off x="4091040" y="34243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9" name="Rectangle 326"/>
                    <p:cNvSpPr/>
                    <p:nvPr/>
                  </p:nvSpPr>
                  <p:spPr>
                    <a:xfrm>
                      <a:off x="4154760" y="34102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0" name="Rectangle 327"/>
                    <p:cNvSpPr/>
                    <p:nvPr/>
                  </p:nvSpPr>
                  <p:spPr>
                    <a:xfrm>
                      <a:off x="4380480" y="34243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1" name="Rectangle 328"/>
                    <p:cNvSpPr/>
                    <p:nvPr/>
                  </p:nvSpPr>
                  <p:spPr>
                    <a:xfrm>
                      <a:off x="4444200" y="34102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2" name="Rectangle 329"/>
                    <p:cNvSpPr/>
                    <p:nvPr/>
                  </p:nvSpPr>
                  <p:spPr>
                    <a:xfrm>
                      <a:off x="4673880" y="34243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3" name="Rectangle 330"/>
                    <p:cNvSpPr/>
                    <p:nvPr/>
                  </p:nvSpPr>
                  <p:spPr>
                    <a:xfrm>
                      <a:off x="4737600" y="34102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4" name="Rectangle 331"/>
                    <p:cNvSpPr/>
                    <p:nvPr/>
                  </p:nvSpPr>
                  <p:spPr>
                    <a:xfrm>
                      <a:off x="4967640" y="34243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5" name="Rectangle 332"/>
                    <p:cNvSpPr/>
                    <p:nvPr/>
                  </p:nvSpPr>
                  <p:spPr>
                    <a:xfrm>
                      <a:off x="5031360" y="34102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6" name="Rectangle 333"/>
                    <p:cNvSpPr/>
                    <p:nvPr/>
                  </p:nvSpPr>
                  <p:spPr>
                    <a:xfrm>
                      <a:off x="5257080" y="34243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67" name="Rectangle 334"/>
                    <p:cNvSpPr/>
                    <p:nvPr/>
                  </p:nvSpPr>
                  <p:spPr>
                    <a:xfrm>
                      <a:off x="5320800" y="34102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468" name="Rectangle 335"/>
                  <p:cNvSpPr/>
                  <p:nvPr/>
                </p:nvSpPr>
                <p:spPr>
                  <a:xfrm>
                    <a:off x="4643640" y="3471120"/>
                    <a:ext cx="2520" cy="3646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69" name="Group 336"/>
                <p:cNvGrpSpPr/>
                <p:nvPr/>
              </p:nvGrpSpPr>
              <p:grpSpPr>
                <a:xfrm>
                  <a:off x="3936960" y="2454120"/>
                  <a:ext cx="200520" cy="944640"/>
                  <a:chOff x="3936960" y="2454120"/>
                  <a:chExt cx="200520" cy="944640"/>
                </a:xfrm>
              </p:grpSpPr>
              <p:sp>
                <p:nvSpPr>
                  <p:cNvPr id="470" name="Line 337"/>
                  <p:cNvSpPr/>
                  <p:nvPr/>
                </p:nvSpPr>
                <p:spPr>
                  <a:xfrm flipV="1">
                    <a:off x="4137480" y="2454120"/>
                    <a:ext cx="0" cy="92376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471" name="Group 338"/>
                  <p:cNvGrpSpPr/>
                  <p:nvPr/>
                </p:nvGrpSpPr>
                <p:grpSpPr>
                  <a:xfrm>
                    <a:off x="3995640" y="2471760"/>
                    <a:ext cx="86040" cy="927000"/>
                    <a:chOff x="3995640" y="2471760"/>
                    <a:chExt cx="86040" cy="927000"/>
                  </a:xfrm>
                </p:grpSpPr>
                <p:sp>
                  <p:nvSpPr>
                    <p:cNvPr id="472" name="Rectangle 339"/>
                    <p:cNvSpPr/>
                    <p:nvPr/>
                  </p:nvSpPr>
                  <p:spPr>
                    <a:xfrm>
                      <a:off x="4059720" y="33526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3" name="Rectangle 340"/>
                    <p:cNvSpPr/>
                    <p:nvPr/>
                  </p:nvSpPr>
                  <p:spPr>
                    <a:xfrm>
                      <a:off x="4027320" y="31773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4" name="Rectangle 341"/>
                    <p:cNvSpPr/>
                    <p:nvPr/>
                  </p:nvSpPr>
                  <p:spPr>
                    <a:xfrm>
                      <a:off x="4027320" y="30016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5" name="Rectangle 342"/>
                    <p:cNvSpPr/>
                    <p:nvPr/>
                  </p:nvSpPr>
                  <p:spPr>
                    <a:xfrm>
                      <a:off x="4027320" y="2822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6" name="Rectangle 343"/>
                    <p:cNvSpPr/>
                    <p:nvPr/>
                  </p:nvSpPr>
                  <p:spPr>
                    <a:xfrm>
                      <a:off x="4027320" y="2647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7" name="Rectangle 344"/>
                    <p:cNvSpPr/>
                    <p:nvPr/>
                  </p:nvSpPr>
                  <p:spPr>
                    <a:xfrm>
                      <a:off x="3995640" y="247176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478" name="Group 345"/>
                  <p:cNvGrpSpPr/>
                  <p:nvPr/>
                </p:nvGrpSpPr>
                <p:grpSpPr>
                  <a:xfrm>
                    <a:off x="4110480" y="2496960"/>
                    <a:ext cx="26640" cy="880560"/>
                    <a:chOff x="4110480" y="2496960"/>
                    <a:chExt cx="26640" cy="880560"/>
                  </a:xfrm>
                </p:grpSpPr>
                <p:sp>
                  <p:nvSpPr>
                    <p:cNvPr id="479" name="Line 346"/>
                    <p:cNvSpPr/>
                    <p:nvPr/>
                  </p:nvSpPr>
                  <p:spPr>
                    <a:xfrm flipH="1">
                      <a:off x="4110480" y="337752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0" name="Line 347"/>
                    <p:cNvSpPr/>
                    <p:nvPr/>
                  </p:nvSpPr>
                  <p:spPr>
                    <a:xfrm flipH="1">
                      <a:off x="4128120" y="333504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1" name="Line 348"/>
                    <p:cNvSpPr/>
                    <p:nvPr/>
                  </p:nvSpPr>
                  <p:spPr>
                    <a:xfrm flipH="1">
                      <a:off x="4128120" y="329184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2" name="Line 349"/>
                    <p:cNvSpPr/>
                    <p:nvPr/>
                  </p:nvSpPr>
                  <p:spPr>
                    <a:xfrm flipH="1">
                      <a:off x="4128120" y="32454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3" name="Line 350"/>
                    <p:cNvSpPr/>
                    <p:nvPr/>
                  </p:nvSpPr>
                  <p:spPr>
                    <a:xfrm flipH="1">
                      <a:off x="4110480" y="320220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4" name="Line 351"/>
                    <p:cNvSpPr/>
                    <p:nvPr/>
                  </p:nvSpPr>
                  <p:spPr>
                    <a:xfrm flipH="1">
                      <a:off x="4128120" y="31590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5" name="Line 352"/>
                    <p:cNvSpPr/>
                    <p:nvPr/>
                  </p:nvSpPr>
                  <p:spPr>
                    <a:xfrm flipH="1">
                      <a:off x="4128120" y="311292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6" name="Line 353"/>
                    <p:cNvSpPr/>
                    <p:nvPr/>
                  </p:nvSpPr>
                  <p:spPr>
                    <a:xfrm flipH="1">
                      <a:off x="4128120" y="306972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7" name="Line 354"/>
                    <p:cNvSpPr/>
                    <p:nvPr/>
                  </p:nvSpPr>
                  <p:spPr>
                    <a:xfrm flipH="1">
                      <a:off x="4110480" y="302688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8" name="Line 355"/>
                    <p:cNvSpPr/>
                    <p:nvPr/>
                  </p:nvSpPr>
                  <p:spPr>
                    <a:xfrm flipH="1">
                      <a:off x="4128120" y="298008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89" name="Line 356"/>
                    <p:cNvSpPr/>
                    <p:nvPr/>
                  </p:nvSpPr>
                  <p:spPr>
                    <a:xfrm flipH="1">
                      <a:off x="4128120" y="29376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0" name="Line 357"/>
                    <p:cNvSpPr/>
                    <p:nvPr/>
                  </p:nvSpPr>
                  <p:spPr>
                    <a:xfrm flipH="1">
                      <a:off x="4128120" y="28944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1" name="Line 358"/>
                    <p:cNvSpPr/>
                    <p:nvPr/>
                  </p:nvSpPr>
                  <p:spPr>
                    <a:xfrm flipH="1">
                      <a:off x="4110480" y="284760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2" name="Line 359"/>
                    <p:cNvSpPr/>
                    <p:nvPr/>
                  </p:nvSpPr>
                  <p:spPr>
                    <a:xfrm flipH="1">
                      <a:off x="4128120" y="280476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3" name="Line 360"/>
                    <p:cNvSpPr/>
                    <p:nvPr/>
                  </p:nvSpPr>
                  <p:spPr>
                    <a:xfrm flipH="1">
                      <a:off x="4128120" y="276192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4" name="Line 361"/>
                    <p:cNvSpPr/>
                    <p:nvPr/>
                  </p:nvSpPr>
                  <p:spPr>
                    <a:xfrm flipH="1">
                      <a:off x="4128120" y="271512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5" name="Line 362"/>
                    <p:cNvSpPr/>
                    <p:nvPr/>
                  </p:nvSpPr>
                  <p:spPr>
                    <a:xfrm flipH="1">
                      <a:off x="4110480" y="267228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6" name="Line 363"/>
                    <p:cNvSpPr/>
                    <p:nvPr/>
                  </p:nvSpPr>
                  <p:spPr>
                    <a:xfrm flipH="1">
                      <a:off x="4128120" y="262908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7" name="Line 364"/>
                    <p:cNvSpPr/>
                    <p:nvPr/>
                  </p:nvSpPr>
                  <p:spPr>
                    <a:xfrm flipH="1">
                      <a:off x="4128120" y="25830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8" name="Line 365"/>
                    <p:cNvSpPr/>
                    <p:nvPr/>
                  </p:nvSpPr>
                  <p:spPr>
                    <a:xfrm flipH="1">
                      <a:off x="4128120" y="2539800"/>
                      <a:ext cx="8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9" name="Line 366"/>
                    <p:cNvSpPr/>
                    <p:nvPr/>
                  </p:nvSpPr>
                  <p:spPr>
                    <a:xfrm flipH="1">
                      <a:off x="4110480" y="249696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00" name="Rectangle 367"/>
                  <p:cNvSpPr/>
                  <p:nvPr/>
                </p:nvSpPr>
                <p:spPr>
                  <a:xfrm rot="16200000">
                    <a:off x="3755160" y="3178080"/>
                    <a:ext cx="365400" cy="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 vert="eaVer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501" name="Group 368"/>
              <p:cNvGrpSpPr/>
              <p:nvPr/>
            </p:nvGrpSpPr>
            <p:grpSpPr>
              <a:xfrm>
                <a:off x="4147920" y="2500200"/>
                <a:ext cx="1152360" cy="871200"/>
                <a:chOff x="4147920" y="2500200"/>
                <a:chExt cx="1152360" cy="871200"/>
              </a:xfrm>
            </p:grpSpPr>
            <p:sp>
              <p:nvSpPr>
                <p:cNvPr id="502" name="Freeform 369"/>
                <p:cNvSpPr/>
                <p:nvPr/>
              </p:nvSpPr>
              <p:spPr>
                <a:xfrm>
                  <a:off x="4147920" y="2500200"/>
                  <a:ext cx="1152360" cy="867960"/>
                </a:xfrm>
                <a:custGeom>
                  <a:avLst/>
                  <a:gdLst>
                    <a:gd name="textAreaLeft" fmla="*/ 0 w 1152360"/>
                    <a:gd name="textAreaRight" fmla="*/ 1152720 w 1152360"/>
                    <a:gd name="textAreaTop" fmla="*/ 0 h 867960"/>
                    <a:gd name="textAreaBottom" fmla="*/ 868320 h 867960"/>
                  </a:gdLst>
                  <a:ahLst/>
                  <a:rect l="textAreaLeft" t="textAreaTop" r="textAreaRight" b="textAreaBottom"/>
                  <a:pathLst>
                    <a:path w="510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  <a:lnTo>
                        <a:pt x="510" y="486"/>
                      </a:lnTo>
                      <a:lnTo>
                        <a:pt x="0" y="486"/>
                      </a:lnTo>
                      <a:close/>
                    </a:path>
                  </a:pathLst>
                </a:custGeom>
                <a:solidFill>
                  <a:srgbClr val="e8e8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Freeform 370"/>
                <p:cNvSpPr/>
                <p:nvPr/>
              </p:nvSpPr>
              <p:spPr>
                <a:xfrm>
                  <a:off x="4152240" y="2503440"/>
                  <a:ext cx="1147680" cy="867960"/>
                </a:xfrm>
                <a:custGeom>
                  <a:avLst/>
                  <a:gdLst>
                    <a:gd name="textAreaLeft" fmla="*/ 0 w 1147680"/>
                    <a:gd name="textAreaRight" fmla="*/ 1148040 w 1147680"/>
                    <a:gd name="textAreaTop" fmla="*/ 0 h 867960"/>
                    <a:gd name="textAreaBottom" fmla="*/ 868320 h 867960"/>
                  </a:gdLst>
                  <a:ahLst/>
                  <a:rect l="textAreaLeft" t="textAreaTop" r="textAreaRight" b="textAreaBottom"/>
                  <a:pathLst>
                    <a:path w="508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</a:path>
                  </a:pathLst>
                </a:custGeom>
                <a:noFill/>
                <a:ln w="6480">
                  <a:solidFill>
                    <a:srgbClr val="b3b3b3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04" name="Freeform 371"/>
              <p:cNvSpPr/>
              <p:nvPr/>
            </p:nvSpPr>
            <p:spPr>
              <a:xfrm>
                <a:off x="4152960" y="2503440"/>
                <a:ext cx="1147680" cy="868320"/>
              </a:xfrm>
              <a:custGeom>
                <a:avLst/>
                <a:gdLst>
                  <a:gd name="textAreaLeft" fmla="*/ 0 w 1147680"/>
                  <a:gd name="textAreaRight" fmla="*/ 1148040 w 1147680"/>
                  <a:gd name="textAreaTop" fmla="*/ 0 h 868320"/>
                  <a:gd name="textAreaBottom" fmla="*/ 868680 h 86832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0" y="472"/>
                    </a:lnTo>
                    <a:lnTo>
                      <a:pt x="0" y="474"/>
                    </a:lnTo>
                    <a:lnTo>
                      <a:pt x="2" y="474"/>
                    </a:lnTo>
                    <a:lnTo>
                      <a:pt x="4" y="476"/>
                    </a:lnTo>
                    <a:lnTo>
                      <a:pt x="6" y="476"/>
                    </a:lnTo>
                    <a:lnTo>
                      <a:pt x="8" y="476"/>
                    </a:lnTo>
                    <a:lnTo>
                      <a:pt x="10" y="476"/>
                    </a:lnTo>
                    <a:lnTo>
                      <a:pt x="12" y="474"/>
                    </a:lnTo>
                    <a:lnTo>
                      <a:pt x="14" y="472"/>
                    </a:lnTo>
                    <a:lnTo>
                      <a:pt x="16" y="466"/>
                    </a:lnTo>
                    <a:lnTo>
                      <a:pt x="18" y="460"/>
                    </a:lnTo>
                    <a:lnTo>
                      <a:pt x="20" y="452"/>
                    </a:lnTo>
                    <a:lnTo>
                      <a:pt x="22" y="442"/>
                    </a:lnTo>
                    <a:lnTo>
                      <a:pt x="24" y="430"/>
                    </a:lnTo>
                    <a:lnTo>
                      <a:pt x="26" y="412"/>
                    </a:lnTo>
                    <a:lnTo>
                      <a:pt x="28" y="390"/>
                    </a:lnTo>
                    <a:lnTo>
                      <a:pt x="30" y="362"/>
                    </a:lnTo>
                    <a:lnTo>
                      <a:pt x="32" y="336"/>
                    </a:lnTo>
                    <a:lnTo>
                      <a:pt x="34" y="310"/>
                    </a:lnTo>
                    <a:lnTo>
                      <a:pt x="36" y="276"/>
                    </a:lnTo>
                    <a:lnTo>
                      <a:pt x="38" y="230"/>
                    </a:lnTo>
                    <a:lnTo>
                      <a:pt x="40" y="188"/>
                    </a:lnTo>
                    <a:lnTo>
                      <a:pt x="42" y="154"/>
                    </a:lnTo>
                    <a:lnTo>
                      <a:pt x="44" y="126"/>
                    </a:lnTo>
                    <a:lnTo>
                      <a:pt x="46" y="106"/>
                    </a:lnTo>
                    <a:lnTo>
                      <a:pt x="48" y="78"/>
                    </a:lnTo>
                    <a:lnTo>
                      <a:pt x="50" y="46"/>
                    </a:lnTo>
                    <a:lnTo>
                      <a:pt x="52" y="38"/>
                    </a:lnTo>
                    <a:lnTo>
                      <a:pt x="54" y="24"/>
                    </a:lnTo>
                    <a:lnTo>
                      <a:pt x="56" y="0"/>
                    </a:lnTo>
                    <a:lnTo>
                      <a:pt x="58" y="28"/>
                    </a:lnTo>
                    <a:lnTo>
                      <a:pt x="60" y="60"/>
                    </a:lnTo>
                    <a:lnTo>
                      <a:pt x="62" y="8"/>
                    </a:lnTo>
                    <a:lnTo>
                      <a:pt x="64" y="0"/>
                    </a:lnTo>
                    <a:lnTo>
                      <a:pt x="66" y="64"/>
                    </a:lnTo>
                    <a:lnTo>
                      <a:pt x="68" y="92"/>
                    </a:lnTo>
                    <a:lnTo>
                      <a:pt x="70" y="90"/>
                    </a:lnTo>
                    <a:lnTo>
                      <a:pt x="72" y="94"/>
                    </a:lnTo>
                    <a:lnTo>
                      <a:pt x="74" y="106"/>
                    </a:lnTo>
                    <a:lnTo>
                      <a:pt x="76" y="106"/>
                    </a:lnTo>
                    <a:lnTo>
                      <a:pt x="78" y="116"/>
                    </a:lnTo>
                    <a:lnTo>
                      <a:pt x="80" y="136"/>
                    </a:lnTo>
                    <a:lnTo>
                      <a:pt x="82" y="132"/>
                    </a:lnTo>
                    <a:lnTo>
                      <a:pt x="84" y="140"/>
                    </a:lnTo>
                    <a:lnTo>
                      <a:pt x="86" y="180"/>
                    </a:lnTo>
                    <a:lnTo>
                      <a:pt x="88" y="198"/>
                    </a:lnTo>
                    <a:lnTo>
                      <a:pt x="90" y="198"/>
                    </a:lnTo>
                    <a:lnTo>
                      <a:pt x="92" y="204"/>
                    </a:lnTo>
                    <a:lnTo>
                      <a:pt x="94" y="216"/>
                    </a:lnTo>
                    <a:lnTo>
                      <a:pt x="96" y="226"/>
                    </a:lnTo>
                    <a:lnTo>
                      <a:pt x="98" y="250"/>
                    </a:lnTo>
                    <a:lnTo>
                      <a:pt x="100" y="272"/>
                    </a:lnTo>
                    <a:lnTo>
                      <a:pt x="102" y="282"/>
                    </a:lnTo>
                    <a:lnTo>
                      <a:pt x="104" y="288"/>
                    </a:lnTo>
                    <a:lnTo>
                      <a:pt x="106" y="288"/>
                    </a:lnTo>
                    <a:lnTo>
                      <a:pt x="108" y="294"/>
                    </a:lnTo>
                    <a:lnTo>
                      <a:pt x="110" y="306"/>
                    </a:lnTo>
                    <a:lnTo>
                      <a:pt x="112" y="316"/>
                    </a:lnTo>
                    <a:lnTo>
                      <a:pt x="114" y="320"/>
                    </a:lnTo>
                    <a:lnTo>
                      <a:pt x="116" y="322"/>
                    </a:lnTo>
                    <a:lnTo>
                      <a:pt x="118" y="328"/>
                    </a:lnTo>
                    <a:lnTo>
                      <a:pt x="120" y="332"/>
                    </a:lnTo>
                    <a:lnTo>
                      <a:pt x="122" y="336"/>
                    </a:lnTo>
                    <a:lnTo>
                      <a:pt x="124" y="344"/>
                    </a:lnTo>
                    <a:lnTo>
                      <a:pt x="126" y="348"/>
                    </a:lnTo>
                    <a:lnTo>
                      <a:pt x="128" y="346"/>
                    </a:lnTo>
                    <a:lnTo>
                      <a:pt x="130" y="348"/>
                    </a:lnTo>
                    <a:lnTo>
                      <a:pt x="132" y="360"/>
                    </a:lnTo>
                    <a:lnTo>
                      <a:pt x="134" y="372"/>
                    </a:lnTo>
                    <a:lnTo>
                      <a:pt x="136" y="374"/>
                    </a:lnTo>
                    <a:lnTo>
                      <a:pt x="138" y="372"/>
                    </a:lnTo>
                    <a:lnTo>
                      <a:pt x="140" y="372"/>
                    </a:lnTo>
                    <a:lnTo>
                      <a:pt x="142" y="372"/>
                    </a:lnTo>
                    <a:lnTo>
                      <a:pt x="144" y="374"/>
                    </a:lnTo>
                    <a:lnTo>
                      <a:pt x="146" y="378"/>
                    </a:lnTo>
                    <a:lnTo>
                      <a:pt x="148" y="384"/>
                    </a:lnTo>
                    <a:lnTo>
                      <a:pt x="150" y="388"/>
                    </a:lnTo>
                    <a:lnTo>
                      <a:pt x="152" y="390"/>
                    </a:lnTo>
                    <a:lnTo>
                      <a:pt x="154" y="390"/>
                    </a:lnTo>
                    <a:lnTo>
                      <a:pt x="156" y="396"/>
                    </a:lnTo>
                    <a:lnTo>
                      <a:pt x="158" y="404"/>
                    </a:lnTo>
                    <a:lnTo>
                      <a:pt x="160" y="406"/>
                    </a:lnTo>
                    <a:lnTo>
                      <a:pt x="162" y="406"/>
                    </a:lnTo>
                    <a:lnTo>
                      <a:pt x="164" y="406"/>
                    </a:lnTo>
                    <a:lnTo>
                      <a:pt x="166" y="412"/>
                    </a:lnTo>
                    <a:lnTo>
                      <a:pt x="168" y="416"/>
                    </a:lnTo>
                    <a:lnTo>
                      <a:pt x="170" y="414"/>
                    </a:lnTo>
                    <a:lnTo>
                      <a:pt x="172" y="412"/>
                    </a:lnTo>
                    <a:lnTo>
                      <a:pt x="174" y="412"/>
                    </a:lnTo>
                    <a:lnTo>
                      <a:pt x="176" y="416"/>
                    </a:lnTo>
                    <a:lnTo>
                      <a:pt x="178" y="422"/>
                    </a:lnTo>
                    <a:lnTo>
                      <a:pt x="180" y="426"/>
                    </a:lnTo>
                    <a:lnTo>
                      <a:pt x="182" y="426"/>
                    </a:lnTo>
                    <a:lnTo>
                      <a:pt x="184" y="422"/>
                    </a:lnTo>
                    <a:lnTo>
                      <a:pt x="186" y="418"/>
                    </a:lnTo>
                    <a:lnTo>
                      <a:pt x="188" y="418"/>
                    </a:lnTo>
                    <a:lnTo>
                      <a:pt x="190" y="422"/>
                    </a:lnTo>
                    <a:lnTo>
                      <a:pt x="192" y="428"/>
                    </a:lnTo>
                    <a:lnTo>
                      <a:pt x="194" y="430"/>
                    </a:lnTo>
                    <a:lnTo>
                      <a:pt x="196" y="430"/>
                    </a:lnTo>
                    <a:lnTo>
                      <a:pt x="198" y="430"/>
                    </a:lnTo>
                    <a:lnTo>
                      <a:pt x="200" y="432"/>
                    </a:lnTo>
                    <a:lnTo>
                      <a:pt x="202" y="436"/>
                    </a:lnTo>
                    <a:lnTo>
                      <a:pt x="204" y="440"/>
                    </a:lnTo>
                    <a:lnTo>
                      <a:pt x="206" y="442"/>
                    </a:lnTo>
                    <a:lnTo>
                      <a:pt x="208" y="442"/>
                    </a:lnTo>
                    <a:lnTo>
                      <a:pt x="210" y="442"/>
                    </a:lnTo>
                    <a:lnTo>
                      <a:pt x="212" y="444"/>
                    </a:lnTo>
                    <a:lnTo>
                      <a:pt x="214" y="444"/>
                    </a:lnTo>
                    <a:lnTo>
                      <a:pt x="216" y="444"/>
                    </a:lnTo>
                    <a:lnTo>
                      <a:pt x="218" y="444"/>
                    </a:lnTo>
                    <a:lnTo>
                      <a:pt x="220" y="442"/>
                    </a:lnTo>
                    <a:lnTo>
                      <a:pt x="222" y="442"/>
                    </a:lnTo>
                    <a:lnTo>
                      <a:pt x="224" y="442"/>
                    </a:lnTo>
                    <a:lnTo>
                      <a:pt x="226" y="442"/>
                    </a:lnTo>
                    <a:lnTo>
                      <a:pt x="228" y="440"/>
                    </a:lnTo>
                    <a:lnTo>
                      <a:pt x="230" y="440"/>
                    </a:lnTo>
                    <a:lnTo>
                      <a:pt x="232" y="442"/>
                    </a:lnTo>
                    <a:lnTo>
                      <a:pt x="234" y="442"/>
                    </a:lnTo>
                    <a:lnTo>
                      <a:pt x="236" y="444"/>
                    </a:lnTo>
                    <a:lnTo>
                      <a:pt x="238" y="446"/>
                    </a:lnTo>
                    <a:lnTo>
                      <a:pt x="240" y="446"/>
                    </a:lnTo>
                    <a:lnTo>
                      <a:pt x="242" y="444"/>
                    </a:lnTo>
                    <a:lnTo>
                      <a:pt x="244" y="444"/>
                    </a:lnTo>
                    <a:lnTo>
                      <a:pt x="246" y="444"/>
                    </a:lnTo>
                    <a:lnTo>
                      <a:pt x="248" y="446"/>
                    </a:lnTo>
                    <a:lnTo>
                      <a:pt x="250" y="448"/>
                    </a:lnTo>
                    <a:lnTo>
                      <a:pt x="252" y="450"/>
                    </a:lnTo>
                    <a:lnTo>
                      <a:pt x="254" y="452"/>
                    </a:lnTo>
                    <a:lnTo>
                      <a:pt x="256" y="454"/>
                    </a:lnTo>
                    <a:lnTo>
                      <a:pt x="258" y="454"/>
                    </a:lnTo>
                    <a:lnTo>
                      <a:pt x="260" y="454"/>
                    </a:lnTo>
                    <a:lnTo>
                      <a:pt x="262" y="454"/>
                    </a:lnTo>
                    <a:lnTo>
                      <a:pt x="264" y="454"/>
                    </a:lnTo>
                    <a:lnTo>
                      <a:pt x="266" y="454"/>
                    </a:lnTo>
                    <a:lnTo>
                      <a:pt x="268" y="454"/>
                    </a:lnTo>
                    <a:lnTo>
                      <a:pt x="270" y="458"/>
                    </a:lnTo>
                    <a:lnTo>
                      <a:pt x="272" y="460"/>
                    </a:lnTo>
                    <a:lnTo>
                      <a:pt x="274" y="460"/>
                    </a:lnTo>
                    <a:lnTo>
                      <a:pt x="276" y="462"/>
                    </a:lnTo>
                    <a:lnTo>
                      <a:pt x="278" y="462"/>
                    </a:lnTo>
                    <a:lnTo>
                      <a:pt x="280" y="462"/>
                    </a:lnTo>
                    <a:lnTo>
                      <a:pt x="282" y="462"/>
                    </a:lnTo>
                    <a:lnTo>
                      <a:pt x="284" y="464"/>
                    </a:lnTo>
                    <a:lnTo>
                      <a:pt x="286" y="464"/>
                    </a:lnTo>
                    <a:lnTo>
                      <a:pt x="288" y="466"/>
                    </a:lnTo>
                    <a:lnTo>
                      <a:pt x="290" y="468"/>
                    </a:lnTo>
                    <a:lnTo>
                      <a:pt x="292" y="470"/>
                    </a:lnTo>
                    <a:lnTo>
                      <a:pt x="294" y="470"/>
                    </a:lnTo>
                    <a:lnTo>
                      <a:pt x="296" y="470"/>
                    </a:lnTo>
                    <a:lnTo>
                      <a:pt x="298" y="472"/>
                    </a:lnTo>
                    <a:lnTo>
                      <a:pt x="300" y="472"/>
                    </a:lnTo>
                    <a:lnTo>
                      <a:pt x="302" y="474"/>
                    </a:lnTo>
                    <a:lnTo>
                      <a:pt x="304" y="474"/>
                    </a:lnTo>
                    <a:lnTo>
                      <a:pt x="306" y="474"/>
                    </a:lnTo>
                    <a:lnTo>
                      <a:pt x="308" y="476"/>
                    </a:lnTo>
                    <a:lnTo>
                      <a:pt x="310" y="476"/>
                    </a:lnTo>
                    <a:lnTo>
                      <a:pt x="312" y="476"/>
                    </a:lnTo>
                    <a:lnTo>
                      <a:pt x="314" y="476"/>
                    </a:lnTo>
                    <a:lnTo>
                      <a:pt x="316" y="476"/>
                    </a:lnTo>
                    <a:lnTo>
                      <a:pt x="318" y="476"/>
                    </a:lnTo>
                    <a:lnTo>
                      <a:pt x="320" y="478"/>
                    </a:lnTo>
                    <a:lnTo>
                      <a:pt x="322" y="478"/>
                    </a:lnTo>
                    <a:lnTo>
                      <a:pt x="324" y="480"/>
                    </a:lnTo>
                    <a:lnTo>
                      <a:pt x="326" y="480"/>
                    </a:lnTo>
                    <a:lnTo>
                      <a:pt x="328" y="482"/>
                    </a:lnTo>
                    <a:lnTo>
                      <a:pt x="330" y="482"/>
                    </a:lnTo>
                    <a:lnTo>
                      <a:pt x="332" y="482"/>
                    </a:lnTo>
                    <a:lnTo>
                      <a:pt x="334" y="484"/>
                    </a:lnTo>
                    <a:lnTo>
                      <a:pt x="336" y="484"/>
                    </a:lnTo>
                    <a:lnTo>
                      <a:pt x="338" y="484"/>
                    </a:lnTo>
                    <a:lnTo>
                      <a:pt x="340" y="484"/>
                    </a:lnTo>
                    <a:lnTo>
                      <a:pt x="342" y="484"/>
                    </a:lnTo>
                    <a:lnTo>
                      <a:pt x="344" y="484"/>
                    </a:lnTo>
                    <a:lnTo>
                      <a:pt x="346" y="484"/>
                    </a:lnTo>
                    <a:lnTo>
                      <a:pt x="348" y="484"/>
                    </a:lnTo>
                    <a:lnTo>
                      <a:pt x="350" y="484"/>
                    </a:lnTo>
                    <a:lnTo>
                      <a:pt x="352" y="484"/>
                    </a:lnTo>
                    <a:lnTo>
                      <a:pt x="354" y="484"/>
                    </a:lnTo>
                    <a:lnTo>
                      <a:pt x="356" y="486"/>
                    </a:lnTo>
                    <a:lnTo>
                      <a:pt x="358" y="486"/>
                    </a:lnTo>
                    <a:lnTo>
                      <a:pt x="360" y="486"/>
                    </a:lnTo>
                    <a:lnTo>
                      <a:pt x="362" y="486"/>
                    </a:lnTo>
                    <a:lnTo>
                      <a:pt x="364" y="484"/>
                    </a:lnTo>
                    <a:lnTo>
                      <a:pt x="366" y="484"/>
                    </a:lnTo>
                    <a:lnTo>
                      <a:pt x="368" y="484"/>
                    </a:lnTo>
                    <a:lnTo>
                      <a:pt x="370" y="484"/>
                    </a:lnTo>
                    <a:lnTo>
                      <a:pt x="372" y="484"/>
                    </a:lnTo>
                    <a:lnTo>
                      <a:pt x="374" y="484"/>
                    </a:lnTo>
                    <a:lnTo>
                      <a:pt x="376" y="484"/>
                    </a:lnTo>
                    <a:lnTo>
                      <a:pt x="378" y="484"/>
                    </a:lnTo>
                    <a:lnTo>
                      <a:pt x="380" y="484"/>
                    </a:lnTo>
                    <a:lnTo>
                      <a:pt x="382" y="484"/>
                    </a:lnTo>
                    <a:lnTo>
                      <a:pt x="384" y="484"/>
                    </a:lnTo>
                    <a:lnTo>
                      <a:pt x="386" y="484"/>
                    </a:lnTo>
                    <a:lnTo>
                      <a:pt x="388" y="484"/>
                    </a:lnTo>
                    <a:lnTo>
                      <a:pt x="390" y="484"/>
                    </a:lnTo>
                    <a:lnTo>
                      <a:pt x="392" y="484"/>
                    </a:lnTo>
                    <a:lnTo>
                      <a:pt x="394" y="484"/>
                    </a:lnTo>
                    <a:lnTo>
                      <a:pt x="396" y="484"/>
                    </a:lnTo>
                    <a:lnTo>
                      <a:pt x="398" y="484"/>
                    </a:lnTo>
                    <a:lnTo>
                      <a:pt x="400" y="484"/>
                    </a:lnTo>
                    <a:lnTo>
                      <a:pt x="402" y="484"/>
                    </a:lnTo>
                    <a:lnTo>
                      <a:pt x="404" y="484"/>
                    </a:lnTo>
                    <a:lnTo>
                      <a:pt x="406" y="484"/>
                    </a:lnTo>
                    <a:lnTo>
                      <a:pt x="408" y="484"/>
                    </a:lnTo>
                    <a:lnTo>
                      <a:pt x="410" y="484"/>
                    </a:lnTo>
                    <a:lnTo>
                      <a:pt x="412" y="484"/>
                    </a:lnTo>
                    <a:lnTo>
                      <a:pt x="414" y="484"/>
                    </a:lnTo>
                    <a:lnTo>
                      <a:pt x="416" y="484"/>
                    </a:lnTo>
                    <a:lnTo>
                      <a:pt x="418" y="484"/>
                    </a:lnTo>
                    <a:lnTo>
                      <a:pt x="420" y="484"/>
                    </a:lnTo>
                    <a:lnTo>
                      <a:pt x="422" y="484"/>
                    </a:lnTo>
                    <a:lnTo>
                      <a:pt x="424" y="484"/>
                    </a:lnTo>
                    <a:lnTo>
                      <a:pt x="426" y="484"/>
                    </a:lnTo>
                    <a:lnTo>
                      <a:pt x="428" y="484"/>
                    </a:lnTo>
                    <a:lnTo>
                      <a:pt x="430" y="484"/>
                    </a:lnTo>
                    <a:lnTo>
                      <a:pt x="432" y="484"/>
                    </a:lnTo>
                    <a:lnTo>
                      <a:pt x="434" y="484"/>
                    </a:lnTo>
                    <a:lnTo>
                      <a:pt x="436" y="484"/>
                    </a:lnTo>
                    <a:lnTo>
                      <a:pt x="438" y="484"/>
                    </a:lnTo>
                    <a:lnTo>
                      <a:pt x="440" y="484"/>
                    </a:lnTo>
                    <a:lnTo>
                      <a:pt x="442" y="484"/>
                    </a:lnTo>
                    <a:lnTo>
                      <a:pt x="444" y="484"/>
                    </a:lnTo>
                    <a:lnTo>
                      <a:pt x="446" y="484"/>
                    </a:lnTo>
                    <a:lnTo>
                      <a:pt x="448" y="484"/>
                    </a:lnTo>
                    <a:lnTo>
                      <a:pt x="450" y="484"/>
                    </a:lnTo>
                    <a:lnTo>
                      <a:pt x="452" y="484"/>
                    </a:lnTo>
                    <a:lnTo>
                      <a:pt x="454" y="484"/>
                    </a:lnTo>
                    <a:lnTo>
                      <a:pt x="456" y="484"/>
                    </a:lnTo>
                    <a:lnTo>
                      <a:pt x="458" y="484"/>
                    </a:lnTo>
                    <a:lnTo>
                      <a:pt x="460" y="484"/>
                    </a:lnTo>
                    <a:lnTo>
                      <a:pt x="462" y="484"/>
                    </a:lnTo>
                    <a:lnTo>
                      <a:pt x="464" y="484"/>
                    </a:lnTo>
                    <a:lnTo>
                      <a:pt x="466" y="484"/>
                    </a:lnTo>
                    <a:lnTo>
                      <a:pt x="468" y="484"/>
                    </a:lnTo>
                    <a:lnTo>
                      <a:pt x="470" y="484"/>
                    </a:lnTo>
                    <a:lnTo>
                      <a:pt x="472" y="484"/>
                    </a:lnTo>
                    <a:lnTo>
                      <a:pt x="474" y="486"/>
                    </a:lnTo>
                    <a:lnTo>
                      <a:pt x="476" y="486"/>
                    </a:lnTo>
                    <a:lnTo>
                      <a:pt x="478" y="486"/>
                    </a:lnTo>
                    <a:lnTo>
                      <a:pt x="480" y="486"/>
                    </a:lnTo>
                    <a:lnTo>
                      <a:pt x="482" y="486"/>
                    </a:lnTo>
                    <a:lnTo>
                      <a:pt x="484" y="486"/>
                    </a:lnTo>
                    <a:lnTo>
                      <a:pt x="486" y="486"/>
                    </a:lnTo>
                    <a:lnTo>
                      <a:pt x="488" y="486"/>
                    </a:lnTo>
                    <a:lnTo>
                      <a:pt x="490" y="486"/>
                    </a:lnTo>
                    <a:lnTo>
                      <a:pt x="492" y="486"/>
                    </a:lnTo>
                    <a:lnTo>
                      <a:pt x="494" y="486"/>
                    </a:lnTo>
                    <a:lnTo>
                      <a:pt x="496" y="486"/>
                    </a:lnTo>
                    <a:lnTo>
                      <a:pt x="498" y="486"/>
                    </a:lnTo>
                    <a:lnTo>
                      <a:pt x="500" y="486"/>
                    </a:lnTo>
                    <a:lnTo>
                      <a:pt x="502" y="486"/>
                    </a:lnTo>
                    <a:lnTo>
                      <a:pt x="504" y="486"/>
                    </a:lnTo>
                    <a:lnTo>
                      <a:pt x="506" y="486"/>
                    </a:lnTo>
                    <a:lnTo>
                      <a:pt x="508" y="486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05" name="Text Box 3834"/>
            <p:cNvSpPr/>
            <p:nvPr/>
          </p:nvSpPr>
          <p:spPr>
            <a:xfrm>
              <a:off x="4629600" y="2458800"/>
              <a:ext cx="70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19.3/16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6" name="Group 3861"/>
          <p:cNvGrpSpPr/>
          <p:nvPr/>
        </p:nvGrpSpPr>
        <p:grpSpPr>
          <a:xfrm>
            <a:off x="1403280" y="4809960"/>
            <a:ext cx="1409760" cy="1388160"/>
            <a:chOff x="1403280" y="4809960"/>
            <a:chExt cx="1409760" cy="1388160"/>
          </a:xfrm>
        </p:grpSpPr>
        <p:grpSp>
          <p:nvGrpSpPr>
            <p:cNvPr id="507" name="Group 3854"/>
            <p:cNvGrpSpPr/>
            <p:nvPr/>
          </p:nvGrpSpPr>
          <p:grpSpPr>
            <a:xfrm>
              <a:off x="1403280" y="4816440"/>
              <a:ext cx="1409760" cy="1381680"/>
              <a:chOff x="1403280" y="4816440"/>
              <a:chExt cx="1409760" cy="1381680"/>
            </a:xfrm>
          </p:grpSpPr>
          <p:grpSp>
            <p:nvGrpSpPr>
              <p:cNvPr id="508" name="Group 9"/>
              <p:cNvGrpSpPr/>
              <p:nvPr/>
            </p:nvGrpSpPr>
            <p:grpSpPr>
              <a:xfrm>
                <a:off x="1403280" y="4816440"/>
                <a:ext cx="1409760" cy="1381680"/>
                <a:chOff x="1403280" y="4816440"/>
                <a:chExt cx="1409760" cy="1381680"/>
              </a:xfrm>
            </p:grpSpPr>
            <p:sp>
              <p:nvSpPr>
                <p:cNvPr id="509" name="Rectangle 10"/>
                <p:cNvSpPr/>
                <p:nvPr/>
              </p:nvSpPr>
              <p:spPr>
                <a:xfrm>
                  <a:off x="1618560" y="4817880"/>
                  <a:ext cx="1158480" cy="92448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10" name="Group 11"/>
                <p:cNvGrpSpPr/>
                <p:nvPr/>
              </p:nvGrpSpPr>
              <p:grpSpPr>
                <a:xfrm>
                  <a:off x="1569960" y="5740200"/>
                  <a:ext cx="1243080" cy="457920"/>
                  <a:chOff x="1569960" y="5740200"/>
                  <a:chExt cx="1243080" cy="457920"/>
                </a:xfrm>
              </p:grpSpPr>
              <p:sp>
                <p:nvSpPr>
                  <p:cNvPr id="511" name="Line 12"/>
                  <p:cNvSpPr/>
                  <p:nvPr/>
                </p:nvSpPr>
                <p:spPr>
                  <a:xfrm>
                    <a:off x="1616400" y="5740200"/>
                    <a:ext cx="115776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512" name="Group 13"/>
                  <p:cNvGrpSpPr/>
                  <p:nvPr/>
                </p:nvGrpSpPr>
                <p:grpSpPr>
                  <a:xfrm>
                    <a:off x="1616400" y="5743800"/>
                    <a:ext cx="1157400" cy="20880"/>
                    <a:chOff x="1616400" y="5743800"/>
                    <a:chExt cx="1157400" cy="20880"/>
                  </a:xfrm>
                </p:grpSpPr>
                <p:sp>
                  <p:nvSpPr>
                    <p:cNvPr id="513" name="Line 14"/>
                    <p:cNvSpPr/>
                    <p:nvPr/>
                  </p:nvSpPr>
                  <p:spPr>
                    <a:xfrm>
                      <a:off x="1616400" y="574380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4" name="Line 15"/>
                    <p:cNvSpPr/>
                    <p:nvPr/>
                  </p:nvSpPr>
                  <p:spPr>
                    <a:xfrm>
                      <a:off x="170136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5" name="Line 16"/>
                    <p:cNvSpPr/>
                    <p:nvPr/>
                  </p:nvSpPr>
                  <p:spPr>
                    <a:xfrm>
                      <a:off x="175068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6" name="Line 17"/>
                    <p:cNvSpPr/>
                    <p:nvPr/>
                  </p:nvSpPr>
                  <p:spPr>
                    <a:xfrm>
                      <a:off x="178668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7" name="Line 18"/>
                    <p:cNvSpPr/>
                    <p:nvPr/>
                  </p:nvSpPr>
                  <p:spPr>
                    <a:xfrm>
                      <a:off x="1818360" y="574380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8" name="Line 19"/>
                    <p:cNvSpPr/>
                    <p:nvPr/>
                  </p:nvSpPr>
                  <p:spPr>
                    <a:xfrm>
                      <a:off x="184068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9" name="Line 20"/>
                    <p:cNvSpPr/>
                    <p:nvPr/>
                  </p:nvSpPr>
                  <p:spPr>
                    <a:xfrm>
                      <a:off x="185832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0" name="Line 21"/>
                    <p:cNvSpPr/>
                    <p:nvPr/>
                  </p:nvSpPr>
                  <p:spPr>
                    <a:xfrm>
                      <a:off x="187632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1" name="Line 22"/>
                    <p:cNvSpPr/>
                    <p:nvPr/>
                  </p:nvSpPr>
                  <p:spPr>
                    <a:xfrm>
                      <a:off x="189000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2" name="Line 23"/>
                    <p:cNvSpPr/>
                    <p:nvPr/>
                  </p:nvSpPr>
                  <p:spPr>
                    <a:xfrm>
                      <a:off x="1903320" y="574380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3" name="Line 24"/>
                    <p:cNvSpPr/>
                    <p:nvPr/>
                  </p:nvSpPr>
                  <p:spPr>
                    <a:xfrm>
                      <a:off x="199332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4" name="Line 25"/>
                    <p:cNvSpPr/>
                    <p:nvPr/>
                  </p:nvSpPr>
                  <p:spPr>
                    <a:xfrm>
                      <a:off x="204264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5" name="Line 26"/>
                    <p:cNvSpPr/>
                    <p:nvPr/>
                  </p:nvSpPr>
                  <p:spPr>
                    <a:xfrm>
                      <a:off x="207828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6" name="Line 27"/>
                    <p:cNvSpPr/>
                    <p:nvPr/>
                  </p:nvSpPr>
                  <p:spPr>
                    <a:xfrm>
                      <a:off x="2105280" y="574380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7" name="Line 28"/>
                    <p:cNvSpPr/>
                    <p:nvPr/>
                  </p:nvSpPr>
                  <p:spPr>
                    <a:xfrm>
                      <a:off x="213228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8" name="Line 29"/>
                    <p:cNvSpPr/>
                    <p:nvPr/>
                  </p:nvSpPr>
                  <p:spPr>
                    <a:xfrm>
                      <a:off x="214992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9" name="Line 30"/>
                    <p:cNvSpPr/>
                    <p:nvPr/>
                  </p:nvSpPr>
                  <p:spPr>
                    <a:xfrm>
                      <a:off x="216828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0" name="Line 31"/>
                    <p:cNvSpPr/>
                    <p:nvPr/>
                  </p:nvSpPr>
                  <p:spPr>
                    <a:xfrm>
                      <a:off x="218160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1" name="Line 32"/>
                    <p:cNvSpPr/>
                    <p:nvPr/>
                  </p:nvSpPr>
                  <p:spPr>
                    <a:xfrm>
                      <a:off x="2194920" y="574380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2" name="Line 33"/>
                    <p:cNvSpPr/>
                    <p:nvPr/>
                  </p:nvSpPr>
                  <p:spPr>
                    <a:xfrm>
                      <a:off x="228024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3" name="Line 34"/>
                    <p:cNvSpPr/>
                    <p:nvPr/>
                  </p:nvSpPr>
                  <p:spPr>
                    <a:xfrm>
                      <a:off x="233424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4" name="Line 35"/>
                    <p:cNvSpPr/>
                    <p:nvPr/>
                  </p:nvSpPr>
                  <p:spPr>
                    <a:xfrm>
                      <a:off x="236988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5" name="Line 36"/>
                    <p:cNvSpPr/>
                    <p:nvPr/>
                  </p:nvSpPr>
                  <p:spPr>
                    <a:xfrm>
                      <a:off x="2396880" y="574380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6" name="Line 37"/>
                    <p:cNvSpPr/>
                    <p:nvPr/>
                  </p:nvSpPr>
                  <p:spPr>
                    <a:xfrm>
                      <a:off x="241920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7" name="Line 38"/>
                    <p:cNvSpPr/>
                    <p:nvPr/>
                  </p:nvSpPr>
                  <p:spPr>
                    <a:xfrm>
                      <a:off x="244224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8" name="Line 39"/>
                    <p:cNvSpPr/>
                    <p:nvPr/>
                  </p:nvSpPr>
                  <p:spPr>
                    <a:xfrm>
                      <a:off x="245520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9" name="Line 40"/>
                    <p:cNvSpPr/>
                    <p:nvPr/>
                  </p:nvSpPr>
                  <p:spPr>
                    <a:xfrm>
                      <a:off x="247320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0" name="Line 41"/>
                    <p:cNvSpPr/>
                    <p:nvPr/>
                  </p:nvSpPr>
                  <p:spPr>
                    <a:xfrm>
                      <a:off x="2486880" y="574380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1" name="Line 42"/>
                    <p:cNvSpPr/>
                    <p:nvPr/>
                  </p:nvSpPr>
                  <p:spPr>
                    <a:xfrm>
                      <a:off x="257184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2" name="Line 43"/>
                    <p:cNvSpPr/>
                    <p:nvPr/>
                  </p:nvSpPr>
                  <p:spPr>
                    <a:xfrm>
                      <a:off x="262584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3" name="Line 44"/>
                    <p:cNvSpPr/>
                    <p:nvPr/>
                  </p:nvSpPr>
                  <p:spPr>
                    <a:xfrm>
                      <a:off x="266184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4" name="Line 45"/>
                    <p:cNvSpPr/>
                    <p:nvPr/>
                  </p:nvSpPr>
                  <p:spPr>
                    <a:xfrm>
                      <a:off x="2688840" y="574380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5" name="Line 46"/>
                    <p:cNvSpPr/>
                    <p:nvPr/>
                  </p:nvSpPr>
                  <p:spPr>
                    <a:xfrm>
                      <a:off x="271116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6" name="Line 47"/>
                    <p:cNvSpPr/>
                    <p:nvPr/>
                  </p:nvSpPr>
                  <p:spPr>
                    <a:xfrm>
                      <a:off x="272916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7" name="Line 48"/>
                    <p:cNvSpPr/>
                    <p:nvPr/>
                  </p:nvSpPr>
                  <p:spPr>
                    <a:xfrm>
                      <a:off x="274680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8" name="Line 49"/>
                    <p:cNvSpPr/>
                    <p:nvPr/>
                  </p:nvSpPr>
                  <p:spPr>
                    <a:xfrm>
                      <a:off x="2760480" y="574380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9" name="Line 50"/>
                    <p:cNvSpPr/>
                    <p:nvPr/>
                  </p:nvSpPr>
                  <p:spPr>
                    <a:xfrm>
                      <a:off x="2773800" y="574380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550" name="Group 51"/>
                  <p:cNvGrpSpPr/>
                  <p:nvPr/>
                </p:nvGrpSpPr>
                <p:grpSpPr>
                  <a:xfrm>
                    <a:off x="1569960" y="5772600"/>
                    <a:ext cx="1243080" cy="60120"/>
                    <a:chOff x="1569960" y="5772600"/>
                    <a:chExt cx="1243080" cy="60120"/>
                  </a:xfrm>
                </p:grpSpPr>
                <p:sp>
                  <p:nvSpPr>
                    <p:cNvPr id="551" name="Rectangle 52"/>
                    <p:cNvSpPr/>
                    <p:nvPr/>
                  </p:nvSpPr>
                  <p:spPr>
                    <a:xfrm>
                      <a:off x="1569960" y="57866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2" name="Rectangle 53"/>
                    <p:cNvSpPr/>
                    <p:nvPr/>
                  </p:nvSpPr>
                  <p:spPr>
                    <a:xfrm>
                      <a:off x="1633320" y="57726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3" name="Rectangle 54"/>
                    <p:cNvSpPr/>
                    <p:nvPr/>
                  </p:nvSpPr>
                  <p:spPr>
                    <a:xfrm>
                      <a:off x="1856880" y="57866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4" name="Rectangle 55"/>
                    <p:cNvSpPr/>
                    <p:nvPr/>
                  </p:nvSpPr>
                  <p:spPr>
                    <a:xfrm>
                      <a:off x="1920600" y="57726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5" name="Rectangle 56"/>
                    <p:cNvSpPr/>
                    <p:nvPr/>
                  </p:nvSpPr>
                  <p:spPr>
                    <a:xfrm>
                      <a:off x="2149560" y="57866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6" name="Rectangle 57"/>
                    <p:cNvSpPr/>
                    <p:nvPr/>
                  </p:nvSpPr>
                  <p:spPr>
                    <a:xfrm>
                      <a:off x="2212200" y="57726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7" name="Rectangle 58"/>
                    <p:cNvSpPr/>
                    <p:nvPr/>
                  </p:nvSpPr>
                  <p:spPr>
                    <a:xfrm>
                      <a:off x="2440440" y="57866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8" name="Rectangle 59"/>
                    <p:cNvSpPr/>
                    <p:nvPr/>
                  </p:nvSpPr>
                  <p:spPr>
                    <a:xfrm>
                      <a:off x="2503800" y="57726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59" name="Rectangle 60"/>
                    <p:cNvSpPr/>
                    <p:nvPr/>
                  </p:nvSpPr>
                  <p:spPr>
                    <a:xfrm>
                      <a:off x="2728800" y="57866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0" name="Rectangle 61"/>
                    <p:cNvSpPr/>
                    <p:nvPr/>
                  </p:nvSpPr>
                  <p:spPr>
                    <a:xfrm>
                      <a:off x="2791080" y="57726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61" name="Rectangle 62"/>
                  <p:cNvSpPr/>
                  <p:nvPr/>
                </p:nvSpPr>
                <p:spPr>
                  <a:xfrm>
                    <a:off x="2119320" y="5833440"/>
                    <a:ext cx="1800" cy="3646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62" name="Group 63"/>
                <p:cNvGrpSpPr/>
                <p:nvPr/>
              </p:nvGrpSpPr>
              <p:grpSpPr>
                <a:xfrm>
                  <a:off x="1403280" y="4816440"/>
                  <a:ext cx="212760" cy="944640"/>
                  <a:chOff x="1403280" y="4816440"/>
                  <a:chExt cx="212760" cy="944640"/>
                </a:xfrm>
              </p:grpSpPr>
              <p:sp>
                <p:nvSpPr>
                  <p:cNvPr id="563" name="Line 64"/>
                  <p:cNvSpPr/>
                  <p:nvPr/>
                </p:nvSpPr>
                <p:spPr>
                  <a:xfrm flipV="1">
                    <a:off x="1616040" y="4816440"/>
                    <a:ext cx="0" cy="92376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564" name="Group 65"/>
                  <p:cNvGrpSpPr/>
                  <p:nvPr/>
                </p:nvGrpSpPr>
                <p:grpSpPr>
                  <a:xfrm>
                    <a:off x="1475640" y="4834080"/>
                    <a:ext cx="84960" cy="927000"/>
                    <a:chOff x="1475640" y="4834080"/>
                    <a:chExt cx="84960" cy="927000"/>
                  </a:xfrm>
                </p:grpSpPr>
                <p:sp>
                  <p:nvSpPr>
                    <p:cNvPr id="565" name="Rectangle 66"/>
                    <p:cNvSpPr/>
                    <p:nvPr/>
                  </p:nvSpPr>
                  <p:spPr>
                    <a:xfrm>
                      <a:off x="1538640" y="571500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6" name="Rectangle 67"/>
                    <p:cNvSpPr/>
                    <p:nvPr/>
                  </p:nvSpPr>
                  <p:spPr>
                    <a:xfrm>
                      <a:off x="1507680" y="55393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7" name="Rectangle 68"/>
                    <p:cNvSpPr/>
                    <p:nvPr/>
                  </p:nvSpPr>
                  <p:spPr>
                    <a:xfrm>
                      <a:off x="1507680" y="53640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8" name="Rectangle 69"/>
                    <p:cNvSpPr/>
                    <p:nvPr/>
                  </p:nvSpPr>
                  <p:spPr>
                    <a:xfrm>
                      <a:off x="1507680" y="5184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69" name="Rectangle 70"/>
                    <p:cNvSpPr/>
                    <p:nvPr/>
                  </p:nvSpPr>
                  <p:spPr>
                    <a:xfrm>
                      <a:off x="1507680" y="500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0" name="Rectangle 71"/>
                    <p:cNvSpPr/>
                    <p:nvPr/>
                  </p:nvSpPr>
                  <p:spPr>
                    <a:xfrm>
                      <a:off x="1475640" y="483408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571" name="Group 72"/>
                  <p:cNvGrpSpPr/>
                  <p:nvPr/>
                </p:nvGrpSpPr>
                <p:grpSpPr>
                  <a:xfrm>
                    <a:off x="1588680" y="4859280"/>
                    <a:ext cx="26280" cy="880560"/>
                    <a:chOff x="1588680" y="4859280"/>
                    <a:chExt cx="26280" cy="880560"/>
                  </a:xfrm>
                </p:grpSpPr>
                <p:sp>
                  <p:nvSpPr>
                    <p:cNvPr id="572" name="Line 73"/>
                    <p:cNvSpPr/>
                    <p:nvPr/>
                  </p:nvSpPr>
                  <p:spPr>
                    <a:xfrm flipH="1">
                      <a:off x="1588680" y="573984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3" name="Line 74"/>
                    <p:cNvSpPr/>
                    <p:nvPr/>
                  </p:nvSpPr>
                  <p:spPr>
                    <a:xfrm flipH="1">
                      <a:off x="1605960" y="56970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4" name="Line 75"/>
                    <p:cNvSpPr/>
                    <p:nvPr/>
                  </p:nvSpPr>
                  <p:spPr>
                    <a:xfrm flipH="1">
                      <a:off x="1605960" y="56541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5" name="Line 76"/>
                    <p:cNvSpPr/>
                    <p:nvPr/>
                  </p:nvSpPr>
                  <p:spPr>
                    <a:xfrm flipH="1">
                      <a:off x="1605960" y="56077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6" name="Line 77"/>
                    <p:cNvSpPr/>
                    <p:nvPr/>
                  </p:nvSpPr>
                  <p:spPr>
                    <a:xfrm flipH="1">
                      <a:off x="1588680" y="556452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7" name="Line 78"/>
                    <p:cNvSpPr/>
                    <p:nvPr/>
                  </p:nvSpPr>
                  <p:spPr>
                    <a:xfrm flipH="1">
                      <a:off x="1605960" y="55213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8" name="Line 79"/>
                    <p:cNvSpPr/>
                    <p:nvPr/>
                  </p:nvSpPr>
                  <p:spPr>
                    <a:xfrm flipH="1">
                      <a:off x="1605960" y="54752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79" name="Line 80"/>
                    <p:cNvSpPr/>
                    <p:nvPr/>
                  </p:nvSpPr>
                  <p:spPr>
                    <a:xfrm flipH="1">
                      <a:off x="1605960" y="54320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0" name="Line 81"/>
                    <p:cNvSpPr/>
                    <p:nvPr/>
                  </p:nvSpPr>
                  <p:spPr>
                    <a:xfrm flipH="1">
                      <a:off x="1588680" y="538920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1" name="Line 82"/>
                    <p:cNvSpPr/>
                    <p:nvPr/>
                  </p:nvSpPr>
                  <p:spPr>
                    <a:xfrm flipH="1">
                      <a:off x="1605960" y="53424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2" name="Line 83"/>
                    <p:cNvSpPr/>
                    <p:nvPr/>
                  </p:nvSpPr>
                  <p:spPr>
                    <a:xfrm flipH="1">
                      <a:off x="1605960" y="52999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3" name="Line 84"/>
                    <p:cNvSpPr/>
                    <p:nvPr/>
                  </p:nvSpPr>
                  <p:spPr>
                    <a:xfrm flipH="1">
                      <a:off x="1605960" y="52567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4" name="Line 85"/>
                    <p:cNvSpPr/>
                    <p:nvPr/>
                  </p:nvSpPr>
                  <p:spPr>
                    <a:xfrm flipH="1">
                      <a:off x="1588680" y="520992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5" name="Line 86"/>
                    <p:cNvSpPr/>
                    <p:nvPr/>
                  </p:nvSpPr>
                  <p:spPr>
                    <a:xfrm flipH="1">
                      <a:off x="1605960" y="51670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6" name="Line 87"/>
                    <p:cNvSpPr/>
                    <p:nvPr/>
                  </p:nvSpPr>
                  <p:spPr>
                    <a:xfrm flipH="1">
                      <a:off x="1605960" y="51238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7" name="Line 88"/>
                    <p:cNvSpPr/>
                    <p:nvPr/>
                  </p:nvSpPr>
                  <p:spPr>
                    <a:xfrm flipH="1">
                      <a:off x="1605960" y="50774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8" name="Line 89"/>
                    <p:cNvSpPr/>
                    <p:nvPr/>
                  </p:nvSpPr>
                  <p:spPr>
                    <a:xfrm flipH="1">
                      <a:off x="1588680" y="503460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89" name="Line 90"/>
                    <p:cNvSpPr/>
                    <p:nvPr/>
                  </p:nvSpPr>
                  <p:spPr>
                    <a:xfrm flipH="1">
                      <a:off x="1605960" y="49914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90" name="Line 91"/>
                    <p:cNvSpPr/>
                    <p:nvPr/>
                  </p:nvSpPr>
                  <p:spPr>
                    <a:xfrm flipH="1">
                      <a:off x="1605960" y="49449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91" name="Line 92"/>
                    <p:cNvSpPr/>
                    <p:nvPr/>
                  </p:nvSpPr>
                  <p:spPr>
                    <a:xfrm flipH="1">
                      <a:off x="1605960" y="49021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92" name="Line 93"/>
                    <p:cNvSpPr/>
                    <p:nvPr/>
                  </p:nvSpPr>
                  <p:spPr>
                    <a:xfrm flipH="1">
                      <a:off x="1588680" y="4859280"/>
                      <a:ext cx="2628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593" name="Rectangle 94"/>
                  <p:cNvSpPr/>
                  <p:nvPr/>
                </p:nvSpPr>
                <p:spPr>
                  <a:xfrm rot="16200000">
                    <a:off x="1221480" y="5545440"/>
                    <a:ext cx="365400" cy="18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 vert="eaVer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594" name="Group 95"/>
              <p:cNvGrpSpPr/>
              <p:nvPr/>
            </p:nvGrpSpPr>
            <p:grpSpPr>
              <a:xfrm>
                <a:off x="1627200" y="4867200"/>
                <a:ext cx="1147320" cy="871200"/>
                <a:chOff x="1627200" y="4867200"/>
                <a:chExt cx="1147320" cy="871200"/>
              </a:xfrm>
            </p:grpSpPr>
            <p:sp>
              <p:nvSpPr>
                <p:cNvPr id="595" name="Freeform 96"/>
                <p:cNvSpPr/>
                <p:nvPr/>
              </p:nvSpPr>
              <p:spPr>
                <a:xfrm>
                  <a:off x="1627200" y="4867200"/>
                  <a:ext cx="1147320" cy="867600"/>
                </a:xfrm>
                <a:custGeom>
                  <a:avLst/>
                  <a:gdLst>
                    <a:gd name="textAreaLeft" fmla="*/ 0 w 1147320"/>
                    <a:gd name="textAreaRight" fmla="*/ 1147680 w 1147320"/>
                    <a:gd name="textAreaTop" fmla="*/ 0 h 867600"/>
                    <a:gd name="textAreaBottom" fmla="*/ 867960 h 867600"/>
                  </a:gdLst>
                  <a:ahLst/>
                  <a:rect l="textAreaLeft" t="textAreaTop" r="textAreaRight" b="textAreaBottom"/>
                  <a:pathLst>
                    <a:path w="510" h="486">
                      <a:moveTo>
                        <a:pt x="0" y="486"/>
                      </a:moveTo>
                      <a:lnTo>
                        <a:pt x="0" y="380"/>
                      </a:lnTo>
                      <a:lnTo>
                        <a:pt x="0" y="398"/>
                      </a:lnTo>
                      <a:lnTo>
                        <a:pt x="2" y="412"/>
                      </a:lnTo>
                      <a:lnTo>
                        <a:pt x="4" y="412"/>
                      </a:lnTo>
                      <a:lnTo>
                        <a:pt x="6" y="402"/>
                      </a:lnTo>
                      <a:lnTo>
                        <a:pt x="8" y="388"/>
                      </a:lnTo>
                      <a:lnTo>
                        <a:pt x="10" y="368"/>
                      </a:lnTo>
                      <a:lnTo>
                        <a:pt x="12" y="340"/>
                      </a:lnTo>
                      <a:lnTo>
                        <a:pt x="14" y="304"/>
                      </a:lnTo>
                      <a:lnTo>
                        <a:pt x="16" y="264"/>
                      </a:lnTo>
                      <a:lnTo>
                        <a:pt x="18" y="228"/>
                      </a:lnTo>
                      <a:lnTo>
                        <a:pt x="20" y="182"/>
                      </a:lnTo>
                      <a:lnTo>
                        <a:pt x="22" y="110"/>
                      </a:lnTo>
                      <a:lnTo>
                        <a:pt x="24" y="70"/>
                      </a:lnTo>
                      <a:lnTo>
                        <a:pt x="26" y="78"/>
                      </a:lnTo>
                      <a:lnTo>
                        <a:pt x="28" y="52"/>
                      </a:lnTo>
                      <a:lnTo>
                        <a:pt x="30" y="18"/>
                      </a:lnTo>
                      <a:lnTo>
                        <a:pt x="32" y="6"/>
                      </a:lnTo>
                      <a:lnTo>
                        <a:pt x="34" y="0"/>
                      </a:lnTo>
                      <a:lnTo>
                        <a:pt x="36" y="0"/>
                      </a:lnTo>
                      <a:lnTo>
                        <a:pt x="38" y="0"/>
                      </a:lnTo>
                      <a:lnTo>
                        <a:pt x="40" y="18"/>
                      </a:lnTo>
                      <a:lnTo>
                        <a:pt x="42" y="54"/>
                      </a:lnTo>
                      <a:lnTo>
                        <a:pt x="44" y="48"/>
                      </a:lnTo>
                      <a:lnTo>
                        <a:pt x="46" y="24"/>
                      </a:lnTo>
                      <a:lnTo>
                        <a:pt x="48" y="96"/>
                      </a:lnTo>
                      <a:lnTo>
                        <a:pt x="50" y="128"/>
                      </a:lnTo>
                      <a:lnTo>
                        <a:pt x="52" y="96"/>
                      </a:lnTo>
                      <a:lnTo>
                        <a:pt x="54" y="128"/>
                      </a:lnTo>
                      <a:lnTo>
                        <a:pt x="56" y="166"/>
                      </a:lnTo>
                      <a:lnTo>
                        <a:pt x="58" y="174"/>
                      </a:lnTo>
                      <a:lnTo>
                        <a:pt x="60" y="184"/>
                      </a:lnTo>
                      <a:lnTo>
                        <a:pt x="62" y="194"/>
                      </a:lnTo>
                      <a:lnTo>
                        <a:pt x="64" y="210"/>
                      </a:lnTo>
                      <a:lnTo>
                        <a:pt x="66" y="236"/>
                      </a:lnTo>
                      <a:lnTo>
                        <a:pt x="68" y="256"/>
                      </a:lnTo>
                      <a:lnTo>
                        <a:pt x="70" y="264"/>
                      </a:lnTo>
                      <a:lnTo>
                        <a:pt x="72" y="270"/>
                      </a:lnTo>
                      <a:lnTo>
                        <a:pt x="74" y="278"/>
                      </a:lnTo>
                      <a:lnTo>
                        <a:pt x="76" y="292"/>
                      </a:lnTo>
                      <a:lnTo>
                        <a:pt x="78" y="304"/>
                      </a:lnTo>
                      <a:lnTo>
                        <a:pt x="80" y="310"/>
                      </a:lnTo>
                      <a:lnTo>
                        <a:pt x="82" y="316"/>
                      </a:lnTo>
                      <a:lnTo>
                        <a:pt x="84" y="320"/>
                      </a:lnTo>
                      <a:lnTo>
                        <a:pt x="86" y="326"/>
                      </a:lnTo>
                      <a:lnTo>
                        <a:pt x="88" y="336"/>
                      </a:lnTo>
                      <a:lnTo>
                        <a:pt x="90" y="340"/>
                      </a:lnTo>
                      <a:lnTo>
                        <a:pt x="92" y="342"/>
                      </a:lnTo>
                      <a:lnTo>
                        <a:pt x="94" y="350"/>
                      </a:lnTo>
                      <a:lnTo>
                        <a:pt x="96" y="360"/>
                      </a:lnTo>
                      <a:lnTo>
                        <a:pt x="98" y="366"/>
                      </a:lnTo>
                      <a:lnTo>
                        <a:pt x="100" y="368"/>
                      </a:lnTo>
                      <a:lnTo>
                        <a:pt x="102" y="366"/>
                      </a:lnTo>
                      <a:lnTo>
                        <a:pt x="104" y="366"/>
                      </a:lnTo>
                      <a:lnTo>
                        <a:pt x="106" y="372"/>
                      </a:lnTo>
                      <a:lnTo>
                        <a:pt x="108" y="386"/>
                      </a:lnTo>
                      <a:lnTo>
                        <a:pt x="110" y="398"/>
                      </a:lnTo>
                      <a:lnTo>
                        <a:pt x="112" y="404"/>
                      </a:lnTo>
                      <a:lnTo>
                        <a:pt x="114" y="404"/>
                      </a:lnTo>
                      <a:lnTo>
                        <a:pt x="116" y="404"/>
                      </a:lnTo>
                      <a:lnTo>
                        <a:pt x="118" y="410"/>
                      </a:lnTo>
                      <a:lnTo>
                        <a:pt x="120" y="416"/>
                      </a:lnTo>
                      <a:lnTo>
                        <a:pt x="122" y="420"/>
                      </a:lnTo>
                      <a:lnTo>
                        <a:pt x="124" y="422"/>
                      </a:lnTo>
                      <a:lnTo>
                        <a:pt x="126" y="426"/>
                      </a:lnTo>
                      <a:lnTo>
                        <a:pt x="128" y="430"/>
                      </a:lnTo>
                      <a:lnTo>
                        <a:pt x="130" y="434"/>
                      </a:lnTo>
                      <a:lnTo>
                        <a:pt x="132" y="436"/>
                      </a:lnTo>
                      <a:lnTo>
                        <a:pt x="134" y="442"/>
                      </a:lnTo>
                      <a:lnTo>
                        <a:pt x="136" y="448"/>
                      </a:lnTo>
                      <a:lnTo>
                        <a:pt x="138" y="450"/>
                      </a:lnTo>
                      <a:lnTo>
                        <a:pt x="140" y="452"/>
                      </a:lnTo>
                      <a:lnTo>
                        <a:pt x="142" y="454"/>
                      </a:lnTo>
                      <a:lnTo>
                        <a:pt x="144" y="456"/>
                      </a:lnTo>
                      <a:lnTo>
                        <a:pt x="146" y="460"/>
                      </a:lnTo>
                      <a:lnTo>
                        <a:pt x="148" y="464"/>
                      </a:lnTo>
                      <a:lnTo>
                        <a:pt x="150" y="466"/>
                      </a:lnTo>
                      <a:lnTo>
                        <a:pt x="152" y="470"/>
                      </a:lnTo>
                      <a:lnTo>
                        <a:pt x="154" y="472"/>
                      </a:lnTo>
                      <a:lnTo>
                        <a:pt x="156" y="474"/>
                      </a:lnTo>
                      <a:lnTo>
                        <a:pt x="158" y="476"/>
                      </a:lnTo>
                      <a:lnTo>
                        <a:pt x="160" y="478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4"/>
                      </a:lnTo>
                      <a:lnTo>
                        <a:pt x="220" y="484"/>
                      </a:lnTo>
                      <a:lnTo>
                        <a:pt x="222" y="484"/>
                      </a:lnTo>
                      <a:lnTo>
                        <a:pt x="224" y="484"/>
                      </a:lnTo>
                      <a:lnTo>
                        <a:pt x="226" y="484"/>
                      </a:lnTo>
                      <a:lnTo>
                        <a:pt x="228" y="484"/>
                      </a:lnTo>
                      <a:lnTo>
                        <a:pt x="230" y="484"/>
                      </a:lnTo>
                      <a:lnTo>
                        <a:pt x="232" y="484"/>
                      </a:lnTo>
                      <a:lnTo>
                        <a:pt x="234" y="484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6"/>
                      </a:lnTo>
                      <a:lnTo>
                        <a:pt x="266" y="486"/>
                      </a:lnTo>
                      <a:lnTo>
                        <a:pt x="268" y="486"/>
                      </a:lnTo>
                      <a:lnTo>
                        <a:pt x="270" y="486"/>
                      </a:lnTo>
                      <a:lnTo>
                        <a:pt x="272" y="486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4"/>
                      </a:lnTo>
                      <a:lnTo>
                        <a:pt x="298" y="484"/>
                      </a:lnTo>
                      <a:lnTo>
                        <a:pt x="300" y="484"/>
                      </a:lnTo>
                      <a:lnTo>
                        <a:pt x="302" y="484"/>
                      </a:lnTo>
                      <a:lnTo>
                        <a:pt x="304" y="484"/>
                      </a:lnTo>
                      <a:lnTo>
                        <a:pt x="306" y="484"/>
                      </a:lnTo>
                      <a:lnTo>
                        <a:pt x="308" y="484"/>
                      </a:lnTo>
                      <a:lnTo>
                        <a:pt x="310" y="484"/>
                      </a:lnTo>
                      <a:lnTo>
                        <a:pt x="312" y="484"/>
                      </a:lnTo>
                      <a:lnTo>
                        <a:pt x="314" y="484"/>
                      </a:lnTo>
                      <a:lnTo>
                        <a:pt x="316" y="484"/>
                      </a:lnTo>
                      <a:lnTo>
                        <a:pt x="318" y="484"/>
                      </a:lnTo>
                      <a:lnTo>
                        <a:pt x="320" y="484"/>
                      </a:lnTo>
                      <a:lnTo>
                        <a:pt x="322" y="484"/>
                      </a:lnTo>
                      <a:lnTo>
                        <a:pt x="324" y="484"/>
                      </a:lnTo>
                      <a:lnTo>
                        <a:pt x="326" y="484"/>
                      </a:lnTo>
                      <a:lnTo>
                        <a:pt x="328" y="484"/>
                      </a:lnTo>
                      <a:lnTo>
                        <a:pt x="330" y="484"/>
                      </a:lnTo>
                      <a:lnTo>
                        <a:pt x="332" y="484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  <a:lnTo>
                        <a:pt x="510" y="486"/>
                      </a:lnTo>
                      <a:lnTo>
                        <a:pt x="0" y="486"/>
                      </a:lnTo>
                      <a:close/>
                    </a:path>
                  </a:pathLst>
                </a:custGeom>
                <a:solidFill>
                  <a:srgbClr val="e8e8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Freeform 97"/>
                <p:cNvSpPr/>
                <p:nvPr/>
              </p:nvSpPr>
              <p:spPr>
                <a:xfrm>
                  <a:off x="1631520" y="4870800"/>
                  <a:ext cx="1142640" cy="867600"/>
                </a:xfrm>
                <a:custGeom>
                  <a:avLst/>
                  <a:gdLst>
                    <a:gd name="textAreaLeft" fmla="*/ 0 w 1142640"/>
                    <a:gd name="textAreaRight" fmla="*/ 1143000 w 1142640"/>
                    <a:gd name="textAreaTop" fmla="*/ 0 h 867600"/>
                    <a:gd name="textAreaBottom" fmla="*/ 867960 h 867600"/>
                  </a:gdLst>
                  <a:ahLst/>
                  <a:rect l="textAreaLeft" t="textAreaTop" r="textAreaRight" b="textAreaBottom"/>
                  <a:pathLst>
                    <a:path w="508" h="486">
                      <a:moveTo>
                        <a:pt x="0" y="486"/>
                      </a:moveTo>
                      <a:lnTo>
                        <a:pt x="0" y="380"/>
                      </a:lnTo>
                      <a:lnTo>
                        <a:pt x="0" y="398"/>
                      </a:lnTo>
                      <a:lnTo>
                        <a:pt x="2" y="412"/>
                      </a:lnTo>
                      <a:lnTo>
                        <a:pt x="4" y="412"/>
                      </a:lnTo>
                      <a:lnTo>
                        <a:pt x="6" y="402"/>
                      </a:lnTo>
                      <a:lnTo>
                        <a:pt x="8" y="388"/>
                      </a:lnTo>
                      <a:lnTo>
                        <a:pt x="10" y="368"/>
                      </a:lnTo>
                      <a:lnTo>
                        <a:pt x="12" y="340"/>
                      </a:lnTo>
                      <a:lnTo>
                        <a:pt x="14" y="304"/>
                      </a:lnTo>
                      <a:lnTo>
                        <a:pt x="16" y="264"/>
                      </a:lnTo>
                      <a:lnTo>
                        <a:pt x="18" y="228"/>
                      </a:lnTo>
                      <a:lnTo>
                        <a:pt x="20" y="182"/>
                      </a:lnTo>
                      <a:lnTo>
                        <a:pt x="22" y="110"/>
                      </a:lnTo>
                      <a:lnTo>
                        <a:pt x="24" y="70"/>
                      </a:lnTo>
                      <a:lnTo>
                        <a:pt x="26" y="78"/>
                      </a:lnTo>
                      <a:lnTo>
                        <a:pt x="28" y="52"/>
                      </a:lnTo>
                      <a:lnTo>
                        <a:pt x="30" y="18"/>
                      </a:lnTo>
                      <a:lnTo>
                        <a:pt x="32" y="6"/>
                      </a:lnTo>
                      <a:lnTo>
                        <a:pt x="34" y="0"/>
                      </a:lnTo>
                      <a:lnTo>
                        <a:pt x="36" y="0"/>
                      </a:lnTo>
                      <a:lnTo>
                        <a:pt x="38" y="0"/>
                      </a:lnTo>
                      <a:lnTo>
                        <a:pt x="40" y="18"/>
                      </a:lnTo>
                      <a:lnTo>
                        <a:pt x="42" y="54"/>
                      </a:lnTo>
                      <a:lnTo>
                        <a:pt x="44" y="48"/>
                      </a:lnTo>
                      <a:lnTo>
                        <a:pt x="46" y="24"/>
                      </a:lnTo>
                      <a:lnTo>
                        <a:pt x="48" y="96"/>
                      </a:lnTo>
                      <a:lnTo>
                        <a:pt x="50" y="128"/>
                      </a:lnTo>
                      <a:lnTo>
                        <a:pt x="52" y="96"/>
                      </a:lnTo>
                      <a:lnTo>
                        <a:pt x="54" y="128"/>
                      </a:lnTo>
                      <a:lnTo>
                        <a:pt x="56" y="166"/>
                      </a:lnTo>
                      <a:lnTo>
                        <a:pt x="58" y="174"/>
                      </a:lnTo>
                      <a:lnTo>
                        <a:pt x="60" y="184"/>
                      </a:lnTo>
                      <a:lnTo>
                        <a:pt x="62" y="194"/>
                      </a:lnTo>
                      <a:lnTo>
                        <a:pt x="64" y="210"/>
                      </a:lnTo>
                      <a:lnTo>
                        <a:pt x="66" y="236"/>
                      </a:lnTo>
                      <a:lnTo>
                        <a:pt x="68" y="256"/>
                      </a:lnTo>
                      <a:lnTo>
                        <a:pt x="70" y="264"/>
                      </a:lnTo>
                      <a:lnTo>
                        <a:pt x="72" y="270"/>
                      </a:lnTo>
                      <a:lnTo>
                        <a:pt x="74" y="278"/>
                      </a:lnTo>
                      <a:lnTo>
                        <a:pt x="76" y="292"/>
                      </a:lnTo>
                      <a:lnTo>
                        <a:pt x="78" y="304"/>
                      </a:lnTo>
                      <a:lnTo>
                        <a:pt x="80" y="310"/>
                      </a:lnTo>
                      <a:lnTo>
                        <a:pt x="82" y="316"/>
                      </a:lnTo>
                      <a:lnTo>
                        <a:pt x="84" y="320"/>
                      </a:lnTo>
                      <a:lnTo>
                        <a:pt x="86" y="326"/>
                      </a:lnTo>
                      <a:lnTo>
                        <a:pt x="88" y="336"/>
                      </a:lnTo>
                      <a:lnTo>
                        <a:pt x="90" y="340"/>
                      </a:lnTo>
                      <a:lnTo>
                        <a:pt x="92" y="342"/>
                      </a:lnTo>
                      <a:lnTo>
                        <a:pt x="94" y="350"/>
                      </a:lnTo>
                      <a:lnTo>
                        <a:pt x="96" y="360"/>
                      </a:lnTo>
                      <a:lnTo>
                        <a:pt x="98" y="366"/>
                      </a:lnTo>
                      <a:lnTo>
                        <a:pt x="100" y="368"/>
                      </a:lnTo>
                      <a:lnTo>
                        <a:pt x="102" y="366"/>
                      </a:lnTo>
                      <a:lnTo>
                        <a:pt x="104" y="366"/>
                      </a:lnTo>
                      <a:lnTo>
                        <a:pt x="106" y="372"/>
                      </a:lnTo>
                      <a:lnTo>
                        <a:pt x="108" y="386"/>
                      </a:lnTo>
                      <a:lnTo>
                        <a:pt x="110" y="398"/>
                      </a:lnTo>
                      <a:lnTo>
                        <a:pt x="112" y="404"/>
                      </a:lnTo>
                      <a:lnTo>
                        <a:pt x="114" y="404"/>
                      </a:lnTo>
                      <a:lnTo>
                        <a:pt x="116" y="404"/>
                      </a:lnTo>
                      <a:lnTo>
                        <a:pt x="118" y="410"/>
                      </a:lnTo>
                      <a:lnTo>
                        <a:pt x="120" y="416"/>
                      </a:lnTo>
                      <a:lnTo>
                        <a:pt x="122" y="420"/>
                      </a:lnTo>
                      <a:lnTo>
                        <a:pt x="124" y="422"/>
                      </a:lnTo>
                      <a:lnTo>
                        <a:pt x="126" y="426"/>
                      </a:lnTo>
                      <a:lnTo>
                        <a:pt x="128" y="430"/>
                      </a:lnTo>
                      <a:lnTo>
                        <a:pt x="130" y="434"/>
                      </a:lnTo>
                      <a:lnTo>
                        <a:pt x="132" y="436"/>
                      </a:lnTo>
                      <a:lnTo>
                        <a:pt x="134" y="442"/>
                      </a:lnTo>
                      <a:lnTo>
                        <a:pt x="136" y="448"/>
                      </a:lnTo>
                      <a:lnTo>
                        <a:pt x="138" y="450"/>
                      </a:lnTo>
                      <a:lnTo>
                        <a:pt x="140" y="452"/>
                      </a:lnTo>
                      <a:lnTo>
                        <a:pt x="142" y="454"/>
                      </a:lnTo>
                      <a:lnTo>
                        <a:pt x="144" y="456"/>
                      </a:lnTo>
                      <a:lnTo>
                        <a:pt x="146" y="460"/>
                      </a:lnTo>
                      <a:lnTo>
                        <a:pt x="148" y="464"/>
                      </a:lnTo>
                      <a:lnTo>
                        <a:pt x="150" y="466"/>
                      </a:lnTo>
                      <a:lnTo>
                        <a:pt x="152" y="470"/>
                      </a:lnTo>
                      <a:lnTo>
                        <a:pt x="154" y="472"/>
                      </a:lnTo>
                      <a:lnTo>
                        <a:pt x="156" y="474"/>
                      </a:lnTo>
                      <a:lnTo>
                        <a:pt x="158" y="476"/>
                      </a:lnTo>
                      <a:lnTo>
                        <a:pt x="160" y="478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4"/>
                      </a:lnTo>
                      <a:lnTo>
                        <a:pt x="220" y="484"/>
                      </a:lnTo>
                      <a:lnTo>
                        <a:pt x="222" y="484"/>
                      </a:lnTo>
                      <a:lnTo>
                        <a:pt x="224" y="484"/>
                      </a:lnTo>
                      <a:lnTo>
                        <a:pt x="226" y="484"/>
                      </a:lnTo>
                      <a:lnTo>
                        <a:pt x="228" y="484"/>
                      </a:lnTo>
                      <a:lnTo>
                        <a:pt x="230" y="484"/>
                      </a:lnTo>
                      <a:lnTo>
                        <a:pt x="232" y="484"/>
                      </a:lnTo>
                      <a:lnTo>
                        <a:pt x="234" y="484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6"/>
                      </a:lnTo>
                      <a:lnTo>
                        <a:pt x="266" y="486"/>
                      </a:lnTo>
                      <a:lnTo>
                        <a:pt x="268" y="486"/>
                      </a:lnTo>
                      <a:lnTo>
                        <a:pt x="270" y="486"/>
                      </a:lnTo>
                      <a:lnTo>
                        <a:pt x="272" y="486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4"/>
                      </a:lnTo>
                      <a:lnTo>
                        <a:pt x="298" y="484"/>
                      </a:lnTo>
                      <a:lnTo>
                        <a:pt x="300" y="484"/>
                      </a:lnTo>
                      <a:lnTo>
                        <a:pt x="302" y="484"/>
                      </a:lnTo>
                      <a:lnTo>
                        <a:pt x="304" y="484"/>
                      </a:lnTo>
                      <a:lnTo>
                        <a:pt x="306" y="484"/>
                      </a:lnTo>
                      <a:lnTo>
                        <a:pt x="308" y="484"/>
                      </a:lnTo>
                      <a:lnTo>
                        <a:pt x="310" y="484"/>
                      </a:lnTo>
                      <a:lnTo>
                        <a:pt x="312" y="484"/>
                      </a:lnTo>
                      <a:lnTo>
                        <a:pt x="314" y="484"/>
                      </a:lnTo>
                      <a:lnTo>
                        <a:pt x="316" y="484"/>
                      </a:lnTo>
                      <a:lnTo>
                        <a:pt x="318" y="484"/>
                      </a:lnTo>
                      <a:lnTo>
                        <a:pt x="320" y="484"/>
                      </a:lnTo>
                      <a:lnTo>
                        <a:pt x="322" y="484"/>
                      </a:lnTo>
                      <a:lnTo>
                        <a:pt x="324" y="484"/>
                      </a:lnTo>
                      <a:lnTo>
                        <a:pt x="326" y="484"/>
                      </a:lnTo>
                      <a:lnTo>
                        <a:pt x="328" y="484"/>
                      </a:lnTo>
                      <a:lnTo>
                        <a:pt x="330" y="484"/>
                      </a:lnTo>
                      <a:lnTo>
                        <a:pt x="332" y="484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</a:path>
                  </a:pathLst>
                </a:custGeom>
                <a:noFill/>
                <a:ln w="6480">
                  <a:solidFill>
                    <a:srgbClr val="b3b3b3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97" name="Freeform 98"/>
              <p:cNvSpPr/>
              <p:nvPr/>
            </p:nvSpPr>
            <p:spPr>
              <a:xfrm>
                <a:off x="1631880" y="4870440"/>
                <a:ext cx="1143000" cy="868320"/>
              </a:xfrm>
              <a:custGeom>
                <a:avLst/>
                <a:gdLst>
                  <a:gd name="textAreaLeft" fmla="*/ 0 w 1143000"/>
                  <a:gd name="textAreaRight" fmla="*/ 1143360 w 1143000"/>
                  <a:gd name="textAreaTop" fmla="*/ 0 h 868320"/>
                  <a:gd name="textAreaBottom" fmla="*/ 868680 h 86832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0" y="470"/>
                    </a:lnTo>
                    <a:lnTo>
                      <a:pt x="2" y="468"/>
                    </a:lnTo>
                    <a:lnTo>
                      <a:pt x="4" y="466"/>
                    </a:lnTo>
                    <a:lnTo>
                      <a:pt x="6" y="462"/>
                    </a:lnTo>
                    <a:lnTo>
                      <a:pt x="8" y="460"/>
                    </a:lnTo>
                    <a:lnTo>
                      <a:pt x="10" y="456"/>
                    </a:lnTo>
                    <a:lnTo>
                      <a:pt x="12" y="452"/>
                    </a:lnTo>
                    <a:lnTo>
                      <a:pt x="14" y="446"/>
                    </a:lnTo>
                    <a:lnTo>
                      <a:pt x="16" y="436"/>
                    </a:lnTo>
                    <a:lnTo>
                      <a:pt x="18" y="424"/>
                    </a:lnTo>
                    <a:lnTo>
                      <a:pt x="20" y="406"/>
                    </a:lnTo>
                    <a:lnTo>
                      <a:pt x="22" y="384"/>
                    </a:lnTo>
                    <a:lnTo>
                      <a:pt x="24" y="354"/>
                    </a:lnTo>
                    <a:lnTo>
                      <a:pt x="26" y="318"/>
                    </a:lnTo>
                    <a:lnTo>
                      <a:pt x="28" y="288"/>
                    </a:lnTo>
                    <a:lnTo>
                      <a:pt x="30" y="270"/>
                    </a:lnTo>
                    <a:lnTo>
                      <a:pt x="32" y="244"/>
                    </a:lnTo>
                    <a:lnTo>
                      <a:pt x="34" y="206"/>
                    </a:lnTo>
                    <a:lnTo>
                      <a:pt x="36" y="154"/>
                    </a:lnTo>
                    <a:lnTo>
                      <a:pt x="38" y="80"/>
                    </a:lnTo>
                    <a:lnTo>
                      <a:pt x="40" y="52"/>
                    </a:lnTo>
                    <a:lnTo>
                      <a:pt x="42" y="98"/>
                    </a:lnTo>
                    <a:lnTo>
                      <a:pt x="44" y="70"/>
                    </a:lnTo>
                    <a:lnTo>
                      <a:pt x="46" y="0"/>
                    </a:lnTo>
                    <a:lnTo>
                      <a:pt x="48" y="26"/>
                    </a:lnTo>
                    <a:lnTo>
                      <a:pt x="50" y="46"/>
                    </a:lnTo>
                    <a:lnTo>
                      <a:pt x="52" y="44"/>
                    </a:lnTo>
                    <a:lnTo>
                      <a:pt x="54" y="66"/>
                    </a:lnTo>
                    <a:lnTo>
                      <a:pt x="56" y="64"/>
                    </a:lnTo>
                    <a:lnTo>
                      <a:pt x="58" y="24"/>
                    </a:lnTo>
                    <a:lnTo>
                      <a:pt x="60" y="36"/>
                    </a:lnTo>
                    <a:lnTo>
                      <a:pt x="62" y="60"/>
                    </a:lnTo>
                    <a:lnTo>
                      <a:pt x="64" y="72"/>
                    </a:lnTo>
                    <a:lnTo>
                      <a:pt x="66" y="96"/>
                    </a:lnTo>
                    <a:lnTo>
                      <a:pt x="68" y="128"/>
                    </a:lnTo>
                    <a:lnTo>
                      <a:pt x="70" y="154"/>
                    </a:lnTo>
                    <a:lnTo>
                      <a:pt x="72" y="166"/>
                    </a:lnTo>
                    <a:lnTo>
                      <a:pt x="74" y="164"/>
                    </a:lnTo>
                    <a:lnTo>
                      <a:pt x="76" y="164"/>
                    </a:lnTo>
                    <a:lnTo>
                      <a:pt x="78" y="180"/>
                    </a:lnTo>
                    <a:lnTo>
                      <a:pt x="80" y="214"/>
                    </a:lnTo>
                    <a:lnTo>
                      <a:pt x="82" y="226"/>
                    </a:lnTo>
                    <a:lnTo>
                      <a:pt x="84" y="220"/>
                    </a:lnTo>
                    <a:lnTo>
                      <a:pt x="86" y="224"/>
                    </a:lnTo>
                    <a:lnTo>
                      <a:pt x="88" y="250"/>
                    </a:lnTo>
                    <a:lnTo>
                      <a:pt x="90" y="264"/>
                    </a:lnTo>
                    <a:lnTo>
                      <a:pt x="92" y="258"/>
                    </a:lnTo>
                    <a:lnTo>
                      <a:pt x="94" y="266"/>
                    </a:lnTo>
                    <a:lnTo>
                      <a:pt x="96" y="284"/>
                    </a:lnTo>
                    <a:lnTo>
                      <a:pt x="98" y="296"/>
                    </a:lnTo>
                    <a:lnTo>
                      <a:pt x="100" y="308"/>
                    </a:lnTo>
                    <a:lnTo>
                      <a:pt x="102" y="328"/>
                    </a:lnTo>
                    <a:lnTo>
                      <a:pt x="104" y="336"/>
                    </a:lnTo>
                    <a:lnTo>
                      <a:pt x="106" y="330"/>
                    </a:lnTo>
                    <a:lnTo>
                      <a:pt x="108" y="330"/>
                    </a:lnTo>
                    <a:lnTo>
                      <a:pt x="110" y="336"/>
                    </a:lnTo>
                    <a:lnTo>
                      <a:pt x="112" y="338"/>
                    </a:lnTo>
                    <a:lnTo>
                      <a:pt x="114" y="346"/>
                    </a:lnTo>
                    <a:lnTo>
                      <a:pt x="116" y="356"/>
                    </a:lnTo>
                    <a:lnTo>
                      <a:pt x="118" y="366"/>
                    </a:lnTo>
                    <a:lnTo>
                      <a:pt x="120" y="374"/>
                    </a:lnTo>
                    <a:lnTo>
                      <a:pt x="122" y="382"/>
                    </a:lnTo>
                    <a:lnTo>
                      <a:pt x="124" y="390"/>
                    </a:lnTo>
                    <a:lnTo>
                      <a:pt x="126" y="396"/>
                    </a:lnTo>
                    <a:lnTo>
                      <a:pt x="128" y="404"/>
                    </a:lnTo>
                    <a:lnTo>
                      <a:pt x="130" y="408"/>
                    </a:lnTo>
                    <a:lnTo>
                      <a:pt x="132" y="408"/>
                    </a:lnTo>
                    <a:lnTo>
                      <a:pt x="134" y="408"/>
                    </a:lnTo>
                    <a:lnTo>
                      <a:pt x="136" y="410"/>
                    </a:lnTo>
                    <a:lnTo>
                      <a:pt x="138" y="418"/>
                    </a:lnTo>
                    <a:lnTo>
                      <a:pt x="140" y="424"/>
                    </a:lnTo>
                    <a:lnTo>
                      <a:pt x="142" y="426"/>
                    </a:lnTo>
                    <a:lnTo>
                      <a:pt x="144" y="428"/>
                    </a:lnTo>
                    <a:lnTo>
                      <a:pt x="146" y="430"/>
                    </a:lnTo>
                    <a:lnTo>
                      <a:pt x="148" y="432"/>
                    </a:lnTo>
                    <a:lnTo>
                      <a:pt x="150" y="432"/>
                    </a:lnTo>
                    <a:lnTo>
                      <a:pt x="152" y="432"/>
                    </a:lnTo>
                    <a:lnTo>
                      <a:pt x="154" y="434"/>
                    </a:lnTo>
                    <a:lnTo>
                      <a:pt x="156" y="432"/>
                    </a:lnTo>
                    <a:lnTo>
                      <a:pt x="158" y="428"/>
                    </a:lnTo>
                    <a:lnTo>
                      <a:pt x="160" y="428"/>
                    </a:lnTo>
                    <a:lnTo>
                      <a:pt x="162" y="434"/>
                    </a:lnTo>
                    <a:lnTo>
                      <a:pt x="164" y="440"/>
                    </a:lnTo>
                    <a:lnTo>
                      <a:pt x="166" y="442"/>
                    </a:lnTo>
                    <a:lnTo>
                      <a:pt x="168" y="440"/>
                    </a:lnTo>
                    <a:lnTo>
                      <a:pt x="170" y="440"/>
                    </a:lnTo>
                    <a:lnTo>
                      <a:pt x="172" y="438"/>
                    </a:lnTo>
                    <a:lnTo>
                      <a:pt x="174" y="438"/>
                    </a:lnTo>
                    <a:lnTo>
                      <a:pt x="176" y="440"/>
                    </a:lnTo>
                    <a:lnTo>
                      <a:pt x="178" y="442"/>
                    </a:lnTo>
                    <a:lnTo>
                      <a:pt x="180" y="444"/>
                    </a:lnTo>
                    <a:lnTo>
                      <a:pt x="182" y="446"/>
                    </a:lnTo>
                    <a:lnTo>
                      <a:pt x="184" y="450"/>
                    </a:lnTo>
                    <a:lnTo>
                      <a:pt x="186" y="454"/>
                    </a:lnTo>
                    <a:lnTo>
                      <a:pt x="188" y="458"/>
                    </a:lnTo>
                    <a:lnTo>
                      <a:pt x="190" y="462"/>
                    </a:lnTo>
                    <a:lnTo>
                      <a:pt x="192" y="464"/>
                    </a:lnTo>
                    <a:lnTo>
                      <a:pt x="194" y="468"/>
                    </a:lnTo>
                    <a:lnTo>
                      <a:pt x="196" y="468"/>
                    </a:lnTo>
                    <a:lnTo>
                      <a:pt x="198" y="470"/>
                    </a:lnTo>
                    <a:lnTo>
                      <a:pt x="200" y="472"/>
                    </a:lnTo>
                    <a:lnTo>
                      <a:pt x="202" y="474"/>
                    </a:lnTo>
                    <a:lnTo>
                      <a:pt x="204" y="476"/>
                    </a:lnTo>
                    <a:lnTo>
                      <a:pt x="206" y="478"/>
                    </a:lnTo>
                    <a:lnTo>
                      <a:pt x="208" y="478"/>
                    </a:lnTo>
                    <a:lnTo>
                      <a:pt x="210" y="480"/>
                    </a:lnTo>
                    <a:lnTo>
                      <a:pt x="212" y="480"/>
                    </a:lnTo>
                    <a:lnTo>
                      <a:pt x="214" y="482"/>
                    </a:lnTo>
                    <a:lnTo>
                      <a:pt x="216" y="482"/>
                    </a:lnTo>
                    <a:lnTo>
                      <a:pt x="218" y="482"/>
                    </a:lnTo>
                    <a:lnTo>
                      <a:pt x="220" y="484"/>
                    </a:lnTo>
                    <a:lnTo>
                      <a:pt x="222" y="484"/>
                    </a:lnTo>
                    <a:lnTo>
                      <a:pt x="224" y="484"/>
                    </a:lnTo>
                    <a:lnTo>
                      <a:pt x="226" y="484"/>
                    </a:lnTo>
                    <a:lnTo>
                      <a:pt x="228" y="484"/>
                    </a:lnTo>
                    <a:lnTo>
                      <a:pt x="230" y="484"/>
                    </a:lnTo>
                    <a:lnTo>
                      <a:pt x="232" y="484"/>
                    </a:lnTo>
                    <a:lnTo>
                      <a:pt x="234" y="484"/>
                    </a:lnTo>
                    <a:lnTo>
                      <a:pt x="236" y="484"/>
                    </a:lnTo>
                    <a:lnTo>
                      <a:pt x="238" y="484"/>
                    </a:lnTo>
                    <a:lnTo>
                      <a:pt x="240" y="484"/>
                    </a:lnTo>
                    <a:lnTo>
                      <a:pt x="242" y="484"/>
                    </a:lnTo>
                    <a:lnTo>
                      <a:pt x="244" y="484"/>
                    </a:lnTo>
                    <a:lnTo>
                      <a:pt x="246" y="484"/>
                    </a:lnTo>
                    <a:lnTo>
                      <a:pt x="248" y="484"/>
                    </a:lnTo>
                    <a:lnTo>
                      <a:pt x="250" y="484"/>
                    </a:lnTo>
                    <a:lnTo>
                      <a:pt x="252" y="484"/>
                    </a:lnTo>
                    <a:lnTo>
                      <a:pt x="254" y="484"/>
                    </a:lnTo>
                    <a:lnTo>
                      <a:pt x="256" y="484"/>
                    </a:lnTo>
                    <a:lnTo>
                      <a:pt x="258" y="484"/>
                    </a:lnTo>
                    <a:lnTo>
                      <a:pt x="260" y="484"/>
                    </a:lnTo>
                    <a:lnTo>
                      <a:pt x="262" y="484"/>
                    </a:lnTo>
                    <a:lnTo>
                      <a:pt x="264" y="484"/>
                    </a:lnTo>
                    <a:lnTo>
                      <a:pt x="266" y="484"/>
                    </a:lnTo>
                    <a:lnTo>
                      <a:pt x="268" y="484"/>
                    </a:lnTo>
                    <a:lnTo>
                      <a:pt x="270" y="484"/>
                    </a:lnTo>
                    <a:lnTo>
                      <a:pt x="272" y="484"/>
                    </a:lnTo>
                    <a:lnTo>
                      <a:pt x="274" y="484"/>
                    </a:lnTo>
                    <a:lnTo>
                      <a:pt x="276" y="484"/>
                    </a:lnTo>
                    <a:lnTo>
                      <a:pt x="278" y="484"/>
                    </a:lnTo>
                    <a:lnTo>
                      <a:pt x="280" y="484"/>
                    </a:lnTo>
                    <a:lnTo>
                      <a:pt x="282" y="484"/>
                    </a:lnTo>
                    <a:lnTo>
                      <a:pt x="284" y="484"/>
                    </a:lnTo>
                    <a:lnTo>
                      <a:pt x="286" y="484"/>
                    </a:lnTo>
                    <a:lnTo>
                      <a:pt x="288" y="484"/>
                    </a:lnTo>
                    <a:lnTo>
                      <a:pt x="290" y="484"/>
                    </a:lnTo>
                    <a:lnTo>
                      <a:pt x="292" y="484"/>
                    </a:lnTo>
                    <a:lnTo>
                      <a:pt x="294" y="484"/>
                    </a:lnTo>
                    <a:lnTo>
                      <a:pt x="296" y="484"/>
                    </a:lnTo>
                    <a:lnTo>
                      <a:pt x="298" y="484"/>
                    </a:lnTo>
                    <a:lnTo>
                      <a:pt x="300" y="484"/>
                    </a:lnTo>
                    <a:lnTo>
                      <a:pt x="302" y="484"/>
                    </a:lnTo>
                    <a:lnTo>
                      <a:pt x="304" y="484"/>
                    </a:lnTo>
                    <a:lnTo>
                      <a:pt x="306" y="484"/>
                    </a:lnTo>
                    <a:lnTo>
                      <a:pt x="308" y="486"/>
                    </a:lnTo>
                    <a:lnTo>
                      <a:pt x="310" y="486"/>
                    </a:lnTo>
                    <a:lnTo>
                      <a:pt x="312" y="486"/>
                    </a:lnTo>
                    <a:lnTo>
                      <a:pt x="314" y="486"/>
                    </a:lnTo>
                    <a:lnTo>
                      <a:pt x="316" y="486"/>
                    </a:lnTo>
                    <a:lnTo>
                      <a:pt x="318" y="486"/>
                    </a:lnTo>
                    <a:lnTo>
                      <a:pt x="320" y="486"/>
                    </a:lnTo>
                    <a:lnTo>
                      <a:pt x="322" y="486"/>
                    </a:lnTo>
                    <a:lnTo>
                      <a:pt x="324" y="486"/>
                    </a:lnTo>
                    <a:lnTo>
                      <a:pt x="326" y="486"/>
                    </a:lnTo>
                    <a:lnTo>
                      <a:pt x="328" y="486"/>
                    </a:lnTo>
                    <a:lnTo>
                      <a:pt x="330" y="486"/>
                    </a:lnTo>
                    <a:lnTo>
                      <a:pt x="332" y="486"/>
                    </a:lnTo>
                    <a:lnTo>
                      <a:pt x="334" y="486"/>
                    </a:lnTo>
                    <a:lnTo>
                      <a:pt x="336" y="484"/>
                    </a:lnTo>
                    <a:lnTo>
                      <a:pt x="338" y="484"/>
                    </a:lnTo>
                    <a:lnTo>
                      <a:pt x="340" y="484"/>
                    </a:lnTo>
                    <a:lnTo>
                      <a:pt x="342" y="484"/>
                    </a:lnTo>
                    <a:lnTo>
                      <a:pt x="344" y="484"/>
                    </a:lnTo>
                    <a:lnTo>
                      <a:pt x="346" y="484"/>
                    </a:lnTo>
                    <a:lnTo>
                      <a:pt x="348" y="484"/>
                    </a:lnTo>
                    <a:lnTo>
                      <a:pt x="350" y="484"/>
                    </a:lnTo>
                    <a:lnTo>
                      <a:pt x="352" y="484"/>
                    </a:lnTo>
                    <a:lnTo>
                      <a:pt x="354" y="484"/>
                    </a:lnTo>
                    <a:lnTo>
                      <a:pt x="356" y="484"/>
                    </a:lnTo>
                    <a:lnTo>
                      <a:pt x="358" y="484"/>
                    </a:lnTo>
                    <a:lnTo>
                      <a:pt x="360" y="484"/>
                    </a:lnTo>
                    <a:lnTo>
                      <a:pt x="362" y="484"/>
                    </a:lnTo>
                    <a:lnTo>
                      <a:pt x="364" y="484"/>
                    </a:lnTo>
                    <a:lnTo>
                      <a:pt x="366" y="484"/>
                    </a:lnTo>
                    <a:lnTo>
                      <a:pt x="368" y="484"/>
                    </a:lnTo>
                    <a:lnTo>
                      <a:pt x="370" y="484"/>
                    </a:lnTo>
                    <a:lnTo>
                      <a:pt x="372" y="484"/>
                    </a:lnTo>
                    <a:lnTo>
                      <a:pt x="374" y="484"/>
                    </a:lnTo>
                    <a:lnTo>
                      <a:pt x="376" y="484"/>
                    </a:lnTo>
                    <a:lnTo>
                      <a:pt x="378" y="484"/>
                    </a:lnTo>
                    <a:lnTo>
                      <a:pt x="380" y="484"/>
                    </a:lnTo>
                    <a:lnTo>
                      <a:pt x="382" y="484"/>
                    </a:lnTo>
                    <a:lnTo>
                      <a:pt x="384" y="484"/>
                    </a:lnTo>
                    <a:lnTo>
                      <a:pt x="386" y="484"/>
                    </a:lnTo>
                    <a:lnTo>
                      <a:pt x="388" y="484"/>
                    </a:lnTo>
                    <a:lnTo>
                      <a:pt x="390" y="484"/>
                    </a:lnTo>
                    <a:lnTo>
                      <a:pt x="392" y="484"/>
                    </a:lnTo>
                    <a:lnTo>
                      <a:pt x="394" y="484"/>
                    </a:lnTo>
                    <a:lnTo>
                      <a:pt x="396" y="486"/>
                    </a:lnTo>
                    <a:lnTo>
                      <a:pt x="398" y="486"/>
                    </a:lnTo>
                    <a:lnTo>
                      <a:pt x="400" y="486"/>
                    </a:lnTo>
                    <a:lnTo>
                      <a:pt x="402" y="486"/>
                    </a:lnTo>
                    <a:lnTo>
                      <a:pt x="404" y="486"/>
                    </a:lnTo>
                    <a:lnTo>
                      <a:pt x="406" y="486"/>
                    </a:lnTo>
                    <a:lnTo>
                      <a:pt x="408" y="486"/>
                    </a:lnTo>
                    <a:lnTo>
                      <a:pt x="410" y="486"/>
                    </a:lnTo>
                    <a:lnTo>
                      <a:pt x="412" y="486"/>
                    </a:lnTo>
                    <a:lnTo>
                      <a:pt x="414" y="486"/>
                    </a:lnTo>
                    <a:lnTo>
                      <a:pt x="416" y="486"/>
                    </a:lnTo>
                    <a:lnTo>
                      <a:pt x="418" y="486"/>
                    </a:lnTo>
                    <a:lnTo>
                      <a:pt x="420" y="486"/>
                    </a:lnTo>
                    <a:lnTo>
                      <a:pt x="422" y="486"/>
                    </a:lnTo>
                    <a:lnTo>
                      <a:pt x="424" y="486"/>
                    </a:lnTo>
                    <a:lnTo>
                      <a:pt x="426" y="486"/>
                    </a:lnTo>
                    <a:lnTo>
                      <a:pt x="428" y="486"/>
                    </a:lnTo>
                    <a:lnTo>
                      <a:pt x="430" y="486"/>
                    </a:lnTo>
                    <a:lnTo>
                      <a:pt x="432" y="486"/>
                    </a:lnTo>
                    <a:lnTo>
                      <a:pt x="434" y="486"/>
                    </a:lnTo>
                    <a:lnTo>
                      <a:pt x="436" y="486"/>
                    </a:lnTo>
                    <a:lnTo>
                      <a:pt x="438" y="486"/>
                    </a:lnTo>
                    <a:lnTo>
                      <a:pt x="440" y="486"/>
                    </a:lnTo>
                    <a:lnTo>
                      <a:pt x="442" y="486"/>
                    </a:lnTo>
                    <a:lnTo>
                      <a:pt x="444" y="486"/>
                    </a:lnTo>
                    <a:lnTo>
                      <a:pt x="446" y="486"/>
                    </a:lnTo>
                    <a:lnTo>
                      <a:pt x="448" y="486"/>
                    </a:lnTo>
                    <a:lnTo>
                      <a:pt x="450" y="486"/>
                    </a:lnTo>
                    <a:lnTo>
                      <a:pt x="452" y="486"/>
                    </a:lnTo>
                    <a:lnTo>
                      <a:pt x="454" y="486"/>
                    </a:lnTo>
                    <a:lnTo>
                      <a:pt x="456" y="486"/>
                    </a:lnTo>
                    <a:lnTo>
                      <a:pt x="458" y="486"/>
                    </a:lnTo>
                    <a:lnTo>
                      <a:pt x="460" y="486"/>
                    </a:lnTo>
                    <a:lnTo>
                      <a:pt x="462" y="486"/>
                    </a:lnTo>
                    <a:lnTo>
                      <a:pt x="464" y="486"/>
                    </a:lnTo>
                    <a:lnTo>
                      <a:pt x="466" y="486"/>
                    </a:lnTo>
                    <a:lnTo>
                      <a:pt x="468" y="486"/>
                    </a:lnTo>
                    <a:lnTo>
                      <a:pt x="470" y="486"/>
                    </a:lnTo>
                    <a:lnTo>
                      <a:pt x="472" y="486"/>
                    </a:lnTo>
                    <a:lnTo>
                      <a:pt x="474" y="486"/>
                    </a:lnTo>
                    <a:lnTo>
                      <a:pt x="476" y="486"/>
                    </a:lnTo>
                    <a:lnTo>
                      <a:pt x="478" y="486"/>
                    </a:lnTo>
                    <a:lnTo>
                      <a:pt x="480" y="486"/>
                    </a:lnTo>
                    <a:lnTo>
                      <a:pt x="482" y="486"/>
                    </a:lnTo>
                    <a:lnTo>
                      <a:pt x="484" y="486"/>
                    </a:lnTo>
                    <a:lnTo>
                      <a:pt x="486" y="486"/>
                    </a:lnTo>
                    <a:lnTo>
                      <a:pt x="488" y="486"/>
                    </a:lnTo>
                    <a:lnTo>
                      <a:pt x="490" y="486"/>
                    </a:lnTo>
                    <a:lnTo>
                      <a:pt x="492" y="486"/>
                    </a:lnTo>
                    <a:lnTo>
                      <a:pt x="494" y="486"/>
                    </a:lnTo>
                    <a:lnTo>
                      <a:pt x="496" y="486"/>
                    </a:lnTo>
                    <a:lnTo>
                      <a:pt x="498" y="486"/>
                    </a:lnTo>
                    <a:lnTo>
                      <a:pt x="500" y="486"/>
                    </a:lnTo>
                    <a:lnTo>
                      <a:pt x="502" y="486"/>
                    </a:lnTo>
                    <a:lnTo>
                      <a:pt x="504" y="486"/>
                    </a:lnTo>
                    <a:lnTo>
                      <a:pt x="506" y="486"/>
                    </a:lnTo>
                    <a:lnTo>
                      <a:pt x="508" y="486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8" name="Text Box 3835"/>
            <p:cNvSpPr/>
            <p:nvPr/>
          </p:nvSpPr>
          <p:spPr>
            <a:xfrm>
              <a:off x="2170080" y="4809960"/>
              <a:ext cx="63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6.91/5.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9" name="Group 3862"/>
          <p:cNvGrpSpPr/>
          <p:nvPr/>
        </p:nvGrpSpPr>
        <p:grpSpPr>
          <a:xfrm>
            <a:off x="3946680" y="3570120"/>
            <a:ext cx="1432800" cy="1400760"/>
            <a:chOff x="3946680" y="3570120"/>
            <a:chExt cx="1432800" cy="1400760"/>
          </a:xfrm>
        </p:grpSpPr>
        <p:grpSp>
          <p:nvGrpSpPr>
            <p:cNvPr id="600" name="Group 3857"/>
            <p:cNvGrpSpPr/>
            <p:nvPr/>
          </p:nvGrpSpPr>
          <p:grpSpPr>
            <a:xfrm>
              <a:off x="3946680" y="3589200"/>
              <a:ext cx="1405800" cy="1381680"/>
              <a:chOff x="3946680" y="3589200"/>
              <a:chExt cx="1405800" cy="1381680"/>
            </a:xfrm>
          </p:grpSpPr>
          <p:grpSp>
            <p:nvGrpSpPr>
              <p:cNvPr id="601" name="Group 100"/>
              <p:cNvGrpSpPr/>
              <p:nvPr/>
            </p:nvGrpSpPr>
            <p:grpSpPr>
              <a:xfrm>
                <a:off x="3946680" y="3589200"/>
                <a:ext cx="1405800" cy="1381680"/>
                <a:chOff x="3946680" y="3589200"/>
                <a:chExt cx="1405800" cy="1381680"/>
              </a:xfrm>
            </p:grpSpPr>
            <p:sp>
              <p:nvSpPr>
                <p:cNvPr id="602" name="Rectangle 101"/>
                <p:cNvSpPr/>
                <p:nvPr/>
              </p:nvSpPr>
              <p:spPr>
                <a:xfrm>
                  <a:off x="4150080" y="3590640"/>
                  <a:ext cx="1166400" cy="92448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03" name="Group 102"/>
                <p:cNvGrpSpPr/>
                <p:nvPr/>
              </p:nvGrpSpPr>
              <p:grpSpPr>
                <a:xfrm>
                  <a:off x="4101480" y="4512960"/>
                  <a:ext cx="1251000" cy="457920"/>
                  <a:chOff x="4101480" y="4512960"/>
                  <a:chExt cx="1251000" cy="457920"/>
                </a:xfrm>
              </p:grpSpPr>
              <p:sp>
                <p:nvSpPr>
                  <p:cNvPr id="604" name="Line 103"/>
                  <p:cNvSpPr/>
                  <p:nvPr/>
                </p:nvSpPr>
                <p:spPr>
                  <a:xfrm>
                    <a:off x="4147920" y="4512960"/>
                    <a:ext cx="116568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605" name="Group 104"/>
                  <p:cNvGrpSpPr/>
                  <p:nvPr/>
                </p:nvGrpSpPr>
                <p:grpSpPr>
                  <a:xfrm>
                    <a:off x="4147920" y="4516560"/>
                    <a:ext cx="1165320" cy="20880"/>
                    <a:chOff x="4147920" y="4516560"/>
                    <a:chExt cx="1165320" cy="20880"/>
                  </a:xfrm>
                </p:grpSpPr>
                <p:sp>
                  <p:nvSpPr>
                    <p:cNvPr id="606" name="Line 105"/>
                    <p:cNvSpPr/>
                    <p:nvPr/>
                  </p:nvSpPr>
                  <p:spPr>
                    <a:xfrm>
                      <a:off x="414792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07" name="Line 106"/>
                    <p:cNvSpPr/>
                    <p:nvPr/>
                  </p:nvSpPr>
                  <p:spPr>
                    <a:xfrm>
                      <a:off x="42332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08" name="Line 107"/>
                    <p:cNvSpPr/>
                    <p:nvPr/>
                  </p:nvSpPr>
                  <p:spPr>
                    <a:xfrm>
                      <a:off x="42829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09" name="Line 108"/>
                    <p:cNvSpPr/>
                    <p:nvPr/>
                  </p:nvSpPr>
                  <p:spPr>
                    <a:xfrm>
                      <a:off x="431928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0" name="Line 109"/>
                    <p:cNvSpPr/>
                    <p:nvPr/>
                  </p:nvSpPr>
                  <p:spPr>
                    <a:xfrm>
                      <a:off x="4350960" y="45165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1" name="Line 110"/>
                    <p:cNvSpPr/>
                    <p:nvPr/>
                  </p:nvSpPr>
                  <p:spPr>
                    <a:xfrm>
                      <a:off x="43736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2" name="Line 111"/>
                    <p:cNvSpPr/>
                    <p:nvPr/>
                  </p:nvSpPr>
                  <p:spPr>
                    <a:xfrm>
                      <a:off x="43916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3" name="Line 112"/>
                    <p:cNvSpPr/>
                    <p:nvPr/>
                  </p:nvSpPr>
                  <p:spPr>
                    <a:xfrm>
                      <a:off x="44096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4" name="Line 113"/>
                    <p:cNvSpPr/>
                    <p:nvPr/>
                  </p:nvSpPr>
                  <p:spPr>
                    <a:xfrm>
                      <a:off x="44233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5" name="Line 114"/>
                    <p:cNvSpPr/>
                    <p:nvPr/>
                  </p:nvSpPr>
                  <p:spPr>
                    <a:xfrm>
                      <a:off x="443664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6" name="Line 115"/>
                    <p:cNvSpPr/>
                    <p:nvPr/>
                  </p:nvSpPr>
                  <p:spPr>
                    <a:xfrm>
                      <a:off x="452736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7" name="Line 116"/>
                    <p:cNvSpPr/>
                    <p:nvPr/>
                  </p:nvSpPr>
                  <p:spPr>
                    <a:xfrm>
                      <a:off x="45770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8" name="Line 117"/>
                    <p:cNvSpPr/>
                    <p:nvPr/>
                  </p:nvSpPr>
                  <p:spPr>
                    <a:xfrm>
                      <a:off x="46130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9" name="Line 118"/>
                    <p:cNvSpPr/>
                    <p:nvPr/>
                  </p:nvSpPr>
                  <p:spPr>
                    <a:xfrm>
                      <a:off x="4640040" y="45165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0" name="Line 119"/>
                    <p:cNvSpPr/>
                    <p:nvPr/>
                  </p:nvSpPr>
                  <p:spPr>
                    <a:xfrm>
                      <a:off x="466740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1" name="Line 120"/>
                    <p:cNvSpPr/>
                    <p:nvPr/>
                  </p:nvSpPr>
                  <p:spPr>
                    <a:xfrm>
                      <a:off x="46850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2" name="Line 121"/>
                    <p:cNvSpPr/>
                    <p:nvPr/>
                  </p:nvSpPr>
                  <p:spPr>
                    <a:xfrm>
                      <a:off x="47030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3" name="Line 122"/>
                    <p:cNvSpPr/>
                    <p:nvPr/>
                  </p:nvSpPr>
                  <p:spPr>
                    <a:xfrm>
                      <a:off x="471708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4" name="Line 123"/>
                    <p:cNvSpPr/>
                    <p:nvPr/>
                  </p:nvSpPr>
                  <p:spPr>
                    <a:xfrm>
                      <a:off x="473040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5" name="Line 124"/>
                    <p:cNvSpPr/>
                    <p:nvPr/>
                  </p:nvSpPr>
                  <p:spPr>
                    <a:xfrm>
                      <a:off x="48164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6" name="Line 125"/>
                    <p:cNvSpPr/>
                    <p:nvPr/>
                  </p:nvSpPr>
                  <p:spPr>
                    <a:xfrm>
                      <a:off x="487080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7" name="Line 126"/>
                    <p:cNvSpPr/>
                    <p:nvPr/>
                  </p:nvSpPr>
                  <p:spPr>
                    <a:xfrm>
                      <a:off x="49064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8" name="Line 127"/>
                    <p:cNvSpPr/>
                    <p:nvPr/>
                  </p:nvSpPr>
                  <p:spPr>
                    <a:xfrm>
                      <a:off x="4933800" y="45165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29" name="Line 128"/>
                    <p:cNvSpPr/>
                    <p:nvPr/>
                  </p:nvSpPr>
                  <p:spPr>
                    <a:xfrm>
                      <a:off x="49561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0" name="Line 129"/>
                    <p:cNvSpPr/>
                    <p:nvPr/>
                  </p:nvSpPr>
                  <p:spPr>
                    <a:xfrm>
                      <a:off x="497880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1" name="Line 130"/>
                    <p:cNvSpPr/>
                    <p:nvPr/>
                  </p:nvSpPr>
                  <p:spPr>
                    <a:xfrm>
                      <a:off x="499248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2" name="Line 131"/>
                    <p:cNvSpPr/>
                    <p:nvPr/>
                  </p:nvSpPr>
                  <p:spPr>
                    <a:xfrm>
                      <a:off x="501048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3" name="Line 132"/>
                    <p:cNvSpPr/>
                    <p:nvPr/>
                  </p:nvSpPr>
                  <p:spPr>
                    <a:xfrm>
                      <a:off x="502416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4" name="Line 133"/>
                    <p:cNvSpPr/>
                    <p:nvPr/>
                  </p:nvSpPr>
                  <p:spPr>
                    <a:xfrm>
                      <a:off x="51098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5" name="Line 134"/>
                    <p:cNvSpPr/>
                    <p:nvPr/>
                  </p:nvSpPr>
                  <p:spPr>
                    <a:xfrm>
                      <a:off x="516420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6" name="Line 135"/>
                    <p:cNvSpPr/>
                    <p:nvPr/>
                  </p:nvSpPr>
                  <p:spPr>
                    <a:xfrm>
                      <a:off x="520056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7" name="Line 136"/>
                    <p:cNvSpPr/>
                    <p:nvPr/>
                  </p:nvSpPr>
                  <p:spPr>
                    <a:xfrm>
                      <a:off x="5227560" y="4516560"/>
                      <a:ext cx="0" cy="136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3120" bIns="-331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8" name="Line 137"/>
                    <p:cNvSpPr/>
                    <p:nvPr/>
                  </p:nvSpPr>
                  <p:spPr>
                    <a:xfrm>
                      <a:off x="52502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9" name="Line 138"/>
                    <p:cNvSpPr/>
                    <p:nvPr/>
                  </p:nvSpPr>
                  <p:spPr>
                    <a:xfrm>
                      <a:off x="52682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0" name="Line 139"/>
                    <p:cNvSpPr/>
                    <p:nvPr/>
                  </p:nvSpPr>
                  <p:spPr>
                    <a:xfrm>
                      <a:off x="528624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1" name="Line 140"/>
                    <p:cNvSpPr/>
                    <p:nvPr/>
                  </p:nvSpPr>
                  <p:spPr>
                    <a:xfrm>
                      <a:off x="5299920" y="4516560"/>
                      <a:ext cx="0" cy="7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600" bIns="-39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2" name="Line 141"/>
                    <p:cNvSpPr/>
                    <p:nvPr/>
                  </p:nvSpPr>
                  <p:spPr>
                    <a:xfrm>
                      <a:off x="5313240" y="4516560"/>
                      <a:ext cx="0" cy="2088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920" bIns="-259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643" name="Group 142"/>
                  <p:cNvGrpSpPr/>
                  <p:nvPr/>
                </p:nvGrpSpPr>
                <p:grpSpPr>
                  <a:xfrm>
                    <a:off x="4101480" y="4545360"/>
                    <a:ext cx="1251000" cy="60120"/>
                    <a:chOff x="4101480" y="4545360"/>
                    <a:chExt cx="1251000" cy="60120"/>
                  </a:xfrm>
                </p:grpSpPr>
                <p:sp>
                  <p:nvSpPr>
                    <p:cNvPr id="644" name="Rectangle 143"/>
                    <p:cNvSpPr/>
                    <p:nvPr/>
                  </p:nvSpPr>
                  <p:spPr>
                    <a:xfrm>
                      <a:off x="410148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5" name="Rectangle 144"/>
                    <p:cNvSpPr/>
                    <p:nvPr/>
                  </p:nvSpPr>
                  <p:spPr>
                    <a:xfrm>
                      <a:off x="416520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6" name="Rectangle 145"/>
                    <p:cNvSpPr/>
                    <p:nvPr/>
                  </p:nvSpPr>
                  <p:spPr>
                    <a:xfrm>
                      <a:off x="439020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7" name="Rectangle 146"/>
                    <p:cNvSpPr/>
                    <p:nvPr/>
                  </p:nvSpPr>
                  <p:spPr>
                    <a:xfrm>
                      <a:off x="445392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8" name="Rectangle 147"/>
                    <p:cNvSpPr/>
                    <p:nvPr/>
                  </p:nvSpPr>
                  <p:spPr>
                    <a:xfrm>
                      <a:off x="468396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49" name="Rectangle 148"/>
                    <p:cNvSpPr/>
                    <p:nvPr/>
                  </p:nvSpPr>
                  <p:spPr>
                    <a:xfrm>
                      <a:off x="474768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0" name="Rectangle 149"/>
                    <p:cNvSpPr/>
                    <p:nvPr/>
                  </p:nvSpPr>
                  <p:spPr>
                    <a:xfrm>
                      <a:off x="497736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1" name="Rectangle 150"/>
                    <p:cNvSpPr/>
                    <p:nvPr/>
                  </p:nvSpPr>
                  <p:spPr>
                    <a:xfrm>
                      <a:off x="504180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2" name="Rectangle 151"/>
                    <p:cNvSpPr/>
                    <p:nvPr/>
                  </p:nvSpPr>
                  <p:spPr>
                    <a:xfrm>
                      <a:off x="5266800" y="455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3" name="Rectangle 152"/>
                    <p:cNvSpPr/>
                    <p:nvPr/>
                  </p:nvSpPr>
                  <p:spPr>
                    <a:xfrm>
                      <a:off x="5330520" y="4545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654" name="Rectangle 153"/>
                  <p:cNvSpPr/>
                  <p:nvPr/>
                </p:nvSpPr>
                <p:spPr>
                  <a:xfrm>
                    <a:off x="4653720" y="4606200"/>
                    <a:ext cx="2520" cy="3646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55" name="Group 154"/>
                <p:cNvGrpSpPr/>
                <p:nvPr/>
              </p:nvGrpSpPr>
              <p:grpSpPr>
                <a:xfrm>
                  <a:off x="3946680" y="3589200"/>
                  <a:ext cx="200880" cy="944640"/>
                  <a:chOff x="3946680" y="3589200"/>
                  <a:chExt cx="200880" cy="944640"/>
                </a:xfrm>
              </p:grpSpPr>
              <p:sp>
                <p:nvSpPr>
                  <p:cNvPr id="656" name="Line 155"/>
                  <p:cNvSpPr/>
                  <p:nvPr/>
                </p:nvSpPr>
                <p:spPr>
                  <a:xfrm flipV="1">
                    <a:off x="4147560" y="3589200"/>
                    <a:ext cx="0" cy="92376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657" name="Group 156"/>
                  <p:cNvGrpSpPr/>
                  <p:nvPr/>
                </p:nvGrpSpPr>
                <p:grpSpPr>
                  <a:xfrm>
                    <a:off x="4005360" y="3606840"/>
                    <a:ext cx="86040" cy="927000"/>
                    <a:chOff x="4005360" y="3606840"/>
                    <a:chExt cx="86040" cy="927000"/>
                  </a:xfrm>
                </p:grpSpPr>
                <p:sp>
                  <p:nvSpPr>
                    <p:cNvPr id="658" name="Rectangle 157"/>
                    <p:cNvSpPr/>
                    <p:nvPr/>
                  </p:nvSpPr>
                  <p:spPr>
                    <a:xfrm>
                      <a:off x="4069440" y="44877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59" name="Rectangle 158"/>
                    <p:cNvSpPr/>
                    <p:nvPr/>
                  </p:nvSpPr>
                  <p:spPr>
                    <a:xfrm>
                      <a:off x="4037040" y="4312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0" name="Rectangle 159"/>
                    <p:cNvSpPr/>
                    <p:nvPr/>
                  </p:nvSpPr>
                  <p:spPr>
                    <a:xfrm>
                      <a:off x="4037040" y="41367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1" name="Rectangle 160"/>
                    <p:cNvSpPr/>
                    <p:nvPr/>
                  </p:nvSpPr>
                  <p:spPr>
                    <a:xfrm>
                      <a:off x="4037040" y="39574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2" name="Rectangle 161"/>
                    <p:cNvSpPr/>
                    <p:nvPr/>
                  </p:nvSpPr>
                  <p:spPr>
                    <a:xfrm>
                      <a:off x="4037040" y="37821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3" name="Rectangle 162"/>
                    <p:cNvSpPr/>
                    <p:nvPr/>
                  </p:nvSpPr>
                  <p:spPr>
                    <a:xfrm>
                      <a:off x="4005360" y="360684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664" name="Group 163"/>
                  <p:cNvGrpSpPr/>
                  <p:nvPr/>
                </p:nvGrpSpPr>
                <p:grpSpPr>
                  <a:xfrm>
                    <a:off x="4120560" y="3632040"/>
                    <a:ext cx="26640" cy="880560"/>
                    <a:chOff x="4120560" y="3632040"/>
                    <a:chExt cx="26640" cy="880560"/>
                  </a:xfrm>
                </p:grpSpPr>
                <p:sp>
                  <p:nvSpPr>
                    <p:cNvPr id="665" name="Line 164"/>
                    <p:cNvSpPr/>
                    <p:nvPr/>
                  </p:nvSpPr>
                  <p:spPr>
                    <a:xfrm flipH="1">
                      <a:off x="4120560" y="451260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6" name="Line 165"/>
                    <p:cNvSpPr/>
                    <p:nvPr/>
                  </p:nvSpPr>
                  <p:spPr>
                    <a:xfrm flipH="1">
                      <a:off x="4137840" y="44701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7" name="Line 166"/>
                    <p:cNvSpPr/>
                    <p:nvPr/>
                  </p:nvSpPr>
                  <p:spPr>
                    <a:xfrm flipH="1">
                      <a:off x="4137840" y="44269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8" name="Line 167"/>
                    <p:cNvSpPr/>
                    <p:nvPr/>
                  </p:nvSpPr>
                  <p:spPr>
                    <a:xfrm flipH="1">
                      <a:off x="4137840" y="43804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69" name="Line 168"/>
                    <p:cNvSpPr/>
                    <p:nvPr/>
                  </p:nvSpPr>
                  <p:spPr>
                    <a:xfrm flipH="1">
                      <a:off x="4120560" y="433728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0" name="Line 169"/>
                    <p:cNvSpPr/>
                    <p:nvPr/>
                  </p:nvSpPr>
                  <p:spPr>
                    <a:xfrm flipH="1">
                      <a:off x="4137840" y="42940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1" name="Line 170"/>
                    <p:cNvSpPr/>
                    <p:nvPr/>
                  </p:nvSpPr>
                  <p:spPr>
                    <a:xfrm flipH="1">
                      <a:off x="4137840" y="42480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2" name="Line 171"/>
                    <p:cNvSpPr/>
                    <p:nvPr/>
                  </p:nvSpPr>
                  <p:spPr>
                    <a:xfrm flipH="1">
                      <a:off x="4137840" y="42048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3" name="Line 172"/>
                    <p:cNvSpPr/>
                    <p:nvPr/>
                  </p:nvSpPr>
                  <p:spPr>
                    <a:xfrm flipH="1">
                      <a:off x="4120560" y="416196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4" name="Line 173"/>
                    <p:cNvSpPr/>
                    <p:nvPr/>
                  </p:nvSpPr>
                  <p:spPr>
                    <a:xfrm flipH="1">
                      <a:off x="4137840" y="41151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5" name="Line 174"/>
                    <p:cNvSpPr/>
                    <p:nvPr/>
                  </p:nvSpPr>
                  <p:spPr>
                    <a:xfrm flipH="1">
                      <a:off x="4137840" y="40726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6" name="Line 175"/>
                    <p:cNvSpPr/>
                    <p:nvPr/>
                  </p:nvSpPr>
                  <p:spPr>
                    <a:xfrm flipH="1">
                      <a:off x="4137840" y="40294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7" name="Line 176"/>
                    <p:cNvSpPr/>
                    <p:nvPr/>
                  </p:nvSpPr>
                  <p:spPr>
                    <a:xfrm flipH="1">
                      <a:off x="4120560" y="398268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8" name="Line 177"/>
                    <p:cNvSpPr/>
                    <p:nvPr/>
                  </p:nvSpPr>
                  <p:spPr>
                    <a:xfrm flipH="1">
                      <a:off x="4137840" y="39398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79" name="Line 178"/>
                    <p:cNvSpPr/>
                    <p:nvPr/>
                  </p:nvSpPr>
                  <p:spPr>
                    <a:xfrm flipH="1">
                      <a:off x="4137840" y="389664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0" name="Line 179"/>
                    <p:cNvSpPr/>
                    <p:nvPr/>
                  </p:nvSpPr>
                  <p:spPr>
                    <a:xfrm flipH="1">
                      <a:off x="4137840" y="385020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1" name="Line 180"/>
                    <p:cNvSpPr/>
                    <p:nvPr/>
                  </p:nvSpPr>
                  <p:spPr>
                    <a:xfrm flipH="1">
                      <a:off x="4120560" y="380736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2" name="Line 181"/>
                    <p:cNvSpPr/>
                    <p:nvPr/>
                  </p:nvSpPr>
                  <p:spPr>
                    <a:xfrm flipH="1">
                      <a:off x="4137840" y="376416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3" name="Line 182"/>
                    <p:cNvSpPr/>
                    <p:nvPr/>
                  </p:nvSpPr>
                  <p:spPr>
                    <a:xfrm flipH="1">
                      <a:off x="4137840" y="371772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4" name="Line 183"/>
                    <p:cNvSpPr/>
                    <p:nvPr/>
                  </p:nvSpPr>
                  <p:spPr>
                    <a:xfrm flipH="1">
                      <a:off x="4137840" y="3674880"/>
                      <a:ext cx="900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85" name="Line 184"/>
                    <p:cNvSpPr/>
                    <p:nvPr/>
                  </p:nvSpPr>
                  <p:spPr>
                    <a:xfrm flipH="1">
                      <a:off x="4120560" y="3632040"/>
                      <a:ext cx="2664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686" name="Rectangle 185"/>
                  <p:cNvSpPr/>
                  <p:nvPr/>
                </p:nvSpPr>
                <p:spPr>
                  <a:xfrm rot="16200000">
                    <a:off x="3765240" y="4316400"/>
                    <a:ext cx="365040" cy="2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 vert="eaVer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687" name="Group 186"/>
              <p:cNvGrpSpPr/>
              <p:nvPr/>
            </p:nvGrpSpPr>
            <p:grpSpPr>
              <a:xfrm>
                <a:off x="4157640" y="3635280"/>
                <a:ext cx="1151640" cy="871200"/>
                <a:chOff x="4157640" y="3635280"/>
                <a:chExt cx="1151640" cy="871200"/>
              </a:xfrm>
            </p:grpSpPr>
            <p:sp>
              <p:nvSpPr>
                <p:cNvPr id="688" name="Freeform 187"/>
                <p:cNvSpPr/>
                <p:nvPr/>
              </p:nvSpPr>
              <p:spPr>
                <a:xfrm>
                  <a:off x="4157640" y="3635280"/>
                  <a:ext cx="1151640" cy="867960"/>
                </a:xfrm>
                <a:custGeom>
                  <a:avLst/>
                  <a:gdLst>
                    <a:gd name="textAreaLeft" fmla="*/ 0 w 1151640"/>
                    <a:gd name="textAreaRight" fmla="*/ 1152000 w 1151640"/>
                    <a:gd name="textAreaTop" fmla="*/ 0 h 867960"/>
                    <a:gd name="textAreaBottom" fmla="*/ 868320 h 867960"/>
                  </a:gdLst>
                  <a:ahLst/>
                  <a:rect l="textAreaLeft" t="textAreaTop" r="textAreaRight" b="textAreaBottom"/>
                  <a:pathLst>
                    <a:path w="510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  <a:lnTo>
                        <a:pt x="510" y="486"/>
                      </a:lnTo>
                      <a:lnTo>
                        <a:pt x="0" y="486"/>
                      </a:lnTo>
                      <a:close/>
                    </a:path>
                  </a:pathLst>
                </a:custGeom>
                <a:solidFill>
                  <a:srgbClr val="e8e8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9" name="Freeform 188"/>
                <p:cNvSpPr/>
                <p:nvPr/>
              </p:nvSpPr>
              <p:spPr>
                <a:xfrm>
                  <a:off x="4161960" y="3638880"/>
                  <a:ext cx="1146960" cy="867600"/>
                </a:xfrm>
                <a:custGeom>
                  <a:avLst/>
                  <a:gdLst>
                    <a:gd name="textAreaLeft" fmla="*/ 0 w 1146960"/>
                    <a:gd name="textAreaRight" fmla="*/ 1147320 w 1146960"/>
                    <a:gd name="textAreaTop" fmla="*/ 0 h 867600"/>
                    <a:gd name="textAreaBottom" fmla="*/ 867960 h 867600"/>
                  </a:gdLst>
                  <a:ahLst/>
                  <a:rect l="textAreaLeft" t="textAreaTop" r="textAreaRight" b="textAreaBottom"/>
                  <a:pathLst>
                    <a:path w="508" h="486">
                      <a:moveTo>
                        <a:pt x="0" y="486"/>
                      </a:moveTo>
                      <a:lnTo>
                        <a:pt x="0" y="126"/>
                      </a:lnTo>
                      <a:lnTo>
                        <a:pt x="0" y="212"/>
                      </a:lnTo>
                      <a:lnTo>
                        <a:pt x="2" y="290"/>
                      </a:lnTo>
                      <a:lnTo>
                        <a:pt x="4" y="320"/>
                      </a:lnTo>
                      <a:lnTo>
                        <a:pt x="6" y="314"/>
                      </a:lnTo>
                      <a:lnTo>
                        <a:pt x="8" y="290"/>
                      </a:lnTo>
                      <a:lnTo>
                        <a:pt x="10" y="262"/>
                      </a:lnTo>
                      <a:lnTo>
                        <a:pt x="12" y="228"/>
                      </a:lnTo>
                      <a:lnTo>
                        <a:pt x="14" y="196"/>
                      </a:lnTo>
                      <a:lnTo>
                        <a:pt x="16" y="168"/>
                      </a:lnTo>
                      <a:lnTo>
                        <a:pt x="18" y="142"/>
                      </a:lnTo>
                      <a:lnTo>
                        <a:pt x="20" y="128"/>
                      </a:lnTo>
                      <a:lnTo>
                        <a:pt x="22" y="96"/>
                      </a:lnTo>
                      <a:lnTo>
                        <a:pt x="24" y="38"/>
                      </a:lnTo>
                      <a:lnTo>
                        <a:pt x="26" y="28"/>
                      </a:lnTo>
                      <a:lnTo>
                        <a:pt x="28" y="44"/>
                      </a:lnTo>
                      <a:lnTo>
                        <a:pt x="30" y="0"/>
                      </a:lnTo>
                      <a:lnTo>
                        <a:pt x="32" y="20"/>
                      </a:lnTo>
                      <a:lnTo>
                        <a:pt x="34" y="64"/>
                      </a:lnTo>
                      <a:lnTo>
                        <a:pt x="36" y="56"/>
                      </a:lnTo>
                      <a:lnTo>
                        <a:pt x="38" y="6"/>
                      </a:lnTo>
                      <a:lnTo>
                        <a:pt x="40" y="4"/>
                      </a:lnTo>
                      <a:lnTo>
                        <a:pt x="42" y="46"/>
                      </a:lnTo>
                      <a:lnTo>
                        <a:pt x="44" y="52"/>
                      </a:lnTo>
                      <a:lnTo>
                        <a:pt x="46" y="54"/>
                      </a:lnTo>
                      <a:lnTo>
                        <a:pt x="48" y="88"/>
                      </a:lnTo>
                      <a:lnTo>
                        <a:pt x="50" y="116"/>
                      </a:lnTo>
                      <a:lnTo>
                        <a:pt x="52" y="144"/>
                      </a:lnTo>
                      <a:lnTo>
                        <a:pt x="54" y="170"/>
                      </a:lnTo>
                      <a:lnTo>
                        <a:pt x="56" y="176"/>
                      </a:lnTo>
                      <a:lnTo>
                        <a:pt x="58" y="160"/>
                      </a:lnTo>
                      <a:lnTo>
                        <a:pt x="60" y="172"/>
                      </a:lnTo>
                      <a:lnTo>
                        <a:pt x="62" y="182"/>
                      </a:lnTo>
                      <a:lnTo>
                        <a:pt x="64" y="188"/>
                      </a:lnTo>
                      <a:lnTo>
                        <a:pt x="66" y="204"/>
                      </a:lnTo>
                      <a:lnTo>
                        <a:pt x="68" y="228"/>
                      </a:lnTo>
                      <a:lnTo>
                        <a:pt x="70" y="238"/>
                      </a:lnTo>
                      <a:lnTo>
                        <a:pt x="72" y="234"/>
                      </a:lnTo>
                      <a:lnTo>
                        <a:pt x="74" y="234"/>
                      </a:lnTo>
                      <a:lnTo>
                        <a:pt x="76" y="250"/>
                      </a:lnTo>
                      <a:lnTo>
                        <a:pt x="78" y="262"/>
                      </a:lnTo>
                      <a:lnTo>
                        <a:pt x="80" y="268"/>
                      </a:lnTo>
                      <a:lnTo>
                        <a:pt x="82" y="274"/>
                      </a:lnTo>
                      <a:lnTo>
                        <a:pt x="84" y="284"/>
                      </a:lnTo>
                      <a:lnTo>
                        <a:pt x="86" y="286"/>
                      </a:lnTo>
                      <a:lnTo>
                        <a:pt x="88" y="278"/>
                      </a:lnTo>
                      <a:lnTo>
                        <a:pt x="90" y="282"/>
                      </a:lnTo>
                      <a:lnTo>
                        <a:pt x="92" y="300"/>
                      </a:lnTo>
                      <a:lnTo>
                        <a:pt x="94" y="310"/>
                      </a:lnTo>
                      <a:lnTo>
                        <a:pt x="96" y="318"/>
                      </a:lnTo>
                      <a:lnTo>
                        <a:pt x="98" y="334"/>
                      </a:lnTo>
                      <a:lnTo>
                        <a:pt x="100" y="346"/>
                      </a:lnTo>
                      <a:lnTo>
                        <a:pt x="102" y="348"/>
                      </a:lnTo>
                      <a:lnTo>
                        <a:pt x="104" y="354"/>
                      </a:lnTo>
                      <a:lnTo>
                        <a:pt x="106" y="364"/>
                      </a:lnTo>
                      <a:lnTo>
                        <a:pt x="108" y="378"/>
                      </a:lnTo>
                      <a:lnTo>
                        <a:pt x="110" y="388"/>
                      </a:lnTo>
                      <a:lnTo>
                        <a:pt x="112" y="386"/>
                      </a:lnTo>
                      <a:lnTo>
                        <a:pt x="114" y="384"/>
                      </a:lnTo>
                      <a:lnTo>
                        <a:pt x="116" y="384"/>
                      </a:lnTo>
                      <a:lnTo>
                        <a:pt x="118" y="386"/>
                      </a:lnTo>
                      <a:lnTo>
                        <a:pt x="120" y="386"/>
                      </a:lnTo>
                      <a:lnTo>
                        <a:pt x="122" y="392"/>
                      </a:lnTo>
                      <a:lnTo>
                        <a:pt x="124" y="404"/>
                      </a:lnTo>
                      <a:lnTo>
                        <a:pt x="126" y="412"/>
                      </a:lnTo>
                      <a:lnTo>
                        <a:pt x="128" y="416"/>
                      </a:lnTo>
                      <a:lnTo>
                        <a:pt x="130" y="420"/>
                      </a:lnTo>
                      <a:lnTo>
                        <a:pt x="132" y="422"/>
                      </a:lnTo>
                      <a:lnTo>
                        <a:pt x="134" y="426"/>
                      </a:lnTo>
                      <a:lnTo>
                        <a:pt x="136" y="430"/>
                      </a:lnTo>
                      <a:lnTo>
                        <a:pt x="138" y="436"/>
                      </a:lnTo>
                      <a:lnTo>
                        <a:pt x="140" y="442"/>
                      </a:lnTo>
                      <a:lnTo>
                        <a:pt x="142" y="446"/>
                      </a:lnTo>
                      <a:lnTo>
                        <a:pt x="144" y="450"/>
                      </a:lnTo>
                      <a:lnTo>
                        <a:pt x="146" y="454"/>
                      </a:lnTo>
                      <a:lnTo>
                        <a:pt x="148" y="458"/>
                      </a:lnTo>
                      <a:lnTo>
                        <a:pt x="150" y="462"/>
                      </a:lnTo>
                      <a:lnTo>
                        <a:pt x="152" y="466"/>
                      </a:lnTo>
                      <a:lnTo>
                        <a:pt x="154" y="468"/>
                      </a:lnTo>
                      <a:lnTo>
                        <a:pt x="156" y="472"/>
                      </a:lnTo>
                      <a:lnTo>
                        <a:pt x="158" y="474"/>
                      </a:lnTo>
                      <a:lnTo>
                        <a:pt x="160" y="476"/>
                      </a:lnTo>
                      <a:lnTo>
                        <a:pt x="162" y="478"/>
                      </a:lnTo>
                      <a:lnTo>
                        <a:pt x="164" y="478"/>
                      </a:lnTo>
                      <a:lnTo>
                        <a:pt x="166" y="480"/>
                      </a:lnTo>
                      <a:lnTo>
                        <a:pt x="168" y="480"/>
                      </a:lnTo>
                      <a:lnTo>
                        <a:pt x="170" y="480"/>
                      </a:lnTo>
                      <a:lnTo>
                        <a:pt x="172" y="480"/>
                      </a:lnTo>
                      <a:lnTo>
                        <a:pt x="174" y="482"/>
                      </a:lnTo>
                      <a:lnTo>
                        <a:pt x="176" y="482"/>
                      </a:lnTo>
                      <a:lnTo>
                        <a:pt x="178" y="482"/>
                      </a:lnTo>
                      <a:lnTo>
                        <a:pt x="180" y="482"/>
                      </a:lnTo>
                      <a:lnTo>
                        <a:pt x="182" y="484"/>
                      </a:lnTo>
                      <a:lnTo>
                        <a:pt x="184" y="484"/>
                      </a:lnTo>
                      <a:lnTo>
                        <a:pt x="186" y="484"/>
                      </a:lnTo>
                      <a:lnTo>
                        <a:pt x="188" y="484"/>
                      </a:lnTo>
                      <a:lnTo>
                        <a:pt x="190" y="484"/>
                      </a:lnTo>
                      <a:lnTo>
                        <a:pt x="192" y="484"/>
                      </a:lnTo>
                      <a:lnTo>
                        <a:pt x="194" y="484"/>
                      </a:lnTo>
                      <a:lnTo>
                        <a:pt x="196" y="484"/>
                      </a:lnTo>
                      <a:lnTo>
                        <a:pt x="198" y="484"/>
                      </a:lnTo>
                      <a:lnTo>
                        <a:pt x="200" y="484"/>
                      </a:lnTo>
                      <a:lnTo>
                        <a:pt x="202" y="484"/>
                      </a:lnTo>
                      <a:lnTo>
                        <a:pt x="204" y="484"/>
                      </a:lnTo>
                      <a:lnTo>
                        <a:pt x="206" y="484"/>
                      </a:lnTo>
                      <a:lnTo>
                        <a:pt x="208" y="484"/>
                      </a:lnTo>
                      <a:lnTo>
                        <a:pt x="210" y="484"/>
                      </a:lnTo>
                      <a:lnTo>
                        <a:pt x="212" y="484"/>
                      </a:lnTo>
                      <a:lnTo>
                        <a:pt x="214" y="484"/>
                      </a:lnTo>
                      <a:lnTo>
                        <a:pt x="216" y="484"/>
                      </a:lnTo>
                      <a:lnTo>
                        <a:pt x="218" y="486"/>
                      </a:lnTo>
                      <a:lnTo>
                        <a:pt x="220" y="486"/>
                      </a:lnTo>
                      <a:lnTo>
                        <a:pt x="222" y="486"/>
                      </a:lnTo>
                      <a:lnTo>
                        <a:pt x="224" y="486"/>
                      </a:lnTo>
                      <a:lnTo>
                        <a:pt x="226" y="486"/>
                      </a:lnTo>
                      <a:lnTo>
                        <a:pt x="228" y="486"/>
                      </a:lnTo>
                      <a:lnTo>
                        <a:pt x="230" y="486"/>
                      </a:lnTo>
                      <a:lnTo>
                        <a:pt x="232" y="486"/>
                      </a:lnTo>
                      <a:lnTo>
                        <a:pt x="234" y="486"/>
                      </a:lnTo>
                      <a:lnTo>
                        <a:pt x="236" y="484"/>
                      </a:lnTo>
                      <a:lnTo>
                        <a:pt x="238" y="484"/>
                      </a:lnTo>
                      <a:lnTo>
                        <a:pt x="240" y="484"/>
                      </a:lnTo>
                      <a:lnTo>
                        <a:pt x="242" y="484"/>
                      </a:lnTo>
                      <a:lnTo>
                        <a:pt x="244" y="484"/>
                      </a:lnTo>
                      <a:lnTo>
                        <a:pt x="246" y="484"/>
                      </a:lnTo>
                      <a:lnTo>
                        <a:pt x="248" y="484"/>
                      </a:lnTo>
                      <a:lnTo>
                        <a:pt x="250" y="484"/>
                      </a:lnTo>
                      <a:lnTo>
                        <a:pt x="252" y="484"/>
                      </a:lnTo>
                      <a:lnTo>
                        <a:pt x="254" y="484"/>
                      </a:lnTo>
                      <a:lnTo>
                        <a:pt x="256" y="484"/>
                      </a:lnTo>
                      <a:lnTo>
                        <a:pt x="258" y="484"/>
                      </a:lnTo>
                      <a:lnTo>
                        <a:pt x="260" y="484"/>
                      </a:lnTo>
                      <a:lnTo>
                        <a:pt x="262" y="484"/>
                      </a:lnTo>
                      <a:lnTo>
                        <a:pt x="264" y="484"/>
                      </a:lnTo>
                      <a:lnTo>
                        <a:pt x="266" y="484"/>
                      </a:lnTo>
                      <a:lnTo>
                        <a:pt x="268" y="484"/>
                      </a:lnTo>
                      <a:lnTo>
                        <a:pt x="270" y="484"/>
                      </a:lnTo>
                      <a:lnTo>
                        <a:pt x="272" y="484"/>
                      </a:lnTo>
                      <a:lnTo>
                        <a:pt x="274" y="486"/>
                      </a:lnTo>
                      <a:lnTo>
                        <a:pt x="276" y="486"/>
                      </a:lnTo>
                      <a:lnTo>
                        <a:pt x="278" y="486"/>
                      </a:lnTo>
                      <a:lnTo>
                        <a:pt x="280" y="486"/>
                      </a:lnTo>
                      <a:lnTo>
                        <a:pt x="282" y="486"/>
                      </a:lnTo>
                      <a:lnTo>
                        <a:pt x="284" y="486"/>
                      </a:lnTo>
                      <a:lnTo>
                        <a:pt x="286" y="486"/>
                      </a:lnTo>
                      <a:lnTo>
                        <a:pt x="288" y="486"/>
                      </a:lnTo>
                      <a:lnTo>
                        <a:pt x="290" y="486"/>
                      </a:lnTo>
                      <a:lnTo>
                        <a:pt x="292" y="486"/>
                      </a:lnTo>
                      <a:lnTo>
                        <a:pt x="294" y="486"/>
                      </a:lnTo>
                      <a:lnTo>
                        <a:pt x="296" y="486"/>
                      </a:lnTo>
                      <a:lnTo>
                        <a:pt x="298" y="486"/>
                      </a:lnTo>
                      <a:lnTo>
                        <a:pt x="300" y="486"/>
                      </a:lnTo>
                      <a:lnTo>
                        <a:pt x="302" y="486"/>
                      </a:lnTo>
                      <a:lnTo>
                        <a:pt x="304" y="486"/>
                      </a:lnTo>
                      <a:lnTo>
                        <a:pt x="306" y="486"/>
                      </a:lnTo>
                      <a:lnTo>
                        <a:pt x="308" y="486"/>
                      </a:lnTo>
                      <a:lnTo>
                        <a:pt x="310" y="486"/>
                      </a:lnTo>
                      <a:lnTo>
                        <a:pt x="312" y="486"/>
                      </a:lnTo>
                      <a:lnTo>
                        <a:pt x="314" y="486"/>
                      </a:lnTo>
                      <a:lnTo>
                        <a:pt x="316" y="486"/>
                      </a:lnTo>
                      <a:lnTo>
                        <a:pt x="318" y="486"/>
                      </a:lnTo>
                      <a:lnTo>
                        <a:pt x="320" y="486"/>
                      </a:lnTo>
                      <a:lnTo>
                        <a:pt x="322" y="486"/>
                      </a:lnTo>
                      <a:lnTo>
                        <a:pt x="324" y="486"/>
                      </a:lnTo>
                      <a:lnTo>
                        <a:pt x="326" y="486"/>
                      </a:lnTo>
                      <a:lnTo>
                        <a:pt x="328" y="486"/>
                      </a:lnTo>
                      <a:lnTo>
                        <a:pt x="330" y="486"/>
                      </a:lnTo>
                      <a:lnTo>
                        <a:pt x="332" y="486"/>
                      </a:lnTo>
                      <a:lnTo>
                        <a:pt x="334" y="486"/>
                      </a:lnTo>
                      <a:lnTo>
                        <a:pt x="336" y="486"/>
                      </a:lnTo>
                      <a:lnTo>
                        <a:pt x="338" y="486"/>
                      </a:lnTo>
                      <a:lnTo>
                        <a:pt x="340" y="486"/>
                      </a:lnTo>
                      <a:lnTo>
                        <a:pt x="342" y="486"/>
                      </a:lnTo>
                      <a:lnTo>
                        <a:pt x="344" y="486"/>
                      </a:lnTo>
                      <a:lnTo>
                        <a:pt x="346" y="486"/>
                      </a:lnTo>
                      <a:lnTo>
                        <a:pt x="348" y="486"/>
                      </a:lnTo>
                      <a:lnTo>
                        <a:pt x="350" y="486"/>
                      </a:lnTo>
                      <a:lnTo>
                        <a:pt x="352" y="486"/>
                      </a:lnTo>
                      <a:lnTo>
                        <a:pt x="354" y="486"/>
                      </a:lnTo>
                      <a:lnTo>
                        <a:pt x="356" y="486"/>
                      </a:lnTo>
                      <a:lnTo>
                        <a:pt x="358" y="486"/>
                      </a:lnTo>
                      <a:lnTo>
                        <a:pt x="360" y="486"/>
                      </a:lnTo>
                      <a:lnTo>
                        <a:pt x="362" y="486"/>
                      </a:lnTo>
                      <a:lnTo>
                        <a:pt x="364" y="486"/>
                      </a:lnTo>
                      <a:lnTo>
                        <a:pt x="366" y="486"/>
                      </a:lnTo>
                      <a:lnTo>
                        <a:pt x="368" y="486"/>
                      </a:lnTo>
                      <a:lnTo>
                        <a:pt x="370" y="486"/>
                      </a:lnTo>
                      <a:lnTo>
                        <a:pt x="372" y="486"/>
                      </a:lnTo>
                      <a:lnTo>
                        <a:pt x="374" y="486"/>
                      </a:lnTo>
                      <a:lnTo>
                        <a:pt x="376" y="486"/>
                      </a:lnTo>
                      <a:lnTo>
                        <a:pt x="378" y="486"/>
                      </a:lnTo>
                      <a:lnTo>
                        <a:pt x="380" y="486"/>
                      </a:lnTo>
                      <a:lnTo>
                        <a:pt x="382" y="486"/>
                      </a:lnTo>
                      <a:lnTo>
                        <a:pt x="384" y="486"/>
                      </a:lnTo>
                      <a:lnTo>
                        <a:pt x="386" y="486"/>
                      </a:lnTo>
                      <a:lnTo>
                        <a:pt x="388" y="486"/>
                      </a:lnTo>
                      <a:lnTo>
                        <a:pt x="390" y="486"/>
                      </a:lnTo>
                      <a:lnTo>
                        <a:pt x="392" y="486"/>
                      </a:lnTo>
                      <a:lnTo>
                        <a:pt x="394" y="486"/>
                      </a:lnTo>
                      <a:lnTo>
                        <a:pt x="396" y="486"/>
                      </a:lnTo>
                      <a:lnTo>
                        <a:pt x="398" y="486"/>
                      </a:lnTo>
                      <a:lnTo>
                        <a:pt x="400" y="486"/>
                      </a:lnTo>
                      <a:lnTo>
                        <a:pt x="402" y="486"/>
                      </a:lnTo>
                      <a:lnTo>
                        <a:pt x="404" y="486"/>
                      </a:lnTo>
                      <a:lnTo>
                        <a:pt x="406" y="486"/>
                      </a:lnTo>
                      <a:lnTo>
                        <a:pt x="408" y="486"/>
                      </a:lnTo>
                      <a:lnTo>
                        <a:pt x="410" y="486"/>
                      </a:lnTo>
                      <a:lnTo>
                        <a:pt x="412" y="486"/>
                      </a:lnTo>
                      <a:lnTo>
                        <a:pt x="414" y="486"/>
                      </a:lnTo>
                      <a:lnTo>
                        <a:pt x="416" y="486"/>
                      </a:lnTo>
                      <a:lnTo>
                        <a:pt x="418" y="486"/>
                      </a:lnTo>
                      <a:lnTo>
                        <a:pt x="420" y="486"/>
                      </a:lnTo>
                      <a:lnTo>
                        <a:pt x="422" y="486"/>
                      </a:lnTo>
                      <a:lnTo>
                        <a:pt x="424" y="486"/>
                      </a:lnTo>
                      <a:lnTo>
                        <a:pt x="426" y="486"/>
                      </a:lnTo>
                      <a:lnTo>
                        <a:pt x="428" y="486"/>
                      </a:lnTo>
                      <a:lnTo>
                        <a:pt x="430" y="486"/>
                      </a:lnTo>
                      <a:lnTo>
                        <a:pt x="432" y="486"/>
                      </a:lnTo>
                      <a:lnTo>
                        <a:pt x="434" y="486"/>
                      </a:lnTo>
                      <a:lnTo>
                        <a:pt x="436" y="486"/>
                      </a:lnTo>
                      <a:lnTo>
                        <a:pt x="438" y="486"/>
                      </a:lnTo>
                      <a:lnTo>
                        <a:pt x="440" y="486"/>
                      </a:lnTo>
                      <a:lnTo>
                        <a:pt x="442" y="486"/>
                      </a:lnTo>
                      <a:lnTo>
                        <a:pt x="444" y="486"/>
                      </a:lnTo>
                      <a:lnTo>
                        <a:pt x="446" y="486"/>
                      </a:lnTo>
                      <a:lnTo>
                        <a:pt x="448" y="486"/>
                      </a:lnTo>
                      <a:lnTo>
                        <a:pt x="450" y="486"/>
                      </a:lnTo>
                      <a:lnTo>
                        <a:pt x="452" y="486"/>
                      </a:lnTo>
                      <a:lnTo>
                        <a:pt x="454" y="486"/>
                      </a:lnTo>
                      <a:lnTo>
                        <a:pt x="456" y="486"/>
                      </a:lnTo>
                      <a:lnTo>
                        <a:pt x="458" y="486"/>
                      </a:lnTo>
                      <a:lnTo>
                        <a:pt x="460" y="486"/>
                      </a:lnTo>
                      <a:lnTo>
                        <a:pt x="462" y="486"/>
                      </a:lnTo>
                      <a:lnTo>
                        <a:pt x="464" y="486"/>
                      </a:lnTo>
                      <a:lnTo>
                        <a:pt x="466" y="486"/>
                      </a:lnTo>
                      <a:lnTo>
                        <a:pt x="468" y="486"/>
                      </a:lnTo>
                      <a:lnTo>
                        <a:pt x="470" y="486"/>
                      </a:lnTo>
                      <a:lnTo>
                        <a:pt x="472" y="486"/>
                      </a:lnTo>
                      <a:lnTo>
                        <a:pt x="474" y="486"/>
                      </a:lnTo>
                      <a:lnTo>
                        <a:pt x="476" y="486"/>
                      </a:lnTo>
                      <a:lnTo>
                        <a:pt x="478" y="486"/>
                      </a:lnTo>
                      <a:lnTo>
                        <a:pt x="480" y="486"/>
                      </a:lnTo>
                      <a:lnTo>
                        <a:pt x="482" y="486"/>
                      </a:lnTo>
                      <a:lnTo>
                        <a:pt x="484" y="486"/>
                      </a:lnTo>
                      <a:lnTo>
                        <a:pt x="486" y="486"/>
                      </a:lnTo>
                      <a:lnTo>
                        <a:pt x="488" y="486"/>
                      </a:lnTo>
                      <a:lnTo>
                        <a:pt x="490" y="486"/>
                      </a:lnTo>
                      <a:lnTo>
                        <a:pt x="492" y="486"/>
                      </a:lnTo>
                      <a:lnTo>
                        <a:pt x="494" y="486"/>
                      </a:lnTo>
                      <a:lnTo>
                        <a:pt x="496" y="486"/>
                      </a:lnTo>
                      <a:lnTo>
                        <a:pt x="498" y="486"/>
                      </a:lnTo>
                      <a:lnTo>
                        <a:pt x="500" y="486"/>
                      </a:lnTo>
                      <a:lnTo>
                        <a:pt x="502" y="486"/>
                      </a:lnTo>
                      <a:lnTo>
                        <a:pt x="504" y="486"/>
                      </a:lnTo>
                      <a:lnTo>
                        <a:pt x="506" y="486"/>
                      </a:lnTo>
                      <a:lnTo>
                        <a:pt x="508" y="486"/>
                      </a:lnTo>
                    </a:path>
                  </a:pathLst>
                </a:custGeom>
                <a:noFill/>
                <a:ln w="6480">
                  <a:solidFill>
                    <a:srgbClr val="b3b3b3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90" name="Freeform 189"/>
              <p:cNvSpPr/>
              <p:nvPr/>
            </p:nvSpPr>
            <p:spPr>
              <a:xfrm>
                <a:off x="4162320" y="3638520"/>
                <a:ext cx="1147320" cy="868320"/>
              </a:xfrm>
              <a:custGeom>
                <a:avLst/>
                <a:gdLst>
                  <a:gd name="textAreaLeft" fmla="*/ 0 w 1147320"/>
                  <a:gd name="textAreaRight" fmla="*/ 1147680 w 1147320"/>
                  <a:gd name="textAreaTop" fmla="*/ 0 h 868320"/>
                  <a:gd name="textAreaBottom" fmla="*/ 868680 h 86832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0" y="484"/>
                    </a:lnTo>
                    <a:lnTo>
                      <a:pt x="2" y="484"/>
                    </a:lnTo>
                    <a:lnTo>
                      <a:pt x="4" y="484"/>
                    </a:lnTo>
                    <a:lnTo>
                      <a:pt x="6" y="484"/>
                    </a:lnTo>
                    <a:lnTo>
                      <a:pt x="8" y="484"/>
                    </a:lnTo>
                    <a:lnTo>
                      <a:pt x="10" y="484"/>
                    </a:lnTo>
                    <a:lnTo>
                      <a:pt x="12" y="484"/>
                    </a:lnTo>
                    <a:lnTo>
                      <a:pt x="14" y="484"/>
                    </a:lnTo>
                    <a:lnTo>
                      <a:pt x="16" y="484"/>
                    </a:lnTo>
                    <a:lnTo>
                      <a:pt x="18" y="484"/>
                    </a:lnTo>
                    <a:lnTo>
                      <a:pt x="20" y="484"/>
                    </a:lnTo>
                    <a:lnTo>
                      <a:pt x="22" y="484"/>
                    </a:lnTo>
                    <a:lnTo>
                      <a:pt x="24" y="484"/>
                    </a:lnTo>
                    <a:lnTo>
                      <a:pt x="26" y="482"/>
                    </a:lnTo>
                    <a:lnTo>
                      <a:pt x="28" y="482"/>
                    </a:lnTo>
                    <a:lnTo>
                      <a:pt x="30" y="482"/>
                    </a:lnTo>
                    <a:lnTo>
                      <a:pt x="32" y="482"/>
                    </a:lnTo>
                    <a:lnTo>
                      <a:pt x="34" y="482"/>
                    </a:lnTo>
                    <a:lnTo>
                      <a:pt x="36" y="482"/>
                    </a:lnTo>
                    <a:lnTo>
                      <a:pt x="38" y="482"/>
                    </a:lnTo>
                    <a:lnTo>
                      <a:pt x="40" y="484"/>
                    </a:lnTo>
                    <a:lnTo>
                      <a:pt x="42" y="484"/>
                    </a:lnTo>
                    <a:lnTo>
                      <a:pt x="44" y="484"/>
                    </a:lnTo>
                    <a:lnTo>
                      <a:pt x="46" y="484"/>
                    </a:lnTo>
                    <a:lnTo>
                      <a:pt x="48" y="484"/>
                    </a:lnTo>
                    <a:lnTo>
                      <a:pt x="50" y="484"/>
                    </a:lnTo>
                    <a:lnTo>
                      <a:pt x="52" y="484"/>
                    </a:lnTo>
                    <a:lnTo>
                      <a:pt x="54" y="484"/>
                    </a:lnTo>
                    <a:lnTo>
                      <a:pt x="56" y="484"/>
                    </a:lnTo>
                    <a:lnTo>
                      <a:pt x="58" y="484"/>
                    </a:lnTo>
                    <a:lnTo>
                      <a:pt x="60" y="484"/>
                    </a:lnTo>
                    <a:lnTo>
                      <a:pt x="62" y="484"/>
                    </a:lnTo>
                    <a:lnTo>
                      <a:pt x="64" y="484"/>
                    </a:lnTo>
                    <a:lnTo>
                      <a:pt x="66" y="484"/>
                    </a:lnTo>
                    <a:lnTo>
                      <a:pt x="68" y="484"/>
                    </a:lnTo>
                    <a:lnTo>
                      <a:pt x="70" y="484"/>
                    </a:lnTo>
                    <a:lnTo>
                      <a:pt x="72" y="484"/>
                    </a:lnTo>
                    <a:lnTo>
                      <a:pt x="74" y="484"/>
                    </a:lnTo>
                    <a:lnTo>
                      <a:pt x="76" y="484"/>
                    </a:lnTo>
                    <a:lnTo>
                      <a:pt x="78" y="484"/>
                    </a:lnTo>
                    <a:lnTo>
                      <a:pt x="80" y="484"/>
                    </a:lnTo>
                    <a:lnTo>
                      <a:pt x="82" y="484"/>
                    </a:lnTo>
                    <a:lnTo>
                      <a:pt x="84" y="484"/>
                    </a:lnTo>
                    <a:lnTo>
                      <a:pt x="86" y="484"/>
                    </a:lnTo>
                    <a:lnTo>
                      <a:pt x="88" y="484"/>
                    </a:lnTo>
                    <a:lnTo>
                      <a:pt x="90" y="484"/>
                    </a:lnTo>
                    <a:lnTo>
                      <a:pt x="92" y="484"/>
                    </a:lnTo>
                    <a:lnTo>
                      <a:pt x="94" y="484"/>
                    </a:lnTo>
                    <a:lnTo>
                      <a:pt x="96" y="484"/>
                    </a:lnTo>
                    <a:lnTo>
                      <a:pt x="98" y="484"/>
                    </a:lnTo>
                    <a:lnTo>
                      <a:pt x="100" y="484"/>
                    </a:lnTo>
                    <a:lnTo>
                      <a:pt x="102" y="484"/>
                    </a:lnTo>
                    <a:lnTo>
                      <a:pt x="104" y="484"/>
                    </a:lnTo>
                    <a:lnTo>
                      <a:pt x="106" y="484"/>
                    </a:lnTo>
                    <a:lnTo>
                      <a:pt x="108" y="484"/>
                    </a:lnTo>
                    <a:lnTo>
                      <a:pt x="110" y="484"/>
                    </a:lnTo>
                    <a:lnTo>
                      <a:pt x="112" y="484"/>
                    </a:lnTo>
                    <a:lnTo>
                      <a:pt x="114" y="484"/>
                    </a:lnTo>
                    <a:lnTo>
                      <a:pt x="116" y="484"/>
                    </a:lnTo>
                    <a:lnTo>
                      <a:pt x="118" y="484"/>
                    </a:lnTo>
                    <a:lnTo>
                      <a:pt x="120" y="484"/>
                    </a:lnTo>
                    <a:lnTo>
                      <a:pt x="122" y="484"/>
                    </a:lnTo>
                    <a:lnTo>
                      <a:pt x="124" y="484"/>
                    </a:lnTo>
                    <a:lnTo>
                      <a:pt x="126" y="484"/>
                    </a:lnTo>
                    <a:lnTo>
                      <a:pt x="128" y="484"/>
                    </a:lnTo>
                    <a:lnTo>
                      <a:pt x="130" y="484"/>
                    </a:lnTo>
                    <a:lnTo>
                      <a:pt x="132" y="482"/>
                    </a:lnTo>
                    <a:lnTo>
                      <a:pt x="134" y="482"/>
                    </a:lnTo>
                    <a:lnTo>
                      <a:pt x="136" y="482"/>
                    </a:lnTo>
                    <a:lnTo>
                      <a:pt x="138" y="482"/>
                    </a:lnTo>
                    <a:lnTo>
                      <a:pt x="140" y="482"/>
                    </a:lnTo>
                    <a:lnTo>
                      <a:pt x="142" y="482"/>
                    </a:lnTo>
                    <a:lnTo>
                      <a:pt x="144" y="482"/>
                    </a:lnTo>
                    <a:lnTo>
                      <a:pt x="146" y="482"/>
                    </a:lnTo>
                    <a:lnTo>
                      <a:pt x="148" y="482"/>
                    </a:lnTo>
                    <a:lnTo>
                      <a:pt x="150" y="482"/>
                    </a:lnTo>
                    <a:lnTo>
                      <a:pt x="152" y="482"/>
                    </a:lnTo>
                    <a:lnTo>
                      <a:pt x="154" y="482"/>
                    </a:lnTo>
                    <a:lnTo>
                      <a:pt x="156" y="482"/>
                    </a:lnTo>
                    <a:lnTo>
                      <a:pt x="158" y="482"/>
                    </a:lnTo>
                    <a:lnTo>
                      <a:pt x="160" y="484"/>
                    </a:lnTo>
                    <a:lnTo>
                      <a:pt x="162" y="484"/>
                    </a:lnTo>
                    <a:lnTo>
                      <a:pt x="164" y="484"/>
                    </a:lnTo>
                    <a:lnTo>
                      <a:pt x="166" y="484"/>
                    </a:lnTo>
                    <a:lnTo>
                      <a:pt x="168" y="484"/>
                    </a:lnTo>
                    <a:lnTo>
                      <a:pt x="170" y="484"/>
                    </a:lnTo>
                    <a:lnTo>
                      <a:pt x="172" y="484"/>
                    </a:lnTo>
                    <a:lnTo>
                      <a:pt x="174" y="484"/>
                    </a:lnTo>
                    <a:lnTo>
                      <a:pt x="176" y="484"/>
                    </a:lnTo>
                    <a:lnTo>
                      <a:pt x="178" y="484"/>
                    </a:lnTo>
                    <a:lnTo>
                      <a:pt x="180" y="484"/>
                    </a:lnTo>
                    <a:lnTo>
                      <a:pt x="182" y="484"/>
                    </a:lnTo>
                    <a:lnTo>
                      <a:pt x="184" y="484"/>
                    </a:lnTo>
                    <a:lnTo>
                      <a:pt x="186" y="482"/>
                    </a:lnTo>
                    <a:lnTo>
                      <a:pt x="188" y="482"/>
                    </a:lnTo>
                    <a:lnTo>
                      <a:pt x="190" y="482"/>
                    </a:lnTo>
                    <a:lnTo>
                      <a:pt x="192" y="482"/>
                    </a:lnTo>
                    <a:lnTo>
                      <a:pt x="194" y="480"/>
                    </a:lnTo>
                    <a:lnTo>
                      <a:pt x="196" y="480"/>
                    </a:lnTo>
                    <a:lnTo>
                      <a:pt x="198" y="478"/>
                    </a:lnTo>
                    <a:lnTo>
                      <a:pt x="200" y="478"/>
                    </a:lnTo>
                    <a:lnTo>
                      <a:pt x="202" y="476"/>
                    </a:lnTo>
                    <a:lnTo>
                      <a:pt x="204" y="474"/>
                    </a:lnTo>
                    <a:lnTo>
                      <a:pt x="206" y="470"/>
                    </a:lnTo>
                    <a:lnTo>
                      <a:pt x="208" y="466"/>
                    </a:lnTo>
                    <a:lnTo>
                      <a:pt x="210" y="462"/>
                    </a:lnTo>
                    <a:lnTo>
                      <a:pt x="212" y="456"/>
                    </a:lnTo>
                    <a:lnTo>
                      <a:pt x="214" y="450"/>
                    </a:lnTo>
                    <a:lnTo>
                      <a:pt x="216" y="442"/>
                    </a:lnTo>
                    <a:lnTo>
                      <a:pt x="218" y="432"/>
                    </a:lnTo>
                    <a:lnTo>
                      <a:pt x="220" y="422"/>
                    </a:lnTo>
                    <a:lnTo>
                      <a:pt x="222" y="412"/>
                    </a:lnTo>
                    <a:lnTo>
                      <a:pt x="224" y="400"/>
                    </a:lnTo>
                    <a:lnTo>
                      <a:pt x="226" y="382"/>
                    </a:lnTo>
                    <a:lnTo>
                      <a:pt x="228" y="356"/>
                    </a:lnTo>
                    <a:lnTo>
                      <a:pt x="230" y="322"/>
                    </a:lnTo>
                    <a:lnTo>
                      <a:pt x="232" y="288"/>
                    </a:lnTo>
                    <a:lnTo>
                      <a:pt x="234" y="252"/>
                    </a:lnTo>
                    <a:lnTo>
                      <a:pt x="236" y="208"/>
                    </a:lnTo>
                    <a:lnTo>
                      <a:pt x="238" y="188"/>
                    </a:lnTo>
                    <a:lnTo>
                      <a:pt x="240" y="190"/>
                    </a:lnTo>
                    <a:lnTo>
                      <a:pt x="242" y="158"/>
                    </a:lnTo>
                    <a:lnTo>
                      <a:pt x="244" y="112"/>
                    </a:lnTo>
                    <a:lnTo>
                      <a:pt x="246" y="82"/>
                    </a:lnTo>
                    <a:lnTo>
                      <a:pt x="248" y="66"/>
                    </a:lnTo>
                    <a:lnTo>
                      <a:pt x="250" y="56"/>
                    </a:lnTo>
                    <a:lnTo>
                      <a:pt x="252" y="44"/>
                    </a:lnTo>
                    <a:lnTo>
                      <a:pt x="254" y="28"/>
                    </a:lnTo>
                    <a:lnTo>
                      <a:pt x="256" y="10"/>
                    </a:lnTo>
                    <a:lnTo>
                      <a:pt x="258" y="0"/>
                    </a:lnTo>
                    <a:lnTo>
                      <a:pt x="260" y="4"/>
                    </a:lnTo>
                    <a:lnTo>
                      <a:pt x="262" y="14"/>
                    </a:lnTo>
                    <a:lnTo>
                      <a:pt x="264" y="22"/>
                    </a:lnTo>
                    <a:lnTo>
                      <a:pt x="266" y="46"/>
                    </a:lnTo>
                    <a:lnTo>
                      <a:pt x="268" y="84"/>
                    </a:lnTo>
                    <a:lnTo>
                      <a:pt x="270" y="116"/>
                    </a:lnTo>
                    <a:lnTo>
                      <a:pt x="272" y="148"/>
                    </a:lnTo>
                    <a:lnTo>
                      <a:pt x="274" y="164"/>
                    </a:lnTo>
                    <a:lnTo>
                      <a:pt x="276" y="152"/>
                    </a:lnTo>
                    <a:lnTo>
                      <a:pt x="278" y="176"/>
                    </a:lnTo>
                    <a:lnTo>
                      <a:pt x="280" y="224"/>
                    </a:lnTo>
                    <a:lnTo>
                      <a:pt x="282" y="252"/>
                    </a:lnTo>
                    <a:lnTo>
                      <a:pt x="284" y="274"/>
                    </a:lnTo>
                    <a:lnTo>
                      <a:pt x="286" y="300"/>
                    </a:lnTo>
                    <a:lnTo>
                      <a:pt x="288" y="316"/>
                    </a:lnTo>
                    <a:lnTo>
                      <a:pt x="290" y="328"/>
                    </a:lnTo>
                    <a:lnTo>
                      <a:pt x="292" y="348"/>
                    </a:lnTo>
                    <a:lnTo>
                      <a:pt x="294" y="374"/>
                    </a:lnTo>
                    <a:lnTo>
                      <a:pt x="296" y="392"/>
                    </a:lnTo>
                    <a:lnTo>
                      <a:pt x="298" y="406"/>
                    </a:lnTo>
                    <a:lnTo>
                      <a:pt x="300" y="418"/>
                    </a:lnTo>
                    <a:lnTo>
                      <a:pt x="302" y="428"/>
                    </a:lnTo>
                    <a:lnTo>
                      <a:pt x="304" y="436"/>
                    </a:lnTo>
                    <a:lnTo>
                      <a:pt x="306" y="440"/>
                    </a:lnTo>
                    <a:lnTo>
                      <a:pt x="308" y="444"/>
                    </a:lnTo>
                    <a:lnTo>
                      <a:pt x="310" y="448"/>
                    </a:lnTo>
                    <a:lnTo>
                      <a:pt x="312" y="452"/>
                    </a:lnTo>
                    <a:lnTo>
                      <a:pt x="314" y="456"/>
                    </a:lnTo>
                    <a:lnTo>
                      <a:pt x="316" y="460"/>
                    </a:lnTo>
                    <a:lnTo>
                      <a:pt x="318" y="460"/>
                    </a:lnTo>
                    <a:lnTo>
                      <a:pt x="320" y="462"/>
                    </a:lnTo>
                    <a:lnTo>
                      <a:pt x="322" y="464"/>
                    </a:lnTo>
                    <a:lnTo>
                      <a:pt x="324" y="466"/>
                    </a:lnTo>
                    <a:lnTo>
                      <a:pt x="326" y="470"/>
                    </a:lnTo>
                    <a:lnTo>
                      <a:pt x="328" y="472"/>
                    </a:lnTo>
                    <a:lnTo>
                      <a:pt x="330" y="472"/>
                    </a:lnTo>
                    <a:lnTo>
                      <a:pt x="332" y="474"/>
                    </a:lnTo>
                    <a:lnTo>
                      <a:pt x="334" y="474"/>
                    </a:lnTo>
                    <a:lnTo>
                      <a:pt x="336" y="474"/>
                    </a:lnTo>
                    <a:lnTo>
                      <a:pt x="338" y="476"/>
                    </a:lnTo>
                    <a:lnTo>
                      <a:pt x="340" y="476"/>
                    </a:lnTo>
                    <a:lnTo>
                      <a:pt x="342" y="478"/>
                    </a:lnTo>
                    <a:lnTo>
                      <a:pt x="344" y="480"/>
                    </a:lnTo>
                    <a:lnTo>
                      <a:pt x="346" y="480"/>
                    </a:lnTo>
                    <a:lnTo>
                      <a:pt x="348" y="482"/>
                    </a:lnTo>
                    <a:lnTo>
                      <a:pt x="350" y="482"/>
                    </a:lnTo>
                    <a:lnTo>
                      <a:pt x="352" y="484"/>
                    </a:lnTo>
                    <a:lnTo>
                      <a:pt x="354" y="484"/>
                    </a:lnTo>
                    <a:lnTo>
                      <a:pt x="356" y="484"/>
                    </a:lnTo>
                    <a:lnTo>
                      <a:pt x="358" y="484"/>
                    </a:lnTo>
                    <a:lnTo>
                      <a:pt x="360" y="484"/>
                    </a:lnTo>
                    <a:lnTo>
                      <a:pt x="362" y="484"/>
                    </a:lnTo>
                    <a:lnTo>
                      <a:pt x="364" y="484"/>
                    </a:lnTo>
                    <a:lnTo>
                      <a:pt x="366" y="484"/>
                    </a:lnTo>
                    <a:lnTo>
                      <a:pt x="368" y="484"/>
                    </a:lnTo>
                    <a:lnTo>
                      <a:pt x="370" y="484"/>
                    </a:lnTo>
                    <a:lnTo>
                      <a:pt x="372" y="484"/>
                    </a:lnTo>
                    <a:lnTo>
                      <a:pt x="374" y="484"/>
                    </a:lnTo>
                    <a:lnTo>
                      <a:pt x="376" y="484"/>
                    </a:lnTo>
                    <a:lnTo>
                      <a:pt x="378" y="484"/>
                    </a:lnTo>
                    <a:lnTo>
                      <a:pt x="380" y="484"/>
                    </a:lnTo>
                    <a:lnTo>
                      <a:pt x="382" y="484"/>
                    </a:lnTo>
                    <a:lnTo>
                      <a:pt x="384" y="484"/>
                    </a:lnTo>
                    <a:lnTo>
                      <a:pt x="386" y="484"/>
                    </a:lnTo>
                    <a:lnTo>
                      <a:pt x="388" y="486"/>
                    </a:lnTo>
                    <a:lnTo>
                      <a:pt x="390" y="486"/>
                    </a:lnTo>
                    <a:lnTo>
                      <a:pt x="392" y="486"/>
                    </a:lnTo>
                    <a:lnTo>
                      <a:pt x="394" y="486"/>
                    </a:lnTo>
                    <a:lnTo>
                      <a:pt x="396" y="486"/>
                    </a:lnTo>
                    <a:lnTo>
                      <a:pt x="398" y="486"/>
                    </a:lnTo>
                    <a:lnTo>
                      <a:pt x="400" y="486"/>
                    </a:lnTo>
                    <a:lnTo>
                      <a:pt x="402" y="486"/>
                    </a:lnTo>
                    <a:lnTo>
                      <a:pt x="404" y="486"/>
                    </a:lnTo>
                    <a:lnTo>
                      <a:pt x="406" y="486"/>
                    </a:lnTo>
                    <a:lnTo>
                      <a:pt x="408" y="486"/>
                    </a:lnTo>
                    <a:lnTo>
                      <a:pt x="410" y="486"/>
                    </a:lnTo>
                    <a:lnTo>
                      <a:pt x="412" y="486"/>
                    </a:lnTo>
                    <a:lnTo>
                      <a:pt x="414" y="486"/>
                    </a:lnTo>
                    <a:lnTo>
                      <a:pt x="416" y="486"/>
                    </a:lnTo>
                    <a:lnTo>
                      <a:pt x="418" y="486"/>
                    </a:lnTo>
                    <a:lnTo>
                      <a:pt x="420" y="486"/>
                    </a:lnTo>
                    <a:lnTo>
                      <a:pt x="422" y="486"/>
                    </a:lnTo>
                    <a:lnTo>
                      <a:pt x="424" y="486"/>
                    </a:lnTo>
                    <a:lnTo>
                      <a:pt x="426" y="486"/>
                    </a:lnTo>
                    <a:lnTo>
                      <a:pt x="428" y="486"/>
                    </a:lnTo>
                    <a:lnTo>
                      <a:pt x="430" y="486"/>
                    </a:lnTo>
                    <a:lnTo>
                      <a:pt x="432" y="486"/>
                    </a:lnTo>
                    <a:lnTo>
                      <a:pt x="434" y="486"/>
                    </a:lnTo>
                    <a:lnTo>
                      <a:pt x="436" y="486"/>
                    </a:lnTo>
                    <a:lnTo>
                      <a:pt x="438" y="486"/>
                    </a:lnTo>
                    <a:lnTo>
                      <a:pt x="440" y="486"/>
                    </a:lnTo>
                    <a:lnTo>
                      <a:pt x="442" y="486"/>
                    </a:lnTo>
                    <a:lnTo>
                      <a:pt x="444" y="486"/>
                    </a:lnTo>
                    <a:lnTo>
                      <a:pt x="446" y="486"/>
                    </a:lnTo>
                    <a:lnTo>
                      <a:pt x="448" y="486"/>
                    </a:lnTo>
                    <a:lnTo>
                      <a:pt x="450" y="486"/>
                    </a:lnTo>
                    <a:lnTo>
                      <a:pt x="452" y="486"/>
                    </a:lnTo>
                    <a:lnTo>
                      <a:pt x="454" y="486"/>
                    </a:lnTo>
                    <a:lnTo>
                      <a:pt x="456" y="486"/>
                    </a:lnTo>
                    <a:lnTo>
                      <a:pt x="458" y="486"/>
                    </a:lnTo>
                    <a:lnTo>
                      <a:pt x="460" y="486"/>
                    </a:lnTo>
                    <a:lnTo>
                      <a:pt x="462" y="486"/>
                    </a:lnTo>
                    <a:lnTo>
                      <a:pt x="464" y="486"/>
                    </a:lnTo>
                    <a:lnTo>
                      <a:pt x="466" y="486"/>
                    </a:lnTo>
                    <a:lnTo>
                      <a:pt x="468" y="486"/>
                    </a:lnTo>
                    <a:lnTo>
                      <a:pt x="470" y="486"/>
                    </a:lnTo>
                    <a:lnTo>
                      <a:pt x="472" y="486"/>
                    </a:lnTo>
                    <a:lnTo>
                      <a:pt x="474" y="486"/>
                    </a:lnTo>
                    <a:lnTo>
                      <a:pt x="476" y="486"/>
                    </a:lnTo>
                    <a:lnTo>
                      <a:pt x="478" y="486"/>
                    </a:lnTo>
                    <a:lnTo>
                      <a:pt x="480" y="486"/>
                    </a:lnTo>
                    <a:lnTo>
                      <a:pt x="482" y="486"/>
                    </a:lnTo>
                    <a:lnTo>
                      <a:pt x="484" y="486"/>
                    </a:lnTo>
                    <a:lnTo>
                      <a:pt x="486" y="486"/>
                    </a:lnTo>
                    <a:lnTo>
                      <a:pt x="488" y="486"/>
                    </a:lnTo>
                    <a:lnTo>
                      <a:pt x="490" y="486"/>
                    </a:lnTo>
                    <a:lnTo>
                      <a:pt x="492" y="486"/>
                    </a:lnTo>
                    <a:lnTo>
                      <a:pt x="494" y="486"/>
                    </a:lnTo>
                    <a:lnTo>
                      <a:pt x="496" y="486"/>
                    </a:lnTo>
                    <a:lnTo>
                      <a:pt x="498" y="486"/>
                    </a:lnTo>
                    <a:lnTo>
                      <a:pt x="500" y="486"/>
                    </a:lnTo>
                    <a:lnTo>
                      <a:pt x="502" y="486"/>
                    </a:lnTo>
                    <a:lnTo>
                      <a:pt x="504" y="486"/>
                    </a:lnTo>
                    <a:lnTo>
                      <a:pt x="506" y="486"/>
                    </a:lnTo>
                    <a:lnTo>
                      <a:pt x="508" y="486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1" name="Text Box 3836"/>
            <p:cNvSpPr/>
            <p:nvPr/>
          </p:nvSpPr>
          <p:spPr>
            <a:xfrm>
              <a:off x="4708080" y="3570120"/>
              <a:ext cx="671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</a:rPr>
                <a:t>99.3/1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2" name="Text Box 104"/>
          <p:cNvSpPr/>
          <p:nvPr/>
        </p:nvSpPr>
        <p:spPr>
          <a:xfrm>
            <a:off x="3178080" y="2714760"/>
            <a:ext cx="67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8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Text Box 95"/>
          <p:cNvSpPr/>
          <p:nvPr/>
        </p:nvSpPr>
        <p:spPr>
          <a:xfrm>
            <a:off x="512640" y="1521000"/>
            <a:ext cx="928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HLA-D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Text Box 98"/>
          <p:cNvSpPr/>
          <p:nvPr/>
        </p:nvSpPr>
        <p:spPr>
          <a:xfrm>
            <a:off x="655560" y="380700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Text Box 97"/>
          <p:cNvSpPr/>
          <p:nvPr/>
        </p:nvSpPr>
        <p:spPr>
          <a:xfrm>
            <a:off x="396720" y="2664000"/>
            <a:ext cx="1160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HLA class 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Text Box 99"/>
          <p:cNvSpPr/>
          <p:nvPr/>
        </p:nvSpPr>
        <p:spPr>
          <a:xfrm>
            <a:off x="3071880" y="1574640"/>
            <a:ext cx="888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11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Text Box 100"/>
          <p:cNvSpPr/>
          <p:nvPr/>
        </p:nvSpPr>
        <p:spPr>
          <a:xfrm>
            <a:off x="3193920" y="377820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4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Text Box 98"/>
          <p:cNvSpPr/>
          <p:nvPr/>
        </p:nvSpPr>
        <p:spPr>
          <a:xfrm>
            <a:off x="673200" y="508176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1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TextBox 27"/>
          <p:cNvSpPr/>
          <p:nvPr/>
        </p:nvSpPr>
        <p:spPr>
          <a:xfrm>
            <a:off x="239040" y="357120"/>
            <a:ext cx="6365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1: Characterisation of human monocytes derived DCs (moDC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TextBox 554"/>
          <p:cNvSpPr/>
          <p:nvPr/>
        </p:nvSpPr>
        <p:spPr>
          <a:xfrm>
            <a:off x="334800" y="6235560"/>
            <a:ext cx="6143760" cy="160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Monocyte derived DCs were stained for cell surface markers using FITC or PE conjugated mouse anti-human antibodies [i.e. anti-CD1a, -CD11c, -HLA-class I, -CD86 and -CD14 (Caltag Medsystem, Buckingham, UK), -HLA-DR (Sigma,</a:t>
            </a: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St. Louis, USA) and -CD40 (BD Biosciences)]. Samples were analysed using FACSCalibur (Becton Dickinson, Mountain View, CA, USA) and t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he FlowJo software (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Tree Star, Inc. Ashland, OR, USA). The numbers shown in each histograms describe percentage of positive cells and mean fluorescence intensity for given marker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1" name="TextBox 27"/>
          <p:cNvSpPr/>
          <p:nvPr/>
        </p:nvSpPr>
        <p:spPr>
          <a:xfrm>
            <a:off x="219960" y="385920"/>
            <a:ext cx="591228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2: </a:t>
            </a: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Characterisation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of different subsets of human D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Text Box 31"/>
          <p:cNvSpPr/>
          <p:nvPr/>
        </p:nvSpPr>
        <p:spPr>
          <a:xfrm>
            <a:off x="765720" y="1585800"/>
            <a:ext cx="1046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Dermal D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Text Box 32"/>
          <p:cNvSpPr/>
          <p:nvPr/>
        </p:nvSpPr>
        <p:spPr>
          <a:xfrm>
            <a:off x="605520" y="2994120"/>
            <a:ext cx="1430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angerhans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TextBox 5"/>
          <p:cNvSpPr/>
          <p:nvPr/>
        </p:nvSpPr>
        <p:spPr>
          <a:xfrm>
            <a:off x="452520" y="4381560"/>
            <a:ext cx="1514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lasmacytoid D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5" name="Group 582"/>
          <p:cNvGrpSpPr/>
          <p:nvPr/>
        </p:nvGrpSpPr>
        <p:grpSpPr>
          <a:xfrm>
            <a:off x="1928880" y="4052880"/>
            <a:ext cx="1593720" cy="1414800"/>
            <a:chOff x="1928880" y="4052880"/>
            <a:chExt cx="1593720" cy="1414800"/>
          </a:xfrm>
        </p:grpSpPr>
        <p:grpSp>
          <p:nvGrpSpPr>
            <p:cNvPr id="706" name="Group 579"/>
            <p:cNvGrpSpPr/>
            <p:nvPr/>
          </p:nvGrpSpPr>
          <p:grpSpPr>
            <a:xfrm>
              <a:off x="1928880" y="4052880"/>
              <a:ext cx="1530360" cy="1414800"/>
              <a:chOff x="1928880" y="4052880"/>
              <a:chExt cx="1530360" cy="1414800"/>
            </a:xfrm>
          </p:grpSpPr>
          <p:sp>
            <p:nvSpPr>
              <p:cNvPr id="707" name="TextBox 7"/>
              <p:cNvSpPr/>
              <p:nvPr/>
            </p:nvSpPr>
            <p:spPr>
              <a:xfrm rot="16200000">
                <a:off x="1738800" y="4465800"/>
                <a:ext cx="656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</a:rPr>
                  <a:t>CD12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TextBox 9"/>
              <p:cNvSpPr/>
              <p:nvPr/>
            </p:nvSpPr>
            <p:spPr>
              <a:xfrm>
                <a:off x="2080800" y="5191200"/>
                <a:ext cx="1374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</a:rPr>
                  <a:t>CD303 (BDCA-2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709" name="Picture 18" descr=""/>
              <p:cNvPicPr/>
              <p:nvPr/>
            </p:nvPicPr>
            <p:blipFill>
              <a:blip r:embed="rId1"/>
              <a:srcRect l="20840" t="0" r="0" b="20587"/>
              <a:stretch/>
            </p:blipFill>
            <p:spPr>
              <a:xfrm>
                <a:off x="2233440" y="4052880"/>
                <a:ext cx="1225800" cy="11602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710" name="Text Box 49"/>
            <p:cNvSpPr/>
            <p:nvPr/>
          </p:nvSpPr>
          <p:spPr>
            <a:xfrm>
              <a:off x="2836800" y="406728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8.23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1" name="TextBox 5"/>
          <p:cNvSpPr/>
          <p:nvPr/>
        </p:nvSpPr>
        <p:spPr>
          <a:xfrm>
            <a:off x="786960" y="5981760"/>
            <a:ext cx="109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Myeloid D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TextBox 5"/>
          <p:cNvSpPr/>
          <p:nvPr/>
        </p:nvSpPr>
        <p:spPr>
          <a:xfrm>
            <a:off x="3676680" y="4362480"/>
            <a:ext cx="2367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D304+ selection then sorted by CD123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+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D303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+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TextBox 5"/>
          <p:cNvSpPr/>
          <p:nvPr/>
        </p:nvSpPr>
        <p:spPr>
          <a:xfrm>
            <a:off x="3747960" y="6039000"/>
            <a:ext cx="2367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D20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depletion and CD1c positive sele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4" name="Group 581"/>
          <p:cNvGrpSpPr/>
          <p:nvPr/>
        </p:nvGrpSpPr>
        <p:grpSpPr>
          <a:xfrm>
            <a:off x="1919160" y="5582160"/>
            <a:ext cx="1657440" cy="1525320"/>
            <a:chOff x="1919160" y="5582160"/>
            <a:chExt cx="1657440" cy="1525320"/>
          </a:xfrm>
        </p:grpSpPr>
        <p:grpSp>
          <p:nvGrpSpPr>
            <p:cNvPr id="715" name="Group 580"/>
            <p:cNvGrpSpPr/>
            <p:nvPr/>
          </p:nvGrpSpPr>
          <p:grpSpPr>
            <a:xfrm>
              <a:off x="1919160" y="5582160"/>
              <a:ext cx="1523880" cy="1525320"/>
              <a:chOff x="1919160" y="5582160"/>
              <a:chExt cx="1523880" cy="1525320"/>
            </a:xfrm>
          </p:grpSpPr>
          <p:pic>
            <p:nvPicPr>
              <p:cNvPr id="716" name="Picture 22" descr=""/>
              <p:cNvPicPr/>
              <p:nvPr/>
            </p:nvPicPr>
            <p:blipFill>
              <a:blip r:embed="rId2"/>
              <a:srcRect l="19538" t="0" r="0" b="20301"/>
              <a:stretch/>
            </p:blipFill>
            <p:spPr>
              <a:xfrm>
                <a:off x="2223720" y="5657760"/>
                <a:ext cx="1219320" cy="11462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717" name="TextBox 7"/>
              <p:cNvSpPr/>
              <p:nvPr/>
            </p:nvSpPr>
            <p:spPr>
              <a:xfrm rot="16200000">
                <a:off x="1400760" y="6100200"/>
                <a:ext cx="1312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</a:rPr>
                  <a:t>CD1C (BDCA-1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TextBox 9"/>
              <p:cNvSpPr/>
              <p:nvPr/>
            </p:nvSpPr>
            <p:spPr>
              <a:xfrm>
                <a:off x="2422080" y="6831000"/>
                <a:ext cx="485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</a:rPr>
                  <a:t>FS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19" name="Text Box 60"/>
            <p:cNvSpPr/>
            <p:nvPr/>
          </p:nvSpPr>
          <p:spPr>
            <a:xfrm>
              <a:off x="2890800" y="5667480"/>
              <a:ext cx="685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2.8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20" name="TextBox 126"/>
          <p:cNvSpPr/>
          <p:nvPr/>
        </p:nvSpPr>
        <p:spPr>
          <a:xfrm>
            <a:off x="504720" y="7194600"/>
            <a:ext cx="5996160" cy="160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Human DCs prepared from different  tissue compartments were stained for characteristic markers of dermal DCs, Langerhans cells, plamacytoid and myeloid DCs. The following monoclonal mouse anti-human antibodies were used in detection of cell surface marker expression on different subsets of DCs: anti-CD1a (Caltag Medsystem, Buckingham, UK), -CD123 (BD Biosciences), -BDCA-1 and -BDCA-2 (Miltenyi Biotech, Surrey, UK), -DC-Sign and -Langerin (R&amp;D Europe Ltd). Samples were analysed using FACSCalibur (Becton Dickinson, Mountain View, CA, USA) and t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he FlowJo software (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Tree Star, Inc. Ashland, OR, USA). The numbers shown in each histograms describe mean fluorescence intensity and /or percentage of cells positive for given marker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Text Box 28"/>
          <p:cNvSpPr/>
          <p:nvPr/>
        </p:nvSpPr>
        <p:spPr>
          <a:xfrm>
            <a:off x="2335320" y="941400"/>
            <a:ext cx="107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DC-SIG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Text Box 26"/>
          <p:cNvSpPr/>
          <p:nvPr/>
        </p:nvSpPr>
        <p:spPr>
          <a:xfrm>
            <a:off x="5324400" y="939960"/>
            <a:ext cx="838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11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Text Box 27"/>
          <p:cNvSpPr/>
          <p:nvPr/>
        </p:nvSpPr>
        <p:spPr>
          <a:xfrm>
            <a:off x="3975120" y="93996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Text Box 41"/>
          <p:cNvSpPr/>
          <p:nvPr/>
        </p:nvSpPr>
        <p:spPr>
          <a:xfrm>
            <a:off x="3992400" y="2452680"/>
            <a:ext cx="762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D1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Text Box 43"/>
          <p:cNvSpPr/>
          <p:nvPr/>
        </p:nvSpPr>
        <p:spPr>
          <a:xfrm>
            <a:off x="2387520" y="2452680"/>
            <a:ext cx="144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Langer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6" name="Group 217"/>
          <p:cNvGrpSpPr/>
          <p:nvPr/>
        </p:nvGrpSpPr>
        <p:grpSpPr>
          <a:xfrm>
            <a:off x="2128320" y="1257480"/>
            <a:ext cx="1478520" cy="1152360"/>
            <a:chOff x="2128320" y="1257480"/>
            <a:chExt cx="1478520" cy="1152360"/>
          </a:xfrm>
        </p:grpSpPr>
        <p:grpSp>
          <p:nvGrpSpPr>
            <p:cNvPr id="727" name="Group 128"/>
            <p:cNvGrpSpPr/>
            <p:nvPr/>
          </p:nvGrpSpPr>
          <p:grpSpPr>
            <a:xfrm>
              <a:off x="2128320" y="1260360"/>
              <a:ext cx="1216080" cy="1149480"/>
              <a:chOff x="2128320" y="1260360"/>
              <a:chExt cx="1216080" cy="1149480"/>
            </a:xfrm>
          </p:grpSpPr>
          <p:grpSp>
            <p:nvGrpSpPr>
              <p:cNvPr id="728" name="Group 129"/>
              <p:cNvGrpSpPr/>
              <p:nvPr/>
            </p:nvGrpSpPr>
            <p:grpSpPr>
              <a:xfrm>
                <a:off x="2128320" y="1260360"/>
                <a:ext cx="1216080" cy="1149480"/>
                <a:chOff x="2128320" y="1260360"/>
                <a:chExt cx="1216080" cy="1149480"/>
              </a:xfrm>
            </p:grpSpPr>
            <p:sp>
              <p:nvSpPr>
                <p:cNvPr id="729" name="Rectangle 130"/>
                <p:cNvSpPr/>
                <p:nvPr/>
              </p:nvSpPr>
              <p:spPr>
                <a:xfrm>
                  <a:off x="2258280" y="1262160"/>
                  <a:ext cx="1051200" cy="105084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30" name="Group 131"/>
                <p:cNvGrpSpPr/>
                <p:nvPr/>
              </p:nvGrpSpPr>
              <p:grpSpPr>
                <a:xfrm>
                  <a:off x="2214360" y="2311200"/>
                  <a:ext cx="1130040" cy="98640"/>
                  <a:chOff x="2214360" y="2311200"/>
                  <a:chExt cx="1130040" cy="98640"/>
                </a:xfrm>
              </p:grpSpPr>
              <p:sp>
                <p:nvSpPr>
                  <p:cNvPr id="731" name="Line 132"/>
                  <p:cNvSpPr/>
                  <p:nvPr/>
                </p:nvSpPr>
                <p:spPr>
                  <a:xfrm>
                    <a:off x="2256120" y="2311200"/>
                    <a:ext cx="105048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732" name="Group 133"/>
                  <p:cNvGrpSpPr/>
                  <p:nvPr/>
                </p:nvGrpSpPr>
                <p:grpSpPr>
                  <a:xfrm>
                    <a:off x="2256120" y="2315160"/>
                    <a:ext cx="1050120" cy="23760"/>
                    <a:chOff x="2256120" y="2315160"/>
                    <a:chExt cx="1050120" cy="23760"/>
                  </a:xfrm>
                </p:grpSpPr>
                <p:sp>
                  <p:nvSpPr>
                    <p:cNvPr id="733" name="Line 134"/>
                    <p:cNvSpPr/>
                    <p:nvPr/>
                  </p:nvSpPr>
                  <p:spPr>
                    <a:xfrm>
                      <a:off x="2256120" y="231516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4" name="Line 135"/>
                    <p:cNvSpPr/>
                    <p:nvPr/>
                  </p:nvSpPr>
                  <p:spPr>
                    <a:xfrm>
                      <a:off x="233352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5" name="Line 136"/>
                    <p:cNvSpPr/>
                    <p:nvPr/>
                  </p:nvSpPr>
                  <p:spPr>
                    <a:xfrm>
                      <a:off x="23781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6" name="Line 137"/>
                    <p:cNvSpPr/>
                    <p:nvPr/>
                  </p:nvSpPr>
                  <p:spPr>
                    <a:xfrm>
                      <a:off x="24105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7" name="Line 138"/>
                    <p:cNvSpPr/>
                    <p:nvPr/>
                  </p:nvSpPr>
                  <p:spPr>
                    <a:xfrm>
                      <a:off x="2439360" y="231516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8" name="Line 139"/>
                    <p:cNvSpPr/>
                    <p:nvPr/>
                  </p:nvSpPr>
                  <p:spPr>
                    <a:xfrm>
                      <a:off x="245952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39" name="Line 140"/>
                    <p:cNvSpPr/>
                    <p:nvPr/>
                  </p:nvSpPr>
                  <p:spPr>
                    <a:xfrm>
                      <a:off x="247572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0" name="Line 141"/>
                    <p:cNvSpPr/>
                    <p:nvPr/>
                  </p:nvSpPr>
                  <p:spPr>
                    <a:xfrm>
                      <a:off x="249228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1" name="Line 142"/>
                    <p:cNvSpPr/>
                    <p:nvPr/>
                  </p:nvSpPr>
                  <p:spPr>
                    <a:xfrm>
                      <a:off x="25041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2" name="Line 143"/>
                    <p:cNvSpPr/>
                    <p:nvPr/>
                  </p:nvSpPr>
                  <p:spPr>
                    <a:xfrm>
                      <a:off x="2516400" y="231516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3" name="Line 144"/>
                    <p:cNvSpPr/>
                    <p:nvPr/>
                  </p:nvSpPr>
                  <p:spPr>
                    <a:xfrm>
                      <a:off x="259812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4" name="Line 145"/>
                    <p:cNvSpPr/>
                    <p:nvPr/>
                  </p:nvSpPr>
                  <p:spPr>
                    <a:xfrm>
                      <a:off x="26427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5" name="Line 146"/>
                    <p:cNvSpPr/>
                    <p:nvPr/>
                  </p:nvSpPr>
                  <p:spPr>
                    <a:xfrm>
                      <a:off x="26751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6" name="Line 147"/>
                    <p:cNvSpPr/>
                    <p:nvPr/>
                  </p:nvSpPr>
                  <p:spPr>
                    <a:xfrm>
                      <a:off x="2699640" y="231516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7" name="Line 148"/>
                    <p:cNvSpPr/>
                    <p:nvPr/>
                  </p:nvSpPr>
                  <p:spPr>
                    <a:xfrm>
                      <a:off x="272412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8" name="Line 149"/>
                    <p:cNvSpPr/>
                    <p:nvPr/>
                  </p:nvSpPr>
                  <p:spPr>
                    <a:xfrm>
                      <a:off x="274068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49" name="Line 150"/>
                    <p:cNvSpPr/>
                    <p:nvPr/>
                  </p:nvSpPr>
                  <p:spPr>
                    <a:xfrm>
                      <a:off x="275688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0" name="Line 151"/>
                    <p:cNvSpPr/>
                    <p:nvPr/>
                  </p:nvSpPr>
                  <p:spPr>
                    <a:xfrm>
                      <a:off x="27687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1" name="Line 152"/>
                    <p:cNvSpPr/>
                    <p:nvPr/>
                  </p:nvSpPr>
                  <p:spPr>
                    <a:xfrm>
                      <a:off x="2781360" y="231516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2" name="Line 153"/>
                    <p:cNvSpPr/>
                    <p:nvPr/>
                  </p:nvSpPr>
                  <p:spPr>
                    <a:xfrm>
                      <a:off x="285840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3" name="Line 154"/>
                    <p:cNvSpPr/>
                    <p:nvPr/>
                  </p:nvSpPr>
                  <p:spPr>
                    <a:xfrm>
                      <a:off x="29073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4" name="Line 155"/>
                    <p:cNvSpPr/>
                    <p:nvPr/>
                  </p:nvSpPr>
                  <p:spPr>
                    <a:xfrm>
                      <a:off x="294012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5" name="Line 156"/>
                    <p:cNvSpPr/>
                    <p:nvPr/>
                  </p:nvSpPr>
                  <p:spPr>
                    <a:xfrm>
                      <a:off x="2964600" y="231516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6" name="Line 157"/>
                    <p:cNvSpPr/>
                    <p:nvPr/>
                  </p:nvSpPr>
                  <p:spPr>
                    <a:xfrm>
                      <a:off x="298512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7" name="Line 158"/>
                    <p:cNvSpPr/>
                    <p:nvPr/>
                  </p:nvSpPr>
                  <p:spPr>
                    <a:xfrm>
                      <a:off x="300528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8" name="Line 159"/>
                    <p:cNvSpPr/>
                    <p:nvPr/>
                  </p:nvSpPr>
                  <p:spPr>
                    <a:xfrm>
                      <a:off x="30171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59" name="Line 160"/>
                    <p:cNvSpPr/>
                    <p:nvPr/>
                  </p:nvSpPr>
                  <p:spPr>
                    <a:xfrm>
                      <a:off x="303408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0" name="Line 161"/>
                    <p:cNvSpPr/>
                    <p:nvPr/>
                  </p:nvSpPr>
                  <p:spPr>
                    <a:xfrm>
                      <a:off x="3045960" y="231516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1" name="Line 162"/>
                    <p:cNvSpPr/>
                    <p:nvPr/>
                  </p:nvSpPr>
                  <p:spPr>
                    <a:xfrm>
                      <a:off x="31233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2" name="Line 163"/>
                    <p:cNvSpPr/>
                    <p:nvPr/>
                  </p:nvSpPr>
                  <p:spPr>
                    <a:xfrm>
                      <a:off x="31719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3" name="Line 164"/>
                    <p:cNvSpPr/>
                    <p:nvPr/>
                  </p:nvSpPr>
                  <p:spPr>
                    <a:xfrm>
                      <a:off x="320472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4" name="Line 165"/>
                    <p:cNvSpPr/>
                    <p:nvPr/>
                  </p:nvSpPr>
                  <p:spPr>
                    <a:xfrm>
                      <a:off x="3229200" y="231516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5" name="Line 166"/>
                    <p:cNvSpPr/>
                    <p:nvPr/>
                  </p:nvSpPr>
                  <p:spPr>
                    <a:xfrm>
                      <a:off x="32493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6" name="Line 167"/>
                    <p:cNvSpPr/>
                    <p:nvPr/>
                  </p:nvSpPr>
                  <p:spPr>
                    <a:xfrm>
                      <a:off x="32655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7" name="Line 168"/>
                    <p:cNvSpPr/>
                    <p:nvPr/>
                  </p:nvSpPr>
                  <p:spPr>
                    <a:xfrm>
                      <a:off x="328248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8" name="Line 169"/>
                    <p:cNvSpPr/>
                    <p:nvPr/>
                  </p:nvSpPr>
                  <p:spPr>
                    <a:xfrm>
                      <a:off x="3294360" y="231516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69" name="Line 170"/>
                    <p:cNvSpPr/>
                    <p:nvPr/>
                  </p:nvSpPr>
                  <p:spPr>
                    <a:xfrm>
                      <a:off x="3306240" y="231516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770" name="Group 171"/>
                  <p:cNvGrpSpPr/>
                  <p:nvPr/>
                </p:nvGrpSpPr>
                <p:grpSpPr>
                  <a:xfrm>
                    <a:off x="2214360" y="2347560"/>
                    <a:ext cx="1130040" cy="62280"/>
                    <a:chOff x="2214360" y="2347560"/>
                    <a:chExt cx="1130040" cy="62280"/>
                  </a:xfrm>
                </p:grpSpPr>
                <p:sp>
                  <p:nvSpPr>
                    <p:cNvPr id="771" name="Rectangle 172"/>
                    <p:cNvSpPr/>
                    <p:nvPr/>
                  </p:nvSpPr>
                  <p:spPr>
                    <a:xfrm>
                      <a:off x="2214360" y="23637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2" name="Rectangle 173"/>
                    <p:cNvSpPr/>
                    <p:nvPr/>
                  </p:nvSpPr>
                  <p:spPr>
                    <a:xfrm>
                      <a:off x="2271600" y="23475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3" name="Rectangle 174"/>
                    <p:cNvSpPr/>
                    <p:nvPr/>
                  </p:nvSpPr>
                  <p:spPr>
                    <a:xfrm>
                      <a:off x="2474640" y="23637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4" name="Rectangle 175"/>
                    <p:cNvSpPr/>
                    <p:nvPr/>
                  </p:nvSpPr>
                  <p:spPr>
                    <a:xfrm>
                      <a:off x="2532600" y="23475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5" name="Rectangle 176"/>
                    <p:cNvSpPr/>
                    <p:nvPr/>
                  </p:nvSpPr>
                  <p:spPr>
                    <a:xfrm>
                      <a:off x="2739600" y="23637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6" name="Rectangle 177"/>
                    <p:cNvSpPr/>
                    <p:nvPr/>
                  </p:nvSpPr>
                  <p:spPr>
                    <a:xfrm>
                      <a:off x="2797200" y="23475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7" name="Rectangle 178"/>
                    <p:cNvSpPr/>
                    <p:nvPr/>
                  </p:nvSpPr>
                  <p:spPr>
                    <a:xfrm>
                      <a:off x="3004200" y="23637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8" name="Rectangle 179"/>
                    <p:cNvSpPr/>
                    <p:nvPr/>
                  </p:nvSpPr>
                  <p:spPr>
                    <a:xfrm>
                      <a:off x="3061440" y="23475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9" name="Rectangle 180"/>
                    <p:cNvSpPr/>
                    <p:nvPr/>
                  </p:nvSpPr>
                  <p:spPr>
                    <a:xfrm>
                      <a:off x="3264480" y="23637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0" name="Rectangle 181"/>
                    <p:cNvSpPr/>
                    <p:nvPr/>
                  </p:nvSpPr>
                  <p:spPr>
                    <a:xfrm>
                      <a:off x="3322440" y="23475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grpSp>
              <p:nvGrpSpPr>
                <p:cNvPr id="781" name="Group 182"/>
                <p:cNvGrpSpPr/>
                <p:nvPr/>
              </p:nvGrpSpPr>
              <p:grpSpPr>
                <a:xfrm>
                  <a:off x="2128320" y="1260360"/>
                  <a:ext cx="127800" cy="1067400"/>
                  <a:chOff x="2128320" y="1260360"/>
                  <a:chExt cx="127800" cy="1067400"/>
                </a:xfrm>
              </p:grpSpPr>
              <p:sp>
                <p:nvSpPr>
                  <p:cNvPr id="782" name="Line 183"/>
                  <p:cNvSpPr/>
                  <p:nvPr/>
                </p:nvSpPr>
                <p:spPr>
                  <a:xfrm flipV="1">
                    <a:off x="2256120" y="1260360"/>
                    <a:ext cx="0" cy="105048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783" name="Group 184"/>
                  <p:cNvGrpSpPr/>
                  <p:nvPr/>
                </p:nvGrpSpPr>
                <p:grpSpPr>
                  <a:xfrm>
                    <a:off x="2128320" y="1280520"/>
                    <a:ext cx="79560" cy="1047240"/>
                    <a:chOff x="2128320" y="1280520"/>
                    <a:chExt cx="79560" cy="1047240"/>
                  </a:xfrm>
                </p:grpSpPr>
                <p:sp>
                  <p:nvSpPr>
                    <p:cNvPr id="784" name="Rectangle 185"/>
                    <p:cNvSpPr/>
                    <p:nvPr/>
                  </p:nvSpPr>
                  <p:spPr>
                    <a:xfrm>
                      <a:off x="2185920" y="22816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5" name="Rectangle 186"/>
                    <p:cNvSpPr/>
                    <p:nvPr/>
                  </p:nvSpPr>
                  <p:spPr>
                    <a:xfrm>
                      <a:off x="2156760" y="20822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6" name="Rectangle 187"/>
                    <p:cNvSpPr/>
                    <p:nvPr/>
                  </p:nvSpPr>
                  <p:spPr>
                    <a:xfrm>
                      <a:off x="2156760" y="18828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7" name="Rectangle 188"/>
                    <p:cNvSpPr/>
                    <p:nvPr/>
                  </p:nvSpPr>
                  <p:spPr>
                    <a:xfrm>
                      <a:off x="2156760" y="16794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8" name="Rectangle 189"/>
                    <p:cNvSpPr/>
                    <p:nvPr/>
                  </p:nvSpPr>
                  <p:spPr>
                    <a:xfrm>
                      <a:off x="2156760" y="14799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89" name="Rectangle 190"/>
                    <p:cNvSpPr/>
                    <p:nvPr/>
                  </p:nvSpPr>
                  <p:spPr>
                    <a:xfrm>
                      <a:off x="2128320" y="128052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790" name="Group 191"/>
                  <p:cNvGrpSpPr/>
                  <p:nvPr/>
                </p:nvGrpSpPr>
                <p:grpSpPr>
                  <a:xfrm>
                    <a:off x="2231640" y="1308600"/>
                    <a:ext cx="23760" cy="1001520"/>
                    <a:chOff x="2231640" y="1308600"/>
                    <a:chExt cx="23760" cy="1001520"/>
                  </a:xfrm>
                </p:grpSpPr>
                <p:sp>
                  <p:nvSpPr>
                    <p:cNvPr id="791" name="Line 192"/>
                    <p:cNvSpPr/>
                    <p:nvPr/>
                  </p:nvSpPr>
                  <p:spPr>
                    <a:xfrm flipH="1">
                      <a:off x="2231640" y="231012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2" name="Line 193"/>
                    <p:cNvSpPr/>
                    <p:nvPr/>
                  </p:nvSpPr>
                  <p:spPr>
                    <a:xfrm flipH="1">
                      <a:off x="2247480" y="22611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3" name="Line 194"/>
                    <p:cNvSpPr/>
                    <p:nvPr/>
                  </p:nvSpPr>
                  <p:spPr>
                    <a:xfrm flipH="1">
                      <a:off x="2247480" y="22122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4" name="Line 195"/>
                    <p:cNvSpPr/>
                    <p:nvPr/>
                  </p:nvSpPr>
                  <p:spPr>
                    <a:xfrm flipH="1">
                      <a:off x="2247480" y="21596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5" name="Line 196"/>
                    <p:cNvSpPr/>
                    <p:nvPr/>
                  </p:nvSpPr>
                  <p:spPr>
                    <a:xfrm flipH="1">
                      <a:off x="2231640" y="211068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6" name="Line 197"/>
                    <p:cNvSpPr/>
                    <p:nvPr/>
                  </p:nvSpPr>
                  <p:spPr>
                    <a:xfrm flipH="1">
                      <a:off x="2247480" y="206172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7" name="Line 198"/>
                    <p:cNvSpPr/>
                    <p:nvPr/>
                  </p:nvSpPr>
                  <p:spPr>
                    <a:xfrm flipH="1">
                      <a:off x="2247480" y="20088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8" name="Line 199"/>
                    <p:cNvSpPr/>
                    <p:nvPr/>
                  </p:nvSpPr>
                  <p:spPr>
                    <a:xfrm flipH="1">
                      <a:off x="2247480" y="19602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99" name="Line 200"/>
                    <p:cNvSpPr/>
                    <p:nvPr/>
                  </p:nvSpPr>
                  <p:spPr>
                    <a:xfrm flipH="1">
                      <a:off x="2231640" y="191124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0" name="Line 201"/>
                    <p:cNvSpPr/>
                    <p:nvPr/>
                  </p:nvSpPr>
                  <p:spPr>
                    <a:xfrm flipH="1">
                      <a:off x="2247480" y="185832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1" name="Line 202"/>
                    <p:cNvSpPr/>
                    <p:nvPr/>
                  </p:nvSpPr>
                  <p:spPr>
                    <a:xfrm flipH="1">
                      <a:off x="2247480" y="18093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2" name="Line 203"/>
                    <p:cNvSpPr/>
                    <p:nvPr/>
                  </p:nvSpPr>
                  <p:spPr>
                    <a:xfrm flipH="1">
                      <a:off x="2247480" y="17604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3" name="Line 204"/>
                    <p:cNvSpPr/>
                    <p:nvPr/>
                  </p:nvSpPr>
                  <p:spPr>
                    <a:xfrm flipH="1">
                      <a:off x="2231640" y="170784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4" name="Line 205"/>
                    <p:cNvSpPr/>
                    <p:nvPr/>
                  </p:nvSpPr>
                  <p:spPr>
                    <a:xfrm flipH="1">
                      <a:off x="2247480" y="16588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5" name="Line 206"/>
                    <p:cNvSpPr/>
                    <p:nvPr/>
                  </p:nvSpPr>
                  <p:spPr>
                    <a:xfrm flipH="1">
                      <a:off x="2247480" y="160992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6" name="Line 207"/>
                    <p:cNvSpPr/>
                    <p:nvPr/>
                  </p:nvSpPr>
                  <p:spPr>
                    <a:xfrm flipH="1">
                      <a:off x="2247480" y="15566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7" name="Line 208"/>
                    <p:cNvSpPr/>
                    <p:nvPr/>
                  </p:nvSpPr>
                  <p:spPr>
                    <a:xfrm flipH="1">
                      <a:off x="2231640" y="150840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8" name="Line 209"/>
                    <p:cNvSpPr/>
                    <p:nvPr/>
                  </p:nvSpPr>
                  <p:spPr>
                    <a:xfrm flipH="1">
                      <a:off x="2247480" y="14594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09" name="Line 210"/>
                    <p:cNvSpPr/>
                    <p:nvPr/>
                  </p:nvSpPr>
                  <p:spPr>
                    <a:xfrm flipH="1">
                      <a:off x="2247480" y="14061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10" name="Line 211"/>
                    <p:cNvSpPr/>
                    <p:nvPr/>
                  </p:nvSpPr>
                  <p:spPr>
                    <a:xfrm flipH="1">
                      <a:off x="2247480" y="13572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11" name="Line 212"/>
                    <p:cNvSpPr/>
                    <p:nvPr/>
                  </p:nvSpPr>
                  <p:spPr>
                    <a:xfrm flipH="1">
                      <a:off x="2231640" y="130860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812" name="Group 213"/>
              <p:cNvGrpSpPr/>
              <p:nvPr/>
            </p:nvGrpSpPr>
            <p:grpSpPr>
              <a:xfrm>
                <a:off x="2264760" y="1267920"/>
                <a:ext cx="1038600" cy="1042920"/>
                <a:chOff x="2264760" y="1267920"/>
                <a:chExt cx="1038600" cy="1042920"/>
              </a:xfrm>
            </p:grpSpPr>
            <p:sp>
              <p:nvSpPr>
                <p:cNvPr id="813" name="Freeform 214"/>
                <p:cNvSpPr/>
                <p:nvPr/>
              </p:nvSpPr>
              <p:spPr>
                <a:xfrm>
                  <a:off x="2264760" y="1267920"/>
                  <a:ext cx="1038600" cy="1038960"/>
                </a:xfrm>
                <a:custGeom>
                  <a:avLst/>
                  <a:gdLst>
                    <a:gd name="textAreaLeft" fmla="*/ 0 w 1038600"/>
                    <a:gd name="textAreaRight" fmla="*/ 1038960 w 1038600"/>
                    <a:gd name="textAreaTop" fmla="*/ 0 h 1038960"/>
                    <a:gd name="textAreaBottom" fmla="*/ 1039320 h 1038960"/>
                  </a:gdLst>
                  <a:ahLst/>
                  <a:rect l="textAreaLeft" t="textAreaTop" r="textAreaRight" b="textAreaBottom"/>
                  <a:pathLst>
                    <a:path w="510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200"/>
                      </a:lnTo>
                      <a:lnTo>
                        <a:pt x="4" y="306"/>
                      </a:lnTo>
                      <a:lnTo>
                        <a:pt x="6" y="298"/>
                      </a:lnTo>
                      <a:lnTo>
                        <a:pt x="8" y="280"/>
                      </a:lnTo>
                      <a:lnTo>
                        <a:pt x="10" y="256"/>
                      </a:lnTo>
                      <a:lnTo>
                        <a:pt x="12" y="226"/>
                      </a:lnTo>
                      <a:lnTo>
                        <a:pt x="14" y="198"/>
                      </a:lnTo>
                      <a:lnTo>
                        <a:pt x="16" y="186"/>
                      </a:lnTo>
                      <a:lnTo>
                        <a:pt x="18" y="164"/>
                      </a:lnTo>
                      <a:lnTo>
                        <a:pt x="20" y="130"/>
                      </a:lnTo>
                      <a:lnTo>
                        <a:pt x="22" y="112"/>
                      </a:lnTo>
                      <a:lnTo>
                        <a:pt x="24" y="108"/>
                      </a:lnTo>
                      <a:lnTo>
                        <a:pt x="26" y="100"/>
                      </a:lnTo>
                      <a:lnTo>
                        <a:pt x="28" y="76"/>
                      </a:lnTo>
                      <a:lnTo>
                        <a:pt x="30" y="46"/>
                      </a:lnTo>
                      <a:lnTo>
                        <a:pt x="32" y="40"/>
                      </a:lnTo>
                      <a:lnTo>
                        <a:pt x="34" y="44"/>
                      </a:lnTo>
                      <a:lnTo>
                        <a:pt x="36" y="62"/>
                      </a:lnTo>
                      <a:lnTo>
                        <a:pt x="38" y="80"/>
                      </a:lnTo>
                      <a:lnTo>
                        <a:pt x="40" y="70"/>
                      </a:lnTo>
                      <a:lnTo>
                        <a:pt x="42" y="46"/>
                      </a:lnTo>
                      <a:lnTo>
                        <a:pt x="44" y="28"/>
                      </a:lnTo>
                      <a:lnTo>
                        <a:pt x="46" y="24"/>
                      </a:lnTo>
                      <a:lnTo>
                        <a:pt x="48" y="42"/>
                      </a:lnTo>
                      <a:lnTo>
                        <a:pt x="50" y="82"/>
                      </a:lnTo>
                      <a:lnTo>
                        <a:pt x="52" y="102"/>
                      </a:lnTo>
                      <a:lnTo>
                        <a:pt x="54" y="104"/>
                      </a:lnTo>
                      <a:lnTo>
                        <a:pt x="56" y="112"/>
                      </a:lnTo>
                      <a:lnTo>
                        <a:pt x="58" y="130"/>
                      </a:lnTo>
                      <a:lnTo>
                        <a:pt x="60" y="162"/>
                      </a:lnTo>
                      <a:lnTo>
                        <a:pt x="62" y="168"/>
                      </a:lnTo>
                      <a:lnTo>
                        <a:pt x="64" y="152"/>
                      </a:lnTo>
                      <a:lnTo>
                        <a:pt x="66" y="142"/>
                      </a:lnTo>
                      <a:lnTo>
                        <a:pt x="68" y="164"/>
                      </a:lnTo>
                      <a:lnTo>
                        <a:pt x="70" y="200"/>
                      </a:lnTo>
                      <a:lnTo>
                        <a:pt x="72" y="232"/>
                      </a:lnTo>
                      <a:lnTo>
                        <a:pt x="74" y="252"/>
                      </a:lnTo>
                      <a:lnTo>
                        <a:pt x="76" y="262"/>
                      </a:lnTo>
                      <a:lnTo>
                        <a:pt x="78" y="276"/>
                      </a:lnTo>
                      <a:lnTo>
                        <a:pt x="80" y="296"/>
                      </a:lnTo>
                      <a:lnTo>
                        <a:pt x="82" y="310"/>
                      </a:lnTo>
                      <a:lnTo>
                        <a:pt x="84" y="318"/>
                      </a:lnTo>
                      <a:lnTo>
                        <a:pt x="86" y="336"/>
                      </a:lnTo>
                      <a:lnTo>
                        <a:pt x="88" y="360"/>
                      </a:lnTo>
                      <a:lnTo>
                        <a:pt x="90" y="376"/>
                      </a:lnTo>
                      <a:lnTo>
                        <a:pt x="92" y="388"/>
                      </a:lnTo>
                      <a:lnTo>
                        <a:pt x="94" y="402"/>
                      </a:lnTo>
                      <a:lnTo>
                        <a:pt x="96" y="418"/>
                      </a:lnTo>
                      <a:lnTo>
                        <a:pt x="98" y="430"/>
                      </a:lnTo>
                      <a:lnTo>
                        <a:pt x="100" y="440"/>
                      </a:lnTo>
                      <a:lnTo>
                        <a:pt x="102" y="448"/>
                      </a:lnTo>
                      <a:lnTo>
                        <a:pt x="104" y="456"/>
                      </a:lnTo>
                      <a:lnTo>
                        <a:pt x="106" y="464"/>
                      </a:lnTo>
                      <a:lnTo>
                        <a:pt x="108" y="468"/>
                      </a:lnTo>
                      <a:lnTo>
                        <a:pt x="110" y="474"/>
                      </a:lnTo>
                      <a:lnTo>
                        <a:pt x="112" y="478"/>
                      </a:lnTo>
                      <a:lnTo>
                        <a:pt x="114" y="482"/>
                      </a:lnTo>
                      <a:lnTo>
                        <a:pt x="116" y="484"/>
                      </a:lnTo>
                      <a:lnTo>
                        <a:pt x="118" y="486"/>
                      </a:lnTo>
                      <a:lnTo>
                        <a:pt x="120" y="488"/>
                      </a:lnTo>
                      <a:lnTo>
                        <a:pt x="122" y="492"/>
                      </a:lnTo>
                      <a:lnTo>
                        <a:pt x="124" y="494"/>
                      </a:lnTo>
                      <a:lnTo>
                        <a:pt x="126" y="496"/>
                      </a:lnTo>
                      <a:lnTo>
                        <a:pt x="128" y="498"/>
                      </a:lnTo>
                      <a:lnTo>
                        <a:pt x="130" y="500"/>
                      </a:lnTo>
                      <a:lnTo>
                        <a:pt x="132" y="500"/>
                      </a:lnTo>
                      <a:lnTo>
                        <a:pt x="134" y="502"/>
                      </a:lnTo>
                      <a:lnTo>
                        <a:pt x="136" y="504"/>
                      </a:lnTo>
                      <a:lnTo>
                        <a:pt x="138" y="504"/>
                      </a:lnTo>
                      <a:lnTo>
                        <a:pt x="140" y="504"/>
                      </a:lnTo>
                      <a:lnTo>
                        <a:pt x="142" y="504"/>
                      </a:lnTo>
                      <a:lnTo>
                        <a:pt x="144" y="506"/>
                      </a:lnTo>
                      <a:lnTo>
                        <a:pt x="146" y="506"/>
                      </a:lnTo>
                      <a:lnTo>
                        <a:pt x="148" y="506"/>
                      </a:lnTo>
                      <a:lnTo>
                        <a:pt x="150" y="506"/>
                      </a:lnTo>
                      <a:lnTo>
                        <a:pt x="152" y="506"/>
                      </a:lnTo>
                      <a:lnTo>
                        <a:pt x="154" y="506"/>
                      </a:lnTo>
                      <a:lnTo>
                        <a:pt x="156" y="508"/>
                      </a:lnTo>
                      <a:lnTo>
                        <a:pt x="158" y="508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08"/>
                      </a:lnTo>
                      <a:lnTo>
                        <a:pt x="176" y="508"/>
                      </a:lnTo>
                      <a:lnTo>
                        <a:pt x="178" y="508"/>
                      </a:lnTo>
                      <a:lnTo>
                        <a:pt x="180" y="508"/>
                      </a:lnTo>
                      <a:lnTo>
                        <a:pt x="182" y="508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10"/>
                      </a:lnTo>
                      <a:lnTo>
                        <a:pt x="216" y="510"/>
                      </a:lnTo>
                      <a:lnTo>
                        <a:pt x="218" y="510"/>
                      </a:lnTo>
                      <a:lnTo>
                        <a:pt x="220" y="510"/>
                      </a:lnTo>
                      <a:lnTo>
                        <a:pt x="222" y="510"/>
                      </a:lnTo>
                      <a:lnTo>
                        <a:pt x="224" y="510"/>
                      </a:lnTo>
                      <a:lnTo>
                        <a:pt x="226" y="510"/>
                      </a:lnTo>
                      <a:lnTo>
                        <a:pt x="228" y="510"/>
                      </a:lnTo>
                      <a:lnTo>
                        <a:pt x="230" y="510"/>
                      </a:lnTo>
                      <a:lnTo>
                        <a:pt x="232" y="510"/>
                      </a:lnTo>
                      <a:lnTo>
                        <a:pt x="234" y="510"/>
                      </a:lnTo>
                      <a:lnTo>
                        <a:pt x="236" y="510"/>
                      </a:lnTo>
                      <a:lnTo>
                        <a:pt x="238" y="510"/>
                      </a:lnTo>
                      <a:lnTo>
                        <a:pt x="240" y="510"/>
                      </a:lnTo>
                      <a:lnTo>
                        <a:pt x="242" y="510"/>
                      </a:lnTo>
                      <a:lnTo>
                        <a:pt x="244" y="510"/>
                      </a:lnTo>
                      <a:lnTo>
                        <a:pt x="246" y="510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10"/>
                      </a:lnTo>
                      <a:lnTo>
                        <a:pt x="254" y="510"/>
                      </a:lnTo>
                      <a:lnTo>
                        <a:pt x="256" y="510"/>
                      </a:lnTo>
                      <a:lnTo>
                        <a:pt x="258" y="510"/>
                      </a:lnTo>
                      <a:lnTo>
                        <a:pt x="260" y="510"/>
                      </a:lnTo>
                      <a:lnTo>
                        <a:pt x="262" y="510"/>
                      </a:lnTo>
                      <a:lnTo>
                        <a:pt x="264" y="510"/>
                      </a:lnTo>
                      <a:lnTo>
                        <a:pt x="266" y="510"/>
                      </a:lnTo>
                      <a:lnTo>
                        <a:pt x="268" y="510"/>
                      </a:lnTo>
                      <a:lnTo>
                        <a:pt x="270" y="510"/>
                      </a:lnTo>
                      <a:lnTo>
                        <a:pt x="272" y="510"/>
                      </a:lnTo>
                      <a:lnTo>
                        <a:pt x="274" y="510"/>
                      </a:lnTo>
                      <a:lnTo>
                        <a:pt x="276" y="510"/>
                      </a:lnTo>
                      <a:lnTo>
                        <a:pt x="278" y="510"/>
                      </a:lnTo>
                      <a:lnTo>
                        <a:pt x="280" y="510"/>
                      </a:lnTo>
                      <a:lnTo>
                        <a:pt x="282" y="510"/>
                      </a:lnTo>
                      <a:lnTo>
                        <a:pt x="284" y="510"/>
                      </a:lnTo>
                      <a:lnTo>
                        <a:pt x="286" y="510"/>
                      </a:lnTo>
                      <a:lnTo>
                        <a:pt x="288" y="510"/>
                      </a:lnTo>
                      <a:lnTo>
                        <a:pt x="290" y="510"/>
                      </a:lnTo>
                      <a:lnTo>
                        <a:pt x="292" y="510"/>
                      </a:lnTo>
                      <a:lnTo>
                        <a:pt x="294" y="510"/>
                      </a:lnTo>
                      <a:lnTo>
                        <a:pt x="296" y="510"/>
                      </a:lnTo>
                      <a:lnTo>
                        <a:pt x="298" y="510"/>
                      </a:lnTo>
                      <a:lnTo>
                        <a:pt x="300" y="510"/>
                      </a:lnTo>
                      <a:lnTo>
                        <a:pt x="302" y="510"/>
                      </a:lnTo>
                      <a:lnTo>
                        <a:pt x="304" y="510"/>
                      </a:lnTo>
                      <a:lnTo>
                        <a:pt x="306" y="510"/>
                      </a:lnTo>
                      <a:lnTo>
                        <a:pt x="308" y="508"/>
                      </a:lnTo>
                      <a:lnTo>
                        <a:pt x="310" y="508"/>
                      </a:lnTo>
                      <a:lnTo>
                        <a:pt x="312" y="508"/>
                      </a:lnTo>
                      <a:lnTo>
                        <a:pt x="314" y="508"/>
                      </a:lnTo>
                      <a:lnTo>
                        <a:pt x="316" y="508"/>
                      </a:lnTo>
                      <a:lnTo>
                        <a:pt x="318" y="508"/>
                      </a:lnTo>
                      <a:lnTo>
                        <a:pt x="320" y="508"/>
                      </a:lnTo>
                      <a:lnTo>
                        <a:pt x="322" y="508"/>
                      </a:lnTo>
                      <a:lnTo>
                        <a:pt x="324" y="508"/>
                      </a:lnTo>
                      <a:lnTo>
                        <a:pt x="326" y="508"/>
                      </a:lnTo>
                      <a:lnTo>
                        <a:pt x="328" y="508"/>
                      </a:lnTo>
                      <a:lnTo>
                        <a:pt x="330" y="508"/>
                      </a:lnTo>
                      <a:lnTo>
                        <a:pt x="332" y="508"/>
                      </a:lnTo>
                      <a:lnTo>
                        <a:pt x="334" y="508"/>
                      </a:lnTo>
                      <a:lnTo>
                        <a:pt x="336" y="508"/>
                      </a:lnTo>
                      <a:lnTo>
                        <a:pt x="338" y="508"/>
                      </a:lnTo>
                      <a:lnTo>
                        <a:pt x="340" y="508"/>
                      </a:lnTo>
                      <a:lnTo>
                        <a:pt x="342" y="508"/>
                      </a:lnTo>
                      <a:lnTo>
                        <a:pt x="344" y="508"/>
                      </a:lnTo>
                      <a:lnTo>
                        <a:pt x="346" y="510"/>
                      </a:lnTo>
                      <a:lnTo>
                        <a:pt x="348" y="510"/>
                      </a:lnTo>
                      <a:lnTo>
                        <a:pt x="350" y="510"/>
                      </a:lnTo>
                      <a:lnTo>
                        <a:pt x="352" y="510"/>
                      </a:lnTo>
                      <a:lnTo>
                        <a:pt x="354" y="510"/>
                      </a:lnTo>
                      <a:lnTo>
                        <a:pt x="356" y="510"/>
                      </a:lnTo>
                      <a:lnTo>
                        <a:pt x="358" y="510"/>
                      </a:lnTo>
                      <a:lnTo>
                        <a:pt x="360" y="510"/>
                      </a:lnTo>
                      <a:lnTo>
                        <a:pt x="362" y="510"/>
                      </a:lnTo>
                      <a:lnTo>
                        <a:pt x="364" y="510"/>
                      </a:lnTo>
                      <a:lnTo>
                        <a:pt x="366" y="510"/>
                      </a:lnTo>
                      <a:lnTo>
                        <a:pt x="368" y="510"/>
                      </a:lnTo>
                      <a:lnTo>
                        <a:pt x="370" y="510"/>
                      </a:lnTo>
                      <a:lnTo>
                        <a:pt x="372" y="510"/>
                      </a:lnTo>
                      <a:lnTo>
                        <a:pt x="374" y="510"/>
                      </a:lnTo>
                      <a:lnTo>
                        <a:pt x="376" y="510"/>
                      </a:lnTo>
                      <a:lnTo>
                        <a:pt x="378" y="510"/>
                      </a:lnTo>
                      <a:lnTo>
                        <a:pt x="380" y="510"/>
                      </a:lnTo>
                      <a:lnTo>
                        <a:pt x="382" y="510"/>
                      </a:lnTo>
                      <a:lnTo>
                        <a:pt x="384" y="510"/>
                      </a:lnTo>
                      <a:lnTo>
                        <a:pt x="386" y="510"/>
                      </a:lnTo>
                      <a:lnTo>
                        <a:pt x="388" y="510"/>
                      </a:lnTo>
                      <a:lnTo>
                        <a:pt x="390" y="510"/>
                      </a:lnTo>
                      <a:lnTo>
                        <a:pt x="392" y="510"/>
                      </a:lnTo>
                      <a:lnTo>
                        <a:pt x="394" y="510"/>
                      </a:lnTo>
                      <a:lnTo>
                        <a:pt x="396" y="510"/>
                      </a:lnTo>
                      <a:lnTo>
                        <a:pt x="398" y="510"/>
                      </a:lnTo>
                      <a:lnTo>
                        <a:pt x="400" y="510"/>
                      </a:lnTo>
                      <a:lnTo>
                        <a:pt x="402" y="510"/>
                      </a:lnTo>
                      <a:lnTo>
                        <a:pt x="404" y="510"/>
                      </a:lnTo>
                      <a:lnTo>
                        <a:pt x="406" y="510"/>
                      </a:lnTo>
                      <a:lnTo>
                        <a:pt x="408" y="510"/>
                      </a:lnTo>
                      <a:lnTo>
                        <a:pt x="410" y="510"/>
                      </a:lnTo>
                      <a:lnTo>
                        <a:pt x="412" y="510"/>
                      </a:lnTo>
                      <a:lnTo>
                        <a:pt x="414" y="510"/>
                      </a:lnTo>
                      <a:lnTo>
                        <a:pt x="416" y="510"/>
                      </a:lnTo>
                      <a:lnTo>
                        <a:pt x="418" y="510"/>
                      </a:lnTo>
                      <a:lnTo>
                        <a:pt x="420" y="510"/>
                      </a:lnTo>
                      <a:lnTo>
                        <a:pt x="422" y="510"/>
                      </a:lnTo>
                      <a:lnTo>
                        <a:pt x="424" y="510"/>
                      </a:lnTo>
                      <a:lnTo>
                        <a:pt x="426" y="510"/>
                      </a:lnTo>
                      <a:lnTo>
                        <a:pt x="428" y="510"/>
                      </a:lnTo>
                      <a:lnTo>
                        <a:pt x="430" y="510"/>
                      </a:lnTo>
                      <a:lnTo>
                        <a:pt x="432" y="510"/>
                      </a:lnTo>
                      <a:lnTo>
                        <a:pt x="434" y="510"/>
                      </a:lnTo>
                      <a:lnTo>
                        <a:pt x="436" y="510"/>
                      </a:lnTo>
                      <a:lnTo>
                        <a:pt x="438" y="510"/>
                      </a:lnTo>
                      <a:lnTo>
                        <a:pt x="440" y="510"/>
                      </a:lnTo>
                      <a:lnTo>
                        <a:pt x="442" y="510"/>
                      </a:lnTo>
                      <a:lnTo>
                        <a:pt x="444" y="510"/>
                      </a:lnTo>
                      <a:lnTo>
                        <a:pt x="446" y="510"/>
                      </a:lnTo>
                      <a:lnTo>
                        <a:pt x="448" y="510"/>
                      </a:lnTo>
                      <a:lnTo>
                        <a:pt x="450" y="510"/>
                      </a:lnTo>
                      <a:lnTo>
                        <a:pt x="452" y="510"/>
                      </a:lnTo>
                      <a:lnTo>
                        <a:pt x="454" y="510"/>
                      </a:lnTo>
                      <a:lnTo>
                        <a:pt x="456" y="510"/>
                      </a:lnTo>
                      <a:lnTo>
                        <a:pt x="458" y="510"/>
                      </a:lnTo>
                      <a:lnTo>
                        <a:pt x="460" y="510"/>
                      </a:lnTo>
                      <a:lnTo>
                        <a:pt x="462" y="510"/>
                      </a:lnTo>
                      <a:lnTo>
                        <a:pt x="464" y="510"/>
                      </a:lnTo>
                      <a:lnTo>
                        <a:pt x="466" y="510"/>
                      </a:lnTo>
                      <a:lnTo>
                        <a:pt x="468" y="510"/>
                      </a:lnTo>
                      <a:lnTo>
                        <a:pt x="470" y="510"/>
                      </a:lnTo>
                      <a:lnTo>
                        <a:pt x="472" y="510"/>
                      </a:lnTo>
                      <a:lnTo>
                        <a:pt x="474" y="510"/>
                      </a:lnTo>
                      <a:lnTo>
                        <a:pt x="476" y="510"/>
                      </a:lnTo>
                      <a:lnTo>
                        <a:pt x="478" y="510"/>
                      </a:lnTo>
                      <a:lnTo>
                        <a:pt x="480" y="510"/>
                      </a:lnTo>
                      <a:lnTo>
                        <a:pt x="482" y="510"/>
                      </a:lnTo>
                      <a:lnTo>
                        <a:pt x="484" y="510"/>
                      </a:lnTo>
                      <a:lnTo>
                        <a:pt x="486" y="510"/>
                      </a:lnTo>
                      <a:lnTo>
                        <a:pt x="488" y="510"/>
                      </a:lnTo>
                      <a:lnTo>
                        <a:pt x="490" y="510"/>
                      </a:lnTo>
                      <a:lnTo>
                        <a:pt x="492" y="510"/>
                      </a:lnTo>
                      <a:lnTo>
                        <a:pt x="494" y="510"/>
                      </a:lnTo>
                      <a:lnTo>
                        <a:pt x="496" y="510"/>
                      </a:lnTo>
                      <a:lnTo>
                        <a:pt x="498" y="510"/>
                      </a:lnTo>
                      <a:lnTo>
                        <a:pt x="500" y="510"/>
                      </a:lnTo>
                      <a:lnTo>
                        <a:pt x="502" y="510"/>
                      </a:lnTo>
                      <a:lnTo>
                        <a:pt x="504" y="510"/>
                      </a:lnTo>
                      <a:lnTo>
                        <a:pt x="506" y="510"/>
                      </a:lnTo>
                      <a:lnTo>
                        <a:pt x="508" y="510"/>
                      </a:lnTo>
                      <a:lnTo>
                        <a:pt x="510" y="510"/>
                      </a:lnTo>
                      <a:lnTo>
                        <a:pt x="0" y="510"/>
                      </a:lnTo>
                      <a:close/>
                    </a:path>
                  </a:pathLst>
                </a:custGeom>
                <a:solidFill>
                  <a:srgbClr val="f0f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4" name="Freeform 215"/>
                <p:cNvSpPr/>
                <p:nvPr/>
              </p:nvSpPr>
              <p:spPr>
                <a:xfrm>
                  <a:off x="2268720" y="1271880"/>
                  <a:ext cx="1034640" cy="1038960"/>
                </a:xfrm>
                <a:custGeom>
                  <a:avLst/>
                  <a:gdLst>
                    <a:gd name="textAreaLeft" fmla="*/ 0 w 1034640"/>
                    <a:gd name="textAreaRight" fmla="*/ 1035000 w 1034640"/>
                    <a:gd name="textAreaTop" fmla="*/ 0 h 1038960"/>
                    <a:gd name="textAreaBottom" fmla="*/ 1039320 h 1038960"/>
                  </a:gdLst>
                  <a:ahLst/>
                  <a:rect l="textAreaLeft" t="textAreaTop" r="textAreaRight" b="textAreaBottom"/>
                  <a:pathLst>
                    <a:path w="508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200"/>
                      </a:lnTo>
                      <a:lnTo>
                        <a:pt x="4" y="306"/>
                      </a:lnTo>
                      <a:lnTo>
                        <a:pt x="6" y="298"/>
                      </a:lnTo>
                      <a:lnTo>
                        <a:pt x="8" y="280"/>
                      </a:lnTo>
                      <a:lnTo>
                        <a:pt x="10" y="256"/>
                      </a:lnTo>
                      <a:lnTo>
                        <a:pt x="12" y="226"/>
                      </a:lnTo>
                      <a:lnTo>
                        <a:pt x="14" y="198"/>
                      </a:lnTo>
                      <a:lnTo>
                        <a:pt x="16" y="186"/>
                      </a:lnTo>
                      <a:lnTo>
                        <a:pt x="18" y="164"/>
                      </a:lnTo>
                      <a:lnTo>
                        <a:pt x="20" y="130"/>
                      </a:lnTo>
                      <a:lnTo>
                        <a:pt x="22" y="112"/>
                      </a:lnTo>
                      <a:lnTo>
                        <a:pt x="24" y="108"/>
                      </a:lnTo>
                      <a:lnTo>
                        <a:pt x="26" y="100"/>
                      </a:lnTo>
                      <a:lnTo>
                        <a:pt x="28" y="76"/>
                      </a:lnTo>
                      <a:lnTo>
                        <a:pt x="30" y="46"/>
                      </a:lnTo>
                      <a:lnTo>
                        <a:pt x="32" y="40"/>
                      </a:lnTo>
                      <a:lnTo>
                        <a:pt x="34" y="44"/>
                      </a:lnTo>
                      <a:lnTo>
                        <a:pt x="36" y="62"/>
                      </a:lnTo>
                      <a:lnTo>
                        <a:pt x="38" y="80"/>
                      </a:lnTo>
                      <a:lnTo>
                        <a:pt x="40" y="70"/>
                      </a:lnTo>
                      <a:lnTo>
                        <a:pt x="42" y="46"/>
                      </a:lnTo>
                      <a:lnTo>
                        <a:pt x="44" y="28"/>
                      </a:lnTo>
                      <a:lnTo>
                        <a:pt x="46" y="24"/>
                      </a:lnTo>
                      <a:lnTo>
                        <a:pt x="48" y="42"/>
                      </a:lnTo>
                      <a:lnTo>
                        <a:pt x="50" y="82"/>
                      </a:lnTo>
                      <a:lnTo>
                        <a:pt x="52" y="102"/>
                      </a:lnTo>
                      <a:lnTo>
                        <a:pt x="54" y="104"/>
                      </a:lnTo>
                      <a:lnTo>
                        <a:pt x="56" y="112"/>
                      </a:lnTo>
                      <a:lnTo>
                        <a:pt x="58" y="130"/>
                      </a:lnTo>
                      <a:lnTo>
                        <a:pt x="60" y="162"/>
                      </a:lnTo>
                      <a:lnTo>
                        <a:pt x="62" y="168"/>
                      </a:lnTo>
                      <a:lnTo>
                        <a:pt x="64" y="152"/>
                      </a:lnTo>
                      <a:lnTo>
                        <a:pt x="66" y="142"/>
                      </a:lnTo>
                      <a:lnTo>
                        <a:pt x="68" y="164"/>
                      </a:lnTo>
                      <a:lnTo>
                        <a:pt x="70" y="200"/>
                      </a:lnTo>
                      <a:lnTo>
                        <a:pt x="72" y="232"/>
                      </a:lnTo>
                      <a:lnTo>
                        <a:pt x="74" y="252"/>
                      </a:lnTo>
                      <a:lnTo>
                        <a:pt x="76" y="262"/>
                      </a:lnTo>
                      <a:lnTo>
                        <a:pt x="78" y="276"/>
                      </a:lnTo>
                      <a:lnTo>
                        <a:pt x="80" y="296"/>
                      </a:lnTo>
                      <a:lnTo>
                        <a:pt x="82" y="310"/>
                      </a:lnTo>
                      <a:lnTo>
                        <a:pt x="84" y="318"/>
                      </a:lnTo>
                      <a:lnTo>
                        <a:pt x="86" y="336"/>
                      </a:lnTo>
                      <a:lnTo>
                        <a:pt x="88" y="360"/>
                      </a:lnTo>
                      <a:lnTo>
                        <a:pt x="90" y="376"/>
                      </a:lnTo>
                      <a:lnTo>
                        <a:pt x="92" y="388"/>
                      </a:lnTo>
                      <a:lnTo>
                        <a:pt x="94" y="402"/>
                      </a:lnTo>
                      <a:lnTo>
                        <a:pt x="96" y="418"/>
                      </a:lnTo>
                      <a:lnTo>
                        <a:pt x="98" y="430"/>
                      </a:lnTo>
                      <a:lnTo>
                        <a:pt x="100" y="440"/>
                      </a:lnTo>
                      <a:lnTo>
                        <a:pt x="102" y="448"/>
                      </a:lnTo>
                      <a:lnTo>
                        <a:pt x="104" y="456"/>
                      </a:lnTo>
                      <a:lnTo>
                        <a:pt x="106" y="464"/>
                      </a:lnTo>
                      <a:lnTo>
                        <a:pt x="108" y="468"/>
                      </a:lnTo>
                      <a:lnTo>
                        <a:pt x="110" y="474"/>
                      </a:lnTo>
                      <a:lnTo>
                        <a:pt x="112" y="478"/>
                      </a:lnTo>
                      <a:lnTo>
                        <a:pt x="114" y="482"/>
                      </a:lnTo>
                      <a:lnTo>
                        <a:pt x="116" y="484"/>
                      </a:lnTo>
                      <a:lnTo>
                        <a:pt x="118" y="486"/>
                      </a:lnTo>
                      <a:lnTo>
                        <a:pt x="120" y="488"/>
                      </a:lnTo>
                      <a:lnTo>
                        <a:pt x="122" y="492"/>
                      </a:lnTo>
                      <a:lnTo>
                        <a:pt x="124" y="494"/>
                      </a:lnTo>
                      <a:lnTo>
                        <a:pt x="126" y="496"/>
                      </a:lnTo>
                      <a:lnTo>
                        <a:pt x="128" y="498"/>
                      </a:lnTo>
                      <a:lnTo>
                        <a:pt x="130" y="500"/>
                      </a:lnTo>
                      <a:lnTo>
                        <a:pt x="132" y="500"/>
                      </a:lnTo>
                      <a:lnTo>
                        <a:pt x="134" y="502"/>
                      </a:lnTo>
                      <a:lnTo>
                        <a:pt x="136" y="504"/>
                      </a:lnTo>
                      <a:lnTo>
                        <a:pt x="138" y="504"/>
                      </a:lnTo>
                      <a:lnTo>
                        <a:pt x="140" y="504"/>
                      </a:lnTo>
                      <a:lnTo>
                        <a:pt x="142" y="504"/>
                      </a:lnTo>
                      <a:lnTo>
                        <a:pt x="144" y="506"/>
                      </a:lnTo>
                      <a:lnTo>
                        <a:pt x="146" y="506"/>
                      </a:lnTo>
                      <a:lnTo>
                        <a:pt x="148" y="506"/>
                      </a:lnTo>
                      <a:lnTo>
                        <a:pt x="150" y="506"/>
                      </a:lnTo>
                      <a:lnTo>
                        <a:pt x="152" y="506"/>
                      </a:lnTo>
                      <a:lnTo>
                        <a:pt x="154" y="506"/>
                      </a:lnTo>
                      <a:lnTo>
                        <a:pt x="156" y="508"/>
                      </a:lnTo>
                      <a:lnTo>
                        <a:pt x="158" y="508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08"/>
                      </a:lnTo>
                      <a:lnTo>
                        <a:pt x="176" y="508"/>
                      </a:lnTo>
                      <a:lnTo>
                        <a:pt x="178" y="508"/>
                      </a:lnTo>
                      <a:lnTo>
                        <a:pt x="180" y="508"/>
                      </a:lnTo>
                      <a:lnTo>
                        <a:pt x="182" y="508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10"/>
                      </a:lnTo>
                      <a:lnTo>
                        <a:pt x="216" y="510"/>
                      </a:lnTo>
                      <a:lnTo>
                        <a:pt x="218" y="510"/>
                      </a:lnTo>
                      <a:lnTo>
                        <a:pt x="220" y="510"/>
                      </a:lnTo>
                      <a:lnTo>
                        <a:pt x="222" y="510"/>
                      </a:lnTo>
                      <a:lnTo>
                        <a:pt x="224" y="510"/>
                      </a:lnTo>
                      <a:lnTo>
                        <a:pt x="226" y="510"/>
                      </a:lnTo>
                      <a:lnTo>
                        <a:pt x="228" y="510"/>
                      </a:lnTo>
                      <a:lnTo>
                        <a:pt x="230" y="510"/>
                      </a:lnTo>
                      <a:lnTo>
                        <a:pt x="232" y="510"/>
                      </a:lnTo>
                      <a:lnTo>
                        <a:pt x="234" y="510"/>
                      </a:lnTo>
                      <a:lnTo>
                        <a:pt x="236" y="510"/>
                      </a:lnTo>
                      <a:lnTo>
                        <a:pt x="238" y="510"/>
                      </a:lnTo>
                      <a:lnTo>
                        <a:pt x="240" y="510"/>
                      </a:lnTo>
                      <a:lnTo>
                        <a:pt x="242" y="510"/>
                      </a:lnTo>
                      <a:lnTo>
                        <a:pt x="244" y="510"/>
                      </a:lnTo>
                      <a:lnTo>
                        <a:pt x="246" y="510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10"/>
                      </a:lnTo>
                      <a:lnTo>
                        <a:pt x="254" y="510"/>
                      </a:lnTo>
                      <a:lnTo>
                        <a:pt x="256" y="510"/>
                      </a:lnTo>
                      <a:lnTo>
                        <a:pt x="258" y="510"/>
                      </a:lnTo>
                      <a:lnTo>
                        <a:pt x="260" y="510"/>
                      </a:lnTo>
                      <a:lnTo>
                        <a:pt x="262" y="510"/>
                      </a:lnTo>
                      <a:lnTo>
                        <a:pt x="264" y="510"/>
                      </a:lnTo>
                      <a:lnTo>
                        <a:pt x="266" y="510"/>
                      </a:lnTo>
                      <a:lnTo>
                        <a:pt x="268" y="510"/>
                      </a:lnTo>
                      <a:lnTo>
                        <a:pt x="270" y="510"/>
                      </a:lnTo>
                      <a:lnTo>
                        <a:pt x="272" y="510"/>
                      </a:lnTo>
                      <a:lnTo>
                        <a:pt x="274" y="510"/>
                      </a:lnTo>
                      <a:lnTo>
                        <a:pt x="276" y="510"/>
                      </a:lnTo>
                      <a:lnTo>
                        <a:pt x="278" y="510"/>
                      </a:lnTo>
                      <a:lnTo>
                        <a:pt x="280" y="510"/>
                      </a:lnTo>
                      <a:lnTo>
                        <a:pt x="282" y="510"/>
                      </a:lnTo>
                      <a:lnTo>
                        <a:pt x="284" y="510"/>
                      </a:lnTo>
                      <a:lnTo>
                        <a:pt x="286" y="510"/>
                      </a:lnTo>
                      <a:lnTo>
                        <a:pt x="288" y="510"/>
                      </a:lnTo>
                      <a:lnTo>
                        <a:pt x="290" y="510"/>
                      </a:lnTo>
                      <a:lnTo>
                        <a:pt x="292" y="510"/>
                      </a:lnTo>
                      <a:lnTo>
                        <a:pt x="294" y="510"/>
                      </a:lnTo>
                      <a:lnTo>
                        <a:pt x="296" y="510"/>
                      </a:lnTo>
                      <a:lnTo>
                        <a:pt x="298" y="510"/>
                      </a:lnTo>
                      <a:lnTo>
                        <a:pt x="300" y="510"/>
                      </a:lnTo>
                      <a:lnTo>
                        <a:pt x="302" y="510"/>
                      </a:lnTo>
                      <a:lnTo>
                        <a:pt x="304" y="510"/>
                      </a:lnTo>
                      <a:lnTo>
                        <a:pt x="306" y="510"/>
                      </a:lnTo>
                      <a:lnTo>
                        <a:pt x="308" y="508"/>
                      </a:lnTo>
                      <a:lnTo>
                        <a:pt x="310" y="508"/>
                      </a:lnTo>
                      <a:lnTo>
                        <a:pt x="312" y="508"/>
                      </a:lnTo>
                      <a:lnTo>
                        <a:pt x="314" y="508"/>
                      </a:lnTo>
                      <a:lnTo>
                        <a:pt x="316" y="508"/>
                      </a:lnTo>
                      <a:lnTo>
                        <a:pt x="318" y="508"/>
                      </a:lnTo>
                      <a:lnTo>
                        <a:pt x="320" y="508"/>
                      </a:lnTo>
                      <a:lnTo>
                        <a:pt x="322" y="508"/>
                      </a:lnTo>
                      <a:lnTo>
                        <a:pt x="324" y="508"/>
                      </a:lnTo>
                      <a:lnTo>
                        <a:pt x="326" y="508"/>
                      </a:lnTo>
                      <a:lnTo>
                        <a:pt x="328" y="508"/>
                      </a:lnTo>
                      <a:lnTo>
                        <a:pt x="330" y="508"/>
                      </a:lnTo>
                      <a:lnTo>
                        <a:pt x="332" y="508"/>
                      </a:lnTo>
                      <a:lnTo>
                        <a:pt x="334" y="508"/>
                      </a:lnTo>
                      <a:lnTo>
                        <a:pt x="336" y="508"/>
                      </a:lnTo>
                      <a:lnTo>
                        <a:pt x="338" y="508"/>
                      </a:lnTo>
                      <a:lnTo>
                        <a:pt x="340" y="508"/>
                      </a:lnTo>
                      <a:lnTo>
                        <a:pt x="342" y="508"/>
                      </a:lnTo>
                      <a:lnTo>
                        <a:pt x="344" y="508"/>
                      </a:lnTo>
                      <a:lnTo>
                        <a:pt x="346" y="510"/>
                      </a:lnTo>
                      <a:lnTo>
                        <a:pt x="348" y="510"/>
                      </a:lnTo>
                      <a:lnTo>
                        <a:pt x="350" y="510"/>
                      </a:lnTo>
                      <a:lnTo>
                        <a:pt x="352" y="510"/>
                      </a:lnTo>
                      <a:lnTo>
                        <a:pt x="354" y="510"/>
                      </a:lnTo>
                      <a:lnTo>
                        <a:pt x="356" y="510"/>
                      </a:lnTo>
                      <a:lnTo>
                        <a:pt x="358" y="510"/>
                      </a:lnTo>
                      <a:lnTo>
                        <a:pt x="360" y="510"/>
                      </a:lnTo>
                      <a:lnTo>
                        <a:pt x="362" y="510"/>
                      </a:lnTo>
                      <a:lnTo>
                        <a:pt x="364" y="510"/>
                      </a:lnTo>
                      <a:lnTo>
                        <a:pt x="366" y="510"/>
                      </a:lnTo>
                      <a:lnTo>
                        <a:pt x="368" y="510"/>
                      </a:lnTo>
                      <a:lnTo>
                        <a:pt x="370" y="510"/>
                      </a:lnTo>
                      <a:lnTo>
                        <a:pt x="372" y="510"/>
                      </a:lnTo>
                      <a:lnTo>
                        <a:pt x="374" y="510"/>
                      </a:lnTo>
                      <a:lnTo>
                        <a:pt x="376" y="510"/>
                      </a:lnTo>
                      <a:lnTo>
                        <a:pt x="378" y="510"/>
                      </a:lnTo>
                      <a:lnTo>
                        <a:pt x="380" y="510"/>
                      </a:lnTo>
                      <a:lnTo>
                        <a:pt x="382" y="510"/>
                      </a:lnTo>
                      <a:lnTo>
                        <a:pt x="384" y="510"/>
                      </a:lnTo>
                      <a:lnTo>
                        <a:pt x="386" y="510"/>
                      </a:lnTo>
                      <a:lnTo>
                        <a:pt x="388" y="510"/>
                      </a:lnTo>
                      <a:lnTo>
                        <a:pt x="390" y="510"/>
                      </a:lnTo>
                      <a:lnTo>
                        <a:pt x="392" y="510"/>
                      </a:lnTo>
                      <a:lnTo>
                        <a:pt x="394" y="510"/>
                      </a:lnTo>
                      <a:lnTo>
                        <a:pt x="396" y="510"/>
                      </a:lnTo>
                      <a:lnTo>
                        <a:pt x="398" y="510"/>
                      </a:lnTo>
                      <a:lnTo>
                        <a:pt x="400" y="510"/>
                      </a:lnTo>
                      <a:lnTo>
                        <a:pt x="402" y="510"/>
                      </a:lnTo>
                      <a:lnTo>
                        <a:pt x="404" y="510"/>
                      </a:lnTo>
                      <a:lnTo>
                        <a:pt x="406" y="510"/>
                      </a:lnTo>
                      <a:lnTo>
                        <a:pt x="408" y="510"/>
                      </a:lnTo>
                      <a:lnTo>
                        <a:pt x="410" y="510"/>
                      </a:lnTo>
                      <a:lnTo>
                        <a:pt x="412" y="510"/>
                      </a:lnTo>
                      <a:lnTo>
                        <a:pt x="414" y="510"/>
                      </a:lnTo>
                      <a:lnTo>
                        <a:pt x="416" y="510"/>
                      </a:lnTo>
                      <a:lnTo>
                        <a:pt x="418" y="510"/>
                      </a:lnTo>
                      <a:lnTo>
                        <a:pt x="420" y="510"/>
                      </a:lnTo>
                      <a:lnTo>
                        <a:pt x="422" y="510"/>
                      </a:lnTo>
                      <a:lnTo>
                        <a:pt x="424" y="510"/>
                      </a:lnTo>
                      <a:lnTo>
                        <a:pt x="426" y="510"/>
                      </a:lnTo>
                      <a:lnTo>
                        <a:pt x="428" y="510"/>
                      </a:lnTo>
                      <a:lnTo>
                        <a:pt x="430" y="510"/>
                      </a:lnTo>
                      <a:lnTo>
                        <a:pt x="432" y="510"/>
                      </a:lnTo>
                      <a:lnTo>
                        <a:pt x="434" y="510"/>
                      </a:lnTo>
                      <a:lnTo>
                        <a:pt x="436" y="510"/>
                      </a:lnTo>
                      <a:lnTo>
                        <a:pt x="438" y="510"/>
                      </a:lnTo>
                      <a:lnTo>
                        <a:pt x="440" y="510"/>
                      </a:lnTo>
                      <a:lnTo>
                        <a:pt x="442" y="510"/>
                      </a:lnTo>
                      <a:lnTo>
                        <a:pt x="444" y="510"/>
                      </a:lnTo>
                      <a:lnTo>
                        <a:pt x="446" y="510"/>
                      </a:lnTo>
                      <a:lnTo>
                        <a:pt x="448" y="510"/>
                      </a:lnTo>
                      <a:lnTo>
                        <a:pt x="450" y="510"/>
                      </a:lnTo>
                      <a:lnTo>
                        <a:pt x="452" y="510"/>
                      </a:lnTo>
                      <a:lnTo>
                        <a:pt x="454" y="510"/>
                      </a:lnTo>
                      <a:lnTo>
                        <a:pt x="456" y="510"/>
                      </a:lnTo>
                      <a:lnTo>
                        <a:pt x="458" y="510"/>
                      </a:lnTo>
                      <a:lnTo>
                        <a:pt x="460" y="510"/>
                      </a:lnTo>
                      <a:lnTo>
                        <a:pt x="462" y="510"/>
                      </a:lnTo>
                      <a:lnTo>
                        <a:pt x="464" y="510"/>
                      </a:lnTo>
                      <a:lnTo>
                        <a:pt x="466" y="510"/>
                      </a:lnTo>
                      <a:lnTo>
                        <a:pt x="468" y="510"/>
                      </a:lnTo>
                      <a:lnTo>
                        <a:pt x="470" y="510"/>
                      </a:lnTo>
                      <a:lnTo>
                        <a:pt x="472" y="510"/>
                      </a:lnTo>
                      <a:lnTo>
                        <a:pt x="474" y="510"/>
                      </a:lnTo>
                      <a:lnTo>
                        <a:pt x="476" y="510"/>
                      </a:lnTo>
                      <a:lnTo>
                        <a:pt x="478" y="510"/>
                      </a:lnTo>
                      <a:lnTo>
                        <a:pt x="480" y="510"/>
                      </a:lnTo>
                      <a:lnTo>
                        <a:pt x="482" y="510"/>
                      </a:lnTo>
                      <a:lnTo>
                        <a:pt x="484" y="510"/>
                      </a:lnTo>
                      <a:lnTo>
                        <a:pt x="486" y="510"/>
                      </a:lnTo>
                      <a:lnTo>
                        <a:pt x="488" y="510"/>
                      </a:lnTo>
                      <a:lnTo>
                        <a:pt x="490" y="510"/>
                      </a:lnTo>
                      <a:lnTo>
                        <a:pt x="492" y="510"/>
                      </a:lnTo>
                      <a:lnTo>
                        <a:pt x="494" y="510"/>
                      </a:lnTo>
                      <a:lnTo>
                        <a:pt x="496" y="510"/>
                      </a:lnTo>
                      <a:lnTo>
                        <a:pt x="498" y="510"/>
                      </a:lnTo>
                      <a:lnTo>
                        <a:pt x="500" y="510"/>
                      </a:lnTo>
                      <a:lnTo>
                        <a:pt x="502" y="510"/>
                      </a:lnTo>
                      <a:lnTo>
                        <a:pt x="504" y="510"/>
                      </a:lnTo>
                      <a:lnTo>
                        <a:pt x="506" y="510"/>
                      </a:lnTo>
                      <a:lnTo>
                        <a:pt x="508" y="510"/>
                      </a:lnTo>
                    </a:path>
                  </a:pathLst>
                </a:custGeom>
                <a:noFill/>
                <a:ln w="6480">
                  <a:solidFill>
                    <a:srgbClr val="cccccc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15" name="Freeform 216"/>
              <p:cNvSpPr/>
              <p:nvPr/>
            </p:nvSpPr>
            <p:spPr>
              <a:xfrm>
                <a:off x="2269080" y="1321200"/>
                <a:ext cx="1034640" cy="990360"/>
              </a:xfrm>
              <a:custGeom>
                <a:avLst/>
                <a:gdLst>
                  <a:gd name="textAreaLeft" fmla="*/ 0 w 1034640"/>
                  <a:gd name="textAreaRight" fmla="*/ 1035000 w 1034640"/>
                  <a:gd name="textAreaTop" fmla="*/ 0 h 990360"/>
                  <a:gd name="textAreaBottom" fmla="*/ 990720 h 99036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2" y="486"/>
                    </a:lnTo>
                    <a:lnTo>
                      <a:pt x="4" y="486"/>
                    </a:lnTo>
                    <a:lnTo>
                      <a:pt x="6" y="486"/>
                    </a:lnTo>
                    <a:lnTo>
                      <a:pt x="8" y="486"/>
                    </a:lnTo>
                    <a:lnTo>
                      <a:pt x="10" y="486"/>
                    </a:lnTo>
                    <a:lnTo>
                      <a:pt x="12" y="486"/>
                    </a:lnTo>
                    <a:lnTo>
                      <a:pt x="14" y="486"/>
                    </a:lnTo>
                    <a:lnTo>
                      <a:pt x="16" y="486"/>
                    </a:lnTo>
                    <a:lnTo>
                      <a:pt x="18" y="486"/>
                    </a:lnTo>
                    <a:lnTo>
                      <a:pt x="20" y="486"/>
                    </a:lnTo>
                    <a:lnTo>
                      <a:pt x="22" y="486"/>
                    </a:lnTo>
                    <a:lnTo>
                      <a:pt x="24" y="486"/>
                    </a:lnTo>
                    <a:lnTo>
                      <a:pt x="26" y="486"/>
                    </a:lnTo>
                    <a:lnTo>
                      <a:pt x="28" y="486"/>
                    </a:lnTo>
                    <a:lnTo>
                      <a:pt x="30" y="486"/>
                    </a:lnTo>
                    <a:lnTo>
                      <a:pt x="32" y="486"/>
                    </a:lnTo>
                    <a:lnTo>
                      <a:pt x="34" y="486"/>
                    </a:lnTo>
                    <a:lnTo>
                      <a:pt x="36" y="486"/>
                    </a:lnTo>
                    <a:lnTo>
                      <a:pt x="38" y="486"/>
                    </a:lnTo>
                    <a:lnTo>
                      <a:pt x="40" y="486"/>
                    </a:lnTo>
                    <a:lnTo>
                      <a:pt x="42" y="486"/>
                    </a:lnTo>
                    <a:lnTo>
                      <a:pt x="44" y="486"/>
                    </a:lnTo>
                    <a:lnTo>
                      <a:pt x="46" y="486"/>
                    </a:lnTo>
                    <a:lnTo>
                      <a:pt x="48" y="486"/>
                    </a:lnTo>
                    <a:lnTo>
                      <a:pt x="50" y="486"/>
                    </a:lnTo>
                    <a:lnTo>
                      <a:pt x="52" y="486"/>
                    </a:lnTo>
                    <a:lnTo>
                      <a:pt x="54" y="486"/>
                    </a:lnTo>
                    <a:lnTo>
                      <a:pt x="56" y="486"/>
                    </a:lnTo>
                    <a:lnTo>
                      <a:pt x="58" y="486"/>
                    </a:lnTo>
                    <a:lnTo>
                      <a:pt x="60" y="486"/>
                    </a:lnTo>
                    <a:lnTo>
                      <a:pt x="62" y="486"/>
                    </a:lnTo>
                    <a:lnTo>
                      <a:pt x="64" y="486"/>
                    </a:lnTo>
                    <a:lnTo>
                      <a:pt x="66" y="486"/>
                    </a:lnTo>
                    <a:lnTo>
                      <a:pt x="68" y="486"/>
                    </a:lnTo>
                    <a:lnTo>
                      <a:pt x="70" y="486"/>
                    </a:lnTo>
                    <a:lnTo>
                      <a:pt x="72" y="486"/>
                    </a:lnTo>
                    <a:lnTo>
                      <a:pt x="74" y="486"/>
                    </a:lnTo>
                    <a:lnTo>
                      <a:pt x="76" y="486"/>
                    </a:lnTo>
                    <a:lnTo>
                      <a:pt x="78" y="486"/>
                    </a:lnTo>
                    <a:lnTo>
                      <a:pt x="80" y="486"/>
                    </a:lnTo>
                    <a:lnTo>
                      <a:pt x="82" y="486"/>
                    </a:lnTo>
                    <a:lnTo>
                      <a:pt x="84" y="484"/>
                    </a:lnTo>
                    <a:lnTo>
                      <a:pt x="86" y="484"/>
                    </a:lnTo>
                    <a:lnTo>
                      <a:pt x="88" y="484"/>
                    </a:lnTo>
                    <a:lnTo>
                      <a:pt x="90" y="484"/>
                    </a:lnTo>
                    <a:lnTo>
                      <a:pt x="92" y="484"/>
                    </a:lnTo>
                    <a:lnTo>
                      <a:pt x="94" y="484"/>
                    </a:lnTo>
                    <a:lnTo>
                      <a:pt x="96" y="484"/>
                    </a:lnTo>
                    <a:lnTo>
                      <a:pt x="98" y="484"/>
                    </a:lnTo>
                    <a:lnTo>
                      <a:pt x="100" y="484"/>
                    </a:lnTo>
                    <a:lnTo>
                      <a:pt x="102" y="484"/>
                    </a:lnTo>
                    <a:lnTo>
                      <a:pt x="104" y="484"/>
                    </a:lnTo>
                    <a:lnTo>
                      <a:pt x="106" y="484"/>
                    </a:lnTo>
                    <a:lnTo>
                      <a:pt x="108" y="484"/>
                    </a:lnTo>
                    <a:lnTo>
                      <a:pt x="110" y="484"/>
                    </a:lnTo>
                    <a:lnTo>
                      <a:pt x="112" y="484"/>
                    </a:lnTo>
                    <a:lnTo>
                      <a:pt x="114" y="484"/>
                    </a:lnTo>
                    <a:lnTo>
                      <a:pt x="116" y="484"/>
                    </a:lnTo>
                    <a:lnTo>
                      <a:pt x="118" y="482"/>
                    </a:lnTo>
                    <a:lnTo>
                      <a:pt x="120" y="482"/>
                    </a:lnTo>
                    <a:lnTo>
                      <a:pt x="122" y="480"/>
                    </a:lnTo>
                    <a:lnTo>
                      <a:pt x="124" y="480"/>
                    </a:lnTo>
                    <a:lnTo>
                      <a:pt x="126" y="478"/>
                    </a:lnTo>
                    <a:lnTo>
                      <a:pt x="128" y="476"/>
                    </a:lnTo>
                    <a:lnTo>
                      <a:pt x="130" y="472"/>
                    </a:lnTo>
                    <a:lnTo>
                      <a:pt x="132" y="466"/>
                    </a:lnTo>
                    <a:lnTo>
                      <a:pt x="134" y="458"/>
                    </a:lnTo>
                    <a:lnTo>
                      <a:pt x="136" y="450"/>
                    </a:lnTo>
                    <a:lnTo>
                      <a:pt x="138" y="440"/>
                    </a:lnTo>
                    <a:lnTo>
                      <a:pt x="140" y="432"/>
                    </a:lnTo>
                    <a:lnTo>
                      <a:pt x="142" y="424"/>
                    </a:lnTo>
                    <a:lnTo>
                      <a:pt x="144" y="412"/>
                    </a:lnTo>
                    <a:lnTo>
                      <a:pt x="146" y="400"/>
                    </a:lnTo>
                    <a:lnTo>
                      <a:pt x="148" y="384"/>
                    </a:lnTo>
                    <a:lnTo>
                      <a:pt x="150" y="366"/>
                    </a:lnTo>
                    <a:lnTo>
                      <a:pt x="152" y="346"/>
                    </a:lnTo>
                    <a:lnTo>
                      <a:pt x="154" y="320"/>
                    </a:lnTo>
                    <a:lnTo>
                      <a:pt x="156" y="300"/>
                    </a:lnTo>
                    <a:lnTo>
                      <a:pt x="158" y="286"/>
                    </a:lnTo>
                    <a:lnTo>
                      <a:pt x="160" y="278"/>
                    </a:lnTo>
                    <a:lnTo>
                      <a:pt x="162" y="264"/>
                    </a:lnTo>
                    <a:lnTo>
                      <a:pt x="164" y="248"/>
                    </a:lnTo>
                    <a:lnTo>
                      <a:pt x="166" y="228"/>
                    </a:lnTo>
                    <a:lnTo>
                      <a:pt x="168" y="208"/>
                    </a:lnTo>
                    <a:lnTo>
                      <a:pt x="170" y="188"/>
                    </a:lnTo>
                    <a:lnTo>
                      <a:pt x="172" y="180"/>
                    </a:lnTo>
                    <a:lnTo>
                      <a:pt x="174" y="166"/>
                    </a:lnTo>
                    <a:lnTo>
                      <a:pt x="176" y="134"/>
                    </a:lnTo>
                    <a:lnTo>
                      <a:pt x="178" y="106"/>
                    </a:lnTo>
                    <a:lnTo>
                      <a:pt x="180" y="98"/>
                    </a:lnTo>
                    <a:lnTo>
                      <a:pt x="182" y="88"/>
                    </a:lnTo>
                    <a:lnTo>
                      <a:pt x="184" y="76"/>
                    </a:lnTo>
                    <a:lnTo>
                      <a:pt x="186" y="62"/>
                    </a:lnTo>
                    <a:lnTo>
                      <a:pt x="188" y="50"/>
                    </a:lnTo>
                    <a:lnTo>
                      <a:pt x="190" y="66"/>
                    </a:lnTo>
                    <a:lnTo>
                      <a:pt x="192" y="78"/>
                    </a:lnTo>
                    <a:lnTo>
                      <a:pt x="194" y="66"/>
                    </a:lnTo>
                    <a:lnTo>
                      <a:pt x="196" y="60"/>
                    </a:lnTo>
                    <a:lnTo>
                      <a:pt x="198" y="64"/>
                    </a:lnTo>
                    <a:lnTo>
                      <a:pt x="200" y="50"/>
                    </a:lnTo>
                    <a:lnTo>
                      <a:pt x="202" y="36"/>
                    </a:lnTo>
                    <a:lnTo>
                      <a:pt x="204" y="36"/>
                    </a:lnTo>
                    <a:lnTo>
                      <a:pt x="206" y="16"/>
                    </a:lnTo>
                    <a:lnTo>
                      <a:pt x="208" y="2"/>
                    </a:lnTo>
                    <a:lnTo>
                      <a:pt x="210" y="2"/>
                    </a:lnTo>
                    <a:lnTo>
                      <a:pt x="212" y="20"/>
                    </a:lnTo>
                    <a:lnTo>
                      <a:pt x="214" y="12"/>
                    </a:lnTo>
                    <a:lnTo>
                      <a:pt x="216" y="0"/>
                    </a:lnTo>
                    <a:lnTo>
                      <a:pt x="218" y="24"/>
                    </a:lnTo>
                    <a:lnTo>
                      <a:pt x="220" y="64"/>
                    </a:lnTo>
                    <a:lnTo>
                      <a:pt x="222" y="82"/>
                    </a:lnTo>
                    <a:lnTo>
                      <a:pt x="224" y="80"/>
                    </a:lnTo>
                    <a:lnTo>
                      <a:pt x="226" y="98"/>
                    </a:lnTo>
                    <a:lnTo>
                      <a:pt x="228" y="128"/>
                    </a:lnTo>
                    <a:lnTo>
                      <a:pt x="230" y="126"/>
                    </a:lnTo>
                    <a:lnTo>
                      <a:pt x="232" y="112"/>
                    </a:lnTo>
                    <a:lnTo>
                      <a:pt x="234" y="140"/>
                    </a:lnTo>
                    <a:lnTo>
                      <a:pt x="236" y="182"/>
                    </a:lnTo>
                    <a:lnTo>
                      <a:pt x="238" y="210"/>
                    </a:lnTo>
                    <a:lnTo>
                      <a:pt x="240" y="228"/>
                    </a:lnTo>
                    <a:lnTo>
                      <a:pt x="242" y="240"/>
                    </a:lnTo>
                    <a:lnTo>
                      <a:pt x="244" y="248"/>
                    </a:lnTo>
                    <a:lnTo>
                      <a:pt x="246" y="256"/>
                    </a:lnTo>
                    <a:lnTo>
                      <a:pt x="248" y="272"/>
                    </a:lnTo>
                    <a:lnTo>
                      <a:pt x="250" y="288"/>
                    </a:lnTo>
                    <a:lnTo>
                      <a:pt x="252" y="302"/>
                    </a:lnTo>
                    <a:lnTo>
                      <a:pt x="254" y="316"/>
                    </a:lnTo>
                    <a:lnTo>
                      <a:pt x="256" y="328"/>
                    </a:lnTo>
                    <a:lnTo>
                      <a:pt x="258" y="340"/>
                    </a:lnTo>
                    <a:lnTo>
                      <a:pt x="260" y="352"/>
                    </a:lnTo>
                    <a:lnTo>
                      <a:pt x="262" y="360"/>
                    </a:lnTo>
                    <a:lnTo>
                      <a:pt x="264" y="362"/>
                    </a:lnTo>
                    <a:lnTo>
                      <a:pt x="266" y="366"/>
                    </a:lnTo>
                    <a:lnTo>
                      <a:pt x="268" y="376"/>
                    </a:lnTo>
                    <a:lnTo>
                      <a:pt x="270" y="388"/>
                    </a:lnTo>
                    <a:lnTo>
                      <a:pt x="272" y="396"/>
                    </a:lnTo>
                    <a:lnTo>
                      <a:pt x="274" y="402"/>
                    </a:lnTo>
                    <a:lnTo>
                      <a:pt x="276" y="404"/>
                    </a:lnTo>
                    <a:lnTo>
                      <a:pt x="278" y="406"/>
                    </a:lnTo>
                    <a:lnTo>
                      <a:pt x="280" y="410"/>
                    </a:lnTo>
                    <a:lnTo>
                      <a:pt x="282" y="416"/>
                    </a:lnTo>
                    <a:lnTo>
                      <a:pt x="284" y="422"/>
                    </a:lnTo>
                    <a:lnTo>
                      <a:pt x="286" y="428"/>
                    </a:lnTo>
                    <a:lnTo>
                      <a:pt x="288" y="430"/>
                    </a:lnTo>
                    <a:lnTo>
                      <a:pt x="290" y="430"/>
                    </a:lnTo>
                    <a:lnTo>
                      <a:pt x="292" y="432"/>
                    </a:lnTo>
                    <a:lnTo>
                      <a:pt x="294" y="438"/>
                    </a:lnTo>
                    <a:lnTo>
                      <a:pt x="296" y="444"/>
                    </a:lnTo>
                    <a:lnTo>
                      <a:pt x="298" y="450"/>
                    </a:lnTo>
                    <a:lnTo>
                      <a:pt x="300" y="454"/>
                    </a:lnTo>
                    <a:lnTo>
                      <a:pt x="302" y="456"/>
                    </a:lnTo>
                    <a:lnTo>
                      <a:pt x="304" y="460"/>
                    </a:lnTo>
                    <a:lnTo>
                      <a:pt x="306" y="462"/>
                    </a:lnTo>
                    <a:lnTo>
                      <a:pt x="308" y="468"/>
                    </a:lnTo>
                    <a:lnTo>
                      <a:pt x="310" y="470"/>
                    </a:lnTo>
                    <a:lnTo>
                      <a:pt x="312" y="474"/>
                    </a:lnTo>
                    <a:lnTo>
                      <a:pt x="314" y="476"/>
                    </a:lnTo>
                    <a:lnTo>
                      <a:pt x="316" y="476"/>
                    </a:lnTo>
                    <a:lnTo>
                      <a:pt x="318" y="478"/>
                    </a:lnTo>
                    <a:lnTo>
                      <a:pt x="320" y="478"/>
                    </a:lnTo>
                    <a:lnTo>
                      <a:pt x="322" y="478"/>
                    </a:lnTo>
                    <a:lnTo>
                      <a:pt x="324" y="480"/>
                    </a:lnTo>
                    <a:lnTo>
                      <a:pt x="326" y="480"/>
                    </a:lnTo>
                    <a:lnTo>
                      <a:pt x="328" y="480"/>
                    </a:lnTo>
                    <a:lnTo>
                      <a:pt x="330" y="480"/>
                    </a:lnTo>
                    <a:lnTo>
                      <a:pt x="332" y="482"/>
                    </a:lnTo>
                    <a:lnTo>
                      <a:pt x="334" y="482"/>
                    </a:lnTo>
                    <a:lnTo>
                      <a:pt x="336" y="482"/>
                    </a:lnTo>
                    <a:lnTo>
                      <a:pt x="338" y="482"/>
                    </a:lnTo>
                    <a:lnTo>
                      <a:pt x="340" y="482"/>
                    </a:lnTo>
                    <a:lnTo>
                      <a:pt x="342" y="482"/>
                    </a:lnTo>
                    <a:lnTo>
                      <a:pt x="344" y="482"/>
                    </a:lnTo>
                    <a:lnTo>
                      <a:pt x="346" y="482"/>
                    </a:lnTo>
                    <a:lnTo>
                      <a:pt x="348" y="482"/>
                    </a:lnTo>
                    <a:lnTo>
                      <a:pt x="350" y="482"/>
                    </a:lnTo>
                    <a:lnTo>
                      <a:pt x="352" y="482"/>
                    </a:lnTo>
                    <a:lnTo>
                      <a:pt x="354" y="482"/>
                    </a:lnTo>
                    <a:lnTo>
                      <a:pt x="356" y="484"/>
                    </a:lnTo>
                    <a:lnTo>
                      <a:pt x="358" y="484"/>
                    </a:lnTo>
                    <a:lnTo>
                      <a:pt x="360" y="484"/>
                    </a:lnTo>
                    <a:lnTo>
                      <a:pt x="362" y="484"/>
                    </a:lnTo>
                    <a:lnTo>
                      <a:pt x="364" y="484"/>
                    </a:lnTo>
                    <a:lnTo>
                      <a:pt x="366" y="484"/>
                    </a:lnTo>
                    <a:lnTo>
                      <a:pt x="368" y="484"/>
                    </a:lnTo>
                    <a:lnTo>
                      <a:pt x="370" y="484"/>
                    </a:lnTo>
                    <a:lnTo>
                      <a:pt x="372" y="484"/>
                    </a:lnTo>
                    <a:lnTo>
                      <a:pt x="374" y="484"/>
                    </a:lnTo>
                    <a:lnTo>
                      <a:pt x="376" y="484"/>
                    </a:lnTo>
                    <a:lnTo>
                      <a:pt x="378" y="484"/>
                    </a:lnTo>
                    <a:lnTo>
                      <a:pt x="380" y="484"/>
                    </a:lnTo>
                    <a:lnTo>
                      <a:pt x="382" y="484"/>
                    </a:lnTo>
                    <a:lnTo>
                      <a:pt x="384" y="484"/>
                    </a:lnTo>
                    <a:lnTo>
                      <a:pt x="386" y="484"/>
                    </a:lnTo>
                    <a:lnTo>
                      <a:pt x="388" y="484"/>
                    </a:lnTo>
                    <a:lnTo>
                      <a:pt x="390" y="484"/>
                    </a:lnTo>
                    <a:lnTo>
                      <a:pt x="392" y="484"/>
                    </a:lnTo>
                    <a:lnTo>
                      <a:pt x="394" y="484"/>
                    </a:lnTo>
                    <a:lnTo>
                      <a:pt x="396" y="484"/>
                    </a:lnTo>
                    <a:lnTo>
                      <a:pt x="398" y="484"/>
                    </a:lnTo>
                    <a:lnTo>
                      <a:pt x="400" y="484"/>
                    </a:lnTo>
                    <a:lnTo>
                      <a:pt x="402" y="484"/>
                    </a:lnTo>
                    <a:lnTo>
                      <a:pt x="404" y="484"/>
                    </a:lnTo>
                    <a:lnTo>
                      <a:pt x="406" y="484"/>
                    </a:lnTo>
                    <a:lnTo>
                      <a:pt x="408" y="484"/>
                    </a:lnTo>
                    <a:lnTo>
                      <a:pt x="410" y="484"/>
                    </a:lnTo>
                    <a:lnTo>
                      <a:pt x="412" y="484"/>
                    </a:lnTo>
                    <a:lnTo>
                      <a:pt x="414" y="484"/>
                    </a:lnTo>
                    <a:lnTo>
                      <a:pt x="416" y="484"/>
                    </a:lnTo>
                    <a:lnTo>
                      <a:pt x="418" y="484"/>
                    </a:lnTo>
                    <a:lnTo>
                      <a:pt x="420" y="484"/>
                    </a:lnTo>
                    <a:lnTo>
                      <a:pt x="422" y="484"/>
                    </a:lnTo>
                    <a:lnTo>
                      <a:pt x="424" y="484"/>
                    </a:lnTo>
                    <a:lnTo>
                      <a:pt x="426" y="484"/>
                    </a:lnTo>
                    <a:lnTo>
                      <a:pt x="428" y="484"/>
                    </a:lnTo>
                    <a:lnTo>
                      <a:pt x="430" y="484"/>
                    </a:lnTo>
                    <a:lnTo>
                      <a:pt x="432" y="484"/>
                    </a:lnTo>
                    <a:lnTo>
                      <a:pt x="434" y="484"/>
                    </a:lnTo>
                    <a:lnTo>
                      <a:pt x="436" y="484"/>
                    </a:lnTo>
                    <a:lnTo>
                      <a:pt x="438" y="484"/>
                    </a:lnTo>
                    <a:lnTo>
                      <a:pt x="440" y="484"/>
                    </a:lnTo>
                    <a:lnTo>
                      <a:pt x="442" y="484"/>
                    </a:lnTo>
                    <a:lnTo>
                      <a:pt x="444" y="484"/>
                    </a:lnTo>
                    <a:lnTo>
                      <a:pt x="446" y="484"/>
                    </a:lnTo>
                    <a:lnTo>
                      <a:pt x="448" y="484"/>
                    </a:lnTo>
                    <a:lnTo>
                      <a:pt x="450" y="484"/>
                    </a:lnTo>
                    <a:lnTo>
                      <a:pt x="452" y="484"/>
                    </a:lnTo>
                    <a:lnTo>
                      <a:pt x="454" y="484"/>
                    </a:lnTo>
                    <a:lnTo>
                      <a:pt x="456" y="484"/>
                    </a:lnTo>
                    <a:lnTo>
                      <a:pt x="458" y="484"/>
                    </a:lnTo>
                    <a:lnTo>
                      <a:pt x="460" y="484"/>
                    </a:lnTo>
                    <a:lnTo>
                      <a:pt x="462" y="484"/>
                    </a:lnTo>
                    <a:lnTo>
                      <a:pt x="464" y="484"/>
                    </a:lnTo>
                    <a:lnTo>
                      <a:pt x="466" y="484"/>
                    </a:lnTo>
                    <a:lnTo>
                      <a:pt x="468" y="484"/>
                    </a:lnTo>
                    <a:lnTo>
                      <a:pt x="470" y="484"/>
                    </a:lnTo>
                    <a:lnTo>
                      <a:pt x="472" y="484"/>
                    </a:lnTo>
                    <a:lnTo>
                      <a:pt x="474" y="484"/>
                    </a:lnTo>
                    <a:lnTo>
                      <a:pt x="476" y="484"/>
                    </a:lnTo>
                    <a:lnTo>
                      <a:pt x="478" y="484"/>
                    </a:lnTo>
                    <a:lnTo>
                      <a:pt x="480" y="484"/>
                    </a:lnTo>
                    <a:lnTo>
                      <a:pt x="482" y="484"/>
                    </a:lnTo>
                    <a:lnTo>
                      <a:pt x="484" y="484"/>
                    </a:lnTo>
                    <a:lnTo>
                      <a:pt x="486" y="484"/>
                    </a:lnTo>
                    <a:lnTo>
                      <a:pt x="488" y="484"/>
                    </a:lnTo>
                    <a:lnTo>
                      <a:pt x="490" y="484"/>
                    </a:lnTo>
                    <a:lnTo>
                      <a:pt x="492" y="484"/>
                    </a:lnTo>
                    <a:lnTo>
                      <a:pt x="494" y="484"/>
                    </a:lnTo>
                    <a:lnTo>
                      <a:pt x="496" y="484"/>
                    </a:lnTo>
                    <a:lnTo>
                      <a:pt x="498" y="484"/>
                    </a:lnTo>
                    <a:lnTo>
                      <a:pt x="500" y="484"/>
                    </a:lnTo>
                    <a:lnTo>
                      <a:pt x="502" y="484"/>
                    </a:lnTo>
                    <a:lnTo>
                      <a:pt x="504" y="484"/>
                    </a:lnTo>
                    <a:lnTo>
                      <a:pt x="506" y="484"/>
                    </a:lnTo>
                    <a:lnTo>
                      <a:pt x="508" y="484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16" name="Text Box 33"/>
            <p:cNvSpPr/>
            <p:nvPr/>
          </p:nvSpPr>
          <p:spPr>
            <a:xfrm>
              <a:off x="2738520" y="1257480"/>
              <a:ext cx="868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52/100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17" name="Group 574"/>
          <p:cNvGrpSpPr/>
          <p:nvPr/>
        </p:nvGrpSpPr>
        <p:grpSpPr>
          <a:xfrm>
            <a:off x="3706200" y="2750760"/>
            <a:ext cx="1434240" cy="1148040"/>
            <a:chOff x="3706200" y="2750760"/>
            <a:chExt cx="1434240" cy="1148040"/>
          </a:xfrm>
        </p:grpSpPr>
        <p:grpSp>
          <p:nvGrpSpPr>
            <p:cNvPr id="818" name="Group 485"/>
            <p:cNvGrpSpPr/>
            <p:nvPr/>
          </p:nvGrpSpPr>
          <p:grpSpPr>
            <a:xfrm>
              <a:off x="3706200" y="2750760"/>
              <a:ext cx="1213200" cy="1148040"/>
              <a:chOff x="3706200" y="2750760"/>
              <a:chExt cx="1213200" cy="1148040"/>
            </a:xfrm>
          </p:grpSpPr>
          <p:grpSp>
            <p:nvGrpSpPr>
              <p:cNvPr id="819" name="Group 486"/>
              <p:cNvGrpSpPr/>
              <p:nvPr/>
            </p:nvGrpSpPr>
            <p:grpSpPr>
              <a:xfrm>
                <a:off x="3706200" y="2750760"/>
                <a:ext cx="1213200" cy="1148040"/>
                <a:chOff x="3706200" y="2750760"/>
                <a:chExt cx="1213200" cy="1148040"/>
              </a:xfrm>
            </p:grpSpPr>
            <p:sp>
              <p:nvSpPr>
                <p:cNvPr id="820" name="Rectangle 487"/>
                <p:cNvSpPr/>
                <p:nvPr/>
              </p:nvSpPr>
              <p:spPr>
                <a:xfrm>
                  <a:off x="3836160" y="2753280"/>
                  <a:ext cx="1048320" cy="104940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821" name="Group 488"/>
                <p:cNvGrpSpPr/>
                <p:nvPr/>
              </p:nvGrpSpPr>
              <p:grpSpPr>
                <a:xfrm>
                  <a:off x="3792240" y="3800880"/>
                  <a:ext cx="1127160" cy="97920"/>
                  <a:chOff x="3792240" y="3800880"/>
                  <a:chExt cx="1127160" cy="97920"/>
                </a:xfrm>
              </p:grpSpPr>
              <p:sp>
                <p:nvSpPr>
                  <p:cNvPr id="822" name="Line 489"/>
                  <p:cNvSpPr/>
                  <p:nvPr/>
                </p:nvSpPr>
                <p:spPr>
                  <a:xfrm>
                    <a:off x="3834000" y="3800880"/>
                    <a:ext cx="104796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823" name="Group 490"/>
                  <p:cNvGrpSpPr/>
                  <p:nvPr/>
                </p:nvGrpSpPr>
                <p:grpSpPr>
                  <a:xfrm>
                    <a:off x="3834000" y="3804840"/>
                    <a:ext cx="1047600" cy="23760"/>
                    <a:chOff x="3834000" y="3804840"/>
                    <a:chExt cx="1047600" cy="23760"/>
                  </a:xfrm>
                </p:grpSpPr>
                <p:sp>
                  <p:nvSpPr>
                    <p:cNvPr id="824" name="Line 491"/>
                    <p:cNvSpPr/>
                    <p:nvPr/>
                  </p:nvSpPr>
                  <p:spPr>
                    <a:xfrm>
                      <a:off x="3834000" y="380484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5" name="Line 492"/>
                    <p:cNvSpPr/>
                    <p:nvPr/>
                  </p:nvSpPr>
                  <p:spPr>
                    <a:xfrm>
                      <a:off x="391140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6" name="Line 493"/>
                    <p:cNvSpPr/>
                    <p:nvPr/>
                  </p:nvSpPr>
                  <p:spPr>
                    <a:xfrm>
                      <a:off x="395604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7" name="Line 494"/>
                    <p:cNvSpPr/>
                    <p:nvPr/>
                  </p:nvSpPr>
                  <p:spPr>
                    <a:xfrm>
                      <a:off x="398844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8" name="Line 495"/>
                    <p:cNvSpPr/>
                    <p:nvPr/>
                  </p:nvSpPr>
                  <p:spPr>
                    <a:xfrm>
                      <a:off x="4016880" y="380484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29" name="Line 496"/>
                    <p:cNvSpPr/>
                    <p:nvPr/>
                  </p:nvSpPr>
                  <p:spPr>
                    <a:xfrm>
                      <a:off x="403740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0" name="Line 497"/>
                    <p:cNvSpPr/>
                    <p:nvPr/>
                  </p:nvSpPr>
                  <p:spPr>
                    <a:xfrm>
                      <a:off x="405360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1" name="Line 498"/>
                    <p:cNvSpPr/>
                    <p:nvPr/>
                  </p:nvSpPr>
                  <p:spPr>
                    <a:xfrm>
                      <a:off x="406944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2" name="Line 499"/>
                    <p:cNvSpPr/>
                    <p:nvPr/>
                  </p:nvSpPr>
                  <p:spPr>
                    <a:xfrm>
                      <a:off x="408204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3" name="Line 500"/>
                    <p:cNvSpPr/>
                    <p:nvPr/>
                  </p:nvSpPr>
                  <p:spPr>
                    <a:xfrm>
                      <a:off x="4093920" y="380484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4" name="Line 501"/>
                    <p:cNvSpPr/>
                    <p:nvPr/>
                  </p:nvSpPr>
                  <p:spPr>
                    <a:xfrm>
                      <a:off x="417564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5" name="Line 502"/>
                    <p:cNvSpPr/>
                    <p:nvPr/>
                  </p:nvSpPr>
                  <p:spPr>
                    <a:xfrm>
                      <a:off x="422064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6" name="Line 503"/>
                    <p:cNvSpPr/>
                    <p:nvPr/>
                  </p:nvSpPr>
                  <p:spPr>
                    <a:xfrm>
                      <a:off x="425268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7" name="Line 504"/>
                    <p:cNvSpPr/>
                    <p:nvPr/>
                  </p:nvSpPr>
                  <p:spPr>
                    <a:xfrm>
                      <a:off x="4277160" y="380484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8" name="Line 505"/>
                    <p:cNvSpPr/>
                    <p:nvPr/>
                  </p:nvSpPr>
                  <p:spPr>
                    <a:xfrm>
                      <a:off x="430164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39" name="Line 506"/>
                    <p:cNvSpPr/>
                    <p:nvPr/>
                  </p:nvSpPr>
                  <p:spPr>
                    <a:xfrm>
                      <a:off x="431784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0" name="Line 507"/>
                    <p:cNvSpPr/>
                    <p:nvPr/>
                  </p:nvSpPr>
                  <p:spPr>
                    <a:xfrm>
                      <a:off x="433440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1" name="Line 508"/>
                    <p:cNvSpPr/>
                    <p:nvPr/>
                  </p:nvSpPr>
                  <p:spPr>
                    <a:xfrm>
                      <a:off x="434628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2" name="Line 509"/>
                    <p:cNvSpPr/>
                    <p:nvPr/>
                  </p:nvSpPr>
                  <p:spPr>
                    <a:xfrm>
                      <a:off x="4358880" y="380484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3" name="Line 510"/>
                    <p:cNvSpPr/>
                    <p:nvPr/>
                  </p:nvSpPr>
                  <p:spPr>
                    <a:xfrm>
                      <a:off x="443412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4" name="Line 511"/>
                    <p:cNvSpPr/>
                    <p:nvPr/>
                  </p:nvSpPr>
                  <p:spPr>
                    <a:xfrm>
                      <a:off x="448308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5" name="Line 512"/>
                    <p:cNvSpPr/>
                    <p:nvPr/>
                  </p:nvSpPr>
                  <p:spPr>
                    <a:xfrm>
                      <a:off x="451548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6" name="Line 513"/>
                    <p:cNvSpPr/>
                    <p:nvPr/>
                  </p:nvSpPr>
                  <p:spPr>
                    <a:xfrm>
                      <a:off x="4539600" y="380484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7" name="Line 514"/>
                    <p:cNvSpPr/>
                    <p:nvPr/>
                  </p:nvSpPr>
                  <p:spPr>
                    <a:xfrm>
                      <a:off x="456012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8" name="Line 515"/>
                    <p:cNvSpPr/>
                    <p:nvPr/>
                  </p:nvSpPr>
                  <p:spPr>
                    <a:xfrm>
                      <a:off x="458028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49" name="Line 516"/>
                    <p:cNvSpPr/>
                    <p:nvPr/>
                  </p:nvSpPr>
                  <p:spPr>
                    <a:xfrm>
                      <a:off x="459288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0" name="Line 517"/>
                    <p:cNvSpPr/>
                    <p:nvPr/>
                  </p:nvSpPr>
                  <p:spPr>
                    <a:xfrm>
                      <a:off x="460908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1" name="Line 518"/>
                    <p:cNvSpPr/>
                    <p:nvPr/>
                  </p:nvSpPr>
                  <p:spPr>
                    <a:xfrm>
                      <a:off x="4620960" y="380484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2" name="Line 519"/>
                    <p:cNvSpPr/>
                    <p:nvPr/>
                  </p:nvSpPr>
                  <p:spPr>
                    <a:xfrm>
                      <a:off x="469836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3" name="Line 520"/>
                    <p:cNvSpPr/>
                    <p:nvPr/>
                  </p:nvSpPr>
                  <p:spPr>
                    <a:xfrm>
                      <a:off x="474732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4" name="Line 521"/>
                    <p:cNvSpPr/>
                    <p:nvPr/>
                  </p:nvSpPr>
                  <p:spPr>
                    <a:xfrm>
                      <a:off x="477972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5" name="Line 522"/>
                    <p:cNvSpPr/>
                    <p:nvPr/>
                  </p:nvSpPr>
                  <p:spPr>
                    <a:xfrm>
                      <a:off x="4804200" y="380484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6" name="Line 523"/>
                    <p:cNvSpPr/>
                    <p:nvPr/>
                  </p:nvSpPr>
                  <p:spPr>
                    <a:xfrm>
                      <a:off x="482436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7" name="Line 524"/>
                    <p:cNvSpPr/>
                    <p:nvPr/>
                  </p:nvSpPr>
                  <p:spPr>
                    <a:xfrm>
                      <a:off x="484092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8" name="Line 525"/>
                    <p:cNvSpPr/>
                    <p:nvPr/>
                  </p:nvSpPr>
                  <p:spPr>
                    <a:xfrm>
                      <a:off x="485712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59" name="Line 526"/>
                    <p:cNvSpPr/>
                    <p:nvPr/>
                  </p:nvSpPr>
                  <p:spPr>
                    <a:xfrm>
                      <a:off x="4869360" y="3804840"/>
                      <a:ext cx="0" cy="75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9240" bIns="-392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0" name="Line 527"/>
                    <p:cNvSpPr/>
                    <p:nvPr/>
                  </p:nvSpPr>
                  <p:spPr>
                    <a:xfrm>
                      <a:off x="4881600" y="380484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861" name="Group 528"/>
                  <p:cNvGrpSpPr/>
                  <p:nvPr/>
                </p:nvGrpSpPr>
                <p:grpSpPr>
                  <a:xfrm>
                    <a:off x="3792240" y="3836880"/>
                    <a:ext cx="1127160" cy="61920"/>
                    <a:chOff x="3792240" y="3836880"/>
                    <a:chExt cx="1127160" cy="61920"/>
                  </a:xfrm>
                </p:grpSpPr>
                <p:sp>
                  <p:nvSpPr>
                    <p:cNvPr id="862" name="Rectangle 529"/>
                    <p:cNvSpPr/>
                    <p:nvPr/>
                  </p:nvSpPr>
                  <p:spPr>
                    <a:xfrm>
                      <a:off x="3792240" y="3852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3" name="Rectangle 530"/>
                    <p:cNvSpPr/>
                    <p:nvPr/>
                  </p:nvSpPr>
                  <p:spPr>
                    <a:xfrm>
                      <a:off x="3849480" y="3836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4" name="Rectangle 531"/>
                    <p:cNvSpPr/>
                    <p:nvPr/>
                  </p:nvSpPr>
                  <p:spPr>
                    <a:xfrm>
                      <a:off x="4052160" y="3852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5" name="Rectangle 532"/>
                    <p:cNvSpPr/>
                    <p:nvPr/>
                  </p:nvSpPr>
                  <p:spPr>
                    <a:xfrm>
                      <a:off x="4110120" y="3836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6" name="Rectangle 533"/>
                    <p:cNvSpPr/>
                    <p:nvPr/>
                  </p:nvSpPr>
                  <p:spPr>
                    <a:xfrm>
                      <a:off x="4317120" y="3852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7" name="Rectangle 534"/>
                    <p:cNvSpPr/>
                    <p:nvPr/>
                  </p:nvSpPr>
                  <p:spPr>
                    <a:xfrm>
                      <a:off x="4372920" y="3836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8" name="Rectangle 535"/>
                    <p:cNvSpPr/>
                    <p:nvPr/>
                  </p:nvSpPr>
                  <p:spPr>
                    <a:xfrm>
                      <a:off x="4579200" y="3852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69" name="Rectangle 536"/>
                    <p:cNvSpPr/>
                    <p:nvPr/>
                  </p:nvSpPr>
                  <p:spPr>
                    <a:xfrm>
                      <a:off x="4637160" y="3836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0" name="Rectangle 537"/>
                    <p:cNvSpPr/>
                    <p:nvPr/>
                  </p:nvSpPr>
                  <p:spPr>
                    <a:xfrm>
                      <a:off x="4839840" y="3852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1" name="Rectangle 538"/>
                    <p:cNvSpPr/>
                    <p:nvPr/>
                  </p:nvSpPr>
                  <p:spPr>
                    <a:xfrm>
                      <a:off x="4897440" y="3836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grpSp>
              <p:nvGrpSpPr>
                <p:cNvPr id="872" name="Group 539"/>
                <p:cNvGrpSpPr/>
                <p:nvPr/>
              </p:nvGrpSpPr>
              <p:grpSpPr>
                <a:xfrm>
                  <a:off x="3706200" y="2750760"/>
                  <a:ext cx="127800" cy="1067040"/>
                  <a:chOff x="3706200" y="2750760"/>
                  <a:chExt cx="127800" cy="1067040"/>
                </a:xfrm>
              </p:grpSpPr>
              <p:sp>
                <p:nvSpPr>
                  <p:cNvPr id="873" name="Line 540"/>
                  <p:cNvSpPr/>
                  <p:nvPr/>
                </p:nvSpPr>
                <p:spPr>
                  <a:xfrm flipV="1">
                    <a:off x="3834000" y="2750760"/>
                    <a:ext cx="0" cy="104940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874" name="Group 541"/>
                  <p:cNvGrpSpPr/>
                  <p:nvPr/>
                </p:nvGrpSpPr>
                <p:grpSpPr>
                  <a:xfrm>
                    <a:off x="3706200" y="2771280"/>
                    <a:ext cx="79560" cy="1046520"/>
                    <a:chOff x="3706200" y="2771280"/>
                    <a:chExt cx="79560" cy="1046520"/>
                  </a:xfrm>
                </p:grpSpPr>
                <p:sp>
                  <p:nvSpPr>
                    <p:cNvPr id="875" name="Rectangle 542"/>
                    <p:cNvSpPr/>
                    <p:nvPr/>
                  </p:nvSpPr>
                  <p:spPr>
                    <a:xfrm>
                      <a:off x="3763800" y="377172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6" name="Rectangle 543"/>
                    <p:cNvSpPr/>
                    <p:nvPr/>
                  </p:nvSpPr>
                  <p:spPr>
                    <a:xfrm>
                      <a:off x="3734640" y="35726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7" name="Rectangle 544"/>
                    <p:cNvSpPr/>
                    <p:nvPr/>
                  </p:nvSpPr>
                  <p:spPr>
                    <a:xfrm>
                      <a:off x="3734640" y="33732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8" name="Rectangle 545"/>
                    <p:cNvSpPr/>
                    <p:nvPr/>
                  </p:nvSpPr>
                  <p:spPr>
                    <a:xfrm>
                      <a:off x="3734640" y="31698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79" name="Rectangle 546"/>
                    <p:cNvSpPr/>
                    <p:nvPr/>
                  </p:nvSpPr>
                  <p:spPr>
                    <a:xfrm>
                      <a:off x="3734640" y="2970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0" name="Rectangle 547"/>
                    <p:cNvSpPr/>
                    <p:nvPr/>
                  </p:nvSpPr>
                  <p:spPr>
                    <a:xfrm>
                      <a:off x="3706200" y="277128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881" name="Group 548"/>
                  <p:cNvGrpSpPr/>
                  <p:nvPr/>
                </p:nvGrpSpPr>
                <p:grpSpPr>
                  <a:xfrm>
                    <a:off x="3809520" y="2799720"/>
                    <a:ext cx="23760" cy="1000080"/>
                    <a:chOff x="3809520" y="2799720"/>
                    <a:chExt cx="23760" cy="1000080"/>
                  </a:xfrm>
                </p:grpSpPr>
                <p:sp>
                  <p:nvSpPr>
                    <p:cNvPr id="882" name="Line 549"/>
                    <p:cNvSpPr/>
                    <p:nvPr/>
                  </p:nvSpPr>
                  <p:spPr>
                    <a:xfrm flipH="1">
                      <a:off x="3809520" y="379980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3" name="Line 550"/>
                    <p:cNvSpPr/>
                    <p:nvPr/>
                  </p:nvSpPr>
                  <p:spPr>
                    <a:xfrm flipH="1">
                      <a:off x="3825360" y="37508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4" name="Line 551"/>
                    <p:cNvSpPr/>
                    <p:nvPr/>
                  </p:nvSpPr>
                  <p:spPr>
                    <a:xfrm flipH="1">
                      <a:off x="3825360" y="37022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5" name="Line 552"/>
                    <p:cNvSpPr/>
                    <p:nvPr/>
                  </p:nvSpPr>
                  <p:spPr>
                    <a:xfrm flipH="1">
                      <a:off x="3825360" y="36489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6" name="Line 553"/>
                    <p:cNvSpPr/>
                    <p:nvPr/>
                  </p:nvSpPr>
                  <p:spPr>
                    <a:xfrm flipH="1">
                      <a:off x="3809520" y="360072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7" name="Line 554"/>
                    <p:cNvSpPr/>
                    <p:nvPr/>
                  </p:nvSpPr>
                  <p:spPr>
                    <a:xfrm flipH="1">
                      <a:off x="3825360" y="35517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8" name="Line 555"/>
                    <p:cNvSpPr/>
                    <p:nvPr/>
                  </p:nvSpPr>
                  <p:spPr>
                    <a:xfrm flipH="1">
                      <a:off x="3825360" y="34988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89" name="Line 556"/>
                    <p:cNvSpPr/>
                    <p:nvPr/>
                  </p:nvSpPr>
                  <p:spPr>
                    <a:xfrm flipH="1">
                      <a:off x="3825360" y="34498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0" name="Line 557"/>
                    <p:cNvSpPr/>
                    <p:nvPr/>
                  </p:nvSpPr>
                  <p:spPr>
                    <a:xfrm flipH="1">
                      <a:off x="3809520" y="340128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1" name="Line 558"/>
                    <p:cNvSpPr/>
                    <p:nvPr/>
                  </p:nvSpPr>
                  <p:spPr>
                    <a:xfrm flipH="1">
                      <a:off x="3825360" y="334872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2" name="Line 559"/>
                    <p:cNvSpPr/>
                    <p:nvPr/>
                  </p:nvSpPr>
                  <p:spPr>
                    <a:xfrm flipH="1">
                      <a:off x="3825360" y="32997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3" name="Line 560"/>
                    <p:cNvSpPr/>
                    <p:nvPr/>
                  </p:nvSpPr>
                  <p:spPr>
                    <a:xfrm flipH="1">
                      <a:off x="3825360" y="32508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4" name="Line 561"/>
                    <p:cNvSpPr/>
                    <p:nvPr/>
                  </p:nvSpPr>
                  <p:spPr>
                    <a:xfrm flipH="1">
                      <a:off x="3809520" y="319824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5" name="Line 562"/>
                    <p:cNvSpPr/>
                    <p:nvPr/>
                  </p:nvSpPr>
                  <p:spPr>
                    <a:xfrm flipH="1">
                      <a:off x="3825360" y="31492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6" name="Line 563"/>
                    <p:cNvSpPr/>
                    <p:nvPr/>
                  </p:nvSpPr>
                  <p:spPr>
                    <a:xfrm flipH="1">
                      <a:off x="3825360" y="31006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7" name="Line 564"/>
                    <p:cNvSpPr/>
                    <p:nvPr/>
                  </p:nvSpPr>
                  <p:spPr>
                    <a:xfrm flipH="1">
                      <a:off x="3825360" y="30474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8" name="Line 565"/>
                    <p:cNvSpPr/>
                    <p:nvPr/>
                  </p:nvSpPr>
                  <p:spPr>
                    <a:xfrm flipH="1">
                      <a:off x="3809520" y="299880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899" name="Line 566"/>
                    <p:cNvSpPr/>
                    <p:nvPr/>
                  </p:nvSpPr>
                  <p:spPr>
                    <a:xfrm flipH="1">
                      <a:off x="3825360" y="29502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00" name="Line 567"/>
                    <p:cNvSpPr/>
                    <p:nvPr/>
                  </p:nvSpPr>
                  <p:spPr>
                    <a:xfrm flipH="1">
                      <a:off x="3825360" y="28972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01" name="Line 568"/>
                    <p:cNvSpPr/>
                    <p:nvPr/>
                  </p:nvSpPr>
                  <p:spPr>
                    <a:xfrm flipH="1">
                      <a:off x="3825360" y="284832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02" name="Line 569"/>
                    <p:cNvSpPr/>
                    <p:nvPr/>
                  </p:nvSpPr>
                  <p:spPr>
                    <a:xfrm flipH="1">
                      <a:off x="3809520" y="279972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903" name="Group 570"/>
              <p:cNvGrpSpPr/>
              <p:nvPr/>
            </p:nvGrpSpPr>
            <p:grpSpPr>
              <a:xfrm>
                <a:off x="3842640" y="2759400"/>
                <a:ext cx="1035720" cy="1041480"/>
                <a:chOff x="3842640" y="2759400"/>
                <a:chExt cx="1035720" cy="1041480"/>
              </a:xfrm>
            </p:grpSpPr>
            <p:sp>
              <p:nvSpPr>
                <p:cNvPr id="904" name="Freeform 571"/>
                <p:cNvSpPr/>
                <p:nvPr/>
              </p:nvSpPr>
              <p:spPr>
                <a:xfrm>
                  <a:off x="3842640" y="2759400"/>
                  <a:ext cx="1035720" cy="1037520"/>
                </a:xfrm>
                <a:custGeom>
                  <a:avLst/>
                  <a:gdLst>
                    <a:gd name="textAreaLeft" fmla="*/ 0 w 1035720"/>
                    <a:gd name="textAreaRight" fmla="*/ 1036080 w 1035720"/>
                    <a:gd name="textAreaTop" fmla="*/ 0 h 1037520"/>
                    <a:gd name="textAreaBottom" fmla="*/ 1037880 h 1037520"/>
                  </a:gdLst>
                  <a:ahLst/>
                  <a:rect l="textAreaLeft" t="textAreaTop" r="textAreaRight" b="textAreaBottom"/>
                  <a:pathLst>
                    <a:path w="509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158"/>
                      </a:lnTo>
                      <a:lnTo>
                        <a:pt x="4" y="222"/>
                      </a:lnTo>
                      <a:lnTo>
                        <a:pt x="6" y="222"/>
                      </a:lnTo>
                      <a:lnTo>
                        <a:pt x="8" y="202"/>
                      </a:lnTo>
                      <a:lnTo>
                        <a:pt x="10" y="182"/>
                      </a:lnTo>
                      <a:lnTo>
                        <a:pt x="12" y="162"/>
                      </a:lnTo>
                      <a:lnTo>
                        <a:pt x="14" y="134"/>
                      </a:lnTo>
                      <a:lnTo>
                        <a:pt x="16" y="94"/>
                      </a:lnTo>
                      <a:lnTo>
                        <a:pt x="18" y="36"/>
                      </a:lnTo>
                      <a:lnTo>
                        <a:pt x="20" y="24"/>
                      </a:lnTo>
                      <a:lnTo>
                        <a:pt x="22" y="36"/>
                      </a:lnTo>
                      <a:lnTo>
                        <a:pt x="24" y="40"/>
                      </a:lnTo>
                      <a:lnTo>
                        <a:pt x="26" y="40"/>
                      </a:lnTo>
                      <a:lnTo>
                        <a:pt x="28" y="40"/>
                      </a:lnTo>
                      <a:lnTo>
                        <a:pt x="30" y="48"/>
                      </a:lnTo>
                      <a:lnTo>
                        <a:pt x="32" y="42"/>
                      </a:lnTo>
                      <a:lnTo>
                        <a:pt x="34" y="50"/>
                      </a:lnTo>
                      <a:lnTo>
                        <a:pt x="36" y="50"/>
                      </a:lnTo>
                      <a:lnTo>
                        <a:pt x="38" y="50"/>
                      </a:lnTo>
                      <a:lnTo>
                        <a:pt x="40" y="66"/>
                      </a:lnTo>
                      <a:lnTo>
                        <a:pt x="42" y="100"/>
                      </a:lnTo>
                      <a:lnTo>
                        <a:pt x="44" y="136"/>
                      </a:lnTo>
                      <a:lnTo>
                        <a:pt x="46" y="152"/>
                      </a:lnTo>
                      <a:lnTo>
                        <a:pt x="48" y="166"/>
                      </a:lnTo>
                      <a:lnTo>
                        <a:pt x="50" y="192"/>
                      </a:lnTo>
                      <a:lnTo>
                        <a:pt x="52" y="220"/>
                      </a:lnTo>
                      <a:lnTo>
                        <a:pt x="54" y="242"/>
                      </a:lnTo>
                      <a:lnTo>
                        <a:pt x="56" y="252"/>
                      </a:lnTo>
                      <a:lnTo>
                        <a:pt x="58" y="254"/>
                      </a:lnTo>
                      <a:lnTo>
                        <a:pt x="60" y="276"/>
                      </a:lnTo>
                      <a:lnTo>
                        <a:pt x="62" y="298"/>
                      </a:lnTo>
                      <a:lnTo>
                        <a:pt x="64" y="310"/>
                      </a:lnTo>
                      <a:lnTo>
                        <a:pt x="66" y="328"/>
                      </a:lnTo>
                      <a:lnTo>
                        <a:pt x="68" y="354"/>
                      </a:lnTo>
                      <a:lnTo>
                        <a:pt x="70" y="374"/>
                      </a:lnTo>
                      <a:lnTo>
                        <a:pt x="72" y="386"/>
                      </a:lnTo>
                      <a:lnTo>
                        <a:pt x="74" y="394"/>
                      </a:lnTo>
                      <a:lnTo>
                        <a:pt x="76" y="400"/>
                      </a:lnTo>
                      <a:lnTo>
                        <a:pt x="78" y="408"/>
                      </a:lnTo>
                      <a:lnTo>
                        <a:pt x="80" y="414"/>
                      </a:lnTo>
                      <a:lnTo>
                        <a:pt x="82" y="418"/>
                      </a:lnTo>
                      <a:lnTo>
                        <a:pt x="84" y="422"/>
                      </a:lnTo>
                      <a:lnTo>
                        <a:pt x="86" y="428"/>
                      </a:lnTo>
                      <a:lnTo>
                        <a:pt x="88" y="432"/>
                      </a:lnTo>
                      <a:lnTo>
                        <a:pt x="90" y="438"/>
                      </a:lnTo>
                      <a:lnTo>
                        <a:pt x="92" y="444"/>
                      </a:lnTo>
                      <a:lnTo>
                        <a:pt x="94" y="450"/>
                      </a:lnTo>
                      <a:lnTo>
                        <a:pt x="96" y="454"/>
                      </a:lnTo>
                      <a:lnTo>
                        <a:pt x="98" y="458"/>
                      </a:lnTo>
                      <a:lnTo>
                        <a:pt x="100" y="464"/>
                      </a:lnTo>
                      <a:lnTo>
                        <a:pt x="102" y="468"/>
                      </a:lnTo>
                      <a:lnTo>
                        <a:pt x="104" y="470"/>
                      </a:lnTo>
                      <a:lnTo>
                        <a:pt x="106" y="474"/>
                      </a:lnTo>
                      <a:lnTo>
                        <a:pt x="108" y="480"/>
                      </a:lnTo>
                      <a:lnTo>
                        <a:pt x="110" y="486"/>
                      </a:lnTo>
                      <a:lnTo>
                        <a:pt x="112" y="490"/>
                      </a:lnTo>
                      <a:lnTo>
                        <a:pt x="114" y="494"/>
                      </a:lnTo>
                      <a:lnTo>
                        <a:pt x="116" y="496"/>
                      </a:lnTo>
                      <a:lnTo>
                        <a:pt x="118" y="498"/>
                      </a:lnTo>
                      <a:lnTo>
                        <a:pt x="120" y="500"/>
                      </a:lnTo>
                      <a:lnTo>
                        <a:pt x="122" y="500"/>
                      </a:lnTo>
                      <a:lnTo>
                        <a:pt x="124" y="502"/>
                      </a:lnTo>
                      <a:lnTo>
                        <a:pt x="126" y="502"/>
                      </a:lnTo>
                      <a:lnTo>
                        <a:pt x="128" y="504"/>
                      </a:lnTo>
                      <a:lnTo>
                        <a:pt x="130" y="504"/>
                      </a:lnTo>
                      <a:lnTo>
                        <a:pt x="132" y="506"/>
                      </a:lnTo>
                      <a:lnTo>
                        <a:pt x="134" y="506"/>
                      </a:lnTo>
                      <a:lnTo>
                        <a:pt x="136" y="506"/>
                      </a:lnTo>
                      <a:lnTo>
                        <a:pt x="138" y="508"/>
                      </a:lnTo>
                      <a:lnTo>
                        <a:pt x="140" y="508"/>
                      </a:lnTo>
                      <a:lnTo>
                        <a:pt x="142" y="508"/>
                      </a:lnTo>
                      <a:lnTo>
                        <a:pt x="144" y="508"/>
                      </a:lnTo>
                      <a:lnTo>
                        <a:pt x="146" y="508"/>
                      </a:lnTo>
                      <a:lnTo>
                        <a:pt x="148" y="508"/>
                      </a:lnTo>
                      <a:lnTo>
                        <a:pt x="150" y="508"/>
                      </a:lnTo>
                      <a:lnTo>
                        <a:pt x="152" y="508"/>
                      </a:lnTo>
                      <a:lnTo>
                        <a:pt x="154" y="508"/>
                      </a:lnTo>
                      <a:lnTo>
                        <a:pt x="156" y="508"/>
                      </a:lnTo>
                      <a:lnTo>
                        <a:pt x="158" y="508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10"/>
                      </a:lnTo>
                      <a:lnTo>
                        <a:pt x="176" y="510"/>
                      </a:lnTo>
                      <a:lnTo>
                        <a:pt x="178" y="510"/>
                      </a:lnTo>
                      <a:lnTo>
                        <a:pt x="180" y="510"/>
                      </a:lnTo>
                      <a:lnTo>
                        <a:pt x="182" y="510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08"/>
                      </a:lnTo>
                      <a:lnTo>
                        <a:pt x="216" y="508"/>
                      </a:lnTo>
                      <a:lnTo>
                        <a:pt x="218" y="508"/>
                      </a:lnTo>
                      <a:lnTo>
                        <a:pt x="220" y="508"/>
                      </a:lnTo>
                      <a:lnTo>
                        <a:pt x="222" y="508"/>
                      </a:lnTo>
                      <a:lnTo>
                        <a:pt x="224" y="508"/>
                      </a:lnTo>
                      <a:lnTo>
                        <a:pt x="226" y="508"/>
                      </a:lnTo>
                      <a:lnTo>
                        <a:pt x="228" y="508"/>
                      </a:lnTo>
                      <a:lnTo>
                        <a:pt x="230" y="508"/>
                      </a:lnTo>
                      <a:lnTo>
                        <a:pt x="232" y="508"/>
                      </a:lnTo>
                      <a:lnTo>
                        <a:pt x="234" y="508"/>
                      </a:lnTo>
                      <a:lnTo>
                        <a:pt x="236" y="508"/>
                      </a:lnTo>
                      <a:lnTo>
                        <a:pt x="238" y="508"/>
                      </a:lnTo>
                      <a:lnTo>
                        <a:pt x="240" y="508"/>
                      </a:lnTo>
                      <a:lnTo>
                        <a:pt x="242" y="508"/>
                      </a:lnTo>
                      <a:lnTo>
                        <a:pt x="244" y="508"/>
                      </a:lnTo>
                      <a:lnTo>
                        <a:pt x="246" y="508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08"/>
                      </a:lnTo>
                      <a:lnTo>
                        <a:pt x="254" y="508"/>
                      </a:lnTo>
                      <a:lnTo>
                        <a:pt x="256" y="508"/>
                      </a:lnTo>
                      <a:lnTo>
                        <a:pt x="257" y="508"/>
                      </a:lnTo>
                      <a:lnTo>
                        <a:pt x="259" y="508"/>
                      </a:lnTo>
                      <a:lnTo>
                        <a:pt x="261" y="508"/>
                      </a:lnTo>
                      <a:lnTo>
                        <a:pt x="263" y="508"/>
                      </a:lnTo>
                      <a:lnTo>
                        <a:pt x="265" y="508"/>
                      </a:lnTo>
                      <a:lnTo>
                        <a:pt x="267" y="508"/>
                      </a:lnTo>
                      <a:lnTo>
                        <a:pt x="269" y="508"/>
                      </a:lnTo>
                      <a:lnTo>
                        <a:pt x="271" y="508"/>
                      </a:lnTo>
                      <a:lnTo>
                        <a:pt x="273" y="508"/>
                      </a:lnTo>
                      <a:lnTo>
                        <a:pt x="275" y="508"/>
                      </a:lnTo>
                      <a:lnTo>
                        <a:pt x="277" y="508"/>
                      </a:lnTo>
                      <a:lnTo>
                        <a:pt x="279" y="508"/>
                      </a:lnTo>
                      <a:lnTo>
                        <a:pt x="281" y="508"/>
                      </a:lnTo>
                      <a:lnTo>
                        <a:pt x="283" y="508"/>
                      </a:lnTo>
                      <a:lnTo>
                        <a:pt x="285" y="508"/>
                      </a:lnTo>
                      <a:lnTo>
                        <a:pt x="287" y="508"/>
                      </a:lnTo>
                      <a:lnTo>
                        <a:pt x="289" y="508"/>
                      </a:lnTo>
                      <a:lnTo>
                        <a:pt x="291" y="508"/>
                      </a:lnTo>
                      <a:lnTo>
                        <a:pt x="293" y="508"/>
                      </a:lnTo>
                      <a:lnTo>
                        <a:pt x="295" y="508"/>
                      </a:lnTo>
                      <a:lnTo>
                        <a:pt x="297" y="508"/>
                      </a:lnTo>
                      <a:lnTo>
                        <a:pt x="299" y="508"/>
                      </a:lnTo>
                      <a:lnTo>
                        <a:pt x="301" y="508"/>
                      </a:lnTo>
                      <a:lnTo>
                        <a:pt x="303" y="508"/>
                      </a:lnTo>
                      <a:lnTo>
                        <a:pt x="305" y="508"/>
                      </a:lnTo>
                      <a:lnTo>
                        <a:pt x="307" y="508"/>
                      </a:lnTo>
                      <a:lnTo>
                        <a:pt x="309" y="508"/>
                      </a:lnTo>
                      <a:lnTo>
                        <a:pt x="311" y="508"/>
                      </a:lnTo>
                      <a:lnTo>
                        <a:pt x="313" y="508"/>
                      </a:lnTo>
                      <a:lnTo>
                        <a:pt x="315" y="508"/>
                      </a:lnTo>
                      <a:lnTo>
                        <a:pt x="317" y="508"/>
                      </a:lnTo>
                      <a:lnTo>
                        <a:pt x="319" y="508"/>
                      </a:lnTo>
                      <a:lnTo>
                        <a:pt x="321" y="508"/>
                      </a:lnTo>
                      <a:lnTo>
                        <a:pt x="323" y="508"/>
                      </a:lnTo>
                      <a:lnTo>
                        <a:pt x="325" y="508"/>
                      </a:lnTo>
                      <a:lnTo>
                        <a:pt x="327" y="508"/>
                      </a:lnTo>
                      <a:lnTo>
                        <a:pt x="329" y="508"/>
                      </a:lnTo>
                      <a:lnTo>
                        <a:pt x="331" y="508"/>
                      </a:lnTo>
                      <a:lnTo>
                        <a:pt x="333" y="508"/>
                      </a:lnTo>
                      <a:lnTo>
                        <a:pt x="335" y="508"/>
                      </a:lnTo>
                      <a:lnTo>
                        <a:pt x="337" y="510"/>
                      </a:lnTo>
                      <a:lnTo>
                        <a:pt x="339" y="510"/>
                      </a:lnTo>
                      <a:lnTo>
                        <a:pt x="341" y="510"/>
                      </a:lnTo>
                      <a:lnTo>
                        <a:pt x="343" y="510"/>
                      </a:lnTo>
                      <a:lnTo>
                        <a:pt x="345" y="510"/>
                      </a:lnTo>
                      <a:lnTo>
                        <a:pt x="347" y="510"/>
                      </a:lnTo>
                      <a:lnTo>
                        <a:pt x="349" y="510"/>
                      </a:lnTo>
                      <a:lnTo>
                        <a:pt x="351" y="510"/>
                      </a:lnTo>
                      <a:lnTo>
                        <a:pt x="353" y="510"/>
                      </a:lnTo>
                      <a:lnTo>
                        <a:pt x="355" y="510"/>
                      </a:lnTo>
                      <a:lnTo>
                        <a:pt x="357" y="510"/>
                      </a:lnTo>
                      <a:lnTo>
                        <a:pt x="359" y="510"/>
                      </a:lnTo>
                      <a:lnTo>
                        <a:pt x="361" y="510"/>
                      </a:lnTo>
                      <a:lnTo>
                        <a:pt x="363" y="510"/>
                      </a:lnTo>
                      <a:lnTo>
                        <a:pt x="365" y="510"/>
                      </a:lnTo>
                      <a:lnTo>
                        <a:pt x="367" y="510"/>
                      </a:lnTo>
                      <a:lnTo>
                        <a:pt x="369" y="510"/>
                      </a:lnTo>
                      <a:lnTo>
                        <a:pt x="371" y="510"/>
                      </a:lnTo>
                      <a:lnTo>
                        <a:pt x="373" y="510"/>
                      </a:lnTo>
                      <a:lnTo>
                        <a:pt x="375" y="510"/>
                      </a:lnTo>
                      <a:lnTo>
                        <a:pt x="377" y="510"/>
                      </a:lnTo>
                      <a:lnTo>
                        <a:pt x="379" y="510"/>
                      </a:lnTo>
                      <a:lnTo>
                        <a:pt x="381" y="510"/>
                      </a:lnTo>
                      <a:lnTo>
                        <a:pt x="383" y="510"/>
                      </a:lnTo>
                      <a:lnTo>
                        <a:pt x="385" y="510"/>
                      </a:lnTo>
                      <a:lnTo>
                        <a:pt x="387" y="510"/>
                      </a:lnTo>
                      <a:lnTo>
                        <a:pt x="389" y="510"/>
                      </a:lnTo>
                      <a:lnTo>
                        <a:pt x="391" y="510"/>
                      </a:lnTo>
                      <a:lnTo>
                        <a:pt x="393" y="510"/>
                      </a:lnTo>
                      <a:lnTo>
                        <a:pt x="395" y="510"/>
                      </a:lnTo>
                      <a:lnTo>
                        <a:pt x="397" y="510"/>
                      </a:lnTo>
                      <a:lnTo>
                        <a:pt x="399" y="510"/>
                      </a:lnTo>
                      <a:lnTo>
                        <a:pt x="401" y="510"/>
                      </a:lnTo>
                      <a:lnTo>
                        <a:pt x="403" y="510"/>
                      </a:lnTo>
                      <a:lnTo>
                        <a:pt x="405" y="510"/>
                      </a:lnTo>
                      <a:lnTo>
                        <a:pt x="407" y="510"/>
                      </a:lnTo>
                      <a:lnTo>
                        <a:pt x="409" y="510"/>
                      </a:lnTo>
                      <a:lnTo>
                        <a:pt x="411" y="510"/>
                      </a:lnTo>
                      <a:lnTo>
                        <a:pt x="413" y="510"/>
                      </a:lnTo>
                      <a:lnTo>
                        <a:pt x="415" y="510"/>
                      </a:lnTo>
                      <a:lnTo>
                        <a:pt x="417" y="510"/>
                      </a:lnTo>
                      <a:lnTo>
                        <a:pt x="419" y="510"/>
                      </a:lnTo>
                      <a:lnTo>
                        <a:pt x="421" y="510"/>
                      </a:lnTo>
                      <a:lnTo>
                        <a:pt x="423" y="510"/>
                      </a:lnTo>
                      <a:lnTo>
                        <a:pt x="425" y="510"/>
                      </a:lnTo>
                      <a:lnTo>
                        <a:pt x="427" y="510"/>
                      </a:lnTo>
                      <a:lnTo>
                        <a:pt x="429" y="510"/>
                      </a:lnTo>
                      <a:lnTo>
                        <a:pt x="431" y="510"/>
                      </a:lnTo>
                      <a:lnTo>
                        <a:pt x="433" y="510"/>
                      </a:lnTo>
                      <a:lnTo>
                        <a:pt x="435" y="510"/>
                      </a:lnTo>
                      <a:lnTo>
                        <a:pt x="437" y="510"/>
                      </a:lnTo>
                      <a:lnTo>
                        <a:pt x="439" y="510"/>
                      </a:lnTo>
                      <a:lnTo>
                        <a:pt x="441" y="510"/>
                      </a:lnTo>
                      <a:lnTo>
                        <a:pt x="443" y="510"/>
                      </a:lnTo>
                      <a:lnTo>
                        <a:pt x="445" y="510"/>
                      </a:lnTo>
                      <a:lnTo>
                        <a:pt x="447" y="510"/>
                      </a:lnTo>
                      <a:lnTo>
                        <a:pt x="449" y="510"/>
                      </a:lnTo>
                      <a:lnTo>
                        <a:pt x="451" y="510"/>
                      </a:lnTo>
                      <a:lnTo>
                        <a:pt x="453" y="510"/>
                      </a:lnTo>
                      <a:lnTo>
                        <a:pt x="455" y="510"/>
                      </a:lnTo>
                      <a:lnTo>
                        <a:pt x="457" y="510"/>
                      </a:lnTo>
                      <a:lnTo>
                        <a:pt x="459" y="510"/>
                      </a:lnTo>
                      <a:lnTo>
                        <a:pt x="461" y="510"/>
                      </a:lnTo>
                      <a:lnTo>
                        <a:pt x="463" y="510"/>
                      </a:lnTo>
                      <a:lnTo>
                        <a:pt x="465" y="510"/>
                      </a:lnTo>
                      <a:lnTo>
                        <a:pt x="467" y="510"/>
                      </a:lnTo>
                      <a:lnTo>
                        <a:pt x="469" y="510"/>
                      </a:lnTo>
                      <a:lnTo>
                        <a:pt x="471" y="510"/>
                      </a:lnTo>
                      <a:lnTo>
                        <a:pt x="473" y="510"/>
                      </a:lnTo>
                      <a:lnTo>
                        <a:pt x="475" y="510"/>
                      </a:lnTo>
                      <a:lnTo>
                        <a:pt x="477" y="510"/>
                      </a:lnTo>
                      <a:lnTo>
                        <a:pt x="479" y="510"/>
                      </a:lnTo>
                      <a:lnTo>
                        <a:pt x="481" y="510"/>
                      </a:lnTo>
                      <a:lnTo>
                        <a:pt x="483" y="510"/>
                      </a:lnTo>
                      <a:lnTo>
                        <a:pt x="485" y="510"/>
                      </a:lnTo>
                      <a:lnTo>
                        <a:pt x="487" y="510"/>
                      </a:lnTo>
                      <a:lnTo>
                        <a:pt x="489" y="510"/>
                      </a:lnTo>
                      <a:lnTo>
                        <a:pt x="491" y="510"/>
                      </a:lnTo>
                      <a:lnTo>
                        <a:pt x="493" y="510"/>
                      </a:lnTo>
                      <a:lnTo>
                        <a:pt x="495" y="510"/>
                      </a:lnTo>
                      <a:lnTo>
                        <a:pt x="497" y="510"/>
                      </a:lnTo>
                      <a:lnTo>
                        <a:pt x="499" y="510"/>
                      </a:lnTo>
                      <a:lnTo>
                        <a:pt x="501" y="510"/>
                      </a:lnTo>
                      <a:lnTo>
                        <a:pt x="503" y="510"/>
                      </a:lnTo>
                      <a:lnTo>
                        <a:pt x="505" y="510"/>
                      </a:lnTo>
                      <a:lnTo>
                        <a:pt x="507" y="510"/>
                      </a:lnTo>
                      <a:lnTo>
                        <a:pt x="509" y="510"/>
                      </a:lnTo>
                      <a:lnTo>
                        <a:pt x="0" y="510"/>
                      </a:lnTo>
                      <a:close/>
                    </a:path>
                  </a:pathLst>
                </a:custGeom>
                <a:solidFill>
                  <a:srgbClr val="f0f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5" name="Freeform 572"/>
                <p:cNvSpPr/>
                <p:nvPr/>
              </p:nvSpPr>
              <p:spPr>
                <a:xfrm>
                  <a:off x="3846240" y="2763360"/>
                  <a:ext cx="1032120" cy="1037520"/>
                </a:xfrm>
                <a:custGeom>
                  <a:avLst/>
                  <a:gdLst>
                    <a:gd name="textAreaLeft" fmla="*/ 0 w 1032120"/>
                    <a:gd name="textAreaRight" fmla="*/ 1032480 w 1032120"/>
                    <a:gd name="textAreaTop" fmla="*/ 0 h 1037520"/>
                    <a:gd name="textAreaBottom" fmla="*/ 1037880 h 1037520"/>
                  </a:gdLst>
                  <a:ahLst/>
                  <a:rect l="textAreaLeft" t="textAreaTop" r="textAreaRight" b="textAreaBottom"/>
                  <a:pathLst>
                    <a:path w="507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158"/>
                      </a:lnTo>
                      <a:lnTo>
                        <a:pt x="4" y="222"/>
                      </a:lnTo>
                      <a:lnTo>
                        <a:pt x="6" y="222"/>
                      </a:lnTo>
                      <a:lnTo>
                        <a:pt x="8" y="202"/>
                      </a:lnTo>
                      <a:lnTo>
                        <a:pt x="10" y="182"/>
                      </a:lnTo>
                      <a:lnTo>
                        <a:pt x="12" y="162"/>
                      </a:lnTo>
                      <a:lnTo>
                        <a:pt x="14" y="134"/>
                      </a:lnTo>
                      <a:lnTo>
                        <a:pt x="16" y="94"/>
                      </a:lnTo>
                      <a:lnTo>
                        <a:pt x="18" y="36"/>
                      </a:lnTo>
                      <a:lnTo>
                        <a:pt x="20" y="24"/>
                      </a:lnTo>
                      <a:lnTo>
                        <a:pt x="22" y="36"/>
                      </a:lnTo>
                      <a:lnTo>
                        <a:pt x="24" y="40"/>
                      </a:lnTo>
                      <a:lnTo>
                        <a:pt x="26" y="40"/>
                      </a:lnTo>
                      <a:lnTo>
                        <a:pt x="28" y="40"/>
                      </a:lnTo>
                      <a:lnTo>
                        <a:pt x="30" y="48"/>
                      </a:lnTo>
                      <a:lnTo>
                        <a:pt x="32" y="42"/>
                      </a:lnTo>
                      <a:lnTo>
                        <a:pt x="34" y="50"/>
                      </a:lnTo>
                      <a:lnTo>
                        <a:pt x="36" y="50"/>
                      </a:lnTo>
                      <a:lnTo>
                        <a:pt x="38" y="50"/>
                      </a:lnTo>
                      <a:lnTo>
                        <a:pt x="40" y="66"/>
                      </a:lnTo>
                      <a:lnTo>
                        <a:pt x="42" y="100"/>
                      </a:lnTo>
                      <a:lnTo>
                        <a:pt x="44" y="136"/>
                      </a:lnTo>
                      <a:lnTo>
                        <a:pt x="46" y="152"/>
                      </a:lnTo>
                      <a:lnTo>
                        <a:pt x="48" y="166"/>
                      </a:lnTo>
                      <a:lnTo>
                        <a:pt x="50" y="192"/>
                      </a:lnTo>
                      <a:lnTo>
                        <a:pt x="52" y="220"/>
                      </a:lnTo>
                      <a:lnTo>
                        <a:pt x="54" y="242"/>
                      </a:lnTo>
                      <a:lnTo>
                        <a:pt x="56" y="252"/>
                      </a:lnTo>
                      <a:lnTo>
                        <a:pt x="58" y="254"/>
                      </a:lnTo>
                      <a:lnTo>
                        <a:pt x="60" y="276"/>
                      </a:lnTo>
                      <a:lnTo>
                        <a:pt x="62" y="298"/>
                      </a:lnTo>
                      <a:lnTo>
                        <a:pt x="64" y="310"/>
                      </a:lnTo>
                      <a:lnTo>
                        <a:pt x="66" y="328"/>
                      </a:lnTo>
                      <a:lnTo>
                        <a:pt x="68" y="354"/>
                      </a:lnTo>
                      <a:lnTo>
                        <a:pt x="70" y="374"/>
                      </a:lnTo>
                      <a:lnTo>
                        <a:pt x="72" y="386"/>
                      </a:lnTo>
                      <a:lnTo>
                        <a:pt x="74" y="394"/>
                      </a:lnTo>
                      <a:lnTo>
                        <a:pt x="76" y="400"/>
                      </a:lnTo>
                      <a:lnTo>
                        <a:pt x="78" y="408"/>
                      </a:lnTo>
                      <a:lnTo>
                        <a:pt x="80" y="414"/>
                      </a:lnTo>
                      <a:lnTo>
                        <a:pt x="82" y="418"/>
                      </a:lnTo>
                      <a:lnTo>
                        <a:pt x="84" y="422"/>
                      </a:lnTo>
                      <a:lnTo>
                        <a:pt x="86" y="428"/>
                      </a:lnTo>
                      <a:lnTo>
                        <a:pt x="88" y="432"/>
                      </a:lnTo>
                      <a:lnTo>
                        <a:pt x="90" y="438"/>
                      </a:lnTo>
                      <a:lnTo>
                        <a:pt x="92" y="444"/>
                      </a:lnTo>
                      <a:lnTo>
                        <a:pt x="94" y="450"/>
                      </a:lnTo>
                      <a:lnTo>
                        <a:pt x="96" y="454"/>
                      </a:lnTo>
                      <a:lnTo>
                        <a:pt x="98" y="458"/>
                      </a:lnTo>
                      <a:lnTo>
                        <a:pt x="100" y="464"/>
                      </a:lnTo>
                      <a:lnTo>
                        <a:pt x="102" y="468"/>
                      </a:lnTo>
                      <a:lnTo>
                        <a:pt x="104" y="470"/>
                      </a:lnTo>
                      <a:lnTo>
                        <a:pt x="106" y="474"/>
                      </a:lnTo>
                      <a:lnTo>
                        <a:pt x="108" y="480"/>
                      </a:lnTo>
                      <a:lnTo>
                        <a:pt x="110" y="486"/>
                      </a:lnTo>
                      <a:lnTo>
                        <a:pt x="112" y="490"/>
                      </a:lnTo>
                      <a:lnTo>
                        <a:pt x="114" y="494"/>
                      </a:lnTo>
                      <a:lnTo>
                        <a:pt x="116" y="496"/>
                      </a:lnTo>
                      <a:lnTo>
                        <a:pt x="118" y="498"/>
                      </a:lnTo>
                      <a:lnTo>
                        <a:pt x="120" y="500"/>
                      </a:lnTo>
                      <a:lnTo>
                        <a:pt x="122" y="500"/>
                      </a:lnTo>
                      <a:lnTo>
                        <a:pt x="124" y="502"/>
                      </a:lnTo>
                      <a:lnTo>
                        <a:pt x="126" y="502"/>
                      </a:lnTo>
                      <a:lnTo>
                        <a:pt x="128" y="504"/>
                      </a:lnTo>
                      <a:lnTo>
                        <a:pt x="130" y="504"/>
                      </a:lnTo>
                      <a:lnTo>
                        <a:pt x="132" y="506"/>
                      </a:lnTo>
                      <a:lnTo>
                        <a:pt x="134" y="506"/>
                      </a:lnTo>
                      <a:lnTo>
                        <a:pt x="136" y="506"/>
                      </a:lnTo>
                      <a:lnTo>
                        <a:pt x="138" y="508"/>
                      </a:lnTo>
                      <a:lnTo>
                        <a:pt x="140" y="508"/>
                      </a:lnTo>
                      <a:lnTo>
                        <a:pt x="142" y="508"/>
                      </a:lnTo>
                      <a:lnTo>
                        <a:pt x="144" y="508"/>
                      </a:lnTo>
                      <a:lnTo>
                        <a:pt x="146" y="508"/>
                      </a:lnTo>
                      <a:lnTo>
                        <a:pt x="148" y="508"/>
                      </a:lnTo>
                      <a:lnTo>
                        <a:pt x="150" y="508"/>
                      </a:lnTo>
                      <a:lnTo>
                        <a:pt x="152" y="508"/>
                      </a:lnTo>
                      <a:lnTo>
                        <a:pt x="154" y="508"/>
                      </a:lnTo>
                      <a:lnTo>
                        <a:pt x="156" y="508"/>
                      </a:lnTo>
                      <a:lnTo>
                        <a:pt x="158" y="508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10"/>
                      </a:lnTo>
                      <a:lnTo>
                        <a:pt x="176" y="510"/>
                      </a:lnTo>
                      <a:lnTo>
                        <a:pt x="178" y="510"/>
                      </a:lnTo>
                      <a:lnTo>
                        <a:pt x="180" y="510"/>
                      </a:lnTo>
                      <a:lnTo>
                        <a:pt x="182" y="510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08"/>
                      </a:lnTo>
                      <a:lnTo>
                        <a:pt x="216" y="508"/>
                      </a:lnTo>
                      <a:lnTo>
                        <a:pt x="218" y="508"/>
                      </a:lnTo>
                      <a:lnTo>
                        <a:pt x="220" y="508"/>
                      </a:lnTo>
                      <a:lnTo>
                        <a:pt x="222" y="508"/>
                      </a:lnTo>
                      <a:lnTo>
                        <a:pt x="224" y="508"/>
                      </a:lnTo>
                      <a:lnTo>
                        <a:pt x="226" y="508"/>
                      </a:lnTo>
                      <a:lnTo>
                        <a:pt x="228" y="508"/>
                      </a:lnTo>
                      <a:lnTo>
                        <a:pt x="230" y="508"/>
                      </a:lnTo>
                      <a:lnTo>
                        <a:pt x="232" y="508"/>
                      </a:lnTo>
                      <a:lnTo>
                        <a:pt x="234" y="508"/>
                      </a:lnTo>
                      <a:lnTo>
                        <a:pt x="236" y="508"/>
                      </a:lnTo>
                      <a:lnTo>
                        <a:pt x="238" y="508"/>
                      </a:lnTo>
                      <a:lnTo>
                        <a:pt x="240" y="508"/>
                      </a:lnTo>
                      <a:lnTo>
                        <a:pt x="242" y="508"/>
                      </a:lnTo>
                      <a:lnTo>
                        <a:pt x="244" y="508"/>
                      </a:lnTo>
                      <a:lnTo>
                        <a:pt x="246" y="508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08"/>
                      </a:lnTo>
                      <a:lnTo>
                        <a:pt x="254" y="508"/>
                      </a:lnTo>
                      <a:lnTo>
                        <a:pt x="255" y="508"/>
                      </a:lnTo>
                      <a:lnTo>
                        <a:pt x="257" y="508"/>
                      </a:lnTo>
                      <a:lnTo>
                        <a:pt x="259" y="508"/>
                      </a:lnTo>
                      <a:lnTo>
                        <a:pt x="261" y="508"/>
                      </a:lnTo>
                      <a:lnTo>
                        <a:pt x="263" y="508"/>
                      </a:lnTo>
                      <a:lnTo>
                        <a:pt x="265" y="508"/>
                      </a:lnTo>
                      <a:lnTo>
                        <a:pt x="267" y="508"/>
                      </a:lnTo>
                      <a:lnTo>
                        <a:pt x="269" y="508"/>
                      </a:lnTo>
                      <a:lnTo>
                        <a:pt x="271" y="508"/>
                      </a:lnTo>
                      <a:lnTo>
                        <a:pt x="273" y="508"/>
                      </a:lnTo>
                      <a:lnTo>
                        <a:pt x="275" y="508"/>
                      </a:lnTo>
                      <a:lnTo>
                        <a:pt x="277" y="508"/>
                      </a:lnTo>
                      <a:lnTo>
                        <a:pt x="279" y="508"/>
                      </a:lnTo>
                      <a:lnTo>
                        <a:pt x="281" y="508"/>
                      </a:lnTo>
                      <a:lnTo>
                        <a:pt x="283" y="508"/>
                      </a:lnTo>
                      <a:lnTo>
                        <a:pt x="285" y="508"/>
                      </a:lnTo>
                      <a:lnTo>
                        <a:pt x="287" y="508"/>
                      </a:lnTo>
                      <a:lnTo>
                        <a:pt x="289" y="508"/>
                      </a:lnTo>
                      <a:lnTo>
                        <a:pt x="291" y="508"/>
                      </a:lnTo>
                      <a:lnTo>
                        <a:pt x="293" y="508"/>
                      </a:lnTo>
                      <a:lnTo>
                        <a:pt x="295" y="508"/>
                      </a:lnTo>
                      <a:lnTo>
                        <a:pt x="297" y="508"/>
                      </a:lnTo>
                      <a:lnTo>
                        <a:pt x="299" y="508"/>
                      </a:lnTo>
                      <a:lnTo>
                        <a:pt x="301" y="508"/>
                      </a:lnTo>
                      <a:lnTo>
                        <a:pt x="303" y="508"/>
                      </a:lnTo>
                      <a:lnTo>
                        <a:pt x="305" y="508"/>
                      </a:lnTo>
                      <a:lnTo>
                        <a:pt x="307" y="508"/>
                      </a:lnTo>
                      <a:lnTo>
                        <a:pt x="309" y="508"/>
                      </a:lnTo>
                      <a:lnTo>
                        <a:pt x="311" y="508"/>
                      </a:lnTo>
                      <a:lnTo>
                        <a:pt x="313" y="508"/>
                      </a:lnTo>
                      <a:lnTo>
                        <a:pt x="315" y="508"/>
                      </a:lnTo>
                      <a:lnTo>
                        <a:pt x="317" y="508"/>
                      </a:lnTo>
                      <a:lnTo>
                        <a:pt x="319" y="508"/>
                      </a:lnTo>
                      <a:lnTo>
                        <a:pt x="321" y="508"/>
                      </a:lnTo>
                      <a:lnTo>
                        <a:pt x="323" y="508"/>
                      </a:lnTo>
                      <a:lnTo>
                        <a:pt x="325" y="508"/>
                      </a:lnTo>
                      <a:lnTo>
                        <a:pt x="327" y="508"/>
                      </a:lnTo>
                      <a:lnTo>
                        <a:pt x="329" y="508"/>
                      </a:lnTo>
                      <a:lnTo>
                        <a:pt x="331" y="508"/>
                      </a:lnTo>
                      <a:lnTo>
                        <a:pt x="333" y="508"/>
                      </a:lnTo>
                      <a:lnTo>
                        <a:pt x="335" y="508"/>
                      </a:lnTo>
                      <a:lnTo>
                        <a:pt x="337" y="510"/>
                      </a:lnTo>
                      <a:lnTo>
                        <a:pt x="339" y="510"/>
                      </a:lnTo>
                      <a:lnTo>
                        <a:pt x="341" y="510"/>
                      </a:lnTo>
                      <a:lnTo>
                        <a:pt x="343" y="510"/>
                      </a:lnTo>
                      <a:lnTo>
                        <a:pt x="345" y="510"/>
                      </a:lnTo>
                      <a:lnTo>
                        <a:pt x="347" y="510"/>
                      </a:lnTo>
                      <a:lnTo>
                        <a:pt x="349" y="510"/>
                      </a:lnTo>
                      <a:lnTo>
                        <a:pt x="351" y="510"/>
                      </a:lnTo>
                      <a:lnTo>
                        <a:pt x="353" y="510"/>
                      </a:lnTo>
                      <a:lnTo>
                        <a:pt x="355" y="510"/>
                      </a:lnTo>
                      <a:lnTo>
                        <a:pt x="357" y="510"/>
                      </a:lnTo>
                      <a:lnTo>
                        <a:pt x="359" y="510"/>
                      </a:lnTo>
                      <a:lnTo>
                        <a:pt x="361" y="510"/>
                      </a:lnTo>
                      <a:lnTo>
                        <a:pt x="363" y="510"/>
                      </a:lnTo>
                      <a:lnTo>
                        <a:pt x="365" y="510"/>
                      </a:lnTo>
                      <a:lnTo>
                        <a:pt x="367" y="510"/>
                      </a:lnTo>
                      <a:lnTo>
                        <a:pt x="369" y="510"/>
                      </a:lnTo>
                      <a:lnTo>
                        <a:pt x="371" y="510"/>
                      </a:lnTo>
                      <a:lnTo>
                        <a:pt x="373" y="510"/>
                      </a:lnTo>
                      <a:lnTo>
                        <a:pt x="375" y="510"/>
                      </a:lnTo>
                      <a:lnTo>
                        <a:pt x="377" y="510"/>
                      </a:lnTo>
                      <a:lnTo>
                        <a:pt x="379" y="510"/>
                      </a:lnTo>
                      <a:lnTo>
                        <a:pt x="381" y="510"/>
                      </a:lnTo>
                      <a:lnTo>
                        <a:pt x="383" y="510"/>
                      </a:lnTo>
                      <a:lnTo>
                        <a:pt x="385" y="510"/>
                      </a:lnTo>
                      <a:lnTo>
                        <a:pt x="387" y="510"/>
                      </a:lnTo>
                      <a:lnTo>
                        <a:pt x="389" y="510"/>
                      </a:lnTo>
                      <a:lnTo>
                        <a:pt x="391" y="510"/>
                      </a:lnTo>
                      <a:lnTo>
                        <a:pt x="393" y="510"/>
                      </a:lnTo>
                      <a:lnTo>
                        <a:pt x="395" y="510"/>
                      </a:lnTo>
                      <a:lnTo>
                        <a:pt x="397" y="510"/>
                      </a:lnTo>
                      <a:lnTo>
                        <a:pt x="399" y="510"/>
                      </a:lnTo>
                      <a:lnTo>
                        <a:pt x="401" y="510"/>
                      </a:lnTo>
                      <a:lnTo>
                        <a:pt x="403" y="510"/>
                      </a:lnTo>
                      <a:lnTo>
                        <a:pt x="405" y="510"/>
                      </a:lnTo>
                      <a:lnTo>
                        <a:pt x="407" y="510"/>
                      </a:lnTo>
                      <a:lnTo>
                        <a:pt x="409" y="510"/>
                      </a:lnTo>
                      <a:lnTo>
                        <a:pt x="411" y="510"/>
                      </a:lnTo>
                      <a:lnTo>
                        <a:pt x="413" y="510"/>
                      </a:lnTo>
                      <a:lnTo>
                        <a:pt x="415" y="510"/>
                      </a:lnTo>
                      <a:lnTo>
                        <a:pt x="417" y="510"/>
                      </a:lnTo>
                      <a:lnTo>
                        <a:pt x="419" y="510"/>
                      </a:lnTo>
                      <a:lnTo>
                        <a:pt x="421" y="510"/>
                      </a:lnTo>
                      <a:lnTo>
                        <a:pt x="423" y="510"/>
                      </a:lnTo>
                      <a:lnTo>
                        <a:pt x="425" y="510"/>
                      </a:lnTo>
                      <a:lnTo>
                        <a:pt x="427" y="510"/>
                      </a:lnTo>
                      <a:lnTo>
                        <a:pt x="429" y="510"/>
                      </a:lnTo>
                      <a:lnTo>
                        <a:pt x="431" y="510"/>
                      </a:lnTo>
                      <a:lnTo>
                        <a:pt x="433" y="510"/>
                      </a:lnTo>
                      <a:lnTo>
                        <a:pt x="435" y="510"/>
                      </a:lnTo>
                      <a:lnTo>
                        <a:pt x="437" y="510"/>
                      </a:lnTo>
                      <a:lnTo>
                        <a:pt x="439" y="510"/>
                      </a:lnTo>
                      <a:lnTo>
                        <a:pt x="441" y="510"/>
                      </a:lnTo>
                      <a:lnTo>
                        <a:pt x="443" y="510"/>
                      </a:lnTo>
                      <a:lnTo>
                        <a:pt x="445" y="510"/>
                      </a:lnTo>
                      <a:lnTo>
                        <a:pt x="447" y="510"/>
                      </a:lnTo>
                      <a:lnTo>
                        <a:pt x="449" y="510"/>
                      </a:lnTo>
                      <a:lnTo>
                        <a:pt x="451" y="510"/>
                      </a:lnTo>
                      <a:lnTo>
                        <a:pt x="453" y="510"/>
                      </a:lnTo>
                      <a:lnTo>
                        <a:pt x="455" y="510"/>
                      </a:lnTo>
                      <a:lnTo>
                        <a:pt x="457" y="510"/>
                      </a:lnTo>
                      <a:lnTo>
                        <a:pt x="459" y="510"/>
                      </a:lnTo>
                      <a:lnTo>
                        <a:pt x="461" y="510"/>
                      </a:lnTo>
                      <a:lnTo>
                        <a:pt x="463" y="510"/>
                      </a:lnTo>
                      <a:lnTo>
                        <a:pt x="465" y="510"/>
                      </a:lnTo>
                      <a:lnTo>
                        <a:pt x="467" y="510"/>
                      </a:lnTo>
                      <a:lnTo>
                        <a:pt x="469" y="510"/>
                      </a:lnTo>
                      <a:lnTo>
                        <a:pt x="471" y="510"/>
                      </a:lnTo>
                      <a:lnTo>
                        <a:pt x="473" y="510"/>
                      </a:lnTo>
                      <a:lnTo>
                        <a:pt x="475" y="510"/>
                      </a:lnTo>
                      <a:lnTo>
                        <a:pt x="477" y="510"/>
                      </a:lnTo>
                      <a:lnTo>
                        <a:pt x="479" y="510"/>
                      </a:lnTo>
                      <a:lnTo>
                        <a:pt x="481" y="510"/>
                      </a:lnTo>
                      <a:lnTo>
                        <a:pt x="483" y="510"/>
                      </a:lnTo>
                      <a:lnTo>
                        <a:pt x="485" y="510"/>
                      </a:lnTo>
                      <a:lnTo>
                        <a:pt x="487" y="510"/>
                      </a:lnTo>
                      <a:lnTo>
                        <a:pt x="489" y="510"/>
                      </a:lnTo>
                      <a:lnTo>
                        <a:pt x="491" y="510"/>
                      </a:lnTo>
                      <a:lnTo>
                        <a:pt x="493" y="510"/>
                      </a:lnTo>
                      <a:lnTo>
                        <a:pt x="495" y="510"/>
                      </a:lnTo>
                      <a:lnTo>
                        <a:pt x="497" y="510"/>
                      </a:lnTo>
                      <a:lnTo>
                        <a:pt x="499" y="510"/>
                      </a:lnTo>
                      <a:lnTo>
                        <a:pt x="501" y="510"/>
                      </a:lnTo>
                      <a:lnTo>
                        <a:pt x="503" y="510"/>
                      </a:lnTo>
                      <a:lnTo>
                        <a:pt x="505" y="510"/>
                      </a:lnTo>
                      <a:lnTo>
                        <a:pt x="507" y="510"/>
                      </a:lnTo>
                    </a:path>
                  </a:pathLst>
                </a:custGeom>
                <a:noFill/>
                <a:ln w="6480">
                  <a:solidFill>
                    <a:srgbClr val="cccccc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06" name="Freeform 573"/>
              <p:cNvSpPr/>
              <p:nvPr/>
            </p:nvSpPr>
            <p:spPr>
              <a:xfrm>
                <a:off x="3846240" y="2812320"/>
                <a:ext cx="1032480" cy="988560"/>
              </a:xfrm>
              <a:custGeom>
                <a:avLst/>
                <a:gdLst>
                  <a:gd name="textAreaLeft" fmla="*/ 0 w 1032480"/>
                  <a:gd name="textAreaRight" fmla="*/ 1032840 w 1032480"/>
                  <a:gd name="textAreaTop" fmla="*/ 0 h 988560"/>
                  <a:gd name="textAreaBottom" fmla="*/ 988920 h 988560"/>
                </a:gdLst>
                <a:ahLst/>
                <a:rect l="textAreaLeft" t="textAreaTop" r="textAreaRight" b="textAreaBottom"/>
                <a:pathLst>
                  <a:path w="507" h="486">
                    <a:moveTo>
                      <a:pt x="0" y="486"/>
                    </a:moveTo>
                    <a:lnTo>
                      <a:pt x="0" y="356"/>
                    </a:lnTo>
                    <a:lnTo>
                      <a:pt x="0" y="396"/>
                    </a:lnTo>
                    <a:lnTo>
                      <a:pt x="2" y="434"/>
                    </a:lnTo>
                    <a:lnTo>
                      <a:pt x="4" y="450"/>
                    </a:lnTo>
                    <a:lnTo>
                      <a:pt x="6" y="452"/>
                    </a:lnTo>
                    <a:lnTo>
                      <a:pt x="8" y="452"/>
                    </a:lnTo>
                    <a:lnTo>
                      <a:pt x="10" y="450"/>
                    </a:lnTo>
                    <a:lnTo>
                      <a:pt x="12" y="450"/>
                    </a:lnTo>
                    <a:lnTo>
                      <a:pt x="14" y="450"/>
                    </a:lnTo>
                    <a:lnTo>
                      <a:pt x="16" y="448"/>
                    </a:lnTo>
                    <a:lnTo>
                      <a:pt x="18" y="444"/>
                    </a:lnTo>
                    <a:lnTo>
                      <a:pt x="20" y="440"/>
                    </a:lnTo>
                    <a:lnTo>
                      <a:pt x="22" y="438"/>
                    </a:lnTo>
                    <a:lnTo>
                      <a:pt x="24" y="434"/>
                    </a:lnTo>
                    <a:lnTo>
                      <a:pt x="26" y="432"/>
                    </a:lnTo>
                    <a:lnTo>
                      <a:pt x="28" y="430"/>
                    </a:lnTo>
                    <a:lnTo>
                      <a:pt x="30" y="430"/>
                    </a:lnTo>
                    <a:lnTo>
                      <a:pt x="32" y="432"/>
                    </a:lnTo>
                    <a:lnTo>
                      <a:pt x="34" y="432"/>
                    </a:lnTo>
                    <a:lnTo>
                      <a:pt x="36" y="434"/>
                    </a:lnTo>
                    <a:lnTo>
                      <a:pt x="38" y="434"/>
                    </a:lnTo>
                    <a:lnTo>
                      <a:pt x="40" y="436"/>
                    </a:lnTo>
                    <a:lnTo>
                      <a:pt x="42" y="438"/>
                    </a:lnTo>
                    <a:lnTo>
                      <a:pt x="44" y="440"/>
                    </a:lnTo>
                    <a:lnTo>
                      <a:pt x="46" y="438"/>
                    </a:lnTo>
                    <a:lnTo>
                      <a:pt x="48" y="436"/>
                    </a:lnTo>
                    <a:lnTo>
                      <a:pt x="50" y="434"/>
                    </a:lnTo>
                    <a:lnTo>
                      <a:pt x="52" y="432"/>
                    </a:lnTo>
                    <a:lnTo>
                      <a:pt x="54" y="434"/>
                    </a:lnTo>
                    <a:lnTo>
                      <a:pt x="56" y="436"/>
                    </a:lnTo>
                    <a:lnTo>
                      <a:pt x="58" y="436"/>
                    </a:lnTo>
                    <a:lnTo>
                      <a:pt x="60" y="432"/>
                    </a:lnTo>
                    <a:lnTo>
                      <a:pt x="62" y="426"/>
                    </a:lnTo>
                    <a:lnTo>
                      <a:pt x="64" y="422"/>
                    </a:lnTo>
                    <a:lnTo>
                      <a:pt x="66" y="420"/>
                    </a:lnTo>
                    <a:lnTo>
                      <a:pt x="68" y="422"/>
                    </a:lnTo>
                    <a:lnTo>
                      <a:pt x="70" y="426"/>
                    </a:lnTo>
                    <a:lnTo>
                      <a:pt x="72" y="430"/>
                    </a:lnTo>
                    <a:lnTo>
                      <a:pt x="74" y="430"/>
                    </a:lnTo>
                    <a:lnTo>
                      <a:pt x="76" y="426"/>
                    </a:lnTo>
                    <a:lnTo>
                      <a:pt x="78" y="422"/>
                    </a:lnTo>
                    <a:lnTo>
                      <a:pt x="80" y="420"/>
                    </a:lnTo>
                    <a:lnTo>
                      <a:pt x="82" y="420"/>
                    </a:lnTo>
                    <a:lnTo>
                      <a:pt x="84" y="420"/>
                    </a:lnTo>
                    <a:lnTo>
                      <a:pt x="86" y="420"/>
                    </a:lnTo>
                    <a:lnTo>
                      <a:pt x="88" y="422"/>
                    </a:lnTo>
                    <a:lnTo>
                      <a:pt x="90" y="422"/>
                    </a:lnTo>
                    <a:lnTo>
                      <a:pt x="92" y="416"/>
                    </a:lnTo>
                    <a:lnTo>
                      <a:pt x="94" y="406"/>
                    </a:lnTo>
                    <a:lnTo>
                      <a:pt x="96" y="396"/>
                    </a:lnTo>
                    <a:lnTo>
                      <a:pt x="98" y="394"/>
                    </a:lnTo>
                    <a:lnTo>
                      <a:pt x="100" y="396"/>
                    </a:lnTo>
                    <a:lnTo>
                      <a:pt x="102" y="396"/>
                    </a:lnTo>
                    <a:lnTo>
                      <a:pt x="104" y="392"/>
                    </a:lnTo>
                    <a:lnTo>
                      <a:pt x="106" y="382"/>
                    </a:lnTo>
                    <a:lnTo>
                      <a:pt x="108" y="374"/>
                    </a:lnTo>
                    <a:lnTo>
                      <a:pt x="110" y="366"/>
                    </a:lnTo>
                    <a:lnTo>
                      <a:pt x="112" y="360"/>
                    </a:lnTo>
                    <a:lnTo>
                      <a:pt x="114" y="356"/>
                    </a:lnTo>
                    <a:lnTo>
                      <a:pt x="116" y="352"/>
                    </a:lnTo>
                    <a:lnTo>
                      <a:pt x="118" y="338"/>
                    </a:lnTo>
                    <a:lnTo>
                      <a:pt x="120" y="322"/>
                    </a:lnTo>
                    <a:lnTo>
                      <a:pt x="122" y="314"/>
                    </a:lnTo>
                    <a:lnTo>
                      <a:pt x="124" y="310"/>
                    </a:lnTo>
                    <a:lnTo>
                      <a:pt x="126" y="302"/>
                    </a:lnTo>
                    <a:lnTo>
                      <a:pt x="128" y="288"/>
                    </a:lnTo>
                    <a:lnTo>
                      <a:pt x="130" y="284"/>
                    </a:lnTo>
                    <a:lnTo>
                      <a:pt x="132" y="284"/>
                    </a:lnTo>
                    <a:lnTo>
                      <a:pt x="134" y="282"/>
                    </a:lnTo>
                    <a:lnTo>
                      <a:pt x="136" y="268"/>
                    </a:lnTo>
                    <a:lnTo>
                      <a:pt x="138" y="244"/>
                    </a:lnTo>
                    <a:lnTo>
                      <a:pt x="140" y="228"/>
                    </a:lnTo>
                    <a:lnTo>
                      <a:pt x="142" y="218"/>
                    </a:lnTo>
                    <a:lnTo>
                      <a:pt x="144" y="198"/>
                    </a:lnTo>
                    <a:lnTo>
                      <a:pt x="146" y="178"/>
                    </a:lnTo>
                    <a:lnTo>
                      <a:pt x="148" y="164"/>
                    </a:lnTo>
                    <a:lnTo>
                      <a:pt x="150" y="144"/>
                    </a:lnTo>
                    <a:lnTo>
                      <a:pt x="152" y="142"/>
                    </a:lnTo>
                    <a:lnTo>
                      <a:pt x="154" y="166"/>
                    </a:lnTo>
                    <a:lnTo>
                      <a:pt x="156" y="176"/>
                    </a:lnTo>
                    <a:lnTo>
                      <a:pt x="158" y="146"/>
                    </a:lnTo>
                    <a:lnTo>
                      <a:pt x="160" y="114"/>
                    </a:lnTo>
                    <a:lnTo>
                      <a:pt x="162" y="112"/>
                    </a:lnTo>
                    <a:lnTo>
                      <a:pt x="164" y="104"/>
                    </a:lnTo>
                    <a:lnTo>
                      <a:pt x="166" y="70"/>
                    </a:lnTo>
                    <a:lnTo>
                      <a:pt x="168" y="54"/>
                    </a:lnTo>
                    <a:lnTo>
                      <a:pt x="170" y="66"/>
                    </a:lnTo>
                    <a:lnTo>
                      <a:pt x="172" y="86"/>
                    </a:lnTo>
                    <a:lnTo>
                      <a:pt x="174" y="76"/>
                    </a:lnTo>
                    <a:lnTo>
                      <a:pt x="176" y="36"/>
                    </a:lnTo>
                    <a:lnTo>
                      <a:pt x="178" y="10"/>
                    </a:lnTo>
                    <a:lnTo>
                      <a:pt x="180" y="0"/>
                    </a:lnTo>
                    <a:lnTo>
                      <a:pt x="182" y="4"/>
                    </a:lnTo>
                    <a:lnTo>
                      <a:pt x="184" y="22"/>
                    </a:lnTo>
                    <a:lnTo>
                      <a:pt x="186" y="30"/>
                    </a:lnTo>
                    <a:lnTo>
                      <a:pt x="188" y="28"/>
                    </a:lnTo>
                    <a:lnTo>
                      <a:pt x="190" y="26"/>
                    </a:lnTo>
                    <a:lnTo>
                      <a:pt x="192" y="18"/>
                    </a:lnTo>
                    <a:lnTo>
                      <a:pt x="194" y="0"/>
                    </a:lnTo>
                    <a:lnTo>
                      <a:pt x="196" y="0"/>
                    </a:lnTo>
                    <a:lnTo>
                      <a:pt x="198" y="42"/>
                    </a:lnTo>
                    <a:lnTo>
                      <a:pt x="200" y="64"/>
                    </a:lnTo>
                    <a:lnTo>
                      <a:pt x="202" y="74"/>
                    </a:lnTo>
                    <a:lnTo>
                      <a:pt x="204" y="72"/>
                    </a:lnTo>
                    <a:lnTo>
                      <a:pt x="206" y="62"/>
                    </a:lnTo>
                    <a:lnTo>
                      <a:pt x="208" y="82"/>
                    </a:lnTo>
                    <a:lnTo>
                      <a:pt x="210" y="118"/>
                    </a:lnTo>
                    <a:lnTo>
                      <a:pt x="212" y="142"/>
                    </a:lnTo>
                    <a:lnTo>
                      <a:pt x="214" y="166"/>
                    </a:lnTo>
                    <a:lnTo>
                      <a:pt x="216" y="198"/>
                    </a:lnTo>
                    <a:lnTo>
                      <a:pt x="218" y="222"/>
                    </a:lnTo>
                    <a:lnTo>
                      <a:pt x="220" y="224"/>
                    </a:lnTo>
                    <a:lnTo>
                      <a:pt x="222" y="208"/>
                    </a:lnTo>
                    <a:lnTo>
                      <a:pt x="224" y="210"/>
                    </a:lnTo>
                    <a:lnTo>
                      <a:pt x="226" y="242"/>
                    </a:lnTo>
                    <a:lnTo>
                      <a:pt x="228" y="270"/>
                    </a:lnTo>
                    <a:lnTo>
                      <a:pt x="230" y="284"/>
                    </a:lnTo>
                    <a:lnTo>
                      <a:pt x="232" y="290"/>
                    </a:lnTo>
                    <a:lnTo>
                      <a:pt x="234" y="294"/>
                    </a:lnTo>
                    <a:lnTo>
                      <a:pt x="236" y="304"/>
                    </a:lnTo>
                    <a:lnTo>
                      <a:pt x="238" y="322"/>
                    </a:lnTo>
                    <a:lnTo>
                      <a:pt x="240" y="342"/>
                    </a:lnTo>
                    <a:lnTo>
                      <a:pt x="242" y="356"/>
                    </a:lnTo>
                    <a:lnTo>
                      <a:pt x="244" y="358"/>
                    </a:lnTo>
                    <a:lnTo>
                      <a:pt x="246" y="358"/>
                    </a:lnTo>
                    <a:lnTo>
                      <a:pt x="248" y="364"/>
                    </a:lnTo>
                    <a:lnTo>
                      <a:pt x="250" y="378"/>
                    </a:lnTo>
                    <a:lnTo>
                      <a:pt x="252" y="394"/>
                    </a:lnTo>
                    <a:lnTo>
                      <a:pt x="254" y="406"/>
                    </a:lnTo>
                    <a:lnTo>
                      <a:pt x="255" y="414"/>
                    </a:lnTo>
                    <a:lnTo>
                      <a:pt x="257" y="420"/>
                    </a:lnTo>
                    <a:lnTo>
                      <a:pt x="259" y="424"/>
                    </a:lnTo>
                    <a:lnTo>
                      <a:pt x="261" y="426"/>
                    </a:lnTo>
                    <a:lnTo>
                      <a:pt x="263" y="426"/>
                    </a:lnTo>
                    <a:lnTo>
                      <a:pt x="265" y="428"/>
                    </a:lnTo>
                    <a:lnTo>
                      <a:pt x="267" y="430"/>
                    </a:lnTo>
                    <a:lnTo>
                      <a:pt x="269" y="434"/>
                    </a:lnTo>
                    <a:lnTo>
                      <a:pt x="271" y="440"/>
                    </a:lnTo>
                    <a:lnTo>
                      <a:pt x="273" y="448"/>
                    </a:lnTo>
                    <a:lnTo>
                      <a:pt x="275" y="456"/>
                    </a:lnTo>
                    <a:lnTo>
                      <a:pt x="277" y="460"/>
                    </a:lnTo>
                    <a:lnTo>
                      <a:pt x="279" y="460"/>
                    </a:lnTo>
                    <a:lnTo>
                      <a:pt x="281" y="462"/>
                    </a:lnTo>
                    <a:lnTo>
                      <a:pt x="283" y="464"/>
                    </a:lnTo>
                    <a:lnTo>
                      <a:pt x="285" y="468"/>
                    </a:lnTo>
                    <a:lnTo>
                      <a:pt x="287" y="470"/>
                    </a:lnTo>
                    <a:lnTo>
                      <a:pt x="289" y="472"/>
                    </a:lnTo>
                    <a:lnTo>
                      <a:pt x="291" y="474"/>
                    </a:lnTo>
                    <a:lnTo>
                      <a:pt x="293" y="476"/>
                    </a:lnTo>
                    <a:lnTo>
                      <a:pt x="295" y="478"/>
                    </a:lnTo>
                    <a:lnTo>
                      <a:pt x="297" y="478"/>
                    </a:lnTo>
                    <a:lnTo>
                      <a:pt x="299" y="480"/>
                    </a:lnTo>
                    <a:lnTo>
                      <a:pt x="301" y="482"/>
                    </a:lnTo>
                    <a:lnTo>
                      <a:pt x="303" y="482"/>
                    </a:lnTo>
                    <a:lnTo>
                      <a:pt x="305" y="484"/>
                    </a:lnTo>
                    <a:lnTo>
                      <a:pt x="307" y="484"/>
                    </a:lnTo>
                    <a:lnTo>
                      <a:pt x="309" y="484"/>
                    </a:lnTo>
                    <a:lnTo>
                      <a:pt x="311" y="484"/>
                    </a:lnTo>
                    <a:lnTo>
                      <a:pt x="313" y="484"/>
                    </a:lnTo>
                    <a:lnTo>
                      <a:pt x="315" y="484"/>
                    </a:lnTo>
                    <a:lnTo>
                      <a:pt x="317" y="484"/>
                    </a:lnTo>
                    <a:lnTo>
                      <a:pt x="319" y="484"/>
                    </a:lnTo>
                    <a:lnTo>
                      <a:pt x="321" y="486"/>
                    </a:lnTo>
                    <a:lnTo>
                      <a:pt x="323" y="486"/>
                    </a:lnTo>
                    <a:lnTo>
                      <a:pt x="325" y="486"/>
                    </a:lnTo>
                    <a:lnTo>
                      <a:pt x="327" y="486"/>
                    </a:lnTo>
                    <a:lnTo>
                      <a:pt x="329" y="486"/>
                    </a:lnTo>
                    <a:lnTo>
                      <a:pt x="331" y="486"/>
                    </a:lnTo>
                    <a:lnTo>
                      <a:pt x="333" y="486"/>
                    </a:lnTo>
                    <a:lnTo>
                      <a:pt x="335" y="486"/>
                    </a:lnTo>
                    <a:lnTo>
                      <a:pt x="337" y="486"/>
                    </a:lnTo>
                    <a:lnTo>
                      <a:pt x="339" y="486"/>
                    </a:lnTo>
                    <a:lnTo>
                      <a:pt x="341" y="486"/>
                    </a:lnTo>
                    <a:lnTo>
                      <a:pt x="343" y="486"/>
                    </a:lnTo>
                    <a:lnTo>
                      <a:pt x="345" y="486"/>
                    </a:lnTo>
                    <a:lnTo>
                      <a:pt x="347" y="486"/>
                    </a:lnTo>
                    <a:lnTo>
                      <a:pt x="349" y="486"/>
                    </a:lnTo>
                    <a:lnTo>
                      <a:pt x="351" y="486"/>
                    </a:lnTo>
                    <a:lnTo>
                      <a:pt x="353" y="486"/>
                    </a:lnTo>
                    <a:lnTo>
                      <a:pt x="355" y="486"/>
                    </a:lnTo>
                    <a:lnTo>
                      <a:pt x="357" y="486"/>
                    </a:lnTo>
                    <a:lnTo>
                      <a:pt x="359" y="486"/>
                    </a:lnTo>
                    <a:lnTo>
                      <a:pt x="361" y="486"/>
                    </a:lnTo>
                    <a:lnTo>
                      <a:pt x="363" y="486"/>
                    </a:lnTo>
                    <a:lnTo>
                      <a:pt x="365" y="486"/>
                    </a:lnTo>
                    <a:lnTo>
                      <a:pt x="367" y="486"/>
                    </a:lnTo>
                    <a:lnTo>
                      <a:pt x="369" y="486"/>
                    </a:lnTo>
                    <a:lnTo>
                      <a:pt x="371" y="486"/>
                    </a:lnTo>
                    <a:lnTo>
                      <a:pt x="373" y="486"/>
                    </a:lnTo>
                    <a:lnTo>
                      <a:pt x="375" y="486"/>
                    </a:lnTo>
                    <a:lnTo>
                      <a:pt x="377" y="486"/>
                    </a:lnTo>
                    <a:lnTo>
                      <a:pt x="379" y="486"/>
                    </a:lnTo>
                    <a:lnTo>
                      <a:pt x="381" y="486"/>
                    </a:lnTo>
                    <a:lnTo>
                      <a:pt x="383" y="486"/>
                    </a:lnTo>
                    <a:lnTo>
                      <a:pt x="385" y="486"/>
                    </a:lnTo>
                    <a:lnTo>
                      <a:pt x="387" y="486"/>
                    </a:lnTo>
                    <a:lnTo>
                      <a:pt x="389" y="486"/>
                    </a:lnTo>
                    <a:lnTo>
                      <a:pt x="391" y="486"/>
                    </a:lnTo>
                    <a:lnTo>
                      <a:pt x="393" y="486"/>
                    </a:lnTo>
                    <a:lnTo>
                      <a:pt x="395" y="486"/>
                    </a:lnTo>
                    <a:lnTo>
                      <a:pt x="397" y="486"/>
                    </a:lnTo>
                    <a:lnTo>
                      <a:pt x="399" y="486"/>
                    </a:lnTo>
                    <a:lnTo>
                      <a:pt x="401" y="486"/>
                    </a:lnTo>
                    <a:lnTo>
                      <a:pt x="403" y="486"/>
                    </a:lnTo>
                    <a:lnTo>
                      <a:pt x="405" y="486"/>
                    </a:lnTo>
                    <a:lnTo>
                      <a:pt x="407" y="486"/>
                    </a:lnTo>
                    <a:lnTo>
                      <a:pt x="409" y="486"/>
                    </a:lnTo>
                    <a:lnTo>
                      <a:pt x="411" y="486"/>
                    </a:lnTo>
                    <a:lnTo>
                      <a:pt x="413" y="486"/>
                    </a:lnTo>
                    <a:lnTo>
                      <a:pt x="415" y="486"/>
                    </a:lnTo>
                    <a:lnTo>
                      <a:pt x="417" y="486"/>
                    </a:lnTo>
                    <a:lnTo>
                      <a:pt x="419" y="486"/>
                    </a:lnTo>
                    <a:lnTo>
                      <a:pt x="421" y="486"/>
                    </a:lnTo>
                    <a:lnTo>
                      <a:pt x="423" y="486"/>
                    </a:lnTo>
                    <a:lnTo>
                      <a:pt x="425" y="486"/>
                    </a:lnTo>
                    <a:lnTo>
                      <a:pt x="427" y="486"/>
                    </a:lnTo>
                    <a:lnTo>
                      <a:pt x="429" y="486"/>
                    </a:lnTo>
                    <a:lnTo>
                      <a:pt x="431" y="486"/>
                    </a:lnTo>
                    <a:lnTo>
                      <a:pt x="433" y="486"/>
                    </a:lnTo>
                    <a:lnTo>
                      <a:pt x="435" y="486"/>
                    </a:lnTo>
                    <a:lnTo>
                      <a:pt x="437" y="486"/>
                    </a:lnTo>
                    <a:lnTo>
                      <a:pt x="439" y="486"/>
                    </a:lnTo>
                    <a:lnTo>
                      <a:pt x="441" y="486"/>
                    </a:lnTo>
                    <a:lnTo>
                      <a:pt x="443" y="486"/>
                    </a:lnTo>
                    <a:lnTo>
                      <a:pt x="445" y="486"/>
                    </a:lnTo>
                    <a:lnTo>
                      <a:pt x="447" y="486"/>
                    </a:lnTo>
                    <a:lnTo>
                      <a:pt x="449" y="486"/>
                    </a:lnTo>
                    <a:lnTo>
                      <a:pt x="451" y="486"/>
                    </a:lnTo>
                    <a:lnTo>
                      <a:pt x="453" y="486"/>
                    </a:lnTo>
                    <a:lnTo>
                      <a:pt x="455" y="486"/>
                    </a:lnTo>
                    <a:lnTo>
                      <a:pt x="457" y="486"/>
                    </a:lnTo>
                    <a:lnTo>
                      <a:pt x="459" y="486"/>
                    </a:lnTo>
                    <a:lnTo>
                      <a:pt x="461" y="486"/>
                    </a:lnTo>
                    <a:lnTo>
                      <a:pt x="463" y="486"/>
                    </a:lnTo>
                    <a:lnTo>
                      <a:pt x="465" y="486"/>
                    </a:lnTo>
                    <a:lnTo>
                      <a:pt x="467" y="486"/>
                    </a:lnTo>
                    <a:lnTo>
                      <a:pt x="469" y="486"/>
                    </a:lnTo>
                    <a:lnTo>
                      <a:pt x="471" y="486"/>
                    </a:lnTo>
                    <a:lnTo>
                      <a:pt x="473" y="486"/>
                    </a:lnTo>
                    <a:lnTo>
                      <a:pt x="475" y="486"/>
                    </a:lnTo>
                    <a:lnTo>
                      <a:pt x="477" y="486"/>
                    </a:lnTo>
                    <a:lnTo>
                      <a:pt x="479" y="486"/>
                    </a:lnTo>
                    <a:lnTo>
                      <a:pt x="481" y="486"/>
                    </a:lnTo>
                    <a:lnTo>
                      <a:pt x="483" y="486"/>
                    </a:lnTo>
                    <a:lnTo>
                      <a:pt x="485" y="486"/>
                    </a:lnTo>
                    <a:lnTo>
                      <a:pt x="487" y="486"/>
                    </a:lnTo>
                    <a:lnTo>
                      <a:pt x="489" y="486"/>
                    </a:lnTo>
                    <a:lnTo>
                      <a:pt x="491" y="486"/>
                    </a:lnTo>
                    <a:lnTo>
                      <a:pt x="493" y="486"/>
                    </a:lnTo>
                    <a:lnTo>
                      <a:pt x="495" y="486"/>
                    </a:lnTo>
                    <a:lnTo>
                      <a:pt x="497" y="486"/>
                    </a:lnTo>
                    <a:lnTo>
                      <a:pt x="499" y="486"/>
                    </a:lnTo>
                    <a:lnTo>
                      <a:pt x="501" y="486"/>
                    </a:lnTo>
                    <a:lnTo>
                      <a:pt x="503" y="486"/>
                    </a:lnTo>
                    <a:lnTo>
                      <a:pt x="505" y="486"/>
                    </a:lnTo>
                    <a:lnTo>
                      <a:pt x="507" y="486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07" name="Text Box 36"/>
            <p:cNvSpPr/>
            <p:nvPr/>
          </p:nvSpPr>
          <p:spPr>
            <a:xfrm>
              <a:off x="4357800" y="2751120"/>
              <a:ext cx="78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6/87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8" name="Group 577"/>
          <p:cNvGrpSpPr/>
          <p:nvPr/>
        </p:nvGrpSpPr>
        <p:grpSpPr>
          <a:xfrm>
            <a:off x="5061600" y="1251000"/>
            <a:ext cx="1439280" cy="1157040"/>
            <a:chOff x="5061600" y="1251000"/>
            <a:chExt cx="1439280" cy="1157040"/>
          </a:xfrm>
        </p:grpSpPr>
        <p:grpSp>
          <p:nvGrpSpPr>
            <p:cNvPr id="909" name="Group 307"/>
            <p:cNvGrpSpPr/>
            <p:nvPr/>
          </p:nvGrpSpPr>
          <p:grpSpPr>
            <a:xfrm>
              <a:off x="5061600" y="1260000"/>
              <a:ext cx="1213560" cy="1148040"/>
              <a:chOff x="5061600" y="1260000"/>
              <a:chExt cx="1213560" cy="1148040"/>
            </a:xfrm>
          </p:grpSpPr>
          <p:grpSp>
            <p:nvGrpSpPr>
              <p:cNvPr id="910" name="Group 308"/>
              <p:cNvGrpSpPr/>
              <p:nvPr/>
            </p:nvGrpSpPr>
            <p:grpSpPr>
              <a:xfrm>
                <a:off x="5061600" y="1260000"/>
                <a:ext cx="1213560" cy="1148040"/>
                <a:chOff x="5061600" y="1260000"/>
                <a:chExt cx="1213560" cy="1148040"/>
              </a:xfrm>
            </p:grpSpPr>
            <p:sp>
              <p:nvSpPr>
                <p:cNvPr id="911" name="Rectangle 309"/>
                <p:cNvSpPr/>
                <p:nvPr/>
              </p:nvSpPr>
              <p:spPr>
                <a:xfrm>
                  <a:off x="5190840" y="1262160"/>
                  <a:ext cx="1049400" cy="104940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12" name="Group 310"/>
                <p:cNvGrpSpPr/>
                <p:nvPr/>
              </p:nvGrpSpPr>
              <p:grpSpPr>
                <a:xfrm>
                  <a:off x="5146560" y="2309760"/>
                  <a:ext cx="1128600" cy="98280"/>
                  <a:chOff x="5146560" y="2309760"/>
                  <a:chExt cx="1128600" cy="98280"/>
                </a:xfrm>
              </p:grpSpPr>
              <p:sp>
                <p:nvSpPr>
                  <p:cNvPr id="913" name="Line 311"/>
                  <p:cNvSpPr/>
                  <p:nvPr/>
                </p:nvSpPr>
                <p:spPr>
                  <a:xfrm>
                    <a:off x="5188320" y="2309760"/>
                    <a:ext cx="104940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914" name="Group 312"/>
                  <p:cNvGrpSpPr/>
                  <p:nvPr/>
                </p:nvGrpSpPr>
                <p:grpSpPr>
                  <a:xfrm>
                    <a:off x="5188320" y="2313720"/>
                    <a:ext cx="1049040" cy="23760"/>
                    <a:chOff x="5188320" y="2313720"/>
                    <a:chExt cx="1049040" cy="23760"/>
                  </a:xfrm>
                </p:grpSpPr>
                <p:sp>
                  <p:nvSpPr>
                    <p:cNvPr id="915" name="Line 313"/>
                    <p:cNvSpPr/>
                    <p:nvPr/>
                  </p:nvSpPr>
                  <p:spPr>
                    <a:xfrm>
                      <a:off x="5188320" y="23137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6" name="Line 314"/>
                    <p:cNvSpPr/>
                    <p:nvPr/>
                  </p:nvSpPr>
                  <p:spPr>
                    <a:xfrm>
                      <a:off x="526572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7" name="Line 315"/>
                    <p:cNvSpPr/>
                    <p:nvPr/>
                  </p:nvSpPr>
                  <p:spPr>
                    <a:xfrm>
                      <a:off x="531036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8" name="Line 316"/>
                    <p:cNvSpPr/>
                    <p:nvPr/>
                  </p:nvSpPr>
                  <p:spPr>
                    <a:xfrm>
                      <a:off x="534276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9" name="Line 317"/>
                    <p:cNvSpPr/>
                    <p:nvPr/>
                  </p:nvSpPr>
                  <p:spPr>
                    <a:xfrm>
                      <a:off x="5371200" y="231372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0" name="Line 318"/>
                    <p:cNvSpPr/>
                    <p:nvPr/>
                  </p:nvSpPr>
                  <p:spPr>
                    <a:xfrm>
                      <a:off x="539136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1" name="Line 319"/>
                    <p:cNvSpPr/>
                    <p:nvPr/>
                  </p:nvSpPr>
                  <p:spPr>
                    <a:xfrm>
                      <a:off x="540792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2" name="Line 320"/>
                    <p:cNvSpPr/>
                    <p:nvPr/>
                  </p:nvSpPr>
                  <p:spPr>
                    <a:xfrm>
                      <a:off x="542412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3" name="Line 321"/>
                    <p:cNvSpPr/>
                    <p:nvPr/>
                  </p:nvSpPr>
                  <p:spPr>
                    <a:xfrm>
                      <a:off x="543600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4" name="Line 322"/>
                    <p:cNvSpPr/>
                    <p:nvPr/>
                  </p:nvSpPr>
                  <p:spPr>
                    <a:xfrm>
                      <a:off x="5448600" y="23137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5" name="Line 323"/>
                    <p:cNvSpPr/>
                    <p:nvPr/>
                  </p:nvSpPr>
                  <p:spPr>
                    <a:xfrm>
                      <a:off x="552960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6" name="Line 324"/>
                    <p:cNvSpPr/>
                    <p:nvPr/>
                  </p:nvSpPr>
                  <p:spPr>
                    <a:xfrm>
                      <a:off x="557460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7" name="Line 325"/>
                    <p:cNvSpPr/>
                    <p:nvPr/>
                  </p:nvSpPr>
                  <p:spPr>
                    <a:xfrm>
                      <a:off x="560736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8" name="Line 326"/>
                    <p:cNvSpPr/>
                    <p:nvPr/>
                  </p:nvSpPr>
                  <p:spPr>
                    <a:xfrm>
                      <a:off x="5631480" y="231372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9" name="Line 327"/>
                    <p:cNvSpPr/>
                    <p:nvPr/>
                  </p:nvSpPr>
                  <p:spPr>
                    <a:xfrm>
                      <a:off x="565560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0" name="Line 328"/>
                    <p:cNvSpPr/>
                    <p:nvPr/>
                  </p:nvSpPr>
                  <p:spPr>
                    <a:xfrm>
                      <a:off x="567216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1" name="Line 329"/>
                    <p:cNvSpPr/>
                    <p:nvPr/>
                  </p:nvSpPr>
                  <p:spPr>
                    <a:xfrm>
                      <a:off x="568836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2" name="Line 330"/>
                    <p:cNvSpPr/>
                    <p:nvPr/>
                  </p:nvSpPr>
                  <p:spPr>
                    <a:xfrm>
                      <a:off x="570096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3" name="Line 331"/>
                    <p:cNvSpPr/>
                    <p:nvPr/>
                  </p:nvSpPr>
                  <p:spPr>
                    <a:xfrm>
                      <a:off x="5712840" y="23137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4" name="Line 332"/>
                    <p:cNvSpPr/>
                    <p:nvPr/>
                  </p:nvSpPr>
                  <p:spPr>
                    <a:xfrm>
                      <a:off x="579024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5" name="Line 333"/>
                    <p:cNvSpPr/>
                    <p:nvPr/>
                  </p:nvSpPr>
                  <p:spPr>
                    <a:xfrm>
                      <a:off x="583848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6" name="Line 334"/>
                    <p:cNvSpPr/>
                    <p:nvPr/>
                  </p:nvSpPr>
                  <p:spPr>
                    <a:xfrm>
                      <a:off x="587124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7" name="Line 335"/>
                    <p:cNvSpPr/>
                    <p:nvPr/>
                  </p:nvSpPr>
                  <p:spPr>
                    <a:xfrm>
                      <a:off x="5895720" y="231372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8" name="Line 336"/>
                    <p:cNvSpPr/>
                    <p:nvPr/>
                  </p:nvSpPr>
                  <p:spPr>
                    <a:xfrm>
                      <a:off x="591624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9" name="Line 337"/>
                    <p:cNvSpPr/>
                    <p:nvPr/>
                  </p:nvSpPr>
                  <p:spPr>
                    <a:xfrm>
                      <a:off x="593640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0" name="Line 338"/>
                    <p:cNvSpPr/>
                    <p:nvPr/>
                  </p:nvSpPr>
                  <p:spPr>
                    <a:xfrm>
                      <a:off x="594828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1" name="Line 339"/>
                    <p:cNvSpPr/>
                    <p:nvPr/>
                  </p:nvSpPr>
                  <p:spPr>
                    <a:xfrm>
                      <a:off x="596484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2" name="Line 340"/>
                    <p:cNvSpPr/>
                    <p:nvPr/>
                  </p:nvSpPr>
                  <p:spPr>
                    <a:xfrm>
                      <a:off x="5977080" y="23137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3" name="Line 341"/>
                    <p:cNvSpPr/>
                    <p:nvPr/>
                  </p:nvSpPr>
                  <p:spPr>
                    <a:xfrm>
                      <a:off x="605448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4" name="Line 342"/>
                    <p:cNvSpPr/>
                    <p:nvPr/>
                  </p:nvSpPr>
                  <p:spPr>
                    <a:xfrm>
                      <a:off x="610344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5" name="Line 343"/>
                    <p:cNvSpPr/>
                    <p:nvPr/>
                  </p:nvSpPr>
                  <p:spPr>
                    <a:xfrm>
                      <a:off x="613548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6" name="Line 344"/>
                    <p:cNvSpPr/>
                    <p:nvPr/>
                  </p:nvSpPr>
                  <p:spPr>
                    <a:xfrm>
                      <a:off x="6159960" y="231372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7" name="Line 345"/>
                    <p:cNvSpPr/>
                    <p:nvPr/>
                  </p:nvSpPr>
                  <p:spPr>
                    <a:xfrm>
                      <a:off x="618012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8" name="Line 346"/>
                    <p:cNvSpPr/>
                    <p:nvPr/>
                  </p:nvSpPr>
                  <p:spPr>
                    <a:xfrm>
                      <a:off x="619632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9" name="Line 347"/>
                    <p:cNvSpPr/>
                    <p:nvPr/>
                  </p:nvSpPr>
                  <p:spPr>
                    <a:xfrm>
                      <a:off x="621288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0" name="Line 348"/>
                    <p:cNvSpPr/>
                    <p:nvPr/>
                  </p:nvSpPr>
                  <p:spPr>
                    <a:xfrm>
                      <a:off x="6225120" y="23137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1" name="Line 349"/>
                    <p:cNvSpPr/>
                    <p:nvPr/>
                  </p:nvSpPr>
                  <p:spPr>
                    <a:xfrm>
                      <a:off x="6237360" y="23137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952" name="Group 350"/>
                  <p:cNvGrpSpPr/>
                  <p:nvPr/>
                </p:nvGrpSpPr>
                <p:grpSpPr>
                  <a:xfrm>
                    <a:off x="5146560" y="2345760"/>
                    <a:ext cx="1128600" cy="62280"/>
                    <a:chOff x="5146560" y="2345760"/>
                    <a:chExt cx="1128600" cy="62280"/>
                  </a:xfrm>
                </p:grpSpPr>
                <p:sp>
                  <p:nvSpPr>
                    <p:cNvPr id="953" name="Rectangle 351"/>
                    <p:cNvSpPr/>
                    <p:nvPr/>
                  </p:nvSpPr>
                  <p:spPr>
                    <a:xfrm>
                      <a:off x="5146560" y="23619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4" name="Rectangle 352"/>
                    <p:cNvSpPr/>
                    <p:nvPr/>
                  </p:nvSpPr>
                  <p:spPr>
                    <a:xfrm>
                      <a:off x="5204160" y="23457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5" name="Rectangle 353"/>
                    <p:cNvSpPr/>
                    <p:nvPr/>
                  </p:nvSpPr>
                  <p:spPr>
                    <a:xfrm>
                      <a:off x="5406840" y="23619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6" name="Rectangle 354"/>
                    <p:cNvSpPr/>
                    <p:nvPr/>
                  </p:nvSpPr>
                  <p:spPr>
                    <a:xfrm>
                      <a:off x="5464440" y="23457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7" name="Rectangle 355"/>
                    <p:cNvSpPr/>
                    <p:nvPr/>
                  </p:nvSpPr>
                  <p:spPr>
                    <a:xfrm>
                      <a:off x="5671800" y="23619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8" name="Rectangle 356"/>
                    <p:cNvSpPr/>
                    <p:nvPr/>
                  </p:nvSpPr>
                  <p:spPr>
                    <a:xfrm>
                      <a:off x="5729040" y="23457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9" name="Rectangle 357"/>
                    <p:cNvSpPr/>
                    <p:nvPr/>
                  </p:nvSpPr>
                  <p:spPr>
                    <a:xfrm>
                      <a:off x="5935320" y="23619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0" name="Rectangle 358"/>
                    <p:cNvSpPr/>
                    <p:nvPr/>
                  </p:nvSpPr>
                  <p:spPr>
                    <a:xfrm>
                      <a:off x="5993280" y="23457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1" name="Rectangle 359"/>
                    <p:cNvSpPr/>
                    <p:nvPr/>
                  </p:nvSpPr>
                  <p:spPr>
                    <a:xfrm>
                      <a:off x="6195240" y="23619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2" name="Rectangle 360"/>
                    <p:cNvSpPr/>
                    <p:nvPr/>
                  </p:nvSpPr>
                  <p:spPr>
                    <a:xfrm>
                      <a:off x="6253200" y="23457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grpSp>
              <p:nvGrpSpPr>
                <p:cNvPr id="963" name="Group 361"/>
                <p:cNvGrpSpPr/>
                <p:nvPr/>
              </p:nvGrpSpPr>
              <p:grpSpPr>
                <a:xfrm>
                  <a:off x="5061600" y="1260000"/>
                  <a:ext cx="126360" cy="1067040"/>
                  <a:chOff x="5061600" y="1260000"/>
                  <a:chExt cx="126360" cy="1067040"/>
                </a:xfrm>
              </p:grpSpPr>
              <p:sp>
                <p:nvSpPr>
                  <p:cNvPr id="964" name="Line 362"/>
                  <p:cNvSpPr/>
                  <p:nvPr/>
                </p:nvSpPr>
                <p:spPr>
                  <a:xfrm flipV="1">
                    <a:off x="5187960" y="1260000"/>
                    <a:ext cx="0" cy="104940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965" name="Group 363"/>
                  <p:cNvGrpSpPr/>
                  <p:nvPr/>
                </p:nvGrpSpPr>
                <p:grpSpPr>
                  <a:xfrm>
                    <a:off x="5061600" y="1280520"/>
                    <a:ext cx="79200" cy="1046520"/>
                    <a:chOff x="5061600" y="1280520"/>
                    <a:chExt cx="79200" cy="1046520"/>
                  </a:xfrm>
                </p:grpSpPr>
                <p:sp>
                  <p:nvSpPr>
                    <p:cNvPr id="966" name="Rectangle 364"/>
                    <p:cNvSpPr/>
                    <p:nvPr/>
                  </p:nvSpPr>
                  <p:spPr>
                    <a:xfrm>
                      <a:off x="5118840" y="22809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7" name="Rectangle 365"/>
                    <p:cNvSpPr/>
                    <p:nvPr/>
                  </p:nvSpPr>
                  <p:spPr>
                    <a:xfrm>
                      <a:off x="5090040" y="20815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8" name="Rectangle 366"/>
                    <p:cNvSpPr/>
                    <p:nvPr/>
                  </p:nvSpPr>
                  <p:spPr>
                    <a:xfrm>
                      <a:off x="5090040" y="18824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9" name="Rectangle 367"/>
                    <p:cNvSpPr/>
                    <p:nvPr/>
                  </p:nvSpPr>
                  <p:spPr>
                    <a:xfrm>
                      <a:off x="5090040" y="167904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0" name="Rectangle 368"/>
                    <p:cNvSpPr/>
                    <p:nvPr/>
                  </p:nvSpPr>
                  <p:spPr>
                    <a:xfrm>
                      <a:off x="5090040" y="14796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1" name="Rectangle 369"/>
                    <p:cNvSpPr/>
                    <p:nvPr/>
                  </p:nvSpPr>
                  <p:spPr>
                    <a:xfrm>
                      <a:off x="5061600" y="128052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972" name="Group 370"/>
                  <p:cNvGrpSpPr/>
                  <p:nvPr/>
                </p:nvGrpSpPr>
                <p:grpSpPr>
                  <a:xfrm>
                    <a:off x="5163840" y="1308600"/>
                    <a:ext cx="23760" cy="1000440"/>
                    <a:chOff x="5163840" y="1308600"/>
                    <a:chExt cx="23760" cy="1000440"/>
                  </a:xfrm>
                </p:grpSpPr>
                <p:sp>
                  <p:nvSpPr>
                    <p:cNvPr id="973" name="Line 371"/>
                    <p:cNvSpPr/>
                    <p:nvPr/>
                  </p:nvSpPr>
                  <p:spPr>
                    <a:xfrm flipH="1">
                      <a:off x="5163840" y="230904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4" name="Line 372"/>
                    <p:cNvSpPr/>
                    <p:nvPr/>
                  </p:nvSpPr>
                  <p:spPr>
                    <a:xfrm flipH="1">
                      <a:off x="5179680" y="226008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5" name="Line 373"/>
                    <p:cNvSpPr/>
                    <p:nvPr/>
                  </p:nvSpPr>
                  <p:spPr>
                    <a:xfrm flipH="1">
                      <a:off x="5179680" y="221148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6" name="Line 374"/>
                    <p:cNvSpPr/>
                    <p:nvPr/>
                  </p:nvSpPr>
                  <p:spPr>
                    <a:xfrm flipH="1">
                      <a:off x="5179680" y="215892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7" name="Line 375"/>
                    <p:cNvSpPr/>
                    <p:nvPr/>
                  </p:nvSpPr>
                  <p:spPr>
                    <a:xfrm flipH="1">
                      <a:off x="5163840" y="210996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8" name="Line 376"/>
                    <p:cNvSpPr/>
                    <p:nvPr/>
                  </p:nvSpPr>
                  <p:spPr>
                    <a:xfrm flipH="1">
                      <a:off x="5179680" y="206100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9" name="Line 377"/>
                    <p:cNvSpPr/>
                    <p:nvPr/>
                  </p:nvSpPr>
                  <p:spPr>
                    <a:xfrm flipH="1">
                      <a:off x="5179680" y="200808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0" name="Line 378"/>
                    <p:cNvSpPr/>
                    <p:nvPr/>
                  </p:nvSpPr>
                  <p:spPr>
                    <a:xfrm flipH="1">
                      <a:off x="5179680" y="195948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1" name="Line 379"/>
                    <p:cNvSpPr/>
                    <p:nvPr/>
                  </p:nvSpPr>
                  <p:spPr>
                    <a:xfrm flipH="1">
                      <a:off x="5163840" y="191052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2" name="Line 380"/>
                    <p:cNvSpPr/>
                    <p:nvPr/>
                  </p:nvSpPr>
                  <p:spPr>
                    <a:xfrm flipH="1">
                      <a:off x="5179680" y="185760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3" name="Line 381"/>
                    <p:cNvSpPr/>
                    <p:nvPr/>
                  </p:nvSpPr>
                  <p:spPr>
                    <a:xfrm flipH="1">
                      <a:off x="5179680" y="180864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4" name="Line 382"/>
                    <p:cNvSpPr/>
                    <p:nvPr/>
                  </p:nvSpPr>
                  <p:spPr>
                    <a:xfrm flipH="1">
                      <a:off x="5179680" y="176004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5" name="Line 383"/>
                    <p:cNvSpPr/>
                    <p:nvPr/>
                  </p:nvSpPr>
                  <p:spPr>
                    <a:xfrm flipH="1">
                      <a:off x="5163840" y="170748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6" name="Line 384"/>
                    <p:cNvSpPr/>
                    <p:nvPr/>
                  </p:nvSpPr>
                  <p:spPr>
                    <a:xfrm flipH="1">
                      <a:off x="5179680" y="165852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7" name="Line 385"/>
                    <p:cNvSpPr/>
                    <p:nvPr/>
                  </p:nvSpPr>
                  <p:spPr>
                    <a:xfrm flipH="1">
                      <a:off x="5179680" y="160956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8" name="Line 386"/>
                    <p:cNvSpPr/>
                    <p:nvPr/>
                  </p:nvSpPr>
                  <p:spPr>
                    <a:xfrm flipH="1">
                      <a:off x="5179680" y="155664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9" name="Line 387"/>
                    <p:cNvSpPr/>
                    <p:nvPr/>
                  </p:nvSpPr>
                  <p:spPr>
                    <a:xfrm flipH="1">
                      <a:off x="5163840" y="150804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90" name="Line 388"/>
                    <p:cNvSpPr/>
                    <p:nvPr/>
                  </p:nvSpPr>
                  <p:spPr>
                    <a:xfrm flipH="1">
                      <a:off x="5179680" y="145908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91" name="Line 389"/>
                    <p:cNvSpPr/>
                    <p:nvPr/>
                  </p:nvSpPr>
                  <p:spPr>
                    <a:xfrm flipH="1">
                      <a:off x="5179680" y="140616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92" name="Line 390"/>
                    <p:cNvSpPr/>
                    <p:nvPr/>
                  </p:nvSpPr>
                  <p:spPr>
                    <a:xfrm flipH="1">
                      <a:off x="5179680" y="1357200"/>
                      <a:ext cx="75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93" name="Line 391"/>
                    <p:cNvSpPr/>
                    <p:nvPr/>
                  </p:nvSpPr>
                  <p:spPr>
                    <a:xfrm flipH="1">
                      <a:off x="5163840" y="130860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994" name="Group 392"/>
              <p:cNvGrpSpPr/>
              <p:nvPr/>
            </p:nvGrpSpPr>
            <p:grpSpPr>
              <a:xfrm>
                <a:off x="5196960" y="1267920"/>
                <a:ext cx="1037160" cy="1041840"/>
                <a:chOff x="5196960" y="1267920"/>
                <a:chExt cx="1037160" cy="1041840"/>
              </a:xfrm>
            </p:grpSpPr>
            <p:sp>
              <p:nvSpPr>
                <p:cNvPr id="995" name="Freeform 393"/>
                <p:cNvSpPr/>
                <p:nvPr/>
              </p:nvSpPr>
              <p:spPr>
                <a:xfrm>
                  <a:off x="5196960" y="1267920"/>
                  <a:ext cx="1037160" cy="1037880"/>
                </a:xfrm>
                <a:custGeom>
                  <a:avLst/>
                  <a:gdLst>
                    <a:gd name="textAreaLeft" fmla="*/ 0 w 1037160"/>
                    <a:gd name="textAreaRight" fmla="*/ 1037520 w 1037160"/>
                    <a:gd name="textAreaTop" fmla="*/ 0 h 1037880"/>
                    <a:gd name="textAreaBottom" fmla="*/ 1038240 h 1037880"/>
                  </a:gdLst>
                  <a:ahLst/>
                  <a:rect l="textAreaLeft" t="textAreaTop" r="textAreaRight" b="textAreaBottom"/>
                  <a:pathLst>
                    <a:path w="510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58"/>
                      </a:lnTo>
                      <a:lnTo>
                        <a:pt x="4" y="150"/>
                      </a:lnTo>
                      <a:lnTo>
                        <a:pt x="6" y="136"/>
                      </a:lnTo>
                      <a:lnTo>
                        <a:pt x="8" y="116"/>
                      </a:lnTo>
                      <a:lnTo>
                        <a:pt x="10" y="108"/>
                      </a:lnTo>
                      <a:lnTo>
                        <a:pt x="12" y="118"/>
                      </a:lnTo>
                      <a:lnTo>
                        <a:pt x="14" y="140"/>
                      </a:lnTo>
                      <a:lnTo>
                        <a:pt x="16" y="138"/>
                      </a:lnTo>
                      <a:lnTo>
                        <a:pt x="18" y="128"/>
                      </a:lnTo>
                      <a:lnTo>
                        <a:pt x="20" y="132"/>
                      </a:lnTo>
                      <a:lnTo>
                        <a:pt x="22" y="124"/>
                      </a:lnTo>
                      <a:lnTo>
                        <a:pt x="24" y="96"/>
                      </a:lnTo>
                      <a:lnTo>
                        <a:pt x="26" y="98"/>
                      </a:lnTo>
                      <a:lnTo>
                        <a:pt x="28" y="116"/>
                      </a:lnTo>
                      <a:lnTo>
                        <a:pt x="30" y="94"/>
                      </a:lnTo>
                      <a:lnTo>
                        <a:pt x="32" y="72"/>
                      </a:lnTo>
                      <a:lnTo>
                        <a:pt x="34" y="62"/>
                      </a:lnTo>
                      <a:lnTo>
                        <a:pt x="36" y="56"/>
                      </a:lnTo>
                      <a:lnTo>
                        <a:pt x="38" y="64"/>
                      </a:lnTo>
                      <a:lnTo>
                        <a:pt x="40" y="64"/>
                      </a:lnTo>
                      <a:lnTo>
                        <a:pt x="42" y="38"/>
                      </a:lnTo>
                      <a:lnTo>
                        <a:pt x="44" y="24"/>
                      </a:lnTo>
                      <a:lnTo>
                        <a:pt x="46" y="58"/>
                      </a:lnTo>
                      <a:lnTo>
                        <a:pt x="48" y="104"/>
                      </a:lnTo>
                      <a:lnTo>
                        <a:pt x="50" y="124"/>
                      </a:lnTo>
                      <a:lnTo>
                        <a:pt x="52" y="132"/>
                      </a:lnTo>
                      <a:lnTo>
                        <a:pt x="54" y="130"/>
                      </a:lnTo>
                      <a:lnTo>
                        <a:pt x="56" y="140"/>
                      </a:lnTo>
                      <a:lnTo>
                        <a:pt x="58" y="166"/>
                      </a:lnTo>
                      <a:lnTo>
                        <a:pt x="60" y="182"/>
                      </a:lnTo>
                      <a:lnTo>
                        <a:pt x="62" y="172"/>
                      </a:lnTo>
                      <a:lnTo>
                        <a:pt x="64" y="174"/>
                      </a:lnTo>
                      <a:lnTo>
                        <a:pt x="66" y="200"/>
                      </a:lnTo>
                      <a:lnTo>
                        <a:pt x="68" y="236"/>
                      </a:lnTo>
                      <a:lnTo>
                        <a:pt x="70" y="270"/>
                      </a:lnTo>
                      <a:lnTo>
                        <a:pt x="72" y="292"/>
                      </a:lnTo>
                      <a:lnTo>
                        <a:pt x="74" y="296"/>
                      </a:lnTo>
                      <a:lnTo>
                        <a:pt x="76" y="298"/>
                      </a:lnTo>
                      <a:lnTo>
                        <a:pt x="78" y="314"/>
                      </a:lnTo>
                      <a:lnTo>
                        <a:pt x="80" y="334"/>
                      </a:lnTo>
                      <a:lnTo>
                        <a:pt x="82" y="352"/>
                      </a:lnTo>
                      <a:lnTo>
                        <a:pt x="84" y="368"/>
                      </a:lnTo>
                      <a:lnTo>
                        <a:pt x="86" y="384"/>
                      </a:lnTo>
                      <a:lnTo>
                        <a:pt x="88" y="392"/>
                      </a:lnTo>
                      <a:lnTo>
                        <a:pt x="90" y="400"/>
                      </a:lnTo>
                      <a:lnTo>
                        <a:pt x="92" y="410"/>
                      </a:lnTo>
                      <a:lnTo>
                        <a:pt x="94" y="420"/>
                      </a:lnTo>
                      <a:lnTo>
                        <a:pt x="96" y="428"/>
                      </a:lnTo>
                      <a:lnTo>
                        <a:pt x="98" y="434"/>
                      </a:lnTo>
                      <a:lnTo>
                        <a:pt x="100" y="438"/>
                      </a:lnTo>
                      <a:lnTo>
                        <a:pt x="102" y="444"/>
                      </a:lnTo>
                      <a:lnTo>
                        <a:pt x="104" y="454"/>
                      </a:lnTo>
                      <a:lnTo>
                        <a:pt x="106" y="460"/>
                      </a:lnTo>
                      <a:lnTo>
                        <a:pt x="108" y="464"/>
                      </a:lnTo>
                      <a:lnTo>
                        <a:pt x="110" y="466"/>
                      </a:lnTo>
                      <a:lnTo>
                        <a:pt x="112" y="468"/>
                      </a:lnTo>
                      <a:lnTo>
                        <a:pt x="114" y="472"/>
                      </a:lnTo>
                      <a:lnTo>
                        <a:pt x="116" y="478"/>
                      </a:lnTo>
                      <a:lnTo>
                        <a:pt x="118" y="482"/>
                      </a:lnTo>
                      <a:lnTo>
                        <a:pt x="120" y="486"/>
                      </a:lnTo>
                      <a:lnTo>
                        <a:pt x="122" y="488"/>
                      </a:lnTo>
                      <a:lnTo>
                        <a:pt x="124" y="492"/>
                      </a:lnTo>
                      <a:lnTo>
                        <a:pt x="126" y="496"/>
                      </a:lnTo>
                      <a:lnTo>
                        <a:pt x="128" y="498"/>
                      </a:lnTo>
                      <a:lnTo>
                        <a:pt x="130" y="500"/>
                      </a:lnTo>
                      <a:lnTo>
                        <a:pt x="132" y="502"/>
                      </a:lnTo>
                      <a:lnTo>
                        <a:pt x="134" y="502"/>
                      </a:lnTo>
                      <a:lnTo>
                        <a:pt x="136" y="502"/>
                      </a:lnTo>
                      <a:lnTo>
                        <a:pt x="138" y="502"/>
                      </a:lnTo>
                      <a:lnTo>
                        <a:pt x="140" y="502"/>
                      </a:lnTo>
                      <a:lnTo>
                        <a:pt x="142" y="502"/>
                      </a:lnTo>
                      <a:lnTo>
                        <a:pt x="144" y="502"/>
                      </a:lnTo>
                      <a:lnTo>
                        <a:pt x="146" y="502"/>
                      </a:lnTo>
                      <a:lnTo>
                        <a:pt x="148" y="504"/>
                      </a:lnTo>
                      <a:lnTo>
                        <a:pt x="150" y="504"/>
                      </a:lnTo>
                      <a:lnTo>
                        <a:pt x="152" y="504"/>
                      </a:lnTo>
                      <a:lnTo>
                        <a:pt x="154" y="506"/>
                      </a:lnTo>
                      <a:lnTo>
                        <a:pt x="156" y="506"/>
                      </a:lnTo>
                      <a:lnTo>
                        <a:pt x="158" y="506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08"/>
                      </a:lnTo>
                      <a:lnTo>
                        <a:pt x="176" y="508"/>
                      </a:lnTo>
                      <a:lnTo>
                        <a:pt x="178" y="508"/>
                      </a:lnTo>
                      <a:lnTo>
                        <a:pt x="180" y="508"/>
                      </a:lnTo>
                      <a:lnTo>
                        <a:pt x="182" y="508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08"/>
                      </a:lnTo>
                      <a:lnTo>
                        <a:pt x="216" y="508"/>
                      </a:lnTo>
                      <a:lnTo>
                        <a:pt x="218" y="508"/>
                      </a:lnTo>
                      <a:lnTo>
                        <a:pt x="220" y="508"/>
                      </a:lnTo>
                      <a:lnTo>
                        <a:pt x="222" y="508"/>
                      </a:lnTo>
                      <a:lnTo>
                        <a:pt x="224" y="508"/>
                      </a:lnTo>
                      <a:lnTo>
                        <a:pt x="226" y="508"/>
                      </a:lnTo>
                      <a:lnTo>
                        <a:pt x="228" y="508"/>
                      </a:lnTo>
                      <a:lnTo>
                        <a:pt x="230" y="508"/>
                      </a:lnTo>
                      <a:lnTo>
                        <a:pt x="232" y="510"/>
                      </a:lnTo>
                      <a:lnTo>
                        <a:pt x="234" y="510"/>
                      </a:lnTo>
                      <a:lnTo>
                        <a:pt x="236" y="510"/>
                      </a:lnTo>
                      <a:lnTo>
                        <a:pt x="238" y="510"/>
                      </a:lnTo>
                      <a:lnTo>
                        <a:pt x="240" y="510"/>
                      </a:lnTo>
                      <a:lnTo>
                        <a:pt x="242" y="510"/>
                      </a:lnTo>
                      <a:lnTo>
                        <a:pt x="244" y="510"/>
                      </a:lnTo>
                      <a:lnTo>
                        <a:pt x="246" y="510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10"/>
                      </a:lnTo>
                      <a:lnTo>
                        <a:pt x="254" y="510"/>
                      </a:lnTo>
                      <a:lnTo>
                        <a:pt x="256" y="508"/>
                      </a:lnTo>
                      <a:lnTo>
                        <a:pt x="258" y="508"/>
                      </a:lnTo>
                      <a:lnTo>
                        <a:pt x="260" y="508"/>
                      </a:lnTo>
                      <a:lnTo>
                        <a:pt x="262" y="508"/>
                      </a:lnTo>
                      <a:lnTo>
                        <a:pt x="264" y="508"/>
                      </a:lnTo>
                      <a:lnTo>
                        <a:pt x="266" y="508"/>
                      </a:lnTo>
                      <a:lnTo>
                        <a:pt x="268" y="508"/>
                      </a:lnTo>
                      <a:lnTo>
                        <a:pt x="270" y="508"/>
                      </a:lnTo>
                      <a:lnTo>
                        <a:pt x="272" y="508"/>
                      </a:lnTo>
                      <a:lnTo>
                        <a:pt x="274" y="508"/>
                      </a:lnTo>
                      <a:lnTo>
                        <a:pt x="276" y="508"/>
                      </a:lnTo>
                      <a:lnTo>
                        <a:pt x="278" y="508"/>
                      </a:lnTo>
                      <a:lnTo>
                        <a:pt x="280" y="508"/>
                      </a:lnTo>
                      <a:lnTo>
                        <a:pt x="282" y="508"/>
                      </a:lnTo>
                      <a:lnTo>
                        <a:pt x="284" y="508"/>
                      </a:lnTo>
                      <a:lnTo>
                        <a:pt x="286" y="508"/>
                      </a:lnTo>
                      <a:lnTo>
                        <a:pt x="288" y="508"/>
                      </a:lnTo>
                      <a:lnTo>
                        <a:pt x="290" y="508"/>
                      </a:lnTo>
                      <a:lnTo>
                        <a:pt x="292" y="508"/>
                      </a:lnTo>
                      <a:lnTo>
                        <a:pt x="294" y="510"/>
                      </a:lnTo>
                      <a:lnTo>
                        <a:pt x="296" y="510"/>
                      </a:lnTo>
                      <a:lnTo>
                        <a:pt x="298" y="510"/>
                      </a:lnTo>
                      <a:lnTo>
                        <a:pt x="300" y="510"/>
                      </a:lnTo>
                      <a:lnTo>
                        <a:pt x="302" y="510"/>
                      </a:lnTo>
                      <a:lnTo>
                        <a:pt x="304" y="510"/>
                      </a:lnTo>
                      <a:lnTo>
                        <a:pt x="306" y="510"/>
                      </a:lnTo>
                      <a:lnTo>
                        <a:pt x="308" y="510"/>
                      </a:lnTo>
                      <a:lnTo>
                        <a:pt x="310" y="510"/>
                      </a:lnTo>
                      <a:lnTo>
                        <a:pt x="312" y="510"/>
                      </a:lnTo>
                      <a:lnTo>
                        <a:pt x="314" y="510"/>
                      </a:lnTo>
                      <a:lnTo>
                        <a:pt x="316" y="510"/>
                      </a:lnTo>
                      <a:lnTo>
                        <a:pt x="318" y="510"/>
                      </a:lnTo>
                      <a:lnTo>
                        <a:pt x="320" y="510"/>
                      </a:lnTo>
                      <a:lnTo>
                        <a:pt x="322" y="510"/>
                      </a:lnTo>
                      <a:lnTo>
                        <a:pt x="324" y="510"/>
                      </a:lnTo>
                      <a:lnTo>
                        <a:pt x="326" y="510"/>
                      </a:lnTo>
                      <a:lnTo>
                        <a:pt x="328" y="510"/>
                      </a:lnTo>
                      <a:lnTo>
                        <a:pt x="330" y="510"/>
                      </a:lnTo>
                      <a:lnTo>
                        <a:pt x="332" y="510"/>
                      </a:lnTo>
                      <a:lnTo>
                        <a:pt x="334" y="510"/>
                      </a:lnTo>
                      <a:lnTo>
                        <a:pt x="336" y="510"/>
                      </a:lnTo>
                      <a:lnTo>
                        <a:pt x="338" y="510"/>
                      </a:lnTo>
                      <a:lnTo>
                        <a:pt x="340" y="510"/>
                      </a:lnTo>
                      <a:lnTo>
                        <a:pt x="342" y="510"/>
                      </a:lnTo>
                      <a:lnTo>
                        <a:pt x="344" y="510"/>
                      </a:lnTo>
                      <a:lnTo>
                        <a:pt x="346" y="510"/>
                      </a:lnTo>
                      <a:lnTo>
                        <a:pt x="348" y="510"/>
                      </a:lnTo>
                      <a:lnTo>
                        <a:pt x="350" y="510"/>
                      </a:lnTo>
                      <a:lnTo>
                        <a:pt x="352" y="510"/>
                      </a:lnTo>
                      <a:lnTo>
                        <a:pt x="354" y="510"/>
                      </a:lnTo>
                      <a:lnTo>
                        <a:pt x="356" y="510"/>
                      </a:lnTo>
                      <a:lnTo>
                        <a:pt x="358" y="510"/>
                      </a:lnTo>
                      <a:lnTo>
                        <a:pt x="360" y="510"/>
                      </a:lnTo>
                      <a:lnTo>
                        <a:pt x="362" y="510"/>
                      </a:lnTo>
                      <a:lnTo>
                        <a:pt x="364" y="510"/>
                      </a:lnTo>
                      <a:lnTo>
                        <a:pt x="366" y="510"/>
                      </a:lnTo>
                      <a:lnTo>
                        <a:pt x="368" y="510"/>
                      </a:lnTo>
                      <a:lnTo>
                        <a:pt x="370" y="510"/>
                      </a:lnTo>
                      <a:lnTo>
                        <a:pt x="372" y="510"/>
                      </a:lnTo>
                      <a:lnTo>
                        <a:pt x="374" y="510"/>
                      </a:lnTo>
                      <a:lnTo>
                        <a:pt x="376" y="510"/>
                      </a:lnTo>
                      <a:lnTo>
                        <a:pt x="378" y="510"/>
                      </a:lnTo>
                      <a:lnTo>
                        <a:pt x="380" y="510"/>
                      </a:lnTo>
                      <a:lnTo>
                        <a:pt x="382" y="510"/>
                      </a:lnTo>
                      <a:lnTo>
                        <a:pt x="384" y="510"/>
                      </a:lnTo>
                      <a:lnTo>
                        <a:pt x="386" y="510"/>
                      </a:lnTo>
                      <a:lnTo>
                        <a:pt x="388" y="510"/>
                      </a:lnTo>
                      <a:lnTo>
                        <a:pt x="390" y="510"/>
                      </a:lnTo>
                      <a:lnTo>
                        <a:pt x="392" y="510"/>
                      </a:lnTo>
                      <a:lnTo>
                        <a:pt x="394" y="510"/>
                      </a:lnTo>
                      <a:lnTo>
                        <a:pt x="396" y="510"/>
                      </a:lnTo>
                      <a:lnTo>
                        <a:pt x="398" y="510"/>
                      </a:lnTo>
                      <a:lnTo>
                        <a:pt x="400" y="510"/>
                      </a:lnTo>
                      <a:lnTo>
                        <a:pt x="402" y="510"/>
                      </a:lnTo>
                      <a:lnTo>
                        <a:pt x="404" y="510"/>
                      </a:lnTo>
                      <a:lnTo>
                        <a:pt x="406" y="510"/>
                      </a:lnTo>
                      <a:lnTo>
                        <a:pt x="408" y="510"/>
                      </a:lnTo>
                      <a:lnTo>
                        <a:pt x="410" y="510"/>
                      </a:lnTo>
                      <a:lnTo>
                        <a:pt x="412" y="510"/>
                      </a:lnTo>
                      <a:lnTo>
                        <a:pt x="414" y="510"/>
                      </a:lnTo>
                      <a:lnTo>
                        <a:pt x="416" y="510"/>
                      </a:lnTo>
                      <a:lnTo>
                        <a:pt x="418" y="510"/>
                      </a:lnTo>
                      <a:lnTo>
                        <a:pt x="420" y="510"/>
                      </a:lnTo>
                      <a:lnTo>
                        <a:pt x="422" y="510"/>
                      </a:lnTo>
                      <a:lnTo>
                        <a:pt x="424" y="510"/>
                      </a:lnTo>
                      <a:lnTo>
                        <a:pt x="426" y="510"/>
                      </a:lnTo>
                      <a:lnTo>
                        <a:pt x="428" y="510"/>
                      </a:lnTo>
                      <a:lnTo>
                        <a:pt x="430" y="510"/>
                      </a:lnTo>
                      <a:lnTo>
                        <a:pt x="432" y="510"/>
                      </a:lnTo>
                      <a:lnTo>
                        <a:pt x="434" y="510"/>
                      </a:lnTo>
                      <a:lnTo>
                        <a:pt x="436" y="510"/>
                      </a:lnTo>
                      <a:lnTo>
                        <a:pt x="438" y="510"/>
                      </a:lnTo>
                      <a:lnTo>
                        <a:pt x="440" y="510"/>
                      </a:lnTo>
                      <a:lnTo>
                        <a:pt x="442" y="510"/>
                      </a:lnTo>
                      <a:lnTo>
                        <a:pt x="444" y="510"/>
                      </a:lnTo>
                      <a:lnTo>
                        <a:pt x="446" y="510"/>
                      </a:lnTo>
                      <a:lnTo>
                        <a:pt x="448" y="510"/>
                      </a:lnTo>
                      <a:lnTo>
                        <a:pt x="450" y="510"/>
                      </a:lnTo>
                      <a:lnTo>
                        <a:pt x="452" y="510"/>
                      </a:lnTo>
                      <a:lnTo>
                        <a:pt x="454" y="510"/>
                      </a:lnTo>
                      <a:lnTo>
                        <a:pt x="456" y="510"/>
                      </a:lnTo>
                      <a:lnTo>
                        <a:pt x="458" y="510"/>
                      </a:lnTo>
                      <a:lnTo>
                        <a:pt x="460" y="510"/>
                      </a:lnTo>
                      <a:lnTo>
                        <a:pt x="462" y="510"/>
                      </a:lnTo>
                      <a:lnTo>
                        <a:pt x="464" y="510"/>
                      </a:lnTo>
                      <a:lnTo>
                        <a:pt x="466" y="510"/>
                      </a:lnTo>
                      <a:lnTo>
                        <a:pt x="468" y="510"/>
                      </a:lnTo>
                      <a:lnTo>
                        <a:pt x="470" y="510"/>
                      </a:lnTo>
                      <a:lnTo>
                        <a:pt x="472" y="510"/>
                      </a:lnTo>
                      <a:lnTo>
                        <a:pt x="474" y="510"/>
                      </a:lnTo>
                      <a:lnTo>
                        <a:pt x="476" y="510"/>
                      </a:lnTo>
                      <a:lnTo>
                        <a:pt x="478" y="510"/>
                      </a:lnTo>
                      <a:lnTo>
                        <a:pt x="480" y="510"/>
                      </a:lnTo>
                      <a:lnTo>
                        <a:pt x="482" y="510"/>
                      </a:lnTo>
                      <a:lnTo>
                        <a:pt x="484" y="510"/>
                      </a:lnTo>
                      <a:lnTo>
                        <a:pt x="486" y="510"/>
                      </a:lnTo>
                      <a:lnTo>
                        <a:pt x="488" y="510"/>
                      </a:lnTo>
                      <a:lnTo>
                        <a:pt x="490" y="510"/>
                      </a:lnTo>
                      <a:lnTo>
                        <a:pt x="492" y="510"/>
                      </a:lnTo>
                      <a:lnTo>
                        <a:pt x="494" y="510"/>
                      </a:lnTo>
                      <a:lnTo>
                        <a:pt x="496" y="510"/>
                      </a:lnTo>
                      <a:lnTo>
                        <a:pt x="498" y="510"/>
                      </a:lnTo>
                      <a:lnTo>
                        <a:pt x="500" y="510"/>
                      </a:lnTo>
                      <a:lnTo>
                        <a:pt x="502" y="510"/>
                      </a:lnTo>
                      <a:lnTo>
                        <a:pt x="504" y="510"/>
                      </a:lnTo>
                      <a:lnTo>
                        <a:pt x="506" y="510"/>
                      </a:lnTo>
                      <a:lnTo>
                        <a:pt x="508" y="510"/>
                      </a:lnTo>
                      <a:lnTo>
                        <a:pt x="510" y="510"/>
                      </a:lnTo>
                      <a:lnTo>
                        <a:pt x="0" y="510"/>
                      </a:lnTo>
                      <a:close/>
                    </a:path>
                  </a:pathLst>
                </a:custGeom>
                <a:solidFill>
                  <a:srgbClr val="f0f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6" name="Freeform 394"/>
                <p:cNvSpPr/>
                <p:nvPr/>
              </p:nvSpPr>
              <p:spPr>
                <a:xfrm>
                  <a:off x="5200920" y="1271880"/>
                  <a:ext cx="1033200" cy="1037880"/>
                </a:xfrm>
                <a:custGeom>
                  <a:avLst/>
                  <a:gdLst>
                    <a:gd name="textAreaLeft" fmla="*/ 0 w 1033200"/>
                    <a:gd name="textAreaRight" fmla="*/ 1033560 w 1033200"/>
                    <a:gd name="textAreaTop" fmla="*/ 0 h 1037880"/>
                    <a:gd name="textAreaBottom" fmla="*/ 1038240 h 1037880"/>
                  </a:gdLst>
                  <a:ahLst/>
                  <a:rect l="textAreaLeft" t="textAreaTop" r="textAreaRight" b="textAreaBottom"/>
                  <a:pathLst>
                    <a:path w="508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58"/>
                      </a:lnTo>
                      <a:lnTo>
                        <a:pt x="4" y="150"/>
                      </a:lnTo>
                      <a:lnTo>
                        <a:pt x="6" y="136"/>
                      </a:lnTo>
                      <a:lnTo>
                        <a:pt x="8" y="116"/>
                      </a:lnTo>
                      <a:lnTo>
                        <a:pt x="10" y="108"/>
                      </a:lnTo>
                      <a:lnTo>
                        <a:pt x="12" y="118"/>
                      </a:lnTo>
                      <a:lnTo>
                        <a:pt x="14" y="140"/>
                      </a:lnTo>
                      <a:lnTo>
                        <a:pt x="16" y="138"/>
                      </a:lnTo>
                      <a:lnTo>
                        <a:pt x="18" y="128"/>
                      </a:lnTo>
                      <a:lnTo>
                        <a:pt x="20" y="132"/>
                      </a:lnTo>
                      <a:lnTo>
                        <a:pt x="22" y="124"/>
                      </a:lnTo>
                      <a:lnTo>
                        <a:pt x="24" y="96"/>
                      </a:lnTo>
                      <a:lnTo>
                        <a:pt x="26" y="98"/>
                      </a:lnTo>
                      <a:lnTo>
                        <a:pt x="28" y="116"/>
                      </a:lnTo>
                      <a:lnTo>
                        <a:pt x="30" y="94"/>
                      </a:lnTo>
                      <a:lnTo>
                        <a:pt x="32" y="72"/>
                      </a:lnTo>
                      <a:lnTo>
                        <a:pt x="34" y="62"/>
                      </a:lnTo>
                      <a:lnTo>
                        <a:pt x="36" y="56"/>
                      </a:lnTo>
                      <a:lnTo>
                        <a:pt x="38" y="64"/>
                      </a:lnTo>
                      <a:lnTo>
                        <a:pt x="40" y="64"/>
                      </a:lnTo>
                      <a:lnTo>
                        <a:pt x="42" y="38"/>
                      </a:lnTo>
                      <a:lnTo>
                        <a:pt x="44" y="24"/>
                      </a:lnTo>
                      <a:lnTo>
                        <a:pt x="46" y="58"/>
                      </a:lnTo>
                      <a:lnTo>
                        <a:pt x="48" y="104"/>
                      </a:lnTo>
                      <a:lnTo>
                        <a:pt x="50" y="124"/>
                      </a:lnTo>
                      <a:lnTo>
                        <a:pt x="52" y="132"/>
                      </a:lnTo>
                      <a:lnTo>
                        <a:pt x="54" y="130"/>
                      </a:lnTo>
                      <a:lnTo>
                        <a:pt x="56" y="140"/>
                      </a:lnTo>
                      <a:lnTo>
                        <a:pt x="58" y="166"/>
                      </a:lnTo>
                      <a:lnTo>
                        <a:pt x="60" y="182"/>
                      </a:lnTo>
                      <a:lnTo>
                        <a:pt x="62" y="172"/>
                      </a:lnTo>
                      <a:lnTo>
                        <a:pt x="64" y="174"/>
                      </a:lnTo>
                      <a:lnTo>
                        <a:pt x="66" y="200"/>
                      </a:lnTo>
                      <a:lnTo>
                        <a:pt x="68" y="236"/>
                      </a:lnTo>
                      <a:lnTo>
                        <a:pt x="70" y="270"/>
                      </a:lnTo>
                      <a:lnTo>
                        <a:pt x="72" y="292"/>
                      </a:lnTo>
                      <a:lnTo>
                        <a:pt x="74" y="296"/>
                      </a:lnTo>
                      <a:lnTo>
                        <a:pt x="76" y="298"/>
                      </a:lnTo>
                      <a:lnTo>
                        <a:pt x="78" y="314"/>
                      </a:lnTo>
                      <a:lnTo>
                        <a:pt x="80" y="334"/>
                      </a:lnTo>
                      <a:lnTo>
                        <a:pt x="82" y="352"/>
                      </a:lnTo>
                      <a:lnTo>
                        <a:pt x="84" y="368"/>
                      </a:lnTo>
                      <a:lnTo>
                        <a:pt x="86" y="384"/>
                      </a:lnTo>
                      <a:lnTo>
                        <a:pt x="88" y="392"/>
                      </a:lnTo>
                      <a:lnTo>
                        <a:pt x="90" y="400"/>
                      </a:lnTo>
                      <a:lnTo>
                        <a:pt x="92" y="410"/>
                      </a:lnTo>
                      <a:lnTo>
                        <a:pt x="94" y="420"/>
                      </a:lnTo>
                      <a:lnTo>
                        <a:pt x="96" y="428"/>
                      </a:lnTo>
                      <a:lnTo>
                        <a:pt x="98" y="434"/>
                      </a:lnTo>
                      <a:lnTo>
                        <a:pt x="100" y="438"/>
                      </a:lnTo>
                      <a:lnTo>
                        <a:pt x="102" y="444"/>
                      </a:lnTo>
                      <a:lnTo>
                        <a:pt x="104" y="454"/>
                      </a:lnTo>
                      <a:lnTo>
                        <a:pt x="106" y="460"/>
                      </a:lnTo>
                      <a:lnTo>
                        <a:pt x="108" y="464"/>
                      </a:lnTo>
                      <a:lnTo>
                        <a:pt x="110" y="466"/>
                      </a:lnTo>
                      <a:lnTo>
                        <a:pt x="112" y="468"/>
                      </a:lnTo>
                      <a:lnTo>
                        <a:pt x="114" y="472"/>
                      </a:lnTo>
                      <a:lnTo>
                        <a:pt x="116" y="478"/>
                      </a:lnTo>
                      <a:lnTo>
                        <a:pt x="118" y="482"/>
                      </a:lnTo>
                      <a:lnTo>
                        <a:pt x="120" y="486"/>
                      </a:lnTo>
                      <a:lnTo>
                        <a:pt x="122" y="488"/>
                      </a:lnTo>
                      <a:lnTo>
                        <a:pt x="124" y="492"/>
                      </a:lnTo>
                      <a:lnTo>
                        <a:pt x="126" y="496"/>
                      </a:lnTo>
                      <a:lnTo>
                        <a:pt x="128" y="498"/>
                      </a:lnTo>
                      <a:lnTo>
                        <a:pt x="130" y="500"/>
                      </a:lnTo>
                      <a:lnTo>
                        <a:pt x="132" y="502"/>
                      </a:lnTo>
                      <a:lnTo>
                        <a:pt x="134" y="502"/>
                      </a:lnTo>
                      <a:lnTo>
                        <a:pt x="136" y="502"/>
                      </a:lnTo>
                      <a:lnTo>
                        <a:pt x="138" y="502"/>
                      </a:lnTo>
                      <a:lnTo>
                        <a:pt x="140" y="502"/>
                      </a:lnTo>
                      <a:lnTo>
                        <a:pt x="142" y="502"/>
                      </a:lnTo>
                      <a:lnTo>
                        <a:pt x="144" y="502"/>
                      </a:lnTo>
                      <a:lnTo>
                        <a:pt x="146" y="502"/>
                      </a:lnTo>
                      <a:lnTo>
                        <a:pt x="148" y="504"/>
                      </a:lnTo>
                      <a:lnTo>
                        <a:pt x="150" y="504"/>
                      </a:lnTo>
                      <a:lnTo>
                        <a:pt x="152" y="504"/>
                      </a:lnTo>
                      <a:lnTo>
                        <a:pt x="154" y="506"/>
                      </a:lnTo>
                      <a:lnTo>
                        <a:pt x="156" y="506"/>
                      </a:lnTo>
                      <a:lnTo>
                        <a:pt x="158" y="506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08"/>
                      </a:lnTo>
                      <a:lnTo>
                        <a:pt x="176" y="508"/>
                      </a:lnTo>
                      <a:lnTo>
                        <a:pt x="178" y="508"/>
                      </a:lnTo>
                      <a:lnTo>
                        <a:pt x="180" y="508"/>
                      </a:lnTo>
                      <a:lnTo>
                        <a:pt x="182" y="508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08"/>
                      </a:lnTo>
                      <a:lnTo>
                        <a:pt x="216" y="508"/>
                      </a:lnTo>
                      <a:lnTo>
                        <a:pt x="218" y="508"/>
                      </a:lnTo>
                      <a:lnTo>
                        <a:pt x="220" y="508"/>
                      </a:lnTo>
                      <a:lnTo>
                        <a:pt x="222" y="508"/>
                      </a:lnTo>
                      <a:lnTo>
                        <a:pt x="224" y="508"/>
                      </a:lnTo>
                      <a:lnTo>
                        <a:pt x="226" y="508"/>
                      </a:lnTo>
                      <a:lnTo>
                        <a:pt x="228" y="508"/>
                      </a:lnTo>
                      <a:lnTo>
                        <a:pt x="230" y="508"/>
                      </a:lnTo>
                      <a:lnTo>
                        <a:pt x="232" y="510"/>
                      </a:lnTo>
                      <a:lnTo>
                        <a:pt x="234" y="510"/>
                      </a:lnTo>
                      <a:lnTo>
                        <a:pt x="236" y="510"/>
                      </a:lnTo>
                      <a:lnTo>
                        <a:pt x="238" y="510"/>
                      </a:lnTo>
                      <a:lnTo>
                        <a:pt x="240" y="510"/>
                      </a:lnTo>
                      <a:lnTo>
                        <a:pt x="242" y="510"/>
                      </a:lnTo>
                      <a:lnTo>
                        <a:pt x="244" y="510"/>
                      </a:lnTo>
                      <a:lnTo>
                        <a:pt x="246" y="510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10"/>
                      </a:lnTo>
                      <a:lnTo>
                        <a:pt x="254" y="510"/>
                      </a:lnTo>
                      <a:lnTo>
                        <a:pt x="256" y="508"/>
                      </a:lnTo>
                      <a:lnTo>
                        <a:pt x="258" y="508"/>
                      </a:lnTo>
                      <a:lnTo>
                        <a:pt x="260" y="508"/>
                      </a:lnTo>
                      <a:lnTo>
                        <a:pt x="262" y="508"/>
                      </a:lnTo>
                      <a:lnTo>
                        <a:pt x="264" y="508"/>
                      </a:lnTo>
                      <a:lnTo>
                        <a:pt x="266" y="508"/>
                      </a:lnTo>
                      <a:lnTo>
                        <a:pt x="268" y="508"/>
                      </a:lnTo>
                      <a:lnTo>
                        <a:pt x="270" y="508"/>
                      </a:lnTo>
                      <a:lnTo>
                        <a:pt x="272" y="508"/>
                      </a:lnTo>
                      <a:lnTo>
                        <a:pt x="274" y="508"/>
                      </a:lnTo>
                      <a:lnTo>
                        <a:pt x="276" y="508"/>
                      </a:lnTo>
                      <a:lnTo>
                        <a:pt x="278" y="508"/>
                      </a:lnTo>
                      <a:lnTo>
                        <a:pt x="280" y="508"/>
                      </a:lnTo>
                      <a:lnTo>
                        <a:pt x="282" y="508"/>
                      </a:lnTo>
                      <a:lnTo>
                        <a:pt x="284" y="508"/>
                      </a:lnTo>
                      <a:lnTo>
                        <a:pt x="286" y="508"/>
                      </a:lnTo>
                      <a:lnTo>
                        <a:pt x="288" y="508"/>
                      </a:lnTo>
                      <a:lnTo>
                        <a:pt x="290" y="508"/>
                      </a:lnTo>
                      <a:lnTo>
                        <a:pt x="292" y="508"/>
                      </a:lnTo>
                      <a:lnTo>
                        <a:pt x="294" y="510"/>
                      </a:lnTo>
                      <a:lnTo>
                        <a:pt x="296" y="510"/>
                      </a:lnTo>
                      <a:lnTo>
                        <a:pt x="298" y="510"/>
                      </a:lnTo>
                      <a:lnTo>
                        <a:pt x="300" y="510"/>
                      </a:lnTo>
                      <a:lnTo>
                        <a:pt x="302" y="510"/>
                      </a:lnTo>
                      <a:lnTo>
                        <a:pt x="304" y="510"/>
                      </a:lnTo>
                      <a:lnTo>
                        <a:pt x="306" y="510"/>
                      </a:lnTo>
                      <a:lnTo>
                        <a:pt x="308" y="510"/>
                      </a:lnTo>
                      <a:lnTo>
                        <a:pt x="310" y="510"/>
                      </a:lnTo>
                      <a:lnTo>
                        <a:pt x="312" y="510"/>
                      </a:lnTo>
                      <a:lnTo>
                        <a:pt x="314" y="510"/>
                      </a:lnTo>
                      <a:lnTo>
                        <a:pt x="316" y="510"/>
                      </a:lnTo>
                      <a:lnTo>
                        <a:pt x="318" y="510"/>
                      </a:lnTo>
                      <a:lnTo>
                        <a:pt x="320" y="510"/>
                      </a:lnTo>
                      <a:lnTo>
                        <a:pt x="322" y="510"/>
                      </a:lnTo>
                      <a:lnTo>
                        <a:pt x="324" y="510"/>
                      </a:lnTo>
                      <a:lnTo>
                        <a:pt x="326" y="510"/>
                      </a:lnTo>
                      <a:lnTo>
                        <a:pt x="328" y="510"/>
                      </a:lnTo>
                      <a:lnTo>
                        <a:pt x="330" y="510"/>
                      </a:lnTo>
                      <a:lnTo>
                        <a:pt x="332" y="510"/>
                      </a:lnTo>
                      <a:lnTo>
                        <a:pt x="334" y="510"/>
                      </a:lnTo>
                      <a:lnTo>
                        <a:pt x="336" y="510"/>
                      </a:lnTo>
                      <a:lnTo>
                        <a:pt x="338" y="510"/>
                      </a:lnTo>
                      <a:lnTo>
                        <a:pt x="340" y="510"/>
                      </a:lnTo>
                      <a:lnTo>
                        <a:pt x="342" y="510"/>
                      </a:lnTo>
                      <a:lnTo>
                        <a:pt x="344" y="510"/>
                      </a:lnTo>
                      <a:lnTo>
                        <a:pt x="346" y="510"/>
                      </a:lnTo>
                      <a:lnTo>
                        <a:pt x="348" y="510"/>
                      </a:lnTo>
                      <a:lnTo>
                        <a:pt x="350" y="510"/>
                      </a:lnTo>
                      <a:lnTo>
                        <a:pt x="352" y="510"/>
                      </a:lnTo>
                      <a:lnTo>
                        <a:pt x="354" y="510"/>
                      </a:lnTo>
                      <a:lnTo>
                        <a:pt x="356" y="510"/>
                      </a:lnTo>
                      <a:lnTo>
                        <a:pt x="358" y="510"/>
                      </a:lnTo>
                      <a:lnTo>
                        <a:pt x="360" y="510"/>
                      </a:lnTo>
                      <a:lnTo>
                        <a:pt x="362" y="510"/>
                      </a:lnTo>
                      <a:lnTo>
                        <a:pt x="364" y="510"/>
                      </a:lnTo>
                      <a:lnTo>
                        <a:pt x="366" y="510"/>
                      </a:lnTo>
                      <a:lnTo>
                        <a:pt x="368" y="510"/>
                      </a:lnTo>
                      <a:lnTo>
                        <a:pt x="370" y="510"/>
                      </a:lnTo>
                      <a:lnTo>
                        <a:pt x="372" y="510"/>
                      </a:lnTo>
                      <a:lnTo>
                        <a:pt x="374" y="510"/>
                      </a:lnTo>
                      <a:lnTo>
                        <a:pt x="376" y="510"/>
                      </a:lnTo>
                      <a:lnTo>
                        <a:pt x="378" y="510"/>
                      </a:lnTo>
                      <a:lnTo>
                        <a:pt x="380" y="510"/>
                      </a:lnTo>
                      <a:lnTo>
                        <a:pt x="382" y="510"/>
                      </a:lnTo>
                      <a:lnTo>
                        <a:pt x="384" y="510"/>
                      </a:lnTo>
                      <a:lnTo>
                        <a:pt x="386" y="510"/>
                      </a:lnTo>
                      <a:lnTo>
                        <a:pt x="388" y="510"/>
                      </a:lnTo>
                      <a:lnTo>
                        <a:pt x="390" y="510"/>
                      </a:lnTo>
                      <a:lnTo>
                        <a:pt x="392" y="510"/>
                      </a:lnTo>
                      <a:lnTo>
                        <a:pt x="394" y="510"/>
                      </a:lnTo>
                      <a:lnTo>
                        <a:pt x="396" y="510"/>
                      </a:lnTo>
                      <a:lnTo>
                        <a:pt x="398" y="510"/>
                      </a:lnTo>
                      <a:lnTo>
                        <a:pt x="400" y="510"/>
                      </a:lnTo>
                      <a:lnTo>
                        <a:pt x="402" y="510"/>
                      </a:lnTo>
                      <a:lnTo>
                        <a:pt x="404" y="510"/>
                      </a:lnTo>
                      <a:lnTo>
                        <a:pt x="406" y="510"/>
                      </a:lnTo>
                      <a:lnTo>
                        <a:pt x="408" y="510"/>
                      </a:lnTo>
                      <a:lnTo>
                        <a:pt x="410" y="510"/>
                      </a:lnTo>
                      <a:lnTo>
                        <a:pt x="412" y="510"/>
                      </a:lnTo>
                      <a:lnTo>
                        <a:pt x="414" y="510"/>
                      </a:lnTo>
                      <a:lnTo>
                        <a:pt x="416" y="510"/>
                      </a:lnTo>
                      <a:lnTo>
                        <a:pt x="418" y="510"/>
                      </a:lnTo>
                      <a:lnTo>
                        <a:pt x="420" y="510"/>
                      </a:lnTo>
                      <a:lnTo>
                        <a:pt x="422" y="510"/>
                      </a:lnTo>
                      <a:lnTo>
                        <a:pt x="424" y="510"/>
                      </a:lnTo>
                      <a:lnTo>
                        <a:pt x="426" y="510"/>
                      </a:lnTo>
                      <a:lnTo>
                        <a:pt x="428" y="510"/>
                      </a:lnTo>
                      <a:lnTo>
                        <a:pt x="430" y="510"/>
                      </a:lnTo>
                      <a:lnTo>
                        <a:pt x="432" y="510"/>
                      </a:lnTo>
                      <a:lnTo>
                        <a:pt x="434" y="510"/>
                      </a:lnTo>
                      <a:lnTo>
                        <a:pt x="436" y="510"/>
                      </a:lnTo>
                      <a:lnTo>
                        <a:pt x="438" y="510"/>
                      </a:lnTo>
                      <a:lnTo>
                        <a:pt x="440" y="510"/>
                      </a:lnTo>
                      <a:lnTo>
                        <a:pt x="442" y="510"/>
                      </a:lnTo>
                      <a:lnTo>
                        <a:pt x="444" y="510"/>
                      </a:lnTo>
                      <a:lnTo>
                        <a:pt x="446" y="510"/>
                      </a:lnTo>
                      <a:lnTo>
                        <a:pt x="448" y="510"/>
                      </a:lnTo>
                      <a:lnTo>
                        <a:pt x="450" y="510"/>
                      </a:lnTo>
                      <a:lnTo>
                        <a:pt x="452" y="510"/>
                      </a:lnTo>
                      <a:lnTo>
                        <a:pt x="454" y="510"/>
                      </a:lnTo>
                      <a:lnTo>
                        <a:pt x="456" y="510"/>
                      </a:lnTo>
                      <a:lnTo>
                        <a:pt x="458" y="510"/>
                      </a:lnTo>
                      <a:lnTo>
                        <a:pt x="460" y="510"/>
                      </a:lnTo>
                      <a:lnTo>
                        <a:pt x="462" y="510"/>
                      </a:lnTo>
                      <a:lnTo>
                        <a:pt x="464" y="510"/>
                      </a:lnTo>
                      <a:lnTo>
                        <a:pt x="466" y="510"/>
                      </a:lnTo>
                      <a:lnTo>
                        <a:pt x="468" y="510"/>
                      </a:lnTo>
                      <a:lnTo>
                        <a:pt x="470" y="510"/>
                      </a:lnTo>
                      <a:lnTo>
                        <a:pt x="472" y="510"/>
                      </a:lnTo>
                      <a:lnTo>
                        <a:pt x="474" y="510"/>
                      </a:lnTo>
                      <a:lnTo>
                        <a:pt x="476" y="510"/>
                      </a:lnTo>
                      <a:lnTo>
                        <a:pt x="478" y="510"/>
                      </a:lnTo>
                      <a:lnTo>
                        <a:pt x="480" y="510"/>
                      </a:lnTo>
                      <a:lnTo>
                        <a:pt x="482" y="510"/>
                      </a:lnTo>
                      <a:lnTo>
                        <a:pt x="484" y="510"/>
                      </a:lnTo>
                      <a:lnTo>
                        <a:pt x="486" y="510"/>
                      </a:lnTo>
                      <a:lnTo>
                        <a:pt x="488" y="510"/>
                      </a:lnTo>
                      <a:lnTo>
                        <a:pt x="490" y="510"/>
                      </a:lnTo>
                      <a:lnTo>
                        <a:pt x="492" y="510"/>
                      </a:lnTo>
                      <a:lnTo>
                        <a:pt x="494" y="510"/>
                      </a:lnTo>
                      <a:lnTo>
                        <a:pt x="496" y="510"/>
                      </a:lnTo>
                      <a:lnTo>
                        <a:pt x="498" y="510"/>
                      </a:lnTo>
                      <a:lnTo>
                        <a:pt x="500" y="510"/>
                      </a:lnTo>
                      <a:lnTo>
                        <a:pt x="502" y="510"/>
                      </a:lnTo>
                      <a:lnTo>
                        <a:pt x="504" y="510"/>
                      </a:lnTo>
                      <a:lnTo>
                        <a:pt x="506" y="510"/>
                      </a:lnTo>
                      <a:lnTo>
                        <a:pt x="508" y="510"/>
                      </a:lnTo>
                    </a:path>
                  </a:pathLst>
                </a:custGeom>
                <a:noFill/>
                <a:ln w="6480">
                  <a:solidFill>
                    <a:srgbClr val="cccccc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97" name="Freeform 395"/>
              <p:cNvSpPr/>
              <p:nvPr/>
            </p:nvSpPr>
            <p:spPr>
              <a:xfrm>
                <a:off x="5200920" y="1321200"/>
                <a:ext cx="1033560" cy="988920"/>
              </a:xfrm>
              <a:custGeom>
                <a:avLst/>
                <a:gdLst>
                  <a:gd name="textAreaLeft" fmla="*/ 0 w 1033560"/>
                  <a:gd name="textAreaRight" fmla="*/ 1033920 w 1033560"/>
                  <a:gd name="textAreaTop" fmla="*/ 0 h 988920"/>
                  <a:gd name="textAreaBottom" fmla="*/ 989280 h 98892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0" y="194"/>
                    </a:lnTo>
                    <a:lnTo>
                      <a:pt x="0" y="302"/>
                    </a:lnTo>
                    <a:lnTo>
                      <a:pt x="2" y="382"/>
                    </a:lnTo>
                    <a:lnTo>
                      <a:pt x="4" y="398"/>
                    </a:lnTo>
                    <a:lnTo>
                      <a:pt x="6" y="392"/>
                    </a:lnTo>
                    <a:lnTo>
                      <a:pt x="8" y="388"/>
                    </a:lnTo>
                    <a:lnTo>
                      <a:pt x="10" y="386"/>
                    </a:lnTo>
                    <a:lnTo>
                      <a:pt x="12" y="386"/>
                    </a:lnTo>
                    <a:lnTo>
                      <a:pt x="14" y="384"/>
                    </a:lnTo>
                    <a:lnTo>
                      <a:pt x="16" y="382"/>
                    </a:lnTo>
                    <a:lnTo>
                      <a:pt x="18" y="374"/>
                    </a:lnTo>
                    <a:lnTo>
                      <a:pt x="20" y="366"/>
                    </a:lnTo>
                    <a:lnTo>
                      <a:pt x="22" y="364"/>
                    </a:lnTo>
                    <a:lnTo>
                      <a:pt x="24" y="366"/>
                    </a:lnTo>
                    <a:lnTo>
                      <a:pt x="26" y="362"/>
                    </a:lnTo>
                    <a:lnTo>
                      <a:pt x="28" y="352"/>
                    </a:lnTo>
                    <a:lnTo>
                      <a:pt x="30" y="340"/>
                    </a:lnTo>
                    <a:lnTo>
                      <a:pt x="32" y="332"/>
                    </a:lnTo>
                    <a:lnTo>
                      <a:pt x="34" y="326"/>
                    </a:lnTo>
                    <a:lnTo>
                      <a:pt x="36" y="328"/>
                    </a:lnTo>
                    <a:lnTo>
                      <a:pt x="38" y="334"/>
                    </a:lnTo>
                    <a:lnTo>
                      <a:pt x="40" y="336"/>
                    </a:lnTo>
                    <a:lnTo>
                      <a:pt x="42" y="328"/>
                    </a:lnTo>
                    <a:lnTo>
                      <a:pt x="44" y="324"/>
                    </a:lnTo>
                    <a:lnTo>
                      <a:pt x="46" y="326"/>
                    </a:lnTo>
                    <a:lnTo>
                      <a:pt x="48" y="334"/>
                    </a:lnTo>
                    <a:lnTo>
                      <a:pt x="50" y="342"/>
                    </a:lnTo>
                    <a:lnTo>
                      <a:pt x="52" y="344"/>
                    </a:lnTo>
                    <a:lnTo>
                      <a:pt x="54" y="340"/>
                    </a:lnTo>
                    <a:lnTo>
                      <a:pt x="56" y="334"/>
                    </a:lnTo>
                    <a:lnTo>
                      <a:pt x="58" y="336"/>
                    </a:lnTo>
                    <a:lnTo>
                      <a:pt x="60" y="342"/>
                    </a:lnTo>
                    <a:lnTo>
                      <a:pt x="62" y="346"/>
                    </a:lnTo>
                    <a:lnTo>
                      <a:pt x="64" y="352"/>
                    </a:lnTo>
                    <a:lnTo>
                      <a:pt x="66" y="360"/>
                    </a:lnTo>
                    <a:lnTo>
                      <a:pt x="68" y="364"/>
                    </a:lnTo>
                    <a:lnTo>
                      <a:pt x="70" y="362"/>
                    </a:lnTo>
                    <a:lnTo>
                      <a:pt x="72" y="364"/>
                    </a:lnTo>
                    <a:lnTo>
                      <a:pt x="74" y="368"/>
                    </a:lnTo>
                    <a:lnTo>
                      <a:pt x="76" y="370"/>
                    </a:lnTo>
                    <a:lnTo>
                      <a:pt x="78" y="374"/>
                    </a:lnTo>
                    <a:lnTo>
                      <a:pt x="80" y="380"/>
                    </a:lnTo>
                    <a:lnTo>
                      <a:pt x="82" y="384"/>
                    </a:lnTo>
                    <a:lnTo>
                      <a:pt x="84" y="384"/>
                    </a:lnTo>
                    <a:lnTo>
                      <a:pt x="86" y="382"/>
                    </a:lnTo>
                    <a:lnTo>
                      <a:pt x="88" y="382"/>
                    </a:lnTo>
                    <a:lnTo>
                      <a:pt x="90" y="380"/>
                    </a:lnTo>
                    <a:lnTo>
                      <a:pt x="92" y="376"/>
                    </a:lnTo>
                    <a:lnTo>
                      <a:pt x="94" y="372"/>
                    </a:lnTo>
                    <a:lnTo>
                      <a:pt x="96" y="372"/>
                    </a:lnTo>
                    <a:lnTo>
                      <a:pt x="98" y="374"/>
                    </a:lnTo>
                    <a:lnTo>
                      <a:pt x="100" y="378"/>
                    </a:lnTo>
                    <a:lnTo>
                      <a:pt x="102" y="386"/>
                    </a:lnTo>
                    <a:lnTo>
                      <a:pt x="104" y="390"/>
                    </a:lnTo>
                    <a:lnTo>
                      <a:pt x="106" y="390"/>
                    </a:lnTo>
                    <a:lnTo>
                      <a:pt x="108" y="386"/>
                    </a:lnTo>
                    <a:lnTo>
                      <a:pt x="110" y="382"/>
                    </a:lnTo>
                    <a:lnTo>
                      <a:pt x="112" y="382"/>
                    </a:lnTo>
                    <a:lnTo>
                      <a:pt x="114" y="382"/>
                    </a:lnTo>
                    <a:lnTo>
                      <a:pt x="116" y="388"/>
                    </a:lnTo>
                    <a:lnTo>
                      <a:pt x="118" y="392"/>
                    </a:lnTo>
                    <a:lnTo>
                      <a:pt x="120" y="396"/>
                    </a:lnTo>
                    <a:lnTo>
                      <a:pt x="122" y="396"/>
                    </a:lnTo>
                    <a:lnTo>
                      <a:pt x="124" y="396"/>
                    </a:lnTo>
                    <a:lnTo>
                      <a:pt x="126" y="398"/>
                    </a:lnTo>
                    <a:lnTo>
                      <a:pt x="128" y="400"/>
                    </a:lnTo>
                    <a:lnTo>
                      <a:pt x="130" y="400"/>
                    </a:lnTo>
                    <a:lnTo>
                      <a:pt x="132" y="400"/>
                    </a:lnTo>
                    <a:lnTo>
                      <a:pt x="134" y="400"/>
                    </a:lnTo>
                    <a:lnTo>
                      <a:pt x="136" y="400"/>
                    </a:lnTo>
                    <a:lnTo>
                      <a:pt x="138" y="400"/>
                    </a:lnTo>
                    <a:lnTo>
                      <a:pt x="140" y="396"/>
                    </a:lnTo>
                    <a:lnTo>
                      <a:pt x="142" y="390"/>
                    </a:lnTo>
                    <a:lnTo>
                      <a:pt x="144" y="388"/>
                    </a:lnTo>
                    <a:lnTo>
                      <a:pt x="146" y="392"/>
                    </a:lnTo>
                    <a:lnTo>
                      <a:pt x="148" y="400"/>
                    </a:lnTo>
                    <a:lnTo>
                      <a:pt x="150" y="404"/>
                    </a:lnTo>
                    <a:lnTo>
                      <a:pt x="152" y="404"/>
                    </a:lnTo>
                    <a:lnTo>
                      <a:pt x="154" y="404"/>
                    </a:lnTo>
                    <a:lnTo>
                      <a:pt x="156" y="408"/>
                    </a:lnTo>
                    <a:lnTo>
                      <a:pt x="158" y="408"/>
                    </a:lnTo>
                    <a:lnTo>
                      <a:pt x="160" y="408"/>
                    </a:lnTo>
                    <a:lnTo>
                      <a:pt x="162" y="408"/>
                    </a:lnTo>
                    <a:lnTo>
                      <a:pt x="164" y="410"/>
                    </a:lnTo>
                    <a:lnTo>
                      <a:pt x="166" y="414"/>
                    </a:lnTo>
                    <a:lnTo>
                      <a:pt x="168" y="410"/>
                    </a:lnTo>
                    <a:lnTo>
                      <a:pt x="170" y="402"/>
                    </a:lnTo>
                    <a:lnTo>
                      <a:pt x="172" y="390"/>
                    </a:lnTo>
                    <a:lnTo>
                      <a:pt x="174" y="382"/>
                    </a:lnTo>
                    <a:lnTo>
                      <a:pt x="176" y="382"/>
                    </a:lnTo>
                    <a:lnTo>
                      <a:pt x="178" y="382"/>
                    </a:lnTo>
                    <a:lnTo>
                      <a:pt x="180" y="380"/>
                    </a:lnTo>
                    <a:lnTo>
                      <a:pt x="182" y="372"/>
                    </a:lnTo>
                    <a:lnTo>
                      <a:pt x="184" y="362"/>
                    </a:lnTo>
                    <a:lnTo>
                      <a:pt x="186" y="352"/>
                    </a:lnTo>
                    <a:lnTo>
                      <a:pt x="188" y="346"/>
                    </a:lnTo>
                    <a:lnTo>
                      <a:pt x="190" y="344"/>
                    </a:lnTo>
                    <a:lnTo>
                      <a:pt x="192" y="338"/>
                    </a:lnTo>
                    <a:lnTo>
                      <a:pt x="194" y="320"/>
                    </a:lnTo>
                    <a:lnTo>
                      <a:pt x="196" y="294"/>
                    </a:lnTo>
                    <a:lnTo>
                      <a:pt x="198" y="268"/>
                    </a:lnTo>
                    <a:lnTo>
                      <a:pt x="200" y="260"/>
                    </a:lnTo>
                    <a:lnTo>
                      <a:pt x="202" y="260"/>
                    </a:lnTo>
                    <a:lnTo>
                      <a:pt x="204" y="238"/>
                    </a:lnTo>
                    <a:lnTo>
                      <a:pt x="206" y="190"/>
                    </a:lnTo>
                    <a:lnTo>
                      <a:pt x="208" y="150"/>
                    </a:lnTo>
                    <a:lnTo>
                      <a:pt x="210" y="140"/>
                    </a:lnTo>
                    <a:lnTo>
                      <a:pt x="212" y="124"/>
                    </a:lnTo>
                    <a:lnTo>
                      <a:pt x="214" y="94"/>
                    </a:lnTo>
                    <a:lnTo>
                      <a:pt x="216" y="70"/>
                    </a:lnTo>
                    <a:lnTo>
                      <a:pt x="218" y="36"/>
                    </a:lnTo>
                    <a:lnTo>
                      <a:pt x="220" y="0"/>
                    </a:lnTo>
                    <a:lnTo>
                      <a:pt x="222" y="0"/>
                    </a:lnTo>
                    <a:lnTo>
                      <a:pt x="224" y="32"/>
                    </a:lnTo>
                    <a:lnTo>
                      <a:pt x="226" y="62"/>
                    </a:lnTo>
                    <a:lnTo>
                      <a:pt x="228" y="66"/>
                    </a:lnTo>
                    <a:lnTo>
                      <a:pt x="230" y="76"/>
                    </a:lnTo>
                    <a:lnTo>
                      <a:pt x="232" y="92"/>
                    </a:lnTo>
                    <a:lnTo>
                      <a:pt x="234" y="118"/>
                    </a:lnTo>
                    <a:lnTo>
                      <a:pt x="236" y="170"/>
                    </a:lnTo>
                    <a:lnTo>
                      <a:pt x="238" y="218"/>
                    </a:lnTo>
                    <a:lnTo>
                      <a:pt x="240" y="250"/>
                    </a:lnTo>
                    <a:lnTo>
                      <a:pt x="242" y="282"/>
                    </a:lnTo>
                    <a:lnTo>
                      <a:pt x="244" y="314"/>
                    </a:lnTo>
                    <a:lnTo>
                      <a:pt x="246" y="344"/>
                    </a:lnTo>
                    <a:lnTo>
                      <a:pt x="248" y="366"/>
                    </a:lnTo>
                    <a:lnTo>
                      <a:pt x="250" y="384"/>
                    </a:lnTo>
                    <a:lnTo>
                      <a:pt x="252" y="400"/>
                    </a:lnTo>
                    <a:lnTo>
                      <a:pt x="254" y="416"/>
                    </a:lnTo>
                    <a:lnTo>
                      <a:pt x="256" y="430"/>
                    </a:lnTo>
                    <a:lnTo>
                      <a:pt x="258" y="442"/>
                    </a:lnTo>
                    <a:lnTo>
                      <a:pt x="260" y="450"/>
                    </a:lnTo>
                    <a:lnTo>
                      <a:pt x="262" y="456"/>
                    </a:lnTo>
                    <a:lnTo>
                      <a:pt x="264" y="460"/>
                    </a:lnTo>
                    <a:lnTo>
                      <a:pt x="266" y="464"/>
                    </a:lnTo>
                    <a:lnTo>
                      <a:pt x="268" y="466"/>
                    </a:lnTo>
                    <a:lnTo>
                      <a:pt x="270" y="468"/>
                    </a:lnTo>
                    <a:lnTo>
                      <a:pt x="272" y="470"/>
                    </a:lnTo>
                    <a:lnTo>
                      <a:pt x="274" y="472"/>
                    </a:lnTo>
                    <a:lnTo>
                      <a:pt x="276" y="474"/>
                    </a:lnTo>
                    <a:lnTo>
                      <a:pt x="278" y="476"/>
                    </a:lnTo>
                    <a:lnTo>
                      <a:pt x="280" y="478"/>
                    </a:lnTo>
                    <a:lnTo>
                      <a:pt x="282" y="480"/>
                    </a:lnTo>
                    <a:lnTo>
                      <a:pt x="284" y="480"/>
                    </a:lnTo>
                    <a:lnTo>
                      <a:pt x="286" y="482"/>
                    </a:lnTo>
                    <a:lnTo>
                      <a:pt x="288" y="482"/>
                    </a:lnTo>
                    <a:lnTo>
                      <a:pt x="290" y="484"/>
                    </a:lnTo>
                    <a:lnTo>
                      <a:pt x="292" y="484"/>
                    </a:lnTo>
                    <a:lnTo>
                      <a:pt x="294" y="484"/>
                    </a:lnTo>
                    <a:lnTo>
                      <a:pt x="296" y="484"/>
                    </a:lnTo>
                    <a:lnTo>
                      <a:pt x="298" y="484"/>
                    </a:lnTo>
                    <a:lnTo>
                      <a:pt x="300" y="484"/>
                    </a:lnTo>
                    <a:lnTo>
                      <a:pt x="302" y="484"/>
                    </a:lnTo>
                    <a:lnTo>
                      <a:pt x="304" y="484"/>
                    </a:lnTo>
                    <a:lnTo>
                      <a:pt x="306" y="484"/>
                    </a:lnTo>
                    <a:lnTo>
                      <a:pt x="308" y="484"/>
                    </a:lnTo>
                    <a:lnTo>
                      <a:pt x="310" y="484"/>
                    </a:lnTo>
                    <a:lnTo>
                      <a:pt x="312" y="484"/>
                    </a:lnTo>
                    <a:lnTo>
                      <a:pt x="314" y="484"/>
                    </a:lnTo>
                    <a:lnTo>
                      <a:pt x="316" y="484"/>
                    </a:lnTo>
                    <a:lnTo>
                      <a:pt x="318" y="484"/>
                    </a:lnTo>
                    <a:lnTo>
                      <a:pt x="320" y="484"/>
                    </a:lnTo>
                    <a:lnTo>
                      <a:pt x="322" y="484"/>
                    </a:lnTo>
                    <a:lnTo>
                      <a:pt x="324" y="484"/>
                    </a:lnTo>
                    <a:lnTo>
                      <a:pt x="326" y="484"/>
                    </a:lnTo>
                    <a:lnTo>
                      <a:pt x="328" y="484"/>
                    </a:lnTo>
                    <a:lnTo>
                      <a:pt x="330" y="484"/>
                    </a:lnTo>
                    <a:lnTo>
                      <a:pt x="332" y="486"/>
                    </a:lnTo>
                    <a:lnTo>
                      <a:pt x="334" y="486"/>
                    </a:lnTo>
                    <a:lnTo>
                      <a:pt x="336" y="486"/>
                    </a:lnTo>
                    <a:lnTo>
                      <a:pt x="338" y="486"/>
                    </a:lnTo>
                    <a:lnTo>
                      <a:pt x="340" y="486"/>
                    </a:lnTo>
                    <a:lnTo>
                      <a:pt x="342" y="486"/>
                    </a:lnTo>
                    <a:lnTo>
                      <a:pt x="344" y="486"/>
                    </a:lnTo>
                    <a:lnTo>
                      <a:pt x="346" y="486"/>
                    </a:lnTo>
                    <a:lnTo>
                      <a:pt x="348" y="486"/>
                    </a:lnTo>
                    <a:lnTo>
                      <a:pt x="350" y="486"/>
                    </a:lnTo>
                    <a:lnTo>
                      <a:pt x="352" y="486"/>
                    </a:lnTo>
                    <a:lnTo>
                      <a:pt x="354" y="486"/>
                    </a:lnTo>
                    <a:lnTo>
                      <a:pt x="356" y="486"/>
                    </a:lnTo>
                    <a:lnTo>
                      <a:pt x="358" y="486"/>
                    </a:lnTo>
                    <a:lnTo>
                      <a:pt x="360" y="486"/>
                    </a:lnTo>
                    <a:lnTo>
                      <a:pt x="362" y="486"/>
                    </a:lnTo>
                    <a:lnTo>
                      <a:pt x="364" y="486"/>
                    </a:lnTo>
                    <a:lnTo>
                      <a:pt x="366" y="486"/>
                    </a:lnTo>
                    <a:lnTo>
                      <a:pt x="368" y="486"/>
                    </a:lnTo>
                    <a:lnTo>
                      <a:pt x="370" y="486"/>
                    </a:lnTo>
                    <a:lnTo>
                      <a:pt x="372" y="486"/>
                    </a:lnTo>
                    <a:lnTo>
                      <a:pt x="374" y="486"/>
                    </a:lnTo>
                    <a:lnTo>
                      <a:pt x="376" y="486"/>
                    </a:lnTo>
                    <a:lnTo>
                      <a:pt x="378" y="486"/>
                    </a:lnTo>
                    <a:lnTo>
                      <a:pt x="380" y="486"/>
                    </a:lnTo>
                    <a:lnTo>
                      <a:pt x="382" y="486"/>
                    </a:lnTo>
                    <a:lnTo>
                      <a:pt x="384" y="486"/>
                    </a:lnTo>
                    <a:lnTo>
                      <a:pt x="386" y="486"/>
                    </a:lnTo>
                    <a:lnTo>
                      <a:pt x="388" y="486"/>
                    </a:lnTo>
                    <a:lnTo>
                      <a:pt x="390" y="486"/>
                    </a:lnTo>
                    <a:lnTo>
                      <a:pt x="392" y="486"/>
                    </a:lnTo>
                    <a:lnTo>
                      <a:pt x="394" y="486"/>
                    </a:lnTo>
                    <a:lnTo>
                      <a:pt x="396" y="486"/>
                    </a:lnTo>
                    <a:lnTo>
                      <a:pt x="398" y="486"/>
                    </a:lnTo>
                    <a:lnTo>
                      <a:pt x="400" y="486"/>
                    </a:lnTo>
                    <a:lnTo>
                      <a:pt x="402" y="486"/>
                    </a:lnTo>
                    <a:lnTo>
                      <a:pt x="404" y="486"/>
                    </a:lnTo>
                    <a:lnTo>
                      <a:pt x="406" y="486"/>
                    </a:lnTo>
                    <a:lnTo>
                      <a:pt x="408" y="486"/>
                    </a:lnTo>
                    <a:lnTo>
                      <a:pt x="410" y="486"/>
                    </a:lnTo>
                    <a:lnTo>
                      <a:pt x="412" y="486"/>
                    </a:lnTo>
                    <a:lnTo>
                      <a:pt x="414" y="486"/>
                    </a:lnTo>
                    <a:lnTo>
                      <a:pt x="416" y="486"/>
                    </a:lnTo>
                    <a:lnTo>
                      <a:pt x="418" y="486"/>
                    </a:lnTo>
                    <a:lnTo>
                      <a:pt x="420" y="486"/>
                    </a:lnTo>
                    <a:lnTo>
                      <a:pt x="422" y="486"/>
                    </a:lnTo>
                    <a:lnTo>
                      <a:pt x="424" y="486"/>
                    </a:lnTo>
                    <a:lnTo>
                      <a:pt x="426" y="486"/>
                    </a:lnTo>
                    <a:lnTo>
                      <a:pt x="428" y="486"/>
                    </a:lnTo>
                    <a:lnTo>
                      <a:pt x="430" y="486"/>
                    </a:lnTo>
                    <a:lnTo>
                      <a:pt x="432" y="486"/>
                    </a:lnTo>
                    <a:lnTo>
                      <a:pt x="434" y="486"/>
                    </a:lnTo>
                    <a:lnTo>
                      <a:pt x="436" y="486"/>
                    </a:lnTo>
                    <a:lnTo>
                      <a:pt x="438" y="486"/>
                    </a:lnTo>
                    <a:lnTo>
                      <a:pt x="440" y="486"/>
                    </a:lnTo>
                    <a:lnTo>
                      <a:pt x="442" y="486"/>
                    </a:lnTo>
                    <a:lnTo>
                      <a:pt x="444" y="486"/>
                    </a:lnTo>
                    <a:lnTo>
                      <a:pt x="446" y="486"/>
                    </a:lnTo>
                    <a:lnTo>
                      <a:pt x="448" y="486"/>
                    </a:lnTo>
                    <a:lnTo>
                      <a:pt x="450" y="486"/>
                    </a:lnTo>
                    <a:lnTo>
                      <a:pt x="452" y="486"/>
                    </a:lnTo>
                    <a:lnTo>
                      <a:pt x="454" y="486"/>
                    </a:lnTo>
                    <a:lnTo>
                      <a:pt x="456" y="486"/>
                    </a:lnTo>
                    <a:lnTo>
                      <a:pt x="458" y="486"/>
                    </a:lnTo>
                    <a:lnTo>
                      <a:pt x="460" y="486"/>
                    </a:lnTo>
                    <a:lnTo>
                      <a:pt x="462" y="486"/>
                    </a:lnTo>
                    <a:lnTo>
                      <a:pt x="464" y="486"/>
                    </a:lnTo>
                    <a:lnTo>
                      <a:pt x="466" y="486"/>
                    </a:lnTo>
                    <a:lnTo>
                      <a:pt x="468" y="486"/>
                    </a:lnTo>
                    <a:lnTo>
                      <a:pt x="470" y="486"/>
                    </a:lnTo>
                    <a:lnTo>
                      <a:pt x="472" y="486"/>
                    </a:lnTo>
                    <a:lnTo>
                      <a:pt x="474" y="486"/>
                    </a:lnTo>
                    <a:lnTo>
                      <a:pt x="476" y="486"/>
                    </a:lnTo>
                    <a:lnTo>
                      <a:pt x="478" y="486"/>
                    </a:lnTo>
                    <a:lnTo>
                      <a:pt x="480" y="486"/>
                    </a:lnTo>
                    <a:lnTo>
                      <a:pt x="482" y="486"/>
                    </a:lnTo>
                    <a:lnTo>
                      <a:pt x="484" y="486"/>
                    </a:lnTo>
                    <a:lnTo>
                      <a:pt x="486" y="486"/>
                    </a:lnTo>
                    <a:lnTo>
                      <a:pt x="488" y="486"/>
                    </a:lnTo>
                    <a:lnTo>
                      <a:pt x="490" y="486"/>
                    </a:lnTo>
                    <a:lnTo>
                      <a:pt x="492" y="486"/>
                    </a:lnTo>
                    <a:lnTo>
                      <a:pt x="494" y="486"/>
                    </a:lnTo>
                    <a:lnTo>
                      <a:pt x="496" y="486"/>
                    </a:lnTo>
                    <a:lnTo>
                      <a:pt x="498" y="486"/>
                    </a:lnTo>
                    <a:lnTo>
                      <a:pt x="500" y="486"/>
                    </a:lnTo>
                    <a:lnTo>
                      <a:pt x="502" y="486"/>
                    </a:lnTo>
                    <a:lnTo>
                      <a:pt x="504" y="486"/>
                    </a:lnTo>
                    <a:lnTo>
                      <a:pt x="506" y="486"/>
                    </a:lnTo>
                    <a:lnTo>
                      <a:pt x="508" y="486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98" name="Text Box 39"/>
            <p:cNvSpPr/>
            <p:nvPr/>
          </p:nvSpPr>
          <p:spPr>
            <a:xfrm>
              <a:off x="5716440" y="1251000"/>
              <a:ext cx="784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/65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99" name="Group 575"/>
          <p:cNvGrpSpPr/>
          <p:nvPr/>
        </p:nvGrpSpPr>
        <p:grpSpPr>
          <a:xfrm>
            <a:off x="2138400" y="2752560"/>
            <a:ext cx="1330200" cy="1162440"/>
            <a:chOff x="2138400" y="2752560"/>
            <a:chExt cx="1330200" cy="1162440"/>
          </a:xfrm>
        </p:grpSpPr>
        <p:grpSp>
          <p:nvGrpSpPr>
            <p:cNvPr id="1000" name="Group 396"/>
            <p:cNvGrpSpPr/>
            <p:nvPr/>
          </p:nvGrpSpPr>
          <p:grpSpPr>
            <a:xfrm>
              <a:off x="2138400" y="2766960"/>
              <a:ext cx="1213920" cy="1148040"/>
              <a:chOff x="2138400" y="2766960"/>
              <a:chExt cx="1213920" cy="1148040"/>
            </a:xfrm>
          </p:grpSpPr>
          <p:grpSp>
            <p:nvGrpSpPr>
              <p:cNvPr id="1001" name="Group 397"/>
              <p:cNvGrpSpPr/>
              <p:nvPr/>
            </p:nvGrpSpPr>
            <p:grpSpPr>
              <a:xfrm>
                <a:off x="2138400" y="2766960"/>
                <a:ext cx="1213920" cy="1148040"/>
                <a:chOff x="2138400" y="2766960"/>
                <a:chExt cx="1213920" cy="1148040"/>
              </a:xfrm>
            </p:grpSpPr>
            <p:sp>
              <p:nvSpPr>
                <p:cNvPr id="1002" name="Rectangle 398"/>
                <p:cNvSpPr/>
                <p:nvPr/>
              </p:nvSpPr>
              <p:spPr>
                <a:xfrm>
                  <a:off x="2267280" y="2768760"/>
                  <a:ext cx="1049760" cy="104976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003" name="Group 399"/>
                <p:cNvGrpSpPr/>
                <p:nvPr/>
              </p:nvGrpSpPr>
              <p:grpSpPr>
                <a:xfrm>
                  <a:off x="2223720" y="3816360"/>
                  <a:ext cx="1128600" cy="98640"/>
                  <a:chOff x="2223720" y="3816360"/>
                  <a:chExt cx="1128600" cy="98640"/>
                </a:xfrm>
              </p:grpSpPr>
              <p:sp>
                <p:nvSpPr>
                  <p:cNvPr id="1004" name="Line 400"/>
                  <p:cNvSpPr/>
                  <p:nvPr/>
                </p:nvSpPr>
                <p:spPr>
                  <a:xfrm>
                    <a:off x="2265480" y="3816360"/>
                    <a:ext cx="104904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005" name="Group 401"/>
                  <p:cNvGrpSpPr/>
                  <p:nvPr/>
                </p:nvGrpSpPr>
                <p:grpSpPr>
                  <a:xfrm>
                    <a:off x="2265480" y="3820320"/>
                    <a:ext cx="1048680" cy="23760"/>
                    <a:chOff x="2265480" y="3820320"/>
                    <a:chExt cx="1048680" cy="23760"/>
                  </a:xfrm>
                </p:grpSpPr>
                <p:sp>
                  <p:nvSpPr>
                    <p:cNvPr id="1006" name="Line 402"/>
                    <p:cNvSpPr/>
                    <p:nvPr/>
                  </p:nvSpPr>
                  <p:spPr>
                    <a:xfrm>
                      <a:off x="2265480" y="38203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07" name="Line 403"/>
                    <p:cNvSpPr/>
                    <p:nvPr/>
                  </p:nvSpPr>
                  <p:spPr>
                    <a:xfrm>
                      <a:off x="234288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08" name="Line 404"/>
                    <p:cNvSpPr/>
                    <p:nvPr/>
                  </p:nvSpPr>
                  <p:spPr>
                    <a:xfrm>
                      <a:off x="238752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09" name="Line 405"/>
                    <p:cNvSpPr/>
                    <p:nvPr/>
                  </p:nvSpPr>
                  <p:spPr>
                    <a:xfrm>
                      <a:off x="241992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0" name="Line 406"/>
                    <p:cNvSpPr/>
                    <p:nvPr/>
                  </p:nvSpPr>
                  <p:spPr>
                    <a:xfrm>
                      <a:off x="2448360" y="382032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1" name="Line 407"/>
                    <p:cNvSpPr/>
                    <p:nvPr/>
                  </p:nvSpPr>
                  <p:spPr>
                    <a:xfrm>
                      <a:off x="246852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2" name="Line 408"/>
                    <p:cNvSpPr/>
                    <p:nvPr/>
                  </p:nvSpPr>
                  <p:spPr>
                    <a:xfrm>
                      <a:off x="248472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3" name="Line 409"/>
                    <p:cNvSpPr/>
                    <p:nvPr/>
                  </p:nvSpPr>
                  <p:spPr>
                    <a:xfrm>
                      <a:off x="250128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4" name="Line 410"/>
                    <p:cNvSpPr/>
                    <p:nvPr/>
                  </p:nvSpPr>
                  <p:spPr>
                    <a:xfrm>
                      <a:off x="251352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5" name="Line 411"/>
                    <p:cNvSpPr/>
                    <p:nvPr/>
                  </p:nvSpPr>
                  <p:spPr>
                    <a:xfrm>
                      <a:off x="2525400" y="38203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6" name="Line 412"/>
                    <p:cNvSpPr/>
                    <p:nvPr/>
                  </p:nvSpPr>
                  <p:spPr>
                    <a:xfrm>
                      <a:off x="260712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7" name="Line 413"/>
                    <p:cNvSpPr/>
                    <p:nvPr/>
                  </p:nvSpPr>
                  <p:spPr>
                    <a:xfrm>
                      <a:off x="265176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8" name="Line 414"/>
                    <p:cNvSpPr/>
                    <p:nvPr/>
                  </p:nvSpPr>
                  <p:spPr>
                    <a:xfrm>
                      <a:off x="268380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9" name="Line 415"/>
                    <p:cNvSpPr/>
                    <p:nvPr/>
                  </p:nvSpPr>
                  <p:spPr>
                    <a:xfrm>
                      <a:off x="2708280" y="382032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0" name="Line 416"/>
                    <p:cNvSpPr/>
                    <p:nvPr/>
                  </p:nvSpPr>
                  <p:spPr>
                    <a:xfrm>
                      <a:off x="273276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1" name="Line 417"/>
                    <p:cNvSpPr/>
                    <p:nvPr/>
                  </p:nvSpPr>
                  <p:spPr>
                    <a:xfrm>
                      <a:off x="274932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2" name="Line 418"/>
                    <p:cNvSpPr/>
                    <p:nvPr/>
                  </p:nvSpPr>
                  <p:spPr>
                    <a:xfrm>
                      <a:off x="276552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3" name="Line 419"/>
                    <p:cNvSpPr/>
                    <p:nvPr/>
                  </p:nvSpPr>
                  <p:spPr>
                    <a:xfrm>
                      <a:off x="277740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4" name="Line 420"/>
                    <p:cNvSpPr/>
                    <p:nvPr/>
                  </p:nvSpPr>
                  <p:spPr>
                    <a:xfrm>
                      <a:off x="2790000" y="38203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5" name="Line 421"/>
                    <p:cNvSpPr/>
                    <p:nvPr/>
                  </p:nvSpPr>
                  <p:spPr>
                    <a:xfrm>
                      <a:off x="286704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6" name="Line 422"/>
                    <p:cNvSpPr/>
                    <p:nvPr/>
                  </p:nvSpPr>
                  <p:spPr>
                    <a:xfrm>
                      <a:off x="291600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7" name="Line 423"/>
                    <p:cNvSpPr/>
                    <p:nvPr/>
                  </p:nvSpPr>
                  <p:spPr>
                    <a:xfrm>
                      <a:off x="294876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8" name="Line 424"/>
                    <p:cNvSpPr/>
                    <p:nvPr/>
                  </p:nvSpPr>
                  <p:spPr>
                    <a:xfrm>
                      <a:off x="2972880" y="382032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29" name="Line 425"/>
                    <p:cNvSpPr/>
                    <p:nvPr/>
                  </p:nvSpPr>
                  <p:spPr>
                    <a:xfrm>
                      <a:off x="299340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0" name="Line 426"/>
                    <p:cNvSpPr/>
                    <p:nvPr/>
                  </p:nvSpPr>
                  <p:spPr>
                    <a:xfrm>
                      <a:off x="301356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1" name="Line 427"/>
                    <p:cNvSpPr/>
                    <p:nvPr/>
                  </p:nvSpPr>
                  <p:spPr>
                    <a:xfrm>
                      <a:off x="302544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2" name="Line 428"/>
                    <p:cNvSpPr/>
                    <p:nvPr/>
                  </p:nvSpPr>
                  <p:spPr>
                    <a:xfrm>
                      <a:off x="304236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3" name="Line 429"/>
                    <p:cNvSpPr/>
                    <p:nvPr/>
                  </p:nvSpPr>
                  <p:spPr>
                    <a:xfrm>
                      <a:off x="3054240" y="38203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4" name="Line 430"/>
                    <p:cNvSpPr/>
                    <p:nvPr/>
                  </p:nvSpPr>
                  <p:spPr>
                    <a:xfrm>
                      <a:off x="313164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5" name="Line 431"/>
                    <p:cNvSpPr/>
                    <p:nvPr/>
                  </p:nvSpPr>
                  <p:spPr>
                    <a:xfrm>
                      <a:off x="318024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6" name="Line 432"/>
                    <p:cNvSpPr/>
                    <p:nvPr/>
                  </p:nvSpPr>
                  <p:spPr>
                    <a:xfrm>
                      <a:off x="321264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7" name="Line 433"/>
                    <p:cNvSpPr/>
                    <p:nvPr/>
                  </p:nvSpPr>
                  <p:spPr>
                    <a:xfrm>
                      <a:off x="3237120" y="3820320"/>
                      <a:ext cx="0" cy="1584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960" bIns="-309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8" name="Line 434"/>
                    <p:cNvSpPr/>
                    <p:nvPr/>
                  </p:nvSpPr>
                  <p:spPr>
                    <a:xfrm>
                      <a:off x="325764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39" name="Line 435"/>
                    <p:cNvSpPr/>
                    <p:nvPr/>
                  </p:nvSpPr>
                  <p:spPr>
                    <a:xfrm>
                      <a:off x="327384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0" name="Line 436"/>
                    <p:cNvSpPr/>
                    <p:nvPr/>
                  </p:nvSpPr>
                  <p:spPr>
                    <a:xfrm>
                      <a:off x="329040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1" name="Line 437"/>
                    <p:cNvSpPr/>
                    <p:nvPr/>
                  </p:nvSpPr>
                  <p:spPr>
                    <a:xfrm>
                      <a:off x="3302280" y="38203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2" name="Line 438"/>
                    <p:cNvSpPr/>
                    <p:nvPr/>
                  </p:nvSpPr>
                  <p:spPr>
                    <a:xfrm>
                      <a:off x="3314160" y="38203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043" name="Group 439"/>
                  <p:cNvGrpSpPr/>
                  <p:nvPr/>
                </p:nvGrpSpPr>
                <p:grpSpPr>
                  <a:xfrm>
                    <a:off x="2223720" y="3853080"/>
                    <a:ext cx="1128600" cy="61920"/>
                    <a:chOff x="2223720" y="3853080"/>
                    <a:chExt cx="1128600" cy="61920"/>
                  </a:xfrm>
                </p:grpSpPr>
                <p:sp>
                  <p:nvSpPr>
                    <p:cNvPr id="1044" name="Rectangle 440"/>
                    <p:cNvSpPr/>
                    <p:nvPr/>
                  </p:nvSpPr>
                  <p:spPr>
                    <a:xfrm>
                      <a:off x="2223720" y="38689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5" name="Rectangle 441"/>
                    <p:cNvSpPr/>
                    <p:nvPr/>
                  </p:nvSpPr>
                  <p:spPr>
                    <a:xfrm>
                      <a:off x="2280960" y="38530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6" name="Rectangle 442"/>
                    <p:cNvSpPr/>
                    <p:nvPr/>
                  </p:nvSpPr>
                  <p:spPr>
                    <a:xfrm>
                      <a:off x="2483640" y="38689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7" name="Rectangle 443"/>
                    <p:cNvSpPr/>
                    <p:nvPr/>
                  </p:nvSpPr>
                  <p:spPr>
                    <a:xfrm>
                      <a:off x="2541600" y="38530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8" name="Rectangle 444"/>
                    <p:cNvSpPr/>
                    <p:nvPr/>
                  </p:nvSpPr>
                  <p:spPr>
                    <a:xfrm>
                      <a:off x="2748960" y="38689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49" name="Rectangle 445"/>
                    <p:cNvSpPr/>
                    <p:nvPr/>
                  </p:nvSpPr>
                  <p:spPr>
                    <a:xfrm>
                      <a:off x="2806200" y="38530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50" name="Rectangle 446"/>
                    <p:cNvSpPr/>
                    <p:nvPr/>
                  </p:nvSpPr>
                  <p:spPr>
                    <a:xfrm>
                      <a:off x="3012480" y="38689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51" name="Rectangle 447"/>
                    <p:cNvSpPr/>
                    <p:nvPr/>
                  </p:nvSpPr>
                  <p:spPr>
                    <a:xfrm>
                      <a:off x="3069720" y="38530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52" name="Rectangle 448"/>
                    <p:cNvSpPr/>
                    <p:nvPr/>
                  </p:nvSpPr>
                  <p:spPr>
                    <a:xfrm>
                      <a:off x="3272400" y="38689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53" name="Rectangle 449"/>
                    <p:cNvSpPr/>
                    <p:nvPr/>
                  </p:nvSpPr>
                  <p:spPr>
                    <a:xfrm>
                      <a:off x="3330360" y="38530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grpSp>
              <p:nvGrpSpPr>
                <p:cNvPr id="1054" name="Group 450"/>
                <p:cNvGrpSpPr/>
                <p:nvPr/>
              </p:nvGrpSpPr>
              <p:grpSpPr>
                <a:xfrm>
                  <a:off x="2138400" y="2766960"/>
                  <a:ext cx="126720" cy="1066680"/>
                  <a:chOff x="2138400" y="2766960"/>
                  <a:chExt cx="126720" cy="1066680"/>
                </a:xfrm>
              </p:grpSpPr>
              <p:sp>
                <p:nvSpPr>
                  <p:cNvPr id="1055" name="Line 451"/>
                  <p:cNvSpPr/>
                  <p:nvPr/>
                </p:nvSpPr>
                <p:spPr>
                  <a:xfrm flipV="1">
                    <a:off x="2265120" y="2766960"/>
                    <a:ext cx="0" cy="104904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056" name="Group 452"/>
                  <p:cNvGrpSpPr/>
                  <p:nvPr/>
                </p:nvGrpSpPr>
                <p:grpSpPr>
                  <a:xfrm>
                    <a:off x="2138400" y="2787120"/>
                    <a:ext cx="79560" cy="1046520"/>
                    <a:chOff x="2138400" y="2787120"/>
                    <a:chExt cx="79560" cy="1046520"/>
                  </a:xfrm>
                </p:grpSpPr>
                <p:sp>
                  <p:nvSpPr>
                    <p:cNvPr id="1057" name="Rectangle 453"/>
                    <p:cNvSpPr/>
                    <p:nvPr/>
                  </p:nvSpPr>
                  <p:spPr>
                    <a:xfrm>
                      <a:off x="2196000" y="37875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58" name="Rectangle 454"/>
                    <p:cNvSpPr/>
                    <p:nvPr/>
                  </p:nvSpPr>
                  <p:spPr>
                    <a:xfrm>
                      <a:off x="2167200" y="358776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59" name="Rectangle 455"/>
                    <p:cNvSpPr/>
                    <p:nvPr/>
                  </p:nvSpPr>
                  <p:spPr>
                    <a:xfrm>
                      <a:off x="2167200" y="33886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0" name="Rectangle 456"/>
                    <p:cNvSpPr/>
                    <p:nvPr/>
                  </p:nvSpPr>
                  <p:spPr>
                    <a:xfrm>
                      <a:off x="2167200" y="31852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1" name="Rectangle 457"/>
                    <p:cNvSpPr/>
                    <p:nvPr/>
                  </p:nvSpPr>
                  <p:spPr>
                    <a:xfrm>
                      <a:off x="2167200" y="29862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2" name="Rectangle 458"/>
                    <p:cNvSpPr/>
                    <p:nvPr/>
                  </p:nvSpPr>
                  <p:spPr>
                    <a:xfrm>
                      <a:off x="2138400" y="278712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063" name="Group 459"/>
                  <p:cNvGrpSpPr/>
                  <p:nvPr/>
                </p:nvGrpSpPr>
                <p:grpSpPr>
                  <a:xfrm>
                    <a:off x="2241000" y="2815560"/>
                    <a:ext cx="23760" cy="999720"/>
                    <a:chOff x="2241000" y="2815560"/>
                    <a:chExt cx="23760" cy="999720"/>
                  </a:xfrm>
                </p:grpSpPr>
                <p:sp>
                  <p:nvSpPr>
                    <p:cNvPr id="1064" name="Line 460"/>
                    <p:cNvSpPr/>
                    <p:nvPr/>
                  </p:nvSpPr>
                  <p:spPr>
                    <a:xfrm flipH="1">
                      <a:off x="2241000" y="381528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5" name="Line 461"/>
                    <p:cNvSpPr/>
                    <p:nvPr/>
                  </p:nvSpPr>
                  <p:spPr>
                    <a:xfrm flipH="1">
                      <a:off x="2256840" y="37670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6" name="Line 462"/>
                    <p:cNvSpPr/>
                    <p:nvPr/>
                  </p:nvSpPr>
                  <p:spPr>
                    <a:xfrm flipH="1">
                      <a:off x="2256840" y="37180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7" name="Line 463"/>
                    <p:cNvSpPr/>
                    <p:nvPr/>
                  </p:nvSpPr>
                  <p:spPr>
                    <a:xfrm flipH="1">
                      <a:off x="2256840" y="36651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8" name="Line 464"/>
                    <p:cNvSpPr/>
                    <p:nvPr/>
                  </p:nvSpPr>
                  <p:spPr>
                    <a:xfrm flipH="1">
                      <a:off x="2241000" y="361620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69" name="Line 465"/>
                    <p:cNvSpPr/>
                    <p:nvPr/>
                  </p:nvSpPr>
                  <p:spPr>
                    <a:xfrm flipH="1">
                      <a:off x="2256840" y="35672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0" name="Line 466"/>
                    <p:cNvSpPr/>
                    <p:nvPr/>
                  </p:nvSpPr>
                  <p:spPr>
                    <a:xfrm flipH="1">
                      <a:off x="2256840" y="35146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1" name="Line 467"/>
                    <p:cNvSpPr/>
                    <p:nvPr/>
                  </p:nvSpPr>
                  <p:spPr>
                    <a:xfrm flipH="1">
                      <a:off x="2256840" y="346572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2" name="Line 468"/>
                    <p:cNvSpPr/>
                    <p:nvPr/>
                  </p:nvSpPr>
                  <p:spPr>
                    <a:xfrm flipH="1">
                      <a:off x="2241000" y="341712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3" name="Line 469"/>
                    <p:cNvSpPr/>
                    <p:nvPr/>
                  </p:nvSpPr>
                  <p:spPr>
                    <a:xfrm flipH="1">
                      <a:off x="2256840" y="33638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4" name="Line 470"/>
                    <p:cNvSpPr/>
                    <p:nvPr/>
                  </p:nvSpPr>
                  <p:spPr>
                    <a:xfrm flipH="1">
                      <a:off x="2256840" y="33156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5" name="Line 471"/>
                    <p:cNvSpPr/>
                    <p:nvPr/>
                  </p:nvSpPr>
                  <p:spPr>
                    <a:xfrm flipH="1">
                      <a:off x="2256840" y="32666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6" name="Line 472"/>
                    <p:cNvSpPr/>
                    <p:nvPr/>
                  </p:nvSpPr>
                  <p:spPr>
                    <a:xfrm flipH="1">
                      <a:off x="2241000" y="321372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7" name="Line 473"/>
                    <p:cNvSpPr/>
                    <p:nvPr/>
                  </p:nvSpPr>
                  <p:spPr>
                    <a:xfrm flipH="1">
                      <a:off x="2256840" y="31647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8" name="Line 474"/>
                    <p:cNvSpPr/>
                    <p:nvPr/>
                  </p:nvSpPr>
                  <p:spPr>
                    <a:xfrm flipH="1">
                      <a:off x="2256840" y="31158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79" name="Line 475"/>
                    <p:cNvSpPr/>
                    <p:nvPr/>
                  </p:nvSpPr>
                  <p:spPr>
                    <a:xfrm flipH="1">
                      <a:off x="2256840" y="30632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80" name="Line 476"/>
                    <p:cNvSpPr/>
                    <p:nvPr/>
                  </p:nvSpPr>
                  <p:spPr>
                    <a:xfrm flipH="1">
                      <a:off x="2241000" y="301464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81" name="Line 477"/>
                    <p:cNvSpPr/>
                    <p:nvPr/>
                  </p:nvSpPr>
                  <p:spPr>
                    <a:xfrm flipH="1">
                      <a:off x="2256840" y="29656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82" name="Line 478"/>
                    <p:cNvSpPr/>
                    <p:nvPr/>
                  </p:nvSpPr>
                  <p:spPr>
                    <a:xfrm flipH="1">
                      <a:off x="2256840" y="29127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83" name="Line 479"/>
                    <p:cNvSpPr/>
                    <p:nvPr/>
                  </p:nvSpPr>
                  <p:spPr>
                    <a:xfrm flipH="1">
                      <a:off x="2256840" y="28641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84" name="Line 480"/>
                    <p:cNvSpPr/>
                    <p:nvPr/>
                  </p:nvSpPr>
                  <p:spPr>
                    <a:xfrm flipH="1">
                      <a:off x="2241000" y="281556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1085" name="Group 481"/>
              <p:cNvGrpSpPr/>
              <p:nvPr/>
            </p:nvGrpSpPr>
            <p:grpSpPr>
              <a:xfrm>
                <a:off x="2274120" y="2775240"/>
                <a:ext cx="1037160" cy="1040760"/>
                <a:chOff x="2274120" y="2775240"/>
                <a:chExt cx="1037160" cy="1040760"/>
              </a:xfrm>
            </p:grpSpPr>
            <p:sp>
              <p:nvSpPr>
                <p:cNvPr id="1086" name="Freeform 482"/>
                <p:cNvSpPr/>
                <p:nvPr/>
              </p:nvSpPr>
              <p:spPr>
                <a:xfrm>
                  <a:off x="2274120" y="2775240"/>
                  <a:ext cx="1037160" cy="1037160"/>
                </a:xfrm>
                <a:custGeom>
                  <a:avLst/>
                  <a:gdLst>
                    <a:gd name="textAreaLeft" fmla="*/ 0 w 1037160"/>
                    <a:gd name="textAreaRight" fmla="*/ 1037520 w 1037160"/>
                    <a:gd name="textAreaTop" fmla="*/ 0 h 1037160"/>
                    <a:gd name="textAreaBottom" fmla="*/ 1037520 h 1037160"/>
                  </a:gdLst>
                  <a:ahLst/>
                  <a:rect l="textAreaLeft" t="textAreaTop" r="textAreaRight" b="textAreaBottom"/>
                  <a:pathLst>
                    <a:path w="510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0"/>
                      </a:lnTo>
                      <a:lnTo>
                        <a:pt x="4" y="0"/>
                      </a:lnTo>
                      <a:lnTo>
                        <a:pt x="6" y="0"/>
                      </a:lnTo>
                      <a:lnTo>
                        <a:pt x="8" y="24"/>
                      </a:lnTo>
                      <a:lnTo>
                        <a:pt x="10" y="132"/>
                      </a:lnTo>
                      <a:lnTo>
                        <a:pt x="12" y="200"/>
                      </a:lnTo>
                      <a:lnTo>
                        <a:pt x="14" y="248"/>
                      </a:lnTo>
                      <a:lnTo>
                        <a:pt x="16" y="272"/>
                      </a:lnTo>
                      <a:lnTo>
                        <a:pt x="18" y="290"/>
                      </a:lnTo>
                      <a:lnTo>
                        <a:pt x="20" y="308"/>
                      </a:lnTo>
                      <a:lnTo>
                        <a:pt x="22" y="320"/>
                      </a:lnTo>
                      <a:lnTo>
                        <a:pt x="24" y="324"/>
                      </a:lnTo>
                      <a:lnTo>
                        <a:pt x="26" y="326"/>
                      </a:lnTo>
                      <a:lnTo>
                        <a:pt x="28" y="338"/>
                      </a:lnTo>
                      <a:lnTo>
                        <a:pt x="30" y="354"/>
                      </a:lnTo>
                      <a:lnTo>
                        <a:pt x="32" y="368"/>
                      </a:lnTo>
                      <a:lnTo>
                        <a:pt x="34" y="382"/>
                      </a:lnTo>
                      <a:lnTo>
                        <a:pt x="36" y="396"/>
                      </a:lnTo>
                      <a:lnTo>
                        <a:pt x="38" y="404"/>
                      </a:lnTo>
                      <a:lnTo>
                        <a:pt x="40" y="406"/>
                      </a:lnTo>
                      <a:lnTo>
                        <a:pt x="42" y="410"/>
                      </a:lnTo>
                      <a:lnTo>
                        <a:pt x="44" y="420"/>
                      </a:lnTo>
                      <a:lnTo>
                        <a:pt x="46" y="432"/>
                      </a:lnTo>
                      <a:lnTo>
                        <a:pt x="48" y="440"/>
                      </a:lnTo>
                      <a:lnTo>
                        <a:pt x="50" y="444"/>
                      </a:lnTo>
                      <a:lnTo>
                        <a:pt x="52" y="452"/>
                      </a:lnTo>
                      <a:lnTo>
                        <a:pt x="54" y="462"/>
                      </a:lnTo>
                      <a:lnTo>
                        <a:pt x="56" y="474"/>
                      </a:lnTo>
                      <a:lnTo>
                        <a:pt x="58" y="482"/>
                      </a:lnTo>
                      <a:lnTo>
                        <a:pt x="60" y="488"/>
                      </a:lnTo>
                      <a:lnTo>
                        <a:pt x="62" y="492"/>
                      </a:lnTo>
                      <a:lnTo>
                        <a:pt x="64" y="494"/>
                      </a:lnTo>
                      <a:lnTo>
                        <a:pt x="66" y="494"/>
                      </a:lnTo>
                      <a:lnTo>
                        <a:pt x="68" y="494"/>
                      </a:lnTo>
                      <a:lnTo>
                        <a:pt x="70" y="494"/>
                      </a:lnTo>
                      <a:lnTo>
                        <a:pt x="72" y="494"/>
                      </a:lnTo>
                      <a:lnTo>
                        <a:pt x="74" y="496"/>
                      </a:lnTo>
                      <a:lnTo>
                        <a:pt x="76" y="498"/>
                      </a:lnTo>
                      <a:lnTo>
                        <a:pt x="78" y="500"/>
                      </a:lnTo>
                      <a:lnTo>
                        <a:pt x="80" y="502"/>
                      </a:lnTo>
                      <a:lnTo>
                        <a:pt x="82" y="504"/>
                      </a:lnTo>
                      <a:lnTo>
                        <a:pt x="84" y="504"/>
                      </a:lnTo>
                      <a:lnTo>
                        <a:pt x="86" y="506"/>
                      </a:lnTo>
                      <a:lnTo>
                        <a:pt x="88" y="506"/>
                      </a:lnTo>
                      <a:lnTo>
                        <a:pt x="90" y="506"/>
                      </a:lnTo>
                      <a:lnTo>
                        <a:pt x="92" y="508"/>
                      </a:lnTo>
                      <a:lnTo>
                        <a:pt x="94" y="508"/>
                      </a:lnTo>
                      <a:lnTo>
                        <a:pt x="96" y="508"/>
                      </a:lnTo>
                      <a:lnTo>
                        <a:pt x="98" y="508"/>
                      </a:lnTo>
                      <a:lnTo>
                        <a:pt x="100" y="508"/>
                      </a:lnTo>
                      <a:lnTo>
                        <a:pt x="102" y="508"/>
                      </a:lnTo>
                      <a:lnTo>
                        <a:pt x="104" y="508"/>
                      </a:lnTo>
                      <a:lnTo>
                        <a:pt x="106" y="508"/>
                      </a:lnTo>
                      <a:lnTo>
                        <a:pt x="108" y="508"/>
                      </a:lnTo>
                      <a:lnTo>
                        <a:pt x="110" y="508"/>
                      </a:lnTo>
                      <a:lnTo>
                        <a:pt x="112" y="508"/>
                      </a:lnTo>
                      <a:lnTo>
                        <a:pt x="114" y="508"/>
                      </a:lnTo>
                      <a:lnTo>
                        <a:pt x="116" y="508"/>
                      </a:lnTo>
                      <a:lnTo>
                        <a:pt x="118" y="508"/>
                      </a:lnTo>
                      <a:lnTo>
                        <a:pt x="120" y="508"/>
                      </a:lnTo>
                      <a:lnTo>
                        <a:pt x="122" y="508"/>
                      </a:lnTo>
                      <a:lnTo>
                        <a:pt x="124" y="508"/>
                      </a:lnTo>
                      <a:lnTo>
                        <a:pt x="126" y="508"/>
                      </a:lnTo>
                      <a:lnTo>
                        <a:pt x="128" y="508"/>
                      </a:lnTo>
                      <a:lnTo>
                        <a:pt x="130" y="508"/>
                      </a:lnTo>
                      <a:lnTo>
                        <a:pt x="132" y="508"/>
                      </a:lnTo>
                      <a:lnTo>
                        <a:pt x="134" y="508"/>
                      </a:lnTo>
                      <a:lnTo>
                        <a:pt x="136" y="508"/>
                      </a:lnTo>
                      <a:lnTo>
                        <a:pt x="138" y="508"/>
                      </a:lnTo>
                      <a:lnTo>
                        <a:pt x="140" y="508"/>
                      </a:lnTo>
                      <a:lnTo>
                        <a:pt x="142" y="508"/>
                      </a:lnTo>
                      <a:lnTo>
                        <a:pt x="144" y="508"/>
                      </a:lnTo>
                      <a:lnTo>
                        <a:pt x="146" y="508"/>
                      </a:lnTo>
                      <a:lnTo>
                        <a:pt x="148" y="508"/>
                      </a:lnTo>
                      <a:lnTo>
                        <a:pt x="150" y="508"/>
                      </a:lnTo>
                      <a:lnTo>
                        <a:pt x="152" y="508"/>
                      </a:lnTo>
                      <a:lnTo>
                        <a:pt x="154" y="508"/>
                      </a:lnTo>
                      <a:lnTo>
                        <a:pt x="156" y="508"/>
                      </a:lnTo>
                      <a:lnTo>
                        <a:pt x="158" y="508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08"/>
                      </a:lnTo>
                      <a:lnTo>
                        <a:pt x="176" y="508"/>
                      </a:lnTo>
                      <a:lnTo>
                        <a:pt x="178" y="508"/>
                      </a:lnTo>
                      <a:lnTo>
                        <a:pt x="180" y="508"/>
                      </a:lnTo>
                      <a:lnTo>
                        <a:pt x="182" y="508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08"/>
                      </a:lnTo>
                      <a:lnTo>
                        <a:pt x="216" y="508"/>
                      </a:lnTo>
                      <a:lnTo>
                        <a:pt x="218" y="508"/>
                      </a:lnTo>
                      <a:lnTo>
                        <a:pt x="220" y="508"/>
                      </a:lnTo>
                      <a:lnTo>
                        <a:pt x="222" y="508"/>
                      </a:lnTo>
                      <a:lnTo>
                        <a:pt x="224" y="510"/>
                      </a:lnTo>
                      <a:lnTo>
                        <a:pt x="226" y="510"/>
                      </a:lnTo>
                      <a:lnTo>
                        <a:pt x="228" y="510"/>
                      </a:lnTo>
                      <a:lnTo>
                        <a:pt x="230" y="510"/>
                      </a:lnTo>
                      <a:lnTo>
                        <a:pt x="232" y="510"/>
                      </a:lnTo>
                      <a:lnTo>
                        <a:pt x="234" y="510"/>
                      </a:lnTo>
                      <a:lnTo>
                        <a:pt x="236" y="510"/>
                      </a:lnTo>
                      <a:lnTo>
                        <a:pt x="238" y="510"/>
                      </a:lnTo>
                      <a:lnTo>
                        <a:pt x="240" y="510"/>
                      </a:lnTo>
                      <a:lnTo>
                        <a:pt x="242" y="510"/>
                      </a:lnTo>
                      <a:lnTo>
                        <a:pt x="244" y="510"/>
                      </a:lnTo>
                      <a:lnTo>
                        <a:pt x="246" y="510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10"/>
                      </a:lnTo>
                      <a:lnTo>
                        <a:pt x="254" y="510"/>
                      </a:lnTo>
                      <a:lnTo>
                        <a:pt x="256" y="510"/>
                      </a:lnTo>
                      <a:lnTo>
                        <a:pt x="258" y="510"/>
                      </a:lnTo>
                      <a:lnTo>
                        <a:pt x="260" y="510"/>
                      </a:lnTo>
                      <a:lnTo>
                        <a:pt x="262" y="510"/>
                      </a:lnTo>
                      <a:lnTo>
                        <a:pt x="264" y="510"/>
                      </a:lnTo>
                      <a:lnTo>
                        <a:pt x="266" y="510"/>
                      </a:lnTo>
                      <a:lnTo>
                        <a:pt x="268" y="510"/>
                      </a:lnTo>
                      <a:lnTo>
                        <a:pt x="270" y="510"/>
                      </a:lnTo>
                      <a:lnTo>
                        <a:pt x="272" y="510"/>
                      </a:lnTo>
                      <a:lnTo>
                        <a:pt x="274" y="510"/>
                      </a:lnTo>
                      <a:lnTo>
                        <a:pt x="276" y="510"/>
                      </a:lnTo>
                      <a:lnTo>
                        <a:pt x="278" y="510"/>
                      </a:lnTo>
                      <a:lnTo>
                        <a:pt x="280" y="510"/>
                      </a:lnTo>
                      <a:lnTo>
                        <a:pt x="282" y="510"/>
                      </a:lnTo>
                      <a:lnTo>
                        <a:pt x="284" y="510"/>
                      </a:lnTo>
                      <a:lnTo>
                        <a:pt x="286" y="510"/>
                      </a:lnTo>
                      <a:lnTo>
                        <a:pt x="288" y="510"/>
                      </a:lnTo>
                      <a:lnTo>
                        <a:pt x="290" y="510"/>
                      </a:lnTo>
                      <a:lnTo>
                        <a:pt x="292" y="510"/>
                      </a:lnTo>
                      <a:lnTo>
                        <a:pt x="294" y="510"/>
                      </a:lnTo>
                      <a:lnTo>
                        <a:pt x="296" y="510"/>
                      </a:lnTo>
                      <a:lnTo>
                        <a:pt x="298" y="510"/>
                      </a:lnTo>
                      <a:lnTo>
                        <a:pt x="300" y="510"/>
                      </a:lnTo>
                      <a:lnTo>
                        <a:pt x="302" y="510"/>
                      </a:lnTo>
                      <a:lnTo>
                        <a:pt x="304" y="510"/>
                      </a:lnTo>
                      <a:lnTo>
                        <a:pt x="306" y="510"/>
                      </a:lnTo>
                      <a:lnTo>
                        <a:pt x="308" y="510"/>
                      </a:lnTo>
                      <a:lnTo>
                        <a:pt x="310" y="510"/>
                      </a:lnTo>
                      <a:lnTo>
                        <a:pt x="312" y="510"/>
                      </a:lnTo>
                      <a:lnTo>
                        <a:pt x="314" y="510"/>
                      </a:lnTo>
                      <a:lnTo>
                        <a:pt x="316" y="510"/>
                      </a:lnTo>
                      <a:lnTo>
                        <a:pt x="318" y="510"/>
                      </a:lnTo>
                      <a:lnTo>
                        <a:pt x="320" y="510"/>
                      </a:lnTo>
                      <a:lnTo>
                        <a:pt x="322" y="510"/>
                      </a:lnTo>
                      <a:lnTo>
                        <a:pt x="324" y="510"/>
                      </a:lnTo>
                      <a:lnTo>
                        <a:pt x="326" y="510"/>
                      </a:lnTo>
                      <a:lnTo>
                        <a:pt x="328" y="510"/>
                      </a:lnTo>
                      <a:lnTo>
                        <a:pt x="330" y="510"/>
                      </a:lnTo>
                      <a:lnTo>
                        <a:pt x="332" y="510"/>
                      </a:lnTo>
                      <a:lnTo>
                        <a:pt x="334" y="510"/>
                      </a:lnTo>
                      <a:lnTo>
                        <a:pt x="336" y="510"/>
                      </a:lnTo>
                      <a:lnTo>
                        <a:pt x="338" y="510"/>
                      </a:lnTo>
                      <a:lnTo>
                        <a:pt x="340" y="510"/>
                      </a:lnTo>
                      <a:lnTo>
                        <a:pt x="342" y="510"/>
                      </a:lnTo>
                      <a:lnTo>
                        <a:pt x="344" y="510"/>
                      </a:lnTo>
                      <a:lnTo>
                        <a:pt x="346" y="510"/>
                      </a:lnTo>
                      <a:lnTo>
                        <a:pt x="348" y="510"/>
                      </a:lnTo>
                      <a:lnTo>
                        <a:pt x="350" y="510"/>
                      </a:lnTo>
                      <a:lnTo>
                        <a:pt x="352" y="510"/>
                      </a:lnTo>
                      <a:lnTo>
                        <a:pt x="354" y="510"/>
                      </a:lnTo>
                      <a:lnTo>
                        <a:pt x="356" y="510"/>
                      </a:lnTo>
                      <a:lnTo>
                        <a:pt x="358" y="510"/>
                      </a:lnTo>
                      <a:lnTo>
                        <a:pt x="360" y="510"/>
                      </a:lnTo>
                      <a:lnTo>
                        <a:pt x="362" y="510"/>
                      </a:lnTo>
                      <a:lnTo>
                        <a:pt x="364" y="510"/>
                      </a:lnTo>
                      <a:lnTo>
                        <a:pt x="366" y="510"/>
                      </a:lnTo>
                      <a:lnTo>
                        <a:pt x="368" y="510"/>
                      </a:lnTo>
                      <a:lnTo>
                        <a:pt x="370" y="510"/>
                      </a:lnTo>
                      <a:lnTo>
                        <a:pt x="372" y="510"/>
                      </a:lnTo>
                      <a:lnTo>
                        <a:pt x="374" y="510"/>
                      </a:lnTo>
                      <a:lnTo>
                        <a:pt x="376" y="510"/>
                      </a:lnTo>
                      <a:lnTo>
                        <a:pt x="378" y="510"/>
                      </a:lnTo>
                      <a:lnTo>
                        <a:pt x="380" y="510"/>
                      </a:lnTo>
                      <a:lnTo>
                        <a:pt x="382" y="510"/>
                      </a:lnTo>
                      <a:lnTo>
                        <a:pt x="384" y="510"/>
                      </a:lnTo>
                      <a:lnTo>
                        <a:pt x="386" y="510"/>
                      </a:lnTo>
                      <a:lnTo>
                        <a:pt x="388" y="510"/>
                      </a:lnTo>
                      <a:lnTo>
                        <a:pt x="390" y="510"/>
                      </a:lnTo>
                      <a:lnTo>
                        <a:pt x="392" y="510"/>
                      </a:lnTo>
                      <a:lnTo>
                        <a:pt x="394" y="510"/>
                      </a:lnTo>
                      <a:lnTo>
                        <a:pt x="396" y="510"/>
                      </a:lnTo>
                      <a:lnTo>
                        <a:pt x="398" y="510"/>
                      </a:lnTo>
                      <a:lnTo>
                        <a:pt x="400" y="510"/>
                      </a:lnTo>
                      <a:lnTo>
                        <a:pt x="402" y="510"/>
                      </a:lnTo>
                      <a:lnTo>
                        <a:pt x="404" y="510"/>
                      </a:lnTo>
                      <a:lnTo>
                        <a:pt x="406" y="510"/>
                      </a:lnTo>
                      <a:lnTo>
                        <a:pt x="408" y="510"/>
                      </a:lnTo>
                      <a:lnTo>
                        <a:pt x="410" y="510"/>
                      </a:lnTo>
                      <a:lnTo>
                        <a:pt x="412" y="510"/>
                      </a:lnTo>
                      <a:lnTo>
                        <a:pt x="414" y="510"/>
                      </a:lnTo>
                      <a:lnTo>
                        <a:pt x="416" y="510"/>
                      </a:lnTo>
                      <a:lnTo>
                        <a:pt x="418" y="510"/>
                      </a:lnTo>
                      <a:lnTo>
                        <a:pt x="420" y="510"/>
                      </a:lnTo>
                      <a:lnTo>
                        <a:pt x="422" y="510"/>
                      </a:lnTo>
                      <a:lnTo>
                        <a:pt x="424" y="510"/>
                      </a:lnTo>
                      <a:lnTo>
                        <a:pt x="426" y="510"/>
                      </a:lnTo>
                      <a:lnTo>
                        <a:pt x="428" y="510"/>
                      </a:lnTo>
                      <a:lnTo>
                        <a:pt x="430" y="510"/>
                      </a:lnTo>
                      <a:lnTo>
                        <a:pt x="432" y="510"/>
                      </a:lnTo>
                      <a:lnTo>
                        <a:pt x="434" y="510"/>
                      </a:lnTo>
                      <a:lnTo>
                        <a:pt x="436" y="510"/>
                      </a:lnTo>
                      <a:lnTo>
                        <a:pt x="438" y="510"/>
                      </a:lnTo>
                      <a:lnTo>
                        <a:pt x="440" y="510"/>
                      </a:lnTo>
                      <a:lnTo>
                        <a:pt x="442" y="510"/>
                      </a:lnTo>
                      <a:lnTo>
                        <a:pt x="444" y="510"/>
                      </a:lnTo>
                      <a:lnTo>
                        <a:pt x="446" y="510"/>
                      </a:lnTo>
                      <a:lnTo>
                        <a:pt x="448" y="510"/>
                      </a:lnTo>
                      <a:lnTo>
                        <a:pt x="450" y="510"/>
                      </a:lnTo>
                      <a:lnTo>
                        <a:pt x="452" y="510"/>
                      </a:lnTo>
                      <a:lnTo>
                        <a:pt x="454" y="510"/>
                      </a:lnTo>
                      <a:lnTo>
                        <a:pt x="456" y="510"/>
                      </a:lnTo>
                      <a:lnTo>
                        <a:pt x="458" y="510"/>
                      </a:lnTo>
                      <a:lnTo>
                        <a:pt x="460" y="510"/>
                      </a:lnTo>
                      <a:lnTo>
                        <a:pt x="462" y="510"/>
                      </a:lnTo>
                      <a:lnTo>
                        <a:pt x="464" y="510"/>
                      </a:lnTo>
                      <a:lnTo>
                        <a:pt x="466" y="510"/>
                      </a:lnTo>
                      <a:lnTo>
                        <a:pt x="468" y="510"/>
                      </a:lnTo>
                      <a:lnTo>
                        <a:pt x="470" y="510"/>
                      </a:lnTo>
                      <a:lnTo>
                        <a:pt x="472" y="510"/>
                      </a:lnTo>
                      <a:lnTo>
                        <a:pt x="474" y="510"/>
                      </a:lnTo>
                      <a:lnTo>
                        <a:pt x="476" y="510"/>
                      </a:lnTo>
                      <a:lnTo>
                        <a:pt x="478" y="510"/>
                      </a:lnTo>
                      <a:lnTo>
                        <a:pt x="480" y="510"/>
                      </a:lnTo>
                      <a:lnTo>
                        <a:pt x="482" y="510"/>
                      </a:lnTo>
                      <a:lnTo>
                        <a:pt x="484" y="510"/>
                      </a:lnTo>
                      <a:lnTo>
                        <a:pt x="486" y="510"/>
                      </a:lnTo>
                      <a:lnTo>
                        <a:pt x="488" y="510"/>
                      </a:lnTo>
                      <a:lnTo>
                        <a:pt x="490" y="510"/>
                      </a:lnTo>
                      <a:lnTo>
                        <a:pt x="492" y="510"/>
                      </a:lnTo>
                      <a:lnTo>
                        <a:pt x="494" y="510"/>
                      </a:lnTo>
                      <a:lnTo>
                        <a:pt x="496" y="510"/>
                      </a:lnTo>
                      <a:lnTo>
                        <a:pt x="498" y="510"/>
                      </a:lnTo>
                      <a:lnTo>
                        <a:pt x="500" y="510"/>
                      </a:lnTo>
                      <a:lnTo>
                        <a:pt x="502" y="510"/>
                      </a:lnTo>
                      <a:lnTo>
                        <a:pt x="504" y="510"/>
                      </a:lnTo>
                      <a:lnTo>
                        <a:pt x="506" y="510"/>
                      </a:lnTo>
                      <a:lnTo>
                        <a:pt x="508" y="510"/>
                      </a:lnTo>
                      <a:lnTo>
                        <a:pt x="510" y="510"/>
                      </a:lnTo>
                      <a:lnTo>
                        <a:pt x="0" y="510"/>
                      </a:lnTo>
                      <a:close/>
                    </a:path>
                  </a:pathLst>
                </a:custGeom>
                <a:solidFill>
                  <a:srgbClr val="f0f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7" name="Freeform 483"/>
                <p:cNvSpPr/>
                <p:nvPr/>
              </p:nvSpPr>
              <p:spPr>
                <a:xfrm>
                  <a:off x="2278080" y="2778840"/>
                  <a:ext cx="1033200" cy="1037160"/>
                </a:xfrm>
                <a:custGeom>
                  <a:avLst/>
                  <a:gdLst>
                    <a:gd name="textAreaLeft" fmla="*/ 0 w 1033200"/>
                    <a:gd name="textAreaRight" fmla="*/ 1033560 w 1033200"/>
                    <a:gd name="textAreaTop" fmla="*/ 0 h 1037160"/>
                    <a:gd name="textAreaBottom" fmla="*/ 1037520 h 1037160"/>
                  </a:gdLst>
                  <a:ahLst/>
                  <a:rect l="textAreaLeft" t="textAreaTop" r="textAreaRight" b="textAreaBottom"/>
                  <a:pathLst>
                    <a:path w="508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0"/>
                      </a:lnTo>
                      <a:lnTo>
                        <a:pt x="4" y="0"/>
                      </a:lnTo>
                      <a:lnTo>
                        <a:pt x="6" y="0"/>
                      </a:lnTo>
                      <a:lnTo>
                        <a:pt x="8" y="24"/>
                      </a:lnTo>
                      <a:lnTo>
                        <a:pt x="10" y="132"/>
                      </a:lnTo>
                      <a:lnTo>
                        <a:pt x="12" y="200"/>
                      </a:lnTo>
                      <a:lnTo>
                        <a:pt x="14" y="248"/>
                      </a:lnTo>
                      <a:lnTo>
                        <a:pt x="16" y="272"/>
                      </a:lnTo>
                      <a:lnTo>
                        <a:pt x="18" y="290"/>
                      </a:lnTo>
                      <a:lnTo>
                        <a:pt x="20" y="308"/>
                      </a:lnTo>
                      <a:lnTo>
                        <a:pt x="22" y="320"/>
                      </a:lnTo>
                      <a:lnTo>
                        <a:pt x="24" y="324"/>
                      </a:lnTo>
                      <a:lnTo>
                        <a:pt x="26" y="326"/>
                      </a:lnTo>
                      <a:lnTo>
                        <a:pt x="28" y="338"/>
                      </a:lnTo>
                      <a:lnTo>
                        <a:pt x="30" y="354"/>
                      </a:lnTo>
                      <a:lnTo>
                        <a:pt x="32" y="368"/>
                      </a:lnTo>
                      <a:lnTo>
                        <a:pt x="34" y="382"/>
                      </a:lnTo>
                      <a:lnTo>
                        <a:pt x="36" y="396"/>
                      </a:lnTo>
                      <a:lnTo>
                        <a:pt x="38" y="404"/>
                      </a:lnTo>
                      <a:lnTo>
                        <a:pt x="40" y="406"/>
                      </a:lnTo>
                      <a:lnTo>
                        <a:pt x="42" y="410"/>
                      </a:lnTo>
                      <a:lnTo>
                        <a:pt x="44" y="420"/>
                      </a:lnTo>
                      <a:lnTo>
                        <a:pt x="46" y="432"/>
                      </a:lnTo>
                      <a:lnTo>
                        <a:pt x="48" y="440"/>
                      </a:lnTo>
                      <a:lnTo>
                        <a:pt x="50" y="444"/>
                      </a:lnTo>
                      <a:lnTo>
                        <a:pt x="52" y="452"/>
                      </a:lnTo>
                      <a:lnTo>
                        <a:pt x="54" y="462"/>
                      </a:lnTo>
                      <a:lnTo>
                        <a:pt x="56" y="474"/>
                      </a:lnTo>
                      <a:lnTo>
                        <a:pt x="58" y="482"/>
                      </a:lnTo>
                      <a:lnTo>
                        <a:pt x="60" y="488"/>
                      </a:lnTo>
                      <a:lnTo>
                        <a:pt x="62" y="492"/>
                      </a:lnTo>
                      <a:lnTo>
                        <a:pt x="64" y="494"/>
                      </a:lnTo>
                      <a:lnTo>
                        <a:pt x="66" y="494"/>
                      </a:lnTo>
                      <a:lnTo>
                        <a:pt x="68" y="494"/>
                      </a:lnTo>
                      <a:lnTo>
                        <a:pt x="70" y="494"/>
                      </a:lnTo>
                      <a:lnTo>
                        <a:pt x="72" y="494"/>
                      </a:lnTo>
                      <a:lnTo>
                        <a:pt x="74" y="496"/>
                      </a:lnTo>
                      <a:lnTo>
                        <a:pt x="76" y="498"/>
                      </a:lnTo>
                      <a:lnTo>
                        <a:pt x="78" y="500"/>
                      </a:lnTo>
                      <a:lnTo>
                        <a:pt x="80" y="502"/>
                      </a:lnTo>
                      <a:lnTo>
                        <a:pt x="82" y="504"/>
                      </a:lnTo>
                      <a:lnTo>
                        <a:pt x="84" y="504"/>
                      </a:lnTo>
                      <a:lnTo>
                        <a:pt x="86" y="506"/>
                      </a:lnTo>
                      <a:lnTo>
                        <a:pt x="88" y="506"/>
                      </a:lnTo>
                      <a:lnTo>
                        <a:pt x="90" y="506"/>
                      </a:lnTo>
                      <a:lnTo>
                        <a:pt x="92" y="508"/>
                      </a:lnTo>
                      <a:lnTo>
                        <a:pt x="94" y="508"/>
                      </a:lnTo>
                      <a:lnTo>
                        <a:pt x="96" y="508"/>
                      </a:lnTo>
                      <a:lnTo>
                        <a:pt x="98" y="508"/>
                      </a:lnTo>
                      <a:lnTo>
                        <a:pt x="100" y="508"/>
                      </a:lnTo>
                      <a:lnTo>
                        <a:pt x="102" y="508"/>
                      </a:lnTo>
                      <a:lnTo>
                        <a:pt x="104" y="508"/>
                      </a:lnTo>
                      <a:lnTo>
                        <a:pt x="106" y="508"/>
                      </a:lnTo>
                      <a:lnTo>
                        <a:pt x="108" y="508"/>
                      </a:lnTo>
                      <a:lnTo>
                        <a:pt x="110" y="508"/>
                      </a:lnTo>
                      <a:lnTo>
                        <a:pt x="112" y="508"/>
                      </a:lnTo>
                      <a:lnTo>
                        <a:pt x="114" y="508"/>
                      </a:lnTo>
                      <a:lnTo>
                        <a:pt x="116" y="508"/>
                      </a:lnTo>
                      <a:lnTo>
                        <a:pt x="118" y="508"/>
                      </a:lnTo>
                      <a:lnTo>
                        <a:pt x="120" y="508"/>
                      </a:lnTo>
                      <a:lnTo>
                        <a:pt x="122" y="508"/>
                      </a:lnTo>
                      <a:lnTo>
                        <a:pt x="124" y="508"/>
                      </a:lnTo>
                      <a:lnTo>
                        <a:pt x="126" y="508"/>
                      </a:lnTo>
                      <a:lnTo>
                        <a:pt x="128" y="508"/>
                      </a:lnTo>
                      <a:lnTo>
                        <a:pt x="130" y="508"/>
                      </a:lnTo>
                      <a:lnTo>
                        <a:pt x="132" y="508"/>
                      </a:lnTo>
                      <a:lnTo>
                        <a:pt x="134" y="508"/>
                      </a:lnTo>
                      <a:lnTo>
                        <a:pt x="136" y="508"/>
                      </a:lnTo>
                      <a:lnTo>
                        <a:pt x="138" y="508"/>
                      </a:lnTo>
                      <a:lnTo>
                        <a:pt x="140" y="508"/>
                      </a:lnTo>
                      <a:lnTo>
                        <a:pt x="142" y="508"/>
                      </a:lnTo>
                      <a:lnTo>
                        <a:pt x="144" y="508"/>
                      </a:lnTo>
                      <a:lnTo>
                        <a:pt x="146" y="508"/>
                      </a:lnTo>
                      <a:lnTo>
                        <a:pt x="148" y="508"/>
                      </a:lnTo>
                      <a:lnTo>
                        <a:pt x="150" y="508"/>
                      </a:lnTo>
                      <a:lnTo>
                        <a:pt x="152" y="508"/>
                      </a:lnTo>
                      <a:lnTo>
                        <a:pt x="154" y="508"/>
                      </a:lnTo>
                      <a:lnTo>
                        <a:pt x="156" y="508"/>
                      </a:lnTo>
                      <a:lnTo>
                        <a:pt x="158" y="508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08"/>
                      </a:lnTo>
                      <a:lnTo>
                        <a:pt x="176" y="508"/>
                      </a:lnTo>
                      <a:lnTo>
                        <a:pt x="178" y="508"/>
                      </a:lnTo>
                      <a:lnTo>
                        <a:pt x="180" y="508"/>
                      </a:lnTo>
                      <a:lnTo>
                        <a:pt x="182" y="508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08"/>
                      </a:lnTo>
                      <a:lnTo>
                        <a:pt x="216" y="508"/>
                      </a:lnTo>
                      <a:lnTo>
                        <a:pt x="218" y="508"/>
                      </a:lnTo>
                      <a:lnTo>
                        <a:pt x="220" y="508"/>
                      </a:lnTo>
                      <a:lnTo>
                        <a:pt x="222" y="508"/>
                      </a:lnTo>
                      <a:lnTo>
                        <a:pt x="224" y="510"/>
                      </a:lnTo>
                      <a:lnTo>
                        <a:pt x="226" y="510"/>
                      </a:lnTo>
                      <a:lnTo>
                        <a:pt x="228" y="510"/>
                      </a:lnTo>
                      <a:lnTo>
                        <a:pt x="230" y="510"/>
                      </a:lnTo>
                      <a:lnTo>
                        <a:pt x="232" y="510"/>
                      </a:lnTo>
                      <a:lnTo>
                        <a:pt x="234" y="510"/>
                      </a:lnTo>
                      <a:lnTo>
                        <a:pt x="236" y="510"/>
                      </a:lnTo>
                      <a:lnTo>
                        <a:pt x="238" y="510"/>
                      </a:lnTo>
                      <a:lnTo>
                        <a:pt x="240" y="510"/>
                      </a:lnTo>
                      <a:lnTo>
                        <a:pt x="242" y="510"/>
                      </a:lnTo>
                      <a:lnTo>
                        <a:pt x="244" y="510"/>
                      </a:lnTo>
                      <a:lnTo>
                        <a:pt x="246" y="510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10"/>
                      </a:lnTo>
                      <a:lnTo>
                        <a:pt x="254" y="510"/>
                      </a:lnTo>
                      <a:lnTo>
                        <a:pt x="256" y="510"/>
                      </a:lnTo>
                      <a:lnTo>
                        <a:pt x="258" y="510"/>
                      </a:lnTo>
                      <a:lnTo>
                        <a:pt x="260" y="510"/>
                      </a:lnTo>
                      <a:lnTo>
                        <a:pt x="262" y="510"/>
                      </a:lnTo>
                      <a:lnTo>
                        <a:pt x="264" y="510"/>
                      </a:lnTo>
                      <a:lnTo>
                        <a:pt x="266" y="510"/>
                      </a:lnTo>
                      <a:lnTo>
                        <a:pt x="268" y="510"/>
                      </a:lnTo>
                      <a:lnTo>
                        <a:pt x="270" y="510"/>
                      </a:lnTo>
                      <a:lnTo>
                        <a:pt x="272" y="510"/>
                      </a:lnTo>
                      <a:lnTo>
                        <a:pt x="274" y="510"/>
                      </a:lnTo>
                      <a:lnTo>
                        <a:pt x="276" y="510"/>
                      </a:lnTo>
                      <a:lnTo>
                        <a:pt x="278" y="510"/>
                      </a:lnTo>
                      <a:lnTo>
                        <a:pt x="280" y="510"/>
                      </a:lnTo>
                      <a:lnTo>
                        <a:pt x="282" y="510"/>
                      </a:lnTo>
                      <a:lnTo>
                        <a:pt x="284" y="510"/>
                      </a:lnTo>
                      <a:lnTo>
                        <a:pt x="286" y="510"/>
                      </a:lnTo>
                      <a:lnTo>
                        <a:pt x="288" y="510"/>
                      </a:lnTo>
                      <a:lnTo>
                        <a:pt x="290" y="510"/>
                      </a:lnTo>
                      <a:lnTo>
                        <a:pt x="292" y="510"/>
                      </a:lnTo>
                      <a:lnTo>
                        <a:pt x="294" y="510"/>
                      </a:lnTo>
                      <a:lnTo>
                        <a:pt x="296" y="510"/>
                      </a:lnTo>
                      <a:lnTo>
                        <a:pt x="298" y="510"/>
                      </a:lnTo>
                      <a:lnTo>
                        <a:pt x="300" y="510"/>
                      </a:lnTo>
                      <a:lnTo>
                        <a:pt x="302" y="510"/>
                      </a:lnTo>
                      <a:lnTo>
                        <a:pt x="304" y="510"/>
                      </a:lnTo>
                      <a:lnTo>
                        <a:pt x="306" y="510"/>
                      </a:lnTo>
                      <a:lnTo>
                        <a:pt x="308" y="510"/>
                      </a:lnTo>
                      <a:lnTo>
                        <a:pt x="310" y="510"/>
                      </a:lnTo>
                      <a:lnTo>
                        <a:pt x="312" y="510"/>
                      </a:lnTo>
                      <a:lnTo>
                        <a:pt x="314" y="510"/>
                      </a:lnTo>
                      <a:lnTo>
                        <a:pt x="316" y="510"/>
                      </a:lnTo>
                      <a:lnTo>
                        <a:pt x="318" y="510"/>
                      </a:lnTo>
                      <a:lnTo>
                        <a:pt x="320" y="510"/>
                      </a:lnTo>
                      <a:lnTo>
                        <a:pt x="322" y="510"/>
                      </a:lnTo>
                      <a:lnTo>
                        <a:pt x="324" y="510"/>
                      </a:lnTo>
                      <a:lnTo>
                        <a:pt x="326" y="510"/>
                      </a:lnTo>
                      <a:lnTo>
                        <a:pt x="328" y="510"/>
                      </a:lnTo>
                      <a:lnTo>
                        <a:pt x="330" y="510"/>
                      </a:lnTo>
                      <a:lnTo>
                        <a:pt x="332" y="510"/>
                      </a:lnTo>
                      <a:lnTo>
                        <a:pt x="334" y="510"/>
                      </a:lnTo>
                      <a:lnTo>
                        <a:pt x="336" y="510"/>
                      </a:lnTo>
                      <a:lnTo>
                        <a:pt x="338" y="510"/>
                      </a:lnTo>
                      <a:lnTo>
                        <a:pt x="340" y="510"/>
                      </a:lnTo>
                      <a:lnTo>
                        <a:pt x="342" y="510"/>
                      </a:lnTo>
                      <a:lnTo>
                        <a:pt x="344" y="510"/>
                      </a:lnTo>
                      <a:lnTo>
                        <a:pt x="346" y="510"/>
                      </a:lnTo>
                      <a:lnTo>
                        <a:pt x="348" y="510"/>
                      </a:lnTo>
                      <a:lnTo>
                        <a:pt x="350" y="510"/>
                      </a:lnTo>
                      <a:lnTo>
                        <a:pt x="352" y="510"/>
                      </a:lnTo>
                      <a:lnTo>
                        <a:pt x="354" y="510"/>
                      </a:lnTo>
                      <a:lnTo>
                        <a:pt x="356" y="510"/>
                      </a:lnTo>
                      <a:lnTo>
                        <a:pt x="358" y="510"/>
                      </a:lnTo>
                      <a:lnTo>
                        <a:pt x="360" y="510"/>
                      </a:lnTo>
                      <a:lnTo>
                        <a:pt x="362" y="510"/>
                      </a:lnTo>
                      <a:lnTo>
                        <a:pt x="364" y="510"/>
                      </a:lnTo>
                      <a:lnTo>
                        <a:pt x="366" y="510"/>
                      </a:lnTo>
                      <a:lnTo>
                        <a:pt x="368" y="510"/>
                      </a:lnTo>
                      <a:lnTo>
                        <a:pt x="370" y="510"/>
                      </a:lnTo>
                      <a:lnTo>
                        <a:pt x="372" y="510"/>
                      </a:lnTo>
                      <a:lnTo>
                        <a:pt x="374" y="510"/>
                      </a:lnTo>
                      <a:lnTo>
                        <a:pt x="376" y="510"/>
                      </a:lnTo>
                      <a:lnTo>
                        <a:pt x="378" y="510"/>
                      </a:lnTo>
                      <a:lnTo>
                        <a:pt x="380" y="510"/>
                      </a:lnTo>
                      <a:lnTo>
                        <a:pt x="382" y="510"/>
                      </a:lnTo>
                      <a:lnTo>
                        <a:pt x="384" y="510"/>
                      </a:lnTo>
                      <a:lnTo>
                        <a:pt x="386" y="510"/>
                      </a:lnTo>
                      <a:lnTo>
                        <a:pt x="388" y="510"/>
                      </a:lnTo>
                      <a:lnTo>
                        <a:pt x="390" y="510"/>
                      </a:lnTo>
                      <a:lnTo>
                        <a:pt x="392" y="510"/>
                      </a:lnTo>
                      <a:lnTo>
                        <a:pt x="394" y="510"/>
                      </a:lnTo>
                      <a:lnTo>
                        <a:pt x="396" y="510"/>
                      </a:lnTo>
                      <a:lnTo>
                        <a:pt x="398" y="510"/>
                      </a:lnTo>
                      <a:lnTo>
                        <a:pt x="400" y="510"/>
                      </a:lnTo>
                      <a:lnTo>
                        <a:pt x="402" y="510"/>
                      </a:lnTo>
                      <a:lnTo>
                        <a:pt x="404" y="510"/>
                      </a:lnTo>
                      <a:lnTo>
                        <a:pt x="406" y="510"/>
                      </a:lnTo>
                      <a:lnTo>
                        <a:pt x="408" y="510"/>
                      </a:lnTo>
                      <a:lnTo>
                        <a:pt x="410" y="510"/>
                      </a:lnTo>
                      <a:lnTo>
                        <a:pt x="412" y="510"/>
                      </a:lnTo>
                      <a:lnTo>
                        <a:pt x="414" y="510"/>
                      </a:lnTo>
                      <a:lnTo>
                        <a:pt x="416" y="510"/>
                      </a:lnTo>
                      <a:lnTo>
                        <a:pt x="418" y="510"/>
                      </a:lnTo>
                      <a:lnTo>
                        <a:pt x="420" y="510"/>
                      </a:lnTo>
                      <a:lnTo>
                        <a:pt x="422" y="510"/>
                      </a:lnTo>
                      <a:lnTo>
                        <a:pt x="424" y="510"/>
                      </a:lnTo>
                      <a:lnTo>
                        <a:pt x="426" y="510"/>
                      </a:lnTo>
                      <a:lnTo>
                        <a:pt x="428" y="510"/>
                      </a:lnTo>
                      <a:lnTo>
                        <a:pt x="430" y="510"/>
                      </a:lnTo>
                      <a:lnTo>
                        <a:pt x="432" y="510"/>
                      </a:lnTo>
                      <a:lnTo>
                        <a:pt x="434" y="510"/>
                      </a:lnTo>
                      <a:lnTo>
                        <a:pt x="436" y="510"/>
                      </a:lnTo>
                      <a:lnTo>
                        <a:pt x="438" y="510"/>
                      </a:lnTo>
                      <a:lnTo>
                        <a:pt x="440" y="510"/>
                      </a:lnTo>
                      <a:lnTo>
                        <a:pt x="442" y="510"/>
                      </a:lnTo>
                      <a:lnTo>
                        <a:pt x="444" y="510"/>
                      </a:lnTo>
                      <a:lnTo>
                        <a:pt x="446" y="510"/>
                      </a:lnTo>
                      <a:lnTo>
                        <a:pt x="448" y="510"/>
                      </a:lnTo>
                      <a:lnTo>
                        <a:pt x="450" y="510"/>
                      </a:lnTo>
                      <a:lnTo>
                        <a:pt x="452" y="510"/>
                      </a:lnTo>
                      <a:lnTo>
                        <a:pt x="454" y="510"/>
                      </a:lnTo>
                      <a:lnTo>
                        <a:pt x="456" y="510"/>
                      </a:lnTo>
                      <a:lnTo>
                        <a:pt x="458" y="510"/>
                      </a:lnTo>
                      <a:lnTo>
                        <a:pt x="460" y="510"/>
                      </a:lnTo>
                      <a:lnTo>
                        <a:pt x="462" y="510"/>
                      </a:lnTo>
                      <a:lnTo>
                        <a:pt x="464" y="510"/>
                      </a:lnTo>
                      <a:lnTo>
                        <a:pt x="466" y="510"/>
                      </a:lnTo>
                      <a:lnTo>
                        <a:pt x="468" y="510"/>
                      </a:lnTo>
                      <a:lnTo>
                        <a:pt x="470" y="510"/>
                      </a:lnTo>
                      <a:lnTo>
                        <a:pt x="472" y="510"/>
                      </a:lnTo>
                      <a:lnTo>
                        <a:pt x="474" y="510"/>
                      </a:lnTo>
                      <a:lnTo>
                        <a:pt x="476" y="510"/>
                      </a:lnTo>
                      <a:lnTo>
                        <a:pt x="478" y="510"/>
                      </a:lnTo>
                      <a:lnTo>
                        <a:pt x="480" y="510"/>
                      </a:lnTo>
                      <a:lnTo>
                        <a:pt x="482" y="510"/>
                      </a:lnTo>
                      <a:lnTo>
                        <a:pt x="484" y="510"/>
                      </a:lnTo>
                      <a:lnTo>
                        <a:pt x="486" y="510"/>
                      </a:lnTo>
                      <a:lnTo>
                        <a:pt x="488" y="510"/>
                      </a:lnTo>
                      <a:lnTo>
                        <a:pt x="490" y="510"/>
                      </a:lnTo>
                      <a:lnTo>
                        <a:pt x="492" y="510"/>
                      </a:lnTo>
                      <a:lnTo>
                        <a:pt x="494" y="510"/>
                      </a:lnTo>
                      <a:lnTo>
                        <a:pt x="496" y="510"/>
                      </a:lnTo>
                      <a:lnTo>
                        <a:pt x="498" y="510"/>
                      </a:lnTo>
                      <a:lnTo>
                        <a:pt x="500" y="510"/>
                      </a:lnTo>
                      <a:lnTo>
                        <a:pt x="502" y="510"/>
                      </a:lnTo>
                      <a:lnTo>
                        <a:pt x="504" y="510"/>
                      </a:lnTo>
                      <a:lnTo>
                        <a:pt x="506" y="510"/>
                      </a:lnTo>
                      <a:lnTo>
                        <a:pt x="508" y="510"/>
                      </a:lnTo>
                    </a:path>
                  </a:pathLst>
                </a:custGeom>
                <a:noFill/>
                <a:ln w="6480">
                  <a:solidFill>
                    <a:srgbClr val="cccccc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88" name="Freeform 484"/>
              <p:cNvSpPr/>
              <p:nvPr/>
            </p:nvSpPr>
            <p:spPr>
              <a:xfrm>
                <a:off x="2278080" y="2827800"/>
                <a:ext cx="1033560" cy="988560"/>
              </a:xfrm>
              <a:custGeom>
                <a:avLst/>
                <a:gdLst>
                  <a:gd name="textAreaLeft" fmla="*/ 0 w 1033560"/>
                  <a:gd name="textAreaRight" fmla="*/ 1033920 w 1033560"/>
                  <a:gd name="textAreaTop" fmla="*/ 0 h 988560"/>
                  <a:gd name="textAreaBottom" fmla="*/ 988920 h 988560"/>
                </a:gdLst>
                <a:ahLst/>
                <a:rect l="textAreaLeft" t="textAreaTop" r="textAreaRight" b="textAreaBottom"/>
                <a:pathLst>
                  <a:path w="508" h="486">
                    <a:moveTo>
                      <a:pt x="0" y="486"/>
                    </a:moveTo>
                    <a:lnTo>
                      <a:pt x="2" y="486"/>
                    </a:lnTo>
                    <a:lnTo>
                      <a:pt x="4" y="486"/>
                    </a:lnTo>
                    <a:lnTo>
                      <a:pt x="6" y="486"/>
                    </a:lnTo>
                    <a:lnTo>
                      <a:pt x="8" y="486"/>
                    </a:lnTo>
                    <a:lnTo>
                      <a:pt x="10" y="486"/>
                    </a:lnTo>
                    <a:lnTo>
                      <a:pt x="12" y="486"/>
                    </a:lnTo>
                    <a:lnTo>
                      <a:pt x="14" y="486"/>
                    </a:lnTo>
                    <a:lnTo>
                      <a:pt x="16" y="486"/>
                    </a:lnTo>
                    <a:lnTo>
                      <a:pt x="18" y="486"/>
                    </a:lnTo>
                    <a:lnTo>
                      <a:pt x="20" y="486"/>
                    </a:lnTo>
                    <a:lnTo>
                      <a:pt x="22" y="486"/>
                    </a:lnTo>
                    <a:lnTo>
                      <a:pt x="24" y="486"/>
                    </a:lnTo>
                    <a:lnTo>
                      <a:pt x="26" y="486"/>
                    </a:lnTo>
                    <a:lnTo>
                      <a:pt x="28" y="486"/>
                    </a:lnTo>
                    <a:lnTo>
                      <a:pt x="30" y="486"/>
                    </a:lnTo>
                    <a:lnTo>
                      <a:pt x="32" y="486"/>
                    </a:lnTo>
                    <a:lnTo>
                      <a:pt x="34" y="486"/>
                    </a:lnTo>
                    <a:lnTo>
                      <a:pt x="36" y="486"/>
                    </a:lnTo>
                    <a:lnTo>
                      <a:pt x="38" y="486"/>
                    </a:lnTo>
                    <a:lnTo>
                      <a:pt x="40" y="486"/>
                    </a:lnTo>
                    <a:lnTo>
                      <a:pt x="42" y="486"/>
                    </a:lnTo>
                    <a:lnTo>
                      <a:pt x="44" y="486"/>
                    </a:lnTo>
                    <a:lnTo>
                      <a:pt x="46" y="484"/>
                    </a:lnTo>
                    <a:lnTo>
                      <a:pt x="48" y="484"/>
                    </a:lnTo>
                    <a:lnTo>
                      <a:pt x="50" y="484"/>
                    </a:lnTo>
                    <a:lnTo>
                      <a:pt x="52" y="484"/>
                    </a:lnTo>
                    <a:lnTo>
                      <a:pt x="54" y="484"/>
                    </a:lnTo>
                    <a:lnTo>
                      <a:pt x="56" y="484"/>
                    </a:lnTo>
                    <a:lnTo>
                      <a:pt x="58" y="484"/>
                    </a:lnTo>
                    <a:lnTo>
                      <a:pt x="60" y="484"/>
                    </a:lnTo>
                    <a:lnTo>
                      <a:pt x="62" y="484"/>
                    </a:lnTo>
                    <a:lnTo>
                      <a:pt x="64" y="484"/>
                    </a:lnTo>
                    <a:lnTo>
                      <a:pt x="66" y="484"/>
                    </a:lnTo>
                    <a:lnTo>
                      <a:pt x="68" y="484"/>
                    </a:lnTo>
                    <a:lnTo>
                      <a:pt x="70" y="484"/>
                    </a:lnTo>
                    <a:lnTo>
                      <a:pt x="72" y="482"/>
                    </a:lnTo>
                    <a:lnTo>
                      <a:pt x="74" y="482"/>
                    </a:lnTo>
                    <a:lnTo>
                      <a:pt x="76" y="482"/>
                    </a:lnTo>
                    <a:lnTo>
                      <a:pt x="78" y="480"/>
                    </a:lnTo>
                    <a:lnTo>
                      <a:pt x="80" y="480"/>
                    </a:lnTo>
                    <a:lnTo>
                      <a:pt x="82" y="480"/>
                    </a:lnTo>
                    <a:lnTo>
                      <a:pt x="84" y="480"/>
                    </a:lnTo>
                    <a:lnTo>
                      <a:pt x="86" y="480"/>
                    </a:lnTo>
                    <a:lnTo>
                      <a:pt x="88" y="478"/>
                    </a:lnTo>
                    <a:lnTo>
                      <a:pt x="90" y="476"/>
                    </a:lnTo>
                    <a:lnTo>
                      <a:pt x="92" y="474"/>
                    </a:lnTo>
                    <a:lnTo>
                      <a:pt x="94" y="472"/>
                    </a:lnTo>
                    <a:lnTo>
                      <a:pt x="96" y="468"/>
                    </a:lnTo>
                    <a:lnTo>
                      <a:pt x="98" y="464"/>
                    </a:lnTo>
                    <a:lnTo>
                      <a:pt x="100" y="460"/>
                    </a:lnTo>
                    <a:lnTo>
                      <a:pt x="102" y="458"/>
                    </a:lnTo>
                    <a:lnTo>
                      <a:pt x="104" y="458"/>
                    </a:lnTo>
                    <a:lnTo>
                      <a:pt x="106" y="458"/>
                    </a:lnTo>
                    <a:lnTo>
                      <a:pt x="108" y="458"/>
                    </a:lnTo>
                    <a:lnTo>
                      <a:pt x="110" y="456"/>
                    </a:lnTo>
                    <a:lnTo>
                      <a:pt x="112" y="450"/>
                    </a:lnTo>
                    <a:lnTo>
                      <a:pt x="114" y="446"/>
                    </a:lnTo>
                    <a:lnTo>
                      <a:pt x="116" y="442"/>
                    </a:lnTo>
                    <a:lnTo>
                      <a:pt x="118" y="442"/>
                    </a:lnTo>
                    <a:lnTo>
                      <a:pt x="120" y="442"/>
                    </a:lnTo>
                    <a:lnTo>
                      <a:pt x="122" y="442"/>
                    </a:lnTo>
                    <a:lnTo>
                      <a:pt x="124" y="440"/>
                    </a:lnTo>
                    <a:lnTo>
                      <a:pt x="126" y="438"/>
                    </a:lnTo>
                    <a:lnTo>
                      <a:pt x="128" y="434"/>
                    </a:lnTo>
                    <a:lnTo>
                      <a:pt x="130" y="428"/>
                    </a:lnTo>
                    <a:lnTo>
                      <a:pt x="132" y="426"/>
                    </a:lnTo>
                    <a:lnTo>
                      <a:pt x="134" y="426"/>
                    </a:lnTo>
                    <a:lnTo>
                      <a:pt x="136" y="426"/>
                    </a:lnTo>
                    <a:lnTo>
                      <a:pt x="138" y="418"/>
                    </a:lnTo>
                    <a:lnTo>
                      <a:pt x="140" y="404"/>
                    </a:lnTo>
                    <a:lnTo>
                      <a:pt x="142" y="392"/>
                    </a:lnTo>
                    <a:lnTo>
                      <a:pt x="144" y="388"/>
                    </a:lnTo>
                    <a:lnTo>
                      <a:pt x="146" y="380"/>
                    </a:lnTo>
                    <a:lnTo>
                      <a:pt x="148" y="370"/>
                    </a:lnTo>
                    <a:lnTo>
                      <a:pt x="150" y="362"/>
                    </a:lnTo>
                    <a:lnTo>
                      <a:pt x="152" y="358"/>
                    </a:lnTo>
                    <a:lnTo>
                      <a:pt x="154" y="358"/>
                    </a:lnTo>
                    <a:lnTo>
                      <a:pt x="156" y="360"/>
                    </a:lnTo>
                    <a:lnTo>
                      <a:pt x="158" y="354"/>
                    </a:lnTo>
                    <a:lnTo>
                      <a:pt x="160" y="338"/>
                    </a:lnTo>
                    <a:lnTo>
                      <a:pt x="162" y="326"/>
                    </a:lnTo>
                    <a:lnTo>
                      <a:pt x="164" y="328"/>
                    </a:lnTo>
                    <a:lnTo>
                      <a:pt x="166" y="326"/>
                    </a:lnTo>
                    <a:lnTo>
                      <a:pt x="168" y="314"/>
                    </a:lnTo>
                    <a:lnTo>
                      <a:pt x="170" y="290"/>
                    </a:lnTo>
                    <a:lnTo>
                      <a:pt x="172" y="258"/>
                    </a:lnTo>
                    <a:lnTo>
                      <a:pt x="174" y="240"/>
                    </a:lnTo>
                    <a:lnTo>
                      <a:pt x="176" y="240"/>
                    </a:lnTo>
                    <a:lnTo>
                      <a:pt x="178" y="240"/>
                    </a:lnTo>
                    <a:lnTo>
                      <a:pt x="180" y="232"/>
                    </a:lnTo>
                    <a:lnTo>
                      <a:pt x="182" y="208"/>
                    </a:lnTo>
                    <a:lnTo>
                      <a:pt x="184" y="166"/>
                    </a:lnTo>
                    <a:lnTo>
                      <a:pt x="186" y="128"/>
                    </a:lnTo>
                    <a:lnTo>
                      <a:pt x="188" y="112"/>
                    </a:lnTo>
                    <a:lnTo>
                      <a:pt x="190" y="122"/>
                    </a:lnTo>
                    <a:lnTo>
                      <a:pt x="192" y="124"/>
                    </a:lnTo>
                    <a:lnTo>
                      <a:pt x="194" y="92"/>
                    </a:lnTo>
                    <a:lnTo>
                      <a:pt x="196" y="46"/>
                    </a:lnTo>
                    <a:lnTo>
                      <a:pt x="198" y="54"/>
                    </a:lnTo>
                    <a:lnTo>
                      <a:pt x="200" y="74"/>
                    </a:lnTo>
                    <a:lnTo>
                      <a:pt x="202" y="68"/>
                    </a:lnTo>
                    <a:lnTo>
                      <a:pt x="204" y="40"/>
                    </a:lnTo>
                    <a:lnTo>
                      <a:pt x="206" y="20"/>
                    </a:lnTo>
                    <a:lnTo>
                      <a:pt x="208" y="10"/>
                    </a:lnTo>
                    <a:lnTo>
                      <a:pt x="210" y="0"/>
                    </a:lnTo>
                    <a:lnTo>
                      <a:pt x="212" y="20"/>
                    </a:lnTo>
                    <a:lnTo>
                      <a:pt x="214" y="58"/>
                    </a:lnTo>
                    <a:lnTo>
                      <a:pt x="216" y="68"/>
                    </a:lnTo>
                    <a:lnTo>
                      <a:pt x="218" y="76"/>
                    </a:lnTo>
                    <a:lnTo>
                      <a:pt x="220" y="120"/>
                    </a:lnTo>
                    <a:lnTo>
                      <a:pt x="222" y="148"/>
                    </a:lnTo>
                    <a:lnTo>
                      <a:pt x="224" y="148"/>
                    </a:lnTo>
                    <a:lnTo>
                      <a:pt x="226" y="166"/>
                    </a:lnTo>
                    <a:lnTo>
                      <a:pt x="228" y="194"/>
                    </a:lnTo>
                    <a:lnTo>
                      <a:pt x="230" y="218"/>
                    </a:lnTo>
                    <a:lnTo>
                      <a:pt x="232" y="238"/>
                    </a:lnTo>
                    <a:lnTo>
                      <a:pt x="234" y="254"/>
                    </a:lnTo>
                    <a:lnTo>
                      <a:pt x="236" y="264"/>
                    </a:lnTo>
                    <a:lnTo>
                      <a:pt x="238" y="276"/>
                    </a:lnTo>
                    <a:lnTo>
                      <a:pt x="240" y="294"/>
                    </a:lnTo>
                    <a:lnTo>
                      <a:pt x="242" y="306"/>
                    </a:lnTo>
                    <a:lnTo>
                      <a:pt x="244" y="322"/>
                    </a:lnTo>
                    <a:lnTo>
                      <a:pt x="246" y="340"/>
                    </a:lnTo>
                    <a:lnTo>
                      <a:pt x="248" y="352"/>
                    </a:lnTo>
                    <a:lnTo>
                      <a:pt x="250" y="360"/>
                    </a:lnTo>
                    <a:lnTo>
                      <a:pt x="252" y="364"/>
                    </a:lnTo>
                    <a:lnTo>
                      <a:pt x="254" y="364"/>
                    </a:lnTo>
                    <a:lnTo>
                      <a:pt x="256" y="366"/>
                    </a:lnTo>
                    <a:lnTo>
                      <a:pt x="258" y="370"/>
                    </a:lnTo>
                    <a:lnTo>
                      <a:pt x="260" y="380"/>
                    </a:lnTo>
                    <a:lnTo>
                      <a:pt x="262" y="392"/>
                    </a:lnTo>
                    <a:lnTo>
                      <a:pt x="264" y="404"/>
                    </a:lnTo>
                    <a:lnTo>
                      <a:pt x="266" y="410"/>
                    </a:lnTo>
                    <a:lnTo>
                      <a:pt x="268" y="412"/>
                    </a:lnTo>
                    <a:lnTo>
                      <a:pt x="270" y="408"/>
                    </a:lnTo>
                    <a:lnTo>
                      <a:pt x="272" y="408"/>
                    </a:lnTo>
                    <a:lnTo>
                      <a:pt x="274" y="414"/>
                    </a:lnTo>
                    <a:lnTo>
                      <a:pt x="276" y="424"/>
                    </a:lnTo>
                    <a:lnTo>
                      <a:pt x="278" y="434"/>
                    </a:lnTo>
                    <a:lnTo>
                      <a:pt x="280" y="438"/>
                    </a:lnTo>
                    <a:lnTo>
                      <a:pt x="282" y="440"/>
                    </a:lnTo>
                    <a:lnTo>
                      <a:pt x="284" y="440"/>
                    </a:lnTo>
                    <a:lnTo>
                      <a:pt x="286" y="442"/>
                    </a:lnTo>
                    <a:lnTo>
                      <a:pt x="288" y="446"/>
                    </a:lnTo>
                    <a:lnTo>
                      <a:pt x="290" y="452"/>
                    </a:lnTo>
                    <a:lnTo>
                      <a:pt x="292" y="458"/>
                    </a:lnTo>
                    <a:lnTo>
                      <a:pt x="294" y="462"/>
                    </a:lnTo>
                    <a:lnTo>
                      <a:pt x="296" y="464"/>
                    </a:lnTo>
                    <a:lnTo>
                      <a:pt x="298" y="468"/>
                    </a:lnTo>
                    <a:lnTo>
                      <a:pt x="300" y="470"/>
                    </a:lnTo>
                    <a:lnTo>
                      <a:pt x="302" y="472"/>
                    </a:lnTo>
                    <a:lnTo>
                      <a:pt x="304" y="472"/>
                    </a:lnTo>
                    <a:lnTo>
                      <a:pt x="306" y="474"/>
                    </a:lnTo>
                    <a:lnTo>
                      <a:pt x="308" y="476"/>
                    </a:lnTo>
                    <a:lnTo>
                      <a:pt x="310" y="478"/>
                    </a:lnTo>
                    <a:lnTo>
                      <a:pt x="312" y="480"/>
                    </a:lnTo>
                    <a:lnTo>
                      <a:pt x="314" y="482"/>
                    </a:lnTo>
                    <a:lnTo>
                      <a:pt x="316" y="482"/>
                    </a:lnTo>
                    <a:lnTo>
                      <a:pt x="318" y="484"/>
                    </a:lnTo>
                    <a:lnTo>
                      <a:pt x="320" y="484"/>
                    </a:lnTo>
                    <a:lnTo>
                      <a:pt x="322" y="484"/>
                    </a:lnTo>
                    <a:lnTo>
                      <a:pt x="324" y="484"/>
                    </a:lnTo>
                    <a:lnTo>
                      <a:pt x="326" y="484"/>
                    </a:lnTo>
                    <a:lnTo>
                      <a:pt x="328" y="484"/>
                    </a:lnTo>
                    <a:lnTo>
                      <a:pt x="330" y="484"/>
                    </a:lnTo>
                    <a:lnTo>
                      <a:pt x="332" y="484"/>
                    </a:lnTo>
                    <a:lnTo>
                      <a:pt x="334" y="484"/>
                    </a:lnTo>
                    <a:lnTo>
                      <a:pt x="336" y="484"/>
                    </a:lnTo>
                    <a:lnTo>
                      <a:pt x="338" y="484"/>
                    </a:lnTo>
                    <a:lnTo>
                      <a:pt x="340" y="484"/>
                    </a:lnTo>
                    <a:lnTo>
                      <a:pt x="342" y="484"/>
                    </a:lnTo>
                    <a:lnTo>
                      <a:pt x="344" y="484"/>
                    </a:lnTo>
                    <a:lnTo>
                      <a:pt x="346" y="484"/>
                    </a:lnTo>
                    <a:lnTo>
                      <a:pt x="348" y="484"/>
                    </a:lnTo>
                    <a:lnTo>
                      <a:pt x="350" y="484"/>
                    </a:lnTo>
                    <a:lnTo>
                      <a:pt x="352" y="484"/>
                    </a:lnTo>
                    <a:lnTo>
                      <a:pt x="354" y="484"/>
                    </a:lnTo>
                    <a:lnTo>
                      <a:pt x="356" y="484"/>
                    </a:lnTo>
                    <a:lnTo>
                      <a:pt x="358" y="484"/>
                    </a:lnTo>
                    <a:lnTo>
                      <a:pt x="360" y="486"/>
                    </a:lnTo>
                    <a:lnTo>
                      <a:pt x="362" y="486"/>
                    </a:lnTo>
                    <a:lnTo>
                      <a:pt x="364" y="486"/>
                    </a:lnTo>
                    <a:lnTo>
                      <a:pt x="366" y="486"/>
                    </a:lnTo>
                    <a:lnTo>
                      <a:pt x="368" y="486"/>
                    </a:lnTo>
                    <a:lnTo>
                      <a:pt x="370" y="486"/>
                    </a:lnTo>
                    <a:lnTo>
                      <a:pt x="372" y="486"/>
                    </a:lnTo>
                    <a:lnTo>
                      <a:pt x="374" y="486"/>
                    </a:lnTo>
                    <a:lnTo>
                      <a:pt x="376" y="486"/>
                    </a:lnTo>
                    <a:lnTo>
                      <a:pt x="378" y="486"/>
                    </a:lnTo>
                    <a:lnTo>
                      <a:pt x="380" y="486"/>
                    </a:lnTo>
                    <a:lnTo>
                      <a:pt x="382" y="486"/>
                    </a:lnTo>
                    <a:lnTo>
                      <a:pt x="384" y="486"/>
                    </a:lnTo>
                    <a:lnTo>
                      <a:pt x="386" y="486"/>
                    </a:lnTo>
                    <a:lnTo>
                      <a:pt x="388" y="486"/>
                    </a:lnTo>
                    <a:lnTo>
                      <a:pt x="390" y="486"/>
                    </a:lnTo>
                    <a:lnTo>
                      <a:pt x="392" y="486"/>
                    </a:lnTo>
                    <a:lnTo>
                      <a:pt x="394" y="486"/>
                    </a:lnTo>
                    <a:lnTo>
                      <a:pt x="396" y="486"/>
                    </a:lnTo>
                    <a:lnTo>
                      <a:pt x="398" y="486"/>
                    </a:lnTo>
                    <a:lnTo>
                      <a:pt x="400" y="486"/>
                    </a:lnTo>
                    <a:lnTo>
                      <a:pt x="402" y="486"/>
                    </a:lnTo>
                    <a:lnTo>
                      <a:pt x="404" y="486"/>
                    </a:lnTo>
                    <a:lnTo>
                      <a:pt x="406" y="486"/>
                    </a:lnTo>
                    <a:lnTo>
                      <a:pt x="408" y="486"/>
                    </a:lnTo>
                    <a:lnTo>
                      <a:pt x="410" y="486"/>
                    </a:lnTo>
                    <a:lnTo>
                      <a:pt x="412" y="486"/>
                    </a:lnTo>
                    <a:lnTo>
                      <a:pt x="414" y="486"/>
                    </a:lnTo>
                    <a:lnTo>
                      <a:pt x="416" y="486"/>
                    </a:lnTo>
                    <a:lnTo>
                      <a:pt x="418" y="486"/>
                    </a:lnTo>
                    <a:lnTo>
                      <a:pt x="420" y="486"/>
                    </a:lnTo>
                    <a:lnTo>
                      <a:pt x="422" y="486"/>
                    </a:lnTo>
                    <a:lnTo>
                      <a:pt x="424" y="486"/>
                    </a:lnTo>
                    <a:lnTo>
                      <a:pt x="426" y="486"/>
                    </a:lnTo>
                    <a:lnTo>
                      <a:pt x="428" y="486"/>
                    </a:lnTo>
                    <a:lnTo>
                      <a:pt x="430" y="486"/>
                    </a:lnTo>
                    <a:lnTo>
                      <a:pt x="432" y="486"/>
                    </a:lnTo>
                    <a:lnTo>
                      <a:pt x="434" y="486"/>
                    </a:lnTo>
                    <a:lnTo>
                      <a:pt x="436" y="486"/>
                    </a:lnTo>
                    <a:lnTo>
                      <a:pt x="438" y="486"/>
                    </a:lnTo>
                    <a:lnTo>
                      <a:pt x="440" y="486"/>
                    </a:lnTo>
                    <a:lnTo>
                      <a:pt x="442" y="486"/>
                    </a:lnTo>
                    <a:lnTo>
                      <a:pt x="444" y="486"/>
                    </a:lnTo>
                    <a:lnTo>
                      <a:pt x="446" y="486"/>
                    </a:lnTo>
                    <a:lnTo>
                      <a:pt x="448" y="486"/>
                    </a:lnTo>
                    <a:lnTo>
                      <a:pt x="450" y="486"/>
                    </a:lnTo>
                    <a:lnTo>
                      <a:pt x="452" y="486"/>
                    </a:lnTo>
                    <a:lnTo>
                      <a:pt x="454" y="486"/>
                    </a:lnTo>
                    <a:lnTo>
                      <a:pt x="456" y="486"/>
                    </a:lnTo>
                    <a:lnTo>
                      <a:pt x="458" y="486"/>
                    </a:lnTo>
                    <a:lnTo>
                      <a:pt x="460" y="486"/>
                    </a:lnTo>
                    <a:lnTo>
                      <a:pt x="462" y="486"/>
                    </a:lnTo>
                    <a:lnTo>
                      <a:pt x="464" y="486"/>
                    </a:lnTo>
                    <a:lnTo>
                      <a:pt x="466" y="486"/>
                    </a:lnTo>
                    <a:lnTo>
                      <a:pt x="468" y="486"/>
                    </a:lnTo>
                    <a:lnTo>
                      <a:pt x="470" y="486"/>
                    </a:lnTo>
                    <a:lnTo>
                      <a:pt x="472" y="486"/>
                    </a:lnTo>
                    <a:lnTo>
                      <a:pt x="474" y="486"/>
                    </a:lnTo>
                    <a:lnTo>
                      <a:pt x="476" y="486"/>
                    </a:lnTo>
                    <a:lnTo>
                      <a:pt x="478" y="486"/>
                    </a:lnTo>
                    <a:lnTo>
                      <a:pt x="480" y="486"/>
                    </a:lnTo>
                    <a:lnTo>
                      <a:pt x="482" y="486"/>
                    </a:lnTo>
                    <a:lnTo>
                      <a:pt x="484" y="486"/>
                    </a:lnTo>
                    <a:lnTo>
                      <a:pt x="486" y="486"/>
                    </a:lnTo>
                    <a:lnTo>
                      <a:pt x="488" y="486"/>
                    </a:lnTo>
                    <a:lnTo>
                      <a:pt x="490" y="486"/>
                    </a:lnTo>
                    <a:lnTo>
                      <a:pt x="492" y="486"/>
                    </a:lnTo>
                    <a:lnTo>
                      <a:pt x="494" y="486"/>
                    </a:lnTo>
                    <a:lnTo>
                      <a:pt x="496" y="486"/>
                    </a:lnTo>
                    <a:lnTo>
                      <a:pt x="498" y="486"/>
                    </a:lnTo>
                    <a:lnTo>
                      <a:pt x="500" y="486"/>
                    </a:lnTo>
                    <a:lnTo>
                      <a:pt x="502" y="486"/>
                    </a:lnTo>
                    <a:lnTo>
                      <a:pt x="504" y="486"/>
                    </a:lnTo>
                    <a:lnTo>
                      <a:pt x="506" y="486"/>
                    </a:lnTo>
                    <a:lnTo>
                      <a:pt x="508" y="486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89" name="Text Box 42"/>
            <p:cNvSpPr/>
            <p:nvPr/>
          </p:nvSpPr>
          <p:spPr>
            <a:xfrm>
              <a:off x="2705040" y="2752560"/>
              <a:ext cx="76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8/100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90" name="Group 576"/>
          <p:cNvGrpSpPr/>
          <p:nvPr/>
        </p:nvGrpSpPr>
        <p:grpSpPr>
          <a:xfrm>
            <a:off x="3671280" y="1236600"/>
            <a:ext cx="1423080" cy="1159200"/>
            <a:chOff x="3671280" y="1236600"/>
            <a:chExt cx="1423080" cy="1159200"/>
          </a:xfrm>
        </p:grpSpPr>
        <p:grpSp>
          <p:nvGrpSpPr>
            <p:cNvPr id="1091" name="Group 218"/>
            <p:cNvGrpSpPr/>
            <p:nvPr/>
          </p:nvGrpSpPr>
          <p:grpSpPr>
            <a:xfrm>
              <a:off x="3671280" y="1247760"/>
              <a:ext cx="1213200" cy="1148040"/>
              <a:chOff x="3671280" y="1247760"/>
              <a:chExt cx="1213200" cy="1148040"/>
            </a:xfrm>
          </p:grpSpPr>
          <p:grpSp>
            <p:nvGrpSpPr>
              <p:cNvPr id="1092" name="Group 219"/>
              <p:cNvGrpSpPr/>
              <p:nvPr/>
            </p:nvGrpSpPr>
            <p:grpSpPr>
              <a:xfrm>
                <a:off x="3671280" y="1247760"/>
                <a:ext cx="1213200" cy="1148040"/>
                <a:chOff x="3671280" y="1247760"/>
                <a:chExt cx="1213200" cy="1148040"/>
              </a:xfrm>
            </p:grpSpPr>
            <p:sp>
              <p:nvSpPr>
                <p:cNvPr id="1093" name="Rectangle 220"/>
                <p:cNvSpPr/>
                <p:nvPr/>
              </p:nvSpPr>
              <p:spPr>
                <a:xfrm>
                  <a:off x="3801240" y="1249560"/>
                  <a:ext cx="1048320" cy="1049760"/>
                </a:xfrm>
                <a:prstGeom prst="rect">
                  <a:avLst/>
                </a:prstGeom>
                <a:solidFill>
                  <a:srgbClr val="ffff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094" name="Group 221"/>
                <p:cNvGrpSpPr/>
                <p:nvPr/>
              </p:nvGrpSpPr>
              <p:grpSpPr>
                <a:xfrm>
                  <a:off x="3757320" y="2297160"/>
                  <a:ext cx="1127160" cy="98640"/>
                  <a:chOff x="3757320" y="2297160"/>
                  <a:chExt cx="1127160" cy="98640"/>
                </a:xfrm>
              </p:grpSpPr>
              <p:sp>
                <p:nvSpPr>
                  <p:cNvPr id="1095" name="Line 222"/>
                  <p:cNvSpPr/>
                  <p:nvPr/>
                </p:nvSpPr>
                <p:spPr>
                  <a:xfrm>
                    <a:off x="3799080" y="2297160"/>
                    <a:ext cx="1047960" cy="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096" name="Group 223"/>
                  <p:cNvGrpSpPr/>
                  <p:nvPr/>
                </p:nvGrpSpPr>
                <p:grpSpPr>
                  <a:xfrm>
                    <a:off x="3799080" y="2301120"/>
                    <a:ext cx="1047600" cy="23760"/>
                    <a:chOff x="3799080" y="2301120"/>
                    <a:chExt cx="1047600" cy="23760"/>
                  </a:xfrm>
                </p:grpSpPr>
                <p:sp>
                  <p:nvSpPr>
                    <p:cNvPr id="1097" name="Line 224"/>
                    <p:cNvSpPr/>
                    <p:nvPr/>
                  </p:nvSpPr>
                  <p:spPr>
                    <a:xfrm>
                      <a:off x="3799080" y="23011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98" name="Line 225"/>
                    <p:cNvSpPr/>
                    <p:nvPr/>
                  </p:nvSpPr>
                  <p:spPr>
                    <a:xfrm>
                      <a:off x="387648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99" name="Line 226"/>
                    <p:cNvSpPr/>
                    <p:nvPr/>
                  </p:nvSpPr>
                  <p:spPr>
                    <a:xfrm>
                      <a:off x="392112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0" name="Line 227"/>
                    <p:cNvSpPr/>
                    <p:nvPr/>
                  </p:nvSpPr>
                  <p:spPr>
                    <a:xfrm>
                      <a:off x="395352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1" name="Line 228"/>
                    <p:cNvSpPr/>
                    <p:nvPr/>
                  </p:nvSpPr>
                  <p:spPr>
                    <a:xfrm>
                      <a:off x="3981960" y="2301120"/>
                      <a:ext cx="0" cy="16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600" bIns="-30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2" name="Line 229"/>
                    <p:cNvSpPr/>
                    <p:nvPr/>
                  </p:nvSpPr>
                  <p:spPr>
                    <a:xfrm>
                      <a:off x="400248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3" name="Line 230"/>
                    <p:cNvSpPr/>
                    <p:nvPr/>
                  </p:nvSpPr>
                  <p:spPr>
                    <a:xfrm>
                      <a:off x="401868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4" name="Line 231"/>
                    <p:cNvSpPr/>
                    <p:nvPr/>
                  </p:nvSpPr>
                  <p:spPr>
                    <a:xfrm>
                      <a:off x="403524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5" name="Line 232"/>
                    <p:cNvSpPr/>
                    <p:nvPr/>
                  </p:nvSpPr>
                  <p:spPr>
                    <a:xfrm>
                      <a:off x="404712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6" name="Line 233"/>
                    <p:cNvSpPr/>
                    <p:nvPr/>
                  </p:nvSpPr>
                  <p:spPr>
                    <a:xfrm>
                      <a:off x="4059000" y="23011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7" name="Line 234"/>
                    <p:cNvSpPr/>
                    <p:nvPr/>
                  </p:nvSpPr>
                  <p:spPr>
                    <a:xfrm>
                      <a:off x="414072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8" name="Line 235"/>
                    <p:cNvSpPr/>
                    <p:nvPr/>
                  </p:nvSpPr>
                  <p:spPr>
                    <a:xfrm>
                      <a:off x="418572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09" name="Line 236"/>
                    <p:cNvSpPr/>
                    <p:nvPr/>
                  </p:nvSpPr>
                  <p:spPr>
                    <a:xfrm>
                      <a:off x="421776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0" name="Line 237"/>
                    <p:cNvSpPr/>
                    <p:nvPr/>
                  </p:nvSpPr>
                  <p:spPr>
                    <a:xfrm>
                      <a:off x="4242240" y="2301120"/>
                      <a:ext cx="0" cy="16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600" bIns="-30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1" name="Line 238"/>
                    <p:cNvSpPr/>
                    <p:nvPr/>
                  </p:nvSpPr>
                  <p:spPr>
                    <a:xfrm>
                      <a:off x="426672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2" name="Line 239"/>
                    <p:cNvSpPr/>
                    <p:nvPr/>
                  </p:nvSpPr>
                  <p:spPr>
                    <a:xfrm>
                      <a:off x="428328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3" name="Line 240"/>
                    <p:cNvSpPr/>
                    <p:nvPr/>
                  </p:nvSpPr>
                  <p:spPr>
                    <a:xfrm>
                      <a:off x="429948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4" name="Line 241"/>
                    <p:cNvSpPr/>
                    <p:nvPr/>
                  </p:nvSpPr>
                  <p:spPr>
                    <a:xfrm>
                      <a:off x="431136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5" name="Line 242"/>
                    <p:cNvSpPr/>
                    <p:nvPr/>
                  </p:nvSpPr>
                  <p:spPr>
                    <a:xfrm>
                      <a:off x="4323960" y="23011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6" name="Line 243"/>
                    <p:cNvSpPr/>
                    <p:nvPr/>
                  </p:nvSpPr>
                  <p:spPr>
                    <a:xfrm>
                      <a:off x="439920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7" name="Line 244"/>
                    <p:cNvSpPr/>
                    <p:nvPr/>
                  </p:nvSpPr>
                  <p:spPr>
                    <a:xfrm>
                      <a:off x="444816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8" name="Line 245"/>
                    <p:cNvSpPr/>
                    <p:nvPr/>
                  </p:nvSpPr>
                  <p:spPr>
                    <a:xfrm>
                      <a:off x="448056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19" name="Line 246"/>
                    <p:cNvSpPr/>
                    <p:nvPr/>
                  </p:nvSpPr>
                  <p:spPr>
                    <a:xfrm>
                      <a:off x="4504680" y="2301120"/>
                      <a:ext cx="0" cy="16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600" bIns="-30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0" name="Line 247"/>
                    <p:cNvSpPr/>
                    <p:nvPr/>
                  </p:nvSpPr>
                  <p:spPr>
                    <a:xfrm>
                      <a:off x="452520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1" name="Line 248"/>
                    <p:cNvSpPr/>
                    <p:nvPr/>
                  </p:nvSpPr>
                  <p:spPr>
                    <a:xfrm>
                      <a:off x="454536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2" name="Line 249"/>
                    <p:cNvSpPr/>
                    <p:nvPr/>
                  </p:nvSpPr>
                  <p:spPr>
                    <a:xfrm>
                      <a:off x="455796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3" name="Line 250"/>
                    <p:cNvSpPr/>
                    <p:nvPr/>
                  </p:nvSpPr>
                  <p:spPr>
                    <a:xfrm>
                      <a:off x="457416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4" name="Line 251"/>
                    <p:cNvSpPr/>
                    <p:nvPr/>
                  </p:nvSpPr>
                  <p:spPr>
                    <a:xfrm>
                      <a:off x="4586400" y="23011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5" name="Line 252"/>
                    <p:cNvSpPr/>
                    <p:nvPr/>
                  </p:nvSpPr>
                  <p:spPr>
                    <a:xfrm>
                      <a:off x="466344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6" name="Line 253"/>
                    <p:cNvSpPr/>
                    <p:nvPr/>
                  </p:nvSpPr>
                  <p:spPr>
                    <a:xfrm>
                      <a:off x="471240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7" name="Line 254"/>
                    <p:cNvSpPr/>
                    <p:nvPr/>
                  </p:nvSpPr>
                  <p:spPr>
                    <a:xfrm>
                      <a:off x="474516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8" name="Line 255"/>
                    <p:cNvSpPr/>
                    <p:nvPr/>
                  </p:nvSpPr>
                  <p:spPr>
                    <a:xfrm>
                      <a:off x="4769280" y="2301120"/>
                      <a:ext cx="0" cy="1620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0600" bIns="-306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29" name="Line 256"/>
                    <p:cNvSpPr/>
                    <p:nvPr/>
                  </p:nvSpPr>
                  <p:spPr>
                    <a:xfrm>
                      <a:off x="479016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0" name="Line 257"/>
                    <p:cNvSpPr/>
                    <p:nvPr/>
                  </p:nvSpPr>
                  <p:spPr>
                    <a:xfrm>
                      <a:off x="480600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1" name="Line 258"/>
                    <p:cNvSpPr/>
                    <p:nvPr/>
                  </p:nvSpPr>
                  <p:spPr>
                    <a:xfrm>
                      <a:off x="482220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2" name="Line 259"/>
                    <p:cNvSpPr/>
                    <p:nvPr/>
                  </p:nvSpPr>
                  <p:spPr>
                    <a:xfrm>
                      <a:off x="4834800" y="2301120"/>
                      <a:ext cx="0" cy="792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880" bIns="-388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3" name="Line 260"/>
                    <p:cNvSpPr/>
                    <p:nvPr/>
                  </p:nvSpPr>
                  <p:spPr>
                    <a:xfrm>
                      <a:off x="4846680" y="2301120"/>
                      <a:ext cx="0" cy="2376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3040" bIns="-2304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134" name="Group 261"/>
                  <p:cNvGrpSpPr/>
                  <p:nvPr/>
                </p:nvGrpSpPr>
                <p:grpSpPr>
                  <a:xfrm>
                    <a:off x="3757320" y="2333880"/>
                    <a:ext cx="1127160" cy="61920"/>
                    <a:chOff x="3757320" y="2333880"/>
                    <a:chExt cx="1127160" cy="61920"/>
                  </a:xfrm>
                </p:grpSpPr>
                <p:sp>
                  <p:nvSpPr>
                    <p:cNvPr id="1135" name="Rectangle 262"/>
                    <p:cNvSpPr/>
                    <p:nvPr/>
                  </p:nvSpPr>
                  <p:spPr>
                    <a:xfrm>
                      <a:off x="3757320" y="2349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6" name="Rectangle 263"/>
                    <p:cNvSpPr/>
                    <p:nvPr/>
                  </p:nvSpPr>
                  <p:spPr>
                    <a:xfrm>
                      <a:off x="3814560" y="2333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7" name="Rectangle 264"/>
                    <p:cNvSpPr/>
                    <p:nvPr/>
                  </p:nvSpPr>
                  <p:spPr>
                    <a:xfrm>
                      <a:off x="4017240" y="2349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8" name="Rectangle 265"/>
                    <p:cNvSpPr/>
                    <p:nvPr/>
                  </p:nvSpPr>
                  <p:spPr>
                    <a:xfrm>
                      <a:off x="4075200" y="2333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39" name="Rectangle 266"/>
                    <p:cNvSpPr/>
                    <p:nvPr/>
                  </p:nvSpPr>
                  <p:spPr>
                    <a:xfrm>
                      <a:off x="4282200" y="2349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0" name="Rectangle 267"/>
                    <p:cNvSpPr/>
                    <p:nvPr/>
                  </p:nvSpPr>
                  <p:spPr>
                    <a:xfrm>
                      <a:off x="4339800" y="2333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1" name="Rectangle 268"/>
                    <p:cNvSpPr/>
                    <p:nvPr/>
                  </p:nvSpPr>
                  <p:spPr>
                    <a:xfrm>
                      <a:off x="4544640" y="2349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2" name="Rectangle 269"/>
                    <p:cNvSpPr/>
                    <p:nvPr/>
                  </p:nvSpPr>
                  <p:spPr>
                    <a:xfrm>
                      <a:off x="4602240" y="2333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3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3" name="Rectangle 270"/>
                    <p:cNvSpPr/>
                    <p:nvPr/>
                  </p:nvSpPr>
                  <p:spPr>
                    <a:xfrm>
                      <a:off x="4804920" y="234972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4" name="Rectangle 271"/>
                    <p:cNvSpPr/>
                    <p:nvPr/>
                  </p:nvSpPr>
                  <p:spPr>
                    <a:xfrm>
                      <a:off x="4862520" y="233388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grpSp>
              <p:nvGrpSpPr>
                <p:cNvPr id="1145" name="Group 272"/>
                <p:cNvGrpSpPr/>
                <p:nvPr/>
              </p:nvGrpSpPr>
              <p:grpSpPr>
                <a:xfrm>
                  <a:off x="3671280" y="1247760"/>
                  <a:ext cx="127800" cy="1066680"/>
                  <a:chOff x="3671280" y="1247760"/>
                  <a:chExt cx="127800" cy="1066680"/>
                </a:xfrm>
              </p:grpSpPr>
              <p:sp>
                <p:nvSpPr>
                  <p:cNvPr id="1146" name="Line 273"/>
                  <p:cNvSpPr/>
                  <p:nvPr/>
                </p:nvSpPr>
                <p:spPr>
                  <a:xfrm flipV="1">
                    <a:off x="3799080" y="1247760"/>
                    <a:ext cx="0" cy="1049040"/>
                  </a:xfrm>
                  <a:prstGeom prst="line">
                    <a:avLst/>
                  </a:prstGeom>
                  <a:ln w="324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147" name="Group 274"/>
                  <p:cNvGrpSpPr/>
                  <p:nvPr/>
                </p:nvGrpSpPr>
                <p:grpSpPr>
                  <a:xfrm>
                    <a:off x="3671280" y="1267920"/>
                    <a:ext cx="79560" cy="1046520"/>
                    <a:chOff x="3671280" y="1267920"/>
                    <a:chExt cx="79560" cy="1046520"/>
                  </a:xfrm>
                </p:grpSpPr>
                <p:sp>
                  <p:nvSpPr>
                    <p:cNvPr id="1148" name="Rectangle 275"/>
                    <p:cNvSpPr/>
                    <p:nvPr/>
                  </p:nvSpPr>
                  <p:spPr>
                    <a:xfrm>
                      <a:off x="3728880" y="2268360"/>
                      <a:ext cx="219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49" name="Rectangle 276"/>
                    <p:cNvSpPr/>
                    <p:nvPr/>
                  </p:nvSpPr>
                  <p:spPr>
                    <a:xfrm>
                      <a:off x="3699720" y="20692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2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0" name="Rectangle 277"/>
                    <p:cNvSpPr/>
                    <p:nvPr/>
                  </p:nvSpPr>
                  <p:spPr>
                    <a:xfrm>
                      <a:off x="3699720" y="18694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4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1" name="Rectangle 278"/>
                    <p:cNvSpPr/>
                    <p:nvPr/>
                  </p:nvSpPr>
                  <p:spPr>
                    <a:xfrm>
                      <a:off x="3699720" y="166608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6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2" name="Rectangle 279"/>
                    <p:cNvSpPr/>
                    <p:nvPr/>
                  </p:nvSpPr>
                  <p:spPr>
                    <a:xfrm>
                      <a:off x="3699720" y="1467000"/>
                      <a:ext cx="4356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8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3" name="Rectangle 280"/>
                    <p:cNvSpPr/>
                    <p:nvPr/>
                  </p:nvSpPr>
                  <p:spPr>
                    <a:xfrm>
                      <a:off x="3671280" y="1267920"/>
                      <a:ext cx="64800" cy="46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00" spc="-1" strike="noStrike">
                          <a:solidFill>
                            <a:srgbClr val="000000"/>
                          </a:solidFill>
                          <a:latin typeface="Arial"/>
                          <a:ea typeface="ＭＳ Ｐゴシック"/>
                        </a:rPr>
                        <a:t>100</a:t>
                      </a:r>
                      <a:endParaRPr b="0" lang="en-US" sz="3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154" name="Group 281"/>
                  <p:cNvGrpSpPr/>
                  <p:nvPr/>
                </p:nvGrpSpPr>
                <p:grpSpPr>
                  <a:xfrm>
                    <a:off x="3774600" y="1296360"/>
                    <a:ext cx="23760" cy="999720"/>
                    <a:chOff x="3774600" y="1296360"/>
                    <a:chExt cx="23760" cy="999720"/>
                  </a:xfrm>
                </p:grpSpPr>
                <p:sp>
                  <p:nvSpPr>
                    <p:cNvPr id="1155" name="Line 282"/>
                    <p:cNvSpPr/>
                    <p:nvPr/>
                  </p:nvSpPr>
                  <p:spPr>
                    <a:xfrm flipH="1">
                      <a:off x="3774600" y="229608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6" name="Line 283"/>
                    <p:cNvSpPr/>
                    <p:nvPr/>
                  </p:nvSpPr>
                  <p:spPr>
                    <a:xfrm flipH="1">
                      <a:off x="3790440" y="22478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7" name="Line 284"/>
                    <p:cNvSpPr/>
                    <p:nvPr/>
                  </p:nvSpPr>
                  <p:spPr>
                    <a:xfrm flipH="1">
                      <a:off x="3790440" y="21988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8" name="Line 285"/>
                    <p:cNvSpPr/>
                    <p:nvPr/>
                  </p:nvSpPr>
                  <p:spPr>
                    <a:xfrm flipH="1">
                      <a:off x="3790440" y="21459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59" name="Line 286"/>
                    <p:cNvSpPr/>
                    <p:nvPr/>
                  </p:nvSpPr>
                  <p:spPr>
                    <a:xfrm flipH="1">
                      <a:off x="3774600" y="209700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0" name="Line 287"/>
                    <p:cNvSpPr/>
                    <p:nvPr/>
                  </p:nvSpPr>
                  <p:spPr>
                    <a:xfrm flipH="1">
                      <a:off x="3790440" y="20480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1" name="Line 288"/>
                    <p:cNvSpPr/>
                    <p:nvPr/>
                  </p:nvSpPr>
                  <p:spPr>
                    <a:xfrm flipH="1">
                      <a:off x="3790440" y="19954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2" name="Line 289"/>
                    <p:cNvSpPr/>
                    <p:nvPr/>
                  </p:nvSpPr>
                  <p:spPr>
                    <a:xfrm flipH="1">
                      <a:off x="3790440" y="194652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3" name="Line 290"/>
                    <p:cNvSpPr/>
                    <p:nvPr/>
                  </p:nvSpPr>
                  <p:spPr>
                    <a:xfrm flipH="1">
                      <a:off x="3774600" y="189792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4" name="Line 291"/>
                    <p:cNvSpPr/>
                    <p:nvPr/>
                  </p:nvSpPr>
                  <p:spPr>
                    <a:xfrm flipH="1">
                      <a:off x="3790440" y="18446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5" name="Line 292"/>
                    <p:cNvSpPr/>
                    <p:nvPr/>
                  </p:nvSpPr>
                  <p:spPr>
                    <a:xfrm flipH="1">
                      <a:off x="3790440" y="17964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6" name="Line 293"/>
                    <p:cNvSpPr/>
                    <p:nvPr/>
                  </p:nvSpPr>
                  <p:spPr>
                    <a:xfrm flipH="1">
                      <a:off x="3790440" y="17474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7" name="Line 294"/>
                    <p:cNvSpPr/>
                    <p:nvPr/>
                  </p:nvSpPr>
                  <p:spPr>
                    <a:xfrm flipH="1">
                      <a:off x="3774600" y="169452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8" name="Line 295"/>
                    <p:cNvSpPr/>
                    <p:nvPr/>
                  </p:nvSpPr>
                  <p:spPr>
                    <a:xfrm flipH="1">
                      <a:off x="3790440" y="16455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69" name="Line 296"/>
                    <p:cNvSpPr/>
                    <p:nvPr/>
                  </p:nvSpPr>
                  <p:spPr>
                    <a:xfrm flipH="1">
                      <a:off x="3790440" y="159660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0" name="Line 297"/>
                    <p:cNvSpPr/>
                    <p:nvPr/>
                  </p:nvSpPr>
                  <p:spPr>
                    <a:xfrm flipH="1">
                      <a:off x="3790440" y="154404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1" name="Line 298"/>
                    <p:cNvSpPr/>
                    <p:nvPr/>
                  </p:nvSpPr>
                  <p:spPr>
                    <a:xfrm flipH="1">
                      <a:off x="3774600" y="149544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2" name="Line 299"/>
                    <p:cNvSpPr/>
                    <p:nvPr/>
                  </p:nvSpPr>
                  <p:spPr>
                    <a:xfrm flipH="1">
                      <a:off x="3790440" y="144648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3" name="Line 300"/>
                    <p:cNvSpPr/>
                    <p:nvPr/>
                  </p:nvSpPr>
                  <p:spPr>
                    <a:xfrm flipH="1">
                      <a:off x="3790440" y="139392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4" name="Line 301"/>
                    <p:cNvSpPr/>
                    <p:nvPr/>
                  </p:nvSpPr>
                  <p:spPr>
                    <a:xfrm flipH="1">
                      <a:off x="3790440" y="1344960"/>
                      <a:ext cx="792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175" name="Line 302"/>
                    <p:cNvSpPr/>
                    <p:nvPr/>
                  </p:nvSpPr>
                  <p:spPr>
                    <a:xfrm flipH="1">
                      <a:off x="3774600" y="1296360"/>
                      <a:ext cx="23760" cy="0"/>
                    </a:xfrm>
                    <a:prstGeom prst="line">
                      <a:avLst/>
                    </a:prstGeom>
                    <a:ln w="324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1176" name="Group 303"/>
              <p:cNvGrpSpPr/>
              <p:nvPr/>
            </p:nvGrpSpPr>
            <p:grpSpPr>
              <a:xfrm>
                <a:off x="3807720" y="1256040"/>
                <a:ext cx="1035720" cy="1040760"/>
                <a:chOff x="3807720" y="1256040"/>
                <a:chExt cx="1035720" cy="1040760"/>
              </a:xfrm>
            </p:grpSpPr>
            <p:sp>
              <p:nvSpPr>
                <p:cNvPr id="1177" name="Freeform 304"/>
                <p:cNvSpPr/>
                <p:nvPr/>
              </p:nvSpPr>
              <p:spPr>
                <a:xfrm>
                  <a:off x="3807720" y="1256040"/>
                  <a:ext cx="1035720" cy="1037160"/>
                </a:xfrm>
                <a:custGeom>
                  <a:avLst/>
                  <a:gdLst>
                    <a:gd name="textAreaLeft" fmla="*/ 0 w 1035720"/>
                    <a:gd name="textAreaRight" fmla="*/ 1036080 w 1035720"/>
                    <a:gd name="textAreaTop" fmla="*/ 0 h 1037160"/>
                    <a:gd name="textAreaBottom" fmla="*/ 1037520 h 1037160"/>
                  </a:gdLst>
                  <a:ahLst/>
                  <a:rect l="textAreaLeft" t="textAreaTop" r="textAreaRight" b="textAreaBottom"/>
                  <a:pathLst>
                    <a:path w="509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200"/>
                      </a:lnTo>
                      <a:lnTo>
                        <a:pt x="4" y="306"/>
                      </a:lnTo>
                      <a:lnTo>
                        <a:pt x="6" y="298"/>
                      </a:lnTo>
                      <a:lnTo>
                        <a:pt x="8" y="280"/>
                      </a:lnTo>
                      <a:lnTo>
                        <a:pt x="10" y="256"/>
                      </a:lnTo>
                      <a:lnTo>
                        <a:pt x="12" y="226"/>
                      </a:lnTo>
                      <a:lnTo>
                        <a:pt x="14" y="198"/>
                      </a:lnTo>
                      <a:lnTo>
                        <a:pt x="16" y="186"/>
                      </a:lnTo>
                      <a:lnTo>
                        <a:pt x="18" y="164"/>
                      </a:lnTo>
                      <a:lnTo>
                        <a:pt x="20" y="130"/>
                      </a:lnTo>
                      <a:lnTo>
                        <a:pt x="22" y="112"/>
                      </a:lnTo>
                      <a:lnTo>
                        <a:pt x="24" y="108"/>
                      </a:lnTo>
                      <a:lnTo>
                        <a:pt x="26" y="100"/>
                      </a:lnTo>
                      <a:lnTo>
                        <a:pt x="28" y="76"/>
                      </a:lnTo>
                      <a:lnTo>
                        <a:pt x="30" y="46"/>
                      </a:lnTo>
                      <a:lnTo>
                        <a:pt x="32" y="40"/>
                      </a:lnTo>
                      <a:lnTo>
                        <a:pt x="34" y="44"/>
                      </a:lnTo>
                      <a:lnTo>
                        <a:pt x="36" y="62"/>
                      </a:lnTo>
                      <a:lnTo>
                        <a:pt x="38" y="80"/>
                      </a:lnTo>
                      <a:lnTo>
                        <a:pt x="40" y="70"/>
                      </a:lnTo>
                      <a:lnTo>
                        <a:pt x="42" y="46"/>
                      </a:lnTo>
                      <a:lnTo>
                        <a:pt x="44" y="28"/>
                      </a:lnTo>
                      <a:lnTo>
                        <a:pt x="46" y="24"/>
                      </a:lnTo>
                      <a:lnTo>
                        <a:pt x="48" y="42"/>
                      </a:lnTo>
                      <a:lnTo>
                        <a:pt x="50" y="82"/>
                      </a:lnTo>
                      <a:lnTo>
                        <a:pt x="52" y="102"/>
                      </a:lnTo>
                      <a:lnTo>
                        <a:pt x="54" y="104"/>
                      </a:lnTo>
                      <a:lnTo>
                        <a:pt x="56" y="112"/>
                      </a:lnTo>
                      <a:lnTo>
                        <a:pt x="58" y="130"/>
                      </a:lnTo>
                      <a:lnTo>
                        <a:pt x="60" y="162"/>
                      </a:lnTo>
                      <a:lnTo>
                        <a:pt x="62" y="168"/>
                      </a:lnTo>
                      <a:lnTo>
                        <a:pt x="64" y="152"/>
                      </a:lnTo>
                      <a:lnTo>
                        <a:pt x="66" y="142"/>
                      </a:lnTo>
                      <a:lnTo>
                        <a:pt x="68" y="164"/>
                      </a:lnTo>
                      <a:lnTo>
                        <a:pt x="70" y="200"/>
                      </a:lnTo>
                      <a:lnTo>
                        <a:pt x="72" y="232"/>
                      </a:lnTo>
                      <a:lnTo>
                        <a:pt x="74" y="252"/>
                      </a:lnTo>
                      <a:lnTo>
                        <a:pt x="76" y="262"/>
                      </a:lnTo>
                      <a:lnTo>
                        <a:pt x="78" y="276"/>
                      </a:lnTo>
                      <a:lnTo>
                        <a:pt x="80" y="296"/>
                      </a:lnTo>
                      <a:lnTo>
                        <a:pt x="82" y="310"/>
                      </a:lnTo>
                      <a:lnTo>
                        <a:pt x="84" y="318"/>
                      </a:lnTo>
                      <a:lnTo>
                        <a:pt x="86" y="336"/>
                      </a:lnTo>
                      <a:lnTo>
                        <a:pt x="88" y="360"/>
                      </a:lnTo>
                      <a:lnTo>
                        <a:pt x="90" y="376"/>
                      </a:lnTo>
                      <a:lnTo>
                        <a:pt x="92" y="388"/>
                      </a:lnTo>
                      <a:lnTo>
                        <a:pt x="94" y="402"/>
                      </a:lnTo>
                      <a:lnTo>
                        <a:pt x="96" y="418"/>
                      </a:lnTo>
                      <a:lnTo>
                        <a:pt x="98" y="430"/>
                      </a:lnTo>
                      <a:lnTo>
                        <a:pt x="100" y="440"/>
                      </a:lnTo>
                      <a:lnTo>
                        <a:pt x="102" y="448"/>
                      </a:lnTo>
                      <a:lnTo>
                        <a:pt x="104" y="456"/>
                      </a:lnTo>
                      <a:lnTo>
                        <a:pt x="106" y="464"/>
                      </a:lnTo>
                      <a:lnTo>
                        <a:pt x="108" y="468"/>
                      </a:lnTo>
                      <a:lnTo>
                        <a:pt x="110" y="474"/>
                      </a:lnTo>
                      <a:lnTo>
                        <a:pt x="112" y="478"/>
                      </a:lnTo>
                      <a:lnTo>
                        <a:pt x="114" y="482"/>
                      </a:lnTo>
                      <a:lnTo>
                        <a:pt x="116" y="484"/>
                      </a:lnTo>
                      <a:lnTo>
                        <a:pt x="118" y="486"/>
                      </a:lnTo>
                      <a:lnTo>
                        <a:pt x="120" y="488"/>
                      </a:lnTo>
                      <a:lnTo>
                        <a:pt x="122" y="492"/>
                      </a:lnTo>
                      <a:lnTo>
                        <a:pt x="124" y="494"/>
                      </a:lnTo>
                      <a:lnTo>
                        <a:pt x="126" y="496"/>
                      </a:lnTo>
                      <a:lnTo>
                        <a:pt x="128" y="498"/>
                      </a:lnTo>
                      <a:lnTo>
                        <a:pt x="130" y="500"/>
                      </a:lnTo>
                      <a:lnTo>
                        <a:pt x="132" y="500"/>
                      </a:lnTo>
                      <a:lnTo>
                        <a:pt x="134" y="502"/>
                      </a:lnTo>
                      <a:lnTo>
                        <a:pt x="136" y="504"/>
                      </a:lnTo>
                      <a:lnTo>
                        <a:pt x="138" y="504"/>
                      </a:lnTo>
                      <a:lnTo>
                        <a:pt x="140" y="504"/>
                      </a:lnTo>
                      <a:lnTo>
                        <a:pt x="142" y="504"/>
                      </a:lnTo>
                      <a:lnTo>
                        <a:pt x="144" y="506"/>
                      </a:lnTo>
                      <a:lnTo>
                        <a:pt x="146" y="506"/>
                      </a:lnTo>
                      <a:lnTo>
                        <a:pt x="148" y="506"/>
                      </a:lnTo>
                      <a:lnTo>
                        <a:pt x="150" y="506"/>
                      </a:lnTo>
                      <a:lnTo>
                        <a:pt x="152" y="506"/>
                      </a:lnTo>
                      <a:lnTo>
                        <a:pt x="154" y="506"/>
                      </a:lnTo>
                      <a:lnTo>
                        <a:pt x="156" y="508"/>
                      </a:lnTo>
                      <a:lnTo>
                        <a:pt x="158" y="508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08"/>
                      </a:lnTo>
                      <a:lnTo>
                        <a:pt x="176" y="508"/>
                      </a:lnTo>
                      <a:lnTo>
                        <a:pt x="178" y="508"/>
                      </a:lnTo>
                      <a:lnTo>
                        <a:pt x="180" y="508"/>
                      </a:lnTo>
                      <a:lnTo>
                        <a:pt x="182" y="508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10"/>
                      </a:lnTo>
                      <a:lnTo>
                        <a:pt x="216" y="510"/>
                      </a:lnTo>
                      <a:lnTo>
                        <a:pt x="218" y="510"/>
                      </a:lnTo>
                      <a:lnTo>
                        <a:pt x="220" y="510"/>
                      </a:lnTo>
                      <a:lnTo>
                        <a:pt x="222" y="510"/>
                      </a:lnTo>
                      <a:lnTo>
                        <a:pt x="224" y="510"/>
                      </a:lnTo>
                      <a:lnTo>
                        <a:pt x="226" y="510"/>
                      </a:lnTo>
                      <a:lnTo>
                        <a:pt x="228" y="510"/>
                      </a:lnTo>
                      <a:lnTo>
                        <a:pt x="230" y="510"/>
                      </a:lnTo>
                      <a:lnTo>
                        <a:pt x="232" y="510"/>
                      </a:lnTo>
                      <a:lnTo>
                        <a:pt x="234" y="510"/>
                      </a:lnTo>
                      <a:lnTo>
                        <a:pt x="236" y="510"/>
                      </a:lnTo>
                      <a:lnTo>
                        <a:pt x="238" y="510"/>
                      </a:lnTo>
                      <a:lnTo>
                        <a:pt x="240" y="510"/>
                      </a:lnTo>
                      <a:lnTo>
                        <a:pt x="242" y="510"/>
                      </a:lnTo>
                      <a:lnTo>
                        <a:pt x="244" y="510"/>
                      </a:lnTo>
                      <a:lnTo>
                        <a:pt x="246" y="510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10"/>
                      </a:lnTo>
                      <a:lnTo>
                        <a:pt x="254" y="510"/>
                      </a:lnTo>
                      <a:lnTo>
                        <a:pt x="256" y="510"/>
                      </a:lnTo>
                      <a:lnTo>
                        <a:pt x="258" y="510"/>
                      </a:lnTo>
                      <a:lnTo>
                        <a:pt x="260" y="510"/>
                      </a:lnTo>
                      <a:lnTo>
                        <a:pt x="262" y="510"/>
                      </a:lnTo>
                      <a:lnTo>
                        <a:pt x="264" y="510"/>
                      </a:lnTo>
                      <a:lnTo>
                        <a:pt x="266" y="510"/>
                      </a:lnTo>
                      <a:lnTo>
                        <a:pt x="268" y="510"/>
                      </a:lnTo>
                      <a:lnTo>
                        <a:pt x="270" y="510"/>
                      </a:lnTo>
                      <a:lnTo>
                        <a:pt x="272" y="510"/>
                      </a:lnTo>
                      <a:lnTo>
                        <a:pt x="274" y="510"/>
                      </a:lnTo>
                      <a:lnTo>
                        <a:pt x="276" y="510"/>
                      </a:lnTo>
                      <a:lnTo>
                        <a:pt x="278" y="510"/>
                      </a:lnTo>
                      <a:lnTo>
                        <a:pt x="280" y="510"/>
                      </a:lnTo>
                      <a:lnTo>
                        <a:pt x="282" y="510"/>
                      </a:lnTo>
                      <a:lnTo>
                        <a:pt x="284" y="510"/>
                      </a:lnTo>
                      <a:lnTo>
                        <a:pt x="286" y="510"/>
                      </a:lnTo>
                      <a:lnTo>
                        <a:pt x="288" y="510"/>
                      </a:lnTo>
                      <a:lnTo>
                        <a:pt x="290" y="510"/>
                      </a:lnTo>
                      <a:lnTo>
                        <a:pt x="291" y="510"/>
                      </a:lnTo>
                      <a:lnTo>
                        <a:pt x="293" y="510"/>
                      </a:lnTo>
                      <a:lnTo>
                        <a:pt x="295" y="510"/>
                      </a:lnTo>
                      <a:lnTo>
                        <a:pt x="297" y="510"/>
                      </a:lnTo>
                      <a:lnTo>
                        <a:pt x="299" y="510"/>
                      </a:lnTo>
                      <a:lnTo>
                        <a:pt x="301" y="510"/>
                      </a:lnTo>
                      <a:lnTo>
                        <a:pt x="303" y="510"/>
                      </a:lnTo>
                      <a:lnTo>
                        <a:pt x="305" y="510"/>
                      </a:lnTo>
                      <a:lnTo>
                        <a:pt x="307" y="508"/>
                      </a:lnTo>
                      <a:lnTo>
                        <a:pt x="309" y="508"/>
                      </a:lnTo>
                      <a:lnTo>
                        <a:pt x="311" y="508"/>
                      </a:lnTo>
                      <a:lnTo>
                        <a:pt x="313" y="508"/>
                      </a:lnTo>
                      <a:lnTo>
                        <a:pt x="315" y="508"/>
                      </a:lnTo>
                      <a:lnTo>
                        <a:pt x="317" y="508"/>
                      </a:lnTo>
                      <a:lnTo>
                        <a:pt x="319" y="508"/>
                      </a:lnTo>
                      <a:lnTo>
                        <a:pt x="321" y="508"/>
                      </a:lnTo>
                      <a:lnTo>
                        <a:pt x="323" y="508"/>
                      </a:lnTo>
                      <a:lnTo>
                        <a:pt x="325" y="508"/>
                      </a:lnTo>
                      <a:lnTo>
                        <a:pt x="327" y="508"/>
                      </a:lnTo>
                      <a:lnTo>
                        <a:pt x="329" y="508"/>
                      </a:lnTo>
                      <a:lnTo>
                        <a:pt x="331" y="508"/>
                      </a:lnTo>
                      <a:lnTo>
                        <a:pt x="333" y="508"/>
                      </a:lnTo>
                      <a:lnTo>
                        <a:pt x="335" y="508"/>
                      </a:lnTo>
                      <a:lnTo>
                        <a:pt x="337" y="508"/>
                      </a:lnTo>
                      <a:lnTo>
                        <a:pt x="339" y="508"/>
                      </a:lnTo>
                      <a:lnTo>
                        <a:pt x="341" y="508"/>
                      </a:lnTo>
                      <a:lnTo>
                        <a:pt x="343" y="508"/>
                      </a:lnTo>
                      <a:lnTo>
                        <a:pt x="345" y="510"/>
                      </a:lnTo>
                      <a:lnTo>
                        <a:pt x="347" y="510"/>
                      </a:lnTo>
                      <a:lnTo>
                        <a:pt x="349" y="510"/>
                      </a:lnTo>
                      <a:lnTo>
                        <a:pt x="351" y="510"/>
                      </a:lnTo>
                      <a:lnTo>
                        <a:pt x="353" y="510"/>
                      </a:lnTo>
                      <a:lnTo>
                        <a:pt x="355" y="510"/>
                      </a:lnTo>
                      <a:lnTo>
                        <a:pt x="357" y="510"/>
                      </a:lnTo>
                      <a:lnTo>
                        <a:pt x="359" y="510"/>
                      </a:lnTo>
                      <a:lnTo>
                        <a:pt x="361" y="510"/>
                      </a:lnTo>
                      <a:lnTo>
                        <a:pt x="363" y="510"/>
                      </a:lnTo>
                      <a:lnTo>
                        <a:pt x="365" y="510"/>
                      </a:lnTo>
                      <a:lnTo>
                        <a:pt x="367" y="510"/>
                      </a:lnTo>
                      <a:lnTo>
                        <a:pt x="369" y="510"/>
                      </a:lnTo>
                      <a:lnTo>
                        <a:pt x="371" y="510"/>
                      </a:lnTo>
                      <a:lnTo>
                        <a:pt x="373" y="510"/>
                      </a:lnTo>
                      <a:lnTo>
                        <a:pt x="375" y="510"/>
                      </a:lnTo>
                      <a:lnTo>
                        <a:pt x="377" y="510"/>
                      </a:lnTo>
                      <a:lnTo>
                        <a:pt x="379" y="510"/>
                      </a:lnTo>
                      <a:lnTo>
                        <a:pt x="381" y="510"/>
                      </a:lnTo>
                      <a:lnTo>
                        <a:pt x="383" y="510"/>
                      </a:lnTo>
                      <a:lnTo>
                        <a:pt x="385" y="510"/>
                      </a:lnTo>
                      <a:lnTo>
                        <a:pt x="387" y="510"/>
                      </a:lnTo>
                      <a:lnTo>
                        <a:pt x="389" y="510"/>
                      </a:lnTo>
                      <a:lnTo>
                        <a:pt x="391" y="510"/>
                      </a:lnTo>
                      <a:lnTo>
                        <a:pt x="393" y="510"/>
                      </a:lnTo>
                      <a:lnTo>
                        <a:pt x="395" y="510"/>
                      </a:lnTo>
                      <a:lnTo>
                        <a:pt x="397" y="510"/>
                      </a:lnTo>
                      <a:lnTo>
                        <a:pt x="399" y="510"/>
                      </a:lnTo>
                      <a:lnTo>
                        <a:pt x="401" y="510"/>
                      </a:lnTo>
                      <a:lnTo>
                        <a:pt x="403" y="510"/>
                      </a:lnTo>
                      <a:lnTo>
                        <a:pt x="405" y="510"/>
                      </a:lnTo>
                      <a:lnTo>
                        <a:pt x="407" y="510"/>
                      </a:lnTo>
                      <a:lnTo>
                        <a:pt x="409" y="510"/>
                      </a:lnTo>
                      <a:lnTo>
                        <a:pt x="411" y="510"/>
                      </a:lnTo>
                      <a:lnTo>
                        <a:pt x="413" y="510"/>
                      </a:lnTo>
                      <a:lnTo>
                        <a:pt x="415" y="510"/>
                      </a:lnTo>
                      <a:lnTo>
                        <a:pt x="417" y="510"/>
                      </a:lnTo>
                      <a:lnTo>
                        <a:pt x="419" y="510"/>
                      </a:lnTo>
                      <a:lnTo>
                        <a:pt x="421" y="510"/>
                      </a:lnTo>
                      <a:lnTo>
                        <a:pt x="423" y="510"/>
                      </a:lnTo>
                      <a:lnTo>
                        <a:pt x="425" y="510"/>
                      </a:lnTo>
                      <a:lnTo>
                        <a:pt x="427" y="510"/>
                      </a:lnTo>
                      <a:lnTo>
                        <a:pt x="429" y="510"/>
                      </a:lnTo>
                      <a:lnTo>
                        <a:pt x="431" y="510"/>
                      </a:lnTo>
                      <a:lnTo>
                        <a:pt x="433" y="510"/>
                      </a:lnTo>
                      <a:lnTo>
                        <a:pt x="435" y="510"/>
                      </a:lnTo>
                      <a:lnTo>
                        <a:pt x="437" y="510"/>
                      </a:lnTo>
                      <a:lnTo>
                        <a:pt x="439" y="510"/>
                      </a:lnTo>
                      <a:lnTo>
                        <a:pt x="441" y="510"/>
                      </a:lnTo>
                      <a:lnTo>
                        <a:pt x="443" y="510"/>
                      </a:lnTo>
                      <a:lnTo>
                        <a:pt x="445" y="510"/>
                      </a:lnTo>
                      <a:lnTo>
                        <a:pt x="447" y="510"/>
                      </a:lnTo>
                      <a:lnTo>
                        <a:pt x="449" y="510"/>
                      </a:lnTo>
                      <a:lnTo>
                        <a:pt x="451" y="510"/>
                      </a:lnTo>
                      <a:lnTo>
                        <a:pt x="453" y="510"/>
                      </a:lnTo>
                      <a:lnTo>
                        <a:pt x="455" y="510"/>
                      </a:lnTo>
                      <a:lnTo>
                        <a:pt x="457" y="510"/>
                      </a:lnTo>
                      <a:lnTo>
                        <a:pt x="459" y="510"/>
                      </a:lnTo>
                      <a:lnTo>
                        <a:pt x="461" y="510"/>
                      </a:lnTo>
                      <a:lnTo>
                        <a:pt x="463" y="510"/>
                      </a:lnTo>
                      <a:lnTo>
                        <a:pt x="465" y="510"/>
                      </a:lnTo>
                      <a:lnTo>
                        <a:pt x="467" y="510"/>
                      </a:lnTo>
                      <a:lnTo>
                        <a:pt x="469" y="510"/>
                      </a:lnTo>
                      <a:lnTo>
                        <a:pt x="471" y="510"/>
                      </a:lnTo>
                      <a:lnTo>
                        <a:pt x="473" y="510"/>
                      </a:lnTo>
                      <a:lnTo>
                        <a:pt x="475" y="510"/>
                      </a:lnTo>
                      <a:lnTo>
                        <a:pt x="477" y="510"/>
                      </a:lnTo>
                      <a:lnTo>
                        <a:pt x="479" y="510"/>
                      </a:lnTo>
                      <a:lnTo>
                        <a:pt x="481" y="510"/>
                      </a:lnTo>
                      <a:lnTo>
                        <a:pt x="483" y="510"/>
                      </a:lnTo>
                      <a:lnTo>
                        <a:pt x="485" y="510"/>
                      </a:lnTo>
                      <a:lnTo>
                        <a:pt x="487" y="510"/>
                      </a:lnTo>
                      <a:lnTo>
                        <a:pt x="489" y="510"/>
                      </a:lnTo>
                      <a:lnTo>
                        <a:pt x="491" y="510"/>
                      </a:lnTo>
                      <a:lnTo>
                        <a:pt x="493" y="510"/>
                      </a:lnTo>
                      <a:lnTo>
                        <a:pt x="495" y="510"/>
                      </a:lnTo>
                      <a:lnTo>
                        <a:pt x="497" y="510"/>
                      </a:lnTo>
                      <a:lnTo>
                        <a:pt x="499" y="510"/>
                      </a:lnTo>
                      <a:lnTo>
                        <a:pt x="501" y="510"/>
                      </a:lnTo>
                      <a:lnTo>
                        <a:pt x="503" y="510"/>
                      </a:lnTo>
                      <a:lnTo>
                        <a:pt x="505" y="510"/>
                      </a:lnTo>
                      <a:lnTo>
                        <a:pt x="507" y="510"/>
                      </a:lnTo>
                      <a:lnTo>
                        <a:pt x="509" y="510"/>
                      </a:lnTo>
                      <a:lnTo>
                        <a:pt x="0" y="510"/>
                      </a:lnTo>
                      <a:close/>
                    </a:path>
                  </a:pathLst>
                </a:custGeom>
                <a:solidFill>
                  <a:srgbClr val="f0f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8" name="Freeform 305"/>
                <p:cNvSpPr/>
                <p:nvPr/>
              </p:nvSpPr>
              <p:spPr>
                <a:xfrm>
                  <a:off x="3811320" y="1259640"/>
                  <a:ext cx="1032120" cy="1037160"/>
                </a:xfrm>
                <a:custGeom>
                  <a:avLst/>
                  <a:gdLst>
                    <a:gd name="textAreaLeft" fmla="*/ 0 w 1032120"/>
                    <a:gd name="textAreaRight" fmla="*/ 1032480 w 1032120"/>
                    <a:gd name="textAreaTop" fmla="*/ 0 h 1037160"/>
                    <a:gd name="textAreaBottom" fmla="*/ 1037520 h 1037160"/>
                  </a:gdLst>
                  <a:ahLst/>
                  <a:rect l="textAreaLeft" t="textAreaTop" r="textAreaRight" b="textAreaBottom"/>
                  <a:pathLst>
                    <a:path w="507" h="510">
                      <a:moveTo>
                        <a:pt x="0" y="510"/>
                      </a:moveTo>
                      <a:lnTo>
                        <a:pt x="0" y="0"/>
                      </a:lnTo>
                      <a:lnTo>
                        <a:pt x="2" y="200"/>
                      </a:lnTo>
                      <a:lnTo>
                        <a:pt x="4" y="306"/>
                      </a:lnTo>
                      <a:lnTo>
                        <a:pt x="6" y="298"/>
                      </a:lnTo>
                      <a:lnTo>
                        <a:pt x="8" y="280"/>
                      </a:lnTo>
                      <a:lnTo>
                        <a:pt x="10" y="256"/>
                      </a:lnTo>
                      <a:lnTo>
                        <a:pt x="12" y="226"/>
                      </a:lnTo>
                      <a:lnTo>
                        <a:pt x="14" y="198"/>
                      </a:lnTo>
                      <a:lnTo>
                        <a:pt x="16" y="186"/>
                      </a:lnTo>
                      <a:lnTo>
                        <a:pt x="18" y="164"/>
                      </a:lnTo>
                      <a:lnTo>
                        <a:pt x="20" y="130"/>
                      </a:lnTo>
                      <a:lnTo>
                        <a:pt x="22" y="112"/>
                      </a:lnTo>
                      <a:lnTo>
                        <a:pt x="24" y="108"/>
                      </a:lnTo>
                      <a:lnTo>
                        <a:pt x="26" y="100"/>
                      </a:lnTo>
                      <a:lnTo>
                        <a:pt x="28" y="76"/>
                      </a:lnTo>
                      <a:lnTo>
                        <a:pt x="30" y="46"/>
                      </a:lnTo>
                      <a:lnTo>
                        <a:pt x="32" y="40"/>
                      </a:lnTo>
                      <a:lnTo>
                        <a:pt x="34" y="44"/>
                      </a:lnTo>
                      <a:lnTo>
                        <a:pt x="36" y="62"/>
                      </a:lnTo>
                      <a:lnTo>
                        <a:pt x="38" y="80"/>
                      </a:lnTo>
                      <a:lnTo>
                        <a:pt x="40" y="70"/>
                      </a:lnTo>
                      <a:lnTo>
                        <a:pt x="42" y="46"/>
                      </a:lnTo>
                      <a:lnTo>
                        <a:pt x="44" y="28"/>
                      </a:lnTo>
                      <a:lnTo>
                        <a:pt x="46" y="24"/>
                      </a:lnTo>
                      <a:lnTo>
                        <a:pt x="48" y="42"/>
                      </a:lnTo>
                      <a:lnTo>
                        <a:pt x="50" y="82"/>
                      </a:lnTo>
                      <a:lnTo>
                        <a:pt x="52" y="102"/>
                      </a:lnTo>
                      <a:lnTo>
                        <a:pt x="54" y="104"/>
                      </a:lnTo>
                      <a:lnTo>
                        <a:pt x="56" y="112"/>
                      </a:lnTo>
                      <a:lnTo>
                        <a:pt x="58" y="130"/>
                      </a:lnTo>
                      <a:lnTo>
                        <a:pt x="60" y="162"/>
                      </a:lnTo>
                      <a:lnTo>
                        <a:pt x="62" y="168"/>
                      </a:lnTo>
                      <a:lnTo>
                        <a:pt x="64" y="152"/>
                      </a:lnTo>
                      <a:lnTo>
                        <a:pt x="66" y="142"/>
                      </a:lnTo>
                      <a:lnTo>
                        <a:pt x="68" y="164"/>
                      </a:lnTo>
                      <a:lnTo>
                        <a:pt x="70" y="200"/>
                      </a:lnTo>
                      <a:lnTo>
                        <a:pt x="72" y="232"/>
                      </a:lnTo>
                      <a:lnTo>
                        <a:pt x="74" y="252"/>
                      </a:lnTo>
                      <a:lnTo>
                        <a:pt x="76" y="262"/>
                      </a:lnTo>
                      <a:lnTo>
                        <a:pt x="78" y="276"/>
                      </a:lnTo>
                      <a:lnTo>
                        <a:pt x="80" y="296"/>
                      </a:lnTo>
                      <a:lnTo>
                        <a:pt x="82" y="310"/>
                      </a:lnTo>
                      <a:lnTo>
                        <a:pt x="84" y="318"/>
                      </a:lnTo>
                      <a:lnTo>
                        <a:pt x="86" y="336"/>
                      </a:lnTo>
                      <a:lnTo>
                        <a:pt x="88" y="360"/>
                      </a:lnTo>
                      <a:lnTo>
                        <a:pt x="90" y="376"/>
                      </a:lnTo>
                      <a:lnTo>
                        <a:pt x="92" y="388"/>
                      </a:lnTo>
                      <a:lnTo>
                        <a:pt x="94" y="402"/>
                      </a:lnTo>
                      <a:lnTo>
                        <a:pt x="96" y="418"/>
                      </a:lnTo>
                      <a:lnTo>
                        <a:pt x="98" y="430"/>
                      </a:lnTo>
                      <a:lnTo>
                        <a:pt x="100" y="440"/>
                      </a:lnTo>
                      <a:lnTo>
                        <a:pt x="102" y="448"/>
                      </a:lnTo>
                      <a:lnTo>
                        <a:pt x="104" y="456"/>
                      </a:lnTo>
                      <a:lnTo>
                        <a:pt x="106" y="464"/>
                      </a:lnTo>
                      <a:lnTo>
                        <a:pt x="108" y="468"/>
                      </a:lnTo>
                      <a:lnTo>
                        <a:pt x="110" y="474"/>
                      </a:lnTo>
                      <a:lnTo>
                        <a:pt x="112" y="478"/>
                      </a:lnTo>
                      <a:lnTo>
                        <a:pt x="114" y="482"/>
                      </a:lnTo>
                      <a:lnTo>
                        <a:pt x="116" y="484"/>
                      </a:lnTo>
                      <a:lnTo>
                        <a:pt x="118" y="486"/>
                      </a:lnTo>
                      <a:lnTo>
                        <a:pt x="120" y="488"/>
                      </a:lnTo>
                      <a:lnTo>
                        <a:pt x="122" y="492"/>
                      </a:lnTo>
                      <a:lnTo>
                        <a:pt x="124" y="494"/>
                      </a:lnTo>
                      <a:lnTo>
                        <a:pt x="126" y="496"/>
                      </a:lnTo>
                      <a:lnTo>
                        <a:pt x="128" y="498"/>
                      </a:lnTo>
                      <a:lnTo>
                        <a:pt x="130" y="500"/>
                      </a:lnTo>
                      <a:lnTo>
                        <a:pt x="132" y="500"/>
                      </a:lnTo>
                      <a:lnTo>
                        <a:pt x="134" y="502"/>
                      </a:lnTo>
                      <a:lnTo>
                        <a:pt x="136" y="504"/>
                      </a:lnTo>
                      <a:lnTo>
                        <a:pt x="138" y="504"/>
                      </a:lnTo>
                      <a:lnTo>
                        <a:pt x="140" y="504"/>
                      </a:lnTo>
                      <a:lnTo>
                        <a:pt x="142" y="504"/>
                      </a:lnTo>
                      <a:lnTo>
                        <a:pt x="144" y="506"/>
                      </a:lnTo>
                      <a:lnTo>
                        <a:pt x="146" y="506"/>
                      </a:lnTo>
                      <a:lnTo>
                        <a:pt x="148" y="506"/>
                      </a:lnTo>
                      <a:lnTo>
                        <a:pt x="150" y="506"/>
                      </a:lnTo>
                      <a:lnTo>
                        <a:pt x="152" y="506"/>
                      </a:lnTo>
                      <a:lnTo>
                        <a:pt x="154" y="506"/>
                      </a:lnTo>
                      <a:lnTo>
                        <a:pt x="156" y="508"/>
                      </a:lnTo>
                      <a:lnTo>
                        <a:pt x="158" y="508"/>
                      </a:lnTo>
                      <a:lnTo>
                        <a:pt x="160" y="508"/>
                      </a:lnTo>
                      <a:lnTo>
                        <a:pt x="162" y="508"/>
                      </a:lnTo>
                      <a:lnTo>
                        <a:pt x="164" y="508"/>
                      </a:lnTo>
                      <a:lnTo>
                        <a:pt x="166" y="508"/>
                      </a:lnTo>
                      <a:lnTo>
                        <a:pt x="168" y="508"/>
                      </a:lnTo>
                      <a:lnTo>
                        <a:pt x="170" y="508"/>
                      </a:lnTo>
                      <a:lnTo>
                        <a:pt x="172" y="508"/>
                      </a:lnTo>
                      <a:lnTo>
                        <a:pt x="174" y="508"/>
                      </a:lnTo>
                      <a:lnTo>
                        <a:pt x="176" y="508"/>
                      </a:lnTo>
                      <a:lnTo>
                        <a:pt x="178" y="508"/>
                      </a:lnTo>
                      <a:lnTo>
                        <a:pt x="180" y="508"/>
                      </a:lnTo>
                      <a:lnTo>
                        <a:pt x="182" y="508"/>
                      </a:lnTo>
                      <a:lnTo>
                        <a:pt x="184" y="508"/>
                      </a:lnTo>
                      <a:lnTo>
                        <a:pt x="186" y="508"/>
                      </a:lnTo>
                      <a:lnTo>
                        <a:pt x="188" y="508"/>
                      </a:lnTo>
                      <a:lnTo>
                        <a:pt x="190" y="508"/>
                      </a:lnTo>
                      <a:lnTo>
                        <a:pt x="192" y="508"/>
                      </a:lnTo>
                      <a:lnTo>
                        <a:pt x="194" y="508"/>
                      </a:lnTo>
                      <a:lnTo>
                        <a:pt x="196" y="508"/>
                      </a:lnTo>
                      <a:lnTo>
                        <a:pt x="198" y="508"/>
                      </a:lnTo>
                      <a:lnTo>
                        <a:pt x="200" y="508"/>
                      </a:lnTo>
                      <a:lnTo>
                        <a:pt x="202" y="508"/>
                      </a:lnTo>
                      <a:lnTo>
                        <a:pt x="204" y="508"/>
                      </a:lnTo>
                      <a:lnTo>
                        <a:pt x="206" y="508"/>
                      </a:lnTo>
                      <a:lnTo>
                        <a:pt x="208" y="508"/>
                      </a:lnTo>
                      <a:lnTo>
                        <a:pt x="210" y="508"/>
                      </a:lnTo>
                      <a:lnTo>
                        <a:pt x="212" y="508"/>
                      </a:lnTo>
                      <a:lnTo>
                        <a:pt x="214" y="510"/>
                      </a:lnTo>
                      <a:lnTo>
                        <a:pt x="216" y="510"/>
                      </a:lnTo>
                      <a:lnTo>
                        <a:pt x="218" y="510"/>
                      </a:lnTo>
                      <a:lnTo>
                        <a:pt x="220" y="510"/>
                      </a:lnTo>
                      <a:lnTo>
                        <a:pt x="222" y="510"/>
                      </a:lnTo>
                      <a:lnTo>
                        <a:pt x="224" y="510"/>
                      </a:lnTo>
                      <a:lnTo>
                        <a:pt x="226" y="510"/>
                      </a:lnTo>
                      <a:lnTo>
                        <a:pt x="228" y="510"/>
                      </a:lnTo>
                      <a:lnTo>
                        <a:pt x="230" y="510"/>
                      </a:lnTo>
                      <a:lnTo>
                        <a:pt x="232" y="510"/>
                      </a:lnTo>
                      <a:lnTo>
                        <a:pt x="234" y="510"/>
                      </a:lnTo>
                      <a:lnTo>
                        <a:pt x="236" y="510"/>
                      </a:lnTo>
                      <a:lnTo>
                        <a:pt x="238" y="510"/>
                      </a:lnTo>
                      <a:lnTo>
                        <a:pt x="240" y="510"/>
                      </a:lnTo>
                      <a:lnTo>
                        <a:pt x="242" y="510"/>
                      </a:lnTo>
                      <a:lnTo>
                        <a:pt x="244" y="510"/>
                      </a:lnTo>
                      <a:lnTo>
                        <a:pt x="246" y="510"/>
                      </a:lnTo>
                      <a:lnTo>
                        <a:pt x="248" y="510"/>
                      </a:lnTo>
                      <a:lnTo>
                        <a:pt x="250" y="510"/>
                      </a:lnTo>
                      <a:lnTo>
                        <a:pt x="252" y="510"/>
                      </a:lnTo>
                      <a:lnTo>
                        <a:pt x="254" y="510"/>
                      </a:lnTo>
                      <a:lnTo>
                        <a:pt x="256" y="510"/>
                      </a:lnTo>
                      <a:lnTo>
                        <a:pt x="258" y="510"/>
                      </a:lnTo>
                      <a:lnTo>
                        <a:pt x="260" y="510"/>
                      </a:lnTo>
                      <a:lnTo>
                        <a:pt x="262" y="510"/>
                      </a:lnTo>
                      <a:lnTo>
                        <a:pt x="264" y="510"/>
                      </a:lnTo>
                      <a:lnTo>
                        <a:pt x="266" y="510"/>
                      </a:lnTo>
                      <a:lnTo>
                        <a:pt x="268" y="510"/>
                      </a:lnTo>
                      <a:lnTo>
                        <a:pt x="270" y="510"/>
                      </a:lnTo>
                      <a:lnTo>
                        <a:pt x="272" y="510"/>
                      </a:lnTo>
                      <a:lnTo>
                        <a:pt x="274" y="510"/>
                      </a:lnTo>
                      <a:lnTo>
                        <a:pt x="276" y="510"/>
                      </a:lnTo>
                      <a:lnTo>
                        <a:pt x="278" y="510"/>
                      </a:lnTo>
                      <a:lnTo>
                        <a:pt x="280" y="510"/>
                      </a:lnTo>
                      <a:lnTo>
                        <a:pt x="282" y="510"/>
                      </a:lnTo>
                      <a:lnTo>
                        <a:pt x="284" y="510"/>
                      </a:lnTo>
                      <a:lnTo>
                        <a:pt x="286" y="510"/>
                      </a:lnTo>
                      <a:lnTo>
                        <a:pt x="288" y="510"/>
                      </a:lnTo>
                      <a:lnTo>
                        <a:pt x="289" y="510"/>
                      </a:lnTo>
                      <a:lnTo>
                        <a:pt x="291" y="510"/>
                      </a:lnTo>
                      <a:lnTo>
                        <a:pt x="293" y="510"/>
                      </a:lnTo>
                      <a:lnTo>
                        <a:pt x="295" y="510"/>
                      </a:lnTo>
                      <a:lnTo>
                        <a:pt x="297" y="510"/>
                      </a:lnTo>
                      <a:lnTo>
                        <a:pt x="299" y="510"/>
                      </a:lnTo>
                      <a:lnTo>
                        <a:pt x="301" y="510"/>
                      </a:lnTo>
                      <a:lnTo>
                        <a:pt x="303" y="510"/>
                      </a:lnTo>
                      <a:lnTo>
                        <a:pt x="305" y="510"/>
                      </a:lnTo>
                      <a:lnTo>
                        <a:pt x="307" y="508"/>
                      </a:lnTo>
                      <a:lnTo>
                        <a:pt x="309" y="508"/>
                      </a:lnTo>
                      <a:lnTo>
                        <a:pt x="311" y="508"/>
                      </a:lnTo>
                      <a:lnTo>
                        <a:pt x="313" y="508"/>
                      </a:lnTo>
                      <a:lnTo>
                        <a:pt x="315" y="508"/>
                      </a:lnTo>
                      <a:lnTo>
                        <a:pt x="317" y="508"/>
                      </a:lnTo>
                      <a:lnTo>
                        <a:pt x="319" y="508"/>
                      </a:lnTo>
                      <a:lnTo>
                        <a:pt x="321" y="508"/>
                      </a:lnTo>
                      <a:lnTo>
                        <a:pt x="323" y="508"/>
                      </a:lnTo>
                      <a:lnTo>
                        <a:pt x="325" y="508"/>
                      </a:lnTo>
                      <a:lnTo>
                        <a:pt x="327" y="508"/>
                      </a:lnTo>
                      <a:lnTo>
                        <a:pt x="329" y="508"/>
                      </a:lnTo>
                      <a:lnTo>
                        <a:pt x="331" y="508"/>
                      </a:lnTo>
                      <a:lnTo>
                        <a:pt x="333" y="508"/>
                      </a:lnTo>
                      <a:lnTo>
                        <a:pt x="335" y="508"/>
                      </a:lnTo>
                      <a:lnTo>
                        <a:pt x="337" y="508"/>
                      </a:lnTo>
                      <a:lnTo>
                        <a:pt x="339" y="508"/>
                      </a:lnTo>
                      <a:lnTo>
                        <a:pt x="341" y="508"/>
                      </a:lnTo>
                      <a:lnTo>
                        <a:pt x="343" y="508"/>
                      </a:lnTo>
                      <a:lnTo>
                        <a:pt x="345" y="510"/>
                      </a:lnTo>
                      <a:lnTo>
                        <a:pt x="347" y="510"/>
                      </a:lnTo>
                      <a:lnTo>
                        <a:pt x="349" y="510"/>
                      </a:lnTo>
                      <a:lnTo>
                        <a:pt x="351" y="510"/>
                      </a:lnTo>
                      <a:lnTo>
                        <a:pt x="353" y="510"/>
                      </a:lnTo>
                      <a:lnTo>
                        <a:pt x="355" y="510"/>
                      </a:lnTo>
                      <a:lnTo>
                        <a:pt x="357" y="510"/>
                      </a:lnTo>
                      <a:lnTo>
                        <a:pt x="359" y="510"/>
                      </a:lnTo>
                      <a:lnTo>
                        <a:pt x="361" y="510"/>
                      </a:lnTo>
                      <a:lnTo>
                        <a:pt x="363" y="510"/>
                      </a:lnTo>
                      <a:lnTo>
                        <a:pt x="365" y="510"/>
                      </a:lnTo>
                      <a:lnTo>
                        <a:pt x="367" y="510"/>
                      </a:lnTo>
                      <a:lnTo>
                        <a:pt x="369" y="510"/>
                      </a:lnTo>
                      <a:lnTo>
                        <a:pt x="371" y="510"/>
                      </a:lnTo>
                      <a:lnTo>
                        <a:pt x="373" y="510"/>
                      </a:lnTo>
                      <a:lnTo>
                        <a:pt x="375" y="510"/>
                      </a:lnTo>
                      <a:lnTo>
                        <a:pt x="377" y="510"/>
                      </a:lnTo>
                      <a:lnTo>
                        <a:pt x="379" y="510"/>
                      </a:lnTo>
                      <a:lnTo>
                        <a:pt x="381" y="510"/>
                      </a:lnTo>
                      <a:lnTo>
                        <a:pt x="383" y="510"/>
                      </a:lnTo>
                      <a:lnTo>
                        <a:pt x="385" y="510"/>
                      </a:lnTo>
                      <a:lnTo>
                        <a:pt x="387" y="510"/>
                      </a:lnTo>
                      <a:lnTo>
                        <a:pt x="389" y="510"/>
                      </a:lnTo>
                      <a:lnTo>
                        <a:pt x="391" y="510"/>
                      </a:lnTo>
                      <a:lnTo>
                        <a:pt x="393" y="510"/>
                      </a:lnTo>
                      <a:lnTo>
                        <a:pt x="395" y="510"/>
                      </a:lnTo>
                      <a:lnTo>
                        <a:pt x="397" y="510"/>
                      </a:lnTo>
                      <a:lnTo>
                        <a:pt x="399" y="510"/>
                      </a:lnTo>
                      <a:lnTo>
                        <a:pt x="401" y="510"/>
                      </a:lnTo>
                      <a:lnTo>
                        <a:pt x="403" y="510"/>
                      </a:lnTo>
                      <a:lnTo>
                        <a:pt x="405" y="510"/>
                      </a:lnTo>
                      <a:lnTo>
                        <a:pt x="407" y="510"/>
                      </a:lnTo>
                      <a:lnTo>
                        <a:pt x="409" y="510"/>
                      </a:lnTo>
                      <a:lnTo>
                        <a:pt x="411" y="510"/>
                      </a:lnTo>
                      <a:lnTo>
                        <a:pt x="413" y="510"/>
                      </a:lnTo>
                      <a:lnTo>
                        <a:pt x="415" y="510"/>
                      </a:lnTo>
                      <a:lnTo>
                        <a:pt x="417" y="510"/>
                      </a:lnTo>
                      <a:lnTo>
                        <a:pt x="419" y="510"/>
                      </a:lnTo>
                      <a:lnTo>
                        <a:pt x="421" y="510"/>
                      </a:lnTo>
                      <a:lnTo>
                        <a:pt x="423" y="510"/>
                      </a:lnTo>
                      <a:lnTo>
                        <a:pt x="425" y="510"/>
                      </a:lnTo>
                      <a:lnTo>
                        <a:pt x="427" y="510"/>
                      </a:lnTo>
                      <a:lnTo>
                        <a:pt x="429" y="510"/>
                      </a:lnTo>
                      <a:lnTo>
                        <a:pt x="431" y="510"/>
                      </a:lnTo>
                      <a:lnTo>
                        <a:pt x="433" y="510"/>
                      </a:lnTo>
                      <a:lnTo>
                        <a:pt x="435" y="510"/>
                      </a:lnTo>
                      <a:lnTo>
                        <a:pt x="437" y="510"/>
                      </a:lnTo>
                      <a:lnTo>
                        <a:pt x="439" y="510"/>
                      </a:lnTo>
                      <a:lnTo>
                        <a:pt x="441" y="510"/>
                      </a:lnTo>
                      <a:lnTo>
                        <a:pt x="443" y="510"/>
                      </a:lnTo>
                      <a:lnTo>
                        <a:pt x="445" y="510"/>
                      </a:lnTo>
                      <a:lnTo>
                        <a:pt x="447" y="510"/>
                      </a:lnTo>
                      <a:lnTo>
                        <a:pt x="449" y="510"/>
                      </a:lnTo>
                      <a:lnTo>
                        <a:pt x="451" y="510"/>
                      </a:lnTo>
                      <a:lnTo>
                        <a:pt x="453" y="510"/>
                      </a:lnTo>
                      <a:lnTo>
                        <a:pt x="455" y="510"/>
                      </a:lnTo>
                      <a:lnTo>
                        <a:pt x="457" y="510"/>
                      </a:lnTo>
                      <a:lnTo>
                        <a:pt x="459" y="510"/>
                      </a:lnTo>
                      <a:lnTo>
                        <a:pt x="461" y="510"/>
                      </a:lnTo>
                      <a:lnTo>
                        <a:pt x="463" y="510"/>
                      </a:lnTo>
                      <a:lnTo>
                        <a:pt x="465" y="510"/>
                      </a:lnTo>
                      <a:lnTo>
                        <a:pt x="467" y="510"/>
                      </a:lnTo>
                      <a:lnTo>
                        <a:pt x="469" y="510"/>
                      </a:lnTo>
                      <a:lnTo>
                        <a:pt x="471" y="510"/>
                      </a:lnTo>
                      <a:lnTo>
                        <a:pt x="473" y="510"/>
                      </a:lnTo>
                      <a:lnTo>
                        <a:pt x="475" y="510"/>
                      </a:lnTo>
                      <a:lnTo>
                        <a:pt x="477" y="510"/>
                      </a:lnTo>
                      <a:lnTo>
                        <a:pt x="479" y="510"/>
                      </a:lnTo>
                      <a:lnTo>
                        <a:pt x="481" y="510"/>
                      </a:lnTo>
                      <a:lnTo>
                        <a:pt x="483" y="510"/>
                      </a:lnTo>
                      <a:lnTo>
                        <a:pt x="485" y="510"/>
                      </a:lnTo>
                      <a:lnTo>
                        <a:pt x="487" y="510"/>
                      </a:lnTo>
                      <a:lnTo>
                        <a:pt x="489" y="510"/>
                      </a:lnTo>
                      <a:lnTo>
                        <a:pt x="491" y="510"/>
                      </a:lnTo>
                      <a:lnTo>
                        <a:pt x="493" y="510"/>
                      </a:lnTo>
                      <a:lnTo>
                        <a:pt x="495" y="510"/>
                      </a:lnTo>
                      <a:lnTo>
                        <a:pt x="497" y="510"/>
                      </a:lnTo>
                      <a:lnTo>
                        <a:pt x="499" y="510"/>
                      </a:lnTo>
                      <a:lnTo>
                        <a:pt x="501" y="510"/>
                      </a:lnTo>
                      <a:lnTo>
                        <a:pt x="503" y="510"/>
                      </a:lnTo>
                      <a:lnTo>
                        <a:pt x="505" y="510"/>
                      </a:lnTo>
                      <a:lnTo>
                        <a:pt x="507" y="510"/>
                      </a:lnTo>
                    </a:path>
                  </a:pathLst>
                </a:custGeom>
                <a:noFill/>
                <a:ln w="6480">
                  <a:solidFill>
                    <a:srgbClr val="cccccc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79" name="Freeform 306"/>
              <p:cNvSpPr/>
              <p:nvPr/>
            </p:nvSpPr>
            <p:spPr>
              <a:xfrm>
                <a:off x="3811320" y="1308600"/>
                <a:ext cx="1032480" cy="988560"/>
              </a:xfrm>
              <a:custGeom>
                <a:avLst/>
                <a:gdLst>
                  <a:gd name="textAreaLeft" fmla="*/ 0 w 1032480"/>
                  <a:gd name="textAreaRight" fmla="*/ 1032840 w 1032480"/>
                  <a:gd name="textAreaTop" fmla="*/ 0 h 988560"/>
                  <a:gd name="textAreaBottom" fmla="*/ 988920 h 988560"/>
                </a:gdLst>
                <a:ahLst/>
                <a:rect l="textAreaLeft" t="textAreaTop" r="textAreaRight" b="textAreaBottom"/>
                <a:pathLst>
                  <a:path w="507" h="486">
                    <a:moveTo>
                      <a:pt x="0" y="486"/>
                    </a:moveTo>
                    <a:lnTo>
                      <a:pt x="0" y="438"/>
                    </a:lnTo>
                    <a:lnTo>
                      <a:pt x="0" y="444"/>
                    </a:lnTo>
                    <a:lnTo>
                      <a:pt x="2" y="454"/>
                    </a:lnTo>
                    <a:lnTo>
                      <a:pt x="4" y="460"/>
                    </a:lnTo>
                    <a:lnTo>
                      <a:pt x="6" y="462"/>
                    </a:lnTo>
                    <a:lnTo>
                      <a:pt x="8" y="460"/>
                    </a:lnTo>
                    <a:lnTo>
                      <a:pt x="10" y="456"/>
                    </a:lnTo>
                    <a:lnTo>
                      <a:pt x="12" y="452"/>
                    </a:lnTo>
                    <a:lnTo>
                      <a:pt x="14" y="444"/>
                    </a:lnTo>
                    <a:lnTo>
                      <a:pt x="16" y="436"/>
                    </a:lnTo>
                    <a:lnTo>
                      <a:pt x="18" y="430"/>
                    </a:lnTo>
                    <a:lnTo>
                      <a:pt x="20" y="426"/>
                    </a:lnTo>
                    <a:lnTo>
                      <a:pt x="22" y="422"/>
                    </a:lnTo>
                    <a:lnTo>
                      <a:pt x="24" y="414"/>
                    </a:lnTo>
                    <a:lnTo>
                      <a:pt x="26" y="404"/>
                    </a:lnTo>
                    <a:lnTo>
                      <a:pt x="28" y="396"/>
                    </a:lnTo>
                    <a:lnTo>
                      <a:pt x="30" y="388"/>
                    </a:lnTo>
                    <a:lnTo>
                      <a:pt x="32" y="378"/>
                    </a:lnTo>
                    <a:lnTo>
                      <a:pt x="34" y="370"/>
                    </a:lnTo>
                    <a:lnTo>
                      <a:pt x="36" y="360"/>
                    </a:lnTo>
                    <a:lnTo>
                      <a:pt x="38" y="350"/>
                    </a:lnTo>
                    <a:lnTo>
                      <a:pt x="40" y="346"/>
                    </a:lnTo>
                    <a:lnTo>
                      <a:pt x="42" y="348"/>
                    </a:lnTo>
                    <a:lnTo>
                      <a:pt x="44" y="350"/>
                    </a:lnTo>
                    <a:lnTo>
                      <a:pt x="46" y="352"/>
                    </a:lnTo>
                    <a:lnTo>
                      <a:pt x="48" y="352"/>
                    </a:lnTo>
                    <a:lnTo>
                      <a:pt x="50" y="348"/>
                    </a:lnTo>
                    <a:lnTo>
                      <a:pt x="52" y="348"/>
                    </a:lnTo>
                    <a:lnTo>
                      <a:pt x="54" y="348"/>
                    </a:lnTo>
                    <a:lnTo>
                      <a:pt x="56" y="346"/>
                    </a:lnTo>
                    <a:lnTo>
                      <a:pt x="58" y="340"/>
                    </a:lnTo>
                    <a:lnTo>
                      <a:pt x="60" y="336"/>
                    </a:lnTo>
                    <a:lnTo>
                      <a:pt x="62" y="340"/>
                    </a:lnTo>
                    <a:lnTo>
                      <a:pt x="64" y="344"/>
                    </a:lnTo>
                    <a:lnTo>
                      <a:pt x="66" y="340"/>
                    </a:lnTo>
                    <a:lnTo>
                      <a:pt x="68" y="334"/>
                    </a:lnTo>
                    <a:lnTo>
                      <a:pt x="70" y="330"/>
                    </a:lnTo>
                    <a:lnTo>
                      <a:pt x="72" y="330"/>
                    </a:lnTo>
                    <a:lnTo>
                      <a:pt x="74" y="332"/>
                    </a:lnTo>
                    <a:lnTo>
                      <a:pt x="76" y="334"/>
                    </a:lnTo>
                    <a:lnTo>
                      <a:pt x="78" y="336"/>
                    </a:lnTo>
                    <a:lnTo>
                      <a:pt x="80" y="334"/>
                    </a:lnTo>
                    <a:lnTo>
                      <a:pt x="82" y="328"/>
                    </a:lnTo>
                    <a:lnTo>
                      <a:pt x="84" y="322"/>
                    </a:lnTo>
                    <a:lnTo>
                      <a:pt x="86" y="322"/>
                    </a:lnTo>
                    <a:lnTo>
                      <a:pt x="88" y="330"/>
                    </a:lnTo>
                    <a:lnTo>
                      <a:pt x="90" y="340"/>
                    </a:lnTo>
                    <a:lnTo>
                      <a:pt x="92" y="344"/>
                    </a:lnTo>
                    <a:lnTo>
                      <a:pt x="94" y="346"/>
                    </a:lnTo>
                    <a:lnTo>
                      <a:pt x="96" y="352"/>
                    </a:lnTo>
                    <a:lnTo>
                      <a:pt x="98" y="362"/>
                    </a:lnTo>
                    <a:lnTo>
                      <a:pt x="100" y="364"/>
                    </a:lnTo>
                    <a:lnTo>
                      <a:pt x="102" y="356"/>
                    </a:lnTo>
                    <a:lnTo>
                      <a:pt x="104" y="344"/>
                    </a:lnTo>
                    <a:lnTo>
                      <a:pt x="106" y="340"/>
                    </a:lnTo>
                    <a:lnTo>
                      <a:pt x="108" y="346"/>
                    </a:lnTo>
                    <a:lnTo>
                      <a:pt x="110" y="356"/>
                    </a:lnTo>
                    <a:lnTo>
                      <a:pt x="112" y="368"/>
                    </a:lnTo>
                    <a:lnTo>
                      <a:pt x="114" y="378"/>
                    </a:lnTo>
                    <a:lnTo>
                      <a:pt x="116" y="382"/>
                    </a:lnTo>
                    <a:lnTo>
                      <a:pt x="118" y="382"/>
                    </a:lnTo>
                    <a:lnTo>
                      <a:pt x="120" y="386"/>
                    </a:lnTo>
                    <a:lnTo>
                      <a:pt x="122" y="392"/>
                    </a:lnTo>
                    <a:lnTo>
                      <a:pt x="124" y="396"/>
                    </a:lnTo>
                    <a:lnTo>
                      <a:pt x="126" y="398"/>
                    </a:lnTo>
                    <a:lnTo>
                      <a:pt x="128" y="396"/>
                    </a:lnTo>
                    <a:lnTo>
                      <a:pt x="130" y="396"/>
                    </a:lnTo>
                    <a:lnTo>
                      <a:pt x="132" y="392"/>
                    </a:lnTo>
                    <a:lnTo>
                      <a:pt x="134" y="388"/>
                    </a:lnTo>
                    <a:lnTo>
                      <a:pt x="136" y="384"/>
                    </a:lnTo>
                    <a:lnTo>
                      <a:pt x="138" y="388"/>
                    </a:lnTo>
                    <a:lnTo>
                      <a:pt x="140" y="396"/>
                    </a:lnTo>
                    <a:lnTo>
                      <a:pt x="142" y="406"/>
                    </a:lnTo>
                    <a:lnTo>
                      <a:pt x="144" y="410"/>
                    </a:lnTo>
                    <a:lnTo>
                      <a:pt x="146" y="412"/>
                    </a:lnTo>
                    <a:lnTo>
                      <a:pt x="148" y="410"/>
                    </a:lnTo>
                    <a:lnTo>
                      <a:pt x="150" y="404"/>
                    </a:lnTo>
                    <a:lnTo>
                      <a:pt x="152" y="400"/>
                    </a:lnTo>
                    <a:lnTo>
                      <a:pt x="154" y="402"/>
                    </a:lnTo>
                    <a:lnTo>
                      <a:pt x="156" y="404"/>
                    </a:lnTo>
                    <a:lnTo>
                      <a:pt x="158" y="406"/>
                    </a:lnTo>
                    <a:lnTo>
                      <a:pt x="160" y="408"/>
                    </a:lnTo>
                    <a:lnTo>
                      <a:pt x="162" y="412"/>
                    </a:lnTo>
                    <a:lnTo>
                      <a:pt x="164" y="414"/>
                    </a:lnTo>
                    <a:lnTo>
                      <a:pt x="166" y="416"/>
                    </a:lnTo>
                    <a:lnTo>
                      <a:pt x="168" y="418"/>
                    </a:lnTo>
                    <a:lnTo>
                      <a:pt x="170" y="416"/>
                    </a:lnTo>
                    <a:lnTo>
                      <a:pt x="172" y="412"/>
                    </a:lnTo>
                    <a:lnTo>
                      <a:pt x="174" y="408"/>
                    </a:lnTo>
                    <a:lnTo>
                      <a:pt x="176" y="404"/>
                    </a:lnTo>
                    <a:lnTo>
                      <a:pt x="178" y="402"/>
                    </a:lnTo>
                    <a:lnTo>
                      <a:pt x="180" y="400"/>
                    </a:lnTo>
                    <a:lnTo>
                      <a:pt x="182" y="402"/>
                    </a:lnTo>
                    <a:lnTo>
                      <a:pt x="184" y="404"/>
                    </a:lnTo>
                    <a:lnTo>
                      <a:pt x="186" y="408"/>
                    </a:lnTo>
                    <a:lnTo>
                      <a:pt x="188" y="410"/>
                    </a:lnTo>
                    <a:lnTo>
                      <a:pt x="190" y="410"/>
                    </a:lnTo>
                    <a:lnTo>
                      <a:pt x="192" y="412"/>
                    </a:lnTo>
                    <a:lnTo>
                      <a:pt x="194" y="412"/>
                    </a:lnTo>
                    <a:lnTo>
                      <a:pt x="196" y="408"/>
                    </a:lnTo>
                    <a:lnTo>
                      <a:pt x="198" y="402"/>
                    </a:lnTo>
                    <a:lnTo>
                      <a:pt x="200" y="394"/>
                    </a:lnTo>
                    <a:lnTo>
                      <a:pt x="202" y="388"/>
                    </a:lnTo>
                    <a:lnTo>
                      <a:pt x="204" y="384"/>
                    </a:lnTo>
                    <a:lnTo>
                      <a:pt x="206" y="382"/>
                    </a:lnTo>
                    <a:lnTo>
                      <a:pt x="208" y="380"/>
                    </a:lnTo>
                    <a:lnTo>
                      <a:pt x="210" y="374"/>
                    </a:lnTo>
                    <a:lnTo>
                      <a:pt x="212" y="370"/>
                    </a:lnTo>
                    <a:lnTo>
                      <a:pt x="214" y="374"/>
                    </a:lnTo>
                    <a:lnTo>
                      <a:pt x="216" y="380"/>
                    </a:lnTo>
                    <a:lnTo>
                      <a:pt x="218" y="384"/>
                    </a:lnTo>
                    <a:lnTo>
                      <a:pt x="220" y="386"/>
                    </a:lnTo>
                    <a:lnTo>
                      <a:pt x="222" y="386"/>
                    </a:lnTo>
                    <a:lnTo>
                      <a:pt x="224" y="388"/>
                    </a:lnTo>
                    <a:lnTo>
                      <a:pt x="226" y="384"/>
                    </a:lnTo>
                    <a:lnTo>
                      <a:pt x="228" y="372"/>
                    </a:lnTo>
                    <a:lnTo>
                      <a:pt x="230" y="364"/>
                    </a:lnTo>
                    <a:lnTo>
                      <a:pt x="232" y="358"/>
                    </a:lnTo>
                    <a:lnTo>
                      <a:pt x="234" y="358"/>
                    </a:lnTo>
                    <a:lnTo>
                      <a:pt x="236" y="358"/>
                    </a:lnTo>
                    <a:lnTo>
                      <a:pt x="238" y="354"/>
                    </a:lnTo>
                    <a:lnTo>
                      <a:pt x="240" y="346"/>
                    </a:lnTo>
                    <a:lnTo>
                      <a:pt x="242" y="338"/>
                    </a:lnTo>
                    <a:lnTo>
                      <a:pt x="244" y="332"/>
                    </a:lnTo>
                    <a:lnTo>
                      <a:pt x="246" y="332"/>
                    </a:lnTo>
                    <a:lnTo>
                      <a:pt x="248" y="332"/>
                    </a:lnTo>
                    <a:lnTo>
                      <a:pt x="250" y="326"/>
                    </a:lnTo>
                    <a:lnTo>
                      <a:pt x="252" y="308"/>
                    </a:lnTo>
                    <a:lnTo>
                      <a:pt x="254" y="290"/>
                    </a:lnTo>
                    <a:lnTo>
                      <a:pt x="256" y="276"/>
                    </a:lnTo>
                    <a:lnTo>
                      <a:pt x="258" y="268"/>
                    </a:lnTo>
                    <a:lnTo>
                      <a:pt x="260" y="264"/>
                    </a:lnTo>
                    <a:lnTo>
                      <a:pt x="262" y="252"/>
                    </a:lnTo>
                    <a:lnTo>
                      <a:pt x="264" y="228"/>
                    </a:lnTo>
                    <a:lnTo>
                      <a:pt x="266" y="190"/>
                    </a:lnTo>
                    <a:lnTo>
                      <a:pt x="268" y="162"/>
                    </a:lnTo>
                    <a:lnTo>
                      <a:pt x="270" y="156"/>
                    </a:lnTo>
                    <a:lnTo>
                      <a:pt x="272" y="154"/>
                    </a:lnTo>
                    <a:lnTo>
                      <a:pt x="274" y="152"/>
                    </a:lnTo>
                    <a:lnTo>
                      <a:pt x="276" y="142"/>
                    </a:lnTo>
                    <a:lnTo>
                      <a:pt x="278" y="108"/>
                    </a:lnTo>
                    <a:lnTo>
                      <a:pt x="280" y="70"/>
                    </a:lnTo>
                    <a:lnTo>
                      <a:pt x="282" y="34"/>
                    </a:lnTo>
                    <a:lnTo>
                      <a:pt x="284" y="2"/>
                    </a:lnTo>
                    <a:lnTo>
                      <a:pt x="286" y="0"/>
                    </a:lnTo>
                    <a:lnTo>
                      <a:pt x="288" y="18"/>
                    </a:lnTo>
                    <a:lnTo>
                      <a:pt x="289" y="38"/>
                    </a:lnTo>
                    <a:lnTo>
                      <a:pt x="291" y="50"/>
                    </a:lnTo>
                    <a:lnTo>
                      <a:pt x="293" y="52"/>
                    </a:lnTo>
                    <a:lnTo>
                      <a:pt x="295" y="60"/>
                    </a:lnTo>
                    <a:lnTo>
                      <a:pt x="297" y="64"/>
                    </a:lnTo>
                    <a:lnTo>
                      <a:pt x="299" y="80"/>
                    </a:lnTo>
                    <a:lnTo>
                      <a:pt x="301" y="130"/>
                    </a:lnTo>
                    <a:lnTo>
                      <a:pt x="303" y="176"/>
                    </a:lnTo>
                    <a:lnTo>
                      <a:pt x="305" y="210"/>
                    </a:lnTo>
                    <a:lnTo>
                      <a:pt x="307" y="248"/>
                    </a:lnTo>
                    <a:lnTo>
                      <a:pt x="309" y="284"/>
                    </a:lnTo>
                    <a:lnTo>
                      <a:pt x="311" y="316"/>
                    </a:lnTo>
                    <a:lnTo>
                      <a:pt x="313" y="344"/>
                    </a:lnTo>
                    <a:lnTo>
                      <a:pt x="315" y="368"/>
                    </a:lnTo>
                    <a:lnTo>
                      <a:pt x="317" y="388"/>
                    </a:lnTo>
                    <a:lnTo>
                      <a:pt x="319" y="406"/>
                    </a:lnTo>
                    <a:lnTo>
                      <a:pt x="321" y="422"/>
                    </a:lnTo>
                    <a:lnTo>
                      <a:pt x="323" y="436"/>
                    </a:lnTo>
                    <a:lnTo>
                      <a:pt x="325" y="444"/>
                    </a:lnTo>
                    <a:lnTo>
                      <a:pt x="327" y="452"/>
                    </a:lnTo>
                    <a:lnTo>
                      <a:pt x="329" y="460"/>
                    </a:lnTo>
                    <a:lnTo>
                      <a:pt x="331" y="464"/>
                    </a:lnTo>
                    <a:lnTo>
                      <a:pt x="333" y="468"/>
                    </a:lnTo>
                    <a:lnTo>
                      <a:pt x="335" y="470"/>
                    </a:lnTo>
                    <a:lnTo>
                      <a:pt x="337" y="472"/>
                    </a:lnTo>
                    <a:lnTo>
                      <a:pt x="339" y="474"/>
                    </a:lnTo>
                    <a:lnTo>
                      <a:pt x="341" y="476"/>
                    </a:lnTo>
                    <a:lnTo>
                      <a:pt x="343" y="478"/>
                    </a:lnTo>
                    <a:lnTo>
                      <a:pt x="345" y="480"/>
                    </a:lnTo>
                    <a:lnTo>
                      <a:pt x="347" y="482"/>
                    </a:lnTo>
                    <a:lnTo>
                      <a:pt x="349" y="482"/>
                    </a:lnTo>
                    <a:lnTo>
                      <a:pt x="351" y="484"/>
                    </a:lnTo>
                    <a:lnTo>
                      <a:pt x="353" y="484"/>
                    </a:lnTo>
                    <a:lnTo>
                      <a:pt x="355" y="484"/>
                    </a:lnTo>
                    <a:lnTo>
                      <a:pt x="357" y="484"/>
                    </a:lnTo>
                    <a:lnTo>
                      <a:pt x="359" y="484"/>
                    </a:lnTo>
                    <a:lnTo>
                      <a:pt x="361" y="484"/>
                    </a:lnTo>
                    <a:lnTo>
                      <a:pt x="363" y="484"/>
                    </a:lnTo>
                    <a:lnTo>
                      <a:pt x="365" y="484"/>
                    </a:lnTo>
                    <a:lnTo>
                      <a:pt x="367" y="484"/>
                    </a:lnTo>
                    <a:lnTo>
                      <a:pt x="369" y="484"/>
                    </a:lnTo>
                    <a:lnTo>
                      <a:pt x="371" y="484"/>
                    </a:lnTo>
                    <a:lnTo>
                      <a:pt x="373" y="484"/>
                    </a:lnTo>
                    <a:lnTo>
                      <a:pt x="375" y="484"/>
                    </a:lnTo>
                    <a:lnTo>
                      <a:pt x="377" y="484"/>
                    </a:lnTo>
                    <a:lnTo>
                      <a:pt x="379" y="484"/>
                    </a:lnTo>
                    <a:lnTo>
                      <a:pt x="381" y="484"/>
                    </a:lnTo>
                    <a:lnTo>
                      <a:pt x="383" y="484"/>
                    </a:lnTo>
                    <a:lnTo>
                      <a:pt x="385" y="484"/>
                    </a:lnTo>
                    <a:lnTo>
                      <a:pt x="387" y="484"/>
                    </a:lnTo>
                    <a:lnTo>
                      <a:pt x="389" y="484"/>
                    </a:lnTo>
                    <a:lnTo>
                      <a:pt x="391" y="484"/>
                    </a:lnTo>
                    <a:lnTo>
                      <a:pt x="393" y="486"/>
                    </a:lnTo>
                    <a:lnTo>
                      <a:pt x="395" y="486"/>
                    </a:lnTo>
                    <a:lnTo>
                      <a:pt x="397" y="486"/>
                    </a:lnTo>
                    <a:lnTo>
                      <a:pt x="399" y="486"/>
                    </a:lnTo>
                    <a:lnTo>
                      <a:pt x="401" y="486"/>
                    </a:lnTo>
                    <a:lnTo>
                      <a:pt x="403" y="486"/>
                    </a:lnTo>
                    <a:lnTo>
                      <a:pt x="405" y="486"/>
                    </a:lnTo>
                    <a:lnTo>
                      <a:pt x="407" y="486"/>
                    </a:lnTo>
                    <a:lnTo>
                      <a:pt x="409" y="486"/>
                    </a:lnTo>
                    <a:lnTo>
                      <a:pt x="411" y="486"/>
                    </a:lnTo>
                    <a:lnTo>
                      <a:pt x="413" y="486"/>
                    </a:lnTo>
                    <a:lnTo>
                      <a:pt x="415" y="486"/>
                    </a:lnTo>
                    <a:lnTo>
                      <a:pt x="417" y="486"/>
                    </a:lnTo>
                    <a:lnTo>
                      <a:pt x="419" y="486"/>
                    </a:lnTo>
                    <a:lnTo>
                      <a:pt x="421" y="486"/>
                    </a:lnTo>
                    <a:lnTo>
                      <a:pt x="423" y="486"/>
                    </a:lnTo>
                    <a:lnTo>
                      <a:pt x="425" y="486"/>
                    </a:lnTo>
                    <a:lnTo>
                      <a:pt x="427" y="486"/>
                    </a:lnTo>
                    <a:lnTo>
                      <a:pt x="429" y="486"/>
                    </a:lnTo>
                    <a:lnTo>
                      <a:pt x="431" y="486"/>
                    </a:lnTo>
                    <a:lnTo>
                      <a:pt x="433" y="486"/>
                    </a:lnTo>
                    <a:lnTo>
                      <a:pt x="435" y="486"/>
                    </a:lnTo>
                    <a:lnTo>
                      <a:pt x="437" y="486"/>
                    </a:lnTo>
                    <a:lnTo>
                      <a:pt x="439" y="486"/>
                    </a:lnTo>
                    <a:lnTo>
                      <a:pt x="441" y="486"/>
                    </a:lnTo>
                    <a:lnTo>
                      <a:pt x="443" y="486"/>
                    </a:lnTo>
                    <a:lnTo>
                      <a:pt x="445" y="486"/>
                    </a:lnTo>
                    <a:lnTo>
                      <a:pt x="447" y="486"/>
                    </a:lnTo>
                    <a:lnTo>
                      <a:pt x="449" y="486"/>
                    </a:lnTo>
                    <a:lnTo>
                      <a:pt x="451" y="486"/>
                    </a:lnTo>
                    <a:lnTo>
                      <a:pt x="453" y="486"/>
                    </a:lnTo>
                    <a:lnTo>
                      <a:pt x="455" y="486"/>
                    </a:lnTo>
                    <a:lnTo>
                      <a:pt x="457" y="486"/>
                    </a:lnTo>
                    <a:lnTo>
                      <a:pt x="459" y="486"/>
                    </a:lnTo>
                    <a:lnTo>
                      <a:pt x="461" y="486"/>
                    </a:lnTo>
                    <a:lnTo>
                      <a:pt x="463" y="486"/>
                    </a:lnTo>
                    <a:lnTo>
                      <a:pt x="465" y="486"/>
                    </a:lnTo>
                    <a:lnTo>
                      <a:pt x="467" y="486"/>
                    </a:lnTo>
                    <a:lnTo>
                      <a:pt x="469" y="486"/>
                    </a:lnTo>
                    <a:lnTo>
                      <a:pt x="471" y="486"/>
                    </a:lnTo>
                    <a:lnTo>
                      <a:pt x="473" y="486"/>
                    </a:lnTo>
                    <a:lnTo>
                      <a:pt x="475" y="486"/>
                    </a:lnTo>
                    <a:lnTo>
                      <a:pt x="477" y="486"/>
                    </a:lnTo>
                    <a:lnTo>
                      <a:pt x="479" y="486"/>
                    </a:lnTo>
                    <a:lnTo>
                      <a:pt x="481" y="486"/>
                    </a:lnTo>
                    <a:lnTo>
                      <a:pt x="483" y="486"/>
                    </a:lnTo>
                    <a:lnTo>
                      <a:pt x="485" y="486"/>
                    </a:lnTo>
                    <a:lnTo>
                      <a:pt x="487" y="486"/>
                    </a:lnTo>
                    <a:lnTo>
                      <a:pt x="489" y="486"/>
                    </a:lnTo>
                    <a:lnTo>
                      <a:pt x="491" y="486"/>
                    </a:lnTo>
                    <a:lnTo>
                      <a:pt x="493" y="486"/>
                    </a:lnTo>
                    <a:lnTo>
                      <a:pt x="495" y="486"/>
                    </a:lnTo>
                    <a:lnTo>
                      <a:pt x="497" y="486"/>
                    </a:lnTo>
                    <a:lnTo>
                      <a:pt x="499" y="486"/>
                    </a:lnTo>
                    <a:lnTo>
                      <a:pt x="501" y="486"/>
                    </a:lnTo>
                    <a:lnTo>
                      <a:pt x="503" y="486"/>
                    </a:lnTo>
                    <a:lnTo>
                      <a:pt x="505" y="486"/>
                    </a:lnTo>
                    <a:lnTo>
                      <a:pt x="507" y="486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80" name="Text Box 45"/>
            <p:cNvSpPr/>
            <p:nvPr/>
          </p:nvSpPr>
          <p:spPr>
            <a:xfrm>
              <a:off x="4336920" y="1236600"/>
              <a:ext cx="757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38/73%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1" name="Text Box 15"/>
          <p:cNvSpPr/>
          <p:nvPr/>
        </p:nvSpPr>
        <p:spPr>
          <a:xfrm rot="19551600">
            <a:off x="1365480" y="1136880"/>
            <a:ext cx="57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Mark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2" name="Text Box 16"/>
          <p:cNvSpPr/>
          <p:nvPr/>
        </p:nvSpPr>
        <p:spPr>
          <a:xfrm rot="19551600">
            <a:off x="1815480" y="120528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C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3" name="Text Box 17"/>
          <p:cNvSpPr/>
          <p:nvPr/>
        </p:nvSpPr>
        <p:spPr>
          <a:xfrm rot="19551600">
            <a:off x="3004920" y="111348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MASP-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4" name="Text Box 18"/>
          <p:cNvSpPr/>
          <p:nvPr/>
        </p:nvSpPr>
        <p:spPr>
          <a:xfrm rot="19551600">
            <a:off x="2185560" y="1170720"/>
            <a:ext cx="45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C8-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5" name="Text Box 18"/>
          <p:cNvSpPr/>
          <p:nvPr/>
        </p:nvSpPr>
        <p:spPr>
          <a:xfrm rot="19551600">
            <a:off x="3389040" y="1113480"/>
            <a:ext cx="65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MASP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6" name="Text Box 18"/>
          <p:cNvSpPr/>
          <p:nvPr/>
        </p:nvSpPr>
        <p:spPr>
          <a:xfrm rot="19551600">
            <a:off x="2586240" y="1172160"/>
            <a:ext cx="45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C8-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87" name="Group 19"/>
          <p:cNvGrpSpPr/>
          <p:nvPr/>
        </p:nvGrpSpPr>
        <p:grpSpPr>
          <a:xfrm>
            <a:off x="1352520" y="3625920"/>
            <a:ext cx="1306440" cy="1492200"/>
            <a:chOff x="1352520" y="3625920"/>
            <a:chExt cx="1306440" cy="1492200"/>
          </a:xfrm>
        </p:grpSpPr>
        <p:pic>
          <p:nvPicPr>
            <p:cNvPr id="1188" name="Picture 41" descr=""/>
            <p:cNvPicPr/>
            <p:nvPr/>
          </p:nvPicPr>
          <p:blipFill>
            <a:blip r:embed="rId1"/>
            <a:stretch/>
          </p:blipFill>
          <p:spPr>
            <a:xfrm>
              <a:off x="1352520" y="4065480"/>
              <a:ext cx="1121040" cy="1052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189" name="Text Box 15"/>
            <p:cNvSpPr/>
            <p:nvPr/>
          </p:nvSpPr>
          <p:spPr>
            <a:xfrm rot="19498200">
              <a:off x="1385280" y="3768480"/>
              <a:ext cx="57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Mark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Text Box 29"/>
            <p:cNvSpPr/>
            <p:nvPr/>
          </p:nvSpPr>
          <p:spPr>
            <a:xfrm rot="19498200">
              <a:off x="1812600" y="381168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R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Text Box 30"/>
            <p:cNvSpPr/>
            <p:nvPr/>
          </p:nvSpPr>
          <p:spPr>
            <a:xfrm rot="19498200">
              <a:off x="2193840" y="381168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0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R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92" name="TextBox 27"/>
          <p:cNvSpPr/>
          <p:nvPr/>
        </p:nvSpPr>
        <p:spPr>
          <a:xfrm>
            <a:off x="157320" y="237960"/>
            <a:ext cx="65102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upplementary figure 3: Positive controls for the mRNA transcripts which were not detected in moDC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3" name="TextBox 19"/>
          <p:cNvSpPr/>
          <p:nvPr/>
        </p:nvSpPr>
        <p:spPr>
          <a:xfrm>
            <a:off x="440280" y="1038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4" name="TextBox 19"/>
          <p:cNvSpPr/>
          <p:nvPr/>
        </p:nvSpPr>
        <p:spPr>
          <a:xfrm>
            <a:off x="440280" y="32576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5" name="TextBox 21"/>
          <p:cNvSpPr/>
          <p:nvPr/>
        </p:nvSpPr>
        <p:spPr>
          <a:xfrm>
            <a:off x="190440" y="5270400"/>
            <a:ext cx="645804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Conventional RT-PCR was performed in HepG2 cells  and  freshly prepared PBMC. The agarose gels show the PCR products for C6, C8 (</a:t>
            </a:r>
            <a:r>
              <a:rPr b="0" lang="en-GB" sz="11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 and </a:t>
            </a:r>
            <a:r>
              <a:rPr b="0" lang="en-GB" sz="11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GB" sz="1100" spc="-1" strike="noStrike">
                <a:solidFill>
                  <a:srgbClr val="000000"/>
                </a:solidFill>
                <a:latin typeface="Arial"/>
              </a:rPr>
              <a:t>), MASP (1 and 2) were detected in HepG2 cells (A), and for CR (1 and 2) were detected in PBMC (B).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96" name="Group 23"/>
          <p:cNvGrpSpPr/>
          <p:nvPr/>
        </p:nvGrpSpPr>
        <p:grpSpPr>
          <a:xfrm>
            <a:off x="1403280" y="1474920"/>
            <a:ext cx="2255760" cy="1125360"/>
            <a:chOff x="1403280" y="1474920"/>
            <a:chExt cx="2255760" cy="1125360"/>
          </a:xfrm>
        </p:grpSpPr>
        <p:pic>
          <p:nvPicPr>
            <p:cNvPr id="1197" name="Picture 21" descr=""/>
            <p:cNvPicPr/>
            <p:nvPr/>
          </p:nvPicPr>
          <p:blipFill>
            <a:blip r:embed="rId2"/>
            <a:stretch/>
          </p:blipFill>
          <p:spPr>
            <a:xfrm>
              <a:off x="1403280" y="1474920"/>
              <a:ext cx="1542960" cy="1124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98" name="Picture 23" descr=""/>
            <p:cNvPicPr/>
            <p:nvPr/>
          </p:nvPicPr>
          <p:blipFill>
            <a:blip r:embed="rId3"/>
            <a:stretch/>
          </p:blipFill>
          <p:spPr>
            <a:xfrm>
              <a:off x="2925720" y="1483920"/>
              <a:ext cx="733320" cy="111636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23T12:44:12Z</dcterms:created>
  <dc:creator>Henrieta</dc:creator>
  <dc:description/>
  <dc:language>en-US</dc:language>
  <cp:lastModifiedBy>Wuding Zhou</cp:lastModifiedBy>
  <dcterms:modified xsi:type="dcterms:W3CDTF">2011-02-01T15:31:44Z</dcterms:modified>
  <cp:revision>585</cp:revision>
  <dc:subject/>
  <dc:title>Slide 1</dc:title>
</cp:coreProperties>
</file>